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12_23FE84C7.xml" ContentType="application/vnd.ms-powerpoint.comments+xml"/>
  <Override PartName="/ppt/comments/modernComment_117_500BA9A6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4" r:id="rId2"/>
    <p:sldId id="280" r:id="rId3"/>
    <p:sldId id="279" r:id="rId4"/>
    <p:sldId id="257" r:id="rId5"/>
    <p:sldId id="282" r:id="rId6"/>
    <p:sldId id="28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B075D77-3FE3-4F41-957C-8D5BC994C8E2}" name="Fehér Attila Dr." initials="FAD" userId="S::feher.attila@o365.u-szeged.hu::68df0ac7-9532-496e-9461-0d500921a7b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6" autoAdjust="0"/>
    <p:restoredTop sz="76823" autoAdjust="0"/>
  </p:normalViewPr>
  <p:slideViewPr>
    <p:cSldViewPr snapToGrid="0">
      <p:cViewPr>
        <p:scale>
          <a:sx n="79" d="100"/>
          <a:sy n="79" d="100"/>
        </p:scale>
        <p:origin x="773" y="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P-RBR\Edu%20Root%20WT-e2fa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P-RBR\PCNA1-CDC6A-RNR2A-dev-leaves%20(2)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UGUST22\Book1qwe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UGUST22\Book1qwe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UGUST22\Book1qwe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E70-46D8-807E-7A663ABD594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E70-46D8-807E-7A663ABD594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D$7:$D$8</c:f>
                <c:numCache>
                  <c:formatCode>General</c:formatCode>
                  <c:ptCount val="2"/>
                  <c:pt idx="0">
                    <c:v>9.2899999999999991</c:v>
                  </c:pt>
                  <c:pt idx="1">
                    <c:v>3</c:v>
                  </c:pt>
                </c:numCache>
              </c:numRef>
            </c:plus>
            <c:minus>
              <c:numRef>
                <c:f>Sheet1!$D$7:$D$8</c:f>
                <c:numCache>
                  <c:formatCode>General</c:formatCode>
                  <c:ptCount val="2"/>
                  <c:pt idx="0">
                    <c:v>9.2899999999999991</c:v>
                  </c:pt>
                  <c:pt idx="1">
                    <c:v>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7:$B$9</c:f>
              <c:strCache>
                <c:ptCount val="2"/>
                <c:pt idx="0">
                  <c:v>WT</c:v>
                </c:pt>
                <c:pt idx="1">
                  <c:v>e2fab</c:v>
                </c:pt>
              </c:strCache>
            </c:strRef>
          </c:cat>
          <c:val>
            <c:numRef>
              <c:f>Sheet1!$C$7:$C$9</c:f>
              <c:numCache>
                <c:formatCode>General</c:formatCode>
                <c:ptCount val="3"/>
                <c:pt idx="0">
                  <c:v>84.3</c:v>
                </c:pt>
                <c:pt idx="1">
                  <c:v>82.5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E70-46D8-807E-7A663ABD59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8885120"/>
        <c:axId val="-8880768"/>
      </c:barChart>
      <c:catAx>
        <c:axId val="-8885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80768"/>
        <c:crosses val="autoZero"/>
        <c:auto val="1"/>
        <c:lblAlgn val="ctr"/>
        <c:lblOffset val="100"/>
        <c:noMultiLvlLbl val="0"/>
      </c:catAx>
      <c:valAx>
        <c:axId val="-8880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8512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hu-HU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hu-HU" sz="1000" i="1" dirty="0">
                <a:solidFill>
                  <a:schemeClr val="tx1"/>
                </a:solidFill>
              </a:rPr>
              <a:t>PCNA1</a:t>
            </a:r>
          </a:p>
        </c:rich>
      </c:tx>
      <c:layout>
        <c:manualLayout>
          <c:xMode val="edge"/>
          <c:yMode val="edge"/>
          <c:x val="0.14304419923105111"/>
          <c:y val="6.686380667409598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u-HU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L$3:$L$6</c:f>
                <c:numCache>
                  <c:formatCode>General</c:formatCode>
                  <c:ptCount val="4"/>
                  <c:pt idx="0">
                    <c:v>0.15639409640045185</c:v>
                  </c:pt>
                  <c:pt idx="1">
                    <c:v>0.10661777836476466</c:v>
                  </c:pt>
                  <c:pt idx="2">
                    <c:v>5.0410627918113612E-2</c:v>
                  </c:pt>
                  <c:pt idx="3">
                    <c:v>2.1613138771650737E-2</c:v>
                  </c:pt>
                </c:numCache>
              </c:numRef>
            </c:plus>
            <c:minus>
              <c:numRef>
                <c:f>results!$L$3:$L$6</c:f>
                <c:numCache>
                  <c:formatCode>General</c:formatCode>
                  <c:ptCount val="4"/>
                  <c:pt idx="0">
                    <c:v>0.15639409640045185</c:v>
                  </c:pt>
                  <c:pt idx="1">
                    <c:v>0.10661777836476466</c:v>
                  </c:pt>
                  <c:pt idx="2">
                    <c:v>5.0410627918113612E-2</c:v>
                  </c:pt>
                  <c:pt idx="3">
                    <c:v>2.16131387716507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results!$B$3:$B$6</c:f>
              <c:numCache>
                <c:formatCode>General</c:formatCode>
                <c:ptCount val="4"/>
                <c:pt idx="0">
                  <c:v>9</c:v>
                </c:pt>
                <c:pt idx="1">
                  <c:v>12</c:v>
                </c:pt>
                <c:pt idx="2">
                  <c:v>16</c:v>
                </c:pt>
                <c:pt idx="3">
                  <c:v>20</c:v>
                </c:pt>
              </c:numCache>
            </c:numRef>
          </c:cat>
          <c:val>
            <c:numRef>
              <c:f>results!$K$3:$K$6</c:f>
              <c:numCache>
                <c:formatCode>General</c:formatCode>
                <c:ptCount val="4"/>
                <c:pt idx="0">
                  <c:v>1.0736001532936923</c:v>
                </c:pt>
                <c:pt idx="1">
                  <c:v>0.42266186864432392</c:v>
                </c:pt>
                <c:pt idx="2">
                  <c:v>0.11895139617394722</c:v>
                </c:pt>
                <c:pt idx="3">
                  <c:v>3.639141875456252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30-402D-B206-0B268A4C1899}"/>
            </c:ext>
          </c:extLst>
        </c:ser>
        <c:ser>
          <c:idx val="1"/>
          <c:order val="1"/>
          <c:tx>
            <c:v>ab</c:v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L$19:$L$22</c:f>
                <c:numCache>
                  <c:formatCode>General</c:formatCode>
                  <c:ptCount val="4"/>
                  <c:pt idx="0">
                    <c:v>0.28166866017169329</c:v>
                  </c:pt>
                  <c:pt idx="1">
                    <c:v>0.14898613288044027</c:v>
                  </c:pt>
                  <c:pt idx="2">
                    <c:v>7.5733602557815707E-2</c:v>
                  </c:pt>
                  <c:pt idx="3">
                    <c:v>2.2882250576452098E-2</c:v>
                  </c:pt>
                </c:numCache>
              </c:numRef>
            </c:plus>
            <c:minus>
              <c:numRef>
                <c:f>results!$L$19:$L$22</c:f>
                <c:numCache>
                  <c:formatCode>General</c:formatCode>
                  <c:ptCount val="4"/>
                  <c:pt idx="0">
                    <c:v>0.28166866017169329</c:v>
                  </c:pt>
                  <c:pt idx="1">
                    <c:v>0.14898613288044027</c:v>
                  </c:pt>
                  <c:pt idx="2">
                    <c:v>7.5733602557815707E-2</c:v>
                  </c:pt>
                  <c:pt idx="3">
                    <c:v>2.28822505764520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sults!$K$19:$K$22</c:f>
              <c:numCache>
                <c:formatCode>General</c:formatCode>
                <c:ptCount val="4"/>
                <c:pt idx="0">
                  <c:v>1.2112092660241134</c:v>
                </c:pt>
                <c:pt idx="1">
                  <c:v>0.49852338395302809</c:v>
                </c:pt>
                <c:pt idx="2">
                  <c:v>8.9281554426783941E-2</c:v>
                </c:pt>
                <c:pt idx="3">
                  <c:v>3.17436609647847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30-402D-B206-0B268A4C1899}"/>
            </c:ext>
          </c:extLst>
        </c:ser>
        <c:ser>
          <c:idx val="2"/>
          <c:order val="2"/>
          <c:tx>
            <c:v>abc</c:v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L$35:$L$38</c:f>
                <c:numCache>
                  <c:formatCode>General</c:formatCode>
                  <c:ptCount val="4"/>
                  <c:pt idx="0">
                    <c:v>1.1764659252429248</c:v>
                  </c:pt>
                  <c:pt idx="1">
                    <c:v>0.89706100912124986</c:v>
                  </c:pt>
                  <c:pt idx="2">
                    <c:v>0.15010203562309199</c:v>
                  </c:pt>
                  <c:pt idx="3">
                    <c:v>0.26648420459052147</c:v>
                  </c:pt>
                </c:numCache>
              </c:numRef>
            </c:plus>
            <c:minus>
              <c:numRef>
                <c:f>results!$L$35:$L$38</c:f>
                <c:numCache>
                  <c:formatCode>General</c:formatCode>
                  <c:ptCount val="4"/>
                  <c:pt idx="0">
                    <c:v>1.1764659252429248</c:v>
                  </c:pt>
                  <c:pt idx="1">
                    <c:v>0.89706100912124986</c:v>
                  </c:pt>
                  <c:pt idx="2">
                    <c:v>0.15010203562309199</c:v>
                  </c:pt>
                  <c:pt idx="3">
                    <c:v>0.266484204590521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sults!$K$35:$K$38</c:f>
              <c:numCache>
                <c:formatCode>General</c:formatCode>
                <c:ptCount val="4"/>
                <c:pt idx="0">
                  <c:v>6.282730053357251</c:v>
                </c:pt>
                <c:pt idx="1">
                  <c:v>2.269078903579262</c:v>
                </c:pt>
                <c:pt idx="2">
                  <c:v>0.44623996294901586</c:v>
                </c:pt>
                <c:pt idx="3">
                  <c:v>0.48365234618055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30-402D-B206-0B268A4C18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1916463"/>
        <c:axId val="1221912303"/>
      </c:barChart>
      <c:catAx>
        <c:axId val="122191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1221912303"/>
        <c:crosses val="autoZero"/>
        <c:auto val="1"/>
        <c:lblAlgn val="ctr"/>
        <c:lblOffset val="100"/>
        <c:noMultiLvlLbl val="0"/>
      </c:catAx>
      <c:valAx>
        <c:axId val="122191230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1221916463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240063043508316"/>
          <c:y val="0.24123618791615792"/>
          <c:w val="0.24741011533964108"/>
          <c:h val="0.2268578398252064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u-H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hu-HU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0310777559055116E-2"/>
          <c:y val="0.16601851851851851"/>
          <c:w val="0.92746932414698158"/>
          <c:h val="0.63122812773403325"/>
        </c:manualLayout>
      </c:layout>
      <c:lineChart>
        <c:grouping val="standard"/>
        <c:varyColors val="0"/>
        <c:ser>
          <c:idx val="0"/>
          <c:order val="0"/>
          <c:tx>
            <c:strRef>
              <c:f>Sheet3!$B$3</c:f>
              <c:strCache>
                <c:ptCount val="1"/>
                <c:pt idx="0">
                  <c:v>Series1</c:v>
                </c:pt>
              </c:strCache>
            </c:strRef>
          </c:tx>
          <c:spPr>
            <a:ln w="12700" cap="rnd">
              <a:solidFill>
                <a:srgbClr val="0099CC"/>
              </a:solidFill>
              <a:round/>
            </a:ln>
            <a:effectLst/>
          </c:spPr>
          <c:marker>
            <c:symbol val="none"/>
          </c:marker>
          <c:val>
            <c:numRef>
              <c:f>Sheet3!$B$4:$B$1016</c:f>
              <c:numCache>
                <c:formatCode>General</c:formatCode>
                <c:ptCount val="1013"/>
                <c:pt idx="0">
                  <c:v>0.95079999999999998</c:v>
                </c:pt>
                <c:pt idx="1">
                  <c:v>0.78100000000000003</c:v>
                </c:pt>
                <c:pt idx="2">
                  <c:v>0.58350000000000002</c:v>
                </c:pt>
                <c:pt idx="3">
                  <c:v>0.50880000000000003</c:v>
                </c:pt>
                <c:pt idx="4">
                  <c:v>0.4042</c:v>
                </c:pt>
                <c:pt idx="5">
                  <c:v>0.37259999999999999</c:v>
                </c:pt>
                <c:pt idx="6">
                  <c:v>0.32540000000000002</c:v>
                </c:pt>
                <c:pt idx="7">
                  <c:v>0.31009999999999999</c:v>
                </c:pt>
                <c:pt idx="8">
                  <c:v>0.2883</c:v>
                </c:pt>
                <c:pt idx="9">
                  <c:v>0.30399999999999999</c:v>
                </c:pt>
                <c:pt idx="10">
                  <c:v>0.29360000000000003</c:v>
                </c:pt>
                <c:pt idx="11">
                  <c:v>0.2863</c:v>
                </c:pt>
                <c:pt idx="12">
                  <c:v>0.31259999999999999</c:v>
                </c:pt>
                <c:pt idx="13">
                  <c:v>0.33260000000000001</c:v>
                </c:pt>
                <c:pt idx="14">
                  <c:v>0.39269999999999999</c:v>
                </c:pt>
                <c:pt idx="15">
                  <c:v>0.40560000000000002</c:v>
                </c:pt>
                <c:pt idx="16">
                  <c:v>0.3468</c:v>
                </c:pt>
                <c:pt idx="17">
                  <c:v>0.32879999999999998</c:v>
                </c:pt>
                <c:pt idx="18">
                  <c:v>0.29959999999999998</c:v>
                </c:pt>
                <c:pt idx="19">
                  <c:v>0.30609999999999998</c:v>
                </c:pt>
                <c:pt idx="20">
                  <c:v>0.31869999999999998</c:v>
                </c:pt>
                <c:pt idx="21">
                  <c:v>0.29859999999999998</c:v>
                </c:pt>
                <c:pt idx="22">
                  <c:v>0.28110000000000002</c:v>
                </c:pt>
                <c:pt idx="23">
                  <c:v>0.3029</c:v>
                </c:pt>
                <c:pt idx="24">
                  <c:v>0.30919999999999997</c:v>
                </c:pt>
                <c:pt idx="25">
                  <c:v>0.28999999999999998</c:v>
                </c:pt>
                <c:pt idx="26">
                  <c:v>0.29060000000000002</c:v>
                </c:pt>
                <c:pt idx="27">
                  <c:v>0.3145</c:v>
                </c:pt>
                <c:pt idx="28">
                  <c:v>0.31900000000000001</c:v>
                </c:pt>
                <c:pt idx="29">
                  <c:v>0.30359999999999998</c:v>
                </c:pt>
                <c:pt idx="30">
                  <c:v>0.29270000000000002</c:v>
                </c:pt>
                <c:pt idx="31">
                  <c:v>0.30659999999999998</c:v>
                </c:pt>
                <c:pt idx="32">
                  <c:v>0.30049999999999999</c:v>
                </c:pt>
                <c:pt idx="33">
                  <c:v>0.32129999999999997</c:v>
                </c:pt>
                <c:pt idx="34">
                  <c:v>0.33110000000000001</c:v>
                </c:pt>
                <c:pt idx="35">
                  <c:v>0.32490000000000002</c:v>
                </c:pt>
                <c:pt idx="36">
                  <c:v>0.30070000000000002</c:v>
                </c:pt>
                <c:pt idx="37">
                  <c:v>0.29870000000000002</c:v>
                </c:pt>
                <c:pt idx="38">
                  <c:v>0.30830000000000002</c:v>
                </c:pt>
                <c:pt idx="39">
                  <c:v>0.28949999999999998</c:v>
                </c:pt>
                <c:pt idx="40">
                  <c:v>0.27139999999999997</c:v>
                </c:pt>
                <c:pt idx="41">
                  <c:v>0.29020000000000001</c:v>
                </c:pt>
                <c:pt idx="42">
                  <c:v>0.29470000000000002</c:v>
                </c:pt>
                <c:pt idx="43">
                  <c:v>0.26819999999999999</c:v>
                </c:pt>
                <c:pt idx="44">
                  <c:v>0.27110000000000001</c:v>
                </c:pt>
                <c:pt idx="45">
                  <c:v>0.29649999999999999</c:v>
                </c:pt>
                <c:pt idx="46">
                  <c:v>0.28260000000000002</c:v>
                </c:pt>
                <c:pt idx="47">
                  <c:v>0.25940000000000002</c:v>
                </c:pt>
                <c:pt idx="48">
                  <c:v>0.26669999999999999</c:v>
                </c:pt>
                <c:pt idx="49">
                  <c:v>0.27179999999999999</c:v>
                </c:pt>
                <c:pt idx="50">
                  <c:v>0.24929999999999999</c:v>
                </c:pt>
                <c:pt idx="51">
                  <c:v>0.24379999999999999</c:v>
                </c:pt>
                <c:pt idx="52">
                  <c:v>0.26079999999999998</c:v>
                </c:pt>
                <c:pt idx="53">
                  <c:v>0.25430000000000003</c:v>
                </c:pt>
                <c:pt idx="54">
                  <c:v>0.2361</c:v>
                </c:pt>
                <c:pt idx="55">
                  <c:v>0.24129999999999999</c:v>
                </c:pt>
                <c:pt idx="56">
                  <c:v>0.24110000000000001</c:v>
                </c:pt>
                <c:pt idx="57">
                  <c:v>0.22409999999999999</c:v>
                </c:pt>
                <c:pt idx="58">
                  <c:v>0.2157</c:v>
                </c:pt>
                <c:pt idx="59">
                  <c:v>0.2218</c:v>
                </c:pt>
                <c:pt idx="60">
                  <c:v>0.2316</c:v>
                </c:pt>
                <c:pt idx="61">
                  <c:v>0.24790000000000001</c:v>
                </c:pt>
                <c:pt idx="62">
                  <c:v>0.25600000000000001</c:v>
                </c:pt>
                <c:pt idx="63">
                  <c:v>0.26250000000000001</c:v>
                </c:pt>
                <c:pt idx="64">
                  <c:v>0.26529999999999998</c:v>
                </c:pt>
                <c:pt idx="65">
                  <c:v>0.2407</c:v>
                </c:pt>
                <c:pt idx="66">
                  <c:v>0.23449999999999999</c:v>
                </c:pt>
                <c:pt idx="67">
                  <c:v>0.25059999999999999</c:v>
                </c:pt>
                <c:pt idx="68">
                  <c:v>0.24160000000000001</c:v>
                </c:pt>
                <c:pt idx="69">
                  <c:v>0.2215</c:v>
                </c:pt>
                <c:pt idx="70">
                  <c:v>0.23100000000000001</c:v>
                </c:pt>
                <c:pt idx="71">
                  <c:v>0.24149999999999999</c:v>
                </c:pt>
                <c:pt idx="72">
                  <c:v>0.2243</c:v>
                </c:pt>
                <c:pt idx="73">
                  <c:v>0.21920000000000001</c:v>
                </c:pt>
                <c:pt idx="74">
                  <c:v>0.2349</c:v>
                </c:pt>
                <c:pt idx="75">
                  <c:v>0.23469999999999999</c:v>
                </c:pt>
                <c:pt idx="76">
                  <c:v>0.21729999999999999</c:v>
                </c:pt>
                <c:pt idx="77">
                  <c:v>0.2261</c:v>
                </c:pt>
                <c:pt idx="78">
                  <c:v>0.24440000000000001</c:v>
                </c:pt>
                <c:pt idx="79">
                  <c:v>0.2346</c:v>
                </c:pt>
                <c:pt idx="80">
                  <c:v>0.22539999999999999</c:v>
                </c:pt>
                <c:pt idx="81">
                  <c:v>0.24179999999999999</c:v>
                </c:pt>
                <c:pt idx="82">
                  <c:v>0.26450000000000001</c:v>
                </c:pt>
                <c:pt idx="83">
                  <c:v>0.312</c:v>
                </c:pt>
                <c:pt idx="84">
                  <c:v>0.40010000000000001</c:v>
                </c:pt>
                <c:pt idx="85">
                  <c:v>0.46639999999999998</c:v>
                </c:pt>
                <c:pt idx="86">
                  <c:v>0.58109999999999995</c:v>
                </c:pt>
                <c:pt idx="87">
                  <c:v>0.76849999999999996</c:v>
                </c:pt>
                <c:pt idx="88">
                  <c:v>0.93989999999999996</c:v>
                </c:pt>
                <c:pt idx="89">
                  <c:v>1.0947</c:v>
                </c:pt>
                <c:pt idx="90">
                  <c:v>1.0677000000000001</c:v>
                </c:pt>
                <c:pt idx="91">
                  <c:v>0.86050000000000004</c:v>
                </c:pt>
                <c:pt idx="92">
                  <c:v>0.72919999999999996</c:v>
                </c:pt>
                <c:pt idx="93">
                  <c:v>0.62860000000000005</c:v>
                </c:pt>
                <c:pt idx="94">
                  <c:v>0.5202</c:v>
                </c:pt>
                <c:pt idx="95">
                  <c:v>0.45700000000000002</c:v>
                </c:pt>
                <c:pt idx="96">
                  <c:v>0.3654</c:v>
                </c:pt>
                <c:pt idx="97">
                  <c:v>0.28320000000000001</c:v>
                </c:pt>
                <c:pt idx="98">
                  <c:v>0.2487</c:v>
                </c:pt>
                <c:pt idx="99">
                  <c:v>0.25559999999999999</c:v>
                </c:pt>
                <c:pt idx="100">
                  <c:v>0.23169999999999999</c:v>
                </c:pt>
                <c:pt idx="101">
                  <c:v>0.22620000000000001</c:v>
                </c:pt>
                <c:pt idx="102">
                  <c:v>0.25700000000000001</c:v>
                </c:pt>
                <c:pt idx="103">
                  <c:v>0.25269999999999998</c:v>
                </c:pt>
                <c:pt idx="104">
                  <c:v>0.22989999999999999</c:v>
                </c:pt>
                <c:pt idx="105">
                  <c:v>0.25290000000000001</c:v>
                </c:pt>
                <c:pt idx="106">
                  <c:v>0.27950000000000003</c:v>
                </c:pt>
                <c:pt idx="107">
                  <c:v>0.26179999999999998</c:v>
                </c:pt>
                <c:pt idx="108">
                  <c:v>0.252</c:v>
                </c:pt>
                <c:pt idx="109">
                  <c:v>0.224</c:v>
                </c:pt>
                <c:pt idx="110">
                  <c:v>0.21199999999999999</c:v>
                </c:pt>
                <c:pt idx="111">
                  <c:v>0.2054</c:v>
                </c:pt>
                <c:pt idx="112">
                  <c:v>0.188</c:v>
                </c:pt>
                <c:pt idx="113">
                  <c:v>0.19259999999999999</c:v>
                </c:pt>
                <c:pt idx="114">
                  <c:v>0.19800000000000001</c:v>
                </c:pt>
                <c:pt idx="115">
                  <c:v>0.1908</c:v>
                </c:pt>
                <c:pt idx="116">
                  <c:v>0.19139999999999999</c:v>
                </c:pt>
                <c:pt idx="117">
                  <c:v>0.19719999999999999</c:v>
                </c:pt>
                <c:pt idx="118">
                  <c:v>0.19850000000000001</c:v>
                </c:pt>
                <c:pt idx="119">
                  <c:v>0.20499999999999999</c:v>
                </c:pt>
                <c:pt idx="120">
                  <c:v>0.20799999999999999</c:v>
                </c:pt>
                <c:pt idx="121">
                  <c:v>0.21329999999999999</c:v>
                </c:pt>
                <c:pt idx="122">
                  <c:v>0.2145</c:v>
                </c:pt>
                <c:pt idx="123">
                  <c:v>0.2263</c:v>
                </c:pt>
                <c:pt idx="124">
                  <c:v>0.2399</c:v>
                </c:pt>
                <c:pt idx="125">
                  <c:v>0.23899999999999999</c:v>
                </c:pt>
                <c:pt idx="126">
                  <c:v>0.2387</c:v>
                </c:pt>
                <c:pt idx="127">
                  <c:v>0.2606</c:v>
                </c:pt>
                <c:pt idx="128">
                  <c:v>0.26479999999999998</c:v>
                </c:pt>
                <c:pt idx="129">
                  <c:v>0.25180000000000002</c:v>
                </c:pt>
                <c:pt idx="130">
                  <c:v>0.26069999999999999</c:v>
                </c:pt>
                <c:pt idx="131">
                  <c:v>0.28249999999999997</c:v>
                </c:pt>
                <c:pt idx="132">
                  <c:v>0.28120000000000001</c:v>
                </c:pt>
                <c:pt idx="133">
                  <c:v>0.26929999999999998</c:v>
                </c:pt>
                <c:pt idx="134">
                  <c:v>0.2752</c:v>
                </c:pt>
                <c:pt idx="135">
                  <c:v>0.27089999999999997</c:v>
                </c:pt>
                <c:pt idx="136">
                  <c:v>0.25459999999999999</c:v>
                </c:pt>
                <c:pt idx="137">
                  <c:v>0.2324</c:v>
                </c:pt>
                <c:pt idx="138">
                  <c:v>0.2155</c:v>
                </c:pt>
                <c:pt idx="139">
                  <c:v>0.2238</c:v>
                </c:pt>
                <c:pt idx="140">
                  <c:v>0.22459999999999999</c:v>
                </c:pt>
                <c:pt idx="141">
                  <c:v>0.2069</c:v>
                </c:pt>
                <c:pt idx="142">
                  <c:v>0.2026</c:v>
                </c:pt>
                <c:pt idx="143">
                  <c:v>0.18579999999999999</c:v>
                </c:pt>
                <c:pt idx="144">
                  <c:v>0.17599999999999999</c:v>
                </c:pt>
                <c:pt idx="145">
                  <c:v>0.17649999999999999</c:v>
                </c:pt>
                <c:pt idx="146">
                  <c:v>0.1777</c:v>
                </c:pt>
                <c:pt idx="147">
                  <c:v>0.1706</c:v>
                </c:pt>
                <c:pt idx="148">
                  <c:v>0.1651</c:v>
                </c:pt>
                <c:pt idx="149">
                  <c:v>0.16930000000000001</c:v>
                </c:pt>
                <c:pt idx="150">
                  <c:v>0.1729</c:v>
                </c:pt>
                <c:pt idx="151">
                  <c:v>0.17</c:v>
                </c:pt>
                <c:pt idx="152">
                  <c:v>0.16769999999999999</c:v>
                </c:pt>
                <c:pt idx="153">
                  <c:v>0.17469999999999999</c:v>
                </c:pt>
                <c:pt idx="154">
                  <c:v>0.1777</c:v>
                </c:pt>
                <c:pt idx="155">
                  <c:v>0.1724</c:v>
                </c:pt>
                <c:pt idx="156">
                  <c:v>0.1744</c:v>
                </c:pt>
                <c:pt idx="157">
                  <c:v>0.1799</c:v>
                </c:pt>
                <c:pt idx="158">
                  <c:v>0.1802</c:v>
                </c:pt>
                <c:pt idx="159">
                  <c:v>0.18060000000000001</c:v>
                </c:pt>
                <c:pt idx="160">
                  <c:v>0.1835</c:v>
                </c:pt>
                <c:pt idx="161">
                  <c:v>0.1905</c:v>
                </c:pt>
                <c:pt idx="162">
                  <c:v>0.19520000000000001</c:v>
                </c:pt>
                <c:pt idx="163">
                  <c:v>0.1966</c:v>
                </c:pt>
                <c:pt idx="164">
                  <c:v>0.19989999999999999</c:v>
                </c:pt>
                <c:pt idx="165">
                  <c:v>0.20960000000000001</c:v>
                </c:pt>
                <c:pt idx="166">
                  <c:v>0.21529999999999999</c:v>
                </c:pt>
                <c:pt idx="167">
                  <c:v>0.2165</c:v>
                </c:pt>
                <c:pt idx="168">
                  <c:v>0.22009999999999999</c:v>
                </c:pt>
                <c:pt idx="169">
                  <c:v>0.22889999999999999</c:v>
                </c:pt>
                <c:pt idx="170">
                  <c:v>0.23649999999999999</c:v>
                </c:pt>
                <c:pt idx="171">
                  <c:v>0.23780000000000001</c:v>
                </c:pt>
                <c:pt idx="172">
                  <c:v>0.31609999999999999</c:v>
                </c:pt>
                <c:pt idx="173">
                  <c:v>0.4395</c:v>
                </c:pt>
                <c:pt idx="174">
                  <c:v>0.5665</c:v>
                </c:pt>
                <c:pt idx="175">
                  <c:v>0.70179999999999998</c:v>
                </c:pt>
                <c:pt idx="176">
                  <c:v>0.73450000000000004</c:v>
                </c:pt>
                <c:pt idx="177">
                  <c:v>0.59240000000000004</c:v>
                </c:pt>
                <c:pt idx="178">
                  <c:v>0.48649999999999999</c:v>
                </c:pt>
                <c:pt idx="179">
                  <c:v>0.37480000000000002</c:v>
                </c:pt>
                <c:pt idx="180">
                  <c:v>0.31630000000000003</c:v>
                </c:pt>
                <c:pt idx="181">
                  <c:v>0.30790000000000001</c:v>
                </c:pt>
                <c:pt idx="182">
                  <c:v>0.27989999999999998</c:v>
                </c:pt>
                <c:pt idx="183">
                  <c:v>0.26229999999999998</c:v>
                </c:pt>
                <c:pt idx="184">
                  <c:v>0.26569999999999999</c:v>
                </c:pt>
                <c:pt idx="185">
                  <c:v>0.25440000000000002</c:v>
                </c:pt>
                <c:pt idx="186">
                  <c:v>0.23580000000000001</c:v>
                </c:pt>
                <c:pt idx="187">
                  <c:v>0.23469999999999999</c:v>
                </c:pt>
                <c:pt idx="188">
                  <c:v>0.2339</c:v>
                </c:pt>
                <c:pt idx="189">
                  <c:v>0.22090000000000001</c:v>
                </c:pt>
                <c:pt idx="190">
                  <c:v>0.20930000000000001</c:v>
                </c:pt>
                <c:pt idx="191">
                  <c:v>0.2132</c:v>
                </c:pt>
                <c:pt idx="192">
                  <c:v>0.215</c:v>
                </c:pt>
                <c:pt idx="193">
                  <c:v>0.20169999999999999</c:v>
                </c:pt>
                <c:pt idx="194">
                  <c:v>0.19139999999999999</c:v>
                </c:pt>
                <c:pt idx="195">
                  <c:v>0.20280000000000001</c:v>
                </c:pt>
                <c:pt idx="196">
                  <c:v>0.20549999999999999</c:v>
                </c:pt>
                <c:pt idx="197">
                  <c:v>0.19309999999999999</c:v>
                </c:pt>
                <c:pt idx="198">
                  <c:v>0.1943</c:v>
                </c:pt>
                <c:pt idx="199">
                  <c:v>0.20430000000000001</c:v>
                </c:pt>
                <c:pt idx="200">
                  <c:v>0.2079</c:v>
                </c:pt>
                <c:pt idx="201">
                  <c:v>0.1993</c:v>
                </c:pt>
                <c:pt idx="202">
                  <c:v>0.20899999999999999</c:v>
                </c:pt>
                <c:pt idx="203">
                  <c:v>0.22020000000000001</c:v>
                </c:pt>
                <c:pt idx="204">
                  <c:v>0.21329999999999999</c:v>
                </c:pt>
                <c:pt idx="205">
                  <c:v>0.19719999999999999</c:v>
                </c:pt>
                <c:pt idx="206">
                  <c:v>0.22489999999999999</c:v>
                </c:pt>
                <c:pt idx="207">
                  <c:v>0.2056</c:v>
                </c:pt>
                <c:pt idx="208">
                  <c:v>0.1966</c:v>
                </c:pt>
                <c:pt idx="209">
                  <c:v>0.18029999999999999</c:v>
                </c:pt>
                <c:pt idx="210">
                  <c:v>0.1767</c:v>
                </c:pt>
                <c:pt idx="211">
                  <c:v>0.17419999999999999</c:v>
                </c:pt>
                <c:pt idx="212">
                  <c:v>0.1794</c:v>
                </c:pt>
                <c:pt idx="213">
                  <c:v>0.1827</c:v>
                </c:pt>
                <c:pt idx="214">
                  <c:v>0.17780000000000001</c:v>
                </c:pt>
                <c:pt idx="215">
                  <c:v>0.1767</c:v>
                </c:pt>
                <c:pt idx="216">
                  <c:v>0.18529999999999999</c:v>
                </c:pt>
                <c:pt idx="217">
                  <c:v>0.18729999999999999</c:v>
                </c:pt>
                <c:pt idx="218">
                  <c:v>0.18149999999999999</c:v>
                </c:pt>
                <c:pt idx="219">
                  <c:v>0.18720000000000001</c:v>
                </c:pt>
                <c:pt idx="220">
                  <c:v>0.1933</c:v>
                </c:pt>
                <c:pt idx="221">
                  <c:v>0.19400000000000001</c:v>
                </c:pt>
                <c:pt idx="222">
                  <c:v>0.19589999999999999</c:v>
                </c:pt>
                <c:pt idx="223">
                  <c:v>0.20380000000000001</c:v>
                </c:pt>
                <c:pt idx="224">
                  <c:v>0.21429999999999999</c:v>
                </c:pt>
                <c:pt idx="225">
                  <c:v>0.21560000000000001</c:v>
                </c:pt>
                <c:pt idx="226">
                  <c:v>0.21609999999999999</c:v>
                </c:pt>
                <c:pt idx="227">
                  <c:v>0.2306</c:v>
                </c:pt>
                <c:pt idx="228">
                  <c:v>0.23469999999999999</c:v>
                </c:pt>
                <c:pt idx="229">
                  <c:v>0.23130000000000001</c:v>
                </c:pt>
                <c:pt idx="230">
                  <c:v>0.24540000000000001</c:v>
                </c:pt>
                <c:pt idx="231">
                  <c:v>0.25269999999999998</c:v>
                </c:pt>
                <c:pt idx="232">
                  <c:v>0.26150000000000001</c:v>
                </c:pt>
                <c:pt idx="233">
                  <c:v>0.2442</c:v>
                </c:pt>
                <c:pt idx="234">
                  <c:v>0.23680000000000001</c:v>
                </c:pt>
                <c:pt idx="235">
                  <c:v>0.23599999999999999</c:v>
                </c:pt>
                <c:pt idx="236">
                  <c:v>0.23499999999999999</c:v>
                </c:pt>
                <c:pt idx="237">
                  <c:v>0.25540000000000002</c:v>
                </c:pt>
                <c:pt idx="238">
                  <c:v>0.2656</c:v>
                </c:pt>
                <c:pt idx="239">
                  <c:v>0.27760000000000001</c:v>
                </c:pt>
                <c:pt idx="240">
                  <c:v>0.2707</c:v>
                </c:pt>
                <c:pt idx="241">
                  <c:v>0.2666</c:v>
                </c:pt>
                <c:pt idx="242">
                  <c:v>0.27510000000000001</c:v>
                </c:pt>
                <c:pt idx="243">
                  <c:v>0.24540000000000001</c:v>
                </c:pt>
                <c:pt idx="244">
                  <c:v>0.23100000000000001</c:v>
                </c:pt>
                <c:pt idx="245">
                  <c:v>0.2379</c:v>
                </c:pt>
                <c:pt idx="246">
                  <c:v>0.2571</c:v>
                </c:pt>
                <c:pt idx="247">
                  <c:v>0.30719999999999997</c:v>
                </c:pt>
                <c:pt idx="248">
                  <c:v>0.36720000000000003</c:v>
                </c:pt>
                <c:pt idx="249">
                  <c:v>0.3755</c:v>
                </c:pt>
                <c:pt idx="250">
                  <c:v>0.37080000000000002</c:v>
                </c:pt>
                <c:pt idx="251">
                  <c:v>0.2747</c:v>
                </c:pt>
                <c:pt idx="252">
                  <c:v>0.2422</c:v>
                </c:pt>
                <c:pt idx="253">
                  <c:v>0.23369999999999999</c:v>
                </c:pt>
                <c:pt idx="254">
                  <c:v>0.21870000000000001</c:v>
                </c:pt>
                <c:pt idx="255">
                  <c:v>0.21260000000000001</c:v>
                </c:pt>
                <c:pt idx="256">
                  <c:v>0.21790000000000001</c:v>
                </c:pt>
                <c:pt idx="257">
                  <c:v>0.21190000000000001</c:v>
                </c:pt>
                <c:pt idx="258">
                  <c:v>0.19889999999999999</c:v>
                </c:pt>
                <c:pt idx="259">
                  <c:v>0.1981</c:v>
                </c:pt>
                <c:pt idx="260">
                  <c:v>0.21029999999999999</c:v>
                </c:pt>
                <c:pt idx="261">
                  <c:v>0.2051</c:v>
                </c:pt>
                <c:pt idx="262">
                  <c:v>0.18859999999999999</c:v>
                </c:pt>
                <c:pt idx="263">
                  <c:v>0.192</c:v>
                </c:pt>
                <c:pt idx="264">
                  <c:v>0.19170000000000001</c:v>
                </c:pt>
                <c:pt idx="265">
                  <c:v>0.20760000000000001</c:v>
                </c:pt>
                <c:pt idx="266">
                  <c:v>0.214</c:v>
                </c:pt>
                <c:pt idx="267">
                  <c:v>0.22850000000000001</c:v>
                </c:pt>
                <c:pt idx="268">
                  <c:v>0.2233</c:v>
                </c:pt>
                <c:pt idx="269">
                  <c:v>0.20979999999999999</c:v>
                </c:pt>
                <c:pt idx="270">
                  <c:v>0.21679999999999999</c:v>
                </c:pt>
                <c:pt idx="271">
                  <c:v>0.21929999999999999</c:v>
                </c:pt>
                <c:pt idx="272">
                  <c:v>0.20810000000000001</c:v>
                </c:pt>
                <c:pt idx="273">
                  <c:v>0.21290000000000001</c:v>
                </c:pt>
                <c:pt idx="274">
                  <c:v>0.2271</c:v>
                </c:pt>
                <c:pt idx="275">
                  <c:v>0.2228</c:v>
                </c:pt>
                <c:pt idx="276">
                  <c:v>0.21759999999999999</c:v>
                </c:pt>
                <c:pt idx="277">
                  <c:v>0.23080000000000001</c:v>
                </c:pt>
                <c:pt idx="278">
                  <c:v>0.23930000000000001</c:v>
                </c:pt>
                <c:pt idx="279">
                  <c:v>0.23300000000000001</c:v>
                </c:pt>
                <c:pt idx="280">
                  <c:v>0.23810000000000001</c:v>
                </c:pt>
                <c:pt idx="281">
                  <c:v>0.25519999999999998</c:v>
                </c:pt>
                <c:pt idx="282">
                  <c:v>0.2586</c:v>
                </c:pt>
                <c:pt idx="283">
                  <c:v>0.25140000000000001</c:v>
                </c:pt>
                <c:pt idx="284">
                  <c:v>0.25019999999999998</c:v>
                </c:pt>
                <c:pt idx="285">
                  <c:v>0.26900000000000002</c:v>
                </c:pt>
                <c:pt idx="286">
                  <c:v>0.26829999999999998</c:v>
                </c:pt>
                <c:pt idx="287">
                  <c:v>0.28110000000000002</c:v>
                </c:pt>
                <c:pt idx="288">
                  <c:v>0.28270000000000001</c:v>
                </c:pt>
                <c:pt idx="289">
                  <c:v>0.29920000000000002</c:v>
                </c:pt>
                <c:pt idx="290">
                  <c:v>0.32890000000000003</c:v>
                </c:pt>
                <c:pt idx="291">
                  <c:v>0.31640000000000001</c:v>
                </c:pt>
                <c:pt idx="292">
                  <c:v>0.33760000000000001</c:v>
                </c:pt>
                <c:pt idx="293">
                  <c:v>0.35830000000000001</c:v>
                </c:pt>
                <c:pt idx="294">
                  <c:v>0.34460000000000002</c:v>
                </c:pt>
                <c:pt idx="295">
                  <c:v>0.37490000000000001</c:v>
                </c:pt>
                <c:pt idx="296">
                  <c:v>0.33300000000000002</c:v>
                </c:pt>
                <c:pt idx="297">
                  <c:v>0.33079999999999998</c:v>
                </c:pt>
                <c:pt idx="298">
                  <c:v>0.28449999999999998</c:v>
                </c:pt>
                <c:pt idx="299">
                  <c:v>0.2717</c:v>
                </c:pt>
                <c:pt idx="300">
                  <c:v>0.27550000000000002</c:v>
                </c:pt>
                <c:pt idx="301">
                  <c:v>0.26979999999999998</c:v>
                </c:pt>
                <c:pt idx="302">
                  <c:v>0.24660000000000001</c:v>
                </c:pt>
                <c:pt idx="303">
                  <c:v>0.2651</c:v>
                </c:pt>
                <c:pt idx="304">
                  <c:v>0.26989999999999997</c:v>
                </c:pt>
                <c:pt idx="305">
                  <c:v>0.27339999999999998</c:v>
                </c:pt>
                <c:pt idx="306">
                  <c:v>0.26119999999999999</c:v>
                </c:pt>
                <c:pt idx="307">
                  <c:v>0.24929999999999999</c:v>
                </c:pt>
                <c:pt idx="308">
                  <c:v>0.24690000000000001</c:v>
                </c:pt>
                <c:pt idx="309">
                  <c:v>0.25069999999999998</c:v>
                </c:pt>
                <c:pt idx="310">
                  <c:v>0.25879999999999997</c:v>
                </c:pt>
                <c:pt idx="311">
                  <c:v>0.27789999999999998</c:v>
                </c:pt>
                <c:pt idx="312">
                  <c:v>0.27800000000000002</c:v>
                </c:pt>
                <c:pt idx="313">
                  <c:v>0.25169999999999998</c:v>
                </c:pt>
                <c:pt idx="314">
                  <c:v>0.2429</c:v>
                </c:pt>
                <c:pt idx="315">
                  <c:v>0.26640000000000003</c:v>
                </c:pt>
                <c:pt idx="316">
                  <c:v>0.27129999999999999</c:v>
                </c:pt>
                <c:pt idx="317">
                  <c:v>0.27910000000000001</c:v>
                </c:pt>
                <c:pt idx="318">
                  <c:v>0.26450000000000001</c:v>
                </c:pt>
                <c:pt idx="319">
                  <c:v>0.24740000000000001</c:v>
                </c:pt>
                <c:pt idx="320">
                  <c:v>0.26369999999999999</c:v>
                </c:pt>
                <c:pt idx="321">
                  <c:v>0.26869999999999999</c:v>
                </c:pt>
                <c:pt idx="322">
                  <c:v>0.24440000000000001</c:v>
                </c:pt>
                <c:pt idx="323">
                  <c:v>0.2392</c:v>
                </c:pt>
                <c:pt idx="324">
                  <c:v>0.26029999999999998</c:v>
                </c:pt>
                <c:pt idx="325">
                  <c:v>0.25600000000000001</c:v>
                </c:pt>
                <c:pt idx="326">
                  <c:v>0.23330000000000001</c:v>
                </c:pt>
                <c:pt idx="327">
                  <c:v>0.24210000000000001</c:v>
                </c:pt>
                <c:pt idx="328">
                  <c:v>0.26519999999999999</c:v>
                </c:pt>
                <c:pt idx="329">
                  <c:v>0.25340000000000001</c:v>
                </c:pt>
                <c:pt idx="330">
                  <c:v>0.24360000000000001</c:v>
                </c:pt>
                <c:pt idx="331">
                  <c:v>0.26629999999999998</c:v>
                </c:pt>
                <c:pt idx="332">
                  <c:v>0.28050000000000003</c:v>
                </c:pt>
                <c:pt idx="333">
                  <c:v>0.2676</c:v>
                </c:pt>
                <c:pt idx="334">
                  <c:v>0.27179999999999999</c:v>
                </c:pt>
                <c:pt idx="335">
                  <c:v>0.25190000000000001</c:v>
                </c:pt>
                <c:pt idx="336">
                  <c:v>0.2356</c:v>
                </c:pt>
                <c:pt idx="337">
                  <c:v>0.21129999999999999</c:v>
                </c:pt>
                <c:pt idx="338">
                  <c:v>0.20280000000000001</c:v>
                </c:pt>
                <c:pt idx="339">
                  <c:v>0.1867</c:v>
                </c:pt>
                <c:pt idx="340">
                  <c:v>0.1966</c:v>
                </c:pt>
                <c:pt idx="341">
                  <c:v>0.1946</c:v>
                </c:pt>
                <c:pt idx="342">
                  <c:v>0.20200000000000001</c:v>
                </c:pt>
                <c:pt idx="343">
                  <c:v>0.2175</c:v>
                </c:pt>
                <c:pt idx="344">
                  <c:v>0.2263</c:v>
                </c:pt>
                <c:pt idx="345">
                  <c:v>0.24690000000000001</c:v>
                </c:pt>
                <c:pt idx="346">
                  <c:v>0.28149999999999997</c:v>
                </c:pt>
                <c:pt idx="347">
                  <c:v>0.25330000000000003</c:v>
                </c:pt>
                <c:pt idx="348">
                  <c:v>0.2445</c:v>
                </c:pt>
                <c:pt idx="349">
                  <c:v>0.2175</c:v>
                </c:pt>
                <c:pt idx="350">
                  <c:v>0.21759999999999999</c:v>
                </c:pt>
                <c:pt idx="351">
                  <c:v>0.24079999999999999</c:v>
                </c:pt>
                <c:pt idx="352">
                  <c:v>0.2442</c:v>
                </c:pt>
                <c:pt idx="353">
                  <c:v>0.23649999999999999</c:v>
                </c:pt>
                <c:pt idx="354">
                  <c:v>0.21690000000000001</c:v>
                </c:pt>
                <c:pt idx="355">
                  <c:v>0.19059999999999999</c:v>
                </c:pt>
                <c:pt idx="356">
                  <c:v>0.18779999999999999</c:v>
                </c:pt>
                <c:pt idx="357">
                  <c:v>0.25950000000000001</c:v>
                </c:pt>
                <c:pt idx="358">
                  <c:v>0.30070000000000002</c:v>
                </c:pt>
                <c:pt idx="359">
                  <c:v>0.23710000000000001</c:v>
                </c:pt>
                <c:pt idx="360">
                  <c:v>0.18</c:v>
                </c:pt>
                <c:pt idx="361">
                  <c:v>0.17299999999999999</c:v>
                </c:pt>
                <c:pt idx="362">
                  <c:v>0.19570000000000001</c:v>
                </c:pt>
                <c:pt idx="363">
                  <c:v>0.23269999999999999</c:v>
                </c:pt>
                <c:pt idx="364">
                  <c:v>0.21079999999999999</c:v>
                </c:pt>
                <c:pt idx="365">
                  <c:v>0.2319</c:v>
                </c:pt>
                <c:pt idx="366">
                  <c:v>0.25259999999999999</c:v>
                </c:pt>
                <c:pt idx="367">
                  <c:v>0.26269999999999999</c:v>
                </c:pt>
                <c:pt idx="368">
                  <c:v>0.39069999999999999</c:v>
                </c:pt>
                <c:pt idx="369">
                  <c:v>0.44</c:v>
                </c:pt>
                <c:pt idx="370">
                  <c:v>0.44330000000000003</c:v>
                </c:pt>
                <c:pt idx="371">
                  <c:v>0.4229</c:v>
                </c:pt>
                <c:pt idx="372">
                  <c:v>0.40189999999999998</c:v>
                </c:pt>
                <c:pt idx="373">
                  <c:v>0.37590000000000001</c:v>
                </c:pt>
                <c:pt idx="374">
                  <c:v>0.3846</c:v>
                </c:pt>
                <c:pt idx="375">
                  <c:v>0.35599999999999998</c:v>
                </c:pt>
                <c:pt idx="376">
                  <c:v>0.3352</c:v>
                </c:pt>
                <c:pt idx="377">
                  <c:v>0.3362</c:v>
                </c:pt>
                <c:pt idx="378">
                  <c:v>0.4501</c:v>
                </c:pt>
                <c:pt idx="379">
                  <c:v>0.36870000000000003</c:v>
                </c:pt>
                <c:pt idx="380">
                  <c:v>0.35149999999999998</c:v>
                </c:pt>
                <c:pt idx="381">
                  <c:v>0.33860000000000001</c:v>
                </c:pt>
                <c:pt idx="382">
                  <c:v>0.34210000000000002</c:v>
                </c:pt>
                <c:pt idx="383">
                  <c:v>0.34470000000000001</c:v>
                </c:pt>
                <c:pt idx="384">
                  <c:v>0.33750000000000002</c:v>
                </c:pt>
                <c:pt idx="385">
                  <c:v>0.35010000000000002</c:v>
                </c:pt>
                <c:pt idx="386">
                  <c:v>0.39140000000000003</c:v>
                </c:pt>
                <c:pt idx="387">
                  <c:v>0.44879999999999998</c:v>
                </c:pt>
                <c:pt idx="388">
                  <c:v>0.53759999999999997</c:v>
                </c:pt>
                <c:pt idx="389">
                  <c:v>0.65410000000000001</c:v>
                </c:pt>
                <c:pt idx="390">
                  <c:v>0.67110000000000003</c:v>
                </c:pt>
                <c:pt idx="391">
                  <c:v>0.66659999999999997</c:v>
                </c:pt>
                <c:pt idx="392">
                  <c:v>0.70120000000000005</c:v>
                </c:pt>
                <c:pt idx="393">
                  <c:v>0.67710000000000004</c:v>
                </c:pt>
                <c:pt idx="394">
                  <c:v>0.77329999999999999</c:v>
                </c:pt>
                <c:pt idx="395">
                  <c:v>0.80279999999999996</c:v>
                </c:pt>
                <c:pt idx="396">
                  <c:v>0.76160000000000005</c:v>
                </c:pt>
                <c:pt idx="397">
                  <c:v>0.7923</c:v>
                </c:pt>
                <c:pt idx="398">
                  <c:v>0.77100000000000002</c:v>
                </c:pt>
                <c:pt idx="399">
                  <c:v>0.67410000000000003</c:v>
                </c:pt>
                <c:pt idx="400">
                  <c:v>0.45779999999999998</c:v>
                </c:pt>
                <c:pt idx="401">
                  <c:v>0.34150000000000003</c:v>
                </c:pt>
                <c:pt idx="402">
                  <c:v>0.29709999999999998</c:v>
                </c:pt>
                <c:pt idx="403">
                  <c:v>0.29120000000000001</c:v>
                </c:pt>
                <c:pt idx="404">
                  <c:v>0.23630000000000001</c:v>
                </c:pt>
                <c:pt idx="405">
                  <c:v>0.20399999999999999</c:v>
                </c:pt>
                <c:pt idx="406">
                  <c:v>0.17949999999999999</c:v>
                </c:pt>
                <c:pt idx="407">
                  <c:v>0.1774</c:v>
                </c:pt>
                <c:pt idx="408">
                  <c:v>0.18340000000000001</c:v>
                </c:pt>
                <c:pt idx="409">
                  <c:v>0.18110000000000001</c:v>
                </c:pt>
                <c:pt idx="410">
                  <c:v>0.17299999999999999</c:v>
                </c:pt>
                <c:pt idx="411">
                  <c:v>0.17910000000000001</c:v>
                </c:pt>
                <c:pt idx="412">
                  <c:v>0.19189999999999999</c:v>
                </c:pt>
                <c:pt idx="413">
                  <c:v>0.1812</c:v>
                </c:pt>
                <c:pt idx="414">
                  <c:v>0.1769</c:v>
                </c:pt>
                <c:pt idx="415">
                  <c:v>0.18790000000000001</c:v>
                </c:pt>
                <c:pt idx="416">
                  <c:v>0.18609999999999999</c:v>
                </c:pt>
                <c:pt idx="417">
                  <c:v>0.1787</c:v>
                </c:pt>
                <c:pt idx="418">
                  <c:v>0.19009999999999999</c:v>
                </c:pt>
                <c:pt idx="419">
                  <c:v>0.20219999999999999</c:v>
                </c:pt>
                <c:pt idx="420">
                  <c:v>0.19550000000000001</c:v>
                </c:pt>
                <c:pt idx="421">
                  <c:v>0.1855</c:v>
                </c:pt>
                <c:pt idx="422">
                  <c:v>0.193</c:v>
                </c:pt>
                <c:pt idx="423">
                  <c:v>0.20699999999999999</c:v>
                </c:pt>
                <c:pt idx="424">
                  <c:v>0.2034</c:v>
                </c:pt>
                <c:pt idx="425">
                  <c:v>0.2142</c:v>
                </c:pt>
                <c:pt idx="426">
                  <c:v>0.21249999999999999</c:v>
                </c:pt>
                <c:pt idx="427">
                  <c:v>0.2142</c:v>
                </c:pt>
                <c:pt idx="428">
                  <c:v>0.20930000000000001</c:v>
                </c:pt>
                <c:pt idx="429">
                  <c:v>0.21759999999999999</c:v>
                </c:pt>
                <c:pt idx="430">
                  <c:v>0.2316</c:v>
                </c:pt>
                <c:pt idx="431">
                  <c:v>0.2263</c:v>
                </c:pt>
                <c:pt idx="432">
                  <c:v>0.21129999999999999</c:v>
                </c:pt>
                <c:pt idx="433">
                  <c:v>0.21990000000000001</c:v>
                </c:pt>
                <c:pt idx="434">
                  <c:v>0.22720000000000001</c:v>
                </c:pt>
                <c:pt idx="435">
                  <c:v>0.2172</c:v>
                </c:pt>
                <c:pt idx="436">
                  <c:v>0.21790000000000001</c:v>
                </c:pt>
                <c:pt idx="437">
                  <c:v>0.23430000000000001</c:v>
                </c:pt>
                <c:pt idx="438">
                  <c:v>0.23710000000000001</c:v>
                </c:pt>
                <c:pt idx="439">
                  <c:v>0.24010000000000001</c:v>
                </c:pt>
                <c:pt idx="440">
                  <c:v>0.28010000000000002</c:v>
                </c:pt>
                <c:pt idx="441">
                  <c:v>0.27579999999999999</c:v>
                </c:pt>
                <c:pt idx="442">
                  <c:v>0.25290000000000001</c:v>
                </c:pt>
                <c:pt idx="443">
                  <c:v>0.2349</c:v>
                </c:pt>
                <c:pt idx="444">
                  <c:v>0.2361</c:v>
                </c:pt>
                <c:pt idx="445">
                  <c:v>0.24149999999999999</c:v>
                </c:pt>
                <c:pt idx="446">
                  <c:v>0.2266</c:v>
                </c:pt>
                <c:pt idx="447">
                  <c:v>0.2099</c:v>
                </c:pt>
                <c:pt idx="448">
                  <c:v>0.21210000000000001</c:v>
                </c:pt>
                <c:pt idx="449">
                  <c:v>0.21060000000000001</c:v>
                </c:pt>
                <c:pt idx="450">
                  <c:v>0.2006</c:v>
                </c:pt>
                <c:pt idx="451">
                  <c:v>0.1958</c:v>
                </c:pt>
                <c:pt idx="452">
                  <c:v>0.1993</c:v>
                </c:pt>
                <c:pt idx="453">
                  <c:v>0.19620000000000001</c:v>
                </c:pt>
                <c:pt idx="454">
                  <c:v>0.182</c:v>
                </c:pt>
                <c:pt idx="455">
                  <c:v>0.18310000000000001</c:v>
                </c:pt>
                <c:pt idx="456">
                  <c:v>0.19059999999999999</c:v>
                </c:pt>
                <c:pt idx="457">
                  <c:v>0.18590000000000001</c:v>
                </c:pt>
                <c:pt idx="458">
                  <c:v>0.17860000000000001</c:v>
                </c:pt>
                <c:pt idx="459">
                  <c:v>0.19189999999999999</c:v>
                </c:pt>
                <c:pt idx="460">
                  <c:v>0.2266</c:v>
                </c:pt>
                <c:pt idx="461">
                  <c:v>0.222</c:v>
                </c:pt>
                <c:pt idx="462">
                  <c:v>0.21279999999999999</c:v>
                </c:pt>
                <c:pt idx="463">
                  <c:v>0.23730000000000001</c:v>
                </c:pt>
                <c:pt idx="464">
                  <c:v>0.29930000000000001</c:v>
                </c:pt>
                <c:pt idx="465">
                  <c:v>0.37490000000000001</c:v>
                </c:pt>
                <c:pt idx="466">
                  <c:v>0.45019999999999999</c:v>
                </c:pt>
                <c:pt idx="467">
                  <c:v>0.49530000000000002</c:v>
                </c:pt>
                <c:pt idx="468">
                  <c:v>0.50190000000000001</c:v>
                </c:pt>
                <c:pt idx="469">
                  <c:v>0.4617</c:v>
                </c:pt>
                <c:pt idx="470">
                  <c:v>0.50670000000000004</c:v>
                </c:pt>
                <c:pt idx="471">
                  <c:v>0.50790000000000002</c:v>
                </c:pt>
                <c:pt idx="472">
                  <c:v>0.4698</c:v>
                </c:pt>
                <c:pt idx="473">
                  <c:v>0.42059999999999997</c:v>
                </c:pt>
                <c:pt idx="474">
                  <c:v>0.30680000000000002</c:v>
                </c:pt>
                <c:pt idx="475">
                  <c:v>0.27260000000000001</c:v>
                </c:pt>
                <c:pt idx="476">
                  <c:v>0.26700000000000002</c:v>
                </c:pt>
                <c:pt idx="477">
                  <c:v>0.24579999999999999</c:v>
                </c:pt>
                <c:pt idx="478">
                  <c:v>0.23230000000000001</c:v>
                </c:pt>
                <c:pt idx="479">
                  <c:v>0.23230000000000001</c:v>
                </c:pt>
                <c:pt idx="480">
                  <c:v>0.21299999999999999</c:v>
                </c:pt>
                <c:pt idx="481">
                  <c:v>0.20150000000000001</c:v>
                </c:pt>
                <c:pt idx="482">
                  <c:v>0.21129999999999999</c:v>
                </c:pt>
                <c:pt idx="483">
                  <c:v>0.2049</c:v>
                </c:pt>
                <c:pt idx="484">
                  <c:v>0.18609999999999999</c:v>
                </c:pt>
                <c:pt idx="485">
                  <c:v>0.1925</c:v>
                </c:pt>
                <c:pt idx="486">
                  <c:v>0.20050000000000001</c:v>
                </c:pt>
                <c:pt idx="487">
                  <c:v>0.19170000000000001</c:v>
                </c:pt>
                <c:pt idx="488">
                  <c:v>0.1857</c:v>
                </c:pt>
                <c:pt idx="489">
                  <c:v>0.19389999999999999</c:v>
                </c:pt>
                <c:pt idx="490">
                  <c:v>0.18149999999999999</c:v>
                </c:pt>
                <c:pt idx="491">
                  <c:v>0.17680000000000001</c:v>
                </c:pt>
                <c:pt idx="492">
                  <c:v>0.18559999999999999</c:v>
                </c:pt>
                <c:pt idx="493">
                  <c:v>0.18759999999999999</c:v>
                </c:pt>
                <c:pt idx="494">
                  <c:v>0.17660000000000001</c:v>
                </c:pt>
                <c:pt idx="495">
                  <c:v>0.17660000000000001</c:v>
                </c:pt>
                <c:pt idx="496">
                  <c:v>0.18820000000000001</c:v>
                </c:pt>
                <c:pt idx="497">
                  <c:v>0.1862</c:v>
                </c:pt>
                <c:pt idx="498">
                  <c:v>0.17630000000000001</c:v>
                </c:pt>
                <c:pt idx="499">
                  <c:v>0.18390000000000001</c:v>
                </c:pt>
                <c:pt idx="500">
                  <c:v>0.19489999999999999</c:v>
                </c:pt>
                <c:pt idx="501">
                  <c:v>0.19040000000000001</c:v>
                </c:pt>
                <c:pt idx="502">
                  <c:v>0.18529999999999999</c:v>
                </c:pt>
                <c:pt idx="503">
                  <c:v>0.19489999999999999</c:v>
                </c:pt>
                <c:pt idx="504">
                  <c:v>0.2021</c:v>
                </c:pt>
                <c:pt idx="505">
                  <c:v>0.19689999999999999</c:v>
                </c:pt>
                <c:pt idx="506">
                  <c:v>0.20069999999999999</c:v>
                </c:pt>
                <c:pt idx="507">
                  <c:v>0.21840000000000001</c:v>
                </c:pt>
                <c:pt idx="508">
                  <c:v>0.23019999999999999</c:v>
                </c:pt>
                <c:pt idx="509">
                  <c:v>0.23019999999999999</c:v>
                </c:pt>
                <c:pt idx="510">
                  <c:v>0.23830000000000001</c:v>
                </c:pt>
                <c:pt idx="511">
                  <c:v>0.25530000000000003</c:v>
                </c:pt>
                <c:pt idx="512">
                  <c:v>0.24840000000000001</c:v>
                </c:pt>
                <c:pt idx="513">
                  <c:v>0.23089999999999999</c:v>
                </c:pt>
                <c:pt idx="514">
                  <c:v>0.22700000000000001</c:v>
                </c:pt>
                <c:pt idx="515">
                  <c:v>0.21129999999999999</c:v>
                </c:pt>
                <c:pt idx="516">
                  <c:v>0.21560000000000001</c:v>
                </c:pt>
                <c:pt idx="517">
                  <c:v>0.20499999999999999</c:v>
                </c:pt>
                <c:pt idx="518">
                  <c:v>0.1948</c:v>
                </c:pt>
                <c:pt idx="519">
                  <c:v>0.1996</c:v>
                </c:pt>
                <c:pt idx="520">
                  <c:v>0.20330000000000001</c:v>
                </c:pt>
                <c:pt idx="521">
                  <c:v>0.1908</c:v>
                </c:pt>
                <c:pt idx="522">
                  <c:v>0.18509999999999999</c:v>
                </c:pt>
                <c:pt idx="523">
                  <c:v>0.17799999999999999</c:v>
                </c:pt>
                <c:pt idx="524">
                  <c:v>0.17510000000000001</c:v>
                </c:pt>
                <c:pt idx="525">
                  <c:v>0.18290000000000001</c:v>
                </c:pt>
                <c:pt idx="526">
                  <c:v>0.17849999999999999</c:v>
                </c:pt>
                <c:pt idx="527">
                  <c:v>0.16700000000000001</c:v>
                </c:pt>
                <c:pt idx="528">
                  <c:v>0.16980000000000001</c:v>
                </c:pt>
                <c:pt idx="529">
                  <c:v>0.17280000000000001</c:v>
                </c:pt>
                <c:pt idx="530">
                  <c:v>0.16719999999999999</c:v>
                </c:pt>
                <c:pt idx="531">
                  <c:v>0.1628</c:v>
                </c:pt>
                <c:pt idx="532">
                  <c:v>0.16750000000000001</c:v>
                </c:pt>
                <c:pt idx="533">
                  <c:v>0.17080000000000001</c:v>
                </c:pt>
                <c:pt idx="534">
                  <c:v>0.16400000000000001</c:v>
                </c:pt>
                <c:pt idx="535">
                  <c:v>0.16139999999999999</c:v>
                </c:pt>
                <c:pt idx="536">
                  <c:v>0.16789999999999999</c:v>
                </c:pt>
                <c:pt idx="537">
                  <c:v>0.1671</c:v>
                </c:pt>
                <c:pt idx="538">
                  <c:v>0.1641</c:v>
                </c:pt>
                <c:pt idx="539">
                  <c:v>0.16869999999999999</c:v>
                </c:pt>
                <c:pt idx="540">
                  <c:v>0.1721</c:v>
                </c:pt>
                <c:pt idx="541">
                  <c:v>0.1666</c:v>
                </c:pt>
                <c:pt idx="542">
                  <c:v>0.17330000000000001</c:v>
                </c:pt>
                <c:pt idx="543">
                  <c:v>0.1719</c:v>
                </c:pt>
                <c:pt idx="544">
                  <c:v>0.18140000000000001</c:v>
                </c:pt>
                <c:pt idx="545">
                  <c:v>0.1668</c:v>
                </c:pt>
                <c:pt idx="546">
                  <c:v>0.16639999999999999</c:v>
                </c:pt>
                <c:pt idx="547">
                  <c:v>0.16919999999999999</c:v>
                </c:pt>
                <c:pt idx="548">
                  <c:v>0.1767</c:v>
                </c:pt>
                <c:pt idx="549">
                  <c:v>0.17280000000000001</c:v>
                </c:pt>
                <c:pt idx="550">
                  <c:v>0.1762</c:v>
                </c:pt>
                <c:pt idx="551">
                  <c:v>0.18079999999999999</c:v>
                </c:pt>
                <c:pt idx="552">
                  <c:v>0.1764</c:v>
                </c:pt>
                <c:pt idx="553">
                  <c:v>0.17369999999999999</c:v>
                </c:pt>
                <c:pt idx="554">
                  <c:v>0.17730000000000001</c:v>
                </c:pt>
                <c:pt idx="555">
                  <c:v>0.1802</c:v>
                </c:pt>
                <c:pt idx="556">
                  <c:v>0.1779</c:v>
                </c:pt>
                <c:pt idx="557">
                  <c:v>0.185</c:v>
                </c:pt>
                <c:pt idx="558">
                  <c:v>0.17760000000000001</c:v>
                </c:pt>
                <c:pt idx="559">
                  <c:v>0.1694</c:v>
                </c:pt>
                <c:pt idx="560">
                  <c:v>0.1741</c:v>
                </c:pt>
                <c:pt idx="561">
                  <c:v>0.1663</c:v>
                </c:pt>
                <c:pt idx="562">
                  <c:v>0.1658</c:v>
                </c:pt>
                <c:pt idx="563">
                  <c:v>0.17069999999999999</c:v>
                </c:pt>
                <c:pt idx="564">
                  <c:v>0.16619999999999999</c:v>
                </c:pt>
                <c:pt idx="565">
                  <c:v>0.16209999999999999</c:v>
                </c:pt>
                <c:pt idx="566">
                  <c:v>0.1699</c:v>
                </c:pt>
                <c:pt idx="567">
                  <c:v>0.17380000000000001</c:v>
                </c:pt>
                <c:pt idx="568">
                  <c:v>0.1726</c:v>
                </c:pt>
                <c:pt idx="569">
                  <c:v>0.17369999999999999</c:v>
                </c:pt>
                <c:pt idx="570">
                  <c:v>0.17760000000000001</c:v>
                </c:pt>
                <c:pt idx="571">
                  <c:v>0.1807</c:v>
                </c:pt>
                <c:pt idx="572">
                  <c:v>0.1825</c:v>
                </c:pt>
                <c:pt idx="573">
                  <c:v>0.18909999999999999</c:v>
                </c:pt>
                <c:pt idx="574">
                  <c:v>0.1893</c:v>
                </c:pt>
                <c:pt idx="575">
                  <c:v>0.17810000000000001</c:v>
                </c:pt>
                <c:pt idx="576">
                  <c:v>0.1764</c:v>
                </c:pt>
                <c:pt idx="577">
                  <c:v>0.18260000000000001</c:v>
                </c:pt>
                <c:pt idx="578">
                  <c:v>0.1706</c:v>
                </c:pt>
                <c:pt idx="579">
                  <c:v>0.1633</c:v>
                </c:pt>
                <c:pt idx="580">
                  <c:v>0.1673</c:v>
                </c:pt>
                <c:pt idx="581">
                  <c:v>0.1663</c:v>
                </c:pt>
                <c:pt idx="582">
                  <c:v>0.1638</c:v>
                </c:pt>
                <c:pt idx="583">
                  <c:v>0.1613</c:v>
                </c:pt>
                <c:pt idx="584">
                  <c:v>0.16020000000000001</c:v>
                </c:pt>
                <c:pt idx="585">
                  <c:v>0.16170000000000001</c:v>
                </c:pt>
                <c:pt idx="586">
                  <c:v>0.1663</c:v>
                </c:pt>
                <c:pt idx="587">
                  <c:v>0.16200000000000001</c:v>
                </c:pt>
                <c:pt idx="588">
                  <c:v>0.1583</c:v>
                </c:pt>
                <c:pt idx="589">
                  <c:v>0.16370000000000001</c:v>
                </c:pt>
                <c:pt idx="590">
                  <c:v>0.16669999999999999</c:v>
                </c:pt>
                <c:pt idx="591">
                  <c:v>0.16550000000000001</c:v>
                </c:pt>
                <c:pt idx="592">
                  <c:v>0.17269999999999999</c:v>
                </c:pt>
                <c:pt idx="593">
                  <c:v>0.17399999999999999</c:v>
                </c:pt>
                <c:pt idx="594">
                  <c:v>0.1694</c:v>
                </c:pt>
                <c:pt idx="595">
                  <c:v>0.1704</c:v>
                </c:pt>
                <c:pt idx="596">
                  <c:v>0.17680000000000001</c:v>
                </c:pt>
                <c:pt idx="597">
                  <c:v>0.185</c:v>
                </c:pt>
                <c:pt idx="598">
                  <c:v>0.1948</c:v>
                </c:pt>
                <c:pt idx="599">
                  <c:v>0.1986</c:v>
                </c:pt>
                <c:pt idx="600">
                  <c:v>0.182</c:v>
                </c:pt>
                <c:pt idx="601">
                  <c:v>0.1875</c:v>
                </c:pt>
                <c:pt idx="602">
                  <c:v>0.17910000000000001</c:v>
                </c:pt>
                <c:pt idx="603">
                  <c:v>0.18790000000000001</c:v>
                </c:pt>
                <c:pt idx="604">
                  <c:v>0.1951</c:v>
                </c:pt>
                <c:pt idx="605">
                  <c:v>0.19239999999999999</c:v>
                </c:pt>
                <c:pt idx="606">
                  <c:v>0.19120000000000001</c:v>
                </c:pt>
                <c:pt idx="607">
                  <c:v>0.2046</c:v>
                </c:pt>
                <c:pt idx="608">
                  <c:v>0.21879999999999999</c:v>
                </c:pt>
                <c:pt idx="609">
                  <c:v>0.2089</c:v>
                </c:pt>
                <c:pt idx="610">
                  <c:v>0.21390000000000001</c:v>
                </c:pt>
                <c:pt idx="611">
                  <c:v>0.2301</c:v>
                </c:pt>
                <c:pt idx="612">
                  <c:v>0.22989999999999999</c:v>
                </c:pt>
                <c:pt idx="613">
                  <c:v>0.2137</c:v>
                </c:pt>
                <c:pt idx="614">
                  <c:v>0.23219999999999999</c:v>
                </c:pt>
                <c:pt idx="615">
                  <c:v>0.252</c:v>
                </c:pt>
                <c:pt idx="616">
                  <c:v>0.23419999999999999</c:v>
                </c:pt>
                <c:pt idx="617">
                  <c:v>0.2152</c:v>
                </c:pt>
                <c:pt idx="618">
                  <c:v>0.2392</c:v>
                </c:pt>
                <c:pt idx="619">
                  <c:v>0.25559999999999999</c:v>
                </c:pt>
                <c:pt idx="620">
                  <c:v>0.23799999999999999</c:v>
                </c:pt>
                <c:pt idx="621">
                  <c:v>0.2301</c:v>
                </c:pt>
                <c:pt idx="622">
                  <c:v>0.2079</c:v>
                </c:pt>
                <c:pt idx="623">
                  <c:v>0.2077</c:v>
                </c:pt>
                <c:pt idx="624">
                  <c:v>0.20549999999999999</c:v>
                </c:pt>
                <c:pt idx="625">
                  <c:v>0.2104</c:v>
                </c:pt>
                <c:pt idx="626">
                  <c:v>0.20669999999999999</c:v>
                </c:pt>
                <c:pt idx="627">
                  <c:v>0.21340000000000001</c:v>
                </c:pt>
                <c:pt idx="628">
                  <c:v>0.2175</c:v>
                </c:pt>
                <c:pt idx="629">
                  <c:v>0.22020000000000001</c:v>
                </c:pt>
                <c:pt idx="630">
                  <c:v>0.21840000000000001</c:v>
                </c:pt>
                <c:pt idx="631">
                  <c:v>0.21590000000000001</c:v>
                </c:pt>
                <c:pt idx="632">
                  <c:v>0.2175</c:v>
                </c:pt>
                <c:pt idx="633">
                  <c:v>0.21540000000000001</c:v>
                </c:pt>
                <c:pt idx="634">
                  <c:v>0.2127</c:v>
                </c:pt>
                <c:pt idx="635">
                  <c:v>0.22259999999999999</c:v>
                </c:pt>
                <c:pt idx="636">
                  <c:v>0.2319</c:v>
                </c:pt>
                <c:pt idx="637">
                  <c:v>0.23069999999999999</c:v>
                </c:pt>
                <c:pt idx="638">
                  <c:v>0.23549999999999999</c:v>
                </c:pt>
                <c:pt idx="639">
                  <c:v>0.2321</c:v>
                </c:pt>
                <c:pt idx="640">
                  <c:v>0.27910000000000001</c:v>
                </c:pt>
                <c:pt idx="641">
                  <c:v>0.39410000000000001</c:v>
                </c:pt>
                <c:pt idx="642">
                  <c:v>0.51649999999999996</c:v>
                </c:pt>
                <c:pt idx="643">
                  <c:v>0.65990000000000004</c:v>
                </c:pt>
                <c:pt idx="644">
                  <c:v>0.77459999999999996</c:v>
                </c:pt>
                <c:pt idx="645">
                  <c:v>0.84250000000000003</c:v>
                </c:pt>
                <c:pt idx="646">
                  <c:v>0.94099999999999995</c:v>
                </c:pt>
                <c:pt idx="647">
                  <c:v>1.0431999999999999</c:v>
                </c:pt>
                <c:pt idx="648">
                  <c:v>1.0929</c:v>
                </c:pt>
                <c:pt idx="649">
                  <c:v>1.2243999999999999</c:v>
                </c:pt>
                <c:pt idx="650">
                  <c:v>1.2594000000000001</c:v>
                </c:pt>
                <c:pt idx="651">
                  <c:v>1.2641</c:v>
                </c:pt>
                <c:pt idx="652">
                  <c:v>1.2447999999999999</c:v>
                </c:pt>
                <c:pt idx="653">
                  <c:v>1.1955</c:v>
                </c:pt>
                <c:pt idx="654">
                  <c:v>1.1778</c:v>
                </c:pt>
                <c:pt idx="655">
                  <c:v>1.1692</c:v>
                </c:pt>
                <c:pt idx="656">
                  <c:v>1.2228000000000001</c:v>
                </c:pt>
                <c:pt idx="657">
                  <c:v>1.3061</c:v>
                </c:pt>
                <c:pt idx="658">
                  <c:v>1.4177999999999999</c:v>
                </c:pt>
                <c:pt idx="659">
                  <c:v>1.5054000000000001</c:v>
                </c:pt>
                <c:pt idx="660">
                  <c:v>1.5928</c:v>
                </c:pt>
                <c:pt idx="661">
                  <c:v>1.5919000000000001</c:v>
                </c:pt>
                <c:pt idx="662">
                  <c:v>1.5286</c:v>
                </c:pt>
                <c:pt idx="663">
                  <c:v>1.4456</c:v>
                </c:pt>
                <c:pt idx="664">
                  <c:v>1.4374</c:v>
                </c:pt>
                <c:pt idx="665">
                  <c:v>1.5257000000000001</c:v>
                </c:pt>
                <c:pt idx="666">
                  <c:v>1.4945999999999999</c:v>
                </c:pt>
                <c:pt idx="667">
                  <c:v>1.5831999999999999</c:v>
                </c:pt>
                <c:pt idx="668">
                  <c:v>1.5530999999999999</c:v>
                </c:pt>
                <c:pt idx="669">
                  <c:v>1.6713</c:v>
                </c:pt>
                <c:pt idx="670">
                  <c:v>1.6543000000000001</c:v>
                </c:pt>
                <c:pt idx="671">
                  <c:v>1.8259000000000001</c:v>
                </c:pt>
                <c:pt idx="672">
                  <c:v>1.8531</c:v>
                </c:pt>
                <c:pt idx="673">
                  <c:v>1.8019000000000001</c:v>
                </c:pt>
                <c:pt idx="674">
                  <c:v>1.6175999999999999</c:v>
                </c:pt>
                <c:pt idx="675">
                  <c:v>1.6596</c:v>
                </c:pt>
                <c:pt idx="676">
                  <c:v>1.647</c:v>
                </c:pt>
                <c:pt idx="677">
                  <c:v>1.6798999999999999</c:v>
                </c:pt>
                <c:pt idx="678">
                  <c:v>1.6862999999999999</c:v>
                </c:pt>
                <c:pt idx="679">
                  <c:v>1.8595999999999999</c:v>
                </c:pt>
                <c:pt idx="680">
                  <c:v>1.9743999999999999</c:v>
                </c:pt>
                <c:pt idx="681">
                  <c:v>1.8652</c:v>
                </c:pt>
                <c:pt idx="682">
                  <c:v>1.7507999999999999</c:v>
                </c:pt>
                <c:pt idx="683">
                  <c:v>1.6616</c:v>
                </c:pt>
                <c:pt idx="684">
                  <c:v>1.6172</c:v>
                </c:pt>
                <c:pt idx="685">
                  <c:v>1.6428</c:v>
                </c:pt>
                <c:pt idx="686">
                  <c:v>1.5717000000000001</c:v>
                </c:pt>
                <c:pt idx="687">
                  <c:v>1.5159</c:v>
                </c:pt>
                <c:pt idx="688">
                  <c:v>1.4865999999999999</c:v>
                </c:pt>
                <c:pt idx="689">
                  <c:v>1.4810000000000001</c:v>
                </c:pt>
                <c:pt idx="690">
                  <c:v>1.4887999999999999</c:v>
                </c:pt>
                <c:pt idx="691">
                  <c:v>1.4799</c:v>
                </c:pt>
                <c:pt idx="692">
                  <c:v>1.4926999999999999</c:v>
                </c:pt>
                <c:pt idx="693">
                  <c:v>1.5731999999999999</c:v>
                </c:pt>
                <c:pt idx="694">
                  <c:v>1.54</c:v>
                </c:pt>
                <c:pt idx="695">
                  <c:v>1.3695999999999999</c:v>
                </c:pt>
                <c:pt idx="696">
                  <c:v>1.2422</c:v>
                </c:pt>
                <c:pt idx="697">
                  <c:v>1.1758999999999999</c:v>
                </c:pt>
                <c:pt idx="698">
                  <c:v>1.0544</c:v>
                </c:pt>
                <c:pt idx="699">
                  <c:v>1.0727</c:v>
                </c:pt>
                <c:pt idx="700">
                  <c:v>0.99550000000000005</c:v>
                </c:pt>
                <c:pt idx="701">
                  <c:v>1.0047999999999999</c:v>
                </c:pt>
                <c:pt idx="702">
                  <c:v>0.92769999999999997</c:v>
                </c:pt>
                <c:pt idx="703">
                  <c:v>0.99</c:v>
                </c:pt>
                <c:pt idx="704">
                  <c:v>1.0599000000000001</c:v>
                </c:pt>
                <c:pt idx="705">
                  <c:v>0.97650000000000003</c:v>
                </c:pt>
                <c:pt idx="706">
                  <c:v>0.99060000000000004</c:v>
                </c:pt>
                <c:pt idx="707">
                  <c:v>0.88929999999999998</c:v>
                </c:pt>
                <c:pt idx="708">
                  <c:v>0.94650000000000001</c:v>
                </c:pt>
                <c:pt idx="709">
                  <c:v>0.95040000000000002</c:v>
                </c:pt>
                <c:pt idx="710">
                  <c:v>0.89080000000000004</c:v>
                </c:pt>
                <c:pt idx="711">
                  <c:v>0.87080000000000002</c:v>
                </c:pt>
                <c:pt idx="712">
                  <c:v>0.85550000000000004</c:v>
                </c:pt>
                <c:pt idx="713">
                  <c:v>0.81169999999999998</c:v>
                </c:pt>
                <c:pt idx="714">
                  <c:v>0.79469999999999996</c:v>
                </c:pt>
                <c:pt idx="715">
                  <c:v>0.88400000000000001</c:v>
                </c:pt>
                <c:pt idx="716">
                  <c:v>0.86860000000000004</c:v>
                </c:pt>
                <c:pt idx="717">
                  <c:v>0.84040000000000004</c:v>
                </c:pt>
                <c:pt idx="718">
                  <c:v>0.81169999999999998</c:v>
                </c:pt>
                <c:pt idx="719">
                  <c:v>0.73550000000000004</c:v>
                </c:pt>
                <c:pt idx="720">
                  <c:v>0.57589999999999997</c:v>
                </c:pt>
                <c:pt idx="721">
                  <c:v>0.42199999999999999</c:v>
                </c:pt>
                <c:pt idx="722">
                  <c:v>0.27879999999999999</c:v>
                </c:pt>
                <c:pt idx="723">
                  <c:v>0.24479999999999999</c:v>
                </c:pt>
                <c:pt idx="724">
                  <c:v>0.2311</c:v>
                </c:pt>
                <c:pt idx="725">
                  <c:v>0.21290000000000001</c:v>
                </c:pt>
                <c:pt idx="726">
                  <c:v>0.21049999999999999</c:v>
                </c:pt>
                <c:pt idx="727">
                  <c:v>0.20469999999999999</c:v>
                </c:pt>
                <c:pt idx="728">
                  <c:v>0.18959999999999999</c:v>
                </c:pt>
                <c:pt idx="729">
                  <c:v>0.18410000000000001</c:v>
                </c:pt>
                <c:pt idx="730">
                  <c:v>0.18579999999999999</c:v>
                </c:pt>
                <c:pt idx="731">
                  <c:v>0.17419999999999999</c:v>
                </c:pt>
                <c:pt idx="732">
                  <c:v>0.1701</c:v>
                </c:pt>
                <c:pt idx="733">
                  <c:v>0.17580000000000001</c:v>
                </c:pt>
                <c:pt idx="734">
                  <c:v>0.1734</c:v>
                </c:pt>
                <c:pt idx="735">
                  <c:v>0.16520000000000001</c:v>
                </c:pt>
                <c:pt idx="736">
                  <c:v>0.1696</c:v>
                </c:pt>
                <c:pt idx="737">
                  <c:v>0.1774</c:v>
                </c:pt>
                <c:pt idx="738">
                  <c:v>0.17610000000000001</c:v>
                </c:pt>
                <c:pt idx="739">
                  <c:v>0.17169999999999999</c:v>
                </c:pt>
                <c:pt idx="740">
                  <c:v>0.17560000000000001</c:v>
                </c:pt>
                <c:pt idx="741">
                  <c:v>0.18149999999999999</c:v>
                </c:pt>
                <c:pt idx="742">
                  <c:v>0.17510000000000001</c:v>
                </c:pt>
                <c:pt idx="743">
                  <c:v>0.1681</c:v>
                </c:pt>
                <c:pt idx="744">
                  <c:v>0.16470000000000001</c:v>
                </c:pt>
                <c:pt idx="745">
                  <c:v>0.16669999999999999</c:v>
                </c:pt>
                <c:pt idx="746">
                  <c:v>0.15870000000000001</c:v>
                </c:pt>
                <c:pt idx="747">
                  <c:v>0.1583</c:v>
                </c:pt>
                <c:pt idx="748">
                  <c:v>0.16250000000000001</c:v>
                </c:pt>
                <c:pt idx="749">
                  <c:v>0.15820000000000001</c:v>
                </c:pt>
                <c:pt idx="750">
                  <c:v>0.15939999999999999</c:v>
                </c:pt>
                <c:pt idx="751">
                  <c:v>0.16930000000000001</c:v>
                </c:pt>
                <c:pt idx="752">
                  <c:v>0.1704</c:v>
                </c:pt>
                <c:pt idx="753">
                  <c:v>0.17460000000000001</c:v>
                </c:pt>
                <c:pt idx="754">
                  <c:v>0.1867</c:v>
                </c:pt>
                <c:pt idx="755">
                  <c:v>0.18190000000000001</c:v>
                </c:pt>
                <c:pt idx="756">
                  <c:v>0.1825</c:v>
                </c:pt>
                <c:pt idx="757">
                  <c:v>0.17949999999999999</c:v>
                </c:pt>
                <c:pt idx="758">
                  <c:v>0.1709</c:v>
                </c:pt>
                <c:pt idx="759">
                  <c:v>0.1729</c:v>
                </c:pt>
                <c:pt idx="760">
                  <c:v>0.17979999999999999</c:v>
                </c:pt>
                <c:pt idx="761">
                  <c:v>0.17549999999999999</c:v>
                </c:pt>
                <c:pt idx="762">
                  <c:v>0.16769999999999999</c:v>
                </c:pt>
                <c:pt idx="763">
                  <c:v>0.1777</c:v>
                </c:pt>
                <c:pt idx="764">
                  <c:v>0.18360000000000001</c:v>
                </c:pt>
                <c:pt idx="765">
                  <c:v>0.1741</c:v>
                </c:pt>
                <c:pt idx="766">
                  <c:v>0.17680000000000001</c:v>
                </c:pt>
                <c:pt idx="767">
                  <c:v>0.19270000000000001</c:v>
                </c:pt>
                <c:pt idx="768">
                  <c:v>0.1903</c:v>
                </c:pt>
                <c:pt idx="769">
                  <c:v>0.18279999999999999</c:v>
                </c:pt>
                <c:pt idx="770">
                  <c:v>0.1956</c:v>
                </c:pt>
                <c:pt idx="771">
                  <c:v>0.2054</c:v>
                </c:pt>
                <c:pt idx="772">
                  <c:v>0.19839999999999999</c:v>
                </c:pt>
                <c:pt idx="773">
                  <c:v>0.18970000000000001</c:v>
                </c:pt>
                <c:pt idx="774">
                  <c:v>0.1981</c:v>
                </c:pt>
                <c:pt idx="775">
                  <c:v>0.19400000000000001</c:v>
                </c:pt>
                <c:pt idx="776">
                  <c:v>0.17899999999999999</c:v>
                </c:pt>
                <c:pt idx="777">
                  <c:v>0.18720000000000001</c:v>
                </c:pt>
                <c:pt idx="778">
                  <c:v>0.18590000000000001</c:v>
                </c:pt>
                <c:pt idx="779">
                  <c:v>0.18090000000000001</c:v>
                </c:pt>
                <c:pt idx="780">
                  <c:v>0.1741</c:v>
                </c:pt>
                <c:pt idx="781">
                  <c:v>0.18149999999999999</c:v>
                </c:pt>
                <c:pt idx="782">
                  <c:v>0.16769999999999999</c:v>
                </c:pt>
                <c:pt idx="783">
                  <c:v>0.17419999999999999</c:v>
                </c:pt>
                <c:pt idx="784">
                  <c:v>0.18060000000000001</c:v>
                </c:pt>
                <c:pt idx="785">
                  <c:v>0.1726</c:v>
                </c:pt>
                <c:pt idx="786">
                  <c:v>0.17249999999999999</c:v>
                </c:pt>
                <c:pt idx="787">
                  <c:v>0.18529999999999999</c:v>
                </c:pt>
                <c:pt idx="788">
                  <c:v>0.18290000000000001</c:v>
                </c:pt>
                <c:pt idx="789">
                  <c:v>0.17749999999999999</c:v>
                </c:pt>
                <c:pt idx="790">
                  <c:v>0.18629999999999999</c:v>
                </c:pt>
                <c:pt idx="791">
                  <c:v>0.1961</c:v>
                </c:pt>
                <c:pt idx="792">
                  <c:v>0.1933</c:v>
                </c:pt>
                <c:pt idx="793">
                  <c:v>0.19689999999999999</c:v>
                </c:pt>
                <c:pt idx="794">
                  <c:v>0.21210000000000001</c:v>
                </c:pt>
                <c:pt idx="795">
                  <c:v>0.2203</c:v>
                </c:pt>
                <c:pt idx="796">
                  <c:v>0.2175</c:v>
                </c:pt>
                <c:pt idx="797">
                  <c:v>0.23080000000000001</c:v>
                </c:pt>
                <c:pt idx="798">
                  <c:v>0.21709999999999999</c:v>
                </c:pt>
                <c:pt idx="799">
                  <c:v>0.22309999999999999</c:v>
                </c:pt>
                <c:pt idx="800">
                  <c:v>0.20699999999999999</c:v>
                </c:pt>
                <c:pt idx="801">
                  <c:v>0.1946</c:v>
                </c:pt>
                <c:pt idx="802">
                  <c:v>0.18779999999999999</c:v>
                </c:pt>
                <c:pt idx="803">
                  <c:v>0.18709999999999999</c:v>
                </c:pt>
                <c:pt idx="804">
                  <c:v>0.1762</c:v>
                </c:pt>
                <c:pt idx="805">
                  <c:v>0.16689999999999999</c:v>
                </c:pt>
                <c:pt idx="806">
                  <c:v>0.1691</c:v>
                </c:pt>
                <c:pt idx="807">
                  <c:v>0.16489999999999999</c:v>
                </c:pt>
                <c:pt idx="808">
                  <c:v>0.16089999999999999</c:v>
                </c:pt>
                <c:pt idx="809">
                  <c:v>0.16819999999999999</c:v>
                </c:pt>
                <c:pt idx="810">
                  <c:v>0.14979999999999999</c:v>
                </c:pt>
                <c:pt idx="811">
                  <c:v>0.16619999999999999</c:v>
                </c:pt>
                <c:pt idx="812">
                  <c:v>0.19189999999999999</c:v>
                </c:pt>
                <c:pt idx="813">
                  <c:v>0.20799999999999999</c:v>
                </c:pt>
                <c:pt idx="814">
                  <c:v>0.19450000000000001</c:v>
                </c:pt>
                <c:pt idx="815">
                  <c:v>0.17829999999999999</c:v>
                </c:pt>
                <c:pt idx="816">
                  <c:v>0.20050000000000001</c:v>
                </c:pt>
                <c:pt idx="817">
                  <c:v>0.22070000000000001</c:v>
                </c:pt>
                <c:pt idx="818">
                  <c:v>0.22</c:v>
                </c:pt>
                <c:pt idx="819">
                  <c:v>0.20569999999999999</c:v>
                </c:pt>
                <c:pt idx="820">
                  <c:v>0.21429999999999999</c:v>
                </c:pt>
                <c:pt idx="821">
                  <c:v>0.21970000000000001</c:v>
                </c:pt>
                <c:pt idx="822">
                  <c:v>0.2167</c:v>
                </c:pt>
                <c:pt idx="823">
                  <c:v>0.20280000000000001</c:v>
                </c:pt>
                <c:pt idx="824">
                  <c:v>0.20019999999999999</c:v>
                </c:pt>
                <c:pt idx="825">
                  <c:v>0.216</c:v>
                </c:pt>
                <c:pt idx="826">
                  <c:v>0.24779999999999999</c:v>
                </c:pt>
                <c:pt idx="827">
                  <c:v>0.28499999999999998</c:v>
                </c:pt>
                <c:pt idx="828">
                  <c:v>0.39460000000000001</c:v>
                </c:pt>
                <c:pt idx="829">
                  <c:v>0.42749999999999999</c:v>
                </c:pt>
                <c:pt idx="830">
                  <c:v>0.41170000000000001</c:v>
                </c:pt>
                <c:pt idx="831">
                  <c:v>0.47589999999999999</c:v>
                </c:pt>
                <c:pt idx="832">
                  <c:v>0.57779999999999998</c:v>
                </c:pt>
                <c:pt idx="833">
                  <c:v>0.60240000000000005</c:v>
                </c:pt>
                <c:pt idx="834">
                  <c:v>0.60929999999999995</c:v>
                </c:pt>
                <c:pt idx="835">
                  <c:v>0.53879999999999995</c:v>
                </c:pt>
                <c:pt idx="836">
                  <c:v>0.56910000000000005</c:v>
                </c:pt>
                <c:pt idx="837">
                  <c:v>0.51280000000000003</c:v>
                </c:pt>
                <c:pt idx="838">
                  <c:v>0.39379999999999998</c:v>
                </c:pt>
                <c:pt idx="839">
                  <c:v>0.3019</c:v>
                </c:pt>
                <c:pt idx="840">
                  <c:v>0.24099999999999999</c:v>
                </c:pt>
                <c:pt idx="841">
                  <c:v>0.2306</c:v>
                </c:pt>
                <c:pt idx="842">
                  <c:v>0.22270000000000001</c:v>
                </c:pt>
                <c:pt idx="843">
                  <c:v>0.2084</c:v>
                </c:pt>
                <c:pt idx="844">
                  <c:v>0.2261</c:v>
                </c:pt>
                <c:pt idx="845">
                  <c:v>0.2298</c:v>
                </c:pt>
                <c:pt idx="846">
                  <c:v>0.21</c:v>
                </c:pt>
                <c:pt idx="847">
                  <c:v>0.2087</c:v>
                </c:pt>
                <c:pt idx="848">
                  <c:v>0.22750000000000001</c:v>
                </c:pt>
                <c:pt idx="849">
                  <c:v>0.23530000000000001</c:v>
                </c:pt>
                <c:pt idx="850">
                  <c:v>0.21659999999999999</c:v>
                </c:pt>
                <c:pt idx="851">
                  <c:v>0.20569999999999999</c:v>
                </c:pt>
                <c:pt idx="852">
                  <c:v>0.21609999999999999</c:v>
                </c:pt>
                <c:pt idx="853">
                  <c:v>0.22939999999999999</c:v>
                </c:pt>
                <c:pt idx="854">
                  <c:v>0.2177</c:v>
                </c:pt>
                <c:pt idx="855">
                  <c:v>0.21129999999999999</c:v>
                </c:pt>
                <c:pt idx="856">
                  <c:v>0.23089999999999999</c:v>
                </c:pt>
                <c:pt idx="857">
                  <c:v>0.2336</c:v>
                </c:pt>
                <c:pt idx="858">
                  <c:v>0.21329999999999999</c:v>
                </c:pt>
                <c:pt idx="859">
                  <c:v>0.21010000000000001</c:v>
                </c:pt>
                <c:pt idx="860">
                  <c:v>0.2271</c:v>
                </c:pt>
                <c:pt idx="861">
                  <c:v>0.22420000000000001</c:v>
                </c:pt>
                <c:pt idx="862">
                  <c:v>0.21029999999999999</c:v>
                </c:pt>
                <c:pt idx="863">
                  <c:v>0.2205</c:v>
                </c:pt>
                <c:pt idx="864">
                  <c:v>0.2213</c:v>
                </c:pt>
                <c:pt idx="865">
                  <c:v>0.216</c:v>
                </c:pt>
                <c:pt idx="866">
                  <c:v>0.3095</c:v>
                </c:pt>
                <c:pt idx="867">
                  <c:v>0.32879999999999998</c:v>
                </c:pt>
                <c:pt idx="868">
                  <c:v>0.40260000000000001</c:v>
                </c:pt>
                <c:pt idx="869">
                  <c:v>0.52159999999999995</c:v>
                </c:pt>
                <c:pt idx="870">
                  <c:v>0.67510000000000003</c:v>
                </c:pt>
                <c:pt idx="871">
                  <c:v>0.85829999999999995</c:v>
                </c:pt>
                <c:pt idx="872">
                  <c:v>1.0116000000000001</c:v>
                </c:pt>
                <c:pt idx="873">
                  <c:v>1.1713</c:v>
                </c:pt>
                <c:pt idx="874">
                  <c:v>1.2957000000000001</c:v>
                </c:pt>
                <c:pt idx="875">
                  <c:v>1.3903000000000001</c:v>
                </c:pt>
                <c:pt idx="876">
                  <c:v>1.3682000000000001</c:v>
                </c:pt>
                <c:pt idx="877">
                  <c:v>1.4141999999999999</c:v>
                </c:pt>
                <c:pt idx="878">
                  <c:v>1.3564000000000001</c:v>
                </c:pt>
                <c:pt idx="879">
                  <c:v>1.3245</c:v>
                </c:pt>
                <c:pt idx="880">
                  <c:v>1.1666000000000001</c:v>
                </c:pt>
                <c:pt idx="881">
                  <c:v>1.0537000000000001</c:v>
                </c:pt>
                <c:pt idx="882">
                  <c:v>0.92900000000000005</c:v>
                </c:pt>
                <c:pt idx="883">
                  <c:v>0.81559999999999999</c:v>
                </c:pt>
                <c:pt idx="884">
                  <c:v>0.7399</c:v>
                </c:pt>
                <c:pt idx="885">
                  <c:v>0.60040000000000004</c:v>
                </c:pt>
                <c:pt idx="886">
                  <c:v>0.43919999999999998</c:v>
                </c:pt>
                <c:pt idx="887">
                  <c:v>0.37609999999999999</c:v>
                </c:pt>
                <c:pt idx="888">
                  <c:v>0.28849999999999998</c:v>
                </c:pt>
                <c:pt idx="889">
                  <c:v>0.2492</c:v>
                </c:pt>
                <c:pt idx="890">
                  <c:v>0.1948</c:v>
                </c:pt>
                <c:pt idx="891">
                  <c:v>0.1812</c:v>
                </c:pt>
                <c:pt idx="892">
                  <c:v>0.21840000000000001</c:v>
                </c:pt>
                <c:pt idx="893">
                  <c:v>0.17069999999999999</c:v>
                </c:pt>
                <c:pt idx="894">
                  <c:v>0.2137</c:v>
                </c:pt>
                <c:pt idx="895">
                  <c:v>0.16769999999999999</c:v>
                </c:pt>
                <c:pt idx="896">
                  <c:v>0.17319999999999999</c:v>
                </c:pt>
                <c:pt idx="897">
                  <c:v>0.1709</c:v>
                </c:pt>
                <c:pt idx="898">
                  <c:v>0.16009999999999999</c:v>
                </c:pt>
                <c:pt idx="899">
                  <c:v>0.14219999999999999</c:v>
                </c:pt>
                <c:pt idx="900">
                  <c:v>0.1636</c:v>
                </c:pt>
                <c:pt idx="901">
                  <c:v>0.17169999999999999</c:v>
                </c:pt>
                <c:pt idx="902">
                  <c:v>0.18049999999999999</c:v>
                </c:pt>
                <c:pt idx="903">
                  <c:v>0.18940000000000001</c:v>
                </c:pt>
                <c:pt idx="904">
                  <c:v>0.22520000000000001</c:v>
                </c:pt>
                <c:pt idx="905">
                  <c:v>0.19209999999999999</c:v>
                </c:pt>
                <c:pt idx="906">
                  <c:v>0.1719</c:v>
                </c:pt>
                <c:pt idx="907">
                  <c:v>0.1593</c:v>
                </c:pt>
                <c:pt idx="908">
                  <c:v>0.15049999999999999</c:v>
                </c:pt>
                <c:pt idx="909">
                  <c:v>0.14860000000000001</c:v>
                </c:pt>
                <c:pt idx="910">
                  <c:v>0.15640000000000001</c:v>
                </c:pt>
                <c:pt idx="911">
                  <c:v>0.16339999999999999</c:v>
                </c:pt>
                <c:pt idx="912">
                  <c:v>0.1739</c:v>
                </c:pt>
                <c:pt idx="913">
                  <c:v>0.2122</c:v>
                </c:pt>
                <c:pt idx="914">
                  <c:v>0.17710000000000001</c:v>
                </c:pt>
                <c:pt idx="915">
                  <c:v>0.18970000000000001</c:v>
                </c:pt>
                <c:pt idx="916">
                  <c:v>0.17899999999999999</c:v>
                </c:pt>
                <c:pt idx="917">
                  <c:v>0.17829999999999999</c:v>
                </c:pt>
                <c:pt idx="918">
                  <c:v>0.19939999999999999</c:v>
                </c:pt>
                <c:pt idx="919">
                  <c:v>0.2051</c:v>
                </c:pt>
                <c:pt idx="920">
                  <c:v>0.1956</c:v>
                </c:pt>
                <c:pt idx="921">
                  <c:v>0.20630000000000001</c:v>
                </c:pt>
                <c:pt idx="922">
                  <c:v>0.193</c:v>
                </c:pt>
                <c:pt idx="923">
                  <c:v>0.189</c:v>
                </c:pt>
                <c:pt idx="924">
                  <c:v>0.1812</c:v>
                </c:pt>
                <c:pt idx="925">
                  <c:v>0.19950000000000001</c:v>
                </c:pt>
                <c:pt idx="926">
                  <c:v>0.19059999999999999</c:v>
                </c:pt>
                <c:pt idx="927">
                  <c:v>0.15659999999999999</c:v>
                </c:pt>
                <c:pt idx="928">
                  <c:v>0.1673</c:v>
                </c:pt>
                <c:pt idx="929">
                  <c:v>0.16039999999999999</c:v>
                </c:pt>
                <c:pt idx="930">
                  <c:v>0.1719</c:v>
                </c:pt>
                <c:pt idx="931">
                  <c:v>0.1769</c:v>
                </c:pt>
                <c:pt idx="932">
                  <c:v>0.18010000000000001</c:v>
                </c:pt>
                <c:pt idx="933">
                  <c:v>0.19650000000000001</c:v>
                </c:pt>
                <c:pt idx="934">
                  <c:v>0.19470000000000001</c:v>
                </c:pt>
                <c:pt idx="935">
                  <c:v>0.20649999999999999</c:v>
                </c:pt>
                <c:pt idx="936">
                  <c:v>0.20100000000000001</c:v>
                </c:pt>
                <c:pt idx="937">
                  <c:v>0.21129999999999999</c:v>
                </c:pt>
                <c:pt idx="938">
                  <c:v>0.22359999999999999</c:v>
                </c:pt>
                <c:pt idx="939">
                  <c:v>0.21929999999999999</c:v>
                </c:pt>
                <c:pt idx="940">
                  <c:v>0.2026</c:v>
                </c:pt>
                <c:pt idx="941">
                  <c:v>0.20019999999999999</c:v>
                </c:pt>
                <c:pt idx="942">
                  <c:v>0.19020000000000001</c:v>
                </c:pt>
                <c:pt idx="943">
                  <c:v>0.18759999999999999</c:v>
                </c:pt>
                <c:pt idx="944">
                  <c:v>0.19439999999999999</c:v>
                </c:pt>
                <c:pt idx="945">
                  <c:v>0.1913</c:v>
                </c:pt>
                <c:pt idx="946">
                  <c:v>0.18770000000000001</c:v>
                </c:pt>
                <c:pt idx="947">
                  <c:v>0.1895</c:v>
                </c:pt>
                <c:pt idx="948">
                  <c:v>0.19409999999999999</c:v>
                </c:pt>
                <c:pt idx="949">
                  <c:v>0.19159999999999999</c:v>
                </c:pt>
                <c:pt idx="950">
                  <c:v>0.19139999999999999</c:v>
                </c:pt>
                <c:pt idx="951">
                  <c:v>0.2001</c:v>
                </c:pt>
                <c:pt idx="952">
                  <c:v>0.20710000000000001</c:v>
                </c:pt>
                <c:pt idx="953">
                  <c:v>0.20280000000000001</c:v>
                </c:pt>
                <c:pt idx="954">
                  <c:v>0.2215</c:v>
                </c:pt>
                <c:pt idx="955">
                  <c:v>0.24379999999999999</c:v>
                </c:pt>
                <c:pt idx="956">
                  <c:v>0.25990000000000002</c:v>
                </c:pt>
                <c:pt idx="957">
                  <c:v>0.29930000000000001</c:v>
                </c:pt>
                <c:pt idx="958">
                  <c:v>0.32129999999999997</c:v>
                </c:pt>
                <c:pt idx="959">
                  <c:v>0.3266</c:v>
                </c:pt>
                <c:pt idx="960">
                  <c:v>0.2893</c:v>
                </c:pt>
                <c:pt idx="961">
                  <c:v>0.24479999999999999</c:v>
                </c:pt>
                <c:pt idx="962">
                  <c:v>0.21609999999999999</c:v>
                </c:pt>
                <c:pt idx="963">
                  <c:v>0.25929999999999997</c:v>
                </c:pt>
                <c:pt idx="964">
                  <c:v>0.2702</c:v>
                </c:pt>
                <c:pt idx="965">
                  <c:v>0.38450000000000001</c:v>
                </c:pt>
                <c:pt idx="966">
                  <c:v>0.33460000000000001</c:v>
                </c:pt>
                <c:pt idx="967">
                  <c:v>0.37530000000000002</c:v>
                </c:pt>
                <c:pt idx="968">
                  <c:v>0.38829999999999998</c:v>
                </c:pt>
                <c:pt idx="969">
                  <c:v>0.45989999999999998</c:v>
                </c:pt>
                <c:pt idx="970">
                  <c:v>0.31719999999999998</c:v>
                </c:pt>
                <c:pt idx="971">
                  <c:v>0.28999999999999998</c:v>
                </c:pt>
                <c:pt idx="972">
                  <c:v>0.28520000000000001</c:v>
                </c:pt>
                <c:pt idx="973">
                  <c:v>0.31569999999999998</c:v>
                </c:pt>
                <c:pt idx="974">
                  <c:v>0.32579999999999998</c:v>
                </c:pt>
                <c:pt idx="975">
                  <c:v>0.34339999999999998</c:v>
                </c:pt>
                <c:pt idx="976">
                  <c:v>0.39729999999999999</c:v>
                </c:pt>
                <c:pt idx="977">
                  <c:v>0.4052</c:v>
                </c:pt>
                <c:pt idx="978">
                  <c:v>0.34449999999999997</c:v>
                </c:pt>
                <c:pt idx="979">
                  <c:v>0.32929999999999998</c:v>
                </c:pt>
                <c:pt idx="980">
                  <c:v>0.36870000000000003</c:v>
                </c:pt>
                <c:pt idx="981">
                  <c:v>0.376</c:v>
                </c:pt>
                <c:pt idx="982">
                  <c:v>0.33560000000000001</c:v>
                </c:pt>
                <c:pt idx="983">
                  <c:v>0.34300000000000003</c:v>
                </c:pt>
                <c:pt idx="984">
                  <c:v>0.38140000000000002</c:v>
                </c:pt>
                <c:pt idx="985">
                  <c:v>0.38979999999999998</c:v>
                </c:pt>
                <c:pt idx="986">
                  <c:v>0.37080000000000002</c:v>
                </c:pt>
                <c:pt idx="987">
                  <c:v>0.3901</c:v>
                </c:pt>
                <c:pt idx="988">
                  <c:v>0.43580000000000002</c:v>
                </c:pt>
                <c:pt idx="989">
                  <c:v>0.44719999999999999</c:v>
                </c:pt>
                <c:pt idx="990">
                  <c:v>0.44490000000000002</c:v>
                </c:pt>
                <c:pt idx="991">
                  <c:v>0.4778</c:v>
                </c:pt>
                <c:pt idx="992">
                  <c:v>0.53439999999999999</c:v>
                </c:pt>
                <c:pt idx="993">
                  <c:v>0.55779999999999996</c:v>
                </c:pt>
                <c:pt idx="994">
                  <c:v>0.57089999999999996</c:v>
                </c:pt>
                <c:pt idx="995">
                  <c:v>0.624</c:v>
                </c:pt>
                <c:pt idx="996">
                  <c:v>0.751</c:v>
                </c:pt>
                <c:pt idx="997">
                  <c:v>0.91100000000000003</c:v>
                </c:pt>
                <c:pt idx="998">
                  <c:v>1.1065</c:v>
                </c:pt>
                <c:pt idx="999">
                  <c:v>1.2457</c:v>
                </c:pt>
                <c:pt idx="1000">
                  <c:v>1.3647</c:v>
                </c:pt>
                <c:pt idx="1001">
                  <c:v>1.4545999999999999</c:v>
                </c:pt>
                <c:pt idx="1002">
                  <c:v>1.522</c:v>
                </c:pt>
                <c:pt idx="1003">
                  <c:v>1.6364000000000001</c:v>
                </c:pt>
                <c:pt idx="1004">
                  <c:v>1.8174999999999999</c:v>
                </c:pt>
                <c:pt idx="1005">
                  <c:v>1.9188000000000001</c:v>
                </c:pt>
                <c:pt idx="1006">
                  <c:v>2.0727000000000002</c:v>
                </c:pt>
                <c:pt idx="1007">
                  <c:v>2.1686000000000001</c:v>
                </c:pt>
                <c:pt idx="1008">
                  <c:v>2.2553000000000001</c:v>
                </c:pt>
                <c:pt idx="1009">
                  <c:v>2.3205</c:v>
                </c:pt>
                <c:pt idx="1010">
                  <c:v>2.4443000000000001</c:v>
                </c:pt>
                <c:pt idx="1011">
                  <c:v>2.4977</c:v>
                </c:pt>
                <c:pt idx="1012">
                  <c:v>2.6025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B0A-42E6-B07E-7FDA21594A85}"/>
            </c:ext>
          </c:extLst>
        </c:ser>
        <c:ser>
          <c:idx val="1"/>
          <c:order val="1"/>
          <c:tx>
            <c:strRef>
              <c:f>Sheet3!$C$3</c:f>
              <c:strCache>
                <c:ptCount val="1"/>
                <c:pt idx="0">
                  <c:v>Series2</c:v>
                </c:pt>
              </c:strCache>
            </c:strRef>
          </c:tx>
          <c:spPr>
            <a:ln w="12700" cap="rnd">
              <a:solidFill>
                <a:srgbClr val="0099FF"/>
              </a:solidFill>
              <a:round/>
            </a:ln>
            <a:effectLst/>
          </c:spPr>
          <c:marker>
            <c:symbol val="none"/>
          </c:marker>
          <c:val>
            <c:numRef>
              <c:f>Sheet3!$C$4:$C$1016</c:f>
              <c:numCache>
                <c:formatCode>General</c:formatCode>
                <c:ptCount val="1013"/>
                <c:pt idx="0">
                  <c:v>2.3908</c:v>
                </c:pt>
                <c:pt idx="1">
                  <c:v>2.2141999999999999</c:v>
                </c:pt>
                <c:pt idx="2">
                  <c:v>2.0638999999999998</c:v>
                </c:pt>
                <c:pt idx="3">
                  <c:v>1.9388000000000001</c:v>
                </c:pt>
                <c:pt idx="4">
                  <c:v>1.7497</c:v>
                </c:pt>
                <c:pt idx="5">
                  <c:v>1.5924</c:v>
                </c:pt>
                <c:pt idx="6">
                  <c:v>1.3936999999999999</c:v>
                </c:pt>
                <c:pt idx="7">
                  <c:v>1.2616000000000001</c:v>
                </c:pt>
                <c:pt idx="8">
                  <c:v>1.0741000000000001</c:v>
                </c:pt>
                <c:pt idx="9">
                  <c:v>0.86909999999999998</c:v>
                </c:pt>
                <c:pt idx="10">
                  <c:v>0.65159999999999996</c:v>
                </c:pt>
                <c:pt idx="11">
                  <c:v>0.57550000000000001</c:v>
                </c:pt>
                <c:pt idx="12">
                  <c:v>0.43130000000000002</c:v>
                </c:pt>
                <c:pt idx="13">
                  <c:v>0.40699999999999997</c:v>
                </c:pt>
                <c:pt idx="14">
                  <c:v>0.49969999999999998</c:v>
                </c:pt>
                <c:pt idx="15">
                  <c:v>0.47089999999999999</c:v>
                </c:pt>
                <c:pt idx="16">
                  <c:v>0.39069999999999999</c:v>
                </c:pt>
                <c:pt idx="17">
                  <c:v>0.38040000000000002</c:v>
                </c:pt>
                <c:pt idx="18">
                  <c:v>0.36670000000000003</c:v>
                </c:pt>
                <c:pt idx="19">
                  <c:v>0.36969999999999997</c:v>
                </c:pt>
                <c:pt idx="20">
                  <c:v>0.38219999999999998</c:v>
                </c:pt>
                <c:pt idx="21">
                  <c:v>0.37280000000000002</c:v>
                </c:pt>
                <c:pt idx="22">
                  <c:v>0.3619</c:v>
                </c:pt>
                <c:pt idx="23">
                  <c:v>0.37980000000000003</c:v>
                </c:pt>
                <c:pt idx="24">
                  <c:v>0.38419999999999999</c:v>
                </c:pt>
                <c:pt idx="25">
                  <c:v>0.36980000000000002</c:v>
                </c:pt>
                <c:pt idx="26">
                  <c:v>0.37259999999999999</c:v>
                </c:pt>
                <c:pt idx="27">
                  <c:v>0.3967</c:v>
                </c:pt>
                <c:pt idx="28">
                  <c:v>0.3987</c:v>
                </c:pt>
                <c:pt idx="29">
                  <c:v>0.38329999999999997</c:v>
                </c:pt>
                <c:pt idx="30">
                  <c:v>0.37690000000000001</c:v>
                </c:pt>
                <c:pt idx="31">
                  <c:v>0.39350000000000002</c:v>
                </c:pt>
                <c:pt idx="32">
                  <c:v>0.39050000000000001</c:v>
                </c:pt>
                <c:pt idx="33">
                  <c:v>0.41010000000000002</c:v>
                </c:pt>
                <c:pt idx="34">
                  <c:v>0.41549999999999998</c:v>
                </c:pt>
                <c:pt idx="35">
                  <c:v>0.40739999999999998</c:v>
                </c:pt>
                <c:pt idx="36">
                  <c:v>0.38650000000000001</c:v>
                </c:pt>
                <c:pt idx="37">
                  <c:v>0.38590000000000002</c:v>
                </c:pt>
                <c:pt idx="38">
                  <c:v>0.39169999999999999</c:v>
                </c:pt>
                <c:pt idx="39">
                  <c:v>0.37269999999999998</c:v>
                </c:pt>
                <c:pt idx="40">
                  <c:v>0.36020000000000002</c:v>
                </c:pt>
                <c:pt idx="41">
                  <c:v>0.37059999999999998</c:v>
                </c:pt>
                <c:pt idx="42">
                  <c:v>0.36940000000000001</c:v>
                </c:pt>
                <c:pt idx="43">
                  <c:v>0.34899999999999998</c:v>
                </c:pt>
                <c:pt idx="44">
                  <c:v>0.34870000000000001</c:v>
                </c:pt>
                <c:pt idx="45">
                  <c:v>0.36230000000000001</c:v>
                </c:pt>
                <c:pt idx="46">
                  <c:v>0.34820000000000001</c:v>
                </c:pt>
                <c:pt idx="47">
                  <c:v>0.32640000000000002</c:v>
                </c:pt>
                <c:pt idx="48">
                  <c:v>0.34039999999999998</c:v>
                </c:pt>
                <c:pt idx="49">
                  <c:v>0.33260000000000001</c:v>
                </c:pt>
                <c:pt idx="50">
                  <c:v>0.30780000000000002</c:v>
                </c:pt>
                <c:pt idx="51">
                  <c:v>0.31230000000000002</c:v>
                </c:pt>
                <c:pt idx="52">
                  <c:v>0.32529999999999998</c:v>
                </c:pt>
                <c:pt idx="53">
                  <c:v>0.30930000000000002</c:v>
                </c:pt>
                <c:pt idx="54">
                  <c:v>0.29070000000000001</c:v>
                </c:pt>
                <c:pt idx="55">
                  <c:v>0.29349999999999998</c:v>
                </c:pt>
                <c:pt idx="56">
                  <c:v>0.28599999999999998</c:v>
                </c:pt>
                <c:pt idx="57">
                  <c:v>0.2717</c:v>
                </c:pt>
                <c:pt idx="58">
                  <c:v>0.26050000000000001</c:v>
                </c:pt>
                <c:pt idx="59">
                  <c:v>0.26440000000000002</c:v>
                </c:pt>
                <c:pt idx="60">
                  <c:v>0.26740000000000003</c:v>
                </c:pt>
                <c:pt idx="61">
                  <c:v>0.3367</c:v>
                </c:pt>
                <c:pt idx="62">
                  <c:v>0.32579999999999998</c:v>
                </c:pt>
                <c:pt idx="63">
                  <c:v>0.32750000000000001</c:v>
                </c:pt>
                <c:pt idx="64">
                  <c:v>0.34289999999999998</c:v>
                </c:pt>
                <c:pt idx="65">
                  <c:v>0.32669999999999999</c:v>
                </c:pt>
                <c:pt idx="66">
                  <c:v>0.309</c:v>
                </c:pt>
                <c:pt idx="67">
                  <c:v>0.32829999999999998</c:v>
                </c:pt>
                <c:pt idx="68">
                  <c:v>0.33150000000000002</c:v>
                </c:pt>
                <c:pt idx="69">
                  <c:v>0.31569999999999998</c:v>
                </c:pt>
                <c:pt idx="70">
                  <c:v>0.3095</c:v>
                </c:pt>
                <c:pt idx="71">
                  <c:v>0.32069999999999999</c:v>
                </c:pt>
                <c:pt idx="72">
                  <c:v>0.30830000000000002</c:v>
                </c:pt>
                <c:pt idx="73">
                  <c:v>0.29680000000000001</c:v>
                </c:pt>
                <c:pt idx="74">
                  <c:v>0.31900000000000001</c:v>
                </c:pt>
                <c:pt idx="75">
                  <c:v>0.3266</c:v>
                </c:pt>
                <c:pt idx="76">
                  <c:v>0.31209999999999999</c:v>
                </c:pt>
                <c:pt idx="77">
                  <c:v>0.31540000000000001</c:v>
                </c:pt>
                <c:pt idx="78">
                  <c:v>0.3377</c:v>
                </c:pt>
                <c:pt idx="79">
                  <c:v>0.33579999999999999</c:v>
                </c:pt>
                <c:pt idx="80">
                  <c:v>0.32840000000000003</c:v>
                </c:pt>
                <c:pt idx="81">
                  <c:v>0.33300000000000002</c:v>
                </c:pt>
                <c:pt idx="82">
                  <c:v>0.35</c:v>
                </c:pt>
                <c:pt idx="83">
                  <c:v>0.37340000000000001</c:v>
                </c:pt>
                <c:pt idx="84">
                  <c:v>0.42649999999999999</c:v>
                </c:pt>
                <c:pt idx="85">
                  <c:v>0.49730000000000002</c:v>
                </c:pt>
                <c:pt idx="86">
                  <c:v>0.57179999999999997</c:v>
                </c:pt>
                <c:pt idx="87">
                  <c:v>0.68340000000000001</c:v>
                </c:pt>
                <c:pt idx="88">
                  <c:v>0.73729999999999996</c:v>
                </c:pt>
                <c:pt idx="89">
                  <c:v>0.85219999999999996</c:v>
                </c:pt>
                <c:pt idx="90">
                  <c:v>0.90300000000000002</c:v>
                </c:pt>
                <c:pt idx="91">
                  <c:v>0.77410000000000001</c:v>
                </c:pt>
                <c:pt idx="92">
                  <c:v>0.7379</c:v>
                </c:pt>
                <c:pt idx="93">
                  <c:v>0.64880000000000004</c:v>
                </c:pt>
                <c:pt idx="94">
                  <c:v>0.52849999999999997</c:v>
                </c:pt>
                <c:pt idx="95">
                  <c:v>0.4844</c:v>
                </c:pt>
                <c:pt idx="96">
                  <c:v>0.39550000000000002</c:v>
                </c:pt>
                <c:pt idx="97">
                  <c:v>0.36549999999999999</c:v>
                </c:pt>
                <c:pt idx="98">
                  <c:v>0.3538</c:v>
                </c:pt>
                <c:pt idx="99">
                  <c:v>0.33679999999999999</c:v>
                </c:pt>
                <c:pt idx="100">
                  <c:v>0.31659999999999999</c:v>
                </c:pt>
                <c:pt idx="101">
                  <c:v>0.32350000000000001</c:v>
                </c:pt>
                <c:pt idx="102">
                  <c:v>0.33729999999999999</c:v>
                </c:pt>
                <c:pt idx="103">
                  <c:v>0.32790000000000002</c:v>
                </c:pt>
                <c:pt idx="104">
                  <c:v>0.31659999999999999</c:v>
                </c:pt>
                <c:pt idx="105">
                  <c:v>0.3306</c:v>
                </c:pt>
                <c:pt idx="106">
                  <c:v>0.34260000000000002</c:v>
                </c:pt>
                <c:pt idx="107">
                  <c:v>0.33069999999999999</c:v>
                </c:pt>
                <c:pt idx="108">
                  <c:v>0.32169999999999999</c:v>
                </c:pt>
                <c:pt idx="109">
                  <c:v>0.30299999999999999</c:v>
                </c:pt>
                <c:pt idx="110">
                  <c:v>0.2928</c:v>
                </c:pt>
                <c:pt idx="111">
                  <c:v>0.28139999999999998</c:v>
                </c:pt>
                <c:pt idx="112">
                  <c:v>0.25619999999999998</c:v>
                </c:pt>
                <c:pt idx="113">
                  <c:v>0.26040000000000002</c:v>
                </c:pt>
                <c:pt idx="114">
                  <c:v>0.26840000000000003</c:v>
                </c:pt>
                <c:pt idx="115">
                  <c:v>0.24560000000000001</c:v>
                </c:pt>
                <c:pt idx="116">
                  <c:v>0.22800000000000001</c:v>
                </c:pt>
                <c:pt idx="117">
                  <c:v>0.23530000000000001</c:v>
                </c:pt>
                <c:pt idx="118">
                  <c:v>0.23669999999999999</c:v>
                </c:pt>
                <c:pt idx="119">
                  <c:v>0.22539999999999999</c:v>
                </c:pt>
                <c:pt idx="120">
                  <c:v>0.23760000000000001</c:v>
                </c:pt>
                <c:pt idx="121">
                  <c:v>0.26219999999999999</c:v>
                </c:pt>
                <c:pt idx="122">
                  <c:v>0.26129999999999998</c:v>
                </c:pt>
                <c:pt idx="123">
                  <c:v>0.25800000000000001</c:v>
                </c:pt>
                <c:pt idx="124">
                  <c:v>0.27929999999999999</c:v>
                </c:pt>
                <c:pt idx="125">
                  <c:v>0.2974</c:v>
                </c:pt>
                <c:pt idx="126">
                  <c:v>0.30320000000000003</c:v>
                </c:pt>
                <c:pt idx="127">
                  <c:v>0.32790000000000002</c:v>
                </c:pt>
                <c:pt idx="128">
                  <c:v>0.33210000000000001</c:v>
                </c:pt>
                <c:pt idx="129">
                  <c:v>0.3226</c:v>
                </c:pt>
                <c:pt idx="130">
                  <c:v>0.33350000000000002</c:v>
                </c:pt>
                <c:pt idx="131">
                  <c:v>0.35809999999999997</c:v>
                </c:pt>
                <c:pt idx="132">
                  <c:v>0.36030000000000001</c:v>
                </c:pt>
                <c:pt idx="133">
                  <c:v>0.3498</c:v>
                </c:pt>
                <c:pt idx="134">
                  <c:v>0.3533</c:v>
                </c:pt>
                <c:pt idx="135">
                  <c:v>0.31759999999999999</c:v>
                </c:pt>
                <c:pt idx="136">
                  <c:v>0.30769999999999997</c:v>
                </c:pt>
                <c:pt idx="137">
                  <c:v>0.30919999999999997</c:v>
                </c:pt>
                <c:pt idx="138">
                  <c:v>0.30759999999999998</c:v>
                </c:pt>
                <c:pt idx="139">
                  <c:v>0.31109999999999999</c:v>
                </c:pt>
                <c:pt idx="140">
                  <c:v>0.31719999999999998</c:v>
                </c:pt>
                <c:pt idx="141">
                  <c:v>0.31940000000000002</c:v>
                </c:pt>
                <c:pt idx="142">
                  <c:v>0.35160000000000002</c:v>
                </c:pt>
                <c:pt idx="143">
                  <c:v>0.25080000000000002</c:v>
                </c:pt>
                <c:pt idx="144">
                  <c:v>0.23469999999999999</c:v>
                </c:pt>
                <c:pt idx="145">
                  <c:v>0.2404</c:v>
                </c:pt>
                <c:pt idx="146">
                  <c:v>0.2487</c:v>
                </c:pt>
                <c:pt idx="147">
                  <c:v>0.23880000000000001</c:v>
                </c:pt>
                <c:pt idx="148">
                  <c:v>0.23369999999999999</c:v>
                </c:pt>
                <c:pt idx="149">
                  <c:v>0.24660000000000001</c:v>
                </c:pt>
                <c:pt idx="150">
                  <c:v>0.2495</c:v>
                </c:pt>
                <c:pt idx="151">
                  <c:v>0.2364</c:v>
                </c:pt>
                <c:pt idx="152">
                  <c:v>0.24030000000000001</c:v>
                </c:pt>
                <c:pt idx="153">
                  <c:v>0.25559999999999999</c:v>
                </c:pt>
                <c:pt idx="154">
                  <c:v>0.25309999999999999</c:v>
                </c:pt>
                <c:pt idx="155">
                  <c:v>0.2457</c:v>
                </c:pt>
                <c:pt idx="156">
                  <c:v>0.25269999999999998</c:v>
                </c:pt>
                <c:pt idx="157">
                  <c:v>0.25940000000000002</c:v>
                </c:pt>
                <c:pt idx="158">
                  <c:v>0.25140000000000001</c:v>
                </c:pt>
                <c:pt idx="159">
                  <c:v>0.24510000000000001</c:v>
                </c:pt>
                <c:pt idx="160">
                  <c:v>0.25950000000000001</c:v>
                </c:pt>
                <c:pt idx="161">
                  <c:v>0.25950000000000001</c:v>
                </c:pt>
                <c:pt idx="162">
                  <c:v>0.2442</c:v>
                </c:pt>
                <c:pt idx="163">
                  <c:v>0.25430000000000003</c:v>
                </c:pt>
                <c:pt idx="164">
                  <c:v>0.27339999999999998</c:v>
                </c:pt>
                <c:pt idx="165">
                  <c:v>0.26319999999999999</c:v>
                </c:pt>
                <c:pt idx="166">
                  <c:v>0.2555</c:v>
                </c:pt>
                <c:pt idx="167">
                  <c:v>0.2641</c:v>
                </c:pt>
                <c:pt idx="168">
                  <c:v>0.27210000000000001</c:v>
                </c:pt>
                <c:pt idx="169">
                  <c:v>0.27250000000000002</c:v>
                </c:pt>
                <c:pt idx="170">
                  <c:v>0.2626</c:v>
                </c:pt>
                <c:pt idx="171">
                  <c:v>0.28360000000000002</c:v>
                </c:pt>
                <c:pt idx="172">
                  <c:v>0.28399999999999997</c:v>
                </c:pt>
                <c:pt idx="173">
                  <c:v>0.34060000000000001</c:v>
                </c:pt>
                <c:pt idx="174">
                  <c:v>0.53029999999999999</c:v>
                </c:pt>
                <c:pt idx="175">
                  <c:v>0.65749999999999997</c:v>
                </c:pt>
                <c:pt idx="176">
                  <c:v>0.52459999999999996</c:v>
                </c:pt>
                <c:pt idx="177">
                  <c:v>0.5504</c:v>
                </c:pt>
                <c:pt idx="178">
                  <c:v>0.53700000000000003</c:v>
                </c:pt>
                <c:pt idx="179">
                  <c:v>0.50039999999999996</c:v>
                </c:pt>
                <c:pt idx="180">
                  <c:v>0.44840000000000002</c:v>
                </c:pt>
                <c:pt idx="181">
                  <c:v>0.37369999999999998</c:v>
                </c:pt>
                <c:pt idx="182">
                  <c:v>0.35070000000000001</c:v>
                </c:pt>
                <c:pt idx="183">
                  <c:v>0.33939999999999998</c:v>
                </c:pt>
                <c:pt idx="184">
                  <c:v>0.34820000000000001</c:v>
                </c:pt>
                <c:pt idx="185">
                  <c:v>0.35110000000000002</c:v>
                </c:pt>
                <c:pt idx="186">
                  <c:v>0.33040000000000003</c:v>
                </c:pt>
                <c:pt idx="187">
                  <c:v>0.3266</c:v>
                </c:pt>
                <c:pt idx="188">
                  <c:v>0.3468</c:v>
                </c:pt>
                <c:pt idx="189">
                  <c:v>0.3387</c:v>
                </c:pt>
                <c:pt idx="190">
                  <c:v>0.31540000000000001</c:v>
                </c:pt>
                <c:pt idx="191">
                  <c:v>0.32969999999999999</c:v>
                </c:pt>
                <c:pt idx="192">
                  <c:v>0.34839999999999999</c:v>
                </c:pt>
                <c:pt idx="193">
                  <c:v>0.32619999999999999</c:v>
                </c:pt>
                <c:pt idx="194">
                  <c:v>0.31669999999999998</c:v>
                </c:pt>
                <c:pt idx="195">
                  <c:v>0.34150000000000003</c:v>
                </c:pt>
                <c:pt idx="196">
                  <c:v>0.34460000000000002</c:v>
                </c:pt>
                <c:pt idx="197">
                  <c:v>0.32</c:v>
                </c:pt>
                <c:pt idx="198">
                  <c:v>0.3286</c:v>
                </c:pt>
                <c:pt idx="199">
                  <c:v>0.35110000000000002</c:v>
                </c:pt>
                <c:pt idx="200">
                  <c:v>0.34089999999999998</c:v>
                </c:pt>
                <c:pt idx="201">
                  <c:v>0.32450000000000001</c:v>
                </c:pt>
                <c:pt idx="202">
                  <c:v>0.3468</c:v>
                </c:pt>
                <c:pt idx="203">
                  <c:v>0.34539999999999998</c:v>
                </c:pt>
                <c:pt idx="204">
                  <c:v>0.35060000000000002</c:v>
                </c:pt>
                <c:pt idx="205">
                  <c:v>0.34889999999999999</c:v>
                </c:pt>
                <c:pt idx="206">
                  <c:v>0.37209999999999999</c:v>
                </c:pt>
                <c:pt idx="207">
                  <c:v>0.3231</c:v>
                </c:pt>
                <c:pt idx="208">
                  <c:v>0.29139999999999999</c:v>
                </c:pt>
                <c:pt idx="209">
                  <c:v>0.26140000000000002</c:v>
                </c:pt>
                <c:pt idx="210">
                  <c:v>0.22020000000000001</c:v>
                </c:pt>
                <c:pt idx="211">
                  <c:v>0.22459999999999999</c:v>
                </c:pt>
                <c:pt idx="212">
                  <c:v>0.24030000000000001</c:v>
                </c:pt>
                <c:pt idx="213">
                  <c:v>0.27029999999999998</c:v>
                </c:pt>
                <c:pt idx="214">
                  <c:v>0.26939999999999997</c:v>
                </c:pt>
                <c:pt idx="215">
                  <c:v>0.2636</c:v>
                </c:pt>
                <c:pt idx="216">
                  <c:v>0.28439999999999999</c:v>
                </c:pt>
                <c:pt idx="217">
                  <c:v>0.29749999999999999</c:v>
                </c:pt>
                <c:pt idx="218">
                  <c:v>0.28939999999999999</c:v>
                </c:pt>
                <c:pt idx="219">
                  <c:v>0.28560000000000002</c:v>
                </c:pt>
                <c:pt idx="220">
                  <c:v>0.307</c:v>
                </c:pt>
                <c:pt idx="221">
                  <c:v>0.31459999999999999</c:v>
                </c:pt>
                <c:pt idx="222">
                  <c:v>0.29549999999999998</c:v>
                </c:pt>
                <c:pt idx="223">
                  <c:v>0.30020000000000002</c:v>
                </c:pt>
                <c:pt idx="224">
                  <c:v>0.32379999999999998</c:v>
                </c:pt>
                <c:pt idx="225">
                  <c:v>0.314</c:v>
                </c:pt>
                <c:pt idx="226">
                  <c:v>0.29310000000000003</c:v>
                </c:pt>
                <c:pt idx="227">
                  <c:v>0.30840000000000001</c:v>
                </c:pt>
                <c:pt idx="228">
                  <c:v>0.32250000000000001</c:v>
                </c:pt>
                <c:pt idx="229">
                  <c:v>0.316</c:v>
                </c:pt>
                <c:pt idx="230">
                  <c:v>0.33779999999999999</c:v>
                </c:pt>
                <c:pt idx="231">
                  <c:v>0.32519999999999999</c:v>
                </c:pt>
                <c:pt idx="232">
                  <c:v>0.31640000000000001</c:v>
                </c:pt>
                <c:pt idx="233">
                  <c:v>0.29409999999999997</c:v>
                </c:pt>
                <c:pt idx="234">
                  <c:v>0.27610000000000001</c:v>
                </c:pt>
                <c:pt idx="235">
                  <c:v>0.25219999999999998</c:v>
                </c:pt>
                <c:pt idx="236">
                  <c:v>0.25119999999999998</c:v>
                </c:pt>
                <c:pt idx="237">
                  <c:v>0.26179999999999998</c:v>
                </c:pt>
                <c:pt idx="238">
                  <c:v>0.2661</c:v>
                </c:pt>
                <c:pt idx="239">
                  <c:v>0.27479999999999999</c:v>
                </c:pt>
                <c:pt idx="240">
                  <c:v>0.26750000000000002</c:v>
                </c:pt>
                <c:pt idx="241">
                  <c:v>0.27510000000000001</c:v>
                </c:pt>
                <c:pt idx="242">
                  <c:v>0.2697</c:v>
                </c:pt>
                <c:pt idx="243">
                  <c:v>0.27910000000000001</c:v>
                </c:pt>
                <c:pt idx="244">
                  <c:v>0.27779999999999999</c:v>
                </c:pt>
                <c:pt idx="245">
                  <c:v>0.28610000000000002</c:v>
                </c:pt>
                <c:pt idx="246">
                  <c:v>0.31780000000000003</c:v>
                </c:pt>
                <c:pt idx="247">
                  <c:v>0.33800000000000002</c:v>
                </c:pt>
                <c:pt idx="248">
                  <c:v>0.38059999999999999</c:v>
                </c:pt>
                <c:pt idx="249">
                  <c:v>0.39050000000000001</c:v>
                </c:pt>
                <c:pt idx="250">
                  <c:v>0.34970000000000001</c:v>
                </c:pt>
                <c:pt idx="251">
                  <c:v>0.32400000000000001</c:v>
                </c:pt>
                <c:pt idx="252">
                  <c:v>0.2959</c:v>
                </c:pt>
                <c:pt idx="253">
                  <c:v>0.29239999999999999</c:v>
                </c:pt>
                <c:pt idx="254">
                  <c:v>0.28310000000000002</c:v>
                </c:pt>
                <c:pt idx="255">
                  <c:v>0.27839999999999998</c:v>
                </c:pt>
                <c:pt idx="256">
                  <c:v>0.27550000000000002</c:v>
                </c:pt>
                <c:pt idx="257">
                  <c:v>0.2681</c:v>
                </c:pt>
                <c:pt idx="258">
                  <c:v>0.26169999999999999</c:v>
                </c:pt>
                <c:pt idx="259">
                  <c:v>0.2596</c:v>
                </c:pt>
                <c:pt idx="260">
                  <c:v>0.25440000000000002</c:v>
                </c:pt>
                <c:pt idx="261">
                  <c:v>0.24979999999999999</c:v>
                </c:pt>
                <c:pt idx="262">
                  <c:v>0.248</c:v>
                </c:pt>
                <c:pt idx="263">
                  <c:v>0.2462</c:v>
                </c:pt>
                <c:pt idx="264">
                  <c:v>0.25800000000000001</c:v>
                </c:pt>
                <c:pt idx="265">
                  <c:v>0.27310000000000001</c:v>
                </c:pt>
                <c:pt idx="266">
                  <c:v>0.29160000000000003</c:v>
                </c:pt>
                <c:pt idx="267">
                  <c:v>0.3145</c:v>
                </c:pt>
                <c:pt idx="268">
                  <c:v>0.30349999999999999</c:v>
                </c:pt>
                <c:pt idx="269">
                  <c:v>0.29559999999999997</c:v>
                </c:pt>
                <c:pt idx="270">
                  <c:v>0.31769999999999998</c:v>
                </c:pt>
                <c:pt idx="271">
                  <c:v>0.32729999999999998</c:v>
                </c:pt>
                <c:pt idx="272">
                  <c:v>0.31879999999999997</c:v>
                </c:pt>
                <c:pt idx="273">
                  <c:v>0.3206</c:v>
                </c:pt>
                <c:pt idx="274">
                  <c:v>0.33479999999999999</c:v>
                </c:pt>
                <c:pt idx="275">
                  <c:v>0.3382</c:v>
                </c:pt>
                <c:pt idx="276">
                  <c:v>0.33250000000000002</c:v>
                </c:pt>
                <c:pt idx="277">
                  <c:v>0.34360000000000002</c:v>
                </c:pt>
                <c:pt idx="278">
                  <c:v>0.35720000000000002</c:v>
                </c:pt>
                <c:pt idx="279">
                  <c:v>0.35670000000000002</c:v>
                </c:pt>
                <c:pt idx="280">
                  <c:v>0.36159999999999998</c:v>
                </c:pt>
                <c:pt idx="281">
                  <c:v>0.37790000000000001</c:v>
                </c:pt>
                <c:pt idx="282">
                  <c:v>0.38450000000000001</c:v>
                </c:pt>
                <c:pt idx="283">
                  <c:v>0.37890000000000001</c:v>
                </c:pt>
                <c:pt idx="284">
                  <c:v>0.38919999999999999</c:v>
                </c:pt>
                <c:pt idx="285">
                  <c:v>0.41360000000000002</c:v>
                </c:pt>
                <c:pt idx="286">
                  <c:v>0.41370000000000001</c:v>
                </c:pt>
                <c:pt idx="287">
                  <c:v>0.44350000000000001</c:v>
                </c:pt>
                <c:pt idx="288">
                  <c:v>0.4143</c:v>
                </c:pt>
                <c:pt idx="289">
                  <c:v>0.40899999999999997</c:v>
                </c:pt>
                <c:pt idx="290">
                  <c:v>0.41349999999999998</c:v>
                </c:pt>
                <c:pt idx="291">
                  <c:v>0.37059999999999998</c:v>
                </c:pt>
                <c:pt idx="292">
                  <c:v>0.38829999999999998</c:v>
                </c:pt>
                <c:pt idx="293">
                  <c:v>0.41460000000000002</c:v>
                </c:pt>
                <c:pt idx="294">
                  <c:v>0.38240000000000002</c:v>
                </c:pt>
                <c:pt idx="295">
                  <c:v>0.37230000000000002</c:v>
                </c:pt>
                <c:pt idx="296">
                  <c:v>0.35589999999999999</c:v>
                </c:pt>
                <c:pt idx="297">
                  <c:v>0.33679999999999999</c:v>
                </c:pt>
                <c:pt idx="298">
                  <c:v>0.32279999999999998</c:v>
                </c:pt>
                <c:pt idx="299">
                  <c:v>0.32619999999999999</c:v>
                </c:pt>
                <c:pt idx="300">
                  <c:v>0.32169999999999999</c:v>
                </c:pt>
                <c:pt idx="301">
                  <c:v>0.30840000000000001</c:v>
                </c:pt>
                <c:pt idx="302">
                  <c:v>0.30880000000000002</c:v>
                </c:pt>
                <c:pt idx="303">
                  <c:v>0.32629999999999998</c:v>
                </c:pt>
                <c:pt idx="304">
                  <c:v>0.36130000000000001</c:v>
                </c:pt>
                <c:pt idx="305">
                  <c:v>0.36649999999999999</c:v>
                </c:pt>
                <c:pt idx="306">
                  <c:v>0.36880000000000002</c:v>
                </c:pt>
                <c:pt idx="307">
                  <c:v>0.36020000000000002</c:v>
                </c:pt>
                <c:pt idx="308">
                  <c:v>0.35870000000000002</c:v>
                </c:pt>
                <c:pt idx="309">
                  <c:v>0.35389999999999999</c:v>
                </c:pt>
                <c:pt idx="310">
                  <c:v>0.36199999999999999</c:v>
                </c:pt>
                <c:pt idx="311">
                  <c:v>0.372</c:v>
                </c:pt>
                <c:pt idx="312">
                  <c:v>0.36570000000000003</c:v>
                </c:pt>
                <c:pt idx="313">
                  <c:v>0.35549999999999998</c:v>
                </c:pt>
                <c:pt idx="314">
                  <c:v>0.3478</c:v>
                </c:pt>
                <c:pt idx="315">
                  <c:v>0.37030000000000002</c:v>
                </c:pt>
                <c:pt idx="316">
                  <c:v>0.4073</c:v>
                </c:pt>
                <c:pt idx="317">
                  <c:v>0.4486</c:v>
                </c:pt>
                <c:pt idx="318">
                  <c:v>0.42159999999999997</c:v>
                </c:pt>
                <c:pt idx="319">
                  <c:v>0.39300000000000002</c:v>
                </c:pt>
                <c:pt idx="320">
                  <c:v>0.4108</c:v>
                </c:pt>
                <c:pt idx="321">
                  <c:v>0.43240000000000001</c:v>
                </c:pt>
                <c:pt idx="322">
                  <c:v>0.40429999999999999</c:v>
                </c:pt>
                <c:pt idx="323">
                  <c:v>0.38690000000000002</c:v>
                </c:pt>
                <c:pt idx="324">
                  <c:v>0.41839999999999999</c:v>
                </c:pt>
                <c:pt idx="325">
                  <c:v>0.4259</c:v>
                </c:pt>
                <c:pt idx="326">
                  <c:v>0.39179999999999998</c:v>
                </c:pt>
                <c:pt idx="327">
                  <c:v>0.38669999999999999</c:v>
                </c:pt>
                <c:pt idx="328">
                  <c:v>0.41510000000000002</c:v>
                </c:pt>
                <c:pt idx="329">
                  <c:v>0.40870000000000001</c:v>
                </c:pt>
                <c:pt idx="330">
                  <c:v>0.37509999999999999</c:v>
                </c:pt>
                <c:pt idx="331">
                  <c:v>0.37709999999999999</c:v>
                </c:pt>
                <c:pt idx="332">
                  <c:v>0.38269999999999998</c:v>
                </c:pt>
                <c:pt idx="333">
                  <c:v>0.35749999999999998</c:v>
                </c:pt>
                <c:pt idx="334">
                  <c:v>0.39660000000000001</c:v>
                </c:pt>
                <c:pt idx="335">
                  <c:v>0.31409999999999999</c:v>
                </c:pt>
                <c:pt idx="336">
                  <c:v>0.33600000000000002</c:v>
                </c:pt>
                <c:pt idx="337">
                  <c:v>0.31109999999999999</c:v>
                </c:pt>
                <c:pt idx="338">
                  <c:v>0.31390000000000001</c:v>
                </c:pt>
                <c:pt idx="339">
                  <c:v>0.30149999999999999</c:v>
                </c:pt>
                <c:pt idx="340">
                  <c:v>0.31359999999999999</c:v>
                </c:pt>
                <c:pt idx="341">
                  <c:v>0.30049999999999999</c:v>
                </c:pt>
                <c:pt idx="342">
                  <c:v>0.2863</c:v>
                </c:pt>
                <c:pt idx="343">
                  <c:v>0.31280000000000002</c:v>
                </c:pt>
                <c:pt idx="344">
                  <c:v>0.32319999999999999</c:v>
                </c:pt>
                <c:pt idx="345">
                  <c:v>0.34239999999999998</c:v>
                </c:pt>
                <c:pt idx="346">
                  <c:v>0.32140000000000002</c:v>
                </c:pt>
                <c:pt idx="347">
                  <c:v>0.32440000000000002</c:v>
                </c:pt>
                <c:pt idx="348">
                  <c:v>0.29970000000000002</c:v>
                </c:pt>
                <c:pt idx="349">
                  <c:v>0.29709999999999998</c:v>
                </c:pt>
                <c:pt idx="350">
                  <c:v>0.28710000000000002</c:v>
                </c:pt>
                <c:pt idx="351">
                  <c:v>0.27839999999999998</c:v>
                </c:pt>
                <c:pt idx="352">
                  <c:v>0.27929999999999999</c:v>
                </c:pt>
                <c:pt idx="353">
                  <c:v>0.26929999999999998</c:v>
                </c:pt>
                <c:pt idx="354">
                  <c:v>0.25990000000000002</c:v>
                </c:pt>
                <c:pt idx="355">
                  <c:v>0.23330000000000001</c:v>
                </c:pt>
                <c:pt idx="356">
                  <c:v>0.2671</c:v>
                </c:pt>
                <c:pt idx="357">
                  <c:v>0.2331</c:v>
                </c:pt>
                <c:pt idx="358">
                  <c:v>0.24429999999999999</c:v>
                </c:pt>
                <c:pt idx="359">
                  <c:v>0.23380000000000001</c:v>
                </c:pt>
                <c:pt idx="360">
                  <c:v>0.2467</c:v>
                </c:pt>
                <c:pt idx="361">
                  <c:v>0.24640000000000001</c:v>
                </c:pt>
                <c:pt idx="362">
                  <c:v>0.24979999999999999</c:v>
                </c:pt>
                <c:pt idx="363">
                  <c:v>0.25140000000000001</c:v>
                </c:pt>
                <c:pt idx="364">
                  <c:v>0.2646</c:v>
                </c:pt>
                <c:pt idx="365">
                  <c:v>0.26329999999999998</c:v>
                </c:pt>
                <c:pt idx="366">
                  <c:v>0.2802</c:v>
                </c:pt>
                <c:pt idx="367">
                  <c:v>0.29210000000000003</c:v>
                </c:pt>
                <c:pt idx="368">
                  <c:v>0.30940000000000001</c:v>
                </c:pt>
                <c:pt idx="369">
                  <c:v>0.3014</c:v>
                </c:pt>
                <c:pt idx="370">
                  <c:v>0.27929999999999999</c:v>
                </c:pt>
                <c:pt idx="371">
                  <c:v>0.26190000000000002</c:v>
                </c:pt>
                <c:pt idx="372">
                  <c:v>0.26319999999999999</c:v>
                </c:pt>
                <c:pt idx="373">
                  <c:v>0.26329999999999998</c:v>
                </c:pt>
                <c:pt idx="374">
                  <c:v>0.26250000000000001</c:v>
                </c:pt>
                <c:pt idx="375">
                  <c:v>0.28170000000000001</c:v>
                </c:pt>
                <c:pt idx="376">
                  <c:v>0.27189999999999998</c:v>
                </c:pt>
                <c:pt idx="377">
                  <c:v>0.23100000000000001</c:v>
                </c:pt>
                <c:pt idx="378">
                  <c:v>0.2571</c:v>
                </c:pt>
                <c:pt idx="379">
                  <c:v>0.25019999999999998</c:v>
                </c:pt>
                <c:pt idx="380">
                  <c:v>0.26540000000000002</c:v>
                </c:pt>
                <c:pt idx="381">
                  <c:v>0.2873</c:v>
                </c:pt>
                <c:pt idx="382">
                  <c:v>0.31180000000000002</c:v>
                </c:pt>
                <c:pt idx="383">
                  <c:v>0.32029999999999997</c:v>
                </c:pt>
                <c:pt idx="384">
                  <c:v>0.33040000000000003</c:v>
                </c:pt>
                <c:pt idx="385">
                  <c:v>0.30669999999999997</c:v>
                </c:pt>
                <c:pt idx="386">
                  <c:v>0.27439999999999998</c:v>
                </c:pt>
                <c:pt idx="387">
                  <c:v>0.26179999999999998</c:v>
                </c:pt>
                <c:pt idx="388">
                  <c:v>0.30149999999999999</c:v>
                </c:pt>
                <c:pt idx="389">
                  <c:v>0.37469999999999998</c:v>
                </c:pt>
                <c:pt idx="390">
                  <c:v>0.3458</c:v>
                </c:pt>
                <c:pt idx="391">
                  <c:v>0.45590000000000003</c:v>
                </c:pt>
                <c:pt idx="392">
                  <c:v>0.45529999999999998</c:v>
                </c:pt>
                <c:pt idx="393">
                  <c:v>0.43340000000000001</c:v>
                </c:pt>
                <c:pt idx="394">
                  <c:v>0.51559999999999995</c:v>
                </c:pt>
                <c:pt idx="395">
                  <c:v>0.42130000000000001</c:v>
                </c:pt>
                <c:pt idx="396">
                  <c:v>0.39150000000000001</c:v>
                </c:pt>
                <c:pt idx="397">
                  <c:v>0.40100000000000002</c:v>
                </c:pt>
                <c:pt idx="398">
                  <c:v>0.44280000000000003</c:v>
                </c:pt>
                <c:pt idx="399">
                  <c:v>0.497</c:v>
                </c:pt>
                <c:pt idx="400">
                  <c:v>0.47610000000000002</c:v>
                </c:pt>
                <c:pt idx="401">
                  <c:v>0.37959999999999999</c:v>
                </c:pt>
                <c:pt idx="402">
                  <c:v>0.40670000000000001</c:v>
                </c:pt>
                <c:pt idx="403">
                  <c:v>0.2326</c:v>
                </c:pt>
                <c:pt idx="404">
                  <c:v>0.19620000000000001</c:v>
                </c:pt>
                <c:pt idx="405">
                  <c:v>0.20030000000000001</c:v>
                </c:pt>
                <c:pt idx="406">
                  <c:v>0.2429</c:v>
                </c:pt>
                <c:pt idx="407">
                  <c:v>0.2135</c:v>
                </c:pt>
                <c:pt idx="408">
                  <c:v>0.2109</c:v>
                </c:pt>
                <c:pt idx="409">
                  <c:v>0.20449999999999999</c:v>
                </c:pt>
                <c:pt idx="410">
                  <c:v>0.2029</c:v>
                </c:pt>
                <c:pt idx="411">
                  <c:v>0.21959999999999999</c:v>
                </c:pt>
                <c:pt idx="412">
                  <c:v>0.217</c:v>
                </c:pt>
                <c:pt idx="413">
                  <c:v>0.20469999999999999</c:v>
                </c:pt>
                <c:pt idx="414">
                  <c:v>0.22209999999999999</c:v>
                </c:pt>
                <c:pt idx="415">
                  <c:v>0.2301</c:v>
                </c:pt>
                <c:pt idx="416">
                  <c:v>0.21890000000000001</c:v>
                </c:pt>
                <c:pt idx="417">
                  <c:v>0.22919999999999999</c:v>
                </c:pt>
                <c:pt idx="418">
                  <c:v>0.25459999999999999</c:v>
                </c:pt>
                <c:pt idx="419">
                  <c:v>0.25259999999999999</c:v>
                </c:pt>
                <c:pt idx="420">
                  <c:v>0.2402</c:v>
                </c:pt>
                <c:pt idx="421">
                  <c:v>0.2422</c:v>
                </c:pt>
                <c:pt idx="422">
                  <c:v>0.26690000000000003</c:v>
                </c:pt>
                <c:pt idx="423">
                  <c:v>0.28249999999999997</c:v>
                </c:pt>
                <c:pt idx="424">
                  <c:v>0.27839999999999998</c:v>
                </c:pt>
                <c:pt idx="425">
                  <c:v>0.30170000000000002</c:v>
                </c:pt>
                <c:pt idx="426">
                  <c:v>0.2989</c:v>
                </c:pt>
                <c:pt idx="427">
                  <c:v>0.30230000000000001</c:v>
                </c:pt>
                <c:pt idx="428">
                  <c:v>0.28539999999999999</c:v>
                </c:pt>
                <c:pt idx="429">
                  <c:v>0.28489999999999999</c:v>
                </c:pt>
                <c:pt idx="430">
                  <c:v>0.30990000000000001</c:v>
                </c:pt>
                <c:pt idx="431">
                  <c:v>0.28920000000000001</c:v>
                </c:pt>
                <c:pt idx="432">
                  <c:v>0.27489999999999998</c:v>
                </c:pt>
                <c:pt idx="433">
                  <c:v>0.30259999999999998</c:v>
                </c:pt>
                <c:pt idx="434">
                  <c:v>0.30790000000000001</c:v>
                </c:pt>
                <c:pt idx="435">
                  <c:v>0.28199999999999997</c:v>
                </c:pt>
                <c:pt idx="436">
                  <c:v>0.29299999999999998</c:v>
                </c:pt>
                <c:pt idx="437">
                  <c:v>0.32229999999999998</c:v>
                </c:pt>
                <c:pt idx="438">
                  <c:v>0.3115</c:v>
                </c:pt>
                <c:pt idx="439">
                  <c:v>0.30680000000000002</c:v>
                </c:pt>
                <c:pt idx="440">
                  <c:v>0.33300000000000002</c:v>
                </c:pt>
                <c:pt idx="441">
                  <c:v>0.39379999999999998</c:v>
                </c:pt>
                <c:pt idx="442">
                  <c:v>0.376</c:v>
                </c:pt>
                <c:pt idx="443">
                  <c:v>0.33090000000000003</c:v>
                </c:pt>
                <c:pt idx="444">
                  <c:v>0.3024</c:v>
                </c:pt>
                <c:pt idx="445">
                  <c:v>0.32050000000000001</c:v>
                </c:pt>
                <c:pt idx="446">
                  <c:v>0.32090000000000002</c:v>
                </c:pt>
                <c:pt idx="447">
                  <c:v>0.3</c:v>
                </c:pt>
                <c:pt idx="448">
                  <c:v>0.31940000000000002</c:v>
                </c:pt>
                <c:pt idx="449">
                  <c:v>0.32579999999999998</c:v>
                </c:pt>
                <c:pt idx="450">
                  <c:v>0.28639999999999999</c:v>
                </c:pt>
                <c:pt idx="451">
                  <c:v>0.28010000000000002</c:v>
                </c:pt>
                <c:pt idx="452">
                  <c:v>0.31540000000000001</c:v>
                </c:pt>
                <c:pt idx="453">
                  <c:v>0.30809999999999998</c:v>
                </c:pt>
                <c:pt idx="454">
                  <c:v>0.27460000000000001</c:v>
                </c:pt>
                <c:pt idx="455">
                  <c:v>0.28449999999999998</c:v>
                </c:pt>
                <c:pt idx="456">
                  <c:v>0.30649999999999999</c:v>
                </c:pt>
                <c:pt idx="457">
                  <c:v>0.29699999999999999</c:v>
                </c:pt>
                <c:pt idx="458">
                  <c:v>0.2752</c:v>
                </c:pt>
                <c:pt idx="459">
                  <c:v>0.29199999999999998</c:v>
                </c:pt>
                <c:pt idx="460">
                  <c:v>0.32529999999999998</c:v>
                </c:pt>
                <c:pt idx="461">
                  <c:v>0.3382</c:v>
                </c:pt>
                <c:pt idx="462">
                  <c:v>0.36520000000000002</c:v>
                </c:pt>
                <c:pt idx="463">
                  <c:v>0.37530000000000002</c:v>
                </c:pt>
                <c:pt idx="464">
                  <c:v>0.43990000000000001</c:v>
                </c:pt>
                <c:pt idx="465">
                  <c:v>0.53069999999999995</c:v>
                </c:pt>
                <c:pt idx="466">
                  <c:v>0.53610000000000002</c:v>
                </c:pt>
                <c:pt idx="467">
                  <c:v>0.55010000000000003</c:v>
                </c:pt>
                <c:pt idx="468">
                  <c:v>0.59530000000000005</c:v>
                </c:pt>
                <c:pt idx="469">
                  <c:v>0.56969999999999998</c:v>
                </c:pt>
                <c:pt idx="470">
                  <c:v>0.55369999999999997</c:v>
                </c:pt>
                <c:pt idx="471">
                  <c:v>0.57879999999999998</c:v>
                </c:pt>
                <c:pt idx="472">
                  <c:v>0.52980000000000005</c:v>
                </c:pt>
                <c:pt idx="473">
                  <c:v>0.63160000000000005</c:v>
                </c:pt>
                <c:pt idx="474">
                  <c:v>0.62</c:v>
                </c:pt>
                <c:pt idx="475">
                  <c:v>0.43530000000000002</c:v>
                </c:pt>
                <c:pt idx="476">
                  <c:v>0.38840000000000002</c:v>
                </c:pt>
                <c:pt idx="477">
                  <c:v>0.39240000000000003</c:v>
                </c:pt>
                <c:pt idx="478">
                  <c:v>0.37780000000000002</c:v>
                </c:pt>
                <c:pt idx="479">
                  <c:v>0.3483</c:v>
                </c:pt>
                <c:pt idx="480">
                  <c:v>0.3402</c:v>
                </c:pt>
                <c:pt idx="481">
                  <c:v>0.34770000000000001</c:v>
                </c:pt>
                <c:pt idx="482">
                  <c:v>0.33260000000000001</c:v>
                </c:pt>
                <c:pt idx="483">
                  <c:v>0.30609999999999998</c:v>
                </c:pt>
                <c:pt idx="484">
                  <c:v>0.30759999999999998</c:v>
                </c:pt>
                <c:pt idx="485">
                  <c:v>0.3135</c:v>
                </c:pt>
                <c:pt idx="486">
                  <c:v>0.29020000000000001</c:v>
                </c:pt>
                <c:pt idx="487">
                  <c:v>0.26719999999999999</c:v>
                </c:pt>
                <c:pt idx="488">
                  <c:v>0.27550000000000002</c:v>
                </c:pt>
                <c:pt idx="489">
                  <c:v>0.28029999999999999</c:v>
                </c:pt>
                <c:pt idx="490">
                  <c:v>0.2545</c:v>
                </c:pt>
                <c:pt idx="491">
                  <c:v>0.2384</c:v>
                </c:pt>
                <c:pt idx="492">
                  <c:v>0.25559999999999999</c:v>
                </c:pt>
                <c:pt idx="493">
                  <c:v>0.25540000000000002</c:v>
                </c:pt>
                <c:pt idx="494">
                  <c:v>0.2258</c:v>
                </c:pt>
                <c:pt idx="495">
                  <c:v>0.22500000000000001</c:v>
                </c:pt>
                <c:pt idx="496">
                  <c:v>0.2412</c:v>
                </c:pt>
                <c:pt idx="497">
                  <c:v>0.2298</c:v>
                </c:pt>
                <c:pt idx="498">
                  <c:v>0.20649999999999999</c:v>
                </c:pt>
                <c:pt idx="499">
                  <c:v>0.2177</c:v>
                </c:pt>
                <c:pt idx="500">
                  <c:v>0.2346</c:v>
                </c:pt>
                <c:pt idx="501">
                  <c:v>0.22040000000000001</c:v>
                </c:pt>
                <c:pt idx="502">
                  <c:v>0.2029</c:v>
                </c:pt>
                <c:pt idx="503">
                  <c:v>0.22220000000000001</c:v>
                </c:pt>
                <c:pt idx="504">
                  <c:v>0.2366</c:v>
                </c:pt>
                <c:pt idx="505">
                  <c:v>0.22</c:v>
                </c:pt>
                <c:pt idx="506">
                  <c:v>0.2112</c:v>
                </c:pt>
                <c:pt idx="507">
                  <c:v>0.24060000000000001</c:v>
                </c:pt>
                <c:pt idx="508">
                  <c:v>0.25259999999999999</c:v>
                </c:pt>
                <c:pt idx="509">
                  <c:v>0.24210000000000001</c:v>
                </c:pt>
                <c:pt idx="510">
                  <c:v>0.24479999999999999</c:v>
                </c:pt>
                <c:pt idx="511">
                  <c:v>0.27400000000000002</c:v>
                </c:pt>
                <c:pt idx="512">
                  <c:v>0.27400000000000002</c:v>
                </c:pt>
                <c:pt idx="513">
                  <c:v>0.27229999999999999</c:v>
                </c:pt>
                <c:pt idx="514">
                  <c:v>0.26340000000000002</c:v>
                </c:pt>
                <c:pt idx="515">
                  <c:v>0.23369999999999999</c:v>
                </c:pt>
                <c:pt idx="516">
                  <c:v>0.2429</c:v>
                </c:pt>
                <c:pt idx="517">
                  <c:v>0.22650000000000001</c:v>
                </c:pt>
                <c:pt idx="518">
                  <c:v>0.2137</c:v>
                </c:pt>
                <c:pt idx="519">
                  <c:v>0.22770000000000001</c:v>
                </c:pt>
                <c:pt idx="520">
                  <c:v>0.23569999999999999</c:v>
                </c:pt>
                <c:pt idx="521">
                  <c:v>0.2157</c:v>
                </c:pt>
                <c:pt idx="522">
                  <c:v>0.2263</c:v>
                </c:pt>
                <c:pt idx="523">
                  <c:v>0.20530000000000001</c:v>
                </c:pt>
                <c:pt idx="524">
                  <c:v>0.19969999999999999</c:v>
                </c:pt>
                <c:pt idx="525">
                  <c:v>0.21229999999999999</c:v>
                </c:pt>
                <c:pt idx="526">
                  <c:v>0.20910000000000001</c:v>
                </c:pt>
                <c:pt idx="527">
                  <c:v>0.19639999999999999</c:v>
                </c:pt>
                <c:pt idx="528">
                  <c:v>0.19769999999999999</c:v>
                </c:pt>
                <c:pt idx="529">
                  <c:v>0.21240000000000001</c:v>
                </c:pt>
                <c:pt idx="530">
                  <c:v>0.20430000000000001</c:v>
                </c:pt>
                <c:pt idx="531">
                  <c:v>0.18640000000000001</c:v>
                </c:pt>
                <c:pt idx="532">
                  <c:v>0.2034</c:v>
                </c:pt>
                <c:pt idx="533">
                  <c:v>0.2165</c:v>
                </c:pt>
                <c:pt idx="534">
                  <c:v>0.1971</c:v>
                </c:pt>
                <c:pt idx="535">
                  <c:v>0.19189999999999999</c:v>
                </c:pt>
                <c:pt idx="536">
                  <c:v>0.2172</c:v>
                </c:pt>
                <c:pt idx="537">
                  <c:v>0.2203</c:v>
                </c:pt>
                <c:pt idx="538">
                  <c:v>0.20030000000000001</c:v>
                </c:pt>
                <c:pt idx="539">
                  <c:v>0.20430000000000001</c:v>
                </c:pt>
                <c:pt idx="540">
                  <c:v>0.21729999999999999</c:v>
                </c:pt>
                <c:pt idx="541">
                  <c:v>0.21229999999999999</c:v>
                </c:pt>
                <c:pt idx="542">
                  <c:v>0.23880000000000001</c:v>
                </c:pt>
                <c:pt idx="543">
                  <c:v>0.24049999999999999</c:v>
                </c:pt>
                <c:pt idx="544">
                  <c:v>0.2482</c:v>
                </c:pt>
                <c:pt idx="545">
                  <c:v>0.24970000000000001</c:v>
                </c:pt>
                <c:pt idx="546">
                  <c:v>0.2387</c:v>
                </c:pt>
                <c:pt idx="547">
                  <c:v>0.23419999999999999</c:v>
                </c:pt>
                <c:pt idx="548">
                  <c:v>0.2215</c:v>
                </c:pt>
                <c:pt idx="549">
                  <c:v>0.2412</c:v>
                </c:pt>
                <c:pt idx="550">
                  <c:v>0.23100000000000001</c:v>
                </c:pt>
                <c:pt idx="551">
                  <c:v>0.21629999999999999</c:v>
                </c:pt>
                <c:pt idx="552">
                  <c:v>0.24249999999999999</c:v>
                </c:pt>
                <c:pt idx="553">
                  <c:v>0.26229999999999998</c:v>
                </c:pt>
                <c:pt idx="554">
                  <c:v>0.24629999999999999</c:v>
                </c:pt>
                <c:pt idx="555">
                  <c:v>0.2387</c:v>
                </c:pt>
                <c:pt idx="556">
                  <c:v>0.2127</c:v>
                </c:pt>
                <c:pt idx="557">
                  <c:v>0.1794</c:v>
                </c:pt>
                <c:pt idx="558">
                  <c:v>0.1721</c:v>
                </c:pt>
                <c:pt idx="559">
                  <c:v>0.1706</c:v>
                </c:pt>
                <c:pt idx="560">
                  <c:v>0.17599999999999999</c:v>
                </c:pt>
                <c:pt idx="561">
                  <c:v>0.1769</c:v>
                </c:pt>
                <c:pt idx="562">
                  <c:v>0.17369999999999999</c:v>
                </c:pt>
                <c:pt idx="563">
                  <c:v>0.1736</c:v>
                </c:pt>
                <c:pt idx="564">
                  <c:v>0.1784</c:v>
                </c:pt>
                <c:pt idx="565">
                  <c:v>0.16700000000000001</c:v>
                </c:pt>
                <c:pt idx="566">
                  <c:v>0.15720000000000001</c:v>
                </c:pt>
                <c:pt idx="567">
                  <c:v>0.16950000000000001</c:v>
                </c:pt>
                <c:pt idx="568">
                  <c:v>0.17269999999999999</c:v>
                </c:pt>
                <c:pt idx="569">
                  <c:v>0.16520000000000001</c:v>
                </c:pt>
                <c:pt idx="570">
                  <c:v>0.1681</c:v>
                </c:pt>
                <c:pt idx="571">
                  <c:v>0.186</c:v>
                </c:pt>
                <c:pt idx="572">
                  <c:v>0.19059999999999999</c:v>
                </c:pt>
                <c:pt idx="573">
                  <c:v>0.19109999999999999</c:v>
                </c:pt>
                <c:pt idx="574">
                  <c:v>0.2</c:v>
                </c:pt>
                <c:pt idx="575">
                  <c:v>0.18959999999999999</c:v>
                </c:pt>
                <c:pt idx="576">
                  <c:v>0.183</c:v>
                </c:pt>
                <c:pt idx="577">
                  <c:v>0.1673</c:v>
                </c:pt>
                <c:pt idx="578">
                  <c:v>0.1744</c:v>
                </c:pt>
                <c:pt idx="579">
                  <c:v>0.17369999999999999</c:v>
                </c:pt>
                <c:pt idx="580">
                  <c:v>0.15590000000000001</c:v>
                </c:pt>
                <c:pt idx="581">
                  <c:v>0.15329999999999999</c:v>
                </c:pt>
                <c:pt idx="582">
                  <c:v>0.16839999999999999</c:v>
                </c:pt>
                <c:pt idx="583">
                  <c:v>0.16020000000000001</c:v>
                </c:pt>
                <c:pt idx="584">
                  <c:v>0.1411</c:v>
                </c:pt>
                <c:pt idx="585">
                  <c:v>0.15740000000000001</c:v>
                </c:pt>
                <c:pt idx="586">
                  <c:v>0.17150000000000001</c:v>
                </c:pt>
                <c:pt idx="587">
                  <c:v>0.14799999999999999</c:v>
                </c:pt>
                <c:pt idx="588">
                  <c:v>0.14149999999999999</c:v>
                </c:pt>
                <c:pt idx="589">
                  <c:v>0.1676</c:v>
                </c:pt>
                <c:pt idx="590">
                  <c:v>0.16259999999999999</c:v>
                </c:pt>
                <c:pt idx="591">
                  <c:v>0.1484</c:v>
                </c:pt>
                <c:pt idx="592">
                  <c:v>0.15559999999999999</c:v>
                </c:pt>
                <c:pt idx="593">
                  <c:v>0.16839999999999999</c:v>
                </c:pt>
                <c:pt idx="594">
                  <c:v>0.17119999999999999</c:v>
                </c:pt>
                <c:pt idx="595">
                  <c:v>0.16259999999999999</c:v>
                </c:pt>
                <c:pt idx="596">
                  <c:v>0.16789999999999999</c:v>
                </c:pt>
                <c:pt idx="597">
                  <c:v>0.18690000000000001</c:v>
                </c:pt>
                <c:pt idx="598">
                  <c:v>0.20080000000000001</c:v>
                </c:pt>
                <c:pt idx="599">
                  <c:v>0.20680000000000001</c:v>
                </c:pt>
                <c:pt idx="600">
                  <c:v>0.18049999999999999</c:v>
                </c:pt>
                <c:pt idx="601">
                  <c:v>0.1754</c:v>
                </c:pt>
                <c:pt idx="602">
                  <c:v>0.16159999999999999</c:v>
                </c:pt>
                <c:pt idx="603">
                  <c:v>0.17180000000000001</c:v>
                </c:pt>
                <c:pt idx="604">
                  <c:v>0.17649999999999999</c:v>
                </c:pt>
                <c:pt idx="605">
                  <c:v>0.16980000000000001</c:v>
                </c:pt>
                <c:pt idx="606">
                  <c:v>0.16980000000000001</c:v>
                </c:pt>
                <c:pt idx="607">
                  <c:v>0.19040000000000001</c:v>
                </c:pt>
                <c:pt idx="608">
                  <c:v>0.19839999999999999</c:v>
                </c:pt>
                <c:pt idx="609">
                  <c:v>0.19139999999999999</c:v>
                </c:pt>
                <c:pt idx="610">
                  <c:v>0.20780000000000001</c:v>
                </c:pt>
                <c:pt idx="611">
                  <c:v>0.2263</c:v>
                </c:pt>
                <c:pt idx="612">
                  <c:v>0.24110000000000001</c:v>
                </c:pt>
                <c:pt idx="613">
                  <c:v>0.22059999999999999</c:v>
                </c:pt>
                <c:pt idx="614">
                  <c:v>0.2253</c:v>
                </c:pt>
                <c:pt idx="615">
                  <c:v>0.2601</c:v>
                </c:pt>
                <c:pt idx="616">
                  <c:v>0.24759999999999999</c:v>
                </c:pt>
                <c:pt idx="617">
                  <c:v>0.2195</c:v>
                </c:pt>
                <c:pt idx="618">
                  <c:v>0.25230000000000002</c:v>
                </c:pt>
                <c:pt idx="619">
                  <c:v>0.27960000000000002</c:v>
                </c:pt>
                <c:pt idx="620">
                  <c:v>0.26119999999999999</c:v>
                </c:pt>
                <c:pt idx="621">
                  <c:v>0.25629999999999997</c:v>
                </c:pt>
                <c:pt idx="622">
                  <c:v>0.21820000000000001</c:v>
                </c:pt>
                <c:pt idx="623">
                  <c:v>0.21390000000000001</c:v>
                </c:pt>
                <c:pt idx="624">
                  <c:v>0.2165</c:v>
                </c:pt>
                <c:pt idx="625">
                  <c:v>0.22070000000000001</c:v>
                </c:pt>
                <c:pt idx="626">
                  <c:v>0.21709999999999999</c:v>
                </c:pt>
                <c:pt idx="627">
                  <c:v>0.2228</c:v>
                </c:pt>
                <c:pt idx="628">
                  <c:v>0.25590000000000002</c:v>
                </c:pt>
                <c:pt idx="629">
                  <c:v>0.27</c:v>
                </c:pt>
                <c:pt idx="630">
                  <c:v>0.28789999999999999</c:v>
                </c:pt>
                <c:pt idx="631">
                  <c:v>0.31969999999999998</c:v>
                </c:pt>
                <c:pt idx="632">
                  <c:v>0.32050000000000001</c:v>
                </c:pt>
                <c:pt idx="633">
                  <c:v>0.30959999999999999</c:v>
                </c:pt>
                <c:pt idx="634">
                  <c:v>0.33929999999999999</c:v>
                </c:pt>
                <c:pt idx="635">
                  <c:v>0.36890000000000001</c:v>
                </c:pt>
                <c:pt idx="636">
                  <c:v>0.35949999999999999</c:v>
                </c:pt>
                <c:pt idx="637">
                  <c:v>0.3604</c:v>
                </c:pt>
                <c:pt idx="638">
                  <c:v>0.38879999999999998</c:v>
                </c:pt>
                <c:pt idx="639">
                  <c:v>0.37690000000000001</c:v>
                </c:pt>
                <c:pt idx="640">
                  <c:v>0.4022</c:v>
                </c:pt>
                <c:pt idx="641">
                  <c:v>0.43619999999999998</c:v>
                </c:pt>
                <c:pt idx="642">
                  <c:v>0.45879999999999999</c:v>
                </c:pt>
                <c:pt idx="643">
                  <c:v>0.53029999999999999</c:v>
                </c:pt>
                <c:pt idx="644">
                  <c:v>0.5796</c:v>
                </c:pt>
                <c:pt idx="645">
                  <c:v>0.57720000000000005</c:v>
                </c:pt>
                <c:pt idx="646">
                  <c:v>0.57269999999999999</c:v>
                </c:pt>
                <c:pt idx="647">
                  <c:v>0.55489999999999995</c:v>
                </c:pt>
                <c:pt idx="648">
                  <c:v>0.5575</c:v>
                </c:pt>
                <c:pt idx="649">
                  <c:v>0.58220000000000005</c:v>
                </c:pt>
                <c:pt idx="650">
                  <c:v>0.60209999999999997</c:v>
                </c:pt>
                <c:pt idx="651">
                  <c:v>0.67979999999999996</c:v>
                </c:pt>
                <c:pt idx="652">
                  <c:v>0.66900000000000004</c:v>
                </c:pt>
                <c:pt idx="653">
                  <c:v>0.66690000000000005</c:v>
                </c:pt>
                <c:pt idx="654">
                  <c:v>0.61180000000000001</c:v>
                </c:pt>
                <c:pt idx="655">
                  <c:v>0.5524</c:v>
                </c:pt>
                <c:pt idx="656">
                  <c:v>0.59309999999999996</c:v>
                </c:pt>
                <c:pt idx="657">
                  <c:v>0.60460000000000003</c:v>
                </c:pt>
                <c:pt idx="658">
                  <c:v>0.59330000000000005</c:v>
                </c:pt>
                <c:pt idx="659">
                  <c:v>0.5454</c:v>
                </c:pt>
                <c:pt idx="660">
                  <c:v>0.61629999999999996</c:v>
                </c:pt>
                <c:pt idx="661">
                  <c:v>0.63300000000000001</c:v>
                </c:pt>
                <c:pt idx="662">
                  <c:v>0.61580000000000001</c:v>
                </c:pt>
                <c:pt idx="663">
                  <c:v>0.63800000000000001</c:v>
                </c:pt>
                <c:pt idx="664">
                  <c:v>0.62619999999999998</c:v>
                </c:pt>
                <c:pt idx="665">
                  <c:v>0.59340000000000004</c:v>
                </c:pt>
                <c:pt idx="666">
                  <c:v>0.58750000000000002</c:v>
                </c:pt>
                <c:pt idx="667">
                  <c:v>0.62180000000000002</c:v>
                </c:pt>
                <c:pt idx="668">
                  <c:v>0.66139999999999999</c:v>
                </c:pt>
                <c:pt idx="669">
                  <c:v>0.66069999999999995</c:v>
                </c:pt>
                <c:pt idx="670">
                  <c:v>0.64600000000000002</c:v>
                </c:pt>
                <c:pt idx="671">
                  <c:v>0.66679999999999995</c:v>
                </c:pt>
                <c:pt idx="672">
                  <c:v>0.72330000000000005</c:v>
                </c:pt>
                <c:pt idx="673">
                  <c:v>0.73419999999999996</c:v>
                </c:pt>
                <c:pt idx="674">
                  <c:v>0.70660000000000001</c:v>
                </c:pt>
                <c:pt idx="675">
                  <c:v>0.69289999999999996</c:v>
                </c:pt>
                <c:pt idx="676">
                  <c:v>0.69430000000000003</c:v>
                </c:pt>
                <c:pt idx="677">
                  <c:v>0.69369999999999998</c:v>
                </c:pt>
                <c:pt idx="678">
                  <c:v>0.72499999999999998</c:v>
                </c:pt>
                <c:pt idx="679">
                  <c:v>0.82020000000000004</c:v>
                </c:pt>
                <c:pt idx="680">
                  <c:v>0.84419999999999995</c:v>
                </c:pt>
                <c:pt idx="681">
                  <c:v>0.72019999999999995</c:v>
                </c:pt>
                <c:pt idx="682">
                  <c:v>0.64470000000000005</c:v>
                </c:pt>
                <c:pt idx="683">
                  <c:v>0.62609999999999999</c:v>
                </c:pt>
                <c:pt idx="684">
                  <c:v>0.64759999999999995</c:v>
                </c:pt>
                <c:pt idx="685">
                  <c:v>0.68769999999999998</c:v>
                </c:pt>
                <c:pt idx="686">
                  <c:v>0.68989999999999996</c:v>
                </c:pt>
                <c:pt idx="687">
                  <c:v>0.66259999999999997</c:v>
                </c:pt>
                <c:pt idx="688">
                  <c:v>0.70369999999999999</c:v>
                </c:pt>
                <c:pt idx="689">
                  <c:v>0.68989999999999996</c:v>
                </c:pt>
                <c:pt idx="690">
                  <c:v>0.63949999999999996</c:v>
                </c:pt>
                <c:pt idx="691">
                  <c:v>0.64439999999999997</c:v>
                </c:pt>
                <c:pt idx="692">
                  <c:v>0.64419999999999999</c:v>
                </c:pt>
                <c:pt idx="693">
                  <c:v>0.65490000000000004</c:v>
                </c:pt>
                <c:pt idx="694">
                  <c:v>0.65959999999999996</c:v>
                </c:pt>
                <c:pt idx="695">
                  <c:v>0.74109999999999998</c:v>
                </c:pt>
                <c:pt idx="696">
                  <c:v>0.66600000000000004</c:v>
                </c:pt>
                <c:pt idx="697">
                  <c:v>0.65290000000000004</c:v>
                </c:pt>
                <c:pt idx="698">
                  <c:v>0.61280000000000001</c:v>
                </c:pt>
                <c:pt idx="699">
                  <c:v>0.54810000000000003</c:v>
                </c:pt>
                <c:pt idx="700">
                  <c:v>0.5907</c:v>
                </c:pt>
                <c:pt idx="701">
                  <c:v>0.51759999999999995</c:v>
                </c:pt>
                <c:pt idx="702">
                  <c:v>0.52569999999999995</c:v>
                </c:pt>
                <c:pt idx="703">
                  <c:v>0.59009999999999996</c:v>
                </c:pt>
                <c:pt idx="704">
                  <c:v>0.58540000000000003</c:v>
                </c:pt>
                <c:pt idx="705">
                  <c:v>0.58250000000000002</c:v>
                </c:pt>
                <c:pt idx="706">
                  <c:v>0.70550000000000002</c:v>
                </c:pt>
                <c:pt idx="707">
                  <c:v>0.6865</c:v>
                </c:pt>
                <c:pt idx="708">
                  <c:v>0.66959999999999997</c:v>
                </c:pt>
                <c:pt idx="709">
                  <c:v>0.63170000000000004</c:v>
                </c:pt>
                <c:pt idx="710">
                  <c:v>0.62729999999999997</c:v>
                </c:pt>
                <c:pt idx="711">
                  <c:v>0.59799999999999998</c:v>
                </c:pt>
                <c:pt idx="712">
                  <c:v>0.62590000000000001</c:v>
                </c:pt>
                <c:pt idx="713">
                  <c:v>0.70720000000000005</c:v>
                </c:pt>
                <c:pt idx="714">
                  <c:v>0.74739999999999995</c:v>
                </c:pt>
                <c:pt idx="715">
                  <c:v>0.89070000000000005</c:v>
                </c:pt>
                <c:pt idx="716">
                  <c:v>0.84670000000000001</c:v>
                </c:pt>
                <c:pt idx="717">
                  <c:v>0.84099999999999997</c:v>
                </c:pt>
                <c:pt idx="718">
                  <c:v>0.69089999999999996</c:v>
                </c:pt>
                <c:pt idx="719">
                  <c:v>0.55010000000000003</c:v>
                </c:pt>
                <c:pt idx="720">
                  <c:v>0.43640000000000001</c:v>
                </c:pt>
                <c:pt idx="721">
                  <c:v>0.37119999999999997</c:v>
                </c:pt>
                <c:pt idx="722">
                  <c:v>0.24809999999999999</c:v>
                </c:pt>
                <c:pt idx="723">
                  <c:v>0.219</c:v>
                </c:pt>
                <c:pt idx="724">
                  <c:v>0.20480000000000001</c:v>
                </c:pt>
                <c:pt idx="725">
                  <c:v>0.18390000000000001</c:v>
                </c:pt>
                <c:pt idx="726">
                  <c:v>0.17810000000000001</c:v>
                </c:pt>
                <c:pt idx="727">
                  <c:v>0.17960000000000001</c:v>
                </c:pt>
                <c:pt idx="728">
                  <c:v>0.1678</c:v>
                </c:pt>
                <c:pt idx="729">
                  <c:v>0.15670000000000001</c:v>
                </c:pt>
                <c:pt idx="730">
                  <c:v>0.1593</c:v>
                </c:pt>
                <c:pt idx="731">
                  <c:v>0.15409999999999999</c:v>
                </c:pt>
                <c:pt idx="732">
                  <c:v>0.14660000000000001</c:v>
                </c:pt>
                <c:pt idx="733">
                  <c:v>0.1459</c:v>
                </c:pt>
                <c:pt idx="734">
                  <c:v>0.1474</c:v>
                </c:pt>
                <c:pt idx="735">
                  <c:v>0.14380000000000001</c:v>
                </c:pt>
                <c:pt idx="736">
                  <c:v>0.14119999999999999</c:v>
                </c:pt>
                <c:pt idx="737">
                  <c:v>0.14680000000000001</c:v>
                </c:pt>
                <c:pt idx="738">
                  <c:v>0.14860000000000001</c:v>
                </c:pt>
                <c:pt idx="739">
                  <c:v>0.1449</c:v>
                </c:pt>
                <c:pt idx="740">
                  <c:v>0.14749999999999999</c:v>
                </c:pt>
                <c:pt idx="741">
                  <c:v>0.15090000000000001</c:v>
                </c:pt>
                <c:pt idx="742">
                  <c:v>0.15459999999999999</c:v>
                </c:pt>
                <c:pt idx="743">
                  <c:v>0.15720000000000001</c:v>
                </c:pt>
                <c:pt idx="744">
                  <c:v>0.15790000000000001</c:v>
                </c:pt>
                <c:pt idx="745">
                  <c:v>0.16320000000000001</c:v>
                </c:pt>
                <c:pt idx="746">
                  <c:v>0.1673</c:v>
                </c:pt>
                <c:pt idx="747">
                  <c:v>0.1678</c:v>
                </c:pt>
                <c:pt idx="748">
                  <c:v>0.1699</c:v>
                </c:pt>
                <c:pt idx="749">
                  <c:v>0.17519999999999999</c:v>
                </c:pt>
                <c:pt idx="750">
                  <c:v>0.1734</c:v>
                </c:pt>
                <c:pt idx="751">
                  <c:v>0.18279999999999999</c:v>
                </c:pt>
                <c:pt idx="752">
                  <c:v>0.19059999999999999</c:v>
                </c:pt>
                <c:pt idx="753">
                  <c:v>0.18890000000000001</c:v>
                </c:pt>
                <c:pt idx="754">
                  <c:v>0.19550000000000001</c:v>
                </c:pt>
                <c:pt idx="755">
                  <c:v>0.19189999999999999</c:v>
                </c:pt>
                <c:pt idx="756">
                  <c:v>0.1976</c:v>
                </c:pt>
                <c:pt idx="757">
                  <c:v>0.18559999999999999</c:v>
                </c:pt>
                <c:pt idx="758">
                  <c:v>0.17230000000000001</c:v>
                </c:pt>
                <c:pt idx="759">
                  <c:v>0.1741</c:v>
                </c:pt>
                <c:pt idx="760">
                  <c:v>0.18140000000000001</c:v>
                </c:pt>
                <c:pt idx="761">
                  <c:v>0.17100000000000001</c:v>
                </c:pt>
                <c:pt idx="762">
                  <c:v>0.1598</c:v>
                </c:pt>
                <c:pt idx="763">
                  <c:v>0.16800000000000001</c:v>
                </c:pt>
                <c:pt idx="764">
                  <c:v>0.1774</c:v>
                </c:pt>
                <c:pt idx="765">
                  <c:v>0.16539999999999999</c:v>
                </c:pt>
                <c:pt idx="766">
                  <c:v>0.1648</c:v>
                </c:pt>
                <c:pt idx="767">
                  <c:v>0.18090000000000001</c:v>
                </c:pt>
                <c:pt idx="768">
                  <c:v>0.18360000000000001</c:v>
                </c:pt>
                <c:pt idx="769">
                  <c:v>0.1754</c:v>
                </c:pt>
                <c:pt idx="770">
                  <c:v>0.182</c:v>
                </c:pt>
                <c:pt idx="771">
                  <c:v>0.19220000000000001</c:v>
                </c:pt>
                <c:pt idx="772">
                  <c:v>0.18940000000000001</c:v>
                </c:pt>
                <c:pt idx="773">
                  <c:v>0.18479999999999999</c:v>
                </c:pt>
                <c:pt idx="774">
                  <c:v>0.19070000000000001</c:v>
                </c:pt>
                <c:pt idx="775">
                  <c:v>0.192</c:v>
                </c:pt>
                <c:pt idx="776">
                  <c:v>0.18279999999999999</c:v>
                </c:pt>
                <c:pt idx="777">
                  <c:v>0.184</c:v>
                </c:pt>
                <c:pt idx="778">
                  <c:v>0.1855</c:v>
                </c:pt>
                <c:pt idx="779">
                  <c:v>0.1817</c:v>
                </c:pt>
                <c:pt idx="780">
                  <c:v>0.1691</c:v>
                </c:pt>
                <c:pt idx="781">
                  <c:v>0.15609999999999999</c:v>
                </c:pt>
                <c:pt idx="782">
                  <c:v>0.16520000000000001</c:v>
                </c:pt>
                <c:pt idx="783">
                  <c:v>0.1724</c:v>
                </c:pt>
                <c:pt idx="784">
                  <c:v>0.17219999999999999</c:v>
                </c:pt>
                <c:pt idx="785">
                  <c:v>0.17030000000000001</c:v>
                </c:pt>
                <c:pt idx="786">
                  <c:v>0.1825</c:v>
                </c:pt>
                <c:pt idx="787">
                  <c:v>0.19109999999999999</c:v>
                </c:pt>
                <c:pt idx="788">
                  <c:v>0.18529999999999999</c:v>
                </c:pt>
                <c:pt idx="789">
                  <c:v>0.19270000000000001</c:v>
                </c:pt>
                <c:pt idx="790">
                  <c:v>0.2097</c:v>
                </c:pt>
                <c:pt idx="791">
                  <c:v>0.21149999999999999</c:v>
                </c:pt>
                <c:pt idx="792">
                  <c:v>0.2024</c:v>
                </c:pt>
                <c:pt idx="793">
                  <c:v>0.216</c:v>
                </c:pt>
                <c:pt idx="794">
                  <c:v>0.23960000000000001</c:v>
                </c:pt>
                <c:pt idx="795">
                  <c:v>0.24440000000000001</c:v>
                </c:pt>
                <c:pt idx="796">
                  <c:v>0.23799999999999999</c:v>
                </c:pt>
                <c:pt idx="797">
                  <c:v>0.25969999999999999</c:v>
                </c:pt>
                <c:pt idx="798">
                  <c:v>0.23799999999999999</c:v>
                </c:pt>
                <c:pt idx="799">
                  <c:v>0.24859999999999999</c:v>
                </c:pt>
                <c:pt idx="800">
                  <c:v>0.2278</c:v>
                </c:pt>
                <c:pt idx="801">
                  <c:v>0.22739999999999999</c:v>
                </c:pt>
                <c:pt idx="802">
                  <c:v>0.21829999999999999</c:v>
                </c:pt>
                <c:pt idx="803">
                  <c:v>0.22270000000000001</c:v>
                </c:pt>
                <c:pt idx="804">
                  <c:v>0.21229999999999999</c:v>
                </c:pt>
                <c:pt idx="805">
                  <c:v>0.1978</c:v>
                </c:pt>
                <c:pt idx="806">
                  <c:v>0.20150000000000001</c:v>
                </c:pt>
                <c:pt idx="807">
                  <c:v>0.2082</c:v>
                </c:pt>
                <c:pt idx="808">
                  <c:v>0.20030000000000001</c:v>
                </c:pt>
                <c:pt idx="809">
                  <c:v>0.1862</c:v>
                </c:pt>
                <c:pt idx="810">
                  <c:v>0.19420000000000001</c:v>
                </c:pt>
                <c:pt idx="811">
                  <c:v>0.19939999999999999</c:v>
                </c:pt>
                <c:pt idx="812">
                  <c:v>0.18509999999999999</c:v>
                </c:pt>
                <c:pt idx="813">
                  <c:v>0.19359999999999999</c:v>
                </c:pt>
                <c:pt idx="814">
                  <c:v>0.1802</c:v>
                </c:pt>
                <c:pt idx="815">
                  <c:v>0.17699999999999999</c:v>
                </c:pt>
                <c:pt idx="816">
                  <c:v>0.18590000000000001</c:v>
                </c:pt>
                <c:pt idx="817">
                  <c:v>0.18410000000000001</c:v>
                </c:pt>
                <c:pt idx="818">
                  <c:v>0.20349999999999999</c:v>
                </c:pt>
                <c:pt idx="819">
                  <c:v>0.20280000000000001</c:v>
                </c:pt>
                <c:pt idx="820">
                  <c:v>0.20730000000000001</c:v>
                </c:pt>
                <c:pt idx="821">
                  <c:v>0.2077</c:v>
                </c:pt>
                <c:pt idx="822">
                  <c:v>0.2104</c:v>
                </c:pt>
                <c:pt idx="823">
                  <c:v>0.19700000000000001</c:v>
                </c:pt>
                <c:pt idx="824">
                  <c:v>0.20030000000000001</c:v>
                </c:pt>
                <c:pt idx="825">
                  <c:v>0.22020000000000001</c:v>
                </c:pt>
                <c:pt idx="826">
                  <c:v>0.25</c:v>
                </c:pt>
                <c:pt idx="827">
                  <c:v>0.28410000000000002</c:v>
                </c:pt>
                <c:pt idx="828">
                  <c:v>0.33339999999999997</c:v>
                </c:pt>
                <c:pt idx="829">
                  <c:v>0.318</c:v>
                </c:pt>
                <c:pt idx="830">
                  <c:v>0.30780000000000002</c:v>
                </c:pt>
                <c:pt idx="831">
                  <c:v>0.36199999999999999</c:v>
                </c:pt>
                <c:pt idx="832">
                  <c:v>0.39679999999999999</c:v>
                </c:pt>
                <c:pt idx="833">
                  <c:v>0.39100000000000001</c:v>
                </c:pt>
                <c:pt idx="834">
                  <c:v>0.40089999999999998</c:v>
                </c:pt>
                <c:pt idx="835">
                  <c:v>0.35659999999999997</c:v>
                </c:pt>
                <c:pt idx="836">
                  <c:v>0.38040000000000002</c:v>
                </c:pt>
                <c:pt idx="837">
                  <c:v>0.32790000000000002</c:v>
                </c:pt>
                <c:pt idx="838">
                  <c:v>0.26879999999999998</c:v>
                </c:pt>
                <c:pt idx="839">
                  <c:v>0.25259999999999999</c:v>
                </c:pt>
                <c:pt idx="840">
                  <c:v>0.2235</c:v>
                </c:pt>
                <c:pt idx="841">
                  <c:v>0.22819999999999999</c:v>
                </c:pt>
                <c:pt idx="842">
                  <c:v>0.22489999999999999</c:v>
                </c:pt>
                <c:pt idx="843">
                  <c:v>0.20610000000000001</c:v>
                </c:pt>
                <c:pt idx="844">
                  <c:v>0.21870000000000001</c:v>
                </c:pt>
                <c:pt idx="845">
                  <c:v>0.22750000000000001</c:v>
                </c:pt>
                <c:pt idx="846">
                  <c:v>0.2094</c:v>
                </c:pt>
                <c:pt idx="847">
                  <c:v>0.20860000000000001</c:v>
                </c:pt>
                <c:pt idx="848">
                  <c:v>0.22420000000000001</c:v>
                </c:pt>
                <c:pt idx="849">
                  <c:v>0.2329</c:v>
                </c:pt>
                <c:pt idx="850">
                  <c:v>0.21909999999999999</c:v>
                </c:pt>
                <c:pt idx="851">
                  <c:v>0.2059</c:v>
                </c:pt>
                <c:pt idx="852">
                  <c:v>0.219</c:v>
                </c:pt>
                <c:pt idx="853">
                  <c:v>0.23200000000000001</c:v>
                </c:pt>
                <c:pt idx="854">
                  <c:v>0.2195</c:v>
                </c:pt>
                <c:pt idx="855">
                  <c:v>0.21129999999999999</c:v>
                </c:pt>
                <c:pt idx="856">
                  <c:v>0.23400000000000001</c:v>
                </c:pt>
                <c:pt idx="857">
                  <c:v>0.22869999999999999</c:v>
                </c:pt>
                <c:pt idx="858">
                  <c:v>0.2069</c:v>
                </c:pt>
                <c:pt idx="859">
                  <c:v>0.219</c:v>
                </c:pt>
                <c:pt idx="860">
                  <c:v>0.2392</c:v>
                </c:pt>
                <c:pt idx="861">
                  <c:v>0.22209999999999999</c:v>
                </c:pt>
                <c:pt idx="862">
                  <c:v>0.21110000000000001</c:v>
                </c:pt>
                <c:pt idx="863">
                  <c:v>0.23400000000000001</c:v>
                </c:pt>
                <c:pt idx="864">
                  <c:v>0.2392</c:v>
                </c:pt>
                <c:pt idx="865">
                  <c:v>0.21809999999999999</c:v>
                </c:pt>
                <c:pt idx="866">
                  <c:v>0.2656</c:v>
                </c:pt>
                <c:pt idx="867">
                  <c:v>0.29570000000000002</c:v>
                </c:pt>
                <c:pt idx="868">
                  <c:v>0.29210000000000003</c:v>
                </c:pt>
                <c:pt idx="869">
                  <c:v>0.36049999999999999</c:v>
                </c:pt>
                <c:pt idx="870">
                  <c:v>0.44869999999999999</c:v>
                </c:pt>
                <c:pt idx="871">
                  <c:v>0.53259999999999996</c:v>
                </c:pt>
                <c:pt idx="872">
                  <c:v>0.63980000000000004</c:v>
                </c:pt>
                <c:pt idx="873">
                  <c:v>0.74050000000000005</c:v>
                </c:pt>
                <c:pt idx="874">
                  <c:v>0.90739999999999998</c:v>
                </c:pt>
                <c:pt idx="875">
                  <c:v>0.97719999999999996</c:v>
                </c:pt>
                <c:pt idx="876">
                  <c:v>1.1688000000000001</c:v>
                </c:pt>
                <c:pt idx="877">
                  <c:v>1.3925000000000001</c:v>
                </c:pt>
                <c:pt idx="878">
                  <c:v>1.4731000000000001</c:v>
                </c:pt>
                <c:pt idx="879">
                  <c:v>1.3467</c:v>
                </c:pt>
                <c:pt idx="880">
                  <c:v>1.1788000000000001</c:v>
                </c:pt>
                <c:pt idx="881">
                  <c:v>1.1061000000000001</c:v>
                </c:pt>
                <c:pt idx="882">
                  <c:v>1.081</c:v>
                </c:pt>
                <c:pt idx="883">
                  <c:v>0.9</c:v>
                </c:pt>
                <c:pt idx="884">
                  <c:v>0.67910000000000004</c:v>
                </c:pt>
                <c:pt idx="885">
                  <c:v>0.61209999999999998</c:v>
                </c:pt>
                <c:pt idx="886">
                  <c:v>0.43559999999999999</c:v>
                </c:pt>
                <c:pt idx="887">
                  <c:v>0.29720000000000002</c:v>
                </c:pt>
                <c:pt idx="888">
                  <c:v>0.2218</c:v>
                </c:pt>
                <c:pt idx="889">
                  <c:v>0.19750000000000001</c:v>
                </c:pt>
                <c:pt idx="890">
                  <c:v>0.17380000000000001</c:v>
                </c:pt>
                <c:pt idx="891">
                  <c:v>0.17399999999999999</c:v>
                </c:pt>
                <c:pt idx="892">
                  <c:v>0.19400000000000001</c:v>
                </c:pt>
                <c:pt idx="893">
                  <c:v>0.18920000000000001</c:v>
                </c:pt>
                <c:pt idx="894">
                  <c:v>0.19320000000000001</c:v>
                </c:pt>
                <c:pt idx="895">
                  <c:v>0.247</c:v>
                </c:pt>
                <c:pt idx="896">
                  <c:v>0.2611</c:v>
                </c:pt>
                <c:pt idx="897">
                  <c:v>0.22320000000000001</c:v>
                </c:pt>
                <c:pt idx="898">
                  <c:v>0.17910000000000001</c:v>
                </c:pt>
                <c:pt idx="899">
                  <c:v>0.185</c:v>
                </c:pt>
                <c:pt idx="900">
                  <c:v>0.16880000000000001</c:v>
                </c:pt>
                <c:pt idx="901">
                  <c:v>0.1643</c:v>
                </c:pt>
                <c:pt idx="902">
                  <c:v>0.21079999999999999</c:v>
                </c:pt>
                <c:pt idx="903">
                  <c:v>0.23580000000000001</c:v>
                </c:pt>
                <c:pt idx="904">
                  <c:v>0.22620000000000001</c:v>
                </c:pt>
                <c:pt idx="905">
                  <c:v>0.20960000000000001</c:v>
                </c:pt>
                <c:pt idx="906">
                  <c:v>0.1661</c:v>
                </c:pt>
                <c:pt idx="907">
                  <c:v>0.15989999999999999</c:v>
                </c:pt>
                <c:pt idx="908">
                  <c:v>0.1651</c:v>
                </c:pt>
                <c:pt idx="909">
                  <c:v>0.16950000000000001</c:v>
                </c:pt>
                <c:pt idx="910">
                  <c:v>0.17910000000000001</c:v>
                </c:pt>
                <c:pt idx="911">
                  <c:v>0.18759999999999999</c:v>
                </c:pt>
                <c:pt idx="912">
                  <c:v>0.1888</c:v>
                </c:pt>
                <c:pt idx="913">
                  <c:v>0.2011</c:v>
                </c:pt>
                <c:pt idx="914">
                  <c:v>0.20649999999999999</c:v>
                </c:pt>
                <c:pt idx="915">
                  <c:v>0.1963</c:v>
                </c:pt>
                <c:pt idx="916">
                  <c:v>0.1764</c:v>
                </c:pt>
                <c:pt idx="917">
                  <c:v>0.20119999999999999</c:v>
                </c:pt>
                <c:pt idx="918">
                  <c:v>0.22309999999999999</c:v>
                </c:pt>
                <c:pt idx="919">
                  <c:v>0.21110000000000001</c:v>
                </c:pt>
                <c:pt idx="920">
                  <c:v>0.21010000000000001</c:v>
                </c:pt>
                <c:pt idx="921">
                  <c:v>0.2263</c:v>
                </c:pt>
                <c:pt idx="922">
                  <c:v>0.23369999999999999</c:v>
                </c:pt>
                <c:pt idx="923">
                  <c:v>0.23860000000000001</c:v>
                </c:pt>
                <c:pt idx="924">
                  <c:v>0.24110000000000001</c:v>
                </c:pt>
                <c:pt idx="925">
                  <c:v>0.25829999999999997</c:v>
                </c:pt>
                <c:pt idx="926">
                  <c:v>0.2571</c:v>
                </c:pt>
                <c:pt idx="927">
                  <c:v>0.2419</c:v>
                </c:pt>
                <c:pt idx="928">
                  <c:v>0.24410000000000001</c:v>
                </c:pt>
                <c:pt idx="929">
                  <c:v>0.2447</c:v>
                </c:pt>
                <c:pt idx="930">
                  <c:v>0.23630000000000001</c:v>
                </c:pt>
                <c:pt idx="931">
                  <c:v>0.2321</c:v>
                </c:pt>
                <c:pt idx="932">
                  <c:v>0.22040000000000001</c:v>
                </c:pt>
                <c:pt idx="933">
                  <c:v>0.23250000000000001</c:v>
                </c:pt>
                <c:pt idx="934">
                  <c:v>0.2281</c:v>
                </c:pt>
                <c:pt idx="935">
                  <c:v>0.23599999999999999</c:v>
                </c:pt>
                <c:pt idx="936">
                  <c:v>0.23960000000000001</c:v>
                </c:pt>
                <c:pt idx="937">
                  <c:v>0.2616</c:v>
                </c:pt>
                <c:pt idx="938">
                  <c:v>0.27439999999999998</c:v>
                </c:pt>
                <c:pt idx="939">
                  <c:v>0.25290000000000001</c:v>
                </c:pt>
                <c:pt idx="940">
                  <c:v>0.2457</c:v>
                </c:pt>
                <c:pt idx="941">
                  <c:v>0.23400000000000001</c:v>
                </c:pt>
                <c:pt idx="942">
                  <c:v>0.22589999999999999</c:v>
                </c:pt>
                <c:pt idx="943">
                  <c:v>0.2286</c:v>
                </c:pt>
                <c:pt idx="944">
                  <c:v>0.246</c:v>
                </c:pt>
                <c:pt idx="945">
                  <c:v>0.23860000000000001</c:v>
                </c:pt>
                <c:pt idx="946">
                  <c:v>0.22470000000000001</c:v>
                </c:pt>
                <c:pt idx="947">
                  <c:v>0.23580000000000001</c:v>
                </c:pt>
                <c:pt idx="948">
                  <c:v>0.24779999999999999</c:v>
                </c:pt>
                <c:pt idx="949">
                  <c:v>0.2316</c:v>
                </c:pt>
                <c:pt idx="950">
                  <c:v>0.2218</c:v>
                </c:pt>
                <c:pt idx="951">
                  <c:v>0.24160000000000001</c:v>
                </c:pt>
                <c:pt idx="952">
                  <c:v>0.2477</c:v>
                </c:pt>
                <c:pt idx="953">
                  <c:v>0.22900000000000001</c:v>
                </c:pt>
                <c:pt idx="954">
                  <c:v>0.2414</c:v>
                </c:pt>
                <c:pt idx="955">
                  <c:v>0.30159999999999998</c:v>
                </c:pt>
                <c:pt idx="956">
                  <c:v>0.32219999999999999</c:v>
                </c:pt>
                <c:pt idx="957">
                  <c:v>0.3931</c:v>
                </c:pt>
                <c:pt idx="958">
                  <c:v>0.4496</c:v>
                </c:pt>
                <c:pt idx="959">
                  <c:v>0.4592</c:v>
                </c:pt>
                <c:pt idx="960">
                  <c:v>0.46410000000000001</c:v>
                </c:pt>
                <c:pt idx="961">
                  <c:v>0.39729999999999999</c:v>
                </c:pt>
                <c:pt idx="962">
                  <c:v>0.41149999999999998</c:v>
                </c:pt>
                <c:pt idx="963">
                  <c:v>0.44030000000000002</c:v>
                </c:pt>
                <c:pt idx="964">
                  <c:v>0.47170000000000001</c:v>
                </c:pt>
                <c:pt idx="965">
                  <c:v>0.47710000000000002</c:v>
                </c:pt>
                <c:pt idx="966">
                  <c:v>0.52139999999999997</c:v>
                </c:pt>
                <c:pt idx="967">
                  <c:v>0.54490000000000005</c:v>
                </c:pt>
                <c:pt idx="968">
                  <c:v>0.50309999999999999</c:v>
                </c:pt>
                <c:pt idx="969">
                  <c:v>0.49869999999999998</c:v>
                </c:pt>
                <c:pt idx="970">
                  <c:v>0.50470000000000004</c:v>
                </c:pt>
                <c:pt idx="971">
                  <c:v>0.41660000000000003</c:v>
                </c:pt>
                <c:pt idx="972">
                  <c:v>0.36580000000000001</c:v>
                </c:pt>
                <c:pt idx="973">
                  <c:v>0.26240000000000002</c:v>
                </c:pt>
                <c:pt idx="974">
                  <c:v>0.27210000000000001</c:v>
                </c:pt>
                <c:pt idx="975">
                  <c:v>0.26600000000000001</c:v>
                </c:pt>
                <c:pt idx="976">
                  <c:v>0.29970000000000002</c:v>
                </c:pt>
                <c:pt idx="977">
                  <c:v>0.2903</c:v>
                </c:pt>
                <c:pt idx="978">
                  <c:v>0.25380000000000003</c:v>
                </c:pt>
                <c:pt idx="979">
                  <c:v>0.26919999999999999</c:v>
                </c:pt>
                <c:pt idx="980">
                  <c:v>0.29520000000000002</c:v>
                </c:pt>
                <c:pt idx="981">
                  <c:v>0.2737</c:v>
                </c:pt>
                <c:pt idx="982">
                  <c:v>0.27289999999999998</c:v>
                </c:pt>
                <c:pt idx="983">
                  <c:v>0.34939999999999999</c:v>
                </c:pt>
                <c:pt idx="984">
                  <c:v>0.37740000000000001</c:v>
                </c:pt>
                <c:pt idx="985">
                  <c:v>0.441</c:v>
                </c:pt>
                <c:pt idx="986">
                  <c:v>0.47399999999999998</c:v>
                </c:pt>
                <c:pt idx="987">
                  <c:v>0.61009999999999998</c:v>
                </c:pt>
                <c:pt idx="988">
                  <c:v>0.69440000000000002</c:v>
                </c:pt>
                <c:pt idx="989">
                  <c:v>0.76859999999999995</c:v>
                </c:pt>
                <c:pt idx="990">
                  <c:v>0.9415</c:v>
                </c:pt>
                <c:pt idx="991">
                  <c:v>1.0657000000000001</c:v>
                </c:pt>
                <c:pt idx="992">
                  <c:v>1.2465999999999999</c:v>
                </c:pt>
                <c:pt idx="993">
                  <c:v>1.3912</c:v>
                </c:pt>
                <c:pt idx="994">
                  <c:v>1.5321</c:v>
                </c:pt>
                <c:pt idx="995">
                  <c:v>1.6805000000000001</c:v>
                </c:pt>
                <c:pt idx="996">
                  <c:v>1.8643000000000001</c:v>
                </c:pt>
                <c:pt idx="997">
                  <c:v>2.0238</c:v>
                </c:pt>
                <c:pt idx="998">
                  <c:v>2.1871</c:v>
                </c:pt>
                <c:pt idx="999">
                  <c:v>2.2865000000000002</c:v>
                </c:pt>
                <c:pt idx="1000">
                  <c:v>2.3525</c:v>
                </c:pt>
                <c:pt idx="1001">
                  <c:v>2.3813</c:v>
                </c:pt>
                <c:pt idx="1002">
                  <c:v>2.3954</c:v>
                </c:pt>
                <c:pt idx="1003">
                  <c:v>2.4207999999999998</c:v>
                </c:pt>
                <c:pt idx="1004">
                  <c:v>2.4558</c:v>
                </c:pt>
                <c:pt idx="1005">
                  <c:v>2.5571999999999999</c:v>
                </c:pt>
                <c:pt idx="1006">
                  <c:v>2.6671999999999998</c:v>
                </c:pt>
                <c:pt idx="1007">
                  <c:v>2.7804000000000002</c:v>
                </c:pt>
                <c:pt idx="1008">
                  <c:v>2.9493</c:v>
                </c:pt>
                <c:pt idx="1009">
                  <c:v>3.085</c:v>
                </c:pt>
                <c:pt idx="1010">
                  <c:v>3.2158000000000002</c:v>
                </c:pt>
                <c:pt idx="1011">
                  <c:v>3.4116</c:v>
                </c:pt>
                <c:pt idx="1012">
                  <c:v>3.5537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B0A-42E6-B07E-7FDA21594A85}"/>
            </c:ext>
          </c:extLst>
        </c:ser>
        <c:ser>
          <c:idx val="2"/>
          <c:order val="2"/>
          <c:tx>
            <c:strRef>
              <c:f>Sheet3!$D$3</c:f>
              <c:strCache>
                <c:ptCount val="1"/>
                <c:pt idx="0">
                  <c:v>Series3</c:v>
                </c:pt>
              </c:strCache>
            </c:strRef>
          </c:tx>
          <c:spPr>
            <a:ln w="12700" cap="rnd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val>
            <c:numRef>
              <c:f>Sheet3!$D$4:$D$1016</c:f>
              <c:numCache>
                <c:formatCode>General</c:formatCode>
                <c:ptCount val="1013"/>
                <c:pt idx="0">
                  <c:v>0.69650000000000001</c:v>
                </c:pt>
                <c:pt idx="1">
                  <c:v>0.64759999999999995</c:v>
                </c:pt>
                <c:pt idx="2">
                  <c:v>0.65369999999999995</c:v>
                </c:pt>
                <c:pt idx="3">
                  <c:v>0.57340000000000002</c:v>
                </c:pt>
                <c:pt idx="4">
                  <c:v>0.61650000000000005</c:v>
                </c:pt>
                <c:pt idx="5">
                  <c:v>0.58330000000000004</c:v>
                </c:pt>
                <c:pt idx="6">
                  <c:v>0.57189999999999996</c:v>
                </c:pt>
                <c:pt idx="7">
                  <c:v>0.72130000000000005</c:v>
                </c:pt>
                <c:pt idx="8">
                  <c:v>0.60360000000000003</c:v>
                </c:pt>
                <c:pt idx="9">
                  <c:v>0.54900000000000004</c:v>
                </c:pt>
                <c:pt idx="10">
                  <c:v>0.47539999999999999</c:v>
                </c:pt>
                <c:pt idx="11">
                  <c:v>0.38340000000000002</c:v>
                </c:pt>
                <c:pt idx="12">
                  <c:v>0.3402</c:v>
                </c:pt>
                <c:pt idx="13">
                  <c:v>0.39169999999999999</c:v>
                </c:pt>
                <c:pt idx="14">
                  <c:v>0.4128</c:v>
                </c:pt>
                <c:pt idx="15">
                  <c:v>0.45469999999999999</c:v>
                </c:pt>
                <c:pt idx="16">
                  <c:v>0.3901</c:v>
                </c:pt>
                <c:pt idx="17">
                  <c:v>0.38950000000000001</c:v>
                </c:pt>
                <c:pt idx="18">
                  <c:v>0.35089999999999999</c:v>
                </c:pt>
                <c:pt idx="19">
                  <c:v>0.33229999999999998</c:v>
                </c:pt>
                <c:pt idx="20">
                  <c:v>0.3553</c:v>
                </c:pt>
                <c:pt idx="21">
                  <c:v>0.34749999999999998</c:v>
                </c:pt>
                <c:pt idx="22">
                  <c:v>0.30859999999999999</c:v>
                </c:pt>
                <c:pt idx="23">
                  <c:v>0.31659999999999999</c:v>
                </c:pt>
                <c:pt idx="24">
                  <c:v>0.34549999999999997</c:v>
                </c:pt>
                <c:pt idx="25">
                  <c:v>0.318</c:v>
                </c:pt>
                <c:pt idx="26">
                  <c:v>0.29430000000000001</c:v>
                </c:pt>
                <c:pt idx="27">
                  <c:v>0.32490000000000002</c:v>
                </c:pt>
                <c:pt idx="28">
                  <c:v>0.35659999999999997</c:v>
                </c:pt>
                <c:pt idx="29">
                  <c:v>0.33860000000000001</c:v>
                </c:pt>
                <c:pt idx="30">
                  <c:v>0.30609999999999998</c:v>
                </c:pt>
                <c:pt idx="31">
                  <c:v>0.32350000000000001</c:v>
                </c:pt>
                <c:pt idx="32">
                  <c:v>0.29049999999999998</c:v>
                </c:pt>
                <c:pt idx="33">
                  <c:v>0.28970000000000001</c:v>
                </c:pt>
                <c:pt idx="34">
                  <c:v>0.28849999999999998</c:v>
                </c:pt>
                <c:pt idx="35">
                  <c:v>0.25890000000000002</c:v>
                </c:pt>
                <c:pt idx="36">
                  <c:v>0.2427</c:v>
                </c:pt>
                <c:pt idx="37">
                  <c:v>0.2626</c:v>
                </c:pt>
                <c:pt idx="38">
                  <c:v>0.25829999999999997</c:v>
                </c:pt>
                <c:pt idx="39">
                  <c:v>0.23419999999999999</c:v>
                </c:pt>
                <c:pt idx="40">
                  <c:v>0.2455</c:v>
                </c:pt>
                <c:pt idx="41">
                  <c:v>0.27229999999999999</c:v>
                </c:pt>
                <c:pt idx="42">
                  <c:v>0.2596</c:v>
                </c:pt>
                <c:pt idx="43">
                  <c:v>0.24809999999999999</c:v>
                </c:pt>
                <c:pt idx="44">
                  <c:v>0.27860000000000001</c:v>
                </c:pt>
                <c:pt idx="45">
                  <c:v>0.3115</c:v>
                </c:pt>
                <c:pt idx="46">
                  <c:v>0.29859999999999998</c:v>
                </c:pt>
                <c:pt idx="47">
                  <c:v>0.28749999999999998</c:v>
                </c:pt>
                <c:pt idx="48">
                  <c:v>0.30980000000000002</c:v>
                </c:pt>
                <c:pt idx="49">
                  <c:v>0.33179999999999998</c:v>
                </c:pt>
                <c:pt idx="50">
                  <c:v>0.31440000000000001</c:v>
                </c:pt>
                <c:pt idx="51">
                  <c:v>0.312</c:v>
                </c:pt>
                <c:pt idx="52">
                  <c:v>0.34989999999999999</c:v>
                </c:pt>
                <c:pt idx="53">
                  <c:v>0.35539999999999999</c:v>
                </c:pt>
                <c:pt idx="54">
                  <c:v>0.33489999999999998</c:v>
                </c:pt>
                <c:pt idx="55">
                  <c:v>0.3584</c:v>
                </c:pt>
                <c:pt idx="56">
                  <c:v>0.39019999999999999</c:v>
                </c:pt>
                <c:pt idx="57">
                  <c:v>0.35580000000000001</c:v>
                </c:pt>
                <c:pt idx="58">
                  <c:v>0.32390000000000002</c:v>
                </c:pt>
                <c:pt idx="59">
                  <c:v>0.3322</c:v>
                </c:pt>
                <c:pt idx="60">
                  <c:v>0.37419999999999998</c:v>
                </c:pt>
                <c:pt idx="61">
                  <c:v>0.38500000000000001</c:v>
                </c:pt>
                <c:pt idx="62">
                  <c:v>0.38800000000000001</c:v>
                </c:pt>
                <c:pt idx="63">
                  <c:v>0.37740000000000001</c:v>
                </c:pt>
                <c:pt idx="64">
                  <c:v>0.36359999999999998</c:v>
                </c:pt>
                <c:pt idx="65">
                  <c:v>0.33589999999999998</c:v>
                </c:pt>
                <c:pt idx="66">
                  <c:v>0.32329999999999998</c:v>
                </c:pt>
                <c:pt idx="67">
                  <c:v>0.31669999999999998</c:v>
                </c:pt>
                <c:pt idx="68">
                  <c:v>0.29959999999999998</c:v>
                </c:pt>
                <c:pt idx="69">
                  <c:v>0.27529999999999999</c:v>
                </c:pt>
                <c:pt idx="70">
                  <c:v>0.27129999999999999</c:v>
                </c:pt>
                <c:pt idx="71">
                  <c:v>0.26840000000000003</c:v>
                </c:pt>
                <c:pt idx="72">
                  <c:v>0.24679999999999999</c:v>
                </c:pt>
                <c:pt idx="73">
                  <c:v>0.23</c:v>
                </c:pt>
                <c:pt idx="74">
                  <c:v>0.23530000000000001</c:v>
                </c:pt>
                <c:pt idx="75">
                  <c:v>0.23019999999999999</c:v>
                </c:pt>
                <c:pt idx="76">
                  <c:v>0.20399999999999999</c:v>
                </c:pt>
                <c:pt idx="77">
                  <c:v>0.20069999999999999</c:v>
                </c:pt>
                <c:pt idx="78">
                  <c:v>0.2039</c:v>
                </c:pt>
                <c:pt idx="79">
                  <c:v>0.20230000000000001</c:v>
                </c:pt>
                <c:pt idx="80">
                  <c:v>0.19109999999999999</c:v>
                </c:pt>
                <c:pt idx="81">
                  <c:v>0.20499999999999999</c:v>
                </c:pt>
                <c:pt idx="82">
                  <c:v>0.2155</c:v>
                </c:pt>
                <c:pt idx="83">
                  <c:v>0.2402</c:v>
                </c:pt>
                <c:pt idx="84">
                  <c:v>0.27450000000000002</c:v>
                </c:pt>
                <c:pt idx="85">
                  <c:v>0.32090000000000002</c:v>
                </c:pt>
                <c:pt idx="86">
                  <c:v>0.43859999999999999</c:v>
                </c:pt>
                <c:pt idx="87">
                  <c:v>0.54879999999999995</c:v>
                </c:pt>
                <c:pt idx="88">
                  <c:v>0.70420000000000005</c:v>
                </c:pt>
                <c:pt idx="89">
                  <c:v>0.68879999999999997</c:v>
                </c:pt>
                <c:pt idx="90">
                  <c:v>0.73119999999999996</c:v>
                </c:pt>
                <c:pt idx="91">
                  <c:v>0.66820000000000002</c:v>
                </c:pt>
                <c:pt idx="92">
                  <c:v>0.6804</c:v>
                </c:pt>
                <c:pt idx="93">
                  <c:v>0.64429999999999998</c:v>
                </c:pt>
                <c:pt idx="94">
                  <c:v>0.69350000000000001</c:v>
                </c:pt>
                <c:pt idx="95">
                  <c:v>0.66459999999999997</c:v>
                </c:pt>
                <c:pt idx="96">
                  <c:v>0.48759999999999998</c:v>
                </c:pt>
                <c:pt idx="97">
                  <c:v>0.32419999999999999</c:v>
                </c:pt>
                <c:pt idx="98">
                  <c:v>0.30059999999999998</c:v>
                </c:pt>
                <c:pt idx="99">
                  <c:v>0.30459999999999998</c:v>
                </c:pt>
                <c:pt idx="100">
                  <c:v>0.26650000000000001</c:v>
                </c:pt>
                <c:pt idx="101">
                  <c:v>0.24809999999999999</c:v>
                </c:pt>
                <c:pt idx="102">
                  <c:v>0.28389999999999999</c:v>
                </c:pt>
                <c:pt idx="103">
                  <c:v>0.2858</c:v>
                </c:pt>
                <c:pt idx="104">
                  <c:v>0.25269999999999998</c:v>
                </c:pt>
                <c:pt idx="105">
                  <c:v>0.2671</c:v>
                </c:pt>
                <c:pt idx="106">
                  <c:v>0.3029</c:v>
                </c:pt>
                <c:pt idx="107">
                  <c:v>0.29289999999999999</c:v>
                </c:pt>
                <c:pt idx="108">
                  <c:v>0.27950000000000003</c:v>
                </c:pt>
                <c:pt idx="109">
                  <c:v>0.25540000000000002</c:v>
                </c:pt>
                <c:pt idx="110">
                  <c:v>0.23050000000000001</c:v>
                </c:pt>
                <c:pt idx="111">
                  <c:v>0.22370000000000001</c:v>
                </c:pt>
                <c:pt idx="112">
                  <c:v>0.21759999999999999</c:v>
                </c:pt>
                <c:pt idx="113">
                  <c:v>0.23350000000000001</c:v>
                </c:pt>
                <c:pt idx="114">
                  <c:v>0.2293</c:v>
                </c:pt>
                <c:pt idx="115">
                  <c:v>0.22409999999999999</c:v>
                </c:pt>
                <c:pt idx="116">
                  <c:v>0.23480000000000001</c:v>
                </c:pt>
                <c:pt idx="117">
                  <c:v>0.245</c:v>
                </c:pt>
                <c:pt idx="118">
                  <c:v>0.2351</c:v>
                </c:pt>
                <c:pt idx="119">
                  <c:v>0.24809999999999999</c:v>
                </c:pt>
                <c:pt idx="120">
                  <c:v>0.26579999999999998</c:v>
                </c:pt>
                <c:pt idx="121">
                  <c:v>0.25219999999999998</c:v>
                </c:pt>
                <c:pt idx="122">
                  <c:v>0.2467</c:v>
                </c:pt>
                <c:pt idx="123">
                  <c:v>0.27179999999999999</c:v>
                </c:pt>
                <c:pt idx="124">
                  <c:v>0.28560000000000002</c:v>
                </c:pt>
                <c:pt idx="125">
                  <c:v>0.26869999999999999</c:v>
                </c:pt>
                <c:pt idx="126">
                  <c:v>0.25669999999999998</c:v>
                </c:pt>
                <c:pt idx="127">
                  <c:v>0.28749999999999998</c:v>
                </c:pt>
                <c:pt idx="128">
                  <c:v>0.2752</c:v>
                </c:pt>
                <c:pt idx="129">
                  <c:v>0.24590000000000001</c:v>
                </c:pt>
                <c:pt idx="130">
                  <c:v>0.2641</c:v>
                </c:pt>
                <c:pt idx="131">
                  <c:v>0.2833</c:v>
                </c:pt>
                <c:pt idx="132">
                  <c:v>0.26300000000000001</c:v>
                </c:pt>
                <c:pt idx="133">
                  <c:v>0.24340000000000001</c:v>
                </c:pt>
                <c:pt idx="134">
                  <c:v>0.25990000000000002</c:v>
                </c:pt>
                <c:pt idx="135">
                  <c:v>0.2787</c:v>
                </c:pt>
                <c:pt idx="136">
                  <c:v>0.25330000000000003</c:v>
                </c:pt>
                <c:pt idx="137">
                  <c:v>0.21779999999999999</c:v>
                </c:pt>
                <c:pt idx="138">
                  <c:v>0.2132</c:v>
                </c:pt>
                <c:pt idx="139">
                  <c:v>0.2195</c:v>
                </c:pt>
                <c:pt idx="140">
                  <c:v>0.2019</c:v>
                </c:pt>
                <c:pt idx="141">
                  <c:v>0.18779999999999999</c:v>
                </c:pt>
                <c:pt idx="142">
                  <c:v>0.17469999999999999</c:v>
                </c:pt>
                <c:pt idx="143">
                  <c:v>0.17280000000000001</c:v>
                </c:pt>
                <c:pt idx="144">
                  <c:v>0.16619999999999999</c:v>
                </c:pt>
                <c:pt idx="145">
                  <c:v>0.15190000000000001</c:v>
                </c:pt>
                <c:pt idx="146">
                  <c:v>0.155</c:v>
                </c:pt>
                <c:pt idx="147">
                  <c:v>0.15759999999999999</c:v>
                </c:pt>
                <c:pt idx="148">
                  <c:v>0.1454</c:v>
                </c:pt>
                <c:pt idx="149">
                  <c:v>0.14349999999999999</c:v>
                </c:pt>
                <c:pt idx="150">
                  <c:v>0.152</c:v>
                </c:pt>
                <c:pt idx="151">
                  <c:v>0.1484</c:v>
                </c:pt>
                <c:pt idx="152">
                  <c:v>0.1363</c:v>
                </c:pt>
                <c:pt idx="153">
                  <c:v>0.14369999999999999</c:v>
                </c:pt>
                <c:pt idx="154">
                  <c:v>0.1449</c:v>
                </c:pt>
                <c:pt idx="155">
                  <c:v>0.13750000000000001</c:v>
                </c:pt>
                <c:pt idx="156">
                  <c:v>0.14180000000000001</c:v>
                </c:pt>
                <c:pt idx="157">
                  <c:v>0.14699999999999999</c:v>
                </c:pt>
                <c:pt idx="158">
                  <c:v>0.14230000000000001</c:v>
                </c:pt>
                <c:pt idx="159">
                  <c:v>0.14779999999999999</c:v>
                </c:pt>
                <c:pt idx="160">
                  <c:v>0.16039999999999999</c:v>
                </c:pt>
                <c:pt idx="161">
                  <c:v>0.16589999999999999</c:v>
                </c:pt>
                <c:pt idx="162">
                  <c:v>0.16830000000000001</c:v>
                </c:pt>
                <c:pt idx="163">
                  <c:v>0.18559999999999999</c:v>
                </c:pt>
                <c:pt idx="164">
                  <c:v>0.20019999999999999</c:v>
                </c:pt>
                <c:pt idx="165">
                  <c:v>0.20169999999999999</c:v>
                </c:pt>
                <c:pt idx="166">
                  <c:v>0.2142</c:v>
                </c:pt>
                <c:pt idx="167">
                  <c:v>0.2341</c:v>
                </c:pt>
                <c:pt idx="168">
                  <c:v>0.2452</c:v>
                </c:pt>
                <c:pt idx="169">
                  <c:v>0.25969999999999999</c:v>
                </c:pt>
                <c:pt idx="170">
                  <c:v>0.30330000000000001</c:v>
                </c:pt>
                <c:pt idx="171">
                  <c:v>0.35099999999999998</c:v>
                </c:pt>
                <c:pt idx="172">
                  <c:v>0.39400000000000002</c:v>
                </c:pt>
                <c:pt idx="173">
                  <c:v>0.47899999999999998</c:v>
                </c:pt>
                <c:pt idx="174">
                  <c:v>0.49220000000000003</c:v>
                </c:pt>
                <c:pt idx="175">
                  <c:v>0.47560000000000002</c:v>
                </c:pt>
                <c:pt idx="176">
                  <c:v>0.42380000000000001</c:v>
                </c:pt>
                <c:pt idx="177">
                  <c:v>0.41880000000000001</c:v>
                </c:pt>
                <c:pt idx="178">
                  <c:v>0.374</c:v>
                </c:pt>
                <c:pt idx="179">
                  <c:v>0.35759999999999997</c:v>
                </c:pt>
                <c:pt idx="180">
                  <c:v>0.33479999999999999</c:v>
                </c:pt>
                <c:pt idx="181">
                  <c:v>0.34</c:v>
                </c:pt>
                <c:pt idx="182">
                  <c:v>0.30980000000000002</c:v>
                </c:pt>
                <c:pt idx="183">
                  <c:v>0.28010000000000002</c:v>
                </c:pt>
                <c:pt idx="184">
                  <c:v>0.29249999999999998</c:v>
                </c:pt>
                <c:pt idx="185">
                  <c:v>0.29210000000000003</c:v>
                </c:pt>
                <c:pt idx="186">
                  <c:v>0.25750000000000001</c:v>
                </c:pt>
                <c:pt idx="187">
                  <c:v>0.24610000000000001</c:v>
                </c:pt>
                <c:pt idx="188">
                  <c:v>0.26450000000000001</c:v>
                </c:pt>
                <c:pt idx="189">
                  <c:v>0.251</c:v>
                </c:pt>
                <c:pt idx="190">
                  <c:v>0.2195</c:v>
                </c:pt>
                <c:pt idx="191">
                  <c:v>0.22459999999999999</c:v>
                </c:pt>
                <c:pt idx="192">
                  <c:v>0.24030000000000001</c:v>
                </c:pt>
                <c:pt idx="193">
                  <c:v>0.21759999999999999</c:v>
                </c:pt>
                <c:pt idx="194">
                  <c:v>0.19570000000000001</c:v>
                </c:pt>
                <c:pt idx="195">
                  <c:v>0.2137</c:v>
                </c:pt>
                <c:pt idx="196">
                  <c:v>0.22209999999999999</c:v>
                </c:pt>
                <c:pt idx="197">
                  <c:v>0.1923</c:v>
                </c:pt>
                <c:pt idx="198">
                  <c:v>0.1883</c:v>
                </c:pt>
                <c:pt idx="199">
                  <c:v>0.21149999999999999</c:v>
                </c:pt>
                <c:pt idx="200">
                  <c:v>0.20549999999999999</c:v>
                </c:pt>
                <c:pt idx="201">
                  <c:v>0.182</c:v>
                </c:pt>
                <c:pt idx="202">
                  <c:v>0.1981</c:v>
                </c:pt>
                <c:pt idx="203">
                  <c:v>0.2296</c:v>
                </c:pt>
                <c:pt idx="204">
                  <c:v>0.23219999999999999</c:v>
                </c:pt>
                <c:pt idx="205">
                  <c:v>0.2019</c:v>
                </c:pt>
                <c:pt idx="206">
                  <c:v>0.18909999999999999</c:v>
                </c:pt>
                <c:pt idx="207">
                  <c:v>0.18310000000000001</c:v>
                </c:pt>
                <c:pt idx="208">
                  <c:v>0.1699</c:v>
                </c:pt>
                <c:pt idx="209">
                  <c:v>0.15820000000000001</c:v>
                </c:pt>
                <c:pt idx="210">
                  <c:v>0.15079999999999999</c:v>
                </c:pt>
                <c:pt idx="211">
                  <c:v>0.14449999999999999</c:v>
                </c:pt>
                <c:pt idx="212">
                  <c:v>0.15690000000000001</c:v>
                </c:pt>
                <c:pt idx="213">
                  <c:v>0.16600000000000001</c:v>
                </c:pt>
                <c:pt idx="214">
                  <c:v>0.15529999999999999</c:v>
                </c:pt>
                <c:pt idx="215">
                  <c:v>0.15809999999999999</c:v>
                </c:pt>
                <c:pt idx="216">
                  <c:v>0.185</c:v>
                </c:pt>
                <c:pt idx="217">
                  <c:v>0.184</c:v>
                </c:pt>
                <c:pt idx="218">
                  <c:v>0.1729</c:v>
                </c:pt>
                <c:pt idx="219">
                  <c:v>0.19270000000000001</c:v>
                </c:pt>
                <c:pt idx="220">
                  <c:v>0.21840000000000001</c:v>
                </c:pt>
                <c:pt idx="221">
                  <c:v>0.216</c:v>
                </c:pt>
                <c:pt idx="222">
                  <c:v>0.216</c:v>
                </c:pt>
                <c:pt idx="223">
                  <c:v>0.24349999999999999</c:v>
                </c:pt>
                <c:pt idx="224">
                  <c:v>0.2591</c:v>
                </c:pt>
                <c:pt idx="225">
                  <c:v>0.26019999999999999</c:v>
                </c:pt>
                <c:pt idx="226">
                  <c:v>0.27600000000000002</c:v>
                </c:pt>
                <c:pt idx="227">
                  <c:v>0.311</c:v>
                </c:pt>
                <c:pt idx="228">
                  <c:v>0.32240000000000002</c:v>
                </c:pt>
                <c:pt idx="229">
                  <c:v>0.30549999999999999</c:v>
                </c:pt>
                <c:pt idx="230">
                  <c:v>0.32990000000000003</c:v>
                </c:pt>
                <c:pt idx="231">
                  <c:v>0.32819999999999999</c:v>
                </c:pt>
                <c:pt idx="232">
                  <c:v>0.3276</c:v>
                </c:pt>
                <c:pt idx="233">
                  <c:v>0.29930000000000001</c:v>
                </c:pt>
                <c:pt idx="234">
                  <c:v>0.28539999999999999</c:v>
                </c:pt>
                <c:pt idx="235">
                  <c:v>0.27079999999999999</c:v>
                </c:pt>
                <c:pt idx="236">
                  <c:v>0.29120000000000001</c:v>
                </c:pt>
                <c:pt idx="237">
                  <c:v>0.34520000000000001</c:v>
                </c:pt>
                <c:pt idx="238">
                  <c:v>0.35089999999999999</c:v>
                </c:pt>
                <c:pt idx="239">
                  <c:v>0.39600000000000002</c:v>
                </c:pt>
                <c:pt idx="240">
                  <c:v>0.36870000000000003</c:v>
                </c:pt>
                <c:pt idx="241">
                  <c:v>0.38090000000000002</c:v>
                </c:pt>
                <c:pt idx="242">
                  <c:v>0.35709999999999997</c:v>
                </c:pt>
                <c:pt idx="243">
                  <c:v>0.34320000000000001</c:v>
                </c:pt>
                <c:pt idx="244">
                  <c:v>0.30919999999999997</c:v>
                </c:pt>
                <c:pt idx="245">
                  <c:v>0.32219999999999999</c:v>
                </c:pt>
                <c:pt idx="246">
                  <c:v>0.36280000000000001</c:v>
                </c:pt>
                <c:pt idx="247">
                  <c:v>0.42420000000000002</c:v>
                </c:pt>
                <c:pt idx="248">
                  <c:v>0.48749999999999999</c:v>
                </c:pt>
                <c:pt idx="249">
                  <c:v>0.50070000000000003</c:v>
                </c:pt>
                <c:pt idx="250">
                  <c:v>0.46479999999999999</c:v>
                </c:pt>
                <c:pt idx="251">
                  <c:v>0.38500000000000001</c:v>
                </c:pt>
                <c:pt idx="252">
                  <c:v>0.34439999999999998</c:v>
                </c:pt>
                <c:pt idx="253">
                  <c:v>0.3261</c:v>
                </c:pt>
                <c:pt idx="254">
                  <c:v>0.29149999999999998</c:v>
                </c:pt>
                <c:pt idx="255">
                  <c:v>0.27389999999999998</c:v>
                </c:pt>
                <c:pt idx="256">
                  <c:v>0.28270000000000001</c:v>
                </c:pt>
                <c:pt idx="257">
                  <c:v>0.26700000000000002</c:v>
                </c:pt>
                <c:pt idx="258">
                  <c:v>0.2336</c:v>
                </c:pt>
                <c:pt idx="259">
                  <c:v>0.2399</c:v>
                </c:pt>
                <c:pt idx="260">
                  <c:v>0.24340000000000001</c:v>
                </c:pt>
                <c:pt idx="261">
                  <c:v>0.2</c:v>
                </c:pt>
                <c:pt idx="262">
                  <c:v>0.17810000000000001</c:v>
                </c:pt>
                <c:pt idx="263">
                  <c:v>0.2</c:v>
                </c:pt>
                <c:pt idx="264">
                  <c:v>0.2019</c:v>
                </c:pt>
                <c:pt idx="265">
                  <c:v>0.2424</c:v>
                </c:pt>
                <c:pt idx="266">
                  <c:v>0.26269999999999999</c:v>
                </c:pt>
                <c:pt idx="267">
                  <c:v>0.27379999999999999</c:v>
                </c:pt>
                <c:pt idx="268">
                  <c:v>0.25430000000000003</c:v>
                </c:pt>
                <c:pt idx="269">
                  <c:v>0.24299999999999999</c:v>
                </c:pt>
                <c:pt idx="270">
                  <c:v>0.27310000000000001</c:v>
                </c:pt>
                <c:pt idx="271">
                  <c:v>0.26300000000000001</c:v>
                </c:pt>
                <c:pt idx="272">
                  <c:v>0.23300000000000001</c:v>
                </c:pt>
                <c:pt idx="273">
                  <c:v>0.26</c:v>
                </c:pt>
                <c:pt idx="274">
                  <c:v>0.28360000000000002</c:v>
                </c:pt>
                <c:pt idx="275">
                  <c:v>0.25800000000000001</c:v>
                </c:pt>
                <c:pt idx="276">
                  <c:v>0.25700000000000001</c:v>
                </c:pt>
                <c:pt idx="277">
                  <c:v>0.29680000000000001</c:v>
                </c:pt>
                <c:pt idx="278">
                  <c:v>0.29909999999999998</c:v>
                </c:pt>
                <c:pt idx="279">
                  <c:v>0.28360000000000002</c:v>
                </c:pt>
                <c:pt idx="280">
                  <c:v>0.30509999999999998</c:v>
                </c:pt>
                <c:pt idx="281">
                  <c:v>0.33460000000000001</c:v>
                </c:pt>
                <c:pt idx="282">
                  <c:v>0.32940000000000003</c:v>
                </c:pt>
                <c:pt idx="283">
                  <c:v>0.31440000000000001</c:v>
                </c:pt>
                <c:pt idx="284">
                  <c:v>0.33229999999999998</c:v>
                </c:pt>
                <c:pt idx="285">
                  <c:v>0.36620000000000003</c:v>
                </c:pt>
                <c:pt idx="286">
                  <c:v>0.372</c:v>
                </c:pt>
                <c:pt idx="287">
                  <c:v>0.40050000000000002</c:v>
                </c:pt>
                <c:pt idx="288">
                  <c:v>0.38169999999999998</c:v>
                </c:pt>
                <c:pt idx="289">
                  <c:v>0.41089999999999999</c:v>
                </c:pt>
                <c:pt idx="290">
                  <c:v>0.435</c:v>
                </c:pt>
                <c:pt idx="291">
                  <c:v>0.41489999999999999</c:v>
                </c:pt>
                <c:pt idx="292">
                  <c:v>0.47439999999999999</c:v>
                </c:pt>
                <c:pt idx="293">
                  <c:v>0.50139999999999996</c:v>
                </c:pt>
                <c:pt idx="294">
                  <c:v>0.45629999999999998</c:v>
                </c:pt>
                <c:pt idx="295">
                  <c:v>0.49130000000000001</c:v>
                </c:pt>
                <c:pt idx="296">
                  <c:v>0.43709999999999999</c:v>
                </c:pt>
                <c:pt idx="297">
                  <c:v>0.40589999999999998</c:v>
                </c:pt>
                <c:pt idx="298">
                  <c:v>0.3634</c:v>
                </c:pt>
                <c:pt idx="299">
                  <c:v>0.376</c:v>
                </c:pt>
                <c:pt idx="300">
                  <c:v>0.39560000000000001</c:v>
                </c:pt>
                <c:pt idx="301">
                  <c:v>0.38690000000000002</c:v>
                </c:pt>
                <c:pt idx="302">
                  <c:v>0.35820000000000002</c:v>
                </c:pt>
                <c:pt idx="303">
                  <c:v>0.37580000000000002</c:v>
                </c:pt>
                <c:pt idx="304">
                  <c:v>0.3931</c:v>
                </c:pt>
                <c:pt idx="305">
                  <c:v>0.3977</c:v>
                </c:pt>
                <c:pt idx="306">
                  <c:v>0.36870000000000003</c:v>
                </c:pt>
                <c:pt idx="307">
                  <c:v>0.35449999999999998</c:v>
                </c:pt>
                <c:pt idx="308">
                  <c:v>0.35720000000000002</c:v>
                </c:pt>
                <c:pt idx="309">
                  <c:v>0.36370000000000002</c:v>
                </c:pt>
                <c:pt idx="310">
                  <c:v>0.3679</c:v>
                </c:pt>
                <c:pt idx="311">
                  <c:v>0.3992</c:v>
                </c:pt>
                <c:pt idx="312">
                  <c:v>0.3921</c:v>
                </c:pt>
                <c:pt idx="313">
                  <c:v>0.35170000000000001</c:v>
                </c:pt>
                <c:pt idx="314">
                  <c:v>0.34639999999999999</c:v>
                </c:pt>
                <c:pt idx="315">
                  <c:v>0.37930000000000003</c:v>
                </c:pt>
                <c:pt idx="316">
                  <c:v>0.38479999999999998</c:v>
                </c:pt>
                <c:pt idx="317">
                  <c:v>0.39989999999999998</c:v>
                </c:pt>
                <c:pt idx="318">
                  <c:v>0.37330000000000002</c:v>
                </c:pt>
                <c:pt idx="319">
                  <c:v>0.32700000000000001</c:v>
                </c:pt>
                <c:pt idx="320">
                  <c:v>0.34710000000000002</c:v>
                </c:pt>
                <c:pt idx="321">
                  <c:v>0.35809999999999997</c:v>
                </c:pt>
                <c:pt idx="322">
                  <c:v>0.31330000000000002</c:v>
                </c:pt>
                <c:pt idx="323">
                  <c:v>0.29360000000000003</c:v>
                </c:pt>
                <c:pt idx="324">
                  <c:v>0.3236</c:v>
                </c:pt>
                <c:pt idx="325">
                  <c:v>0.3155</c:v>
                </c:pt>
                <c:pt idx="326">
                  <c:v>0.27789999999999998</c:v>
                </c:pt>
                <c:pt idx="327">
                  <c:v>0.28710000000000002</c:v>
                </c:pt>
                <c:pt idx="328">
                  <c:v>0.3115</c:v>
                </c:pt>
                <c:pt idx="329">
                  <c:v>0.28960000000000002</c:v>
                </c:pt>
                <c:pt idx="330">
                  <c:v>0.26650000000000001</c:v>
                </c:pt>
                <c:pt idx="331">
                  <c:v>0.29880000000000001</c:v>
                </c:pt>
                <c:pt idx="332">
                  <c:v>0.31590000000000001</c:v>
                </c:pt>
                <c:pt idx="333">
                  <c:v>0.29649999999999999</c:v>
                </c:pt>
                <c:pt idx="334">
                  <c:v>0.2989</c:v>
                </c:pt>
                <c:pt idx="335">
                  <c:v>0.2707</c:v>
                </c:pt>
                <c:pt idx="336">
                  <c:v>0.25459999999999999</c:v>
                </c:pt>
                <c:pt idx="337">
                  <c:v>0.2235</c:v>
                </c:pt>
                <c:pt idx="338">
                  <c:v>0.21299999999999999</c:v>
                </c:pt>
                <c:pt idx="339">
                  <c:v>0.19040000000000001</c:v>
                </c:pt>
                <c:pt idx="340">
                  <c:v>0.20449999999999999</c:v>
                </c:pt>
                <c:pt idx="341">
                  <c:v>0.19439999999999999</c:v>
                </c:pt>
                <c:pt idx="342">
                  <c:v>0.19089999999999999</c:v>
                </c:pt>
                <c:pt idx="343">
                  <c:v>0.2243</c:v>
                </c:pt>
                <c:pt idx="344">
                  <c:v>0.26040000000000002</c:v>
                </c:pt>
                <c:pt idx="345">
                  <c:v>0.31929999999999997</c:v>
                </c:pt>
                <c:pt idx="346">
                  <c:v>0.37059999999999998</c:v>
                </c:pt>
                <c:pt idx="347">
                  <c:v>0.31230000000000002</c:v>
                </c:pt>
                <c:pt idx="348">
                  <c:v>0.29349999999999998</c:v>
                </c:pt>
                <c:pt idx="349">
                  <c:v>0.24479999999999999</c:v>
                </c:pt>
                <c:pt idx="350">
                  <c:v>0.22500000000000001</c:v>
                </c:pt>
                <c:pt idx="351">
                  <c:v>0.23880000000000001</c:v>
                </c:pt>
                <c:pt idx="352">
                  <c:v>0.2369</c:v>
                </c:pt>
                <c:pt idx="353">
                  <c:v>0.23519999999999999</c:v>
                </c:pt>
                <c:pt idx="354">
                  <c:v>0.1923</c:v>
                </c:pt>
                <c:pt idx="355">
                  <c:v>0.1696</c:v>
                </c:pt>
                <c:pt idx="356">
                  <c:v>0.2777</c:v>
                </c:pt>
                <c:pt idx="357">
                  <c:v>0.25330000000000003</c:v>
                </c:pt>
                <c:pt idx="358">
                  <c:v>0.28499999999999998</c:v>
                </c:pt>
                <c:pt idx="359">
                  <c:v>0.22489999999999999</c:v>
                </c:pt>
                <c:pt idx="360">
                  <c:v>0.21440000000000001</c:v>
                </c:pt>
                <c:pt idx="361">
                  <c:v>0.22070000000000001</c:v>
                </c:pt>
                <c:pt idx="362">
                  <c:v>0.18840000000000001</c:v>
                </c:pt>
                <c:pt idx="363">
                  <c:v>0.18740000000000001</c:v>
                </c:pt>
                <c:pt idx="364">
                  <c:v>0.1925</c:v>
                </c:pt>
                <c:pt idx="365">
                  <c:v>0.20419999999999999</c:v>
                </c:pt>
                <c:pt idx="366">
                  <c:v>0.21160000000000001</c:v>
                </c:pt>
                <c:pt idx="367">
                  <c:v>0.21970000000000001</c:v>
                </c:pt>
                <c:pt idx="368">
                  <c:v>0.24030000000000001</c:v>
                </c:pt>
                <c:pt idx="369">
                  <c:v>0.25729999999999997</c:v>
                </c:pt>
                <c:pt idx="370">
                  <c:v>0.27979999999999999</c:v>
                </c:pt>
                <c:pt idx="371">
                  <c:v>0.24929999999999999</c:v>
                </c:pt>
                <c:pt idx="372">
                  <c:v>0.20710000000000001</c:v>
                </c:pt>
                <c:pt idx="373">
                  <c:v>0.1862</c:v>
                </c:pt>
                <c:pt idx="374">
                  <c:v>0.1971</c:v>
                </c:pt>
                <c:pt idx="375">
                  <c:v>0.18459999999999999</c:v>
                </c:pt>
                <c:pt idx="376">
                  <c:v>0.22170000000000001</c:v>
                </c:pt>
                <c:pt idx="377">
                  <c:v>0.2417</c:v>
                </c:pt>
                <c:pt idx="378">
                  <c:v>0.2747</c:v>
                </c:pt>
                <c:pt idx="379">
                  <c:v>0.34160000000000001</c:v>
                </c:pt>
                <c:pt idx="380">
                  <c:v>0.27729999999999999</c:v>
                </c:pt>
                <c:pt idx="381">
                  <c:v>0.2974</c:v>
                </c:pt>
                <c:pt idx="382">
                  <c:v>0.3286</c:v>
                </c:pt>
                <c:pt idx="383">
                  <c:v>0.47210000000000002</c:v>
                </c:pt>
                <c:pt idx="384">
                  <c:v>0.53029999999999999</c:v>
                </c:pt>
                <c:pt idx="385">
                  <c:v>0.47910000000000003</c:v>
                </c:pt>
                <c:pt idx="386">
                  <c:v>0.3483</c:v>
                </c:pt>
                <c:pt idx="387">
                  <c:v>0.3155</c:v>
                </c:pt>
                <c:pt idx="388">
                  <c:v>0.36709999999999998</c:v>
                </c:pt>
                <c:pt idx="389">
                  <c:v>0.44390000000000002</c:v>
                </c:pt>
                <c:pt idx="390">
                  <c:v>0.48699999999999999</c:v>
                </c:pt>
                <c:pt idx="391">
                  <c:v>0.57779999999999998</c:v>
                </c:pt>
                <c:pt idx="392">
                  <c:v>0.54600000000000004</c:v>
                </c:pt>
                <c:pt idx="393">
                  <c:v>0.5575</c:v>
                </c:pt>
                <c:pt idx="394">
                  <c:v>0.65239999999999998</c:v>
                </c:pt>
                <c:pt idx="395">
                  <c:v>0.75139999999999996</c:v>
                </c:pt>
                <c:pt idx="396">
                  <c:v>0.85660000000000003</c:v>
                </c:pt>
                <c:pt idx="397">
                  <c:v>0.79920000000000002</c:v>
                </c:pt>
                <c:pt idx="398">
                  <c:v>0.65790000000000004</c:v>
                </c:pt>
                <c:pt idx="399">
                  <c:v>0.47499999999999998</c:v>
                </c:pt>
                <c:pt idx="400">
                  <c:v>0.33939999999999998</c:v>
                </c:pt>
                <c:pt idx="401">
                  <c:v>0.26190000000000002</c:v>
                </c:pt>
                <c:pt idx="402">
                  <c:v>0.23830000000000001</c:v>
                </c:pt>
                <c:pt idx="403">
                  <c:v>0.24679999999999999</c:v>
                </c:pt>
                <c:pt idx="404">
                  <c:v>0.2455</c:v>
                </c:pt>
                <c:pt idx="405">
                  <c:v>0.1958</c:v>
                </c:pt>
                <c:pt idx="406">
                  <c:v>0.16669999999999999</c:v>
                </c:pt>
                <c:pt idx="407">
                  <c:v>0.16159999999999999</c:v>
                </c:pt>
                <c:pt idx="408">
                  <c:v>0.1588</c:v>
                </c:pt>
                <c:pt idx="409">
                  <c:v>0.14779999999999999</c:v>
                </c:pt>
                <c:pt idx="410">
                  <c:v>0.15279999999999999</c:v>
                </c:pt>
                <c:pt idx="411">
                  <c:v>0.15909999999999999</c:v>
                </c:pt>
                <c:pt idx="412">
                  <c:v>0.15359999999999999</c:v>
                </c:pt>
                <c:pt idx="413">
                  <c:v>0.1643</c:v>
                </c:pt>
                <c:pt idx="414">
                  <c:v>0.17630000000000001</c:v>
                </c:pt>
                <c:pt idx="415">
                  <c:v>0.17860000000000001</c:v>
                </c:pt>
                <c:pt idx="416">
                  <c:v>0.18179999999999999</c:v>
                </c:pt>
                <c:pt idx="417">
                  <c:v>0.18990000000000001</c:v>
                </c:pt>
                <c:pt idx="418">
                  <c:v>0.2001</c:v>
                </c:pt>
                <c:pt idx="419">
                  <c:v>0.2064</c:v>
                </c:pt>
                <c:pt idx="420">
                  <c:v>0.20860000000000001</c:v>
                </c:pt>
                <c:pt idx="421">
                  <c:v>0.20849999999999999</c:v>
                </c:pt>
                <c:pt idx="422">
                  <c:v>0.21629999999999999</c:v>
                </c:pt>
                <c:pt idx="423">
                  <c:v>0.2361</c:v>
                </c:pt>
                <c:pt idx="424">
                  <c:v>0.23910000000000001</c:v>
                </c:pt>
                <c:pt idx="425">
                  <c:v>0.25309999999999999</c:v>
                </c:pt>
                <c:pt idx="426">
                  <c:v>0.2361</c:v>
                </c:pt>
                <c:pt idx="427">
                  <c:v>0.25369999999999998</c:v>
                </c:pt>
                <c:pt idx="428">
                  <c:v>0.26290000000000002</c:v>
                </c:pt>
                <c:pt idx="429">
                  <c:v>0.27800000000000002</c:v>
                </c:pt>
                <c:pt idx="430">
                  <c:v>0.30620000000000003</c:v>
                </c:pt>
                <c:pt idx="431">
                  <c:v>0.30080000000000001</c:v>
                </c:pt>
                <c:pt idx="432">
                  <c:v>0.28070000000000001</c:v>
                </c:pt>
                <c:pt idx="433">
                  <c:v>0.29389999999999999</c:v>
                </c:pt>
                <c:pt idx="434">
                  <c:v>0.31409999999999999</c:v>
                </c:pt>
                <c:pt idx="435">
                  <c:v>0.29949999999999999</c:v>
                </c:pt>
                <c:pt idx="436">
                  <c:v>0.28920000000000001</c:v>
                </c:pt>
                <c:pt idx="437">
                  <c:v>0.31269999999999998</c:v>
                </c:pt>
                <c:pt idx="438">
                  <c:v>0.32419999999999999</c:v>
                </c:pt>
                <c:pt idx="439">
                  <c:v>0.30580000000000002</c:v>
                </c:pt>
                <c:pt idx="440">
                  <c:v>0.31080000000000002</c:v>
                </c:pt>
                <c:pt idx="441">
                  <c:v>0.30170000000000002</c:v>
                </c:pt>
                <c:pt idx="442">
                  <c:v>0.31080000000000002</c:v>
                </c:pt>
                <c:pt idx="443">
                  <c:v>0.27160000000000001</c:v>
                </c:pt>
                <c:pt idx="444">
                  <c:v>0.27710000000000001</c:v>
                </c:pt>
                <c:pt idx="445">
                  <c:v>0.26840000000000003</c:v>
                </c:pt>
                <c:pt idx="446">
                  <c:v>0.25719999999999998</c:v>
                </c:pt>
                <c:pt idx="447">
                  <c:v>0.24540000000000001</c:v>
                </c:pt>
                <c:pt idx="448">
                  <c:v>0.24199999999999999</c:v>
                </c:pt>
                <c:pt idx="449">
                  <c:v>0.23630000000000001</c:v>
                </c:pt>
                <c:pt idx="450">
                  <c:v>0.22370000000000001</c:v>
                </c:pt>
                <c:pt idx="451">
                  <c:v>0.21460000000000001</c:v>
                </c:pt>
                <c:pt idx="452">
                  <c:v>0.21560000000000001</c:v>
                </c:pt>
                <c:pt idx="453">
                  <c:v>0.20580000000000001</c:v>
                </c:pt>
                <c:pt idx="454">
                  <c:v>0.1923</c:v>
                </c:pt>
                <c:pt idx="455">
                  <c:v>0.19059999999999999</c:v>
                </c:pt>
                <c:pt idx="456">
                  <c:v>0.1903</c:v>
                </c:pt>
                <c:pt idx="457">
                  <c:v>0.1804</c:v>
                </c:pt>
                <c:pt idx="458">
                  <c:v>0.16980000000000001</c:v>
                </c:pt>
                <c:pt idx="459">
                  <c:v>0.17330000000000001</c:v>
                </c:pt>
                <c:pt idx="460">
                  <c:v>0.1832</c:v>
                </c:pt>
                <c:pt idx="461">
                  <c:v>0.2056</c:v>
                </c:pt>
                <c:pt idx="462">
                  <c:v>0.22889999999999999</c:v>
                </c:pt>
                <c:pt idx="463">
                  <c:v>0.2873</c:v>
                </c:pt>
                <c:pt idx="464">
                  <c:v>0.31280000000000002</c:v>
                </c:pt>
                <c:pt idx="465">
                  <c:v>0.3851</c:v>
                </c:pt>
                <c:pt idx="466">
                  <c:v>0.4093</c:v>
                </c:pt>
                <c:pt idx="467">
                  <c:v>0.40960000000000002</c:v>
                </c:pt>
                <c:pt idx="468">
                  <c:v>0.49859999999999999</c:v>
                </c:pt>
                <c:pt idx="469">
                  <c:v>0.4617</c:v>
                </c:pt>
                <c:pt idx="470">
                  <c:v>0.43309999999999998</c:v>
                </c:pt>
                <c:pt idx="471">
                  <c:v>0.43780000000000002</c:v>
                </c:pt>
                <c:pt idx="472">
                  <c:v>0.44159999999999999</c:v>
                </c:pt>
                <c:pt idx="473">
                  <c:v>0.41089999999999999</c:v>
                </c:pt>
                <c:pt idx="474">
                  <c:v>0.31619999999999998</c:v>
                </c:pt>
                <c:pt idx="475">
                  <c:v>0.251</c:v>
                </c:pt>
                <c:pt idx="476">
                  <c:v>0.22950000000000001</c:v>
                </c:pt>
                <c:pt idx="477">
                  <c:v>0.2198</c:v>
                </c:pt>
                <c:pt idx="478">
                  <c:v>0.2271</c:v>
                </c:pt>
                <c:pt idx="479">
                  <c:v>0.20569999999999999</c:v>
                </c:pt>
                <c:pt idx="480">
                  <c:v>0.1842</c:v>
                </c:pt>
                <c:pt idx="481">
                  <c:v>0.2</c:v>
                </c:pt>
                <c:pt idx="482">
                  <c:v>0.20949999999999999</c:v>
                </c:pt>
                <c:pt idx="483">
                  <c:v>0.185</c:v>
                </c:pt>
                <c:pt idx="484">
                  <c:v>0.18110000000000001</c:v>
                </c:pt>
                <c:pt idx="485">
                  <c:v>0.2006</c:v>
                </c:pt>
                <c:pt idx="486">
                  <c:v>0.1996</c:v>
                </c:pt>
                <c:pt idx="487">
                  <c:v>0.1835</c:v>
                </c:pt>
                <c:pt idx="488">
                  <c:v>0.1923</c:v>
                </c:pt>
                <c:pt idx="489">
                  <c:v>0.20669999999999999</c:v>
                </c:pt>
                <c:pt idx="490">
                  <c:v>0.19520000000000001</c:v>
                </c:pt>
                <c:pt idx="491">
                  <c:v>0.18970000000000001</c:v>
                </c:pt>
                <c:pt idx="492">
                  <c:v>0.20830000000000001</c:v>
                </c:pt>
                <c:pt idx="493">
                  <c:v>0.2155</c:v>
                </c:pt>
                <c:pt idx="494">
                  <c:v>0.20219999999999999</c:v>
                </c:pt>
                <c:pt idx="495">
                  <c:v>0.20749999999999999</c:v>
                </c:pt>
                <c:pt idx="496">
                  <c:v>0.22919999999999999</c:v>
                </c:pt>
                <c:pt idx="497">
                  <c:v>0.22900000000000001</c:v>
                </c:pt>
                <c:pt idx="498">
                  <c:v>0.22270000000000001</c:v>
                </c:pt>
                <c:pt idx="499">
                  <c:v>0.23549999999999999</c:v>
                </c:pt>
                <c:pt idx="500">
                  <c:v>0.254</c:v>
                </c:pt>
                <c:pt idx="501">
                  <c:v>0.252</c:v>
                </c:pt>
                <c:pt idx="502">
                  <c:v>0.24959999999999999</c:v>
                </c:pt>
                <c:pt idx="503">
                  <c:v>0.27229999999999999</c:v>
                </c:pt>
                <c:pt idx="504">
                  <c:v>0.2833</c:v>
                </c:pt>
                <c:pt idx="505">
                  <c:v>0.27910000000000001</c:v>
                </c:pt>
                <c:pt idx="506">
                  <c:v>0.2873</c:v>
                </c:pt>
                <c:pt idx="507">
                  <c:v>0.308</c:v>
                </c:pt>
                <c:pt idx="508">
                  <c:v>0.31669999999999998</c:v>
                </c:pt>
                <c:pt idx="509">
                  <c:v>0.32329999999999998</c:v>
                </c:pt>
                <c:pt idx="510">
                  <c:v>0.3337</c:v>
                </c:pt>
                <c:pt idx="511">
                  <c:v>0.35020000000000001</c:v>
                </c:pt>
                <c:pt idx="512">
                  <c:v>0.34670000000000001</c:v>
                </c:pt>
                <c:pt idx="513">
                  <c:v>0.33260000000000001</c:v>
                </c:pt>
                <c:pt idx="514">
                  <c:v>0.34089999999999998</c:v>
                </c:pt>
                <c:pt idx="515">
                  <c:v>0.30499999999999999</c:v>
                </c:pt>
                <c:pt idx="516">
                  <c:v>0.29859999999999998</c:v>
                </c:pt>
                <c:pt idx="517">
                  <c:v>0.28699999999999998</c:v>
                </c:pt>
                <c:pt idx="518">
                  <c:v>0.2676</c:v>
                </c:pt>
                <c:pt idx="519">
                  <c:v>0.25940000000000002</c:v>
                </c:pt>
                <c:pt idx="520">
                  <c:v>0.25719999999999998</c:v>
                </c:pt>
                <c:pt idx="521">
                  <c:v>0.2414</c:v>
                </c:pt>
                <c:pt idx="522">
                  <c:v>0.2271</c:v>
                </c:pt>
                <c:pt idx="523">
                  <c:v>0.21129999999999999</c:v>
                </c:pt>
                <c:pt idx="524">
                  <c:v>0.21079999999999999</c:v>
                </c:pt>
                <c:pt idx="525">
                  <c:v>0.20710000000000001</c:v>
                </c:pt>
                <c:pt idx="526">
                  <c:v>0.1925</c:v>
                </c:pt>
                <c:pt idx="527">
                  <c:v>0.18820000000000001</c:v>
                </c:pt>
                <c:pt idx="528">
                  <c:v>0.1923</c:v>
                </c:pt>
                <c:pt idx="529">
                  <c:v>0.186</c:v>
                </c:pt>
                <c:pt idx="530">
                  <c:v>0.1741</c:v>
                </c:pt>
                <c:pt idx="531">
                  <c:v>0.17299999999999999</c:v>
                </c:pt>
                <c:pt idx="532">
                  <c:v>0.1772</c:v>
                </c:pt>
                <c:pt idx="533">
                  <c:v>0.16850000000000001</c:v>
                </c:pt>
                <c:pt idx="534">
                  <c:v>0.1578</c:v>
                </c:pt>
                <c:pt idx="535">
                  <c:v>0.1605</c:v>
                </c:pt>
                <c:pt idx="536">
                  <c:v>0.1636</c:v>
                </c:pt>
                <c:pt idx="537">
                  <c:v>0.1525</c:v>
                </c:pt>
                <c:pt idx="538">
                  <c:v>0.1497</c:v>
                </c:pt>
                <c:pt idx="539">
                  <c:v>0.1595</c:v>
                </c:pt>
                <c:pt idx="540">
                  <c:v>0.1595</c:v>
                </c:pt>
                <c:pt idx="541">
                  <c:v>0.14360000000000001</c:v>
                </c:pt>
                <c:pt idx="542">
                  <c:v>0.14710000000000001</c:v>
                </c:pt>
                <c:pt idx="543">
                  <c:v>0.1439</c:v>
                </c:pt>
                <c:pt idx="544">
                  <c:v>0.15579999999999999</c:v>
                </c:pt>
                <c:pt idx="545">
                  <c:v>0.154</c:v>
                </c:pt>
                <c:pt idx="546">
                  <c:v>0.15190000000000001</c:v>
                </c:pt>
                <c:pt idx="547">
                  <c:v>0.15479999999999999</c:v>
                </c:pt>
                <c:pt idx="548">
                  <c:v>0.15840000000000001</c:v>
                </c:pt>
                <c:pt idx="549">
                  <c:v>0.15840000000000001</c:v>
                </c:pt>
                <c:pt idx="550">
                  <c:v>0.1623</c:v>
                </c:pt>
                <c:pt idx="551">
                  <c:v>0.1694</c:v>
                </c:pt>
                <c:pt idx="552">
                  <c:v>0.16930000000000001</c:v>
                </c:pt>
                <c:pt idx="553">
                  <c:v>0.1709</c:v>
                </c:pt>
                <c:pt idx="554">
                  <c:v>0.1804</c:v>
                </c:pt>
                <c:pt idx="555">
                  <c:v>0.1832</c:v>
                </c:pt>
                <c:pt idx="556">
                  <c:v>0.18360000000000001</c:v>
                </c:pt>
                <c:pt idx="557">
                  <c:v>0.18310000000000001</c:v>
                </c:pt>
                <c:pt idx="558">
                  <c:v>0.18279999999999999</c:v>
                </c:pt>
                <c:pt idx="559">
                  <c:v>0.19570000000000001</c:v>
                </c:pt>
                <c:pt idx="560">
                  <c:v>0.19439999999999999</c:v>
                </c:pt>
                <c:pt idx="561">
                  <c:v>0.18920000000000001</c:v>
                </c:pt>
                <c:pt idx="562">
                  <c:v>0.1993</c:v>
                </c:pt>
                <c:pt idx="563">
                  <c:v>0.2177</c:v>
                </c:pt>
                <c:pt idx="564">
                  <c:v>0.21229999999999999</c:v>
                </c:pt>
                <c:pt idx="565">
                  <c:v>0.19739999999999999</c:v>
                </c:pt>
                <c:pt idx="566">
                  <c:v>0.21890000000000001</c:v>
                </c:pt>
                <c:pt idx="567">
                  <c:v>0.2417</c:v>
                </c:pt>
                <c:pt idx="568">
                  <c:v>0.2238</c:v>
                </c:pt>
                <c:pt idx="569">
                  <c:v>0.19900000000000001</c:v>
                </c:pt>
                <c:pt idx="570">
                  <c:v>0.22209999999999999</c:v>
                </c:pt>
                <c:pt idx="571">
                  <c:v>0.22969999999999999</c:v>
                </c:pt>
                <c:pt idx="572">
                  <c:v>0.21859999999999999</c:v>
                </c:pt>
                <c:pt idx="573">
                  <c:v>0.2266</c:v>
                </c:pt>
                <c:pt idx="574">
                  <c:v>0.214</c:v>
                </c:pt>
                <c:pt idx="575">
                  <c:v>0.1963</c:v>
                </c:pt>
                <c:pt idx="576">
                  <c:v>0.18049999999999999</c:v>
                </c:pt>
                <c:pt idx="577">
                  <c:v>0.1749</c:v>
                </c:pt>
                <c:pt idx="578">
                  <c:v>0.17150000000000001</c:v>
                </c:pt>
                <c:pt idx="579">
                  <c:v>0.17030000000000001</c:v>
                </c:pt>
                <c:pt idx="580">
                  <c:v>0.17599999999999999</c:v>
                </c:pt>
                <c:pt idx="581">
                  <c:v>0.1724</c:v>
                </c:pt>
                <c:pt idx="582">
                  <c:v>0.1696</c:v>
                </c:pt>
                <c:pt idx="583">
                  <c:v>0.17730000000000001</c:v>
                </c:pt>
                <c:pt idx="584">
                  <c:v>0.1789</c:v>
                </c:pt>
                <c:pt idx="585">
                  <c:v>0.17369999999999999</c:v>
                </c:pt>
                <c:pt idx="586">
                  <c:v>0.1774</c:v>
                </c:pt>
                <c:pt idx="587">
                  <c:v>0.1885</c:v>
                </c:pt>
                <c:pt idx="588">
                  <c:v>0.18959999999999999</c:v>
                </c:pt>
                <c:pt idx="589">
                  <c:v>0.17979999999999999</c:v>
                </c:pt>
                <c:pt idx="590">
                  <c:v>0.17949999999999999</c:v>
                </c:pt>
                <c:pt idx="591">
                  <c:v>0.1913</c:v>
                </c:pt>
                <c:pt idx="592">
                  <c:v>0.1948</c:v>
                </c:pt>
                <c:pt idx="593">
                  <c:v>0.19350000000000001</c:v>
                </c:pt>
                <c:pt idx="594">
                  <c:v>0.1852</c:v>
                </c:pt>
                <c:pt idx="595">
                  <c:v>0.19520000000000001</c:v>
                </c:pt>
                <c:pt idx="596">
                  <c:v>0.20519999999999999</c:v>
                </c:pt>
                <c:pt idx="597">
                  <c:v>0.20080000000000001</c:v>
                </c:pt>
                <c:pt idx="598">
                  <c:v>0.21410000000000001</c:v>
                </c:pt>
                <c:pt idx="599">
                  <c:v>0.2092</c:v>
                </c:pt>
                <c:pt idx="600">
                  <c:v>0.2036</c:v>
                </c:pt>
                <c:pt idx="601">
                  <c:v>0.21160000000000001</c:v>
                </c:pt>
                <c:pt idx="602">
                  <c:v>0.21779999999999999</c:v>
                </c:pt>
                <c:pt idx="603">
                  <c:v>0.2293</c:v>
                </c:pt>
                <c:pt idx="604">
                  <c:v>0.23699999999999999</c:v>
                </c:pt>
                <c:pt idx="605">
                  <c:v>0.24249999999999999</c:v>
                </c:pt>
                <c:pt idx="606">
                  <c:v>0.24990000000000001</c:v>
                </c:pt>
                <c:pt idx="607">
                  <c:v>0.27079999999999999</c:v>
                </c:pt>
                <c:pt idx="608">
                  <c:v>0.2833</c:v>
                </c:pt>
                <c:pt idx="609">
                  <c:v>0.28699999999999998</c:v>
                </c:pt>
                <c:pt idx="610">
                  <c:v>0.30020000000000002</c:v>
                </c:pt>
                <c:pt idx="611">
                  <c:v>0.30940000000000001</c:v>
                </c:pt>
                <c:pt idx="612">
                  <c:v>0.32719999999999999</c:v>
                </c:pt>
                <c:pt idx="613">
                  <c:v>0.29339999999999999</c:v>
                </c:pt>
                <c:pt idx="614">
                  <c:v>0.29189999999999999</c:v>
                </c:pt>
                <c:pt idx="615">
                  <c:v>0.31540000000000001</c:v>
                </c:pt>
                <c:pt idx="616">
                  <c:v>0.30509999999999998</c:v>
                </c:pt>
                <c:pt idx="617">
                  <c:v>0.27389999999999998</c:v>
                </c:pt>
                <c:pt idx="618">
                  <c:v>0.29070000000000001</c:v>
                </c:pt>
                <c:pt idx="619">
                  <c:v>0.31130000000000002</c:v>
                </c:pt>
                <c:pt idx="620">
                  <c:v>0.28620000000000001</c:v>
                </c:pt>
                <c:pt idx="621">
                  <c:v>0.27079999999999999</c:v>
                </c:pt>
                <c:pt idx="622">
                  <c:v>0.23960000000000001</c:v>
                </c:pt>
                <c:pt idx="623">
                  <c:v>0.23630000000000001</c:v>
                </c:pt>
                <c:pt idx="624">
                  <c:v>0.2195</c:v>
                </c:pt>
                <c:pt idx="625">
                  <c:v>0.221</c:v>
                </c:pt>
                <c:pt idx="626">
                  <c:v>0.2243</c:v>
                </c:pt>
                <c:pt idx="627">
                  <c:v>0.21360000000000001</c:v>
                </c:pt>
                <c:pt idx="628">
                  <c:v>0.2079</c:v>
                </c:pt>
                <c:pt idx="629">
                  <c:v>0.21709999999999999</c:v>
                </c:pt>
                <c:pt idx="630">
                  <c:v>0.21249999999999999</c:v>
                </c:pt>
                <c:pt idx="631">
                  <c:v>0.22270000000000001</c:v>
                </c:pt>
                <c:pt idx="632">
                  <c:v>0.21099999999999999</c:v>
                </c:pt>
                <c:pt idx="633">
                  <c:v>0.1978</c:v>
                </c:pt>
                <c:pt idx="634">
                  <c:v>0.20910000000000001</c:v>
                </c:pt>
                <c:pt idx="635">
                  <c:v>0.21659999999999999</c:v>
                </c:pt>
                <c:pt idx="636">
                  <c:v>0.20660000000000001</c:v>
                </c:pt>
                <c:pt idx="637">
                  <c:v>0.20619999999999999</c:v>
                </c:pt>
                <c:pt idx="638">
                  <c:v>0.22409999999999999</c:v>
                </c:pt>
                <c:pt idx="639">
                  <c:v>0.2324</c:v>
                </c:pt>
                <c:pt idx="640">
                  <c:v>0.27879999999999999</c:v>
                </c:pt>
                <c:pt idx="641">
                  <c:v>0.35649999999999998</c:v>
                </c:pt>
                <c:pt idx="642">
                  <c:v>0.54159999999999997</c:v>
                </c:pt>
                <c:pt idx="643">
                  <c:v>0.75280000000000002</c:v>
                </c:pt>
                <c:pt idx="644">
                  <c:v>0.91569999999999996</c:v>
                </c:pt>
                <c:pt idx="645">
                  <c:v>0.83750000000000002</c:v>
                </c:pt>
                <c:pt idx="646">
                  <c:v>0.90169999999999995</c:v>
                </c:pt>
                <c:pt idx="647">
                  <c:v>0.85919999999999996</c:v>
                </c:pt>
                <c:pt idx="648">
                  <c:v>0.92520000000000002</c:v>
                </c:pt>
                <c:pt idx="649">
                  <c:v>0.90859999999999996</c:v>
                </c:pt>
                <c:pt idx="650">
                  <c:v>0.95340000000000003</c:v>
                </c:pt>
                <c:pt idx="651">
                  <c:v>0.96699999999999997</c:v>
                </c:pt>
                <c:pt idx="652">
                  <c:v>0.91739999999999999</c:v>
                </c:pt>
                <c:pt idx="653">
                  <c:v>0.93169999999999997</c:v>
                </c:pt>
                <c:pt idx="654">
                  <c:v>0.91080000000000005</c:v>
                </c:pt>
                <c:pt idx="655">
                  <c:v>0.93820000000000003</c:v>
                </c:pt>
                <c:pt idx="656">
                  <c:v>0.98599999999999999</c:v>
                </c:pt>
                <c:pt idx="657">
                  <c:v>1.0918000000000001</c:v>
                </c:pt>
                <c:pt idx="658">
                  <c:v>1.1778999999999999</c:v>
                </c:pt>
                <c:pt idx="659">
                  <c:v>1.1794</c:v>
                </c:pt>
                <c:pt idx="660">
                  <c:v>1.0512999999999999</c:v>
                </c:pt>
                <c:pt idx="661">
                  <c:v>1.0321</c:v>
                </c:pt>
                <c:pt idx="662">
                  <c:v>1.0013000000000001</c:v>
                </c:pt>
                <c:pt idx="663">
                  <c:v>1.0743</c:v>
                </c:pt>
                <c:pt idx="664">
                  <c:v>1.0649999999999999</c:v>
                </c:pt>
                <c:pt idx="665">
                  <c:v>1.0504</c:v>
                </c:pt>
                <c:pt idx="666">
                  <c:v>1.0474000000000001</c:v>
                </c:pt>
                <c:pt idx="667">
                  <c:v>1.0109999999999999</c:v>
                </c:pt>
                <c:pt idx="668">
                  <c:v>1.0763</c:v>
                </c:pt>
                <c:pt idx="669">
                  <c:v>1.0298</c:v>
                </c:pt>
                <c:pt idx="670">
                  <c:v>1.1004</c:v>
                </c:pt>
                <c:pt idx="671">
                  <c:v>1.0745</c:v>
                </c:pt>
                <c:pt idx="672">
                  <c:v>1.0649999999999999</c:v>
                </c:pt>
                <c:pt idx="673">
                  <c:v>1.0721000000000001</c:v>
                </c:pt>
                <c:pt idx="674">
                  <c:v>1.0960000000000001</c:v>
                </c:pt>
                <c:pt idx="675">
                  <c:v>1.1406000000000001</c:v>
                </c:pt>
                <c:pt idx="676">
                  <c:v>1.1958</c:v>
                </c:pt>
                <c:pt idx="677">
                  <c:v>1.1497999999999999</c:v>
                </c:pt>
                <c:pt idx="678">
                  <c:v>1.2050000000000001</c:v>
                </c:pt>
                <c:pt idx="679">
                  <c:v>1.2494000000000001</c:v>
                </c:pt>
                <c:pt idx="680">
                  <c:v>1.2214</c:v>
                </c:pt>
                <c:pt idx="681">
                  <c:v>1.107</c:v>
                </c:pt>
                <c:pt idx="682">
                  <c:v>1.0823</c:v>
                </c:pt>
                <c:pt idx="683">
                  <c:v>0.99509999999999998</c:v>
                </c:pt>
                <c:pt idx="684">
                  <c:v>1.0347999999999999</c:v>
                </c:pt>
                <c:pt idx="685">
                  <c:v>1.0564</c:v>
                </c:pt>
                <c:pt idx="686">
                  <c:v>1.0707</c:v>
                </c:pt>
                <c:pt idx="687">
                  <c:v>1.0379</c:v>
                </c:pt>
                <c:pt idx="688">
                  <c:v>0.99570000000000003</c:v>
                </c:pt>
                <c:pt idx="689">
                  <c:v>1.0314000000000001</c:v>
                </c:pt>
                <c:pt idx="690">
                  <c:v>1.0831</c:v>
                </c:pt>
                <c:pt idx="691">
                  <c:v>1.0203</c:v>
                </c:pt>
                <c:pt idx="692">
                  <c:v>1.0017</c:v>
                </c:pt>
                <c:pt idx="693">
                  <c:v>0.97499999999999998</c:v>
                </c:pt>
                <c:pt idx="694">
                  <c:v>0.95609999999999995</c:v>
                </c:pt>
                <c:pt idx="695">
                  <c:v>0.96889999999999998</c:v>
                </c:pt>
                <c:pt idx="696">
                  <c:v>0.96</c:v>
                </c:pt>
                <c:pt idx="697">
                  <c:v>1.0632999999999999</c:v>
                </c:pt>
                <c:pt idx="698">
                  <c:v>1.0016</c:v>
                </c:pt>
                <c:pt idx="699">
                  <c:v>0.93859999999999999</c:v>
                </c:pt>
                <c:pt idx="700">
                  <c:v>0.85409999999999997</c:v>
                </c:pt>
                <c:pt idx="701">
                  <c:v>0.77290000000000003</c:v>
                </c:pt>
                <c:pt idx="702">
                  <c:v>0.66890000000000005</c:v>
                </c:pt>
                <c:pt idx="703">
                  <c:v>0.63</c:v>
                </c:pt>
                <c:pt idx="704">
                  <c:v>0.60589999999999999</c:v>
                </c:pt>
                <c:pt idx="705">
                  <c:v>0.53</c:v>
                </c:pt>
                <c:pt idx="706">
                  <c:v>0.51739999999999997</c:v>
                </c:pt>
                <c:pt idx="707">
                  <c:v>0.52280000000000004</c:v>
                </c:pt>
                <c:pt idx="708">
                  <c:v>0.47360000000000002</c:v>
                </c:pt>
                <c:pt idx="709">
                  <c:v>0.51100000000000001</c:v>
                </c:pt>
                <c:pt idx="710">
                  <c:v>0.55910000000000004</c:v>
                </c:pt>
                <c:pt idx="711">
                  <c:v>0.6018</c:v>
                </c:pt>
                <c:pt idx="712">
                  <c:v>0.64739999999999998</c:v>
                </c:pt>
                <c:pt idx="713">
                  <c:v>0.62270000000000003</c:v>
                </c:pt>
                <c:pt idx="714">
                  <c:v>0.65790000000000004</c:v>
                </c:pt>
                <c:pt idx="715">
                  <c:v>0.64219999999999999</c:v>
                </c:pt>
                <c:pt idx="716">
                  <c:v>0.64570000000000005</c:v>
                </c:pt>
                <c:pt idx="717">
                  <c:v>0.77929999999999999</c:v>
                </c:pt>
                <c:pt idx="718">
                  <c:v>0.77410000000000001</c:v>
                </c:pt>
                <c:pt idx="719">
                  <c:v>0.63539999999999996</c:v>
                </c:pt>
                <c:pt idx="720">
                  <c:v>0.53210000000000002</c:v>
                </c:pt>
                <c:pt idx="721">
                  <c:v>0.40479999999999999</c:v>
                </c:pt>
                <c:pt idx="722">
                  <c:v>0.33639999999999998</c:v>
                </c:pt>
                <c:pt idx="723">
                  <c:v>0.30859999999999999</c:v>
                </c:pt>
                <c:pt idx="724">
                  <c:v>0.2802</c:v>
                </c:pt>
                <c:pt idx="725">
                  <c:v>0.2611</c:v>
                </c:pt>
                <c:pt idx="726">
                  <c:v>0.2727</c:v>
                </c:pt>
                <c:pt idx="727">
                  <c:v>0.26879999999999998</c:v>
                </c:pt>
                <c:pt idx="728">
                  <c:v>0.24329999999999999</c:v>
                </c:pt>
                <c:pt idx="729">
                  <c:v>0.24299999999999999</c:v>
                </c:pt>
                <c:pt idx="730">
                  <c:v>0.25629999999999997</c:v>
                </c:pt>
                <c:pt idx="731">
                  <c:v>0.23910000000000001</c:v>
                </c:pt>
                <c:pt idx="732">
                  <c:v>0.22470000000000001</c:v>
                </c:pt>
                <c:pt idx="733">
                  <c:v>0.2379</c:v>
                </c:pt>
                <c:pt idx="734">
                  <c:v>0.2384</c:v>
                </c:pt>
                <c:pt idx="735">
                  <c:v>0.2198</c:v>
                </c:pt>
                <c:pt idx="736">
                  <c:v>0.21870000000000001</c:v>
                </c:pt>
                <c:pt idx="737">
                  <c:v>0.2331</c:v>
                </c:pt>
                <c:pt idx="738">
                  <c:v>0.2268</c:v>
                </c:pt>
                <c:pt idx="739">
                  <c:v>0.21310000000000001</c:v>
                </c:pt>
                <c:pt idx="740">
                  <c:v>0.2218</c:v>
                </c:pt>
                <c:pt idx="741">
                  <c:v>0.23300000000000001</c:v>
                </c:pt>
                <c:pt idx="742">
                  <c:v>0.2253</c:v>
                </c:pt>
                <c:pt idx="743">
                  <c:v>0.21759999999999999</c:v>
                </c:pt>
                <c:pt idx="744">
                  <c:v>0.23280000000000001</c:v>
                </c:pt>
                <c:pt idx="745">
                  <c:v>0.2417</c:v>
                </c:pt>
                <c:pt idx="746">
                  <c:v>0.23499999999999999</c:v>
                </c:pt>
                <c:pt idx="747">
                  <c:v>0.23780000000000001</c:v>
                </c:pt>
                <c:pt idx="748">
                  <c:v>0.2477</c:v>
                </c:pt>
                <c:pt idx="749">
                  <c:v>0.25380000000000003</c:v>
                </c:pt>
                <c:pt idx="750">
                  <c:v>0.23150000000000001</c:v>
                </c:pt>
                <c:pt idx="751">
                  <c:v>0.22650000000000001</c:v>
                </c:pt>
                <c:pt idx="752">
                  <c:v>0.2329</c:v>
                </c:pt>
                <c:pt idx="753">
                  <c:v>0.2485</c:v>
                </c:pt>
                <c:pt idx="754">
                  <c:v>0.26040000000000002</c:v>
                </c:pt>
                <c:pt idx="755">
                  <c:v>0.25740000000000002</c:v>
                </c:pt>
                <c:pt idx="756">
                  <c:v>0.25480000000000003</c:v>
                </c:pt>
                <c:pt idx="757">
                  <c:v>0.2462</c:v>
                </c:pt>
                <c:pt idx="758">
                  <c:v>0.24110000000000001</c:v>
                </c:pt>
                <c:pt idx="759">
                  <c:v>0.25159999999999999</c:v>
                </c:pt>
                <c:pt idx="760">
                  <c:v>0.25819999999999999</c:v>
                </c:pt>
                <c:pt idx="761">
                  <c:v>0.24640000000000001</c:v>
                </c:pt>
                <c:pt idx="762">
                  <c:v>0.2455</c:v>
                </c:pt>
                <c:pt idx="763">
                  <c:v>0.26229999999999998</c:v>
                </c:pt>
                <c:pt idx="764">
                  <c:v>0.26119999999999999</c:v>
                </c:pt>
                <c:pt idx="765">
                  <c:v>0.24729999999999999</c:v>
                </c:pt>
                <c:pt idx="766">
                  <c:v>0.25819999999999999</c:v>
                </c:pt>
                <c:pt idx="767">
                  <c:v>0.2722</c:v>
                </c:pt>
                <c:pt idx="768">
                  <c:v>0.26100000000000001</c:v>
                </c:pt>
                <c:pt idx="769">
                  <c:v>0.25430000000000003</c:v>
                </c:pt>
                <c:pt idx="770">
                  <c:v>0.27489999999999998</c:v>
                </c:pt>
                <c:pt idx="771">
                  <c:v>0.28339999999999999</c:v>
                </c:pt>
                <c:pt idx="772">
                  <c:v>0.26740000000000003</c:v>
                </c:pt>
                <c:pt idx="773">
                  <c:v>0.25559999999999999</c:v>
                </c:pt>
                <c:pt idx="774">
                  <c:v>0.25040000000000001</c:v>
                </c:pt>
                <c:pt idx="775">
                  <c:v>0.2412</c:v>
                </c:pt>
                <c:pt idx="776">
                  <c:v>0.2266</c:v>
                </c:pt>
                <c:pt idx="777">
                  <c:v>0.22489999999999999</c:v>
                </c:pt>
                <c:pt idx="778">
                  <c:v>0.21279999999999999</c:v>
                </c:pt>
                <c:pt idx="779">
                  <c:v>0.20960000000000001</c:v>
                </c:pt>
                <c:pt idx="780">
                  <c:v>0.19839999999999999</c:v>
                </c:pt>
                <c:pt idx="781">
                  <c:v>0.20630000000000001</c:v>
                </c:pt>
                <c:pt idx="782">
                  <c:v>0.2001</c:v>
                </c:pt>
                <c:pt idx="783">
                  <c:v>0.2092</c:v>
                </c:pt>
                <c:pt idx="784">
                  <c:v>0.22109999999999999</c:v>
                </c:pt>
                <c:pt idx="785">
                  <c:v>0.2198</c:v>
                </c:pt>
                <c:pt idx="786">
                  <c:v>0.21929999999999999</c:v>
                </c:pt>
                <c:pt idx="787">
                  <c:v>0.23180000000000001</c:v>
                </c:pt>
                <c:pt idx="788">
                  <c:v>0.2417</c:v>
                </c:pt>
                <c:pt idx="789">
                  <c:v>0.23680000000000001</c:v>
                </c:pt>
                <c:pt idx="790">
                  <c:v>0.2394</c:v>
                </c:pt>
                <c:pt idx="791">
                  <c:v>0.25790000000000002</c:v>
                </c:pt>
                <c:pt idx="792">
                  <c:v>0.2601</c:v>
                </c:pt>
                <c:pt idx="793">
                  <c:v>0.25659999999999999</c:v>
                </c:pt>
                <c:pt idx="794">
                  <c:v>0.27089999999999997</c:v>
                </c:pt>
                <c:pt idx="795">
                  <c:v>0.28770000000000001</c:v>
                </c:pt>
                <c:pt idx="796">
                  <c:v>0.2828</c:v>
                </c:pt>
                <c:pt idx="797">
                  <c:v>0.2873</c:v>
                </c:pt>
                <c:pt idx="798">
                  <c:v>0.26819999999999999</c:v>
                </c:pt>
                <c:pt idx="799">
                  <c:v>0.27</c:v>
                </c:pt>
                <c:pt idx="800">
                  <c:v>0.25230000000000002</c:v>
                </c:pt>
                <c:pt idx="801">
                  <c:v>0.2452</c:v>
                </c:pt>
                <c:pt idx="802">
                  <c:v>0.22889999999999999</c:v>
                </c:pt>
                <c:pt idx="803">
                  <c:v>0.2208</c:v>
                </c:pt>
                <c:pt idx="804">
                  <c:v>0.22670000000000001</c:v>
                </c:pt>
                <c:pt idx="805">
                  <c:v>0.21429999999999999</c:v>
                </c:pt>
                <c:pt idx="806">
                  <c:v>0.2056</c:v>
                </c:pt>
                <c:pt idx="807">
                  <c:v>0.2109</c:v>
                </c:pt>
                <c:pt idx="808">
                  <c:v>0.2026</c:v>
                </c:pt>
                <c:pt idx="809">
                  <c:v>0.1958</c:v>
                </c:pt>
                <c:pt idx="810">
                  <c:v>0.18579999999999999</c:v>
                </c:pt>
                <c:pt idx="811">
                  <c:v>0.18770000000000001</c:v>
                </c:pt>
                <c:pt idx="812">
                  <c:v>0.18970000000000001</c:v>
                </c:pt>
                <c:pt idx="813">
                  <c:v>0.19009999999999999</c:v>
                </c:pt>
                <c:pt idx="814">
                  <c:v>0.20130000000000001</c:v>
                </c:pt>
                <c:pt idx="815">
                  <c:v>0.17979999999999999</c:v>
                </c:pt>
                <c:pt idx="816">
                  <c:v>0.1867</c:v>
                </c:pt>
                <c:pt idx="817">
                  <c:v>0.215</c:v>
                </c:pt>
                <c:pt idx="818">
                  <c:v>0.21010000000000001</c:v>
                </c:pt>
                <c:pt idx="819">
                  <c:v>0.19620000000000001</c:v>
                </c:pt>
                <c:pt idx="820">
                  <c:v>0.20449999999999999</c:v>
                </c:pt>
                <c:pt idx="821">
                  <c:v>0.21659999999999999</c:v>
                </c:pt>
                <c:pt idx="822">
                  <c:v>0.22090000000000001</c:v>
                </c:pt>
                <c:pt idx="823">
                  <c:v>0.2142</c:v>
                </c:pt>
                <c:pt idx="824">
                  <c:v>0.21079999999999999</c:v>
                </c:pt>
                <c:pt idx="825">
                  <c:v>0.23760000000000001</c:v>
                </c:pt>
                <c:pt idx="826">
                  <c:v>0.2576</c:v>
                </c:pt>
                <c:pt idx="827">
                  <c:v>0.31809999999999999</c:v>
                </c:pt>
                <c:pt idx="828">
                  <c:v>0.39079999999999998</c:v>
                </c:pt>
                <c:pt idx="829">
                  <c:v>0.40250000000000002</c:v>
                </c:pt>
                <c:pt idx="830">
                  <c:v>0.4088</c:v>
                </c:pt>
                <c:pt idx="831">
                  <c:v>0.49869999999999998</c:v>
                </c:pt>
                <c:pt idx="832">
                  <c:v>0.56010000000000004</c:v>
                </c:pt>
                <c:pt idx="833">
                  <c:v>0.56889999999999996</c:v>
                </c:pt>
                <c:pt idx="834">
                  <c:v>0.60509999999999997</c:v>
                </c:pt>
                <c:pt idx="835">
                  <c:v>0.53659999999999997</c:v>
                </c:pt>
                <c:pt idx="836">
                  <c:v>0.56169999999999998</c:v>
                </c:pt>
                <c:pt idx="837">
                  <c:v>0.49619999999999997</c:v>
                </c:pt>
                <c:pt idx="838">
                  <c:v>0.37009999999999998</c:v>
                </c:pt>
                <c:pt idx="839">
                  <c:v>0.28910000000000002</c:v>
                </c:pt>
                <c:pt idx="840">
                  <c:v>0.2336</c:v>
                </c:pt>
                <c:pt idx="841">
                  <c:v>0.23949999999999999</c:v>
                </c:pt>
                <c:pt idx="842">
                  <c:v>0.23730000000000001</c:v>
                </c:pt>
                <c:pt idx="843">
                  <c:v>0.2273</c:v>
                </c:pt>
                <c:pt idx="844">
                  <c:v>0.24410000000000001</c:v>
                </c:pt>
                <c:pt idx="845">
                  <c:v>0.2581</c:v>
                </c:pt>
                <c:pt idx="846">
                  <c:v>0.2485</c:v>
                </c:pt>
                <c:pt idx="847">
                  <c:v>0.2477</c:v>
                </c:pt>
                <c:pt idx="848">
                  <c:v>0.26910000000000001</c:v>
                </c:pt>
                <c:pt idx="849">
                  <c:v>0.28010000000000002</c:v>
                </c:pt>
                <c:pt idx="850">
                  <c:v>0.2697</c:v>
                </c:pt>
                <c:pt idx="851">
                  <c:v>0.25850000000000001</c:v>
                </c:pt>
                <c:pt idx="852">
                  <c:v>0.27150000000000002</c:v>
                </c:pt>
                <c:pt idx="853">
                  <c:v>0.2913</c:v>
                </c:pt>
                <c:pt idx="854">
                  <c:v>0.28079999999999999</c:v>
                </c:pt>
                <c:pt idx="855">
                  <c:v>0.27679999999999999</c:v>
                </c:pt>
                <c:pt idx="856">
                  <c:v>0.2959</c:v>
                </c:pt>
                <c:pt idx="857">
                  <c:v>0.31219999999999998</c:v>
                </c:pt>
                <c:pt idx="858">
                  <c:v>0.29349999999999998</c:v>
                </c:pt>
                <c:pt idx="859">
                  <c:v>0.28370000000000001</c:v>
                </c:pt>
                <c:pt idx="860">
                  <c:v>0.30270000000000002</c:v>
                </c:pt>
                <c:pt idx="861">
                  <c:v>0.31080000000000002</c:v>
                </c:pt>
                <c:pt idx="862">
                  <c:v>0.2949</c:v>
                </c:pt>
                <c:pt idx="863">
                  <c:v>0.29980000000000001</c:v>
                </c:pt>
                <c:pt idx="864">
                  <c:v>0.28960000000000002</c:v>
                </c:pt>
                <c:pt idx="865">
                  <c:v>0.27950000000000003</c:v>
                </c:pt>
                <c:pt idx="866">
                  <c:v>0.31569999999999998</c:v>
                </c:pt>
                <c:pt idx="867">
                  <c:v>0.3841</c:v>
                </c:pt>
                <c:pt idx="868">
                  <c:v>0.56879999999999997</c:v>
                </c:pt>
                <c:pt idx="869">
                  <c:v>0.71960000000000002</c:v>
                </c:pt>
                <c:pt idx="870">
                  <c:v>0.83420000000000005</c:v>
                </c:pt>
                <c:pt idx="871">
                  <c:v>1.0044999999999999</c:v>
                </c:pt>
                <c:pt idx="872">
                  <c:v>1.1208</c:v>
                </c:pt>
                <c:pt idx="873">
                  <c:v>1.274</c:v>
                </c:pt>
                <c:pt idx="874">
                  <c:v>1.3264</c:v>
                </c:pt>
                <c:pt idx="875">
                  <c:v>1.34</c:v>
                </c:pt>
                <c:pt idx="876">
                  <c:v>1.1520999999999999</c:v>
                </c:pt>
                <c:pt idx="877">
                  <c:v>1.1413</c:v>
                </c:pt>
                <c:pt idx="878">
                  <c:v>1.2450000000000001</c:v>
                </c:pt>
                <c:pt idx="879">
                  <c:v>1.1884999999999999</c:v>
                </c:pt>
                <c:pt idx="880">
                  <c:v>0.99109999999999998</c:v>
                </c:pt>
                <c:pt idx="881">
                  <c:v>0.7419</c:v>
                </c:pt>
                <c:pt idx="882">
                  <c:v>0.62309999999999999</c:v>
                </c:pt>
                <c:pt idx="883">
                  <c:v>0.52359999999999995</c:v>
                </c:pt>
                <c:pt idx="884">
                  <c:v>0.43790000000000001</c:v>
                </c:pt>
                <c:pt idx="885">
                  <c:v>0.41839999999999999</c:v>
                </c:pt>
                <c:pt idx="886">
                  <c:v>0.38290000000000002</c:v>
                </c:pt>
                <c:pt idx="887">
                  <c:v>0.33579999999999999</c:v>
                </c:pt>
                <c:pt idx="888">
                  <c:v>0.30630000000000002</c:v>
                </c:pt>
                <c:pt idx="889">
                  <c:v>0.28660000000000002</c:v>
                </c:pt>
                <c:pt idx="890">
                  <c:v>0.26690000000000003</c:v>
                </c:pt>
                <c:pt idx="891">
                  <c:v>0.25509999999999999</c:v>
                </c:pt>
                <c:pt idx="892">
                  <c:v>0.26179999999999998</c:v>
                </c:pt>
                <c:pt idx="893">
                  <c:v>0.26179999999999998</c:v>
                </c:pt>
                <c:pt idx="894">
                  <c:v>0.24399999999999999</c:v>
                </c:pt>
                <c:pt idx="895">
                  <c:v>0.23039999999999999</c:v>
                </c:pt>
                <c:pt idx="896">
                  <c:v>0.23019999999999999</c:v>
                </c:pt>
                <c:pt idx="897">
                  <c:v>0.19500000000000001</c:v>
                </c:pt>
                <c:pt idx="898">
                  <c:v>0.1832</c:v>
                </c:pt>
                <c:pt idx="899">
                  <c:v>0.1772</c:v>
                </c:pt>
                <c:pt idx="900">
                  <c:v>0.17349999999999999</c:v>
                </c:pt>
                <c:pt idx="901">
                  <c:v>0.17929999999999999</c:v>
                </c:pt>
                <c:pt idx="902">
                  <c:v>0.1968</c:v>
                </c:pt>
                <c:pt idx="903">
                  <c:v>0.2203</c:v>
                </c:pt>
                <c:pt idx="904">
                  <c:v>0.2233</c:v>
                </c:pt>
                <c:pt idx="905">
                  <c:v>0.20180000000000001</c:v>
                </c:pt>
                <c:pt idx="906">
                  <c:v>0.1772</c:v>
                </c:pt>
                <c:pt idx="907">
                  <c:v>0.16070000000000001</c:v>
                </c:pt>
                <c:pt idx="908">
                  <c:v>0.16170000000000001</c:v>
                </c:pt>
                <c:pt idx="909">
                  <c:v>0.15540000000000001</c:v>
                </c:pt>
                <c:pt idx="910">
                  <c:v>0.16139999999999999</c:v>
                </c:pt>
                <c:pt idx="911">
                  <c:v>0.16370000000000001</c:v>
                </c:pt>
                <c:pt idx="912">
                  <c:v>0.1618</c:v>
                </c:pt>
                <c:pt idx="913">
                  <c:v>0.1714</c:v>
                </c:pt>
                <c:pt idx="914">
                  <c:v>0.22439999999999999</c:v>
                </c:pt>
                <c:pt idx="915">
                  <c:v>0.22259999999999999</c:v>
                </c:pt>
                <c:pt idx="916">
                  <c:v>0.19900000000000001</c:v>
                </c:pt>
                <c:pt idx="917">
                  <c:v>0.18720000000000001</c:v>
                </c:pt>
                <c:pt idx="918">
                  <c:v>0.2031</c:v>
                </c:pt>
                <c:pt idx="919">
                  <c:v>0.2019</c:v>
                </c:pt>
                <c:pt idx="920">
                  <c:v>0.18340000000000001</c:v>
                </c:pt>
                <c:pt idx="921">
                  <c:v>0.1933</c:v>
                </c:pt>
                <c:pt idx="922">
                  <c:v>0.1915</c:v>
                </c:pt>
                <c:pt idx="923">
                  <c:v>0.17299999999999999</c:v>
                </c:pt>
                <c:pt idx="924">
                  <c:v>0.1583</c:v>
                </c:pt>
                <c:pt idx="925">
                  <c:v>0.16839999999999999</c:v>
                </c:pt>
                <c:pt idx="926">
                  <c:v>0.16869999999999999</c:v>
                </c:pt>
                <c:pt idx="927">
                  <c:v>0.15820000000000001</c:v>
                </c:pt>
                <c:pt idx="928">
                  <c:v>0.157</c:v>
                </c:pt>
                <c:pt idx="929">
                  <c:v>0.1595</c:v>
                </c:pt>
                <c:pt idx="930">
                  <c:v>0.1598</c:v>
                </c:pt>
                <c:pt idx="931">
                  <c:v>0.16589999999999999</c:v>
                </c:pt>
                <c:pt idx="932">
                  <c:v>0.16320000000000001</c:v>
                </c:pt>
                <c:pt idx="933">
                  <c:v>0.16700000000000001</c:v>
                </c:pt>
                <c:pt idx="934">
                  <c:v>0.1739</c:v>
                </c:pt>
                <c:pt idx="935">
                  <c:v>0.1862</c:v>
                </c:pt>
                <c:pt idx="936">
                  <c:v>0.17560000000000001</c:v>
                </c:pt>
                <c:pt idx="937">
                  <c:v>0.19969999999999999</c:v>
                </c:pt>
                <c:pt idx="938">
                  <c:v>0.20710000000000001</c:v>
                </c:pt>
                <c:pt idx="939">
                  <c:v>0.20649999999999999</c:v>
                </c:pt>
                <c:pt idx="940">
                  <c:v>0.2014</c:v>
                </c:pt>
                <c:pt idx="941">
                  <c:v>0.18429999999999999</c:v>
                </c:pt>
                <c:pt idx="942">
                  <c:v>0.17169999999999999</c:v>
                </c:pt>
                <c:pt idx="943">
                  <c:v>0.16569999999999999</c:v>
                </c:pt>
                <c:pt idx="944">
                  <c:v>0.16800000000000001</c:v>
                </c:pt>
                <c:pt idx="945">
                  <c:v>0.1623</c:v>
                </c:pt>
                <c:pt idx="946">
                  <c:v>0.15490000000000001</c:v>
                </c:pt>
                <c:pt idx="947">
                  <c:v>0.1646</c:v>
                </c:pt>
                <c:pt idx="948">
                  <c:v>0.1704</c:v>
                </c:pt>
                <c:pt idx="949">
                  <c:v>0.15920000000000001</c:v>
                </c:pt>
                <c:pt idx="950">
                  <c:v>0.1583</c:v>
                </c:pt>
                <c:pt idx="951">
                  <c:v>0.1739</c:v>
                </c:pt>
                <c:pt idx="952">
                  <c:v>0.16880000000000001</c:v>
                </c:pt>
                <c:pt idx="953">
                  <c:v>0.15920000000000001</c:v>
                </c:pt>
                <c:pt idx="954">
                  <c:v>0.19020000000000001</c:v>
                </c:pt>
                <c:pt idx="955">
                  <c:v>0.21210000000000001</c:v>
                </c:pt>
                <c:pt idx="956">
                  <c:v>0.2571</c:v>
                </c:pt>
                <c:pt idx="957">
                  <c:v>0.2833</c:v>
                </c:pt>
                <c:pt idx="958">
                  <c:v>0.29759999999999998</c:v>
                </c:pt>
                <c:pt idx="959">
                  <c:v>0.50839999999999996</c:v>
                </c:pt>
                <c:pt idx="960">
                  <c:v>0.52759999999999996</c:v>
                </c:pt>
                <c:pt idx="961">
                  <c:v>0.50160000000000005</c:v>
                </c:pt>
                <c:pt idx="962">
                  <c:v>0.37240000000000001</c:v>
                </c:pt>
                <c:pt idx="963">
                  <c:v>0.40889999999999999</c:v>
                </c:pt>
                <c:pt idx="964">
                  <c:v>0.50719999999999998</c:v>
                </c:pt>
                <c:pt idx="965">
                  <c:v>0.49519999999999997</c:v>
                </c:pt>
                <c:pt idx="966">
                  <c:v>0.46329999999999999</c:v>
                </c:pt>
                <c:pt idx="967">
                  <c:v>0.39610000000000001</c:v>
                </c:pt>
                <c:pt idx="968">
                  <c:v>0.41139999999999999</c:v>
                </c:pt>
                <c:pt idx="969">
                  <c:v>0.35410000000000003</c:v>
                </c:pt>
                <c:pt idx="970">
                  <c:v>0.28289999999999998</c:v>
                </c:pt>
                <c:pt idx="971">
                  <c:v>0.27010000000000001</c:v>
                </c:pt>
                <c:pt idx="972">
                  <c:v>0.28399999999999997</c:v>
                </c:pt>
                <c:pt idx="973">
                  <c:v>0.28039999999999998</c:v>
                </c:pt>
                <c:pt idx="974">
                  <c:v>0.34949999999999998</c:v>
                </c:pt>
                <c:pt idx="975">
                  <c:v>0.41199999999999998</c:v>
                </c:pt>
                <c:pt idx="976">
                  <c:v>0.36470000000000002</c:v>
                </c:pt>
                <c:pt idx="977">
                  <c:v>0.42099999999999999</c:v>
                </c:pt>
                <c:pt idx="978">
                  <c:v>0.33289999999999997</c:v>
                </c:pt>
                <c:pt idx="979">
                  <c:v>0.36859999999999998</c:v>
                </c:pt>
                <c:pt idx="980">
                  <c:v>0.51970000000000005</c:v>
                </c:pt>
                <c:pt idx="981">
                  <c:v>0.50460000000000005</c:v>
                </c:pt>
                <c:pt idx="982">
                  <c:v>0.434</c:v>
                </c:pt>
                <c:pt idx="983">
                  <c:v>0.6159</c:v>
                </c:pt>
                <c:pt idx="984">
                  <c:v>0.71640000000000004</c:v>
                </c:pt>
                <c:pt idx="985">
                  <c:v>0.64500000000000002</c:v>
                </c:pt>
                <c:pt idx="986">
                  <c:v>0.72119999999999995</c:v>
                </c:pt>
                <c:pt idx="987">
                  <c:v>0.88029999999999997</c:v>
                </c:pt>
                <c:pt idx="988">
                  <c:v>0.89580000000000004</c:v>
                </c:pt>
                <c:pt idx="989">
                  <c:v>0.88529999999999998</c:v>
                </c:pt>
                <c:pt idx="990">
                  <c:v>1.0685</c:v>
                </c:pt>
                <c:pt idx="991">
                  <c:v>1.1977</c:v>
                </c:pt>
                <c:pt idx="992">
                  <c:v>1.2579</c:v>
                </c:pt>
                <c:pt idx="993">
                  <c:v>1.3399000000000001</c:v>
                </c:pt>
                <c:pt idx="994">
                  <c:v>1.4301999999999999</c:v>
                </c:pt>
                <c:pt idx="995">
                  <c:v>1.5169999999999999</c:v>
                </c:pt>
                <c:pt idx="996">
                  <c:v>1.5653999999999999</c:v>
                </c:pt>
                <c:pt idx="997">
                  <c:v>1.72</c:v>
                </c:pt>
                <c:pt idx="998">
                  <c:v>1.7864</c:v>
                </c:pt>
                <c:pt idx="999">
                  <c:v>1.8769</c:v>
                </c:pt>
                <c:pt idx="1000">
                  <c:v>1.9910000000000001</c:v>
                </c:pt>
                <c:pt idx="1001">
                  <c:v>2.0859000000000001</c:v>
                </c:pt>
                <c:pt idx="1002">
                  <c:v>2.1959</c:v>
                </c:pt>
                <c:pt idx="1003">
                  <c:v>2.2288000000000001</c:v>
                </c:pt>
                <c:pt idx="1004">
                  <c:v>2.3445</c:v>
                </c:pt>
                <c:pt idx="1005">
                  <c:v>2.3934000000000002</c:v>
                </c:pt>
                <c:pt idx="1006">
                  <c:v>2.4948999999999999</c:v>
                </c:pt>
                <c:pt idx="1007">
                  <c:v>2.6457999999999999</c:v>
                </c:pt>
                <c:pt idx="1008">
                  <c:v>2.7570999999999999</c:v>
                </c:pt>
                <c:pt idx="1009">
                  <c:v>2.8281999999999998</c:v>
                </c:pt>
                <c:pt idx="1010">
                  <c:v>2.8885999999999998</c:v>
                </c:pt>
                <c:pt idx="1011">
                  <c:v>3.0177999999999998</c:v>
                </c:pt>
                <c:pt idx="1012">
                  <c:v>3.08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B0A-42E6-B07E-7FDA21594A85}"/>
            </c:ext>
          </c:extLst>
        </c:ser>
        <c:ser>
          <c:idx val="3"/>
          <c:order val="3"/>
          <c:tx>
            <c:strRef>
              <c:f>Sheet3!$E$3</c:f>
              <c:strCache>
                <c:ptCount val="1"/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val>
            <c:numRef>
              <c:f>Sheet3!$E$4:$E$1016</c:f>
              <c:numCache>
                <c:formatCode>General</c:formatCode>
                <c:ptCount val="101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B0A-42E6-B07E-7FDA21594A85}"/>
            </c:ext>
          </c:extLst>
        </c:ser>
        <c:ser>
          <c:idx val="4"/>
          <c:order val="4"/>
          <c:tx>
            <c:strRef>
              <c:f>Sheet3!$F$3</c:f>
              <c:strCache>
                <c:ptCount val="1"/>
                <c:pt idx="0">
                  <c:v>Series4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val>
            <c:numRef>
              <c:f>Sheet3!$F$4:$F$1016</c:f>
              <c:numCache>
                <c:formatCode>General</c:formatCode>
                <c:ptCount val="1013"/>
                <c:pt idx="0">
                  <c:v>2.7094999999999998</c:v>
                </c:pt>
                <c:pt idx="1">
                  <c:v>2.6253000000000002</c:v>
                </c:pt>
                <c:pt idx="2">
                  <c:v>2.5167000000000002</c:v>
                </c:pt>
                <c:pt idx="3">
                  <c:v>2.3502000000000001</c:v>
                </c:pt>
                <c:pt idx="4">
                  <c:v>2.1440999999999999</c:v>
                </c:pt>
                <c:pt idx="5">
                  <c:v>2.0484</c:v>
                </c:pt>
                <c:pt idx="6">
                  <c:v>1.8919999999999999</c:v>
                </c:pt>
                <c:pt idx="7">
                  <c:v>1.6988000000000001</c:v>
                </c:pt>
                <c:pt idx="8">
                  <c:v>1.45</c:v>
                </c:pt>
                <c:pt idx="9">
                  <c:v>1.2377</c:v>
                </c:pt>
                <c:pt idx="10">
                  <c:v>1.0133000000000001</c:v>
                </c:pt>
                <c:pt idx="11">
                  <c:v>0.78939999999999999</c:v>
                </c:pt>
                <c:pt idx="12">
                  <c:v>0.56299999999999994</c:v>
                </c:pt>
                <c:pt idx="13">
                  <c:v>0.4007</c:v>
                </c:pt>
                <c:pt idx="14">
                  <c:v>0.30530000000000002</c:v>
                </c:pt>
                <c:pt idx="15">
                  <c:v>0.28789999999999999</c:v>
                </c:pt>
                <c:pt idx="16">
                  <c:v>0.27310000000000001</c:v>
                </c:pt>
                <c:pt idx="17">
                  <c:v>0.26829999999999998</c:v>
                </c:pt>
                <c:pt idx="18">
                  <c:v>0.23400000000000001</c:v>
                </c:pt>
                <c:pt idx="19">
                  <c:v>0.2319</c:v>
                </c:pt>
                <c:pt idx="20">
                  <c:v>0.253</c:v>
                </c:pt>
                <c:pt idx="21">
                  <c:v>0.2379</c:v>
                </c:pt>
                <c:pt idx="22">
                  <c:v>0.2137</c:v>
                </c:pt>
                <c:pt idx="23">
                  <c:v>0.23130000000000001</c:v>
                </c:pt>
                <c:pt idx="24">
                  <c:v>0.24229999999999999</c:v>
                </c:pt>
                <c:pt idx="25">
                  <c:v>0.21740000000000001</c:v>
                </c:pt>
                <c:pt idx="26">
                  <c:v>0.21490000000000001</c:v>
                </c:pt>
                <c:pt idx="27">
                  <c:v>0.24260000000000001</c:v>
                </c:pt>
                <c:pt idx="28">
                  <c:v>0.25530000000000003</c:v>
                </c:pt>
                <c:pt idx="29">
                  <c:v>0.23180000000000001</c:v>
                </c:pt>
                <c:pt idx="30">
                  <c:v>0.216</c:v>
                </c:pt>
                <c:pt idx="31">
                  <c:v>0.23710000000000001</c:v>
                </c:pt>
                <c:pt idx="32">
                  <c:v>0.2258</c:v>
                </c:pt>
                <c:pt idx="33">
                  <c:v>0.24260000000000001</c:v>
                </c:pt>
                <c:pt idx="34">
                  <c:v>0.25480000000000003</c:v>
                </c:pt>
                <c:pt idx="35">
                  <c:v>0.2455</c:v>
                </c:pt>
                <c:pt idx="36">
                  <c:v>0.21809999999999999</c:v>
                </c:pt>
                <c:pt idx="37">
                  <c:v>0.22059999999999999</c:v>
                </c:pt>
                <c:pt idx="38">
                  <c:v>0.2306</c:v>
                </c:pt>
                <c:pt idx="39">
                  <c:v>0.21249999999999999</c:v>
                </c:pt>
                <c:pt idx="40">
                  <c:v>0.19670000000000001</c:v>
                </c:pt>
                <c:pt idx="41">
                  <c:v>0.2112</c:v>
                </c:pt>
                <c:pt idx="42">
                  <c:v>0.21590000000000001</c:v>
                </c:pt>
                <c:pt idx="43">
                  <c:v>0.1981</c:v>
                </c:pt>
                <c:pt idx="44">
                  <c:v>0.19769999999999999</c:v>
                </c:pt>
                <c:pt idx="45">
                  <c:v>0.2177</c:v>
                </c:pt>
                <c:pt idx="46">
                  <c:v>0.21690000000000001</c:v>
                </c:pt>
                <c:pt idx="47">
                  <c:v>0.1988</c:v>
                </c:pt>
                <c:pt idx="48">
                  <c:v>0.22070000000000001</c:v>
                </c:pt>
                <c:pt idx="49">
                  <c:v>0.23350000000000001</c:v>
                </c:pt>
                <c:pt idx="50">
                  <c:v>0.20780000000000001</c:v>
                </c:pt>
                <c:pt idx="51">
                  <c:v>0.19819999999999999</c:v>
                </c:pt>
                <c:pt idx="52">
                  <c:v>0.2177</c:v>
                </c:pt>
                <c:pt idx="53">
                  <c:v>0.219</c:v>
                </c:pt>
                <c:pt idx="54">
                  <c:v>0.1976</c:v>
                </c:pt>
                <c:pt idx="55">
                  <c:v>0.1993</c:v>
                </c:pt>
                <c:pt idx="56">
                  <c:v>0.21659999999999999</c:v>
                </c:pt>
                <c:pt idx="57">
                  <c:v>0.2031</c:v>
                </c:pt>
                <c:pt idx="58">
                  <c:v>0.19020000000000001</c:v>
                </c:pt>
                <c:pt idx="59">
                  <c:v>0.20860000000000001</c:v>
                </c:pt>
                <c:pt idx="60">
                  <c:v>0.24690000000000001</c:v>
                </c:pt>
                <c:pt idx="61">
                  <c:v>0.36220000000000002</c:v>
                </c:pt>
                <c:pt idx="62">
                  <c:v>0.27150000000000002</c:v>
                </c:pt>
                <c:pt idx="63">
                  <c:v>0.2581</c:v>
                </c:pt>
                <c:pt idx="64">
                  <c:v>0.23</c:v>
                </c:pt>
                <c:pt idx="65">
                  <c:v>0.19620000000000001</c:v>
                </c:pt>
                <c:pt idx="66">
                  <c:v>0.192</c:v>
                </c:pt>
                <c:pt idx="67">
                  <c:v>0.19370000000000001</c:v>
                </c:pt>
                <c:pt idx="68">
                  <c:v>0.1767</c:v>
                </c:pt>
                <c:pt idx="69">
                  <c:v>0.16500000000000001</c:v>
                </c:pt>
                <c:pt idx="70">
                  <c:v>0.1696</c:v>
                </c:pt>
                <c:pt idx="71">
                  <c:v>0.17180000000000001</c:v>
                </c:pt>
                <c:pt idx="72">
                  <c:v>0.15720000000000001</c:v>
                </c:pt>
                <c:pt idx="73">
                  <c:v>0.15329999999999999</c:v>
                </c:pt>
                <c:pt idx="74">
                  <c:v>0.1641</c:v>
                </c:pt>
                <c:pt idx="75">
                  <c:v>0.1641</c:v>
                </c:pt>
                <c:pt idx="76">
                  <c:v>0.15310000000000001</c:v>
                </c:pt>
                <c:pt idx="77">
                  <c:v>0.1583</c:v>
                </c:pt>
                <c:pt idx="78">
                  <c:v>0.1701</c:v>
                </c:pt>
                <c:pt idx="79">
                  <c:v>0.16619999999999999</c:v>
                </c:pt>
                <c:pt idx="80">
                  <c:v>0.16209999999999999</c:v>
                </c:pt>
                <c:pt idx="81">
                  <c:v>0.17749999999999999</c:v>
                </c:pt>
                <c:pt idx="82">
                  <c:v>0.1983</c:v>
                </c:pt>
                <c:pt idx="83">
                  <c:v>0.2422</c:v>
                </c:pt>
                <c:pt idx="84">
                  <c:v>0.30620000000000003</c:v>
                </c:pt>
                <c:pt idx="85">
                  <c:v>0.36759999999999998</c:v>
                </c:pt>
                <c:pt idx="86">
                  <c:v>0.44590000000000002</c:v>
                </c:pt>
                <c:pt idx="87">
                  <c:v>0.55300000000000005</c:v>
                </c:pt>
                <c:pt idx="88">
                  <c:v>0.67030000000000001</c:v>
                </c:pt>
                <c:pt idx="89">
                  <c:v>0.77700000000000002</c:v>
                </c:pt>
                <c:pt idx="90">
                  <c:v>0.82620000000000005</c:v>
                </c:pt>
                <c:pt idx="91">
                  <c:v>0.75260000000000005</c:v>
                </c:pt>
                <c:pt idx="92">
                  <c:v>0.83550000000000002</c:v>
                </c:pt>
                <c:pt idx="93">
                  <c:v>0.76100000000000001</c:v>
                </c:pt>
                <c:pt idx="94">
                  <c:v>0.66039999999999999</c:v>
                </c:pt>
                <c:pt idx="95">
                  <c:v>0.56440000000000001</c:v>
                </c:pt>
                <c:pt idx="96">
                  <c:v>0.38769999999999999</c:v>
                </c:pt>
                <c:pt idx="97">
                  <c:v>0.2356</c:v>
                </c:pt>
                <c:pt idx="98">
                  <c:v>0.18859999999999999</c:v>
                </c:pt>
                <c:pt idx="99">
                  <c:v>0.1731</c:v>
                </c:pt>
                <c:pt idx="100">
                  <c:v>0.15790000000000001</c:v>
                </c:pt>
                <c:pt idx="101">
                  <c:v>0.15790000000000001</c:v>
                </c:pt>
                <c:pt idx="102">
                  <c:v>0.1663</c:v>
                </c:pt>
                <c:pt idx="103">
                  <c:v>0.16200000000000001</c:v>
                </c:pt>
                <c:pt idx="104">
                  <c:v>0.16039999999999999</c:v>
                </c:pt>
                <c:pt idx="105">
                  <c:v>0.17380000000000001</c:v>
                </c:pt>
                <c:pt idx="106">
                  <c:v>0.18629999999999999</c:v>
                </c:pt>
                <c:pt idx="107">
                  <c:v>0.18340000000000001</c:v>
                </c:pt>
                <c:pt idx="108">
                  <c:v>0.188</c:v>
                </c:pt>
                <c:pt idx="109">
                  <c:v>0.1694</c:v>
                </c:pt>
                <c:pt idx="110">
                  <c:v>0.16009999999999999</c:v>
                </c:pt>
                <c:pt idx="111">
                  <c:v>0.1467</c:v>
                </c:pt>
                <c:pt idx="112">
                  <c:v>0.14910000000000001</c:v>
                </c:pt>
                <c:pt idx="113">
                  <c:v>0.1605</c:v>
                </c:pt>
                <c:pt idx="114">
                  <c:v>0.1502</c:v>
                </c:pt>
                <c:pt idx="115">
                  <c:v>0.14510000000000001</c:v>
                </c:pt>
                <c:pt idx="116">
                  <c:v>0.15690000000000001</c:v>
                </c:pt>
                <c:pt idx="117">
                  <c:v>0.16070000000000001</c:v>
                </c:pt>
                <c:pt idx="118">
                  <c:v>0.15840000000000001</c:v>
                </c:pt>
                <c:pt idx="119">
                  <c:v>0.17100000000000001</c:v>
                </c:pt>
                <c:pt idx="120">
                  <c:v>0.17080000000000001</c:v>
                </c:pt>
                <c:pt idx="121">
                  <c:v>0.16089999999999999</c:v>
                </c:pt>
                <c:pt idx="122">
                  <c:v>0.1673</c:v>
                </c:pt>
                <c:pt idx="123">
                  <c:v>0.1757</c:v>
                </c:pt>
                <c:pt idx="124">
                  <c:v>0.1719</c:v>
                </c:pt>
                <c:pt idx="125">
                  <c:v>0.1764</c:v>
                </c:pt>
                <c:pt idx="126">
                  <c:v>0.18529999999999999</c:v>
                </c:pt>
                <c:pt idx="127">
                  <c:v>0.2034</c:v>
                </c:pt>
                <c:pt idx="128">
                  <c:v>0.2006</c:v>
                </c:pt>
                <c:pt idx="129">
                  <c:v>0.18740000000000001</c:v>
                </c:pt>
                <c:pt idx="130">
                  <c:v>0.20569999999999999</c:v>
                </c:pt>
                <c:pt idx="131">
                  <c:v>0.22420000000000001</c:v>
                </c:pt>
                <c:pt idx="132">
                  <c:v>0.21609999999999999</c:v>
                </c:pt>
                <c:pt idx="133">
                  <c:v>0.20530000000000001</c:v>
                </c:pt>
                <c:pt idx="134">
                  <c:v>0.2205</c:v>
                </c:pt>
                <c:pt idx="135">
                  <c:v>0.2346</c:v>
                </c:pt>
                <c:pt idx="136">
                  <c:v>0.21340000000000001</c:v>
                </c:pt>
                <c:pt idx="137">
                  <c:v>0.18909999999999999</c:v>
                </c:pt>
                <c:pt idx="138">
                  <c:v>0.1976</c:v>
                </c:pt>
                <c:pt idx="139">
                  <c:v>0.20269999999999999</c:v>
                </c:pt>
                <c:pt idx="140">
                  <c:v>0.1855</c:v>
                </c:pt>
                <c:pt idx="141">
                  <c:v>0.17469999999999999</c:v>
                </c:pt>
                <c:pt idx="142">
                  <c:v>0.18709999999999999</c:v>
                </c:pt>
                <c:pt idx="143">
                  <c:v>0.1431</c:v>
                </c:pt>
                <c:pt idx="144">
                  <c:v>0.1376</c:v>
                </c:pt>
                <c:pt idx="145">
                  <c:v>0.1229</c:v>
                </c:pt>
                <c:pt idx="146">
                  <c:v>0.1192</c:v>
                </c:pt>
                <c:pt idx="147">
                  <c:v>0.127</c:v>
                </c:pt>
                <c:pt idx="148">
                  <c:v>0.1153</c:v>
                </c:pt>
                <c:pt idx="149">
                  <c:v>0.1043</c:v>
                </c:pt>
                <c:pt idx="150">
                  <c:v>0.12089999999999999</c:v>
                </c:pt>
                <c:pt idx="151">
                  <c:v>0.12230000000000001</c:v>
                </c:pt>
                <c:pt idx="152">
                  <c:v>0.107</c:v>
                </c:pt>
                <c:pt idx="153">
                  <c:v>0.10780000000000001</c:v>
                </c:pt>
                <c:pt idx="154">
                  <c:v>0.12529999999999999</c:v>
                </c:pt>
                <c:pt idx="155">
                  <c:v>0.1196</c:v>
                </c:pt>
                <c:pt idx="156">
                  <c:v>0.10580000000000001</c:v>
                </c:pt>
                <c:pt idx="157">
                  <c:v>0.1171</c:v>
                </c:pt>
                <c:pt idx="158">
                  <c:v>0.12920000000000001</c:v>
                </c:pt>
                <c:pt idx="159">
                  <c:v>0.1196</c:v>
                </c:pt>
                <c:pt idx="160">
                  <c:v>0.1179</c:v>
                </c:pt>
                <c:pt idx="161">
                  <c:v>0.13800000000000001</c:v>
                </c:pt>
                <c:pt idx="162">
                  <c:v>0.14560000000000001</c:v>
                </c:pt>
                <c:pt idx="163">
                  <c:v>0.13669999999999999</c:v>
                </c:pt>
                <c:pt idx="164">
                  <c:v>0.1444</c:v>
                </c:pt>
                <c:pt idx="165">
                  <c:v>0.1658</c:v>
                </c:pt>
                <c:pt idx="166">
                  <c:v>0.1691</c:v>
                </c:pt>
                <c:pt idx="167">
                  <c:v>0.16170000000000001</c:v>
                </c:pt>
                <c:pt idx="168">
                  <c:v>0.17030000000000001</c:v>
                </c:pt>
                <c:pt idx="169">
                  <c:v>0.19270000000000001</c:v>
                </c:pt>
                <c:pt idx="170">
                  <c:v>0.21099999999999999</c:v>
                </c:pt>
                <c:pt idx="171">
                  <c:v>0.2666</c:v>
                </c:pt>
                <c:pt idx="172">
                  <c:v>0.3372</c:v>
                </c:pt>
                <c:pt idx="173">
                  <c:v>0.39550000000000002</c:v>
                </c:pt>
                <c:pt idx="174">
                  <c:v>0.39279999999999998</c:v>
                </c:pt>
                <c:pt idx="175">
                  <c:v>0.44650000000000001</c:v>
                </c:pt>
                <c:pt idx="176">
                  <c:v>0.55369999999999997</c:v>
                </c:pt>
                <c:pt idx="177">
                  <c:v>0.54600000000000004</c:v>
                </c:pt>
                <c:pt idx="178">
                  <c:v>0.51649999999999996</c:v>
                </c:pt>
                <c:pt idx="179">
                  <c:v>0.36370000000000002</c:v>
                </c:pt>
                <c:pt idx="180">
                  <c:v>0.31469999999999998</c:v>
                </c:pt>
                <c:pt idx="181">
                  <c:v>0.25380000000000003</c:v>
                </c:pt>
                <c:pt idx="182">
                  <c:v>0.23619999999999999</c:v>
                </c:pt>
                <c:pt idx="183">
                  <c:v>0.23119999999999999</c:v>
                </c:pt>
                <c:pt idx="184">
                  <c:v>0.21729999999999999</c:v>
                </c:pt>
                <c:pt idx="185">
                  <c:v>0.20019999999999999</c:v>
                </c:pt>
                <c:pt idx="186">
                  <c:v>0.18559999999999999</c:v>
                </c:pt>
                <c:pt idx="187">
                  <c:v>0.18029999999999999</c:v>
                </c:pt>
                <c:pt idx="188">
                  <c:v>0.17150000000000001</c:v>
                </c:pt>
                <c:pt idx="189">
                  <c:v>0.15540000000000001</c:v>
                </c:pt>
                <c:pt idx="190">
                  <c:v>0.14580000000000001</c:v>
                </c:pt>
                <c:pt idx="191">
                  <c:v>0.1421</c:v>
                </c:pt>
                <c:pt idx="192">
                  <c:v>0.13689999999999999</c:v>
                </c:pt>
                <c:pt idx="193">
                  <c:v>0.124</c:v>
                </c:pt>
                <c:pt idx="194">
                  <c:v>0.11609999999999999</c:v>
                </c:pt>
                <c:pt idx="195">
                  <c:v>0.1166</c:v>
                </c:pt>
                <c:pt idx="196">
                  <c:v>0.1134</c:v>
                </c:pt>
                <c:pt idx="197">
                  <c:v>0.1036</c:v>
                </c:pt>
                <c:pt idx="198">
                  <c:v>0.1014</c:v>
                </c:pt>
                <c:pt idx="199">
                  <c:v>0.1072</c:v>
                </c:pt>
                <c:pt idx="200">
                  <c:v>0.1085</c:v>
                </c:pt>
                <c:pt idx="201">
                  <c:v>0.10440000000000001</c:v>
                </c:pt>
                <c:pt idx="202">
                  <c:v>0.1128</c:v>
                </c:pt>
                <c:pt idx="203">
                  <c:v>0.128</c:v>
                </c:pt>
                <c:pt idx="204">
                  <c:v>0.12920000000000001</c:v>
                </c:pt>
                <c:pt idx="205">
                  <c:v>0.10920000000000001</c:v>
                </c:pt>
                <c:pt idx="206">
                  <c:v>0.1132</c:v>
                </c:pt>
                <c:pt idx="207">
                  <c:v>0.1246</c:v>
                </c:pt>
                <c:pt idx="208">
                  <c:v>0.1178</c:v>
                </c:pt>
                <c:pt idx="209">
                  <c:v>0.1128</c:v>
                </c:pt>
                <c:pt idx="210">
                  <c:v>0.1043</c:v>
                </c:pt>
                <c:pt idx="211">
                  <c:v>9.8799999999999999E-2</c:v>
                </c:pt>
                <c:pt idx="212">
                  <c:v>9.69E-2</c:v>
                </c:pt>
                <c:pt idx="213">
                  <c:v>9.64E-2</c:v>
                </c:pt>
                <c:pt idx="214">
                  <c:v>9.2700000000000005E-2</c:v>
                </c:pt>
                <c:pt idx="215">
                  <c:v>9.8500000000000004E-2</c:v>
                </c:pt>
                <c:pt idx="216">
                  <c:v>0.1042</c:v>
                </c:pt>
                <c:pt idx="217">
                  <c:v>9.8400000000000001E-2</c:v>
                </c:pt>
                <c:pt idx="218">
                  <c:v>0.1021</c:v>
                </c:pt>
                <c:pt idx="219">
                  <c:v>0.111</c:v>
                </c:pt>
                <c:pt idx="220">
                  <c:v>0.1118</c:v>
                </c:pt>
                <c:pt idx="221">
                  <c:v>0.1139</c:v>
                </c:pt>
                <c:pt idx="222">
                  <c:v>0.1244</c:v>
                </c:pt>
                <c:pt idx="223">
                  <c:v>0.13109999999999999</c:v>
                </c:pt>
                <c:pt idx="224">
                  <c:v>0.13589999999999999</c:v>
                </c:pt>
                <c:pt idx="225">
                  <c:v>0.1452</c:v>
                </c:pt>
                <c:pt idx="226">
                  <c:v>0.15429999999999999</c:v>
                </c:pt>
                <c:pt idx="227">
                  <c:v>0.15759999999999999</c:v>
                </c:pt>
                <c:pt idx="228">
                  <c:v>0.16339999999999999</c:v>
                </c:pt>
                <c:pt idx="229">
                  <c:v>0.17419999999999999</c:v>
                </c:pt>
                <c:pt idx="230">
                  <c:v>0.2009</c:v>
                </c:pt>
                <c:pt idx="231">
                  <c:v>0.2064</c:v>
                </c:pt>
                <c:pt idx="232">
                  <c:v>0.22020000000000001</c:v>
                </c:pt>
                <c:pt idx="233">
                  <c:v>0.1991</c:v>
                </c:pt>
                <c:pt idx="234">
                  <c:v>0.18820000000000001</c:v>
                </c:pt>
                <c:pt idx="235">
                  <c:v>0.1925</c:v>
                </c:pt>
                <c:pt idx="236">
                  <c:v>0.2014</c:v>
                </c:pt>
                <c:pt idx="237">
                  <c:v>0.2072</c:v>
                </c:pt>
                <c:pt idx="238">
                  <c:v>0.2152</c:v>
                </c:pt>
                <c:pt idx="239">
                  <c:v>0.25540000000000002</c:v>
                </c:pt>
                <c:pt idx="240">
                  <c:v>0.2621</c:v>
                </c:pt>
                <c:pt idx="241">
                  <c:v>0.2281</c:v>
                </c:pt>
                <c:pt idx="242">
                  <c:v>0.22470000000000001</c:v>
                </c:pt>
                <c:pt idx="243">
                  <c:v>0.20280000000000001</c:v>
                </c:pt>
                <c:pt idx="244">
                  <c:v>0.17860000000000001</c:v>
                </c:pt>
                <c:pt idx="245">
                  <c:v>0.17519999999999999</c:v>
                </c:pt>
                <c:pt idx="246">
                  <c:v>0.2059</c:v>
                </c:pt>
                <c:pt idx="247">
                  <c:v>0.24310000000000001</c:v>
                </c:pt>
                <c:pt idx="248">
                  <c:v>0.30769999999999997</c:v>
                </c:pt>
                <c:pt idx="249">
                  <c:v>0.30549999999999999</c:v>
                </c:pt>
                <c:pt idx="250">
                  <c:v>0.25619999999999998</c:v>
                </c:pt>
                <c:pt idx="251">
                  <c:v>0.23400000000000001</c:v>
                </c:pt>
                <c:pt idx="252">
                  <c:v>0.1925</c:v>
                </c:pt>
                <c:pt idx="253">
                  <c:v>0.16889999999999999</c:v>
                </c:pt>
                <c:pt idx="254">
                  <c:v>0.15590000000000001</c:v>
                </c:pt>
                <c:pt idx="255">
                  <c:v>0.1419</c:v>
                </c:pt>
                <c:pt idx="256">
                  <c:v>0.1467</c:v>
                </c:pt>
                <c:pt idx="257">
                  <c:v>0.14829999999999999</c:v>
                </c:pt>
                <c:pt idx="258">
                  <c:v>0.1343</c:v>
                </c:pt>
                <c:pt idx="259">
                  <c:v>0.13250000000000001</c:v>
                </c:pt>
                <c:pt idx="260">
                  <c:v>0.14729999999999999</c:v>
                </c:pt>
                <c:pt idx="261">
                  <c:v>0.1431</c:v>
                </c:pt>
                <c:pt idx="262">
                  <c:v>0.1295</c:v>
                </c:pt>
                <c:pt idx="263">
                  <c:v>0.13689999999999999</c:v>
                </c:pt>
                <c:pt idx="264">
                  <c:v>0.1275</c:v>
                </c:pt>
                <c:pt idx="265">
                  <c:v>0.15129999999999999</c:v>
                </c:pt>
                <c:pt idx="266">
                  <c:v>0.14749999999999999</c:v>
                </c:pt>
                <c:pt idx="267">
                  <c:v>0.15509999999999999</c:v>
                </c:pt>
                <c:pt idx="268">
                  <c:v>0.14680000000000001</c:v>
                </c:pt>
                <c:pt idx="269">
                  <c:v>0.1285</c:v>
                </c:pt>
                <c:pt idx="270">
                  <c:v>0.14099999999999999</c:v>
                </c:pt>
                <c:pt idx="271">
                  <c:v>0.1396</c:v>
                </c:pt>
                <c:pt idx="272">
                  <c:v>0.1215</c:v>
                </c:pt>
                <c:pt idx="273">
                  <c:v>0.12870000000000001</c:v>
                </c:pt>
                <c:pt idx="274">
                  <c:v>0.14099999999999999</c:v>
                </c:pt>
                <c:pt idx="275">
                  <c:v>0.1333</c:v>
                </c:pt>
                <c:pt idx="276">
                  <c:v>0.12839999999999999</c:v>
                </c:pt>
                <c:pt idx="277">
                  <c:v>0.14599999999999999</c:v>
                </c:pt>
                <c:pt idx="278">
                  <c:v>0.15110000000000001</c:v>
                </c:pt>
                <c:pt idx="279">
                  <c:v>0.14249999999999999</c:v>
                </c:pt>
                <c:pt idx="280">
                  <c:v>0.14680000000000001</c:v>
                </c:pt>
                <c:pt idx="281">
                  <c:v>0.16550000000000001</c:v>
                </c:pt>
                <c:pt idx="282">
                  <c:v>0.1686</c:v>
                </c:pt>
                <c:pt idx="283">
                  <c:v>0.15690000000000001</c:v>
                </c:pt>
                <c:pt idx="284">
                  <c:v>0.1628</c:v>
                </c:pt>
                <c:pt idx="285">
                  <c:v>0.1782</c:v>
                </c:pt>
                <c:pt idx="286">
                  <c:v>0.18060000000000001</c:v>
                </c:pt>
                <c:pt idx="287">
                  <c:v>0.19980000000000001</c:v>
                </c:pt>
                <c:pt idx="288">
                  <c:v>0.1986</c:v>
                </c:pt>
                <c:pt idx="289">
                  <c:v>0.22600000000000001</c:v>
                </c:pt>
                <c:pt idx="290">
                  <c:v>0.23219999999999999</c:v>
                </c:pt>
                <c:pt idx="291">
                  <c:v>0.19450000000000001</c:v>
                </c:pt>
                <c:pt idx="292">
                  <c:v>0.2185</c:v>
                </c:pt>
                <c:pt idx="293">
                  <c:v>0.25940000000000002</c:v>
                </c:pt>
                <c:pt idx="294">
                  <c:v>0.24979999999999999</c:v>
                </c:pt>
                <c:pt idx="295">
                  <c:v>0.28620000000000001</c:v>
                </c:pt>
                <c:pt idx="296">
                  <c:v>0.25679999999999997</c:v>
                </c:pt>
                <c:pt idx="297">
                  <c:v>0.25940000000000002</c:v>
                </c:pt>
                <c:pt idx="298">
                  <c:v>0.2094</c:v>
                </c:pt>
                <c:pt idx="299">
                  <c:v>0.19850000000000001</c:v>
                </c:pt>
                <c:pt idx="300">
                  <c:v>0.22070000000000001</c:v>
                </c:pt>
                <c:pt idx="301">
                  <c:v>0.21840000000000001</c:v>
                </c:pt>
                <c:pt idx="302">
                  <c:v>0.18940000000000001</c:v>
                </c:pt>
                <c:pt idx="303">
                  <c:v>0.18790000000000001</c:v>
                </c:pt>
                <c:pt idx="304">
                  <c:v>0.1898</c:v>
                </c:pt>
                <c:pt idx="305">
                  <c:v>0.19650000000000001</c:v>
                </c:pt>
                <c:pt idx="306">
                  <c:v>0.17879999999999999</c:v>
                </c:pt>
                <c:pt idx="307">
                  <c:v>0.1583</c:v>
                </c:pt>
                <c:pt idx="308">
                  <c:v>0.1603</c:v>
                </c:pt>
                <c:pt idx="309">
                  <c:v>0.16639999999999999</c:v>
                </c:pt>
                <c:pt idx="310">
                  <c:v>0.17230000000000001</c:v>
                </c:pt>
                <c:pt idx="311">
                  <c:v>0.20749999999999999</c:v>
                </c:pt>
                <c:pt idx="312">
                  <c:v>0.24129999999999999</c:v>
                </c:pt>
                <c:pt idx="313">
                  <c:v>0.19220000000000001</c:v>
                </c:pt>
                <c:pt idx="314">
                  <c:v>0.183</c:v>
                </c:pt>
                <c:pt idx="315">
                  <c:v>0.2142</c:v>
                </c:pt>
                <c:pt idx="316">
                  <c:v>0.2555</c:v>
                </c:pt>
                <c:pt idx="317">
                  <c:v>0.27260000000000001</c:v>
                </c:pt>
                <c:pt idx="318">
                  <c:v>0.21160000000000001</c:v>
                </c:pt>
                <c:pt idx="319">
                  <c:v>0.185</c:v>
                </c:pt>
                <c:pt idx="320">
                  <c:v>0.18640000000000001</c:v>
                </c:pt>
                <c:pt idx="321">
                  <c:v>0.18529999999999999</c:v>
                </c:pt>
                <c:pt idx="322">
                  <c:v>0.16300000000000001</c:v>
                </c:pt>
                <c:pt idx="323">
                  <c:v>0.14940000000000001</c:v>
                </c:pt>
                <c:pt idx="324">
                  <c:v>0.1588</c:v>
                </c:pt>
                <c:pt idx="325">
                  <c:v>0.16239999999999999</c:v>
                </c:pt>
                <c:pt idx="326">
                  <c:v>0.1472</c:v>
                </c:pt>
                <c:pt idx="327">
                  <c:v>0.14269999999999999</c:v>
                </c:pt>
                <c:pt idx="328">
                  <c:v>0.16109999999999999</c:v>
                </c:pt>
                <c:pt idx="329">
                  <c:v>0.1699</c:v>
                </c:pt>
                <c:pt idx="330">
                  <c:v>0.1583</c:v>
                </c:pt>
                <c:pt idx="331">
                  <c:v>0.17610000000000001</c:v>
                </c:pt>
                <c:pt idx="332">
                  <c:v>0.19719999999999999</c:v>
                </c:pt>
                <c:pt idx="333">
                  <c:v>0.2024</c:v>
                </c:pt>
                <c:pt idx="334">
                  <c:v>0.23910000000000001</c:v>
                </c:pt>
                <c:pt idx="335">
                  <c:v>0.1782</c:v>
                </c:pt>
                <c:pt idx="336">
                  <c:v>0.1648</c:v>
                </c:pt>
                <c:pt idx="337">
                  <c:v>0.152</c:v>
                </c:pt>
                <c:pt idx="338">
                  <c:v>0.1444</c:v>
                </c:pt>
                <c:pt idx="339">
                  <c:v>0.1242</c:v>
                </c:pt>
                <c:pt idx="340">
                  <c:v>0.13059999999999999</c:v>
                </c:pt>
                <c:pt idx="341">
                  <c:v>0.13700000000000001</c:v>
                </c:pt>
                <c:pt idx="342">
                  <c:v>0.13919999999999999</c:v>
                </c:pt>
                <c:pt idx="343">
                  <c:v>0.17150000000000001</c:v>
                </c:pt>
                <c:pt idx="344">
                  <c:v>0.17649999999999999</c:v>
                </c:pt>
                <c:pt idx="345">
                  <c:v>0.1774</c:v>
                </c:pt>
                <c:pt idx="346">
                  <c:v>0.1938</c:v>
                </c:pt>
                <c:pt idx="347">
                  <c:v>0.18310000000000001</c:v>
                </c:pt>
                <c:pt idx="348">
                  <c:v>0.18779999999999999</c:v>
                </c:pt>
                <c:pt idx="349">
                  <c:v>0.16689999999999999</c:v>
                </c:pt>
                <c:pt idx="350">
                  <c:v>0.15570000000000001</c:v>
                </c:pt>
                <c:pt idx="351">
                  <c:v>0.16450000000000001</c:v>
                </c:pt>
                <c:pt idx="352">
                  <c:v>0.1804</c:v>
                </c:pt>
                <c:pt idx="353">
                  <c:v>0.1681</c:v>
                </c:pt>
                <c:pt idx="354">
                  <c:v>0.1648</c:v>
                </c:pt>
                <c:pt idx="355">
                  <c:v>0.15579999999999999</c:v>
                </c:pt>
                <c:pt idx="356">
                  <c:v>0.15670000000000001</c:v>
                </c:pt>
                <c:pt idx="357">
                  <c:v>0.13519999999999999</c:v>
                </c:pt>
                <c:pt idx="358">
                  <c:v>0.17549999999999999</c:v>
                </c:pt>
                <c:pt idx="359">
                  <c:v>0.1958</c:v>
                </c:pt>
                <c:pt idx="360">
                  <c:v>0.16109999999999999</c:v>
                </c:pt>
                <c:pt idx="361">
                  <c:v>0.1666</c:v>
                </c:pt>
                <c:pt idx="362">
                  <c:v>0.16159999999999999</c:v>
                </c:pt>
                <c:pt idx="363">
                  <c:v>0.17799999999999999</c:v>
                </c:pt>
                <c:pt idx="364">
                  <c:v>0.18049999999999999</c:v>
                </c:pt>
                <c:pt idx="365">
                  <c:v>0.19270000000000001</c:v>
                </c:pt>
                <c:pt idx="366">
                  <c:v>0.22359999999999999</c:v>
                </c:pt>
                <c:pt idx="367">
                  <c:v>0.27789999999999998</c:v>
                </c:pt>
                <c:pt idx="368">
                  <c:v>0.34</c:v>
                </c:pt>
                <c:pt idx="369">
                  <c:v>0.42320000000000002</c:v>
                </c:pt>
                <c:pt idx="370">
                  <c:v>0.55769999999999997</c:v>
                </c:pt>
                <c:pt idx="371">
                  <c:v>0.65180000000000005</c:v>
                </c:pt>
                <c:pt idx="372">
                  <c:v>0.8044</c:v>
                </c:pt>
                <c:pt idx="373">
                  <c:v>0.85580000000000001</c:v>
                </c:pt>
                <c:pt idx="374">
                  <c:v>0.7177</c:v>
                </c:pt>
                <c:pt idx="375">
                  <c:v>0.66790000000000005</c:v>
                </c:pt>
                <c:pt idx="376">
                  <c:v>0.5544</c:v>
                </c:pt>
                <c:pt idx="377">
                  <c:v>0.4768</c:v>
                </c:pt>
                <c:pt idx="378">
                  <c:v>0.4133</c:v>
                </c:pt>
                <c:pt idx="379">
                  <c:v>0.37830000000000003</c:v>
                </c:pt>
                <c:pt idx="380">
                  <c:v>0.28129999999999999</c:v>
                </c:pt>
                <c:pt idx="381">
                  <c:v>0.19370000000000001</c:v>
                </c:pt>
                <c:pt idx="382">
                  <c:v>0.1862</c:v>
                </c:pt>
                <c:pt idx="383">
                  <c:v>0.17230000000000001</c:v>
                </c:pt>
                <c:pt idx="384">
                  <c:v>0.1996</c:v>
                </c:pt>
                <c:pt idx="385">
                  <c:v>0.25</c:v>
                </c:pt>
                <c:pt idx="386">
                  <c:v>0.26989999999999997</c:v>
                </c:pt>
                <c:pt idx="387">
                  <c:v>0.31069999999999998</c:v>
                </c:pt>
                <c:pt idx="388">
                  <c:v>0.36399999999999999</c:v>
                </c:pt>
                <c:pt idx="389">
                  <c:v>0.4239</c:v>
                </c:pt>
                <c:pt idx="390">
                  <c:v>0.4572</c:v>
                </c:pt>
                <c:pt idx="391">
                  <c:v>0.45679999999999998</c:v>
                </c:pt>
                <c:pt idx="392">
                  <c:v>0.4788</c:v>
                </c:pt>
                <c:pt idx="393">
                  <c:v>0.52649999999999997</c:v>
                </c:pt>
                <c:pt idx="394">
                  <c:v>0.48699999999999999</c:v>
                </c:pt>
                <c:pt idx="395">
                  <c:v>0.4657</c:v>
                </c:pt>
                <c:pt idx="396">
                  <c:v>0.45579999999999998</c:v>
                </c:pt>
                <c:pt idx="397">
                  <c:v>0.41070000000000001</c:v>
                </c:pt>
                <c:pt idx="398">
                  <c:v>0.42499999999999999</c:v>
                </c:pt>
                <c:pt idx="399">
                  <c:v>0.35510000000000003</c:v>
                </c:pt>
                <c:pt idx="400">
                  <c:v>0.32900000000000001</c:v>
                </c:pt>
                <c:pt idx="401">
                  <c:v>0.24970000000000001</c:v>
                </c:pt>
                <c:pt idx="402">
                  <c:v>0.29709999999999998</c:v>
                </c:pt>
                <c:pt idx="403">
                  <c:v>0.34599999999999997</c:v>
                </c:pt>
                <c:pt idx="404">
                  <c:v>0.29020000000000001</c:v>
                </c:pt>
                <c:pt idx="405">
                  <c:v>0.20039999999999999</c:v>
                </c:pt>
                <c:pt idx="406">
                  <c:v>0.13569999999999999</c:v>
                </c:pt>
                <c:pt idx="407">
                  <c:v>0.12559999999999999</c:v>
                </c:pt>
                <c:pt idx="408">
                  <c:v>0.14000000000000001</c:v>
                </c:pt>
                <c:pt idx="409">
                  <c:v>0.1338</c:v>
                </c:pt>
                <c:pt idx="410">
                  <c:v>0.11890000000000001</c:v>
                </c:pt>
                <c:pt idx="411">
                  <c:v>0.13100000000000001</c:v>
                </c:pt>
                <c:pt idx="412">
                  <c:v>0.15290000000000001</c:v>
                </c:pt>
                <c:pt idx="413">
                  <c:v>0.14269999999999999</c:v>
                </c:pt>
                <c:pt idx="414">
                  <c:v>0.1313</c:v>
                </c:pt>
                <c:pt idx="415">
                  <c:v>0.1517</c:v>
                </c:pt>
                <c:pt idx="416">
                  <c:v>0.15759999999999999</c:v>
                </c:pt>
                <c:pt idx="417">
                  <c:v>0.14710000000000001</c:v>
                </c:pt>
                <c:pt idx="418">
                  <c:v>0.15890000000000001</c:v>
                </c:pt>
                <c:pt idx="419">
                  <c:v>0.17829999999999999</c:v>
                </c:pt>
                <c:pt idx="420">
                  <c:v>0.18459999999999999</c:v>
                </c:pt>
                <c:pt idx="421">
                  <c:v>0.1699</c:v>
                </c:pt>
                <c:pt idx="422">
                  <c:v>0.1699</c:v>
                </c:pt>
                <c:pt idx="423">
                  <c:v>0.1966</c:v>
                </c:pt>
                <c:pt idx="424">
                  <c:v>0.19489999999999999</c:v>
                </c:pt>
                <c:pt idx="425">
                  <c:v>0.2097</c:v>
                </c:pt>
                <c:pt idx="426">
                  <c:v>0.19939999999999999</c:v>
                </c:pt>
                <c:pt idx="427">
                  <c:v>0.20499999999999999</c:v>
                </c:pt>
                <c:pt idx="428">
                  <c:v>0.21210000000000001</c:v>
                </c:pt>
                <c:pt idx="429">
                  <c:v>0.2346</c:v>
                </c:pt>
                <c:pt idx="430">
                  <c:v>0.27529999999999999</c:v>
                </c:pt>
                <c:pt idx="431">
                  <c:v>0.26519999999999999</c:v>
                </c:pt>
                <c:pt idx="432">
                  <c:v>0.23300000000000001</c:v>
                </c:pt>
                <c:pt idx="433">
                  <c:v>0.25430000000000003</c:v>
                </c:pt>
                <c:pt idx="434">
                  <c:v>0.2707</c:v>
                </c:pt>
                <c:pt idx="435">
                  <c:v>0.2407</c:v>
                </c:pt>
                <c:pt idx="436">
                  <c:v>0.2404</c:v>
                </c:pt>
                <c:pt idx="437">
                  <c:v>0.27200000000000002</c:v>
                </c:pt>
                <c:pt idx="438">
                  <c:v>0.26569999999999999</c:v>
                </c:pt>
                <c:pt idx="439">
                  <c:v>0.24629999999999999</c:v>
                </c:pt>
                <c:pt idx="440">
                  <c:v>0.2646</c:v>
                </c:pt>
                <c:pt idx="441">
                  <c:v>0.28289999999999998</c:v>
                </c:pt>
                <c:pt idx="442">
                  <c:v>0.308</c:v>
                </c:pt>
                <c:pt idx="443">
                  <c:v>0.25019999999999998</c:v>
                </c:pt>
                <c:pt idx="444">
                  <c:v>0.24859999999999999</c:v>
                </c:pt>
                <c:pt idx="445">
                  <c:v>0.23380000000000001</c:v>
                </c:pt>
                <c:pt idx="446">
                  <c:v>0.22869999999999999</c:v>
                </c:pt>
                <c:pt idx="447">
                  <c:v>0.21870000000000001</c:v>
                </c:pt>
                <c:pt idx="448">
                  <c:v>0.2046</c:v>
                </c:pt>
                <c:pt idx="449">
                  <c:v>0.20069999999999999</c:v>
                </c:pt>
                <c:pt idx="450">
                  <c:v>0.19889999999999999</c:v>
                </c:pt>
                <c:pt idx="451">
                  <c:v>0.18890000000000001</c:v>
                </c:pt>
                <c:pt idx="452">
                  <c:v>0.1852</c:v>
                </c:pt>
                <c:pt idx="453">
                  <c:v>0.18490000000000001</c:v>
                </c:pt>
                <c:pt idx="454">
                  <c:v>0.16750000000000001</c:v>
                </c:pt>
                <c:pt idx="455">
                  <c:v>0.1623</c:v>
                </c:pt>
                <c:pt idx="456">
                  <c:v>0.1787</c:v>
                </c:pt>
                <c:pt idx="457">
                  <c:v>0.1749</c:v>
                </c:pt>
                <c:pt idx="458">
                  <c:v>0.15529999999999999</c:v>
                </c:pt>
                <c:pt idx="459">
                  <c:v>0.16109999999999999</c:v>
                </c:pt>
                <c:pt idx="460">
                  <c:v>0.19539999999999999</c:v>
                </c:pt>
                <c:pt idx="461">
                  <c:v>0.2288</c:v>
                </c:pt>
                <c:pt idx="462">
                  <c:v>0.22720000000000001</c:v>
                </c:pt>
                <c:pt idx="463">
                  <c:v>0.2374</c:v>
                </c:pt>
                <c:pt idx="464">
                  <c:v>0.24759999999999999</c:v>
                </c:pt>
                <c:pt idx="465">
                  <c:v>0.3004</c:v>
                </c:pt>
                <c:pt idx="466">
                  <c:v>0.40150000000000002</c:v>
                </c:pt>
                <c:pt idx="467">
                  <c:v>0.43990000000000001</c:v>
                </c:pt>
                <c:pt idx="468">
                  <c:v>0.36380000000000001</c:v>
                </c:pt>
                <c:pt idx="469">
                  <c:v>0.38279999999999997</c:v>
                </c:pt>
                <c:pt idx="470">
                  <c:v>0.44180000000000003</c:v>
                </c:pt>
                <c:pt idx="471">
                  <c:v>0.35720000000000002</c:v>
                </c:pt>
                <c:pt idx="472">
                  <c:v>0.32900000000000001</c:v>
                </c:pt>
                <c:pt idx="473">
                  <c:v>0.29749999999999999</c:v>
                </c:pt>
                <c:pt idx="474">
                  <c:v>0.29549999999999998</c:v>
                </c:pt>
                <c:pt idx="475">
                  <c:v>0.25190000000000001</c:v>
                </c:pt>
                <c:pt idx="476">
                  <c:v>0.19339999999999999</c:v>
                </c:pt>
                <c:pt idx="477">
                  <c:v>0.18410000000000001</c:v>
                </c:pt>
                <c:pt idx="478">
                  <c:v>0.20519999999999999</c:v>
                </c:pt>
                <c:pt idx="479">
                  <c:v>0.17249999999999999</c:v>
                </c:pt>
                <c:pt idx="480">
                  <c:v>0.1489</c:v>
                </c:pt>
                <c:pt idx="481">
                  <c:v>0.17949999999999999</c:v>
                </c:pt>
                <c:pt idx="482">
                  <c:v>0.18229999999999999</c:v>
                </c:pt>
                <c:pt idx="483">
                  <c:v>0.15920000000000001</c:v>
                </c:pt>
                <c:pt idx="484">
                  <c:v>0.15909999999999999</c:v>
                </c:pt>
                <c:pt idx="485">
                  <c:v>0.17849999999999999</c:v>
                </c:pt>
                <c:pt idx="486">
                  <c:v>0.17280000000000001</c:v>
                </c:pt>
                <c:pt idx="487">
                  <c:v>0.1613</c:v>
                </c:pt>
                <c:pt idx="488">
                  <c:v>0.16639999999999999</c:v>
                </c:pt>
                <c:pt idx="489">
                  <c:v>0.1777</c:v>
                </c:pt>
                <c:pt idx="490">
                  <c:v>0.16569999999999999</c:v>
                </c:pt>
                <c:pt idx="491">
                  <c:v>0.15529999999999999</c:v>
                </c:pt>
                <c:pt idx="492">
                  <c:v>0.1661</c:v>
                </c:pt>
                <c:pt idx="493">
                  <c:v>0.1721</c:v>
                </c:pt>
                <c:pt idx="494">
                  <c:v>0.1641</c:v>
                </c:pt>
                <c:pt idx="495">
                  <c:v>0.16489999999999999</c:v>
                </c:pt>
                <c:pt idx="496">
                  <c:v>0.1913</c:v>
                </c:pt>
                <c:pt idx="497">
                  <c:v>0.19600000000000001</c:v>
                </c:pt>
                <c:pt idx="498">
                  <c:v>0.18390000000000001</c:v>
                </c:pt>
                <c:pt idx="499">
                  <c:v>0.19139999999999999</c:v>
                </c:pt>
                <c:pt idx="500">
                  <c:v>0.21010000000000001</c:v>
                </c:pt>
                <c:pt idx="501">
                  <c:v>0.2122</c:v>
                </c:pt>
                <c:pt idx="502">
                  <c:v>0.2082</c:v>
                </c:pt>
                <c:pt idx="503">
                  <c:v>0.2145</c:v>
                </c:pt>
                <c:pt idx="504">
                  <c:v>0.22839999999999999</c:v>
                </c:pt>
                <c:pt idx="505">
                  <c:v>0.2278</c:v>
                </c:pt>
                <c:pt idx="506">
                  <c:v>0.2228</c:v>
                </c:pt>
                <c:pt idx="507">
                  <c:v>0.2344</c:v>
                </c:pt>
                <c:pt idx="508">
                  <c:v>0.2505</c:v>
                </c:pt>
                <c:pt idx="509">
                  <c:v>0.25309999999999999</c:v>
                </c:pt>
                <c:pt idx="510">
                  <c:v>0.247</c:v>
                </c:pt>
                <c:pt idx="511">
                  <c:v>0.26590000000000003</c:v>
                </c:pt>
                <c:pt idx="512">
                  <c:v>0.25769999999999998</c:v>
                </c:pt>
                <c:pt idx="513">
                  <c:v>0.25309999999999999</c:v>
                </c:pt>
                <c:pt idx="514">
                  <c:v>0.24030000000000001</c:v>
                </c:pt>
                <c:pt idx="515">
                  <c:v>0.22259999999999999</c:v>
                </c:pt>
                <c:pt idx="516">
                  <c:v>0.22589999999999999</c:v>
                </c:pt>
                <c:pt idx="517">
                  <c:v>0.19969999999999999</c:v>
                </c:pt>
                <c:pt idx="518">
                  <c:v>0.1792</c:v>
                </c:pt>
                <c:pt idx="519">
                  <c:v>0.1968</c:v>
                </c:pt>
                <c:pt idx="520">
                  <c:v>0.19889999999999999</c:v>
                </c:pt>
                <c:pt idx="521">
                  <c:v>0.17050000000000001</c:v>
                </c:pt>
                <c:pt idx="522">
                  <c:v>0.15640000000000001</c:v>
                </c:pt>
                <c:pt idx="523">
                  <c:v>0.13950000000000001</c:v>
                </c:pt>
                <c:pt idx="524">
                  <c:v>0.13980000000000001</c:v>
                </c:pt>
                <c:pt idx="525">
                  <c:v>0.1464</c:v>
                </c:pt>
                <c:pt idx="526">
                  <c:v>0.1308</c:v>
                </c:pt>
                <c:pt idx="527">
                  <c:v>0.12379999999999999</c:v>
                </c:pt>
                <c:pt idx="528">
                  <c:v>0.1333</c:v>
                </c:pt>
                <c:pt idx="529">
                  <c:v>0.13200000000000001</c:v>
                </c:pt>
                <c:pt idx="530">
                  <c:v>0.1179</c:v>
                </c:pt>
                <c:pt idx="531">
                  <c:v>0.1198</c:v>
                </c:pt>
                <c:pt idx="532">
                  <c:v>0.12770000000000001</c:v>
                </c:pt>
                <c:pt idx="533">
                  <c:v>0.122</c:v>
                </c:pt>
                <c:pt idx="534">
                  <c:v>0.114</c:v>
                </c:pt>
                <c:pt idx="535">
                  <c:v>0.1195</c:v>
                </c:pt>
                <c:pt idx="536">
                  <c:v>0.12770000000000001</c:v>
                </c:pt>
                <c:pt idx="537">
                  <c:v>0.10979999999999999</c:v>
                </c:pt>
                <c:pt idx="538">
                  <c:v>0.1148</c:v>
                </c:pt>
                <c:pt idx="539">
                  <c:v>0.14399999999999999</c:v>
                </c:pt>
                <c:pt idx="540">
                  <c:v>0.129</c:v>
                </c:pt>
                <c:pt idx="541">
                  <c:v>0.1305</c:v>
                </c:pt>
                <c:pt idx="542">
                  <c:v>0.1222</c:v>
                </c:pt>
                <c:pt idx="543">
                  <c:v>0.14280000000000001</c:v>
                </c:pt>
                <c:pt idx="544">
                  <c:v>0.1326</c:v>
                </c:pt>
                <c:pt idx="545">
                  <c:v>0.1217</c:v>
                </c:pt>
                <c:pt idx="546">
                  <c:v>0.1275</c:v>
                </c:pt>
                <c:pt idx="547">
                  <c:v>0.1216</c:v>
                </c:pt>
                <c:pt idx="548">
                  <c:v>0.11849999999999999</c:v>
                </c:pt>
                <c:pt idx="549">
                  <c:v>0.1179</c:v>
                </c:pt>
                <c:pt idx="550">
                  <c:v>0.11360000000000001</c:v>
                </c:pt>
                <c:pt idx="551">
                  <c:v>0.11700000000000001</c:v>
                </c:pt>
                <c:pt idx="552">
                  <c:v>0.13289999999999999</c:v>
                </c:pt>
                <c:pt idx="553">
                  <c:v>0.1394</c:v>
                </c:pt>
                <c:pt idx="554">
                  <c:v>0.13339999999999999</c:v>
                </c:pt>
                <c:pt idx="555">
                  <c:v>0.1363</c:v>
                </c:pt>
                <c:pt idx="556">
                  <c:v>0.126</c:v>
                </c:pt>
                <c:pt idx="557">
                  <c:v>0.12529999999999999</c:v>
                </c:pt>
                <c:pt idx="558">
                  <c:v>0.11749999999999999</c:v>
                </c:pt>
                <c:pt idx="559">
                  <c:v>0.1171</c:v>
                </c:pt>
                <c:pt idx="560">
                  <c:v>0.1258</c:v>
                </c:pt>
                <c:pt idx="561">
                  <c:v>0.1206</c:v>
                </c:pt>
                <c:pt idx="562">
                  <c:v>0.11849999999999999</c:v>
                </c:pt>
                <c:pt idx="563">
                  <c:v>0.13109999999999999</c:v>
                </c:pt>
                <c:pt idx="564">
                  <c:v>0.13689999999999999</c:v>
                </c:pt>
                <c:pt idx="565">
                  <c:v>0.13100000000000001</c:v>
                </c:pt>
                <c:pt idx="566">
                  <c:v>0.14419999999999999</c:v>
                </c:pt>
                <c:pt idx="567">
                  <c:v>0.15379999999999999</c:v>
                </c:pt>
                <c:pt idx="568">
                  <c:v>0.14990000000000001</c:v>
                </c:pt>
                <c:pt idx="569">
                  <c:v>0.15570000000000001</c:v>
                </c:pt>
                <c:pt idx="570">
                  <c:v>0.17699999999999999</c:v>
                </c:pt>
                <c:pt idx="571">
                  <c:v>0.1855</c:v>
                </c:pt>
                <c:pt idx="572">
                  <c:v>0.18809999999999999</c:v>
                </c:pt>
                <c:pt idx="573">
                  <c:v>0.2054</c:v>
                </c:pt>
                <c:pt idx="574">
                  <c:v>0.1981</c:v>
                </c:pt>
                <c:pt idx="575">
                  <c:v>0.158</c:v>
                </c:pt>
                <c:pt idx="576">
                  <c:v>0.151</c:v>
                </c:pt>
                <c:pt idx="577">
                  <c:v>0.15720000000000001</c:v>
                </c:pt>
                <c:pt idx="578">
                  <c:v>0.14549999999999999</c:v>
                </c:pt>
                <c:pt idx="579">
                  <c:v>0.1321</c:v>
                </c:pt>
                <c:pt idx="580">
                  <c:v>0.1416</c:v>
                </c:pt>
                <c:pt idx="581">
                  <c:v>0.14030000000000001</c:v>
                </c:pt>
                <c:pt idx="582">
                  <c:v>0.124</c:v>
                </c:pt>
                <c:pt idx="583">
                  <c:v>0.1237</c:v>
                </c:pt>
                <c:pt idx="584">
                  <c:v>0.12479999999999999</c:v>
                </c:pt>
                <c:pt idx="585">
                  <c:v>0.1149</c:v>
                </c:pt>
                <c:pt idx="586">
                  <c:v>0.1099</c:v>
                </c:pt>
                <c:pt idx="587">
                  <c:v>0.11</c:v>
                </c:pt>
                <c:pt idx="588">
                  <c:v>0.1062</c:v>
                </c:pt>
                <c:pt idx="589">
                  <c:v>9.9000000000000005E-2</c:v>
                </c:pt>
                <c:pt idx="590">
                  <c:v>9.5500000000000002E-2</c:v>
                </c:pt>
                <c:pt idx="591">
                  <c:v>9.5000000000000001E-2</c:v>
                </c:pt>
                <c:pt idx="592">
                  <c:v>9.2100000000000001E-2</c:v>
                </c:pt>
                <c:pt idx="593">
                  <c:v>9.11E-2</c:v>
                </c:pt>
                <c:pt idx="594">
                  <c:v>9.5600000000000004E-2</c:v>
                </c:pt>
                <c:pt idx="595">
                  <c:v>9.8500000000000004E-2</c:v>
                </c:pt>
                <c:pt idx="596">
                  <c:v>0.1009</c:v>
                </c:pt>
                <c:pt idx="597">
                  <c:v>0.1091</c:v>
                </c:pt>
                <c:pt idx="598">
                  <c:v>0.12659999999999999</c:v>
                </c:pt>
                <c:pt idx="599">
                  <c:v>0.13400000000000001</c:v>
                </c:pt>
                <c:pt idx="600">
                  <c:v>0.1186</c:v>
                </c:pt>
                <c:pt idx="601">
                  <c:v>0.13070000000000001</c:v>
                </c:pt>
                <c:pt idx="602">
                  <c:v>0.12230000000000001</c:v>
                </c:pt>
                <c:pt idx="603">
                  <c:v>0.1303</c:v>
                </c:pt>
                <c:pt idx="604">
                  <c:v>0.14749999999999999</c:v>
                </c:pt>
                <c:pt idx="605">
                  <c:v>0.14530000000000001</c:v>
                </c:pt>
                <c:pt idx="606">
                  <c:v>0.13969999999999999</c:v>
                </c:pt>
                <c:pt idx="607">
                  <c:v>0.15790000000000001</c:v>
                </c:pt>
                <c:pt idx="608">
                  <c:v>0.1696</c:v>
                </c:pt>
                <c:pt idx="609">
                  <c:v>0.16220000000000001</c:v>
                </c:pt>
                <c:pt idx="610">
                  <c:v>0.16589999999999999</c:v>
                </c:pt>
                <c:pt idx="611">
                  <c:v>0.18790000000000001</c:v>
                </c:pt>
                <c:pt idx="612">
                  <c:v>0.193</c:v>
                </c:pt>
                <c:pt idx="613">
                  <c:v>0.1729</c:v>
                </c:pt>
                <c:pt idx="614">
                  <c:v>0.18090000000000001</c:v>
                </c:pt>
                <c:pt idx="615">
                  <c:v>0.2031</c:v>
                </c:pt>
                <c:pt idx="616">
                  <c:v>0.189</c:v>
                </c:pt>
                <c:pt idx="617">
                  <c:v>0.1608</c:v>
                </c:pt>
                <c:pt idx="618">
                  <c:v>0.18659999999999999</c:v>
                </c:pt>
                <c:pt idx="619">
                  <c:v>0.2041</c:v>
                </c:pt>
                <c:pt idx="620">
                  <c:v>0.1807</c:v>
                </c:pt>
                <c:pt idx="621">
                  <c:v>0.17430000000000001</c:v>
                </c:pt>
                <c:pt idx="622">
                  <c:v>0.14460000000000001</c:v>
                </c:pt>
                <c:pt idx="623">
                  <c:v>0.14810000000000001</c:v>
                </c:pt>
                <c:pt idx="624">
                  <c:v>0.1449</c:v>
                </c:pt>
                <c:pt idx="625">
                  <c:v>0.1666</c:v>
                </c:pt>
                <c:pt idx="626">
                  <c:v>0.17180000000000001</c:v>
                </c:pt>
                <c:pt idx="627">
                  <c:v>0.16450000000000001</c:v>
                </c:pt>
                <c:pt idx="628">
                  <c:v>0.17649999999999999</c:v>
                </c:pt>
                <c:pt idx="629">
                  <c:v>0.2041</c:v>
                </c:pt>
                <c:pt idx="630">
                  <c:v>0.20449999999999999</c:v>
                </c:pt>
                <c:pt idx="631">
                  <c:v>0.2697</c:v>
                </c:pt>
                <c:pt idx="632">
                  <c:v>0.33029999999999998</c:v>
                </c:pt>
                <c:pt idx="633">
                  <c:v>0.32729999999999998</c:v>
                </c:pt>
                <c:pt idx="634">
                  <c:v>0.34289999999999998</c:v>
                </c:pt>
                <c:pt idx="635">
                  <c:v>0.48010000000000003</c:v>
                </c:pt>
                <c:pt idx="636">
                  <c:v>0.54279999999999995</c:v>
                </c:pt>
                <c:pt idx="637">
                  <c:v>0.52090000000000003</c:v>
                </c:pt>
                <c:pt idx="638">
                  <c:v>0.63529999999999998</c:v>
                </c:pt>
                <c:pt idx="639">
                  <c:v>0.75549999999999995</c:v>
                </c:pt>
                <c:pt idx="640">
                  <c:v>0.77490000000000003</c:v>
                </c:pt>
                <c:pt idx="641">
                  <c:v>0.8165</c:v>
                </c:pt>
                <c:pt idx="642">
                  <c:v>0.97360000000000002</c:v>
                </c:pt>
                <c:pt idx="643">
                  <c:v>1.0511999999999999</c:v>
                </c:pt>
                <c:pt idx="644">
                  <c:v>1.1031</c:v>
                </c:pt>
                <c:pt idx="645">
                  <c:v>1.1947000000000001</c:v>
                </c:pt>
                <c:pt idx="646">
                  <c:v>1.3398000000000001</c:v>
                </c:pt>
                <c:pt idx="647">
                  <c:v>1.3361000000000001</c:v>
                </c:pt>
                <c:pt idx="648">
                  <c:v>1.3260000000000001</c:v>
                </c:pt>
                <c:pt idx="649">
                  <c:v>1.423</c:v>
                </c:pt>
                <c:pt idx="650">
                  <c:v>1.492</c:v>
                </c:pt>
                <c:pt idx="651">
                  <c:v>1.5838000000000001</c:v>
                </c:pt>
                <c:pt idx="652">
                  <c:v>1.6279999999999999</c:v>
                </c:pt>
                <c:pt idx="653">
                  <c:v>1.6648000000000001</c:v>
                </c:pt>
                <c:pt idx="654">
                  <c:v>1.7089000000000001</c:v>
                </c:pt>
                <c:pt idx="655">
                  <c:v>1.7437</c:v>
                </c:pt>
                <c:pt idx="656">
                  <c:v>1.7044999999999999</c:v>
                </c:pt>
                <c:pt idx="657">
                  <c:v>1.5570999999999999</c:v>
                </c:pt>
                <c:pt idx="658">
                  <c:v>1.4870000000000001</c:v>
                </c:pt>
                <c:pt idx="659">
                  <c:v>1.4080999999999999</c:v>
                </c:pt>
                <c:pt idx="660">
                  <c:v>1.3109999999999999</c:v>
                </c:pt>
                <c:pt idx="661">
                  <c:v>1.2646999999999999</c:v>
                </c:pt>
                <c:pt idx="662">
                  <c:v>1.204</c:v>
                </c:pt>
                <c:pt idx="663">
                  <c:v>1.1096999999999999</c:v>
                </c:pt>
                <c:pt idx="664">
                  <c:v>1.0243</c:v>
                </c:pt>
                <c:pt idx="665">
                  <c:v>1.0229999999999999</c:v>
                </c:pt>
                <c:pt idx="666">
                  <c:v>0.97760000000000002</c:v>
                </c:pt>
                <c:pt idx="667">
                  <c:v>0.90739999999999998</c:v>
                </c:pt>
                <c:pt idx="668">
                  <c:v>0.94140000000000001</c:v>
                </c:pt>
                <c:pt idx="669">
                  <c:v>0.94</c:v>
                </c:pt>
                <c:pt idx="670">
                  <c:v>0.8669</c:v>
                </c:pt>
                <c:pt idx="671">
                  <c:v>0.62290000000000001</c:v>
                </c:pt>
                <c:pt idx="672">
                  <c:v>0.57540000000000002</c:v>
                </c:pt>
                <c:pt idx="673">
                  <c:v>0.48680000000000001</c:v>
                </c:pt>
                <c:pt idx="674">
                  <c:v>0.57269999999999999</c:v>
                </c:pt>
                <c:pt idx="675">
                  <c:v>0.62070000000000003</c:v>
                </c:pt>
                <c:pt idx="676">
                  <c:v>0.63239999999999996</c:v>
                </c:pt>
                <c:pt idx="677">
                  <c:v>0.7087</c:v>
                </c:pt>
                <c:pt idx="678">
                  <c:v>0.72060000000000002</c:v>
                </c:pt>
                <c:pt idx="679">
                  <c:v>0.90229999999999999</c:v>
                </c:pt>
                <c:pt idx="680">
                  <c:v>0.88419999999999999</c:v>
                </c:pt>
                <c:pt idx="681">
                  <c:v>0.8125</c:v>
                </c:pt>
                <c:pt idx="682">
                  <c:v>0.68420000000000003</c:v>
                </c:pt>
                <c:pt idx="683">
                  <c:v>0.62039999999999995</c:v>
                </c:pt>
                <c:pt idx="684">
                  <c:v>0.57709999999999995</c:v>
                </c:pt>
                <c:pt idx="685">
                  <c:v>0.53720000000000001</c:v>
                </c:pt>
                <c:pt idx="686">
                  <c:v>0.50870000000000004</c:v>
                </c:pt>
                <c:pt idx="687">
                  <c:v>0.51570000000000005</c:v>
                </c:pt>
                <c:pt idx="688">
                  <c:v>0.49530000000000002</c:v>
                </c:pt>
                <c:pt idx="689">
                  <c:v>0.4541</c:v>
                </c:pt>
                <c:pt idx="690">
                  <c:v>0.45710000000000001</c:v>
                </c:pt>
                <c:pt idx="691">
                  <c:v>0.47620000000000001</c:v>
                </c:pt>
                <c:pt idx="692">
                  <c:v>0.44729999999999998</c:v>
                </c:pt>
                <c:pt idx="693">
                  <c:v>0.43059999999999998</c:v>
                </c:pt>
                <c:pt idx="694">
                  <c:v>0.54190000000000005</c:v>
                </c:pt>
                <c:pt idx="695">
                  <c:v>0.56299999999999994</c:v>
                </c:pt>
                <c:pt idx="696">
                  <c:v>0.53700000000000003</c:v>
                </c:pt>
                <c:pt idx="697">
                  <c:v>0.56579999999999997</c:v>
                </c:pt>
                <c:pt idx="698">
                  <c:v>0.54710000000000003</c:v>
                </c:pt>
                <c:pt idx="699">
                  <c:v>0.50090000000000001</c:v>
                </c:pt>
                <c:pt idx="700">
                  <c:v>0.42580000000000001</c:v>
                </c:pt>
                <c:pt idx="701">
                  <c:v>0.32040000000000002</c:v>
                </c:pt>
                <c:pt idx="702">
                  <c:v>0.2681</c:v>
                </c:pt>
                <c:pt idx="703">
                  <c:v>0.2145</c:v>
                </c:pt>
                <c:pt idx="704">
                  <c:v>0.1822</c:v>
                </c:pt>
                <c:pt idx="705">
                  <c:v>0.18140000000000001</c:v>
                </c:pt>
                <c:pt idx="706">
                  <c:v>0.1852</c:v>
                </c:pt>
                <c:pt idx="707">
                  <c:v>0.1709</c:v>
                </c:pt>
                <c:pt idx="708">
                  <c:v>0.16930000000000001</c:v>
                </c:pt>
                <c:pt idx="709">
                  <c:v>0.1779</c:v>
                </c:pt>
                <c:pt idx="710">
                  <c:v>0.19040000000000001</c:v>
                </c:pt>
                <c:pt idx="711">
                  <c:v>0.20100000000000001</c:v>
                </c:pt>
                <c:pt idx="712">
                  <c:v>0.18310000000000001</c:v>
                </c:pt>
                <c:pt idx="713">
                  <c:v>0.20449999999999999</c:v>
                </c:pt>
                <c:pt idx="714">
                  <c:v>0.21859999999999999</c:v>
                </c:pt>
                <c:pt idx="715">
                  <c:v>0.21820000000000001</c:v>
                </c:pt>
                <c:pt idx="716">
                  <c:v>0.21260000000000001</c:v>
                </c:pt>
                <c:pt idx="717">
                  <c:v>0.26129999999999998</c:v>
                </c:pt>
                <c:pt idx="718">
                  <c:v>0.3291</c:v>
                </c:pt>
                <c:pt idx="719">
                  <c:v>0.42249999999999999</c:v>
                </c:pt>
                <c:pt idx="720">
                  <c:v>0.38429999999999997</c:v>
                </c:pt>
                <c:pt idx="721">
                  <c:v>0.27739999999999998</c:v>
                </c:pt>
                <c:pt idx="722">
                  <c:v>0.21490000000000001</c:v>
                </c:pt>
                <c:pt idx="723">
                  <c:v>0.1966</c:v>
                </c:pt>
                <c:pt idx="724">
                  <c:v>0.17749999999999999</c:v>
                </c:pt>
                <c:pt idx="725">
                  <c:v>0.16289999999999999</c:v>
                </c:pt>
                <c:pt idx="726">
                  <c:v>0.16270000000000001</c:v>
                </c:pt>
                <c:pt idx="727">
                  <c:v>0.16200000000000001</c:v>
                </c:pt>
                <c:pt idx="728">
                  <c:v>0.14779999999999999</c:v>
                </c:pt>
                <c:pt idx="729">
                  <c:v>0.1346</c:v>
                </c:pt>
                <c:pt idx="730">
                  <c:v>0.13769999999999999</c:v>
                </c:pt>
                <c:pt idx="731">
                  <c:v>0.1321</c:v>
                </c:pt>
                <c:pt idx="732">
                  <c:v>0.11700000000000001</c:v>
                </c:pt>
                <c:pt idx="733">
                  <c:v>0.1143</c:v>
                </c:pt>
                <c:pt idx="734">
                  <c:v>0.11840000000000001</c:v>
                </c:pt>
                <c:pt idx="735">
                  <c:v>0.1119</c:v>
                </c:pt>
                <c:pt idx="736">
                  <c:v>0.1013</c:v>
                </c:pt>
                <c:pt idx="737">
                  <c:v>0.10879999999999999</c:v>
                </c:pt>
                <c:pt idx="738">
                  <c:v>0.11559999999999999</c:v>
                </c:pt>
                <c:pt idx="739">
                  <c:v>0.10489999999999999</c:v>
                </c:pt>
                <c:pt idx="740">
                  <c:v>0.1033</c:v>
                </c:pt>
                <c:pt idx="741">
                  <c:v>0.11840000000000001</c:v>
                </c:pt>
                <c:pt idx="742">
                  <c:v>0.12509999999999999</c:v>
                </c:pt>
                <c:pt idx="743">
                  <c:v>0.1129</c:v>
                </c:pt>
                <c:pt idx="744">
                  <c:v>0.11550000000000001</c:v>
                </c:pt>
                <c:pt idx="745">
                  <c:v>0.13089999999999999</c:v>
                </c:pt>
                <c:pt idx="746">
                  <c:v>0.13500000000000001</c:v>
                </c:pt>
                <c:pt idx="747">
                  <c:v>0.1295</c:v>
                </c:pt>
                <c:pt idx="748">
                  <c:v>0.1386</c:v>
                </c:pt>
                <c:pt idx="749">
                  <c:v>0.15190000000000001</c:v>
                </c:pt>
                <c:pt idx="750">
                  <c:v>0.154</c:v>
                </c:pt>
                <c:pt idx="751">
                  <c:v>0.16059999999999999</c:v>
                </c:pt>
                <c:pt idx="752">
                  <c:v>0.17330000000000001</c:v>
                </c:pt>
                <c:pt idx="753">
                  <c:v>0.1671</c:v>
                </c:pt>
                <c:pt idx="754">
                  <c:v>0.17169999999999999</c:v>
                </c:pt>
                <c:pt idx="755">
                  <c:v>0.17460000000000001</c:v>
                </c:pt>
                <c:pt idx="756">
                  <c:v>0.16650000000000001</c:v>
                </c:pt>
                <c:pt idx="757">
                  <c:v>0.14960000000000001</c:v>
                </c:pt>
                <c:pt idx="758">
                  <c:v>0.1376</c:v>
                </c:pt>
                <c:pt idx="759">
                  <c:v>0.1416</c:v>
                </c:pt>
                <c:pt idx="760">
                  <c:v>0.14080000000000001</c:v>
                </c:pt>
                <c:pt idx="761">
                  <c:v>0.12280000000000001</c:v>
                </c:pt>
                <c:pt idx="762">
                  <c:v>0.1201</c:v>
                </c:pt>
                <c:pt idx="763">
                  <c:v>0.1338</c:v>
                </c:pt>
                <c:pt idx="764">
                  <c:v>0.12970000000000001</c:v>
                </c:pt>
                <c:pt idx="765">
                  <c:v>0.1134</c:v>
                </c:pt>
                <c:pt idx="766">
                  <c:v>0.12759999999999999</c:v>
                </c:pt>
                <c:pt idx="767">
                  <c:v>0.14119999999999999</c:v>
                </c:pt>
                <c:pt idx="768">
                  <c:v>0.12559999999999999</c:v>
                </c:pt>
                <c:pt idx="769">
                  <c:v>0.1198</c:v>
                </c:pt>
                <c:pt idx="770">
                  <c:v>0.14410000000000001</c:v>
                </c:pt>
                <c:pt idx="771">
                  <c:v>0.151</c:v>
                </c:pt>
                <c:pt idx="772">
                  <c:v>0.13639999999999999</c:v>
                </c:pt>
                <c:pt idx="773">
                  <c:v>0.12770000000000001</c:v>
                </c:pt>
                <c:pt idx="774">
                  <c:v>0.13159999999999999</c:v>
                </c:pt>
                <c:pt idx="775">
                  <c:v>0.12509999999999999</c:v>
                </c:pt>
                <c:pt idx="776">
                  <c:v>0.10879999999999999</c:v>
                </c:pt>
                <c:pt idx="777">
                  <c:v>0.1144</c:v>
                </c:pt>
                <c:pt idx="778">
                  <c:v>0.1118</c:v>
                </c:pt>
                <c:pt idx="779">
                  <c:v>0.1027</c:v>
                </c:pt>
                <c:pt idx="780">
                  <c:v>9.3700000000000006E-2</c:v>
                </c:pt>
                <c:pt idx="781">
                  <c:v>9.4E-2</c:v>
                </c:pt>
                <c:pt idx="782">
                  <c:v>9.5799999999999996E-2</c:v>
                </c:pt>
                <c:pt idx="783">
                  <c:v>0.1036</c:v>
                </c:pt>
                <c:pt idx="784">
                  <c:v>0.10290000000000001</c:v>
                </c:pt>
                <c:pt idx="785">
                  <c:v>0.1036</c:v>
                </c:pt>
                <c:pt idx="786">
                  <c:v>0.1135</c:v>
                </c:pt>
                <c:pt idx="787">
                  <c:v>0.11849999999999999</c:v>
                </c:pt>
                <c:pt idx="788">
                  <c:v>0.1176</c:v>
                </c:pt>
                <c:pt idx="789">
                  <c:v>0.12570000000000001</c:v>
                </c:pt>
                <c:pt idx="790">
                  <c:v>0.13789999999999999</c:v>
                </c:pt>
                <c:pt idx="791">
                  <c:v>0.14149999999999999</c:v>
                </c:pt>
                <c:pt idx="792">
                  <c:v>0.14499999999999999</c:v>
                </c:pt>
                <c:pt idx="793">
                  <c:v>0.15859999999999999</c:v>
                </c:pt>
                <c:pt idx="794">
                  <c:v>0.1724</c:v>
                </c:pt>
                <c:pt idx="795">
                  <c:v>0.1822</c:v>
                </c:pt>
                <c:pt idx="796">
                  <c:v>0.18609999999999999</c:v>
                </c:pt>
                <c:pt idx="797">
                  <c:v>0.20080000000000001</c:v>
                </c:pt>
                <c:pt idx="798">
                  <c:v>0.19270000000000001</c:v>
                </c:pt>
                <c:pt idx="799">
                  <c:v>0.2044</c:v>
                </c:pt>
                <c:pt idx="800">
                  <c:v>0.1862</c:v>
                </c:pt>
                <c:pt idx="801">
                  <c:v>0.18329999999999999</c:v>
                </c:pt>
                <c:pt idx="802">
                  <c:v>0.16289999999999999</c:v>
                </c:pt>
                <c:pt idx="803">
                  <c:v>0.17560000000000001</c:v>
                </c:pt>
                <c:pt idx="804">
                  <c:v>0.17130000000000001</c:v>
                </c:pt>
                <c:pt idx="805">
                  <c:v>0.14360000000000001</c:v>
                </c:pt>
                <c:pt idx="806">
                  <c:v>0.1449</c:v>
                </c:pt>
                <c:pt idx="807">
                  <c:v>0.15939999999999999</c:v>
                </c:pt>
                <c:pt idx="808">
                  <c:v>0.14549999999999999</c:v>
                </c:pt>
                <c:pt idx="809">
                  <c:v>0.13020000000000001</c:v>
                </c:pt>
                <c:pt idx="810">
                  <c:v>0.14319999999999999</c:v>
                </c:pt>
                <c:pt idx="811">
                  <c:v>0.1484</c:v>
                </c:pt>
                <c:pt idx="812">
                  <c:v>0.1358</c:v>
                </c:pt>
                <c:pt idx="813">
                  <c:v>0.1323</c:v>
                </c:pt>
                <c:pt idx="814">
                  <c:v>0.12889999999999999</c:v>
                </c:pt>
                <c:pt idx="815">
                  <c:v>0.1212</c:v>
                </c:pt>
                <c:pt idx="816">
                  <c:v>0.14680000000000001</c:v>
                </c:pt>
                <c:pt idx="817">
                  <c:v>0.15679999999999999</c:v>
                </c:pt>
                <c:pt idx="818">
                  <c:v>0.15210000000000001</c:v>
                </c:pt>
                <c:pt idx="819">
                  <c:v>0.13450000000000001</c:v>
                </c:pt>
                <c:pt idx="820">
                  <c:v>0.14349999999999999</c:v>
                </c:pt>
                <c:pt idx="821">
                  <c:v>0.16450000000000001</c:v>
                </c:pt>
                <c:pt idx="822">
                  <c:v>0.1696</c:v>
                </c:pt>
                <c:pt idx="823">
                  <c:v>0.1661</c:v>
                </c:pt>
                <c:pt idx="824">
                  <c:v>0.1908</c:v>
                </c:pt>
                <c:pt idx="825">
                  <c:v>0.15590000000000001</c:v>
                </c:pt>
                <c:pt idx="826">
                  <c:v>0.19750000000000001</c:v>
                </c:pt>
                <c:pt idx="827">
                  <c:v>0.31359999999999999</c:v>
                </c:pt>
                <c:pt idx="828">
                  <c:v>0.35170000000000001</c:v>
                </c:pt>
                <c:pt idx="829">
                  <c:v>0.32040000000000002</c:v>
                </c:pt>
                <c:pt idx="830">
                  <c:v>0.35049999999999998</c:v>
                </c:pt>
                <c:pt idx="831">
                  <c:v>0.45810000000000001</c:v>
                </c:pt>
                <c:pt idx="832">
                  <c:v>0.47820000000000001</c:v>
                </c:pt>
                <c:pt idx="833">
                  <c:v>0.46629999999999999</c:v>
                </c:pt>
                <c:pt idx="834">
                  <c:v>0.5272</c:v>
                </c:pt>
                <c:pt idx="835">
                  <c:v>0.43740000000000001</c:v>
                </c:pt>
                <c:pt idx="836">
                  <c:v>0.50280000000000002</c:v>
                </c:pt>
                <c:pt idx="837">
                  <c:v>0.47870000000000001</c:v>
                </c:pt>
                <c:pt idx="838">
                  <c:v>0.40560000000000002</c:v>
                </c:pt>
                <c:pt idx="839">
                  <c:v>0.28820000000000001</c:v>
                </c:pt>
                <c:pt idx="840">
                  <c:v>0.19020000000000001</c:v>
                </c:pt>
                <c:pt idx="841">
                  <c:v>0.16109999999999999</c:v>
                </c:pt>
                <c:pt idx="842">
                  <c:v>0.1532</c:v>
                </c:pt>
                <c:pt idx="843">
                  <c:v>0.13950000000000001</c:v>
                </c:pt>
                <c:pt idx="844">
                  <c:v>0.15770000000000001</c:v>
                </c:pt>
                <c:pt idx="845">
                  <c:v>0.16389999999999999</c:v>
                </c:pt>
                <c:pt idx="846">
                  <c:v>0.14280000000000001</c:v>
                </c:pt>
                <c:pt idx="847">
                  <c:v>0.14149999999999999</c:v>
                </c:pt>
                <c:pt idx="848">
                  <c:v>0.16550000000000001</c:v>
                </c:pt>
                <c:pt idx="849">
                  <c:v>0.17100000000000001</c:v>
                </c:pt>
                <c:pt idx="850">
                  <c:v>0.15279999999999999</c:v>
                </c:pt>
                <c:pt idx="851">
                  <c:v>0.13780000000000001</c:v>
                </c:pt>
                <c:pt idx="852">
                  <c:v>0.15570000000000001</c:v>
                </c:pt>
                <c:pt idx="853">
                  <c:v>0.1729</c:v>
                </c:pt>
                <c:pt idx="854">
                  <c:v>0.15840000000000001</c:v>
                </c:pt>
                <c:pt idx="855">
                  <c:v>0.151</c:v>
                </c:pt>
                <c:pt idx="856">
                  <c:v>0.1807</c:v>
                </c:pt>
                <c:pt idx="857">
                  <c:v>0.188</c:v>
                </c:pt>
                <c:pt idx="858">
                  <c:v>0.16450000000000001</c:v>
                </c:pt>
                <c:pt idx="859">
                  <c:v>0.16539999999999999</c:v>
                </c:pt>
                <c:pt idx="860">
                  <c:v>0.1958</c:v>
                </c:pt>
                <c:pt idx="861">
                  <c:v>0.19259999999999999</c:v>
                </c:pt>
                <c:pt idx="862">
                  <c:v>0.1739</c:v>
                </c:pt>
                <c:pt idx="863">
                  <c:v>0.188</c:v>
                </c:pt>
                <c:pt idx="864">
                  <c:v>0.18990000000000001</c:v>
                </c:pt>
                <c:pt idx="865">
                  <c:v>0.18740000000000001</c:v>
                </c:pt>
                <c:pt idx="866">
                  <c:v>0.2452</c:v>
                </c:pt>
                <c:pt idx="867">
                  <c:v>0.28889999999999999</c:v>
                </c:pt>
                <c:pt idx="868">
                  <c:v>0.33929999999999999</c:v>
                </c:pt>
                <c:pt idx="869">
                  <c:v>0.4279</c:v>
                </c:pt>
                <c:pt idx="870">
                  <c:v>0.44280000000000003</c:v>
                </c:pt>
                <c:pt idx="871">
                  <c:v>0.4819</c:v>
                </c:pt>
                <c:pt idx="872">
                  <c:v>0.54869999999999997</c:v>
                </c:pt>
                <c:pt idx="873">
                  <c:v>0.66520000000000001</c:v>
                </c:pt>
                <c:pt idx="874">
                  <c:v>0.74739999999999995</c:v>
                </c:pt>
                <c:pt idx="875">
                  <c:v>0.79349999999999998</c:v>
                </c:pt>
                <c:pt idx="876">
                  <c:v>0.8851</c:v>
                </c:pt>
                <c:pt idx="877">
                  <c:v>0.85029999999999994</c:v>
                </c:pt>
                <c:pt idx="878">
                  <c:v>0.98470000000000002</c:v>
                </c:pt>
                <c:pt idx="879">
                  <c:v>1.0325</c:v>
                </c:pt>
                <c:pt idx="880">
                  <c:v>0.93959999999999999</c:v>
                </c:pt>
                <c:pt idx="881">
                  <c:v>0.98960000000000004</c:v>
                </c:pt>
                <c:pt idx="882">
                  <c:v>0.91020000000000001</c:v>
                </c:pt>
                <c:pt idx="883">
                  <c:v>0.82150000000000001</c:v>
                </c:pt>
                <c:pt idx="884">
                  <c:v>0.70220000000000005</c:v>
                </c:pt>
                <c:pt idx="885">
                  <c:v>0.53400000000000003</c:v>
                </c:pt>
                <c:pt idx="886">
                  <c:v>0.38419999999999999</c:v>
                </c:pt>
                <c:pt idx="887">
                  <c:v>0.28120000000000001</c:v>
                </c:pt>
                <c:pt idx="888">
                  <c:v>0.21410000000000001</c:v>
                </c:pt>
                <c:pt idx="889">
                  <c:v>0.21190000000000001</c:v>
                </c:pt>
                <c:pt idx="890">
                  <c:v>0.16930000000000001</c:v>
                </c:pt>
                <c:pt idx="891">
                  <c:v>0.1701</c:v>
                </c:pt>
                <c:pt idx="892">
                  <c:v>0.1963</c:v>
                </c:pt>
                <c:pt idx="893">
                  <c:v>0.16850000000000001</c:v>
                </c:pt>
                <c:pt idx="894">
                  <c:v>0.19359999999999999</c:v>
                </c:pt>
                <c:pt idx="895">
                  <c:v>0.1804</c:v>
                </c:pt>
                <c:pt idx="896">
                  <c:v>0.20949999999999999</c:v>
                </c:pt>
                <c:pt idx="897">
                  <c:v>0.2155</c:v>
                </c:pt>
                <c:pt idx="898">
                  <c:v>0.2661</c:v>
                </c:pt>
                <c:pt idx="899">
                  <c:v>0.31530000000000002</c:v>
                </c:pt>
                <c:pt idx="900">
                  <c:v>0.41539999999999999</c:v>
                </c:pt>
                <c:pt idx="901">
                  <c:v>0.44019999999999998</c:v>
                </c:pt>
                <c:pt idx="902">
                  <c:v>0.56859999999999999</c:v>
                </c:pt>
                <c:pt idx="903">
                  <c:v>0.69699999999999995</c:v>
                </c:pt>
                <c:pt idx="904">
                  <c:v>0.76</c:v>
                </c:pt>
                <c:pt idx="905">
                  <c:v>0.63780000000000003</c:v>
                </c:pt>
                <c:pt idx="906">
                  <c:v>0.60309999999999997</c:v>
                </c:pt>
                <c:pt idx="907">
                  <c:v>0.48349999999999999</c:v>
                </c:pt>
                <c:pt idx="908">
                  <c:v>0.37869999999999998</c:v>
                </c:pt>
                <c:pt idx="909">
                  <c:v>0.28420000000000001</c:v>
                </c:pt>
                <c:pt idx="910">
                  <c:v>0.27150000000000002</c:v>
                </c:pt>
                <c:pt idx="911">
                  <c:v>0.3352</c:v>
                </c:pt>
                <c:pt idx="912">
                  <c:v>0.44319999999999998</c:v>
                </c:pt>
                <c:pt idx="913">
                  <c:v>0.5181</c:v>
                </c:pt>
                <c:pt idx="914">
                  <c:v>0.70020000000000004</c:v>
                </c:pt>
                <c:pt idx="915">
                  <c:v>0.80549999999999999</c:v>
                </c:pt>
                <c:pt idx="916">
                  <c:v>0.73619999999999997</c:v>
                </c:pt>
                <c:pt idx="917">
                  <c:v>0.73129999999999995</c:v>
                </c:pt>
                <c:pt idx="918">
                  <c:v>0.85140000000000005</c:v>
                </c:pt>
                <c:pt idx="919">
                  <c:v>1.0033000000000001</c:v>
                </c:pt>
                <c:pt idx="920">
                  <c:v>1.0164</c:v>
                </c:pt>
                <c:pt idx="921">
                  <c:v>1.0693999999999999</c:v>
                </c:pt>
                <c:pt idx="922">
                  <c:v>1.1778</c:v>
                </c:pt>
                <c:pt idx="923">
                  <c:v>1.2334000000000001</c:v>
                </c:pt>
                <c:pt idx="924">
                  <c:v>1.2716000000000001</c:v>
                </c:pt>
                <c:pt idx="925">
                  <c:v>1.2857000000000001</c:v>
                </c:pt>
                <c:pt idx="926">
                  <c:v>1.1508</c:v>
                </c:pt>
                <c:pt idx="927">
                  <c:v>0.99550000000000005</c:v>
                </c:pt>
                <c:pt idx="928">
                  <c:v>0.91539999999999999</c:v>
                </c:pt>
                <c:pt idx="929">
                  <c:v>0.76629999999999998</c:v>
                </c:pt>
                <c:pt idx="930">
                  <c:v>0.72260000000000002</c:v>
                </c:pt>
                <c:pt idx="931">
                  <c:v>0.63539999999999996</c:v>
                </c:pt>
                <c:pt idx="932">
                  <c:v>0.61829999999999996</c:v>
                </c:pt>
                <c:pt idx="933">
                  <c:v>0.63770000000000004</c:v>
                </c:pt>
                <c:pt idx="934">
                  <c:v>0.59489999999999998</c:v>
                </c:pt>
                <c:pt idx="935">
                  <c:v>0.58460000000000001</c:v>
                </c:pt>
                <c:pt idx="936">
                  <c:v>0.60119999999999996</c:v>
                </c:pt>
                <c:pt idx="937">
                  <c:v>0.71140000000000003</c:v>
                </c:pt>
                <c:pt idx="938">
                  <c:v>0.79239999999999999</c:v>
                </c:pt>
                <c:pt idx="939">
                  <c:v>0.85089999999999999</c:v>
                </c:pt>
                <c:pt idx="940">
                  <c:v>0.80620000000000003</c:v>
                </c:pt>
                <c:pt idx="941">
                  <c:v>0.80720000000000003</c:v>
                </c:pt>
                <c:pt idx="942">
                  <c:v>0.72560000000000002</c:v>
                </c:pt>
                <c:pt idx="943">
                  <c:v>0.75939999999999996</c:v>
                </c:pt>
                <c:pt idx="944">
                  <c:v>0.74429999999999996</c:v>
                </c:pt>
                <c:pt idx="945">
                  <c:v>0.62590000000000001</c:v>
                </c:pt>
                <c:pt idx="946">
                  <c:v>0.59330000000000005</c:v>
                </c:pt>
                <c:pt idx="947">
                  <c:v>0.65500000000000003</c:v>
                </c:pt>
                <c:pt idx="948">
                  <c:v>0.5837</c:v>
                </c:pt>
                <c:pt idx="949">
                  <c:v>0.4884</c:v>
                </c:pt>
                <c:pt idx="950">
                  <c:v>0.55569999999999997</c:v>
                </c:pt>
                <c:pt idx="951">
                  <c:v>0.59199999999999997</c:v>
                </c:pt>
                <c:pt idx="952">
                  <c:v>0.49680000000000002</c:v>
                </c:pt>
                <c:pt idx="953">
                  <c:v>0.50329999999999997</c:v>
                </c:pt>
                <c:pt idx="954">
                  <c:v>0.60470000000000002</c:v>
                </c:pt>
                <c:pt idx="955">
                  <c:v>0.58109999999999995</c:v>
                </c:pt>
                <c:pt idx="956">
                  <c:v>0.55059999999999998</c:v>
                </c:pt>
                <c:pt idx="957">
                  <c:v>0.66169999999999995</c:v>
                </c:pt>
                <c:pt idx="958">
                  <c:v>0.74260000000000004</c:v>
                </c:pt>
                <c:pt idx="959">
                  <c:v>0.83840000000000003</c:v>
                </c:pt>
                <c:pt idx="960">
                  <c:v>0.80569999999999997</c:v>
                </c:pt>
                <c:pt idx="961">
                  <c:v>0.89700000000000002</c:v>
                </c:pt>
                <c:pt idx="962">
                  <c:v>0.88600000000000001</c:v>
                </c:pt>
                <c:pt idx="963">
                  <c:v>0.78520000000000001</c:v>
                </c:pt>
                <c:pt idx="964">
                  <c:v>0.61309999999999998</c:v>
                </c:pt>
                <c:pt idx="965">
                  <c:v>0.63480000000000003</c:v>
                </c:pt>
                <c:pt idx="966">
                  <c:v>0.5776</c:v>
                </c:pt>
                <c:pt idx="967">
                  <c:v>0.67359999999999998</c:v>
                </c:pt>
                <c:pt idx="968">
                  <c:v>0.63419999999999999</c:v>
                </c:pt>
                <c:pt idx="969">
                  <c:v>0.62080000000000002</c:v>
                </c:pt>
                <c:pt idx="970">
                  <c:v>0.7177</c:v>
                </c:pt>
                <c:pt idx="971">
                  <c:v>0.70020000000000004</c:v>
                </c:pt>
                <c:pt idx="972">
                  <c:v>0.62980000000000003</c:v>
                </c:pt>
                <c:pt idx="973">
                  <c:v>0.52259999999999995</c:v>
                </c:pt>
                <c:pt idx="974">
                  <c:v>0.49440000000000001</c:v>
                </c:pt>
                <c:pt idx="975">
                  <c:v>0.50329999999999997</c:v>
                </c:pt>
                <c:pt idx="976">
                  <c:v>0.50090000000000001</c:v>
                </c:pt>
                <c:pt idx="977">
                  <c:v>0.46929999999999999</c:v>
                </c:pt>
                <c:pt idx="978">
                  <c:v>0.48559999999999998</c:v>
                </c:pt>
                <c:pt idx="979">
                  <c:v>0.55400000000000005</c:v>
                </c:pt>
                <c:pt idx="980">
                  <c:v>0.56200000000000006</c:v>
                </c:pt>
                <c:pt idx="981">
                  <c:v>0.58140000000000003</c:v>
                </c:pt>
                <c:pt idx="982">
                  <c:v>0.65790000000000004</c:v>
                </c:pt>
                <c:pt idx="983">
                  <c:v>0.7288</c:v>
                </c:pt>
                <c:pt idx="984">
                  <c:v>0.75870000000000004</c:v>
                </c:pt>
                <c:pt idx="985">
                  <c:v>0.82850000000000001</c:v>
                </c:pt>
                <c:pt idx="986">
                  <c:v>0.91869999999999996</c:v>
                </c:pt>
                <c:pt idx="987">
                  <c:v>0.97819999999999996</c:v>
                </c:pt>
                <c:pt idx="988">
                  <c:v>1.0406</c:v>
                </c:pt>
                <c:pt idx="989">
                  <c:v>1.0813999999999999</c:v>
                </c:pt>
                <c:pt idx="990">
                  <c:v>1.2145999999999999</c:v>
                </c:pt>
                <c:pt idx="991">
                  <c:v>1.3031999999999999</c:v>
                </c:pt>
                <c:pt idx="992">
                  <c:v>1.4158999999999999</c:v>
                </c:pt>
                <c:pt idx="993">
                  <c:v>1.5299</c:v>
                </c:pt>
                <c:pt idx="994">
                  <c:v>1.6238999999999999</c:v>
                </c:pt>
                <c:pt idx="995">
                  <c:v>1.732</c:v>
                </c:pt>
                <c:pt idx="996">
                  <c:v>1.8116000000000001</c:v>
                </c:pt>
                <c:pt idx="997">
                  <c:v>1.9970000000000001</c:v>
                </c:pt>
                <c:pt idx="998">
                  <c:v>2.0954999999999999</c:v>
                </c:pt>
                <c:pt idx="999">
                  <c:v>1.9975000000000001</c:v>
                </c:pt>
                <c:pt idx="1000">
                  <c:v>1.9891000000000001</c:v>
                </c:pt>
                <c:pt idx="1001">
                  <c:v>2.0512000000000001</c:v>
                </c:pt>
                <c:pt idx="1002">
                  <c:v>2.1215000000000002</c:v>
                </c:pt>
                <c:pt idx="1003">
                  <c:v>2.1897000000000002</c:v>
                </c:pt>
                <c:pt idx="1004">
                  <c:v>2.2951000000000001</c:v>
                </c:pt>
                <c:pt idx="1005">
                  <c:v>2.2572999999999999</c:v>
                </c:pt>
                <c:pt idx="1006">
                  <c:v>2.4058999999999999</c:v>
                </c:pt>
                <c:pt idx="1007">
                  <c:v>2.5261999999999998</c:v>
                </c:pt>
                <c:pt idx="1008">
                  <c:v>2.4805000000000001</c:v>
                </c:pt>
                <c:pt idx="1009">
                  <c:v>2.5985</c:v>
                </c:pt>
                <c:pt idx="1010">
                  <c:v>2.7696999999999998</c:v>
                </c:pt>
                <c:pt idx="1011">
                  <c:v>2.9186999999999999</c:v>
                </c:pt>
                <c:pt idx="1012">
                  <c:v>3.0514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B0A-42E6-B07E-7FDA21594A85}"/>
            </c:ext>
          </c:extLst>
        </c:ser>
        <c:ser>
          <c:idx val="5"/>
          <c:order val="5"/>
          <c:tx>
            <c:strRef>
              <c:f>Sheet3!$G$3</c:f>
              <c:strCache>
                <c:ptCount val="1"/>
                <c:pt idx="0">
                  <c:v>Series5</c:v>
                </c:pt>
              </c:strCache>
            </c:strRef>
          </c:tx>
          <c:spPr>
            <a:ln w="12700" cap="rnd">
              <a:solidFill>
                <a:srgbClr val="FF9933"/>
              </a:solidFill>
              <a:round/>
            </a:ln>
            <a:effectLst/>
          </c:spPr>
          <c:marker>
            <c:symbol val="none"/>
          </c:marker>
          <c:val>
            <c:numRef>
              <c:f>Sheet3!$G$4:$G$1016</c:f>
              <c:numCache>
                <c:formatCode>General</c:formatCode>
                <c:ptCount val="1013"/>
                <c:pt idx="0">
                  <c:v>2.5135999999999998</c:v>
                </c:pt>
                <c:pt idx="1">
                  <c:v>2.4192</c:v>
                </c:pt>
                <c:pt idx="2">
                  <c:v>2.2418999999999998</c:v>
                </c:pt>
                <c:pt idx="3">
                  <c:v>2.1053999999999999</c:v>
                </c:pt>
                <c:pt idx="4">
                  <c:v>1.8462000000000001</c:v>
                </c:pt>
                <c:pt idx="5">
                  <c:v>1.6832</c:v>
                </c:pt>
                <c:pt idx="6">
                  <c:v>1.5325</c:v>
                </c:pt>
                <c:pt idx="7">
                  <c:v>1.3030999999999999</c:v>
                </c:pt>
                <c:pt idx="8">
                  <c:v>1.0998000000000001</c:v>
                </c:pt>
                <c:pt idx="9">
                  <c:v>0.96199999999999997</c:v>
                </c:pt>
                <c:pt idx="10">
                  <c:v>0.75619999999999998</c:v>
                </c:pt>
                <c:pt idx="11">
                  <c:v>0.58340000000000003</c:v>
                </c:pt>
                <c:pt idx="12">
                  <c:v>0.5786</c:v>
                </c:pt>
                <c:pt idx="13">
                  <c:v>0.56559999999999999</c:v>
                </c:pt>
                <c:pt idx="14">
                  <c:v>0.51239999999999997</c:v>
                </c:pt>
                <c:pt idx="15">
                  <c:v>0.49030000000000001</c:v>
                </c:pt>
                <c:pt idx="16">
                  <c:v>0.52280000000000004</c:v>
                </c:pt>
                <c:pt idx="17">
                  <c:v>0.49769999999999998</c:v>
                </c:pt>
                <c:pt idx="18">
                  <c:v>0.43419999999999997</c:v>
                </c:pt>
                <c:pt idx="19">
                  <c:v>0.44529999999999997</c:v>
                </c:pt>
                <c:pt idx="20">
                  <c:v>0.46529999999999999</c:v>
                </c:pt>
                <c:pt idx="21">
                  <c:v>0.41599999999999998</c:v>
                </c:pt>
                <c:pt idx="22">
                  <c:v>0.37409999999999999</c:v>
                </c:pt>
                <c:pt idx="23">
                  <c:v>0.40920000000000001</c:v>
                </c:pt>
                <c:pt idx="24">
                  <c:v>0.40570000000000001</c:v>
                </c:pt>
                <c:pt idx="25">
                  <c:v>0.34060000000000001</c:v>
                </c:pt>
                <c:pt idx="26">
                  <c:v>0.34079999999999999</c:v>
                </c:pt>
                <c:pt idx="27">
                  <c:v>0.38100000000000001</c:v>
                </c:pt>
                <c:pt idx="28">
                  <c:v>0.37659999999999999</c:v>
                </c:pt>
                <c:pt idx="29">
                  <c:v>0.31919999999999998</c:v>
                </c:pt>
                <c:pt idx="30">
                  <c:v>0.28199999999999997</c:v>
                </c:pt>
                <c:pt idx="31">
                  <c:v>0.32700000000000001</c:v>
                </c:pt>
                <c:pt idx="32">
                  <c:v>0.33839999999999998</c:v>
                </c:pt>
                <c:pt idx="33">
                  <c:v>0.3972</c:v>
                </c:pt>
                <c:pt idx="34">
                  <c:v>0.44409999999999999</c:v>
                </c:pt>
                <c:pt idx="35">
                  <c:v>0.43769999999999998</c:v>
                </c:pt>
                <c:pt idx="36">
                  <c:v>0.37409999999999999</c:v>
                </c:pt>
                <c:pt idx="37">
                  <c:v>0.39250000000000002</c:v>
                </c:pt>
                <c:pt idx="38">
                  <c:v>0.43569999999999998</c:v>
                </c:pt>
                <c:pt idx="39">
                  <c:v>0.39560000000000001</c:v>
                </c:pt>
                <c:pt idx="40">
                  <c:v>0.3604</c:v>
                </c:pt>
                <c:pt idx="41">
                  <c:v>0.4118</c:v>
                </c:pt>
                <c:pt idx="42">
                  <c:v>0.42720000000000002</c:v>
                </c:pt>
                <c:pt idx="43">
                  <c:v>0.37619999999999998</c:v>
                </c:pt>
                <c:pt idx="44">
                  <c:v>0.38030000000000003</c:v>
                </c:pt>
                <c:pt idx="45">
                  <c:v>0.42830000000000001</c:v>
                </c:pt>
                <c:pt idx="46">
                  <c:v>0.40660000000000002</c:v>
                </c:pt>
                <c:pt idx="47">
                  <c:v>0.36130000000000001</c:v>
                </c:pt>
                <c:pt idx="48">
                  <c:v>0.40310000000000001</c:v>
                </c:pt>
                <c:pt idx="49">
                  <c:v>0.40910000000000002</c:v>
                </c:pt>
                <c:pt idx="50">
                  <c:v>0.35020000000000001</c:v>
                </c:pt>
                <c:pt idx="51">
                  <c:v>0.34329999999999999</c:v>
                </c:pt>
                <c:pt idx="52">
                  <c:v>0.38590000000000002</c:v>
                </c:pt>
                <c:pt idx="53">
                  <c:v>0.3624</c:v>
                </c:pt>
                <c:pt idx="54">
                  <c:v>0.31390000000000001</c:v>
                </c:pt>
                <c:pt idx="55">
                  <c:v>0.34029999999999999</c:v>
                </c:pt>
                <c:pt idx="56">
                  <c:v>0.33750000000000002</c:v>
                </c:pt>
                <c:pt idx="57">
                  <c:v>0.28089999999999998</c:v>
                </c:pt>
                <c:pt idx="58">
                  <c:v>0.25280000000000002</c:v>
                </c:pt>
                <c:pt idx="59">
                  <c:v>0.26169999999999999</c:v>
                </c:pt>
                <c:pt idx="60">
                  <c:v>0.31580000000000003</c:v>
                </c:pt>
                <c:pt idx="61">
                  <c:v>0.35189999999999999</c:v>
                </c:pt>
                <c:pt idx="62">
                  <c:v>0.37319999999999998</c:v>
                </c:pt>
                <c:pt idx="63">
                  <c:v>0.379</c:v>
                </c:pt>
                <c:pt idx="64">
                  <c:v>0.37409999999999999</c:v>
                </c:pt>
                <c:pt idx="65">
                  <c:v>0.31590000000000001</c:v>
                </c:pt>
                <c:pt idx="66">
                  <c:v>0.3029</c:v>
                </c:pt>
                <c:pt idx="67">
                  <c:v>0.32479999999999998</c:v>
                </c:pt>
                <c:pt idx="68">
                  <c:v>0.28449999999999998</c:v>
                </c:pt>
                <c:pt idx="69">
                  <c:v>0.24329999999999999</c:v>
                </c:pt>
                <c:pt idx="70">
                  <c:v>0.26989999999999997</c:v>
                </c:pt>
                <c:pt idx="71">
                  <c:v>0.28670000000000001</c:v>
                </c:pt>
                <c:pt idx="72">
                  <c:v>0.23430000000000001</c:v>
                </c:pt>
                <c:pt idx="73">
                  <c:v>0.22589999999999999</c:v>
                </c:pt>
                <c:pt idx="74">
                  <c:v>0.27600000000000002</c:v>
                </c:pt>
                <c:pt idx="75">
                  <c:v>0.26550000000000001</c:v>
                </c:pt>
                <c:pt idx="76">
                  <c:v>0.2195</c:v>
                </c:pt>
                <c:pt idx="77">
                  <c:v>0.25209999999999999</c:v>
                </c:pt>
                <c:pt idx="78">
                  <c:v>0.29649999999999999</c:v>
                </c:pt>
                <c:pt idx="79">
                  <c:v>0.26550000000000001</c:v>
                </c:pt>
                <c:pt idx="80">
                  <c:v>0.25719999999999998</c:v>
                </c:pt>
                <c:pt idx="81">
                  <c:v>0.30580000000000002</c:v>
                </c:pt>
                <c:pt idx="82">
                  <c:v>0.35160000000000002</c:v>
                </c:pt>
                <c:pt idx="83">
                  <c:v>0.37640000000000001</c:v>
                </c:pt>
                <c:pt idx="84">
                  <c:v>0.35370000000000001</c:v>
                </c:pt>
                <c:pt idx="85">
                  <c:v>0.4597</c:v>
                </c:pt>
                <c:pt idx="86">
                  <c:v>0.54079999999999995</c:v>
                </c:pt>
                <c:pt idx="87">
                  <c:v>0.65680000000000005</c:v>
                </c:pt>
                <c:pt idx="88">
                  <c:v>0.79810000000000003</c:v>
                </c:pt>
                <c:pt idx="89">
                  <c:v>0.87190000000000001</c:v>
                </c:pt>
                <c:pt idx="90">
                  <c:v>0.82599999999999996</c:v>
                </c:pt>
                <c:pt idx="91">
                  <c:v>0.70630000000000004</c:v>
                </c:pt>
                <c:pt idx="92">
                  <c:v>0.66539999999999999</c:v>
                </c:pt>
                <c:pt idx="93">
                  <c:v>0.59699999999999998</c:v>
                </c:pt>
                <c:pt idx="94">
                  <c:v>0.47520000000000001</c:v>
                </c:pt>
                <c:pt idx="95">
                  <c:v>0.47289999999999999</c:v>
                </c:pt>
                <c:pt idx="96">
                  <c:v>0.33389999999999997</c:v>
                </c:pt>
                <c:pt idx="97">
                  <c:v>0.2707</c:v>
                </c:pt>
                <c:pt idx="98">
                  <c:v>0.24529999999999999</c:v>
                </c:pt>
                <c:pt idx="99">
                  <c:v>0.1888</c:v>
                </c:pt>
                <c:pt idx="100">
                  <c:v>0.16070000000000001</c:v>
                </c:pt>
                <c:pt idx="101">
                  <c:v>0.15459999999999999</c:v>
                </c:pt>
                <c:pt idx="102">
                  <c:v>0.19339999999999999</c:v>
                </c:pt>
                <c:pt idx="103">
                  <c:v>0.2084</c:v>
                </c:pt>
                <c:pt idx="104">
                  <c:v>0.1938</c:v>
                </c:pt>
                <c:pt idx="105">
                  <c:v>0.2175</c:v>
                </c:pt>
                <c:pt idx="106">
                  <c:v>0.25609999999999999</c:v>
                </c:pt>
                <c:pt idx="107">
                  <c:v>0.26700000000000002</c:v>
                </c:pt>
                <c:pt idx="108">
                  <c:v>0.25890000000000002</c:v>
                </c:pt>
                <c:pt idx="109">
                  <c:v>0.21540000000000001</c:v>
                </c:pt>
                <c:pt idx="110">
                  <c:v>0.18360000000000001</c:v>
                </c:pt>
                <c:pt idx="111">
                  <c:v>0.1424</c:v>
                </c:pt>
                <c:pt idx="112">
                  <c:v>0.15160000000000001</c:v>
                </c:pt>
                <c:pt idx="113">
                  <c:v>0.17660000000000001</c:v>
                </c:pt>
                <c:pt idx="114">
                  <c:v>0.16089999999999999</c:v>
                </c:pt>
                <c:pt idx="115">
                  <c:v>0.1356</c:v>
                </c:pt>
                <c:pt idx="116">
                  <c:v>0.1525</c:v>
                </c:pt>
                <c:pt idx="117">
                  <c:v>0.1704</c:v>
                </c:pt>
                <c:pt idx="118">
                  <c:v>0.16250000000000001</c:v>
                </c:pt>
                <c:pt idx="119">
                  <c:v>0.15959999999999999</c:v>
                </c:pt>
                <c:pt idx="120">
                  <c:v>0.1958</c:v>
                </c:pt>
                <c:pt idx="121">
                  <c:v>0.22040000000000001</c:v>
                </c:pt>
                <c:pt idx="122">
                  <c:v>0.20810000000000001</c:v>
                </c:pt>
                <c:pt idx="123">
                  <c:v>0.22339999999999999</c:v>
                </c:pt>
                <c:pt idx="124">
                  <c:v>0.2646</c:v>
                </c:pt>
                <c:pt idx="125">
                  <c:v>0.28199999999999997</c:v>
                </c:pt>
                <c:pt idx="126">
                  <c:v>0.27650000000000002</c:v>
                </c:pt>
                <c:pt idx="127">
                  <c:v>0.32390000000000002</c:v>
                </c:pt>
                <c:pt idx="128">
                  <c:v>0.3473</c:v>
                </c:pt>
                <c:pt idx="129">
                  <c:v>0.31869999999999998</c:v>
                </c:pt>
                <c:pt idx="130">
                  <c:v>0.34339999999999998</c:v>
                </c:pt>
                <c:pt idx="131">
                  <c:v>0.39550000000000002</c:v>
                </c:pt>
                <c:pt idx="132">
                  <c:v>0.39779999999999999</c:v>
                </c:pt>
                <c:pt idx="133">
                  <c:v>0.37240000000000001</c:v>
                </c:pt>
                <c:pt idx="134">
                  <c:v>0.3871</c:v>
                </c:pt>
                <c:pt idx="135">
                  <c:v>0.3795</c:v>
                </c:pt>
                <c:pt idx="136">
                  <c:v>0.3427</c:v>
                </c:pt>
                <c:pt idx="137">
                  <c:v>0.29730000000000001</c:v>
                </c:pt>
                <c:pt idx="138">
                  <c:v>0.25219999999999998</c:v>
                </c:pt>
                <c:pt idx="139">
                  <c:v>0.27250000000000002</c:v>
                </c:pt>
                <c:pt idx="140">
                  <c:v>0.27539999999999998</c:v>
                </c:pt>
                <c:pt idx="141">
                  <c:v>0.2273</c:v>
                </c:pt>
                <c:pt idx="142">
                  <c:v>0.19969999999999999</c:v>
                </c:pt>
                <c:pt idx="143">
                  <c:v>0.16880000000000001</c:v>
                </c:pt>
                <c:pt idx="144">
                  <c:v>0.1638</c:v>
                </c:pt>
                <c:pt idx="145">
                  <c:v>0.16259999999999999</c:v>
                </c:pt>
                <c:pt idx="146">
                  <c:v>0.12759999999999999</c:v>
                </c:pt>
                <c:pt idx="147">
                  <c:v>0.1174</c:v>
                </c:pt>
                <c:pt idx="148">
                  <c:v>0.14169999999999999</c:v>
                </c:pt>
                <c:pt idx="149">
                  <c:v>0.1298</c:v>
                </c:pt>
                <c:pt idx="150">
                  <c:v>0.11899999999999999</c:v>
                </c:pt>
                <c:pt idx="151">
                  <c:v>0.14610000000000001</c:v>
                </c:pt>
                <c:pt idx="152">
                  <c:v>0.15670000000000001</c:v>
                </c:pt>
                <c:pt idx="153">
                  <c:v>0.15160000000000001</c:v>
                </c:pt>
                <c:pt idx="154">
                  <c:v>0.16750000000000001</c:v>
                </c:pt>
                <c:pt idx="155">
                  <c:v>0.19689999999999999</c:v>
                </c:pt>
                <c:pt idx="156">
                  <c:v>0.20039999999999999</c:v>
                </c:pt>
                <c:pt idx="157">
                  <c:v>0.1993</c:v>
                </c:pt>
                <c:pt idx="158">
                  <c:v>0.23069999999999999</c:v>
                </c:pt>
                <c:pt idx="159">
                  <c:v>0.25269999999999998</c:v>
                </c:pt>
                <c:pt idx="160">
                  <c:v>0.24829999999999999</c:v>
                </c:pt>
                <c:pt idx="161">
                  <c:v>0.26319999999999999</c:v>
                </c:pt>
                <c:pt idx="162">
                  <c:v>0.3049</c:v>
                </c:pt>
                <c:pt idx="163">
                  <c:v>0.31330000000000002</c:v>
                </c:pt>
                <c:pt idx="164">
                  <c:v>0.30620000000000003</c:v>
                </c:pt>
                <c:pt idx="165">
                  <c:v>0.33510000000000001</c:v>
                </c:pt>
                <c:pt idx="166">
                  <c:v>0.3654</c:v>
                </c:pt>
                <c:pt idx="167">
                  <c:v>0.36670000000000003</c:v>
                </c:pt>
                <c:pt idx="168">
                  <c:v>0.36099999999999999</c:v>
                </c:pt>
                <c:pt idx="169">
                  <c:v>0.38450000000000001</c:v>
                </c:pt>
                <c:pt idx="170">
                  <c:v>0.37569999999999998</c:v>
                </c:pt>
                <c:pt idx="171">
                  <c:v>0.39200000000000002</c:v>
                </c:pt>
                <c:pt idx="172">
                  <c:v>0.44900000000000001</c:v>
                </c:pt>
                <c:pt idx="173">
                  <c:v>0.46939999999999998</c:v>
                </c:pt>
                <c:pt idx="174">
                  <c:v>0.45619999999999999</c:v>
                </c:pt>
                <c:pt idx="175">
                  <c:v>0.46379999999999999</c:v>
                </c:pt>
                <c:pt idx="176">
                  <c:v>0.46050000000000002</c:v>
                </c:pt>
                <c:pt idx="177">
                  <c:v>0.45800000000000002</c:v>
                </c:pt>
                <c:pt idx="178">
                  <c:v>0.44019999999999998</c:v>
                </c:pt>
                <c:pt idx="179">
                  <c:v>0.4173</c:v>
                </c:pt>
                <c:pt idx="180">
                  <c:v>0.42470000000000002</c:v>
                </c:pt>
                <c:pt idx="181">
                  <c:v>0.3896</c:v>
                </c:pt>
                <c:pt idx="182">
                  <c:v>0.38440000000000002</c:v>
                </c:pt>
                <c:pt idx="183">
                  <c:v>0.36820000000000003</c:v>
                </c:pt>
                <c:pt idx="184">
                  <c:v>0.33579999999999999</c:v>
                </c:pt>
                <c:pt idx="185">
                  <c:v>0.32</c:v>
                </c:pt>
                <c:pt idx="186">
                  <c:v>0.3165</c:v>
                </c:pt>
                <c:pt idx="187">
                  <c:v>0.2888</c:v>
                </c:pt>
                <c:pt idx="188">
                  <c:v>0.26479999999999998</c:v>
                </c:pt>
                <c:pt idx="189">
                  <c:v>0.26829999999999998</c:v>
                </c:pt>
                <c:pt idx="190">
                  <c:v>0.2525</c:v>
                </c:pt>
                <c:pt idx="191">
                  <c:v>0.2198</c:v>
                </c:pt>
                <c:pt idx="192">
                  <c:v>0.22090000000000001</c:v>
                </c:pt>
                <c:pt idx="193">
                  <c:v>0.22969999999999999</c:v>
                </c:pt>
                <c:pt idx="194">
                  <c:v>0.1978</c:v>
                </c:pt>
                <c:pt idx="195">
                  <c:v>0.18160000000000001</c:v>
                </c:pt>
                <c:pt idx="196">
                  <c:v>0.20369999999999999</c:v>
                </c:pt>
                <c:pt idx="197">
                  <c:v>0.20219999999999999</c:v>
                </c:pt>
                <c:pt idx="198">
                  <c:v>0.1706</c:v>
                </c:pt>
                <c:pt idx="199">
                  <c:v>0.18410000000000001</c:v>
                </c:pt>
                <c:pt idx="200">
                  <c:v>0.21149999999999999</c:v>
                </c:pt>
                <c:pt idx="201">
                  <c:v>0.20569999999999999</c:v>
                </c:pt>
                <c:pt idx="202">
                  <c:v>0.19470000000000001</c:v>
                </c:pt>
                <c:pt idx="203">
                  <c:v>0.21410000000000001</c:v>
                </c:pt>
                <c:pt idx="204">
                  <c:v>0.2462</c:v>
                </c:pt>
                <c:pt idx="205">
                  <c:v>0.21879999999999999</c:v>
                </c:pt>
                <c:pt idx="206">
                  <c:v>0.20860000000000001</c:v>
                </c:pt>
                <c:pt idx="207">
                  <c:v>0.19170000000000001</c:v>
                </c:pt>
                <c:pt idx="208">
                  <c:v>0.18959999999999999</c:v>
                </c:pt>
                <c:pt idx="209">
                  <c:v>0.191</c:v>
                </c:pt>
                <c:pt idx="210">
                  <c:v>0.2046</c:v>
                </c:pt>
                <c:pt idx="211">
                  <c:v>0.21190000000000001</c:v>
                </c:pt>
                <c:pt idx="212">
                  <c:v>0.24429999999999999</c:v>
                </c:pt>
                <c:pt idx="213">
                  <c:v>0.24160000000000001</c:v>
                </c:pt>
                <c:pt idx="214">
                  <c:v>0.2203</c:v>
                </c:pt>
                <c:pt idx="215">
                  <c:v>0.2475</c:v>
                </c:pt>
                <c:pt idx="216">
                  <c:v>0.27450000000000002</c:v>
                </c:pt>
                <c:pt idx="217">
                  <c:v>0.248</c:v>
                </c:pt>
                <c:pt idx="218">
                  <c:v>0.249</c:v>
                </c:pt>
                <c:pt idx="219">
                  <c:v>0.3004</c:v>
                </c:pt>
                <c:pt idx="220">
                  <c:v>0.29499999999999998</c:v>
                </c:pt>
                <c:pt idx="221">
                  <c:v>0.26640000000000003</c:v>
                </c:pt>
                <c:pt idx="222">
                  <c:v>0.30020000000000002</c:v>
                </c:pt>
                <c:pt idx="223">
                  <c:v>0.33350000000000002</c:v>
                </c:pt>
                <c:pt idx="224">
                  <c:v>0.31159999999999999</c:v>
                </c:pt>
                <c:pt idx="225">
                  <c:v>0.30940000000000001</c:v>
                </c:pt>
                <c:pt idx="226">
                  <c:v>0.35389999999999999</c:v>
                </c:pt>
                <c:pt idx="227">
                  <c:v>0.36530000000000001</c:v>
                </c:pt>
                <c:pt idx="228">
                  <c:v>0.3453</c:v>
                </c:pt>
                <c:pt idx="229">
                  <c:v>0.3533</c:v>
                </c:pt>
                <c:pt idx="230">
                  <c:v>0.39829999999999999</c:v>
                </c:pt>
                <c:pt idx="231">
                  <c:v>0.43030000000000002</c:v>
                </c:pt>
                <c:pt idx="232">
                  <c:v>0.44059999999999999</c:v>
                </c:pt>
                <c:pt idx="233">
                  <c:v>0.39950000000000002</c:v>
                </c:pt>
                <c:pt idx="234">
                  <c:v>0.40770000000000001</c:v>
                </c:pt>
                <c:pt idx="235">
                  <c:v>0.42159999999999997</c:v>
                </c:pt>
                <c:pt idx="236">
                  <c:v>0.44750000000000001</c:v>
                </c:pt>
                <c:pt idx="237">
                  <c:v>0.4995</c:v>
                </c:pt>
                <c:pt idx="238">
                  <c:v>0.51149999999999995</c:v>
                </c:pt>
                <c:pt idx="239">
                  <c:v>0.59150000000000003</c:v>
                </c:pt>
                <c:pt idx="240">
                  <c:v>0.59019999999999995</c:v>
                </c:pt>
                <c:pt idx="241">
                  <c:v>0.53549999999999998</c:v>
                </c:pt>
                <c:pt idx="242">
                  <c:v>0.5262</c:v>
                </c:pt>
                <c:pt idx="243">
                  <c:v>0.48180000000000001</c:v>
                </c:pt>
                <c:pt idx="244">
                  <c:v>0.47760000000000002</c:v>
                </c:pt>
                <c:pt idx="245">
                  <c:v>0.48970000000000002</c:v>
                </c:pt>
                <c:pt idx="246">
                  <c:v>0.50770000000000004</c:v>
                </c:pt>
                <c:pt idx="247">
                  <c:v>0.55259999999999998</c:v>
                </c:pt>
                <c:pt idx="248">
                  <c:v>0.61009999999999998</c:v>
                </c:pt>
                <c:pt idx="249">
                  <c:v>0.61639999999999995</c:v>
                </c:pt>
                <c:pt idx="250">
                  <c:v>0.58279999999999998</c:v>
                </c:pt>
                <c:pt idx="251">
                  <c:v>0.52910000000000001</c:v>
                </c:pt>
                <c:pt idx="252">
                  <c:v>0.4945</c:v>
                </c:pt>
                <c:pt idx="253">
                  <c:v>0.46379999999999999</c:v>
                </c:pt>
                <c:pt idx="254">
                  <c:v>0.4224</c:v>
                </c:pt>
                <c:pt idx="255">
                  <c:v>0.40279999999999999</c:v>
                </c:pt>
                <c:pt idx="256">
                  <c:v>0.43659999999999999</c:v>
                </c:pt>
                <c:pt idx="257">
                  <c:v>0.43419999999999997</c:v>
                </c:pt>
                <c:pt idx="258">
                  <c:v>0.38619999999999999</c:v>
                </c:pt>
                <c:pt idx="259">
                  <c:v>0.40579999999999999</c:v>
                </c:pt>
                <c:pt idx="260">
                  <c:v>0.44890000000000002</c:v>
                </c:pt>
                <c:pt idx="261">
                  <c:v>0.41499999999999998</c:v>
                </c:pt>
                <c:pt idx="262">
                  <c:v>0.3639</c:v>
                </c:pt>
                <c:pt idx="263">
                  <c:v>0.37869999999999998</c:v>
                </c:pt>
                <c:pt idx="264">
                  <c:v>0.3574</c:v>
                </c:pt>
                <c:pt idx="265">
                  <c:v>0.39929999999999999</c:v>
                </c:pt>
                <c:pt idx="266">
                  <c:v>0.40789999999999998</c:v>
                </c:pt>
                <c:pt idx="267">
                  <c:v>0.40849999999999997</c:v>
                </c:pt>
                <c:pt idx="268">
                  <c:v>0.36549999999999999</c:v>
                </c:pt>
                <c:pt idx="269">
                  <c:v>0.34279999999999999</c:v>
                </c:pt>
                <c:pt idx="270">
                  <c:v>0.3644</c:v>
                </c:pt>
                <c:pt idx="271">
                  <c:v>0.34339999999999998</c:v>
                </c:pt>
                <c:pt idx="272">
                  <c:v>0.29959999999999998</c:v>
                </c:pt>
                <c:pt idx="273">
                  <c:v>0.31940000000000002</c:v>
                </c:pt>
                <c:pt idx="274">
                  <c:v>0.33360000000000001</c:v>
                </c:pt>
                <c:pt idx="275">
                  <c:v>0.29399999999999998</c:v>
                </c:pt>
                <c:pt idx="276">
                  <c:v>0.27629999999999999</c:v>
                </c:pt>
                <c:pt idx="277">
                  <c:v>0.30780000000000002</c:v>
                </c:pt>
                <c:pt idx="278">
                  <c:v>0.30120000000000002</c:v>
                </c:pt>
                <c:pt idx="279">
                  <c:v>0.26390000000000002</c:v>
                </c:pt>
                <c:pt idx="280">
                  <c:v>0.27489999999999998</c:v>
                </c:pt>
                <c:pt idx="281">
                  <c:v>0.3024</c:v>
                </c:pt>
                <c:pt idx="282">
                  <c:v>0.29039999999999999</c:v>
                </c:pt>
                <c:pt idx="283">
                  <c:v>0.26779999999999998</c:v>
                </c:pt>
                <c:pt idx="284">
                  <c:v>0.26879999999999998</c:v>
                </c:pt>
                <c:pt idx="285">
                  <c:v>0.29570000000000002</c:v>
                </c:pt>
                <c:pt idx="286">
                  <c:v>0.30830000000000002</c:v>
                </c:pt>
                <c:pt idx="287">
                  <c:v>0.34160000000000001</c:v>
                </c:pt>
                <c:pt idx="288">
                  <c:v>0.35089999999999999</c:v>
                </c:pt>
                <c:pt idx="289">
                  <c:v>0.3826</c:v>
                </c:pt>
                <c:pt idx="290">
                  <c:v>0.4118</c:v>
                </c:pt>
                <c:pt idx="291">
                  <c:v>0.43090000000000001</c:v>
                </c:pt>
                <c:pt idx="292">
                  <c:v>0.46939999999999998</c:v>
                </c:pt>
                <c:pt idx="293">
                  <c:v>0.46160000000000001</c:v>
                </c:pt>
                <c:pt idx="294">
                  <c:v>0.44640000000000002</c:v>
                </c:pt>
                <c:pt idx="295">
                  <c:v>0.4783</c:v>
                </c:pt>
                <c:pt idx="296">
                  <c:v>0.44650000000000001</c:v>
                </c:pt>
                <c:pt idx="297">
                  <c:v>0.48599999999999999</c:v>
                </c:pt>
                <c:pt idx="298">
                  <c:v>0.4299</c:v>
                </c:pt>
                <c:pt idx="299">
                  <c:v>0.44900000000000001</c:v>
                </c:pt>
                <c:pt idx="300">
                  <c:v>0.51380000000000003</c:v>
                </c:pt>
                <c:pt idx="301">
                  <c:v>0.53500000000000003</c:v>
                </c:pt>
                <c:pt idx="302">
                  <c:v>0.48959999999999998</c:v>
                </c:pt>
                <c:pt idx="303">
                  <c:v>0.50919999999999999</c:v>
                </c:pt>
                <c:pt idx="304">
                  <c:v>0.48409999999999997</c:v>
                </c:pt>
                <c:pt idx="305">
                  <c:v>0.50109999999999999</c:v>
                </c:pt>
                <c:pt idx="306">
                  <c:v>0.45200000000000001</c:v>
                </c:pt>
                <c:pt idx="307">
                  <c:v>0.40279999999999999</c:v>
                </c:pt>
                <c:pt idx="308">
                  <c:v>0.36759999999999998</c:v>
                </c:pt>
                <c:pt idx="309">
                  <c:v>0.36199999999999999</c:v>
                </c:pt>
                <c:pt idx="310">
                  <c:v>0.3337</c:v>
                </c:pt>
                <c:pt idx="311">
                  <c:v>0.34739999999999999</c:v>
                </c:pt>
                <c:pt idx="312">
                  <c:v>0.3377</c:v>
                </c:pt>
                <c:pt idx="313">
                  <c:v>0.30609999999999998</c:v>
                </c:pt>
                <c:pt idx="314">
                  <c:v>0.30480000000000002</c:v>
                </c:pt>
                <c:pt idx="315">
                  <c:v>0.33069999999999999</c:v>
                </c:pt>
                <c:pt idx="316">
                  <c:v>0.3337</c:v>
                </c:pt>
                <c:pt idx="317">
                  <c:v>0.32869999999999999</c:v>
                </c:pt>
                <c:pt idx="318">
                  <c:v>0.30030000000000001</c:v>
                </c:pt>
                <c:pt idx="319">
                  <c:v>0.27600000000000002</c:v>
                </c:pt>
                <c:pt idx="320">
                  <c:v>0.25969999999999999</c:v>
                </c:pt>
                <c:pt idx="321">
                  <c:v>0.2621</c:v>
                </c:pt>
                <c:pt idx="322">
                  <c:v>0.25259999999999999</c:v>
                </c:pt>
                <c:pt idx="323">
                  <c:v>0.22439999999999999</c:v>
                </c:pt>
                <c:pt idx="324">
                  <c:v>0.22570000000000001</c:v>
                </c:pt>
                <c:pt idx="325">
                  <c:v>0.24490000000000001</c:v>
                </c:pt>
                <c:pt idx="326">
                  <c:v>0.219</c:v>
                </c:pt>
                <c:pt idx="327">
                  <c:v>0.19570000000000001</c:v>
                </c:pt>
                <c:pt idx="328">
                  <c:v>0.22450000000000001</c:v>
                </c:pt>
                <c:pt idx="329">
                  <c:v>0.22889999999999999</c:v>
                </c:pt>
                <c:pt idx="330">
                  <c:v>0.20630000000000001</c:v>
                </c:pt>
                <c:pt idx="331">
                  <c:v>0.2727</c:v>
                </c:pt>
                <c:pt idx="332">
                  <c:v>0.34570000000000001</c:v>
                </c:pt>
                <c:pt idx="333">
                  <c:v>0.29430000000000001</c:v>
                </c:pt>
                <c:pt idx="334">
                  <c:v>0.20660000000000001</c:v>
                </c:pt>
                <c:pt idx="335">
                  <c:v>0.2074</c:v>
                </c:pt>
                <c:pt idx="336">
                  <c:v>0.184</c:v>
                </c:pt>
                <c:pt idx="337">
                  <c:v>0.13700000000000001</c:v>
                </c:pt>
                <c:pt idx="338">
                  <c:v>0.1376</c:v>
                </c:pt>
                <c:pt idx="339">
                  <c:v>0.14230000000000001</c:v>
                </c:pt>
                <c:pt idx="340">
                  <c:v>0.15870000000000001</c:v>
                </c:pt>
                <c:pt idx="341">
                  <c:v>0.15970000000000001</c:v>
                </c:pt>
                <c:pt idx="342">
                  <c:v>0.1686</c:v>
                </c:pt>
                <c:pt idx="343">
                  <c:v>0.19309999999999999</c:v>
                </c:pt>
                <c:pt idx="344">
                  <c:v>0.2069</c:v>
                </c:pt>
                <c:pt idx="345">
                  <c:v>0.25769999999999998</c:v>
                </c:pt>
                <c:pt idx="346">
                  <c:v>0.29220000000000002</c:v>
                </c:pt>
                <c:pt idx="347">
                  <c:v>0.25509999999999999</c:v>
                </c:pt>
                <c:pt idx="348">
                  <c:v>0.22919999999999999</c:v>
                </c:pt>
                <c:pt idx="349">
                  <c:v>0.18290000000000001</c:v>
                </c:pt>
                <c:pt idx="350">
                  <c:v>0.17630000000000001</c:v>
                </c:pt>
                <c:pt idx="351">
                  <c:v>0.214</c:v>
                </c:pt>
                <c:pt idx="352">
                  <c:v>0.2636</c:v>
                </c:pt>
                <c:pt idx="353">
                  <c:v>0.2883</c:v>
                </c:pt>
                <c:pt idx="354">
                  <c:v>0.25940000000000002</c:v>
                </c:pt>
                <c:pt idx="355">
                  <c:v>0.17380000000000001</c:v>
                </c:pt>
                <c:pt idx="356">
                  <c:v>0.19439999999999999</c:v>
                </c:pt>
                <c:pt idx="357">
                  <c:v>0.1799</c:v>
                </c:pt>
                <c:pt idx="358">
                  <c:v>0.28149999999999997</c:v>
                </c:pt>
                <c:pt idx="359">
                  <c:v>0.31979999999999997</c:v>
                </c:pt>
                <c:pt idx="360">
                  <c:v>0.23960000000000001</c:v>
                </c:pt>
                <c:pt idx="361">
                  <c:v>0.30559999999999998</c:v>
                </c:pt>
                <c:pt idx="362">
                  <c:v>0.29459999999999997</c:v>
                </c:pt>
                <c:pt idx="363">
                  <c:v>0.26329999999999998</c:v>
                </c:pt>
                <c:pt idx="364">
                  <c:v>0.27700000000000002</c:v>
                </c:pt>
                <c:pt idx="365">
                  <c:v>0.28029999999999999</c:v>
                </c:pt>
                <c:pt idx="366">
                  <c:v>0.34739999999999999</c:v>
                </c:pt>
                <c:pt idx="367">
                  <c:v>0.39500000000000002</c:v>
                </c:pt>
                <c:pt idx="368">
                  <c:v>0.4723</c:v>
                </c:pt>
                <c:pt idx="369">
                  <c:v>0.52429999999999999</c:v>
                </c:pt>
                <c:pt idx="370">
                  <c:v>0.60529999999999995</c:v>
                </c:pt>
                <c:pt idx="371">
                  <c:v>0.69</c:v>
                </c:pt>
                <c:pt idx="372">
                  <c:v>0.71989999999999998</c:v>
                </c:pt>
                <c:pt idx="373">
                  <c:v>0.62480000000000002</c:v>
                </c:pt>
                <c:pt idx="374">
                  <c:v>0.58050000000000002</c:v>
                </c:pt>
                <c:pt idx="375">
                  <c:v>0.50790000000000002</c:v>
                </c:pt>
                <c:pt idx="376">
                  <c:v>0.42159999999999997</c:v>
                </c:pt>
                <c:pt idx="377">
                  <c:v>0.40770000000000001</c:v>
                </c:pt>
                <c:pt idx="378">
                  <c:v>0.38450000000000001</c:v>
                </c:pt>
                <c:pt idx="379">
                  <c:v>0.35449999999999998</c:v>
                </c:pt>
                <c:pt idx="380">
                  <c:v>0.31409999999999999</c:v>
                </c:pt>
                <c:pt idx="381">
                  <c:v>0.29220000000000002</c:v>
                </c:pt>
                <c:pt idx="382">
                  <c:v>0.32929999999999998</c:v>
                </c:pt>
                <c:pt idx="383">
                  <c:v>0.30509999999999998</c:v>
                </c:pt>
                <c:pt idx="384">
                  <c:v>0.30809999999999998</c:v>
                </c:pt>
                <c:pt idx="385">
                  <c:v>0.32740000000000002</c:v>
                </c:pt>
                <c:pt idx="386">
                  <c:v>0.36749999999999999</c:v>
                </c:pt>
                <c:pt idx="387">
                  <c:v>0.40660000000000002</c:v>
                </c:pt>
                <c:pt idx="388">
                  <c:v>0.44640000000000002</c:v>
                </c:pt>
                <c:pt idx="389">
                  <c:v>0.48799999999999999</c:v>
                </c:pt>
                <c:pt idx="390">
                  <c:v>0.53549999999999998</c:v>
                </c:pt>
                <c:pt idx="391">
                  <c:v>0.62060000000000004</c:v>
                </c:pt>
                <c:pt idx="392">
                  <c:v>0.73550000000000004</c:v>
                </c:pt>
                <c:pt idx="393">
                  <c:v>0.9103</c:v>
                </c:pt>
                <c:pt idx="394">
                  <c:v>1.02</c:v>
                </c:pt>
                <c:pt idx="395">
                  <c:v>0.9466</c:v>
                </c:pt>
                <c:pt idx="396">
                  <c:v>0.83679999999999999</c:v>
                </c:pt>
                <c:pt idx="397">
                  <c:v>0.75619999999999998</c:v>
                </c:pt>
                <c:pt idx="398">
                  <c:v>0.72089999999999999</c:v>
                </c:pt>
                <c:pt idx="399">
                  <c:v>0.5423</c:v>
                </c:pt>
                <c:pt idx="400">
                  <c:v>0.45569999999999999</c:v>
                </c:pt>
                <c:pt idx="401">
                  <c:v>0.3669</c:v>
                </c:pt>
                <c:pt idx="402">
                  <c:v>0.2908</c:v>
                </c:pt>
                <c:pt idx="403">
                  <c:v>0.2802</c:v>
                </c:pt>
                <c:pt idx="404">
                  <c:v>0.23499999999999999</c:v>
                </c:pt>
                <c:pt idx="405">
                  <c:v>0.23419999999999999</c:v>
                </c:pt>
                <c:pt idx="406">
                  <c:v>0.21920000000000001</c:v>
                </c:pt>
                <c:pt idx="407">
                  <c:v>0.24340000000000001</c:v>
                </c:pt>
                <c:pt idx="408">
                  <c:v>0.27060000000000001</c:v>
                </c:pt>
                <c:pt idx="409">
                  <c:v>0.26050000000000001</c:v>
                </c:pt>
                <c:pt idx="410">
                  <c:v>0.2485</c:v>
                </c:pt>
                <c:pt idx="411">
                  <c:v>0.27489999999999998</c:v>
                </c:pt>
                <c:pt idx="412">
                  <c:v>0.29820000000000002</c:v>
                </c:pt>
                <c:pt idx="413">
                  <c:v>0.28870000000000001</c:v>
                </c:pt>
                <c:pt idx="414">
                  <c:v>0.2843</c:v>
                </c:pt>
                <c:pt idx="415">
                  <c:v>0.31409999999999999</c:v>
                </c:pt>
                <c:pt idx="416">
                  <c:v>0.33019999999999999</c:v>
                </c:pt>
                <c:pt idx="417">
                  <c:v>0.315</c:v>
                </c:pt>
                <c:pt idx="418">
                  <c:v>0.32279999999999998</c:v>
                </c:pt>
                <c:pt idx="419">
                  <c:v>0.35620000000000002</c:v>
                </c:pt>
                <c:pt idx="420">
                  <c:v>0.3528</c:v>
                </c:pt>
                <c:pt idx="421">
                  <c:v>0.33350000000000002</c:v>
                </c:pt>
                <c:pt idx="422">
                  <c:v>0.33069999999999999</c:v>
                </c:pt>
                <c:pt idx="423">
                  <c:v>0.35510000000000003</c:v>
                </c:pt>
                <c:pt idx="424">
                  <c:v>0.35720000000000002</c:v>
                </c:pt>
                <c:pt idx="425">
                  <c:v>0.36209999999999998</c:v>
                </c:pt>
                <c:pt idx="426">
                  <c:v>0.33950000000000002</c:v>
                </c:pt>
                <c:pt idx="427">
                  <c:v>0.35520000000000002</c:v>
                </c:pt>
                <c:pt idx="428">
                  <c:v>0.37759999999999999</c:v>
                </c:pt>
                <c:pt idx="429">
                  <c:v>0.40010000000000001</c:v>
                </c:pt>
                <c:pt idx="430">
                  <c:v>0.437</c:v>
                </c:pt>
                <c:pt idx="431">
                  <c:v>0.43730000000000002</c:v>
                </c:pt>
                <c:pt idx="432">
                  <c:v>0.41420000000000001</c:v>
                </c:pt>
                <c:pt idx="433">
                  <c:v>0.42630000000000001</c:v>
                </c:pt>
                <c:pt idx="434">
                  <c:v>0.45079999999999998</c:v>
                </c:pt>
                <c:pt idx="435">
                  <c:v>0.44019999999999998</c:v>
                </c:pt>
                <c:pt idx="436">
                  <c:v>0.43</c:v>
                </c:pt>
                <c:pt idx="437">
                  <c:v>0.45739999999999997</c:v>
                </c:pt>
                <c:pt idx="438">
                  <c:v>0.46750000000000003</c:v>
                </c:pt>
                <c:pt idx="439">
                  <c:v>0.44579999999999997</c:v>
                </c:pt>
                <c:pt idx="440">
                  <c:v>0.4738</c:v>
                </c:pt>
                <c:pt idx="441">
                  <c:v>0.46029999999999999</c:v>
                </c:pt>
                <c:pt idx="442">
                  <c:v>0.4551</c:v>
                </c:pt>
                <c:pt idx="443">
                  <c:v>0.40870000000000001</c:v>
                </c:pt>
                <c:pt idx="444">
                  <c:v>0.42159999999999997</c:v>
                </c:pt>
                <c:pt idx="445">
                  <c:v>0.42720000000000002</c:v>
                </c:pt>
                <c:pt idx="446">
                  <c:v>0.37809999999999999</c:v>
                </c:pt>
                <c:pt idx="447">
                  <c:v>0.35170000000000001</c:v>
                </c:pt>
                <c:pt idx="448">
                  <c:v>0.37369999999999998</c:v>
                </c:pt>
                <c:pt idx="449">
                  <c:v>0.36659999999999998</c:v>
                </c:pt>
                <c:pt idx="450">
                  <c:v>0.31440000000000001</c:v>
                </c:pt>
                <c:pt idx="451">
                  <c:v>0.30559999999999998</c:v>
                </c:pt>
                <c:pt idx="452">
                  <c:v>0.31369999999999998</c:v>
                </c:pt>
                <c:pt idx="453">
                  <c:v>0.30149999999999999</c:v>
                </c:pt>
                <c:pt idx="454">
                  <c:v>0.28220000000000001</c:v>
                </c:pt>
                <c:pt idx="455">
                  <c:v>0.26690000000000003</c:v>
                </c:pt>
                <c:pt idx="456">
                  <c:v>0.26200000000000001</c:v>
                </c:pt>
                <c:pt idx="457">
                  <c:v>0.25829999999999997</c:v>
                </c:pt>
                <c:pt idx="458">
                  <c:v>0.2409</c:v>
                </c:pt>
                <c:pt idx="459">
                  <c:v>0.24460000000000001</c:v>
                </c:pt>
                <c:pt idx="460">
                  <c:v>0.29210000000000003</c:v>
                </c:pt>
                <c:pt idx="461">
                  <c:v>0.26819999999999999</c:v>
                </c:pt>
                <c:pt idx="462">
                  <c:v>0.28489999999999999</c:v>
                </c:pt>
                <c:pt idx="463">
                  <c:v>0.31569999999999998</c:v>
                </c:pt>
                <c:pt idx="464">
                  <c:v>0.36170000000000002</c:v>
                </c:pt>
                <c:pt idx="465">
                  <c:v>0.35410000000000003</c:v>
                </c:pt>
                <c:pt idx="466">
                  <c:v>0.37269999999999998</c:v>
                </c:pt>
                <c:pt idx="467">
                  <c:v>0.37880000000000003</c:v>
                </c:pt>
                <c:pt idx="468">
                  <c:v>0.35439999999999999</c:v>
                </c:pt>
                <c:pt idx="469">
                  <c:v>0.40920000000000001</c:v>
                </c:pt>
                <c:pt idx="470">
                  <c:v>0.40610000000000002</c:v>
                </c:pt>
                <c:pt idx="471">
                  <c:v>0.37690000000000001</c:v>
                </c:pt>
                <c:pt idx="472">
                  <c:v>0.36280000000000001</c:v>
                </c:pt>
                <c:pt idx="473">
                  <c:v>0.30890000000000001</c:v>
                </c:pt>
                <c:pt idx="474">
                  <c:v>0.31059999999999999</c:v>
                </c:pt>
                <c:pt idx="475">
                  <c:v>0.30499999999999999</c:v>
                </c:pt>
                <c:pt idx="476">
                  <c:v>0.2576</c:v>
                </c:pt>
                <c:pt idx="477">
                  <c:v>0.2487</c:v>
                </c:pt>
                <c:pt idx="478">
                  <c:v>0.2732</c:v>
                </c:pt>
                <c:pt idx="479">
                  <c:v>0.25209999999999999</c:v>
                </c:pt>
                <c:pt idx="480">
                  <c:v>0.23019999999999999</c:v>
                </c:pt>
                <c:pt idx="481">
                  <c:v>0.25640000000000002</c:v>
                </c:pt>
                <c:pt idx="482">
                  <c:v>0.26900000000000002</c:v>
                </c:pt>
                <c:pt idx="483">
                  <c:v>0.24579999999999999</c:v>
                </c:pt>
                <c:pt idx="484">
                  <c:v>0.2472</c:v>
                </c:pt>
                <c:pt idx="485">
                  <c:v>0.27510000000000001</c:v>
                </c:pt>
                <c:pt idx="486">
                  <c:v>0.2777</c:v>
                </c:pt>
                <c:pt idx="487">
                  <c:v>0.26390000000000002</c:v>
                </c:pt>
                <c:pt idx="488">
                  <c:v>0.27760000000000001</c:v>
                </c:pt>
                <c:pt idx="489">
                  <c:v>0.29849999999999999</c:v>
                </c:pt>
                <c:pt idx="490">
                  <c:v>0.29420000000000002</c:v>
                </c:pt>
                <c:pt idx="491">
                  <c:v>0.28839999999999999</c:v>
                </c:pt>
                <c:pt idx="492">
                  <c:v>0.31159999999999999</c:v>
                </c:pt>
                <c:pt idx="493">
                  <c:v>0.32650000000000001</c:v>
                </c:pt>
                <c:pt idx="494">
                  <c:v>0.32279999999999998</c:v>
                </c:pt>
                <c:pt idx="495">
                  <c:v>0.32790000000000002</c:v>
                </c:pt>
                <c:pt idx="496">
                  <c:v>0.3543</c:v>
                </c:pt>
                <c:pt idx="497">
                  <c:v>0.36380000000000001</c:v>
                </c:pt>
                <c:pt idx="498">
                  <c:v>0.36020000000000002</c:v>
                </c:pt>
                <c:pt idx="499">
                  <c:v>0.36680000000000001</c:v>
                </c:pt>
                <c:pt idx="500">
                  <c:v>0.39119999999999999</c:v>
                </c:pt>
                <c:pt idx="501">
                  <c:v>0.39939999999999998</c:v>
                </c:pt>
                <c:pt idx="502">
                  <c:v>0.39650000000000002</c:v>
                </c:pt>
                <c:pt idx="503">
                  <c:v>0.41489999999999999</c:v>
                </c:pt>
                <c:pt idx="504">
                  <c:v>0.43719999999999998</c:v>
                </c:pt>
                <c:pt idx="505">
                  <c:v>0.44479999999999997</c:v>
                </c:pt>
                <c:pt idx="506">
                  <c:v>0.45169999999999999</c:v>
                </c:pt>
                <c:pt idx="507">
                  <c:v>0.47799999999999998</c:v>
                </c:pt>
                <c:pt idx="508">
                  <c:v>0.50129999999999997</c:v>
                </c:pt>
                <c:pt idx="509">
                  <c:v>0.51390000000000002</c:v>
                </c:pt>
                <c:pt idx="510">
                  <c:v>0.52610000000000001</c:v>
                </c:pt>
                <c:pt idx="511">
                  <c:v>0.54930000000000001</c:v>
                </c:pt>
                <c:pt idx="512">
                  <c:v>0.53290000000000004</c:v>
                </c:pt>
                <c:pt idx="513">
                  <c:v>0.49569999999999997</c:v>
                </c:pt>
                <c:pt idx="514">
                  <c:v>0.50129999999999997</c:v>
                </c:pt>
                <c:pt idx="515">
                  <c:v>0.46410000000000001</c:v>
                </c:pt>
                <c:pt idx="516">
                  <c:v>0.45960000000000001</c:v>
                </c:pt>
                <c:pt idx="517">
                  <c:v>0.43619999999999998</c:v>
                </c:pt>
                <c:pt idx="518">
                  <c:v>0.41260000000000002</c:v>
                </c:pt>
                <c:pt idx="519">
                  <c:v>0.4098</c:v>
                </c:pt>
                <c:pt idx="520">
                  <c:v>0.40479999999999999</c:v>
                </c:pt>
                <c:pt idx="521">
                  <c:v>0.38179999999999997</c:v>
                </c:pt>
                <c:pt idx="522">
                  <c:v>0.36670000000000003</c:v>
                </c:pt>
                <c:pt idx="523">
                  <c:v>0.33400000000000002</c:v>
                </c:pt>
                <c:pt idx="524">
                  <c:v>0.34160000000000001</c:v>
                </c:pt>
                <c:pt idx="525">
                  <c:v>0.3448</c:v>
                </c:pt>
                <c:pt idx="526">
                  <c:v>0.31</c:v>
                </c:pt>
                <c:pt idx="527">
                  <c:v>0.2923</c:v>
                </c:pt>
                <c:pt idx="528">
                  <c:v>0.31380000000000002</c:v>
                </c:pt>
                <c:pt idx="529">
                  <c:v>0.30359999999999998</c:v>
                </c:pt>
                <c:pt idx="530">
                  <c:v>0.26579999999999998</c:v>
                </c:pt>
                <c:pt idx="531">
                  <c:v>0.27089999999999997</c:v>
                </c:pt>
                <c:pt idx="532">
                  <c:v>0.28520000000000001</c:v>
                </c:pt>
                <c:pt idx="533">
                  <c:v>0.25840000000000002</c:v>
                </c:pt>
                <c:pt idx="534">
                  <c:v>0.24360000000000001</c:v>
                </c:pt>
                <c:pt idx="535">
                  <c:v>0.26119999999999999</c:v>
                </c:pt>
                <c:pt idx="536">
                  <c:v>0.25440000000000002</c:v>
                </c:pt>
                <c:pt idx="537">
                  <c:v>0.22040000000000001</c:v>
                </c:pt>
                <c:pt idx="538">
                  <c:v>0.2281</c:v>
                </c:pt>
                <c:pt idx="539">
                  <c:v>0.25080000000000002</c:v>
                </c:pt>
                <c:pt idx="540">
                  <c:v>0.2417</c:v>
                </c:pt>
                <c:pt idx="541">
                  <c:v>0.20610000000000001</c:v>
                </c:pt>
                <c:pt idx="542">
                  <c:v>0.193</c:v>
                </c:pt>
                <c:pt idx="543">
                  <c:v>0.16309999999999999</c:v>
                </c:pt>
                <c:pt idx="544">
                  <c:v>0.17730000000000001</c:v>
                </c:pt>
                <c:pt idx="545">
                  <c:v>0.1948</c:v>
                </c:pt>
                <c:pt idx="546">
                  <c:v>0.1908</c:v>
                </c:pt>
                <c:pt idx="547">
                  <c:v>0.20730000000000001</c:v>
                </c:pt>
                <c:pt idx="548">
                  <c:v>0.2185</c:v>
                </c:pt>
                <c:pt idx="549">
                  <c:v>0.21160000000000001</c:v>
                </c:pt>
                <c:pt idx="550">
                  <c:v>0.2248</c:v>
                </c:pt>
                <c:pt idx="551">
                  <c:v>0.245</c:v>
                </c:pt>
                <c:pt idx="552">
                  <c:v>0.24629999999999999</c:v>
                </c:pt>
                <c:pt idx="553">
                  <c:v>0.24379999999999999</c:v>
                </c:pt>
                <c:pt idx="554">
                  <c:v>0.26079999999999998</c:v>
                </c:pt>
                <c:pt idx="555">
                  <c:v>0.27650000000000002</c:v>
                </c:pt>
                <c:pt idx="556">
                  <c:v>0.28560000000000002</c:v>
                </c:pt>
                <c:pt idx="557">
                  <c:v>0.2792</c:v>
                </c:pt>
                <c:pt idx="558">
                  <c:v>0.25230000000000002</c:v>
                </c:pt>
                <c:pt idx="559">
                  <c:v>0.2944</c:v>
                </c:pt>
                <c:pt idx="560">
                  <c:v>0.30959999999999999</c:v>
                </c:pt>
                <c:pt idx="561">
                  <c:v>0.27500000000000002</c:v>
                </c:pt>
                <c:pt idx="562">
                  <c:v>0.28249999999999997</c:v>
                </c:pt>
                <c:pt idx="563">
                  <c:v>0.32050000000000001</c:v>
                </c:pt>
                <c:pt idx="564">
                  <c:v>0.32479999999999998</c:v>
                </c:pt>
                <c:pt idx="565">
                  <c:v>0.30170000000000002</c:v>
                </c:pt>
                <c:pt idx="566">
                  <c:v>0.33550000000000002</c:v>
                </c:pt>
                <c:pt idx="567">
                  <c:v>0.35639999999999999</c:v>
                </c:pt>
                <c:pt idx="568">
                  <c:v>0.3382</c:v>
                </c:pt>
                <c:pt idx="569">
                  <c:v>0.34399999999999997</c:v>
                </c:pt>
                <c:pt idx="570">
                  <c:v>0.377</c:v>
                </c:pt>
                <c:pt idx="571">
                  <c:v>0.38100000000000001</c:v>
                </c:pt>
                <c:pt idx="572">
                  <c:v>0.37430000000000002</c:v>
                </c:pt>
                <c:pt idx="573">
                  <c:v>0.39610000000000001</c:v>
                </c:pt>
                <c:pt idx="574">
                  <c:v>0.3841</c:v>
                </c:pt>
                <c:pt idx="575">
                  <c:v>0.3362</c:v>
                </c:pt>
                <c:pt idx="576">
                  <c:v>0.31680000000000003</c:v>
                </c:pt>
                <c:pt idx="577">
                  <c:v>0.31140000000000001</c:v>
                </c:pt>
                <c:pt idx="578">
                  <c:v>0.27</c:v>
                </c:pt>
                <c:pt idx="579">
                  <c:v>0.2671</c:v>
                </c:pt>
                <c:pt idx="580">
                  <c:v>0.2908</c:v>
                </c:pt>
                <c:pt idx="581">
                  <c:v>0.26550000000000001</c:v>
                </c:pt>
                <c:pt idx="582">
                  <c:v>0.23230000000000001</c:v>
                </c:pt>
                <c:pt idx="583">
                  <c:v>0.25600000000000001</c:v>
                </c:pt>
                <c:pt idx="584">
                  <c:v>0.26379999999999998</c:v>
                </c:pt>
                <c:pt idx="585">
                  <c:v>0.22309999999999999</c:v>
                </c:pt>
                <c:pt idx="586">
                  <c:v>0.21609999999999999</c:v>
                </c:pt>
                <c:pt idx="587">
                  <c:v>0.24429999999999999</c:v>
                </c:pt>
                <c:pt idx="588">
                  <c:v>0.2266</c:v>
                </c:pt>
                <c:pt idx="589">
                  <c:v>0.18909999999999999</c:v>
                </c:pt>
                <c:pt idx="590">
                  <c:v>0.214</c:v>
                </c:pt>
                <c:pt idx="591">
                  <c:v>0.23810000000000001</c:v>
                </c:pt>
                <c:pt idx="592">
                  <c:v>0.2082</c:v>
                </c:pt>
                <c:pt idx="593">
                  <c:v>0.19670000000000001</c:v>
                </c:pt>
                <c:pt idx="594">
                  <c:v>0.214</c:v>
                </c:pt>
                <c:pt idx="595">
                  <c:v>0.25169999999999998</c:v>
                </c:pt>
                <c:pt idx="596">
                  <c:v>0.25259999999999999</c:v>
                </c:pt>
                <c:pt idx="597">
                  <c:v>0.24909999999999999</c:v>
                </c:pt>
                <c:pt idx="598">
                  <c:v>0.28370000000000001</c:v>
                </c:pt>
                <c:pt idx="599">
                  <c:v>0.31309999999999999</c:v>
                </c:pt>
                <c:pt idx="600">
                  <c:v>0.30309999999999998</c:v>
                </c:pt>
                <c:pt idx="601">
                  <c:v>0.33910000000000001</c:v>
                </c:pt>
                <c:pt idx="602">
                  <c:v>0.33789999999999998</c:v>
                </c:pt>
                <c:pt idx="603">
                  <c:v>0.3584</c:v>
                </c:pt>
                <c:pt idx="604">
                  <c:v>0.39340000000000003</c:v>
                </c:pt>
                <c:pt idx="605">
                  <c:v>0.40160000000000001</c:v>
                </c:pt>
                <c:pt idx="606">
                  <c:v>0.39679999999999999</c:v>
                </c:pt>
                <c:pt idx="607">
                  <c:v>0.43159999999999998</c:v>
                </c:pt>
                <c:pt idx="608">
                  <c:v>0.46410000000000001</c:v>
                </c:pt>
                <c:pt idx="609">
                  <c:v>0.45379999999999998</c:v>
                </c:pt>
                <c:pt idx="610">
                  <c:v>0.45910000000000001</c:v>
                </c:pt>
                <c:pt idx="611">
                  <c:v>0.48349999999999999</c:v>
                </c:pt>
                <c:pt idx="612">
                  <c:v>0.4672</c:v>
                </c:pt>
                <c:pt idx="613">
                  <c:v>0.42330000000000001</c:v>
                </c:pt>
                <c:pt idx="614">
                  <c:v>0.44319999999999998</c:v>
                </c:pt>
                <c:pt idx="615">
                  <c:v>0.45789999999999997</c:v>
                </c:pt>
                <c:pt idx="616">
                  <c:v>0.42059999999999997</c:v>
                </c:pt>
                <c:pt idx="617">
                  <c:v>0.39300000000000002</c:v>
                </c:pt>
                <c:pt idx="618">
                  <c:v>0.42199999999999999</c:v>
                </c:pt>
                <c:pt idx="619">
                  <c:v>0.42670000000000002</c:v>
                </c:pt>
                <c:pt idx="620">
                  <c:v>0.38369999999999999</c:v>
                </c:pt>
                <c:pt idx="621">
                  <c:v>0.38250000000000001</c:v>
                </c:pt>
                <c:pt idx="622">
                  <c:v>0.34889999999999999</c:v>
                </c:pt>
                <c:pt idx="623">
                  <c:v>0.36699999999999999</c:v>
                </c:pt>
                <c:pt idx="624">
                  <c:v>0.35580000000000001</c:v>
                </c:pt>
                <c:pt idx="625">
                  <c:v>0.37869999999999998</c:v>
                </c:pt>
                <c:pt idx="626">
                  <c:v>0.39360000000000001</c:v>
                </c:pt>
                <c:pt idx="627">
                  <c:v>0.3674</c:v>
                </c:pt>
                <c:pt idx="628">
                  <c:v>0.35880000000000001</c:v>
                </c:pt>
                <c:pt idx="629">
                  <c:v>0.3508</c:v>
                </c:pt>
                <c:pt idx="630">
                  <c:v>0.3261</c:v>
                </c:pt>
                <c:pt idx="631">
                  <c:v>0.32790000000000002</c:v>
                </c:pt>
                <c:pt idx="632">
                  <c:v>0.35439999999999999</c:v>
                </c:pt>
                <c:pt idx="633">
                  <c:v>0.34470000000000001</c:v>
                </c:pt>
                <c:pt idx="634">
                  <c:v>0.32390000000000002</c:v>
                </c:pt>
                <c:pt idx="635">
                  <c:v>0.35270000000000001</c:v>
                </c:pt>
                <c:pt idx="636">
                  <c:v>0.373</c:v>
                </c:pt>
                <c:pt idx="637">
                  <c:v>0.34139999999999998</c:v>
                </c:pt>
                <c:pt idx="638">
                  <c:v>0.3453</c:v>
                </c:pt>
                <c:pt idx="639">
                  <c:v>0.3886</c:v>
                </c:pt>
                <c:pt idx="640">
                  <c:v>0.38619999999999999</c:v>
                </c:pt>
                <c:pt idx="641">
                  <c:v>0.36840000000000001</c:v>
                </c:pt>
                <c:pt idx="642">
                  <c:v>0.40239999999999998</c:v>
                </c:pt>
                <c:pt idx="643">
                  <c:v>0.43390000000000001</c:v>
                </c:pt>
                <c:pt idx="644">
                  <c:v>0.42570000000000002</c:v>
                </c:pt>
                <c:pt idx="645">
                  <c:v>0.442</c:v>
                </c:pt>
                <c:pt idx="646">
                  <c:v>0.55120000000000002</c:v>
                </c:pt>
                <c:pt idx="647">
                  <c:v>0.64139999999999997</c:v>
                </c:pt>
                <c:pt idx="648">
                  <c:v>0.73880000000000001</c:v>
                </c:pt>
                <c:pt idx="649">
                  <c:v>0.90759999999999996</c:v>
                </c:pt>
                <c:pt idx="650">
                  <c:v>0.96</c:v>
                </c:pt>
                <c:pt idx="651">
                  <c:v>1.1116999999999999</c:v>
                </c:pt>
                <c:pt idx="652">
                  <c:v>1.2777000000000001</c:v>
                </c:pt>
                <c:pt idx="653">
                  <c:v>1.3122</c:v>
                </c:pt>
                <c:pt idx="654">
                  <c:v>1.3572</c:v>
                </c:pt>
                <c:pt idx="655">
                  <c:v>1.4822</c:v>
                </c:pt>
                <c:pt idx="656">
                  <c:v>1.49</c:v>
                </c:pt>
                <c:pt idx="657">
                  <c:v>1.2641</c:v>
                </c:pt>
                <c:pt idx="658">
                  <c:v>1.1975</c:v>
                </c:pt>
                <c:pt idx="659">
                  <c:v>1.1515</c:v>
                </c:pt>
                <c:pt idx="660">
                  <c:v>1.0902000000000001</c:v>
                </c:pt>
                <c:pt idx="661">
                  <c:v>0.95509999999999995</c:v>
                </c:pt>
                <c:pt idx="662">
                  <c:v>0.90110000000000001</c:v>
                </c:pt>
                <c:pt idx="663">
                  <c:v>0.74109999999999998</c:v>
                </c:pt>
                <c:pt idx="664">
                  <c:v>0.72099999999999997</c:v>
                </c:pt>
                <c:pt idx="665">
                  <c:v>0.75180000000000002</c:v>
                </c:pt>
                <c:pt idx="666">
                  <c:v>0.8075</c:v>
                </c:pt>
                <c:pt idx="667">
                  <c:v>0.76790000000000003</c:v>
                </c:pt>
                <c:pt idx="668">
                  <c:v>0.77700000000000002</c:v>
                </c:pt>
                <c:pt idx="669">
                  <c:v>0.83950000000000002</c:v>
                </c:pt>
                <c:pt idx="670">
                  <c:v>0.77470000000000006</c:v>
                </c:pt>
                <c:pt idx="671">
                  <c:v>0.7843</c:v>
                </c:pt>
                <c:pt idx="672">
                  <c:v>0.82620000000000005</c:v>
                </c:pt>
                <c:pt idx="673">
                  <c:v>0.78439999999999999</c:v>
                </c:pt>
                <c:pt idx="674">
                  <c:v>0.83020000000000005</c:v>
                </c:pt>
                <c:pt idx="675">
                  <c:v>0.874</c:v>
                </c:pt>
                <c:pt idx="676">
                  <c:v>0.86470000000000002</c:v>
                </c:pt>
                <c:pt idx="677">
                  <c:v>0.92810000000000004</c:v>
                </c:pt>
                <c:pt idx="678">
                  <c:v>0.96719999999999995</c:v>
                </c:pt>
                <c:pt idx="679">
                  <c:v>1.0156000000000001</c:v>
                </c:pt>
                <c:pt idx="680">
                  <c:v>1.0687</c:v>
                </c:pt>
                <c:pt idx="681">
                  <c:v>1.143</c:v>
                </c:pt>
                <c:pt idx="682">
                  <c:v>1.2022999999999999</c:v>
                </c:pt>
                <c:pt idx="683">
                  <c:v>1.2000999999999999</c:v>
                </c:pt>
                <c:pt idx="684">
                  <c:v>1.1356999999999999</c:v>
                </c:pt>
                <c:pt idx="685">
                  <c:v>1.1749000000000001</c:v>
                </c:pt>
                <c:pt idx="686">
                  <c:v>1.0623</c:v>
                </c:pt>
                <c:pt idx="687">
                  <c:v>0.94810000000000005</c:v>
                </c:pt>
                <c:pt idx="688">
                  <c:v>1.0013000000000001</c:v>
                </c:pt>
                <c:pt idx="689">
                  <c:v>1.0228999999999999</c:v>
                </c:pt>
                <c:pt idx="690">
                  <c:v>0.89610000000000001</c:v>
                </c:pt>
                <c:pt idx="691">
                  <c:v>0.85070000000000001</c:v>
                </c:pt>
                <c:pt idx="692">
                  <c:v>0.94620000000000004</c:v>
                </c:pt>
                <c:pt idx="693">
                  <c:v>0.93479999999999996</c:v>
                </c:pt>
                <c:pt idx="694">
                  <c:v>0.82369999999999999</c:v>
                </c:pt>
                <c:pt idx="695">
                  <c:v>0.79069999999999996</c:v>
                </c:pt>
                <c:pt idx="696">
                  <c:v>0.84060000000000001</c:v>
                </c:pt>
                <c:pt idx="697">
                  <c:v>0.84619999999999995</c:v>
                </c:pt>
                <c:pt idx="698">
                  <c:v>0.63049999999999995</c:v>
                </c:pt>
                <c:pt idx="699">
                  <c:v>0.55110000000000003</c:v>
                </c:pt>
                <c:pt idx="700">
                  <c:v>0.49020000000000002</c:v>
                </c:pt>
                <c:pt idx="701">
                  <c:v>0.42420000000000002</c:v>
                </c:pt>
                <c:pt idx="702">
                  <c:v>0.37190000000000001</c:v>
                </c:pt>
                <c:pt idx="703">
                  <c:v>0.376</c:v>
                </c:pt>
                <c:pt idx="704">
                  <c:v>0.39939999999999998</c:v>
                </c:pt>
                <c:pt idx="705">
                  <c:v>0.3896</c:v>
                </c:pt>
                <c:pt idx="706">
                  <c:v>0.40460000000000002</c:v>
                </c:pt>
                <c:pt idx="707">
                  <c:v>0.3931</c:v>
                </c:pt>
                <c:pt idx="708">
                  <c:v>0.36170000000000002</c:v>
                </c:pt>
                <c:pt idx="709">
                  <c:v>0.35360000000000003</c:v>
                </c:pt>
                <c:pt idx="710">
                  <c:v>0.38840000000000002</c:v>
                </c:pt>
                <c:pt idx="711">
                  <c:v>0.43290000000000001</c:v>
                </c:pt>
                <c:pt idx="712">
                  <c:v>0.4602</c:v>
                </c:pt>
                <c:pt idx="713">
                  <c:v>0.51870000000000005</c:v>
                </c:pt>
                <c:pt idx="714">
                  <c:v>0.53200000000000003</c:v>
                </c:pt>
                <c:pt idx="715">
                  <c:v>0.55900000000000005</c:v>
                </c:pt>
                <c:pt idx="716">
                  <c:v>0.53390000000000004</c:v>
                </c:pt>
                <c:pt idx="717">
                  <c:v>0.58560000000000001</c:v>
                </c:pt>
                <c:pt idx="718">
                  <c:v>0.626</c:v>
                </c:pt>
                <c:pt idx="719">
                  <c:v>0.74070000000000003</c:v>
                </c:pt>
                <c:pt idx="720">
                  <c:v>0.68169999999999997</c:v>
                </c:pt>
                <c:pt idx="721">
                  <c:v>0.66420000000000001</c:v>
                </c:pt>
                <c:pt idx="722">
                  <c:v>0.5514</c:v>
                </c:pt>
                <c:pt idx="723">
                  <c:v>0.51449999999999996</c:v>
                </c:pt>
                <c:pt idx="724">
                  <c:v>0.46739999999999998</c:v>
                </c:pt>
                <c:pt idx="725">
                  <c:v>0.44240000000000002</c:v>
                </c:pt>
                <c:pt idx="726">
                  <c:v>0.45889999999999997</c:v>
                </c:pt>
                <c:pt idx="727">
                  <c:v>0.45579999999999998</c:v>
                </c:pt>
                <c:pt idx="728">
                  <c:v>0.41520000000000001</c:v>
                </c:pt>
                <c:pt idx="729">
                  <c:v>0.3896</c:v>
                </c:pt>
                <c:pt idx="730">
                  <c:v>0.40899999999999997</c:v>
                </c:pt>
                <c:pt idx="731">
                  <c:v>0.3861</c:v>
                </c:pt>
                <c:pt idx="732">
                  <c:v>0.33850000000000002</c:v>
                </c:pt>
                <c:pt idx="733">
                  <c:v>0.34379999999999999</c:v>
                </c:pt>
                <c:pt idx="734">
                  <c:v>0.3644</c:v>
                </c:pt>
                <c:pt idx="735">
                  <c:v>0.32619999999999999</c:v>
                </c:pt>
                <c:pt idx="736">
                  <c:v>0.29049999999999998</c:v>
                </c:pt>
                <c:pt idx="737">
                  <c:v>0.31859999999999999</c:v>
                </c:pt>
                <c:pt idx="738">
                  <c:v>0.33050000000000002</c:v>
                </c:pt>
                <c:pt idx="739">
                  <c:v>0.27500000000000002</c:v>
                </c:pt>
                <c:pt idx="740">
                  <c:v>0.26400000000000001</c:v>
                </c:pt>
                <c:pt idx="741">
                  <c:v>0.309</c:v>
                </c:pt>
                <c:pt idx="742">
                  <c:v>0.29549999999999998</c:v>
                </c:pt>
                <c:pt idx="743">
                  <c:v>0.24790000000000001</c:v>
                </c:pt>
                <c:pt idx="744">
                  <c:v>0.27489999999999998</c:v>
                </c:pt>
                <c:pt idx="745">
                  <c:v>0.31680000000000003</c:v>
                </c:pt>
                <c:pt idx="746">
                  <c:v>0.29189999999999999</c:v>
                </c:pt>
                <c:pt idx="747">
                  <c:v>0.2727</c:v>
                </c:pt>
                <c:pt idx="748">
                  <c:v>0.31979999999999997</c:v>
                </c:pt>
                <c:pt idx="749">
                  <c:v>0.35010000000000002</c:v>
                </c:pt>
                <c:pt idx="750">
                  <c:v>0.32500000000000001</c:v>
                </c:pt>
                <c:pt idx="751">
                  <c:v>0.3286</c:v>
                </c:pt>
                <c:pt idx="752">
                  <c:v>0.378</c:v>
                </c:pt>
                <c:pt idx="753">
                  <c:v>0.36880000000000002</c:v>
                </c:pt>
                <c:pt idx="754">
                  <c:v>0.40639999999999998</c:v>
                </c:pt>
                <c:pt idx="755">
                  <c:v>0.41930000000000001</c:v>
                </c:pt>
                <c:pt idx="756">
                  <c:v>0.4163</c:v>
                </c:pt>
                <c:pt idx="757">
                  <c:v>0.36959999999999998</c:v>
                </c:pt>
                <c:pt idx="758">
                  <c:v>0.35899999999999999</c:v>
                </c:pt>
                <c:pt idx="759">
                  <c:v>0.37769999999999998</c:v>
                </c:pt>
                <c:pt idx="760">
                  <c:v>0.35610000000000003</c:v>
                </c:pt>
                <c:pt idx="761">
                  <c:v>0.30919999999999997</c:v>
                </c:pt>
                <c:pt idx="762">
                  <c:v>0.31809999999999999</c:v>
                </c:pt>
                <c:pt idx="763">
                  <c:v>0.34849999999999998</c:v>
                </c:pt>
                <c:pt idx="764">
                  <c:v>0.312</c:v>
                </c:pt>
                <c:pt idx="765">
                  <c:v>0.28110000000000002</c:v>
                </c:pt>
                <c:pt idx="766">
                  <c:v>0.32240000000000002</c:v>
                </c:pt>
                <c:pt idx="767">
                  <c:v>0.33090000000000003</c:v>
                </c:pt>
                <c:pt idx="768">
                  <c:v>0.28660000000000002</c:v>
                </c:pt>
                <c:pt idx="769">
                  <c:v>0.29620000000000002</c:v>
                </c:pt>
                <c:pt idx="770">
                  <c:v>0.34370000000000001</c:v>
                </c:pt>
                <c:pt idx="771">
                  <c:v>0.33460000000000001</c:v>
                </c:pt>
                <c:pt idx="772">
                  <c:v>0.29430000000000001</c:v>
                </c:pt>
                <c:pt idx="773">
                  <c:v>0.29949999999999999</c:v>
                </c:pt>
                <c:pt idx="774">
                  <c:v>0.28920000000000001</c:v>
                </c:pt>
                <c:pt idx="775">
                  <c:v>0.255</c:v>
                </c:pt>
                <c:pt idx="776">
                  <c:v>0.25230000000000002</c:v>
                </c:pt>
                <c:pt idx="777">
                  <c:v>0.27110000000000001</c:v>
                </c:pt>
                <c:pt idx="778">
                  <c:v>0.24390000000000001</c:v>
                </c:pt>
                <c:pt idx="779">
                  <c:v>0.2089</c:v>
                </c:pt>
                <c:pt idx="780">
                  <c:v>0.18190000000000001</c:v>
                </c:pt>
                <c:pt idx="781">
                  <c:v>0.20039999999999999</c:v>
                </c:pt>
                <c:pt idx="782">
                  <c:v>0.17749999999999999</c:v>
                </c:pt>
                <c:pt idx="783">
                  <c:v>0.16769999999999999</c:v>
                </c:pt>
                <c:pt idx="784">
                  <c:v>0.19670000000000001</c:v>
                </c:pt>
                <c:pt idx="785">
                  <c:v>0.2145</c:v>
                </c:pt>
                <c:pt idx="786">
                  <c:v>0.20330000000000001</c:v>
                </c:pt>
                <c:pt idx="787">
                  <c:v>0.2084</c:v>
                </c:pt>
                <c:pt idx="788">
                  <c:v>0.24360000000000001</c:v>
                </c:pt>
                <c:pt idx="789">
                  <c:v>0.26400000000000001</c:v>
                </c:pt>
                <c:pt idx="790">
                  <c:v>0.25580000000000003</c:v>
                </c:pt>
                <c:pt idx="791">
                  <c:v>0.26379999999999998</c:v>
                </c:pt>
                <c:pt idx="792">
                  <c:v>0.30309999999999998</c:v>
                </c:pt>
                <c:pt idx="793">
                  <c:v>0.31230000000000002</c:v>
                </c:pt>
                <c:pt idx="794">
                  <c:v>0.30159999999999998</c:v>
                </c:pt>
                <c:pt idx="795">
                  <c:v>0.32329999999999998</c:v>
                </c:pt>
                <c:pt idx="796">
                  <c:v>0.35520000000000002</c:v>
                </c:pt>
                <c:pt idx="797">
                  <c:v>0.35399999999999998</c:v>
                </c:pt>
                <c:pt idx="798">
                  <c:v>0.34649999999999997</c:v>
                </c:pt>
                <c:pt idx="799">
                  <c:v>0.3463</c:v>
                </c:pt>
                <c:pt idx="800">
                  <c:v>0.31680000000000003</c:v>
                </c:pt>
                <c:pt idx="801">
                  <c:v>0.28539999999999999</c:v>
                </c:pt>
                <c:pt idx="802">
                  <c:v>0.24440000000000001</c:v>
                </c:pt>
                <c:pt idx="803">
                  <c:v>0.25559999999999999</c:v>
                </c:pt>
                <c:pt idx="804">
                  <c:v>0.28179999999999999</c:v>
                </c:pt>
                <c:pt idx="805">
                  <c:v>0.25390000000000001</c:v>
                </c:pt>
                <c:pt idx="806">
                  <c:v>0.2235</c:v>
                </c:pt>
                <c:pt idx="807">
                  <c:v>0.25700000000000001</c:v>
                </c:pt>
                <c:pt idx="808">
                  <c:v>0.26860000000000001</c:v>
                </c:pt>
                <c:pt idx="809">
                  <c:v>0.2258</c:v>
                </c:pt>
                <c:pt idx="810">
                  <c:v>0.22819999999999999</c:v>
                </c:pt>
                <c:pt idx="811">
                  <c:v>0.27060000000000001</c:v>
                </c:pt>
                <c:pt idx="812">
                  <c:v>0.25190000000000001</c:v>
                </c:pt>
                <c:pt idx="813">
                  <c:v>0.2535</c:v>
                </c:pt>
                <c:pt idx="814">
                  <c:v>0.2132</c:v>
                </c:pt>
                <c:pt idx="815">
                  <c:v>0.17749999999999999</c:v>
                </c:pt>
                <c:pt idx="816">
                  <c:v>0.1454</c:v>
                </c:pt>
                <c:pt idx="817">
                  <c:v>0.19120000000000001</c:v>
                </c:pt>
                <c:pt idx="818">
                  <c:v>0.19040000000000001</c:v>
                </c:pt>
                <c:pt idx="819">
                  <c:v>0.15989999999999999</c:v>
                </c:pt>
                <c:pt idx="820">
                  <c:v>0.17649999999999999</c:v>
                </c:pt>
                <c:pt idx="821">
                  <c:v>0.18720000000000001</c:v>
                </c:pt>
                <c:pt idx="822">
                  <c:v>0.19980000000000001</c:v>
                </c:pt>
                <c:pt idx="823">
                  <c:v>0.1898</c:v>
                </c:pt>
                <c:pt idx="824">
                  <c:v>0.2112</c:v>
                </c:pt>
                <c:pt idx="825">
                  <c:v>0.26269999999999999</c:v>
                </c:pt>
                <c:pt idx="826">
                  <c:v>0.3498</c:v>
                </c:pt>
                <c:pt idx="827">
                  <c:v>0.47639999999999999</c:v>
                </c:pt>
                <c:pt idx="828">
                  <c:v>0.57669999999999999</c:v>
                </c:pt>
                <c:pt idx="829">
                  <c:v>0.49399999999999999</c:v>
                </c:pt>
                <c:pt idx="830">
                  <c:v>0.46289999999999998</c:v>
                </c:pt>
                <c:pt idx="831">
                  <c:v>0.62450000000000006</c:v>
                </c:pt>
                <c:pt idx="832">
                  <c:v>0.6583</c:v>
                </c:pt>
                <c:pt idx="833">
                  <c:v>0.57420000000000004</c:v>
                </c:pt>
                <c:pt idx="834">
                  <c:v>0.61419999999999997</c:v>
                </c:pt>
                <c:pt idx="835">
                  <c:v>0.50070000000000003</c:v>
                </c:pt>
                <c:pt idx="836">
                  <c:v>0.56289999999999996</c:v>
                </c:pt>
                <c:pt idx="837">
                  <c:v>0.5101</c:v>
                </c:pt>
                <c:pt idx="838">
                  <c:v>0.40949999999999998</c:v>
                </c:pt>
                <c:pt idx="839">
                  <c:v>0.32540000000000002</c:v>
                </c:pt>
                <c:pt idx="840">
                  <c:v>0.2457</c:v>
                </c:pt>
                <c:pt idx="841">
                  <c:v>0.22170000000000001</c:v>
                </c:pt>
                <c:pt idx="842">
                  <c:v>0.21060000000000001</c:v>
                </c:pt>
                <c:pt idx="843">
                  <c:v>0.18970000000000001</c:v>
                </c:pt>
                <c:pt idx="844">
                  <c:v>0.21479999999999999</c:v>
                </c:pt>
                <c:pt idx="845">
                  <c:v>0.22020000000000001</c:v>
                </c:pt>
                <c:pt idx="846">
                  <c:v>0.19839999999999999</c:v>
                </c:pt>
                <c:pt idx="847">
                  <c:v>0.2074</c:v>
                </c:pt>
                <c:pt idx="848">
                  <c:v>0.23230000000000001</c:v>
                </c:pt>
                <c:pt idx="849">
                  <c:v>0.24299999999999999</c:v>
                </c:pt>
                <c:pt idx="850">
                  <c:v>0.2293</c:v>
                </c:pt>
                <c:pt idx="851">
                  <c:v>0.22140000000000001</c:v>
                </c:pt>
                <c:pt idx="852">
                  <c:v>0.24310000000000001</c:v>
                </c:pt>
                <c:pt idx="853">
                  <c:v>0.26679999999999998</c:v>
                </c:pt>
                <c:pt idx="854">
                  <c:v>0.26939999999999997</c:v>
                </c:pt>
                <c:pt idx="855">
                  <c:v>0.27229999999999999</c:v>
                </c:pt>
                <c:pt idx="856">
                  <c:v>0.29349999999999998</c:v>
                </c:pt>
                <c:pt idx="857">
                  <c:v>0.32740000000000002</c:v>
                </c:pt>
                <c:pt idx="858">
                  <c:v>0.32240000000000002</c:v>
                </c:pt>
                <c:pt idx="859">
                  <c:v>0.31209999999999999</c:v>
                </c:pt>
                <c:pt idx="860">
                  <c:v>0.34970000000000001</c:v>
                </c:pt>
                <c:pt idx="861">
                  <c:v>0.37340000000000001</c:v>
                </c:pt>
                <c:pt idx="862">
                  <c:v>0.3624</c:v>
                </c:pt>
                <c:pt idx="863">
                  <c:v>0.37440000000000001</c:v>
                </c:pt>
                <c:pt idx="864">
                  <c:v>0.38579999999999998</c:v>
                </c:pt>
                <c:pt idx="865">
                  <c:v>0.39410000000000001</c:v>
                </c:pt>
                <c:pt idx="866">
                  <c:v>0.43909999999999999</c:v>
                </c:pt>
                <c:pt idx="867">
                  <c:v>0.47860000000000003</c:v>
                </c:pt>
                <c:pt idx="868">
                  <c:v>0.51219999999999999</c:v>
                </c:pt>
                <c:pt idx="869">
                  <c:v>0.57930000000000004</c:v>
                </c:pt>
                <c:pt idx="870">
                  <c:v>0.56210000000000004</c:v>
                </c:pt>
                <c:pt idx="871">
                  <c:v>0.54039999999999999</c:v>
                </c:pt>
                <c:pt idx="872">
                  <c:v>0.61019999999999996</c:v>
                </c:pt>
                <c:pt idx="873">
                  <c:v>0.67400000000000004</c:v>
                </c:pt>
                <c:pt idx="874">
                  <c:v>0.6744</c:v>
                </c:pt>
                <c:pt idx="875">
                  <c:v>0.69110000000000005</c:v>
                </c:pt>
                <c:pt idx="876">
                  <c:v>0.78839999999999999</c:v>
                </c:pt>
                <c:pt idx="877">
                  <c:v>0.82679999999999998</c:v>
                </c:pt>
                <c:pt idx="878">
                  <c:v>0.86639999999999995</c:v>
                </c:pt>
                <c:pt idx="879">
                  <c:v>0.95499999999999996</c:v>
                </c:pt>
                <c:pt idx="880">
                  <c:v>0.94269999999999998</c:v>
                </c:pt>
                <c:pt idx="881">
                  <c:v>0.89059999999999995</c:v>
                </c:pt>
                <c:pt idx="882">
                  <c:v>0.87709999999999999</c:v>
                </c:pt>
                <c:pt idx="883">
                  <c:v>0.85609999999999997</c:v>
                </c:pt>
                <c:pt idx="884">
                  <c:v>0.8286</c:v>
                </c:pt>
                <c:pt idx="885">
                  <c:v>0.79430000000000001</c:v>
                </c:pt>
                <c:pt idx="886">
                  <c:v>0.76529999999999998</c:v>
                </c:pt>
                <c:pt idx="887">
                  <c:v>0.66859999999999997</c:v>
                </c:pt>
                <c:pt idx="888">
                  <c:v>0.53420000000000001</c:v>
                </c:pt>
                <c:pt idx="889">
                  <c:v>0.48249999999999998</c:v>
                </c:pt>
                <c:pt idx="890">
                  <c:v>0.39989999999999998</c:v>
                </c:pt>
                <c:pt idx="891">
                  <c:v>0.37980000000000003</c:v>
                </c:pt>
                <c:pt idx="892">
                  <c:v>0.41170000000000001</c:v>
                </c:pt>
                <c:pt idx="893">
                  <c:v>0.36199999999999999</c:v>
                </c:pt>
                <c:pt idx="894">
                  <c:v>0.36940000000000001</c:v>
                </c:pt>
                <c:pt idx="895">
                  <c:v>0.377</c:v>
                </c:pt>
                <c:pt idx="896">
                  <c:v>0.35599999999999998</c:v>
                </c:pt>
                <c:pt idx="897">
                  <c:v>0.39179999999999998</c:v>
                </c:pt>
                <c:pt idx="898">
                  <c:v>0.48</c:v>
                </c:pt>
                <c:pt idx="899">
                  <c:v>0.52800000000000002</c:v>
                </c:pt>
                <c:pt idx="900">
                  <c:v>0.56440000000000001</c:v>
                </c:pt>
                <c:pt idx="901">
                  <c:v>0.57720000000000005</c:v>
                </c:pt>
                <c:pt idx="902">
                  <c:v>0.59509999999999996</c:v>
                </c:pt>
                <c:pt idx="903">
                  <c:v>0.60829999999999995</c:v>
                </c:pt>
                <c:pt idx="904">
                  <c:v>0.64939999999999998</c:v>
                </c:pt>
                <c:pt idx="905">
                  <c:v>0.63439999999999996</c:v>
                </c:pt>
                <c:pt idx="906">
                  <c:v>0.58909999999999996</c:v>
                </c:pt>
                <c:pt idx="907">
                  <c:v>0.5847</c:v>
                </c:pt>
                <c:pt idx="908">
                  <c:v>0.56359999999999999</c:v>
                </c:pt>
                <c:pt idx="909">
                  <c:v>0.56579999999999997</c:v>
                </c:pt>
                <c:pt idx="910">
                  <c:v>0.56740000000000002</c:v>
                </c:pt>
                <c:pt idx="911">
                  <c:v>0.57969999999999999</c:v>
                </c:pt>
                <c:pt idx="912">
                  <c:v>0.55179999999999996</c:v>
                </c:pt>
                <c:pt idx="913">
                  <c:v>0.71750000000000003</c:v>
                </c:pt>
                <c:pt idx="914">
                  <c:v>0.81820000000000004</c:v>
                </c:pt>
                <c:pt idx="915">
                  <c:v>0.77480000000000004</c:v>
                </c:pt>
                <c:pt idx="916">
                  <c:v>0.61160000000000003</c:v>
                </c:pt>
                <c:pt idx="917">
                  <c:v>0.60429999999999995</c:v>
                </c:pt>
                <c:pt idx="918">
                  <c:v>0.7036</c:v>
                </c:pt>
                <c:pt idx="919">
                  <c:v>0.63539999999999996</c:v>
                </c:pt>
                <c:pt idx="920">
                  <c:v>0.59799999999999998</c:v>
                </c:pt>
                <c:pt idx="921">
                  <c:v>0.72399999999999998</c:v>
                </c:pt>
                <c:pt idx="922">
                  <c:v>0.79430000000000001</c:v>
                </c:pt>
                <c:pt idx="923">
                  <c:v>0.85209999999999997</c:v>
                </c:pt>
                <c:pt idx="924">
                  <c:v>0.94479999999999997</c:v>
                </c:pt>
                <c:pt idx="925">
                  <c:v>0.92459999999999998</c:v>
                </c:pt>
                <c:pt idx="926">
                  <c:v>0.95479999999999998</c:v>
                </c:pt>
                <c:pt idx="927">
                  <c:v>0.89770000000000005</c:v>
                </c:pt>
                <c:pt idx="928">
                  <c:v>0.99329999999999996</c:v>
                </c:pt>
                <c:pt idx="929">
                  <c:v>0.94599999999999995</c:v>
                </c:pt>
                <c:pt idx="930">
                  <c:v>1.0255000000000001</c:v>
                </c:pt>
                <c:pt idx="931">
                  <c:v>1.0398000000000001</c:v>
                </c:pt>
                <c:pt idx="932">
                  <c:v>1.1631</c:v>
                </c:pt>
                <c:pt idx="933">
                  <c:v>1.2432000000000001</c:v>
                </c:pt>
                <c:pt idx="934">
                  <c:v>1.2683</c:v>
                </c:pt>
                <c:pt idx="935">
                  <c:v>1.2538</c:v>
                </c:pt>
                <c:pt idx="936">
                  <c:v>1.3069</c:v>
                </c:pt>
                <c:pt idx="937">
                  <c:v>1.4171</c:v>
                </c:pt>
                <c:pt idx="938">
                  <c:v>1.4463999999999999</c:v>
                </c:pt>
                <c:pt idx="939">
                  <c:v>1.5339</c:v>
                </c:pt>
                <c:pt idx="940">
                  <c:v>1.5959000000000001</c:v>
                </c:pt>
                <c:pt idx="941">
                  <c:v>1.6587000000000001</c:v>
                </c:pt>
                <c:pt idx="942">
                  <c:v>1.8425</c:v>
                </c:pt>
                <c:pt idx="943">
                  <c:v>1.8594999999999999</c:v>
                </c:pt>
                <c:pt idx="944">
                  <c:v>1.9717</c:v>
                </c:pt>
                <c:pt idx="945">
                  <c:v>1.9301999999999999</c:v>
                </c:pt>
                <c:pt idx="946">
                  <c:v>1.8206</c:v>
                </c:pt>
                <c:pt idx="947">
                  <c:v>1.8880999999999999</c:v>
                </c:pt>
                <c:pt idx="948">
                  <c:v>1.9641</c:v>
                </c:pt>
                <c:pt idx="949">
                  <c:v>1.8721000000000001</c:v>
                </c:pt>
                <c:pt idx="950">
                  <c:v>1.8183</c:v>
                </c:pt>
                <c:pt idx="951">
                  <c:v>1.9359</c:v>
                </c:pt>
                <c:pt idx="952">
                  <c:v>1.9577</c:v>
                </c:pt>
                <c:pt idx="953">
                  <c:v>1.8459000000000001</c:v>
                </c:pt>
                <c:pt idx="954">
                  <c:v>1.8693</c:v>
                </c:pt>
                <c:pt idx="955">
                  <c:v>1.9944</c:v>
                </c:pt>
                <c:pt idx="956">
                  <c:v>1.9674</c:v>
                </c:pt>
                <c:pt idx="957">
                  <c:v>1.8847</c:v>
                </c:pt>
                <c:pt idx="958">
                  <c:v>1.9713000000000001</c:v>
                </c:pt>
                <c:pt idx="959">
                  <c:v>2.0537000000000001</c:v>
                </c:pt>
                <c:pt idx="960">
                  <c:v>2.0087999999999999</c:v>
                </c:pt>
                <c:pt idx="961">
                  <c:v>2.0074999999999998</c:v>
                </c:pt>
                <c:pt idx="962">
                  <c:v>1.9917</c:v>
                </c:pt>
                <c:pt idx="963">
                  <c:v>1.9376</c:v>
                </c:pt>
                <c:pt idx="964">
                  <c:v>1.9386000000000001</c:v>
                </c:pt>
                <c:pt idx="965">
                  <c:v>1.9365000000000001</c:v>
                </c:pt>
                <c:pt idx="966">
                  <c:v>1.9342999999999999</c:v>
                </c:pt>
                <c:pt idx="967">
                  <c:v>1.9556</c:v>
                </c:pt>
                <c:pt idx="968">
                  <c:v>1.9694</c:v>
                </c:pt>
                <c:pt idx="969">
                  <c:v>1.9703999999999999</c:v>
                </c:pt>
                <c:pt idx="970">
                  <c:v>1.9888999999999999</c:v>
                </c:pt>
                <c:pt idx="971">
                  <c:v>2.0377999999999998</c:v>
                </c:pt>
                <c:pt idx="972">
                  <c:v>2.0106000000000002</c:v>
                </c:pt>
                <c:pt idx="973">
                  <c:v>1.9593</c:v>
                </c:pt>
                <c:pt idx="974">
                  <c:v>2.0350000000000001</c:v>
                </c:pt>
                <c:pt idx="975">
                  <c:v>2.0305</c:v>
                </c:pt>
                <c:pt idx="976">
                  <c:v>2.1297000000000001</c:v>
                </c:pt>
                <c:pt idx="977">
                  <c:v>2.0569000000000002</c:v>
                </c:pt>
                <c:pt idx="978">
                  <c:v>1.9551000000000001</c:v>
                </c:pt>
                <c:pt idx="979">
                  <c:v>2.0436000000000001</c:v>
                </c:pt>
                <c:pt idx="980">
                  <c:v>2.1349</c:v>
                </c:pt>
                <c:pt idx="981">
                  <c:v>2.0577999999999999</c:v>
                </c:pt>
                <c:pt idx="982">
                  <c:v>2.0428999999999999</c:v>
                </c:pt>
                <c:pt idx="983">
                  <c:v>2.1825000000000001</c:v>
                </c:pt>
                <c:pt idx="984">
                  <c:v>2.2465000000000002</c:v>
                </c:pt>
                <c:pt idx="985">
                  <c:v>2.1991999999999998</c:v>
                </c:pt>
                <c:pt idx="986">
                  <c:v>2.2679</c:v>
                </c:pt>
                <c:pt idx="987">
                  <c:v>2.4302999999999999</c:v>
                </c:pt>
                <c:pt idx="988">
                  <c:v>2.4664000000000001</c:v>
                </c:pt>
                <c:pt idx="989">
                  <c:v>2.4735</c:v>
                </c:pt>
                <c:pt idx="990">
                  <c:v>2.5996000000000001</c:v>
                </c:pt>
                <c:pt idx="991">
                  <c:v>2.512</c:v>
                </c:pt>
                <c:pt idx="992">
                  <c:v>2.5415000000000001</c:v>
                </c:pt>
                <c:pt idx="993">
                  <c:v>2.5745</c:v>
                </c:pt>
                <c:pt idx="994">
                  <c:v>2.6185</c:v>
                </c:pt>
                <c:pt idx="995">
                  <c:v>2.6823000000000001</c:v>
                </c:pt>
                <c:pt idx="996">
                  <c:v>2.7288999999999999</c:v>
                </c:pt>
                <c:pt idx="997">
                  <c:v>2.8329</c:v>
                </c:pt>
                <c:pt idx="998">
                  <c:v>2.9237000000000002</c:v>
                </c:pt>
                <c:pt idx="999">
                  <c:v>2.9184999999999999</c:v>
                </c:pt>
                <c:pt idx="1000">
                  <c:v>2.9647999999999999</c:v>
                </c:pt>
                <c:pt idx="1001">
                  <c:v>3.0188999999999999</c:v>
                </c:pt>
                <c:pt idx="1002">
                  <c:v>3.1166999999999998</c:v>
                </c:pt>
                <c:pt idx="1003">
                  <c:v>3.2193000000000001</c:v>
                </c:pt>
                <c:pt idx="1004">
                  <c:v>3.2988</c:v>
                </c:pt>
                <c:pt idx="1005">
                  <c:v>3.2629000000000001</c:v>
                </c:pt>
                <c:pt idx="1006">
                  <c:v>3.2621000000000002</c:v>
                </c:pt>
                <c:pt idx="1007">
                  <c:v>3.3433999999999999</c:v>
                </c:pt>
                <c:pt idx="1008">
                  <c:v>3.3803999999999998</c:v>
                </c:pt>
                <c:pt idx="1009">
                  <c:v>3.5063</c:v>
                </c:pt>
                <c:pt idx="1010">
                  <c:v>3.5674000000000001</c:v>
                </c:pt>
                <c:pt idx="1011">
                  <c:v>3.6135000000000002</c:v>
                </c:pt>
                <c:pt idx="1012">
                  <c:v>3.7065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B0A-42E6-B07E-7FDA21594A85}"/>
            </c:ext>
          </c:extLst>
        </c:ser>
        <c:ser>
          <c:idx val="6"/>
          <c:order val="6"/>
          <c:tx>
            <c:strRef>
              <c:f>Sheet3!$H$3</c:f>
              <c:strCache>
                <c:ptCount val="1"/>
                <c:pt idx="0">
                  <c:v>Series6</c:v>
                </c:pt>
              </c:strCache>
            </c:strRef>
          </c:tx>
          <c:spPr>
            <a:ln w="12700" cap="rnd">
              <a:solidFill>
                <a:srgbClr val="FFCC00"/>
              </a:solidFill>
              <a:round/>
            </a:ln>
            <a:effectLst/>
          </c:spPr>
          <c:marker>
            <c:symbol val="none"/>
          </c:marker>
          <c:val>
            <c:numRef>
              <c:f>Sheet3!$H$4:$H$1016</c:f>
              <c:numCache>
                <c:formatCode>General</c:formatCode>
                <c:ptCount val="1013"/>
                <c:pt idx="0">
                  <c:v>2.7383999999999999</c:v>
                </c:pt>
                <c:pt idx="1">
                  <c:v>2.6223999999999998</c:v>
                </c:pt>
                <c:pt idx="2">
                  <c:v>2.4315000000000002</c:v>
                </c:pt>
                <c:pt idx="3">
                  <c:v>2.2252000000000001</c:v>
                </c:pt>
                <c:pt idx="4">
                  <c:v>1.9899</c:v>
                </c:pt>
                <c:pt idx="5">
                  <c:v>1.8202</c:v>
                </c:pt>
                <c:pt idx="6">
                  <c:v>1.6863999999999999</c:v>
                </c:pt>
                <c:pt idx="7">
                  <c:v>1.5165999999999999</c:v>
                </c:pt>
                <c:pt idx="8">
                  <c:v>1.3258000000000001</c:v>
                </c:pt>
                <c:pt idx="9">
                  <c:v>1.1851</c:v>
                </c:pt>
                <c:pt idx="10">
                  <c:v>0.99209999999999998</c:v>
                </c:pt>
                <c:pt idx="11">
                  <c:v>0.87509999999999999</c:v>
                </c:pt>
                <c:pt idx="12">
                  <c:v>0.66369999999999996</c:v>
                </c:pt>
                <c:pt idx="13">
                  <c:v>0.58350000000000002</c:v>
                </c:pt>
                <c:pt idx="14">
                  <c:v>0.53700000000000003</c:v>
                </c:pt>
                <c:pt idx="15">
                  <c:v>0.39450000000000002</c:v>
                </c:pt>
                <c:pt idx="16">
                  <c:v>0.39090000000000003</c:v>
                </c:pt>
                <c:pt idx="17">
                  <c:v>0.38769999999999999</c:v>
                </c:pt>
                <c:pt idx="18">
                  <c:v>0.34799999999999998</c:v>
                </c:pt>
                <c:pt idx="19">
                  <c:v>0.34610000000000002</c:v>
                </c:pt>
                <c:pt idx="20">
                  <c:v>0.3679</c:v>
                </c:pt>
                <c:pt idx="21">
                  <c:v>0.34449999999999997</c:v>
                </c:pt>
                <c:pt idx="22">
                  <c:v>0.3095</c:v>
                </c:pt>
                <c:pt idx="23">
                  <c:v>0.33260000000000001</c:v>
                </c:pt>
                <c:pt idx="24">
                  <c:v>0.3407</c:v>
                </c:pt>
                <c:pt idx="25">
                  <c:v>0.29849999999999999</c:v>
                </c:pt>
                <c:pt idx="26">
                  <c:v>0.29220000000000002</c:v>
                </c:pt>
                <c:pt idx="27">
                  <c:v>0.3271</c:v>
                </c:pt>
                <c:pt idx="28">
                  <c:v>0.33460000000000001</c:v>
                </c:pt>
                <c:pt idx="29">
                  <c:v>0.29859999999999998</c:v>
                </c:pt>
                <c:pt idx="30">
                  <c:v>0.27129999999999999</c:v>
                </c:pt>
                <c:pt idx="31">
                  <c:v>0.30049999999999999</c:v>
                </c:pt>
                <c:pt idx="32">
                  <c:v>0.29620000000000002</c:v>
                </c:pt>
                <c:pt idx="33">
                  <c:v>0.3271</c:v>
                </c:pt>
                <c:pt idx="34">
                  <c:v>0.35510000000000003</c:v>
                </c:pt>
                <c:pt idx="35">
                  <c:v>0.34399999999999997</c:v>
                </c:pt>
                <c:pt idx="36">
                  <c:v>0.2989</c:v>
                </c:pt>
                <c:pt idx="37">
                  <c:v>0.31159999999999999</c:v>
                </c:pt>
                <c:pt idx="38">
                  <c:v>0.33289999999999997</c:v>
                </c:pt>
                <c:pt idx="39">
                  <c:v>0.29970000000000002</c:v>
                </c:pt>
                <c:pt idx="40">
                  <c:v>0.27789999999999998</c:v>
                </c:pt>
                <c:pt idx="41">
                  <c:v>0.31240000000000001</c:v>
                </c:pt>
                <c:pt idx="42">
                  <c:v>0.31469999999999998</c:v>
                </c:pt>
                <c:pt idx="43">
                  <c:v>0.27460000000000001</c:v>
                </c:pt>
                <c:pt idx="44">
                  <c:v>0.28470000000000001</c:v>
                </c:pt>
                <c:pt idx="45">
                  <c:v>0.31990000000000002</c:v>
                </c:pt>
                <c:pt idx="46">
                  <c:v>0.29859999999999998</c:v>
                </c:pt>
                <c:pt idx="47">
                  <c:v>0.2722</c:v>
                </c:pt>
                <c:pt idx="48">
                  <c:v>0.30790000000000001</c:v>
                </c:pt>
                <c:pt idx="49">
                  <c:v>0.31090000000000001</c:v>
                </c:pt>
                <c:pt idx="50">
                  <c:v>0.27200000000000002</c:v>
                </c:pt>
                <c:pt idx="51">
                  <c:v>0.27879999999999999</c:v>
                </c:pt>
                <c:pt idx="52">
                  <c:v>0.31569999999999998</c:v>
                </c:pt>
                <c:pt idx="53">
                  <c:v>0.29909999999999998</c:v>
                </c:pt>
                <c:pt idx="54">
                  <c:v>0.2727</c:v>
                </c:pt>
                <c:pt idx="55">
                  <c:v>0.30109999999999998</c:v>
                </c:pt>
                <c:pt idx="56">
                  <c:v>0.31080000000000002</c:v>
                </c:pt>
                <c:pt idx="57">
                  <c:v>0.26919999999999999</c:v>
                </c:pt>
                <c:pt idx="58">
                  <c:v>0.254</c:v>
                </c:pt>
                <c:pt idx="59">
                  <c:v>0.26869999999999999</c:v>
                </c:pt>
                <c:pt idx="60">
                  <c:v>0.32169999999999999</c:v>
                </c:pt>
                <c:pt idx="61">
                  <c:v>0.37280000000000002</c:v>
                </c:pt>
                <c:pt idx="62">
                  <c:v>0.34920000000000001</c:v>
                </c:pt>
                <c:pt idx="63">
                  <c:v>0.35189999999999999</c:v>
                </c:pt>
                <c:pt idx="64">
                  <c:v>0.33200000000000002</c:v>
                </c:pt>
                <c:pt idx="65">
                  <c:v>0.29099999999999998</c:v>
                </c:pt>
                <c:pt idx="66">
                  <c:v>0.28199999999999997</c:v>
                </c:pt>
                <c:pt idx="67">
                  <c:v>0.29139999999999999</c:v>
                </c:pt>
                <c:pt idx="68">
                  <c:v>0.26400000000000001</c:v>
                </c:pt>
                <c:pt idx="69">
                  <c:v>0.23680000000000001</c:v>
                </c:pt>
                <c:pt idx="70">
                  <c:v>0.24410000000000001</c:v>
                </c:pt>
                <c:pt idx="71">
                  <c:v>0.248</c:v>
                </c:pt>
                <c:pt idx="72">
                  <c:v>0.2137</c:v>
                </c:pt>
                <c:pt idx="73">
                  <c:v>0.19800000000000001</c:v>
                </c:pt>
                <c:pt idx="74">
                  <c:v>0.2248</c:v>
                </c:pt>
                <c:pt idx="75">
                  <c:v>0.22159999999999999</c:v>
                </c:pt>
                <c:pt idx="76">
                  <c:v>0.19350000000000001</c:v>
                </c:pt>
                <c:pt idx="77">
                  <c:v>0.2026</c:v>
                </c:pt>
                <c:pt idx="78">
                  <c:v>0.22620000000000001</c:v>
                </c:pt>
                <c:pt idx="79">
                  <c:v>0.21510000000000001</c:v>
                </c:pt>
                <c:pt idx="80">
                  <c:v>0.20780000000000001</c:v>
                </c:pt>
                <c:pt idx="81">
                  <c:v>0.2263</c:v>
                </c:pt>
                <c:pt idx="82">
                  <c:v>0.25850000000000001</c:v>
                </c:pt>
                <c:pt idx="83">
                  <c:v>0.31409999999999999</c:v>
                </c:pt>
                <c:pt idx="84">
                  <c:v>0.39150000000000001</c:v>
                </c:pt>
                <c:pt idx="85">
                  <c:v>0.48880000000000001</c:v>
                </c:pt>
                <c:pt idx="86">
                  <c:v>0.60570000000000002</c:v>
                </c:pt>
                <c:pt idx="87">
                  <c:v>0.71109999999999995</c:v>
                </c:pt>
                <c:pt idx="88">
                  <c:v>0.78010000000000002</c:v>
                </c:pt>
                <c:pt idx="89">
                  <c:v>0.93310000000000004</c:v>
                </c:pt>
                <c:pt idx="90">
                  <c:v>0.96899999999999997</c:v>
                </c:pt>
                <c:pt idx="91">
                  <c:v>0.9849</c:v>
                </c:pt>
                <c:pt idx="92">
                  <c:v>0.80930000000000002</c:v>
                </c:pt>
                <c:pt idx="93">
                  <c:v>0.73399999999999999</c:v>
                </c:pt>
                <c:pt idx="94">
                  <c:v>0.747</c:v>
                </c:pt>
                <c:pt idx="95">
                  <c:v>0.68799999999999994</c:v>
                </c:pt>
                <c:pt idx="96">
                  <c:v>0.54600000000000004</c:v>
                </c:pt>
                <c:pt idx="97">
                  <c:v>0.32990000000000003</c:v>
                </c:pt>
                <c:pt idx="98">
                  <c:v>0.23860000000000001</c:v>
                </c:pt>
                <c:pt idx="99">
                  <c:v>0.2056</c:v>
                </c:pt>
                <c:pt idx="100">
                  <c:v>0.19159999999999999</c:v>
                </c:pt>
                <c:pt idx="101">
                  <c:v>0.1948</c:v>
                </c:pt>
                <c:pt idx="102">
                  <c:v>0.2112</c:v>
                </c:pt>
                <c:pt idx="103">
                  <c:v>0.20799999999999999</c:v>
                </c:pt>
                <c:pt idx="104">
                  <c:v>0.20649999999999999</c:v>
                </c:pt>
                <c:pt idx="105">
                  <c:v>0.2253</c:v>
                </c:pt>
                <c:pt idx="106">
                  <c:v>0.24149999999999999</c:v>
                </c:pt>
                <c:pt idx="107">
                  <c:v>0.2452</c:v>
                </c:pt>
                <c:pt idx="108">
                  <c:v>0.2477</c:v>
                </c:pt>
                <c:pt idx="109">
                  <c:v>0.2258</c:v>
                </c:pt>
                <c:pt idx="110">
                  <c:v>0.22309999999999999</c:v>
                </c:pt>
                <c:pt idx="111">
                  <c:v>0.1769</c:v>
                </c:pt>
                <c:pt idx="112">
                  <c:v>0.186</c:v>
                </c:pt>
                <c:pt idx="113">
                  <c:v>0.2155</c:v>
                </c:pt>
                <c:pt idx="114">
                  <c:v>0.19389999999999999</c:v>
                </c:pt>
                <c:pt idx="115">
                  <c:v>0.1716</c:v>
                </c:pt>
                <c:pt idx="116">
                  <c:v>0.20250000000000001</c:v>
                </c:pt>
                <c:pt idx="117">
                  <c:v>0.20549999999999999</c:v>
                </c:pt>
                <c:pt idx="118">
                  <c:v>0.1726</c:v>
                </c:pt>
                <c:pt idx="119">
                  <c:v>0.17180000000000001</c:v>
                </c:pt>
                <c:pt idx="120">
                  <c:v>0.19570000000000001</c:v>
                </c:pt>
                <c:pt idx="121">
                  <c:v>0.19189999999999999</c:v>
                </c:pt>
                <c:pt idx="122">
                  <c:v>0.1739</c:v>
                </c:pt>
                <c:pt idx="123">
                  <c:v>0.18609999999999999</c:v>
                </c:pt>
                <c:pt idx="124">
                  <c:v>0.21460000000000001</c:v>
                </c:pt>
                <c:pt idx="125">
                  <c:v>0.21829999999999999</c:v>
                </c:pt>
                <c:pt idx="126">
                  <c:v>0.21329999999999999</c:v>
                </c:pt>
                <c:pt idx="127">
                  <c:v>0.2462</c:v>
                </c:pt>
                <c:pt idx="128">
                  <c:v>0.252</c:v>
                </c:pt>
                <c:pt idx="129">
                  <c:v>0.23319999999999999</c:v>
                </c:pt>
                <c:pt idx="130">
                  <c:v>0.25309999999999999</c:v>
                </c:pt>
                <c:pt idx="131">
                  <c:v>0.28439999999999999</c:v>
                </c:pt>
                <c:pt idx="132">
                  <c:v>0.28370000000000001</c:v>
                </c:pt>
                <c:pt idx="133">
                  <c:v>0.26769999999999999</c:v>
                </c:pt>
                <c:pt idx="134">
                  <c:v>0.27410000000000001</c:v>
                </c:pt>
                <c:pt idx="135">
                  <c:v>0.25800000000000001</c:v>
                </c:pt>
                <c:pt idx="136">
                  <c:v>0.23350000000000001</c:v>
                </c:pt>
                <c:pt idx="137">
                  <c:v>0.21609999999999999</c:v>
                </c:pt>
                <c:pt idx="138">
                  <c:v>0.2114</c:v>
                </c:pt>
                <c:pt idx="139">
                  <c:v>0.22259999999999999</c:v>
                </c:pt>
                <c:pt idx="140">
                  <c:v>0.2213</c:v>
                </c:pt>
                <c:pt idx="141">
                  <c:v>0.21249999999999999</c:v>
                </c:pt>
                <c:pt idx="142">
                  <c:v>0.25090000000000001</c:v>
                </c:pt>
                <c:pt idx="143">
                  <c:v>0.1346</c:v>
                </c:pt>
                <c:pt idx="144">
                  <c:v>0.1323</c:v>
                </c:pt>
                <c:pt idx="145">
                  <c:v>0.1285</c:v>
                </c:pt>
                <c:pt idx="146">
                  <c:v>0.12479999999999999</c:v>
                </c:pt>
                <c:pt idx="147">
                  <c:v>0.1396</c:v>
                </c:pt>
                <c:pt idx="148">
                  <c:v>0.1363</c:v>
                </c:pt>
                <c:pt idx="149">
                  <c:v>0.124</c:v>
                </c:pt>
                <c:pt idx="150">
                  <c:v>0.13739999999999999</c:v>
                </c:pt>
                <c:pt idx="151">
                  <c:v>0.15210000000000001</c:v>
                </c:pt>
                <c:pt idx="152">
                  <c:v>0.1459</c:v>
                </c:pt>
                <c:pt idx="153">
                  <c:v>0.14269999999999999</c:v>
                </c:pt>
                <c:pt idx="154">
                  <c:v>0.16639999999999999</c:v>
                </c:pt>
                <c:pt idx="155">
                  <c:v>0.1754</c:v>
                </c:pt>
                <c:pt idx="156">
                  <c:v>0.1593</c:v>
                </c:pt>
                <c:pt idx="157">
                  <c:v>0.16700000000000001</c:v>
                </c:pt>
                <c:pt idx="158">
                  <c:v>0.1958</c:v>
                </c:pt>
                <c:pt idx="159">
                  <c:v>0.19059999999999999</c:v>
                </c:pt>
                <c:pt idx="160">
                  <c:v>0.1779</c:v>
                </c:pt>
                <c:pt idx="161">
                  <c:v>0.1981</c:v>
                </c:pt>
                <c:pt idx="162">
                  <c:v>0.22</c:v>
                </c:pt>
                <c:pt idx="163">
                  <c:v>0.2092</c:v>
                </c:pt>
                <c:pt idx="164">
                  <c:v>0.20469999999999999</c:v>
                </c:pt>
                <c:pt idx="165">
                  <c:v>0.23400000000000001</c:v>
                </c:pt>
                <c:pt idx="166">
                  <c:v>0.2409</c:v>
                </c:pt>
                <c:pt idx="167">
                  <c:v>0.2278</c:v>
                </c:pt>
                <c:pt idx="168">
                  <c:v>0.22700000000000001</c:v>
                </c:pt>
                <c:pt idx="169">
                  <c:v>0.24690000000000001</c:v>
                </c:pt>
                <c:pt idx="170">
                  <c:v>0.28970000000000001</c:v>
                </c:pt>
                <c:pt idx="171">
                  <c:v>0.3891</c:v>
                </c:pt>
                <c:pt idx="172">
                  <c:v>0.45639999999999997</c:v>
                </c:pt>
                <c:pt idx="173">
                  <c:v>0.441</c:v>
                </c:pt>
                <c:pt idx="174">
                  <c:v>0.40639999999999998</c:v>
                </c:pt>
                <c:pt idx="175">
                  <c:v>0.46850000000000003</c:v>
                </c:pt>
                <c:pt idx="176">
                  <c:v>0.46960000000000002</c:v>
                </c:pt>
                <c:pt idx="177">
                  <c:v>0.41070000000000001</c:v>
                </c:pt>
                <c:pt idx="178">
                  <c:v>0.36370000000000002</c:v>
                </c:pt>
                <c:pt idx="179">
                  <c:v>0.3347</c:v>
                </c:pt>
                <c:pt idx="180">
                  <c:v>0.29970000000000002</c:v>
                </c:pt>
                <c:pt idx="181">
                  <c:v>0.28920000000000001</c:v>
                </c:pt>
                <c:pt idx="182">
                  <c:v>0.28620000000000001</c:v>
                </c:pt>
                <c:pt idx="183">
                  <c:v>0.26719999999999999</c:v>
                </c:pt>
                <c:pt idx="184">
                  <c:v>0.24490000000000001</c:v>
                </c:pt>
                <c:pt idx="185">
                  <c:v>0.23100000000000001</c:v>
                </c:pt>
                <c:pt idx="186">
                  <c:v>0.22289999999999999</c:v>
                </c:pt>
                <c:pt idx="187">
                  <c:v>0.20930000000000001</c:v>
                </c:pt>
                <c:pt idx="188">
                  <c:v>0.19239999999999999</c:v>
                </c:pt>
                <c:pt idx="189">
                  <c:v>0.18859999999999999</c:v>
                </c:pt>
                <c:pt idx="190">
                  <c:v>0.1827</c:v>
                </c:pt>
                <c:pt idx="191">
                  <c:v>0.16470000000000001</c:v>
                </c:pt>
                <c:pt idx="192">
                  <c:v>0.16309999999999999</c:v>
                </c:pt>
                <c:pt idx="193">
                  <c:v>0.1595</c:v>
                </c:pt>
                <c:pt idx="194">
                  <c:v>0.1464</c:v>
                </c:pt>
                <c:pt idx="195">
                  <c:v>0.14369999999999999</c:v>
                </c:pt>
                <c:pt idx="196">
                  <c:v>0.1507</c:v>
                </c:pt>
                <c:pt idx="197">
                  <c:v>0.14130000000000001</c:v>
                </c:pt>
                <c:pt idx="198">
                  <c:v>0.13120000000000001</c:v>
                </c:pt>
                <c:pt idx="199">
                  <c:v>0.14610000000000001</c:v>
                </c:pt>
                <c:pt idx="200">
                  <c:v>0.15240000000000001</c:v>
                </c:pt>
                <c:pt idx="201">
                  <c:v>0.13589999999999999</c:v>
                </c:pt>
                <c:pt idx="202">
                  <c:v>0.1426</c:v>
                </c:pt>
                <c:pt idx="203">
                  <c:v>0.15720000000000001</c:v>
                </c:pt>
                <c:pt idx="204">
                  <c:v>0.16550000000000001</c:v>
                </c:pt>
                <c:pt idx="205">
                  <c:v>0.14030000000000001</c:v>
                </c:pt>
                <c:pt idx="206">
                  <c:v>0.13150000000000001</c:v>
                </c:pt>
                <c:pt idx="207">
                  <c:v>0.1235</c:v>
                </c:pt>
                <c:pt idx="208">
                  <c:v>0.1244</c:v>
                </c:pt>
                <c:pt idx="209">
                  <c:v>0.1205</c:v>
                </c:pt>
                <c:pt idx="210">
                  <c:v>0.14680000000000001</c:v>
                </c:pt>
                <c:pt idx="211">
                  <c:v>0.15559999999999999</c:v>
                </c:pt>
                <c:pt idx="212">
                  <c:v>0.17430000000000001</c:v>
                </c:pt>
                <c:pt idx="213">
                  <c:v>0.16139999999999999</c:v>
                </c:pt>
                <c:pt idx="214">
                  <c:v>0.1449</c:v>
                </c:pt>
                <c:pt idx="215">
                  <c:v>0.16769999999999999</c:v>
                </c:pt>
                <c:pt idx="216">
                  <c:v>0.17649999999999999</c:v>
                </c:pt>
                <c:pt idx="217">
                  <c:v>0.1555</c:v>
                </c:pt>
                <c:pt idx="218">
                  <c:v>0.15920000000000001</c:v>
                </c:pt>
                <c:pt idx="219">
                  <c:v>0.18240000000000001</c:v>
                </c:pt>
                <c:pt idx="220">
                  <c:v>0.1789</c:v>
                </c:pt>
                <c:pt idx="221">
                  <c:v>0.1671</c:v>
                </c:pt>
                <c:pt idx="222">
                  <c:v>0.18279999999999999</c:v>
                </c:pt>
                <c:pt idx="223">
                  <c:v>0.1971</c:v>
                </c:pt>
                <c:pt idx="224">
                  <c:v>0.1883</c:v>
                </c:pt>
                <c:pt idx="225">
                  <c:v>0.18709999999999999</c:v>
                </c:pt>
                <c:pt idx="226">
                  <c:v>0.2077</c:v>
                </c:pt>
                <c:pt idx="227">
                  <c:v>0.2215</c:v>
                </c:pt>
                <c:pt idx="228">
                  <c:v>0.2102</c:v>
                </c:pt>
                <c:pt idx="229">
                  <c:v>0.2155</c:v>
                </c:pt>
                <c:pt idx="230">
                  <c:v>0.24010000000000001</c:v>
                </c:pt>
                <c:pt idx="231">
                  <c:v>0.25380000000000003</c:v>
                </c:pt>
                <c:pt idx="232">
                  <c:v>0.26540000000000002</c:v>
                </c:pt>
                <c:pt idx="233">
                  <c:v>0.24249999999999999</c:v>
                </c:pt>
                <c:pt idx="234">
                  <c:v>0.24349999999999999</c:v>
                </c:pt>
                <c:pt idx="235">
                  <c:v>0.2576</c:v>
                </c:pt>
                <c:pt idx="236">
                  <c:v>0.27839999999999998</c:v>
                </c:pt>
                <c:pt idx="237">
                  <c:v>0.31409999999999999</c:v>
                </c:pt>
                <c:pt idx="238">
                  <c:v>0.31690000000000002</c:v>
                </c:pt>
                <c:pt idx="239">
                  <c:v>0.36559999999999998</c:v>
                </c:pt>
                <c:pt idx="240">
                  <c:v>0.3755</c:v>
                </c:pt>
                <c:pt idx="241">
                  <c:v>0.35239999999999999</c:v>
                </c:pt>
                <c:pt idx="242">
                  <c:v>0.36890000000000001</c:v>
                </c:pt>
                <c:pt idx="243">
                  <c:v>0.33939999999999998</c:v>
                </c:pt>
                <c:pt idx="244">
                  <c:v>0.30330000000000001</c:v>
                </c:pt>
                <c:pt idx="245">
                  <c:v>0.32500000000000001</c:v>
                </c:pt>
                <c:pt idx="246">
                  <c:v>0.33800000000000002</c:v>
                </c:pt>
                <c:pt idx="247">
                  <c:v>0.3861</c:v>
                </c:pt>
                <c:pt idx="248">
                  <c:v>0.45079999999999998</c:v>
                </c:pt>
                <c:pt idx="249">
                  <c:v>0.40310000000000001</c:v>
                </c:pt>
                <c:pt idx="250">
                  <c:v>0.29820000000000002</c:v>
                </c:pt>
                <c:pt idx="251">
                  <c:v>0.32300000000000001</c:v>
                </c:pt>
                <c:pt idx="252">
                  <c:v>0.29680000000000001</c:v>
                </c:pt>
                <c:pt idx="253">
                  <c:v>0.28179999999999999</c:v>
                </c:pt>
                <c:pt idx="254">
                  <c:v>0.254</c:v>
                </c:pt>
                <c:pt idx="255">
                  <c:v>0.24610000000000001</c:v>
                </c:pt>
                <c:pt idx="256">
                  <c:v>0.27050000000000002</c:v>
                </c:pt>
                <c:pt idx="257">
                  <c:v>0.26719999999999999</c:v>
                </c:pt>
                <c:pt idx="258">
                  <c:v>0.23810000000000001</c:v>
                </c:pt>
                <c:pt idx="259">
                  <c:v>0.2495</c:v>
                </c:pt>
                <c:pt idx="260">
                  <c:v>0.27729999999999999</c:v>
                </c:pt>
                <c:pt idx="261">
                  <c:v>0.26290000000000002</c:v>
                </c:pt>
                <c:pt idx="262">
                  <c:v>0.2344</c:v>
                </c:pt>
                <c:pt idx="263">
                  <c:v>0.2465</c:v>
                </c:pt>
                <c:pt idx="264">
                  <c:v>0.23069999999999999</c:v>
                </c:pt>
                <c:pt idx="265">
                  <c:v>0.25019999999999998</c:v>
                </c:pt>
                <c:pt idx="266">
                  <c:v>0.25369999999999998</c:v>
                </c:pt>
                <c:pt idx="267">
                  <c:v>0.2571</c:v>
                </c:pt>
                <c:pt idx="268">
                  <c:v>0.22839999999999999</c:v>
                </c:pt>
                <c:pt idx="269">
                  <c:v>0.21260000000000001</c:v>
                </c:pt>
                <c:pt idx="270">
                  <c:v>0.22689999999999999</c:v>
                </c:pt>
                <c:pt idx="271">
                  <c:v>0.21759999999999999</c:v>
                </c:pt>
                <c:pt idx="272">
                  <c:v>0.18809999999999999</c:v>
                </c:pt>
                <c:pt idx="273">
                  <c:v>0.1963</c:v>
                </c:pt>
                <c:pt idx="274">
                  <c:v>0.2117</c:v>
                </c:pt>
                <c:pt idx="275">
                  <c:v>0.192</c:v>
                </c:pt>
                <c:pt idx="276">
                  <c:v>0.17979999999999999</c:v>
                </c:pt>
                <c:pt idx="277">
                  <c:v>0.20050000000000001</c:v>
                </c:pt>
                <c:pt idx="278">
                  <c:v>0.2069</c:v>
                </c:pt>
                <c:pt idx="279">
                  <c:v>0.19040000000000001</c:v>
                </c:pt>
                <c:pt idx="280">
                  <c:v>0.19359999999999999</c:v>
                </c:pt>
                <c:pt idx="281">
                  <c:v>0.21540000000000001</c:v>
                </c:pt>
                <c:pt idx="282">
                  <c:v>0.2208</c:v>
                </c:pt>
                <c:pt idx="283">
                  <c:v>0.20710000000000001</c:v>
                </c:pt>
                <c:pt idx="284">
                  <c:v>0.20549999999999999</c:v>
                </c:pt>
                <c:pt idx="285">
                  <c:v>0.2266</c:v>
                </c:pt>
                <c:pt idx="286">
                  <c:v>0.22600000000000001</c:v>
                </c:pt>
                <c:pt idx="287">
                  <c:v>0.25469999999999998</c:v>
                </c:pt>
                <c:pt idx="288">
                  <c:v>0.25019999999999998</c:v>
                </c:pt>
                <c:pt idx="289">
                  <c:v>0.28239999999999998</c:v>
                </c:pt>
                <c:pt idx="290">
                  <c:v>0.31890000000000002</c:v>
                </c:pt>
                <c:pt idx="291">
                  <c:v>0.29260000000000003</c:v>
                </c:pt>
                <c:pt idx="292">
                  <c:v>0.33110000000000001</c:v>
                </c:pt>
                <c:pt idx="293">
                  <c:v>0.3377</c:v>
                </c:pt>
                <c:pt idx="294">
                  <c:v>0.29799999999999999</c:v>
                </c:pt>
                <c:pt idx="295">
                  <c:v>0.32840000000000003</c:v>
                </c:pt>
                <c:pt idx="296">
                  <c:v>0.29320000000000002</c:v>
                </c:pt>
                <c:pt idx="297">
                  <c:v>0.29020000000000001</c:v>
                </c:pt>
                <c:pt idx="298">
                  <c:v>0.26079999999999998</c:v>
                </c:pt>
                <c:pt idx="299">
                  <c:v>0.26040000000000002</c:v>
                </c:pt>
                <c:pt idx="300">
                  <c:v>0.28310000000000002</c:v>
                </c:pt>
                <c:pt idx="301">
                  <c:v>0.3039</c:v>
                </c:pt>
                <c:pt idx="302">
                  <c:v>0.28589999999999999</c:v>
                </c:pt>
                <c:pt idx="303">
                  <c:v>0.29770000000000002</c:v>
                </c:pt>
                <c:pt idx="304">
                  <c:v>0.29730000000000001</c:v>
                </c:pt>
                <c:pt idx="305">
                  <c:v>0.30459999999999998</c:v>
                </c:pt>
                <c:pt idx="306">
                  <c:v>0.27979999999999999</c:v>
                </c:pt>
                <c:pt idx="307">
                  <c:v>0.252</c:v>
                </c:pt>
                <c:pt idx="308">
                  <c:v>0.23269999999999999</c:v>
                </c:pt>
                <c:pt idx="309">
                  <c:v>0.22650000000000001</c:v>
                </c:pt>
                <c:pt idx="310">
                  <c:v>0.21859999999999999</c:v>
                </c:pt>
                <c:pt idx="311">
                  <c:v>0.2324</c:v>
                </c:pt>
                <c:pt idx="312">
                  <c:v>0.22500000000000001</c:v>
                </c:pt>
                <c:pt idx="313">
                  <c:v>0.2009</c:v>
                </c:pt>
                <c:pt idx="314">
                  <c:v>0.2059</c:v>
                </c:pt>
                <c:pt idx="315">
                  <c:v>0.2364</c:v>
                </c:pt>
                <c:pt idx="316">
                  <c:v>0.25840000000000002</c:v>
                </c:pt>
                <c:pt idx="317">
                  <c:v>0.27410000000000001</c:v>
                </c:pt>
                <c:pt idx="318">
                  <c:v>0.23330000000000001</c:v>
                </c:pt>
                <c:pt idx="319">
                  <c:v>0.2109</c:v>
                </c:pt>
                <c:pt idx="320">
                  <c:v>0.21790000000000001</c:v>
                </c:pt>
                <c:pt idx="321">
                  <c:v>0.22209999999999999</c:v>
                </c:pt>
                <c:pt idx="322">
                  <c:v>0.20530000000000001</c:v>
                </c:pt>
                <c:pt idx="323">
                  <c:v>0.1971</c:v>
                </c:pt>
                <c:pt idx="324">
                  <c:v>0.21379999999999999</c:v>
                </c:pt>
                <c:pt idx="325">
                  <c:v>0.21210000000000001</c:v>
                </c:pt>
                <c:pt idx="326">
                  <c:v>0.19209999999999999</c:v>
                </c:pt>
                <c:pt idx="327">
                  <c:v>0.19689999999999999</c:v>
                </c:pt>
                <c:pt idx="328">
                  <c:v>0.22189999999999999</c:v>
                </c:pt>
                <c:pt idx="329">
                  <c:v>0.20580000000000001</c:v>
                </c:pt>
                <c:pt idx="330">
                  <c:v>0.17929999999999999</c:v>
                </c:pt>
                <c:pt idx="331">
                  <c:v>0.20119999999999999</c:v>
                </c:pt>
                <c:pt idx="332">
                  <c:v>0.21379999999999999</c:v>
                </c:pt>
                <c:pt idx="333">
                  <c:v>0.19350000000000001</c:v>
                </c:pt>
                <c:pt idx="334">
                  <c:v>0.21679999999999999</c:v>
                </c:pt>
                <c:pt idx="335">
                  <c:v>0.15459999999999999</c:v>
                </c:pt>
                <c:pt idx="336">
                  <c:v>0.18229999999999999</c:v>
                </c:pt>
                <c:pt idx="337">
                  <c:v>0.16250000000000001</c:v>
                </c:pt>
                <c:pt idx="338">
                  <c:v>0.15939999999999999</c:v>
                </c:pt>
                <c:pt idx="339">
                  <c:v>0.14050000000000001</c:v>
                </c:pt>
                <c:pt idx="340">
                  <c:v>0.15490000000000001</c:v>
                </c:pt>
                <c:pt idx="341">
                  <c:v>0.16750000000000001</c:v>
                </c:pt>
                <c:pt idx="342">
                  <c:v>0.15920000000000001</c:v>
                </c:pt>
                <c:pt idx="343">
                  <c:v>0.16300000000000001</c:v>
                </c:pt>
                <c:pt idx="344">
                  <c:v>0.2094</c:v>
                </c:pt>
                <c:pt idx="345">
                  <c:v>0.25280000000000002</c:v>
                </c:pt>
                <c:pt idx="346">
                  <c:v>0.3115</c:v>
                </c:pt>
                <c:pt idx="347">
                  <c:v>0.24049999999999999</c:v>
                </c:pt>
                <c:pt idx="348">
                  <c:v>0.2253</c:v>
                </c:pt>
                <c:pt idx="349">
                  <c:v>0.20710000000000001</c:v>
                </c:pt>
                <c:pt idx="350">
                  <c:v>0.19320000000000001</c:v>
                </c:pt>
                <c:pt idx="351">
                  <c:v>0.2374</c:v>
                </c:pt>
                <c:pt idx="352">
                  <c:v>0.26919999999999999</c:v>
                </c:pt>
                <c:pt idx="353">
                  <c:v>0.23380000000000001</c:v>
                </c:pt>
                <c:pt idx="354">
                  <c:v>0.22040000000000001</c:v>
                </c:pt>
                <c:pt idx="355">
                  <c:v>0.19350000000000001</c:v>
                </c:pt>
                <c:pt idx="356">
                  <c:v>0.19889999999999999</c:v>
                </c:pt>
                <c:pt idx="357">
                  <c:v>0.16389999999999999</c:v>
                </c:pt>
                <c:pt idx="358">
                  <c:v>0.1633</c:v>
                </c:pt>
                <c:pt idx="359">
                  <c:v>0.18379999999999999</c:v>
                </c:pt>
                <c:pt idx="360">
                  <c:v>0.21179999999999999</c:v>
                </c:pt>
                <c:pt idx="361">
                  <c:v>0.30509999999999998</c:v>
                </c:pt>
                <c:pt idx="362">
                  <c:v>0.31430000000000002</c:v>
                </c:pt>
                <c:pt idx="363">
                  <c:v>0.37669999999999998</c:v>
                </c:pt>
                <c:pt idx="364">
                  <c:v>0.4345</c:v>
                </c:pt>
                <c:pt idx="365">
                  <c:v>0.50680000000000003</c:v>
                </c:pt>
                <c:pt idx="366">
                  <c:v>0.53800000000000003</c:v>
                </c:pt>
                <c:pt idx="367">
                  <c:v>0.64749999999999996</c:v>
                </c:pt>
                <c:pt idx="368">
                  <c:v>0.71689999999999998</c:v>
                </c:pt>
                <c:pt idx="369">
                  <c:v>0.7752</c:v>
                </c:pt>
                <c:pt idx="370">
                  <c:v>0.93220000000000003</c:v>
                </c:pt>
                <c:pt idx="371">
                  <c:v>0.96289999999999998</c:v>
                </c:pt>
                <c:pt idx="372">
                  <c:v>1.0108999999999999</c:v>
                </c:pt>
                <c:pt idx="373">
                  <c:v>0.94530000000000003</c:v>
                </c:pt>
                <c:pt idx="374">
                  <c:v>0.87949999999999995</c:v>
                </c:pt>
                <c:pt idx="375">
                  <c:v>0.84099999999999997</c:v>
                </c:pt>
                <c:pt idx="376">
                  <c:v>0.90720000000000001</c:v>
                </c:pt>
                <c:pt idx="377">
                  <c:v>0.92559999999999998</c:v>
                </c:pt>
                <c:pt idx="378">
                  <c:v>1.0067999999999999</c:v>
                </c:pt>
                <c:pt idx="379">
                  <c:v>1.1462000000000001</c:v>
                </c:pt>
                <c:pt idx="380">
                  <c:v>1.252</c:v>
                </c:pt>
                <c:pt idx="381">
                  <c:v>1.4043000000000001</c:v>
                </c:pt>
                <c:pt idx="382">
                  <c:v>1.5878000000000001</c:v>
                </c:pt>
                <c:pt idx="383">
                  <c:v>1.6674</c:v>
                </c:pt>
                <c:pt idx="384">
                  <c:v>1.5865</c:v>
                </c:pt>
                <c:pt idx="385">
                  <c:v>1.6062000000000001</c:v>
                </c:pt>
                <c:pt idx="386">
                  <c:v>1.5953999999999999</c:v>
                </c:pt>
                <c:pt idx="387">
                  <c:v>1.522</c:v>
                </c:pt>
                <c:pt idx="388">
                  <c:v>1.5539000000000001</c:v>
                </c:pt>
                <c:pt idx="389">
                  <c:v>1.4675</c:v>
                </c:pt>
                <c:pt idx="390">
                  <c:v>1.4954000000000001</c:v>
                </c:pt>
                <c:pt idx="391">
                  <c:v>1.5424</c:v>
                </c:pt>
                <c:pt idx="392">
                  <c:v>1.5064</c:v>
                </c:pt>
                <c:pt idx="393">
                  <c:v>1.3453999999999999</c:v>
                </c:pt>
                <c:pt idx="394">
                  <c:v>1.3117000000000001</c:v>
                </c:pt>
                <c:pt idx="395">
                  <c:v>1.1431</c:v>
                </c:pt>
                <c:pt idx="396">
                  <c:v>0.91859999999999997</c:v>
                </c:pt>
                <c:pt idx="397">
                  <c:v>0.78080000000000005</c:v>
                </c:pt>
                <c:pt idx="398">
                  <c:v>0.68520000000000003</c:v>
                </c:pt>
                <c:pt idx="399">
                  <c:v>0.62770000000000004</c:v>
                </c:pt>
                <c:pt idx="400">
                  <c:v>0.49049999999999999</c:v>
                </c:pt>
                <c:pt idx="401">
                  <c:v>0.36659999999999998</c:v>
                </c:pt>
                <c:pt idx="402">
                  <c:v>0.31969999999999998</c:v>
                </c:pt>
                <c:pt idx="403">
                  <c:v>0.31309999999999999</c:v>
                </c:pt>
                <c:pt idx="404">
                  <c:v>0.27289999999999998</c:v>
                </c:pt>
                <c:pt idx="405">
                  <c:v>0.23269999999999999</c:v>
                </c:pt>
                <c:pt idx="406">
                  <c:v>0.21609999999999999</c:v>
                </c:pt>
                <c:pt idx="407">
                  <c:v>0.1915</c:v>
                </c:pt>
                <c:pt idx="408">
                  <c:v>0.2175</c:v>
                </c:pt>
                <c:pt idx="409">
                  <c:v>0.2346</c:v>
                </c:pt>
                <c:pt idx="410">
                  <c:v>0.20860000000000001</c:v>
                </c:pt>
                <c:pt idx="411">
                  <c:v>0.2137</c:v>
                </c:pt>
                <c:pt idx="412">
                  <c:v>0.24260000000000001</c:v>
                </c:pt>
                <c:pt idx="413">
                  <c:v>0.24049999999999999</c:v>
                </c:pt>
                <c:pt idx="414">
                  <c:v>0.22670000000000001</c:v>
                </c:pt>
                <c:pt idx="415">
                  <c:v>0.24379999999999999</c:v>
                </c:pt>
                <c:pt idx="416">
                  <c:v>0.23380000000000001</c:v>
                </c:pt>
                <c:pt idx="417">
                  <c:v>0.20960000000000001</c:v>
                </c:pt>
                <c:pt idx="418">
                  <c:v>0.23549999999999999</c:v>
                </c:pt>
                <c:pt idx="419">
                  <c:v>0.26129999999999998</c:v>
                </c:pt>
                <c:pt idx="420">
                  <c:v>0.25619999999999998</c:v>
                </c:pt>
                <c:pt idx="421">
                  <c:v>0.2336</c:v>
                </c:pt>
                <c:pt idx="422">
                  <c:v>0.24149999999999999</c:v>
                </c:pt>
                <c:pt idx="423">
                  <c:v>0.26569999999999999</c:v>
                </c:pt>
                <c:pt idx="424">
                  <c:v>0.26050000000000001</c:v>
                </c:pt>
                <c:pt idx="425">
                  <c:v>0.26860000000000001</c:v>
                </c:pt>
                <c:pt idx="426">
                  <c:v>0.25480000000000003</c:v>
                </c:pt>
                <c:pt idx="427">
                  <c:v>0.2525</c:v>
                </c:pt>
                <c:pt idx="428">
                  <c:v>0.24990000000000001</c:v>
                </c:pt>
                <c:pt idx="429">
                  <c:v>0.28070000000000001</c:v>
                </c:pt>
                <c:pt idx="430">
                  <c:v>0.30730000000000002</c:v>
                </c:pt>
                <c:pt idx="431">
                  <c:v>0.29959999999999998</c:v>
                </c:pt>
                <c:pt idx="432">
                  <c:v>0.25990000000000002</c:v>
                </c:pt>
                <c:pt idx="433">
                  <c:v>0.27389999999999998</c:v>
                </c:pt>
                <c:pt idx="434">
                  <c:v>0.30080000000000001</c:v>
                </c:pt>
                <c:pt idx="435">
                  <c:v>0.27129999999999999</c:v>
                </c:pt>
                <c:pt idx="436">
                  <c:v>0.25340000000000001</c:v>
                </c:pt>
                <c:pt idx="437">
                  <c:v>0.2903</c:v>
                </c:pt>
                <c:pt idx="438">
                  <c:v>0.2979</c:v>
                </c:pt>
                <c:pt idx="439">
                  <c:v>0.2757</c:v>
                </c:pt>
                <c:pt idx="440">
                  <c:v>0.29239999999999999</c:v>
                </c:pt>
                <c:pt idx="441">
                  <c:v>0.28420000000000001</c:v>
                </c:pt>
                <c:pt idx="442">
                  <c:v>0.27310000000000001</c:v>
                </c:pt>
                <c:pt idx="443">
                  <c:v>0.2366</c:v>
                </c:pt>
                <c:pt idx="444">
                  <c:v>0.23200000000000001</c:v>
                </c:pt>
                <c:pt idx="445">
                  <c:v>0.22739999999999999</c:v>
                </c:pt>
                <c:pt idx="446">
                  <c:v>0.22220000000000001</c:v>
                </c:pt>
                <c:pt idx="447">
                  <c:v>0.20910000000000001</c:v>
                </c:pt>
                <c:pt idx="448">
                  <c:v>0.20280000000000001</c:v>
                </c:pt>
                <c:pt idx="449">
                  <c:v>0.2021</c:v>
                </c:pt>
                <c:pt idx="450">
                  <c:v>0.1953</c:v>
                </c:pt>
                <c:pt idx="451">
                  <c:v>0.17929999999999999</c:v>
                </c:pt>
                <c:pt idx="452">
                  <c:v>0.1787</c:v>
                </c:pt>
                <c:pt idx="453">
                  <c:v>0.17519999999999999</c:v>
                </c:pt>
                <c:pt idx="454">
                  <c:v>0.15970000000000001</c:v>
                </c:pt>
                <c:pt idx="455">
                  <c:v>0.15970000000000001</c:v>
                </c:pt>
                <c:pt idx="456">
                  <c:v>0.17019999999999999</c:v>
                </c:pt>
                <c:pt idx="457">
                  <c:v>0.1585</c:v>
                </c:pt>
                <c:pt idx="458">
                  <c:v>0.1477</c:v>
                </c:pt>
                <c:pt idx="459">
                  <c:v>0.17069999999999999</c:v>
                </c:pt>
                <c:pt idx="460">
                  <c:v>0.22620000000000001</c:v>
                </c:pt>
                <c:pt idx="461">
                  <c:v>0.22989999999999999</c:v>
                </c:pt>
                <c:pt idx="462">
                  <c:v>0.21479999999999999</c:v>
                </c:pt>
                <c:pt idx="463">
                  <c:v>0.20730000000000001</c:v>
                </c:pt>
                <c:pt idx="464">
                  <c:v>0.3306</c:v>
                </c:pt>
                <c:pt idx="465">
                  <c:v>0.49509999999999998</c:v>
                </c:pt>
                <c:pt idx="466">
                  <c:v>0.64039999999999997</c:v>
                </c:pt>
                <c:pt idx="467">
                  <c:v>0.76019999999999999</c:v>
                </c:pt>
                <c:pt idx="468">
                  <c:v>0.77349999999999997</c:v>
                </c:pt>
                <c:pt idx="469">
                  <c:v>0.77829999999999999</c:v>
                </c:pt>
                <c:pt idx="470">
                  <c:v>0.72589999999999999</c:v>
                </c:pt>
                <c:pt idx="471">
                  <c:v>0.64419999999999999</c:v>
                </c:pt>
                <c:pt idx="472">
                  <c:v>0.50119999999999998</c:v>
                </c:pt>
                <c:pt idx="473">
                  <c:v>0.41339999999999999</c:v>
                </c:pt>
                <c:pt idx="474">
                  <c:v>0.3165</c:v>
                </c:pt>
                <c:pt idx="475">
                  <c:v>0.28010000000000002</c:v>
                </c:pt>
                <c:pt idx="476">
                  <c:v>0.22220000000000001</c:v>
                </c:pt>
                <c:pt idx="477">
                  <c:v>0.21479999999999999</c:v>
                </c:pt>
                <c:pt idx="478">
                  <c:v>0.247</c:v>
                </c:pt>
                <c:pt idx="479">
                  <c:v>0.2135</c:v>
                </c:pt>
                <c:pt idx="480">
                  <c:v>0.1641</c:v>
                </c:pt>
                <c:pt idx="481">
                  <c:v>0.192</c:v>
                </c:pt>
                <c:pt idx="482">
                  <c:v>0.21490000000000001</c:v>
                </c:pt>
                <c:pt idx="483">
                  <c:v>0.17879999999999999</c:v>
                </c:pt>
                <c:pt idx="484">
                  <c:v>0.1565</c:v>
                </c:pt>
                <c:pt idx="485">
                  <c:v>0.18740000000000001</c:v>
                </c:pt>
                <c:pt idx="486">
                  <c:v>0.19550000000000001</c:v>
                </c:pt>
                <c:pt idx="487">
                  <c:v>0.16789999999999999</c:v>
                </c:pt>
                <c:pt idx="488">
                  <c:v>0.16930000000000001</c:v>
                </c:pt>
                <c:pt idx="489">
                  <c:v>0.19939999999999999</c:v>
                </c:pt>
                <c:pt idx="490">
                  <c:v>0.1958</c:v>
                </c:pt>
                <c:pt idx="491">
                  <c:v>0.18140000000000001</c:v>
                </c:pt>
                <c:pt idx="492">
                  <c:v>0.1948</c:v>
                </c:pt>
                <c:pt idx="493">
                  <c:v>0.21590000000000001</c:v>
                </c:pt>
                <c:pt idx="494">
                  <c:v>0.20730000000000001</c:v>
                </c:pt>
                <c:pt idx="495">
                  <c:v>0.1981</c:v>
                </c:pt>
                <c:pt idx="496">
                  <c:v>0.22040000000000001</c:v>
                </c:pt>
                <c:pt idx="497">
                  <c:v>0.23369999999999999</c:v>
                </c:pt>
                <c:pt idx="498">
                  <c:v>0.22259999999999999</c:v>
                </c:pt>
                <c:pt idx="499">
                  <c:v>0.2175</c:v>
                </c:pt>
                <c:pt idx="500">
                  <c:v>0.24490000000000001</c:v>
                </c:pt>
                <c:pt idx="501">
                  <c:v>0.25290000000000001</c:v>
                </c:pt>
                <c:pt idx="502">
                  <c:v>0.23730000000000001</c:v>
                </c:pt>
                <c:pt idx="503">
                  <c:v>0.2467</c:v>
                </c:pt>
                <c:pt idx="504">
                  <c:v>0.27589999999999998</c:v>
                </c:pt>
                <c:pt idx="505">
                  <c:v>0.27479999999999999</c:v>
                </c:pt>
                <c:pt idx="506">
                  <c:v>0.26469999999999999</c:v>
                </c:pt>
                <c:pt idx="507">
                  <c:v>0.28570000000000001</c:v>
                </c:pt>
                <c:pt idx="508">
                  <c:v>0.31309999999999999</c:v>
                </c:pt>
                <c:pt idx="509">
                  <c:v>0.30630000000000002</c:v>
                </c:pt>
                <c:pt idx="510">
                  <c:v>0.29930000000000001</c:v>
                </c:pt>
                <c:pt idx="511">
                  <c:v>0.32929999999999998</c:v>
                </c:pt>
                <c:pt idx="512">
                  <c:v>0.31230000000000002</c:v>
                </c:pt>
                <c:pt idx="513">
                  <c:v>0.29559999999999997</c:v>
                </c:pt>
                <c:pt idx="514">
                  <c:v>0.26900000000000002</c:v>
                </c:pt>
                <c:pt idx="515">
                  <c:v>0.2397</c:v>
                </c:pt>
                <c:pt idx="516">
                  <c:v>0.22650000000000001</c:v>
                </c:pt>
                <c:pt idx="517">
                  <c:v>0.21179999999999999</c:v>
                </c:pt>
                <c:pt idx="518">
                  <c:v>0.20530000000000001</c:v>
                </c:pt>
                <c:pt idx="519">
                  <c:v>0.2049</c:v>
                </c:pt>
                <c:pt idx="520">
                  <c:v>0.19450000000000001</c:v>
                </c:pt>
                <c:pt idx="521">
                  <c:v>0.17499999999999999</c:v>
                </c:pt>
                <c:pt idx="522">
                  <c:v>0.16120000000000001</c:v>
                </c:pt>
                <c:pt idx="523">
                  <c:v>0.14949999999999999</c:v>
                </c:pt>
                <c:pt idx="524">
                  <c:v>0.16300000000000001</c:v>
                </c:pt>
                <c:pt idx="525">
                  <c:v>0.1739</c:v>
                </c:pt>
                <c:pt idx="526">
                  <c:v>0.15820000000000001</c:v>
                </c:pt>
                <c:pt idx="527">
                  <c:v>0.15310000000000001</c:v>
                </c:pt>
                <c:pt idx="528">
                  <c:v>0.16700000000000001</c:v>
                </c:pt>
                <c:pt idx="529">
                  <c:v>0.1656</c:v>
                </c:pt>
                <c:pt idx="530">
                  <c:v>0.15340000000000001</c:v>
                </c:pt>
                <c:pt idx="531">
                  <c:v>0.1638</c:v>
                </c:pt>
                <c:pt idx="532">
                  <c:v>0.1734</c:v>
                </c:pt>
                <c:pt idx="533">
                  <c:v>0.16070000000000001</c:v>
                </c:pt>
                <c:pt idx="534">
                  <c:v>0.15659999999999999</c:v>
                </c:pt>
                <c:pt idx="535">
                  <c:v>0.1729</c:v>
                </c:pt>
                <c:pt idx="536">
                  <c:v>0.1686</c:v>
                </c:pt>
                <c:pt idx="537">
                  <c:v>0.1575</c:v>
                </c:pt>
                <c:pt idx="538">
                  <c:v>0.16619999999999999</c:v>
                </c:pt>
                <c:pt idx="539">
                  <c:v>0.1759</c:v>
                </c:pt>
                <c:pt idx="540">
                  <c:v>0.16769999999999999</c:v>
                </c:pt>
                <c:pt idx="541">
                  <c:v>0.15790000000000001</c:v>
                </c:pt>
                <c:pt idx="542">
                  <c:v>0.14319999999999999</c:v>
                </c:pt>
                <c:pt idx="543">
                  <c:v>0.1283</c:v>
                </c:pt>
                <c:pt idx="544">
                  <c:v>0.13289999999999999</c:v>
                </c:pt>
                <c:pt idx="545">
                  <c:v>0.1239</c:v>
                </c:pt>
                <c:pt idx="546">
                  <c:v>0.1295</c:v>
                </c:pt>
                <c:pt idx="547">
                  <c:v>0.1242</c:v>
                </c:pt>
                <c:pt idx="548">
                  <c:v>0.1198</c:v>
                </c:pt>
                <c:pt idx="549">
                  <c:v>0.1169</c:v>
                </c:pt>
                <c:pt idx="550">
                  <c:v>0.1288</c:v>
                </c:pt>
                <c:pt idx="551">
                  <c:v>0.13200000000000001</c:v>
                </c:pt>
                <c:pt idx="552">
                  <c:v>0.12820000000000001</c:v>
                </c:pt>
                <c:pt idx="553">
                  <c:v>0.1333</c:v>
                </c:pt>
                <c:pt idx="554">
                  <c:v>0.14149999999999999</c:v>
                </c:pt>
                <c:pt idx="555">
                  <c:v>0.1363</c:v>
                </c:pt>
                <c:pt idx="556">
                  <c:v>0.12870000000000001</c:v>
                </c:pt>
                <c:pt idx="557">
                  <c:v>0.1305</c:v>
                </c:pt>
                <c:pt idx="558">
                  <c:v>0.13550000000000001</c:v>
                </c:pt>
                <c:pt idx="559">
                  <c:v>0.14050000000000001</c:v>
                </c:pt>
                <c:pt idx="560">
                  <c:v>0.14430000000000001</c:v>
                </c:pt>
                <c:pt idx="561">
                  <c:v>0.14910000000000001</c:v>
                </c:pt>
                <c:pt idx="562">
                  <c:v>0.1605</c:v>
                </c:pt>
                <c:pt idx="563">
                  <c:v>0.17</c:v>
                </c:pt>
                <c:pt idx="564">
                  <c:v>0.18240000000000001</c:v>
                </c:pt>
                <c:pt idx="565">
                  <c:v>0.18720000000000001</c:v>
                </c:pt>
                <c:pt idx="566">
                  <c:v>0.2084</c:v>
                </c:pt>
                <c:pt idx="567">
                  <c:v>0.21199999999999999</c:v>
                </c:pt>
                <c:pt idx="568">
                  <c:v>0.21049999999999999</c:v>
                </c:pt>
                <c:pt idx="569">
                  <c:v>0.22939999999999999</c:v>
                </c:pt>
                <c:pt idx="570">
                  <c:v>0.24429999999999999</c:v>
                </c:pt>
                <c:pt idx="571">
                  <c:v>0.2447</c:v>
                </c:pt>
                <c:pt idx="572">
                  <c:v>0.24840000000000001</c:v>
                </c:pt>
                <c:pt idx="573">
                  <c:v>0.27889999999999998</c:v>
                </c:pt>
                <c:pt idx="574">
                  <c:v>0.26910000000000001</c:v>
                </c:pt>
                <c:pt idx="575">
                  <c:v>0.24060000000000001</c:v>
                </c:pt>
                <c:pt idx="576">
                  <c:v>0.24010000000000001</c:v>
                </c:pt>
                <c:pt idx="577">
                  <c:v>0.25140000000000001</c:v>
                </c:pt>
                <c:pt idx="578">
                  <c:v>0.2258</c:v>
                </c:pt>
                <c:pt idx="579">
                  <c:v>0.2029</c:v>
                </c:pt>
                <c:pt idx="580">
                  <c:v>0.21709999999999999</c:v>
                </c:pt>
                <c:pt idx="581">
                  <c:v>0.2157</c:v>
                </c:pt>
                <c:pt idx="582">
                  <c:v>0.18720000000000001</c:v>
                </c:pt>
                <c:pt idx="583">
                  <c:v>0.18540000000000001</c:v>
                </c:pt>
                <c:pt idx="584">
                  <c:v>0.20219999999999999</c:v>
                </c:pt>
                <c:pt idx="585">
                  <c:v>0.1857</c:v>
                </c:pt>
                <c:pt idx="586">
                  <c:v>0.16220000000000001</c:v>
                </c:pt>
                <c:pt idx="587">
                  <c:v>0.1769</c:v>
                </c:pt>
                <c:pt idx="588">
                  <c:v>0.186</c:v>
                </c:pt>
                <c:pt idx="589">
                  <c:v>0.1573</c:v>
                </c:pt>
                <c:pt idx="590">
                  <c:v>0.1469</c:v>
                </c:pt>
                <c:pt idx="591">
                  <c:v>0.16750000000000001</c:v>
                </c:pt>
                <c:pt idx="592">
                  <c:v>0.1731</c:v>
                </c:pt>
                <c:pt idx="593">
                  <c:v>0.1615</c:v>
                </c:pt>
                <c:pt idx="594">
                  <c:v>0.1411</c:v>
                </c:pt>
                <c:pt idx="595">
                  <c:v>0.14050000000000001</c:v>
                </c:pt>
                <c:pt idx="596">
                  <c:v>0.14860000000000001</c:v>
                </c:pt>
                <c:pt idx="597">
                  <c:v>0.1439</c:v>
                </c:pt>
                <c:pt idx="598">
                  <c:v>0.1452</c:v>
                </c:pt>
                <c:pt idx="599">
                  <c:v>0.13850000000000001</c:v>
                </c:pt>
                <c:pt idx="600">
                  <c:v>0.13100000000000001</c:v>
                </c:pt>
                <c:pt idx="601">
                  <c:v>0.1326</c:v>
                </c:pt>
                <c:pt idx="602">
                  <c:v>0.14660000000000001</c:v>
                </c:pt>
                <c:pt idx="603">
                  <c:v>0.1472</c:v>
                </c:pt>
                <c:pt idx="604">
                  <c:v>0.14360000000000001</c:v>
                </c:pt>
                <c:pt idx="605">
                  <c:v>0.16059999999999999</c:v>
                </c:pt>
                <c:pt idx="606">
                  <c:v>0.17180000000000001</c:v>
                </c:pt>
                <c:pt idx="607">
                  <c:v>0.17269999999999999</c:v>
                </c:pt>
                <c:pt idx="608">
                  <c:v>0.18279999999999999</c:v>
                </c:pt>
                <c:pt idx="609">
                  <c:v>0.20280000000000001</c:v>
                </c:pt>
                <c:pt idx="610">
                  <c:v>0.21260000000000001</c:v>
                </c:pt>
                <c:pt idx="611">
                  <c:v>0.21460000000000001</c:v>
                </c:pt>
                <c:pt idx="612">
                  <c:v>0.2324</c:v>
                </c:pt>
                <c:pt idx="613">
                  <c:v>0.21659999999999999</c:v>
                </c:pt>
                <c:pt idx="614">
                  <c:v>0.19370000000000001</c:v>
                </c:pt>
                <c:pt idx="615">
                  <c:v>0.2157</c:v>
                </c:pt>
                <c:pt idx="616">
                  <c:v>0.21590000000000001</c:v>
                </c:pt>
                <c:pt idx="617">
                  <c:v>0.1784</c:v>
                </c:pt>
                <c:pt idx="618">
                  <c:v>0.18540000000000001</c:v>
                </c:pt>
                <c:pt idx="619">
                  <c:v>0.21779999999999999</c:v>
                </c:pt>
                <c:pt idx="620">
                  <c:v>0.20130000000000001</c:v>
                </c:pt>
                <c:pt idx="621">
                  <c:v>0.17810000000000001</c:v>
                </c:pt>
                <c:pt idx="622">
                  <c:v>0.15409999999999999</c:v>
                </c:pt>
                <c:pt idx="623">
                  <c:v>0.1421</c:v>
                </c:pt>
                <c:pt idx="624">
                  <c:v>0.1346</c:v>
                </c:pt>
                <c:pt idx="625">
                  <c:v>0.154</c:v>
                </c:pt>
                <c:pt idx="626">
                  <c:v>0.17330000000000001</c:v>
                </c:pt>
                <c:pt idx="627">
                  <c:v>0.18940000000000001</c:v>
                </c:pt>
                <c:pt idx="628">
                  <c:v>0.191</c:v>
                </c:pt>
                <c:pt idx="629">
                  <c:v>0.20330000000000001</c:v>
                </c:pt>
                <c:pt idx="630">
                  <c:v>0.22589999999999999</c:v>
                </c:pt>
                <c:pt idx="631">
                  <c:v>0.2455</c:v>
                </c:pt>
                <c:pt idx="632">
                  <c:v>0.28889999999999999</c:v>
                </c:pt>
                <c:pt idx="633">
                  <c:v>0.2802</c:v>
                </c:pt>
                <c:pt idx="634">
                  <c:v>0.25940000000000002</c:v>
                </c:pt>
                <c:pt idx="635">
                  <c:v>0.31630000000000003</c:v>
                </c:pt>
                <c:pt idx="636">
                  <c:v>0.35089999999999999</c:v>
                </c:pt>
                <c:pt idx="637">
                  <c:v>0.33139999999999997</c:v>
                </c:pt>
                <c:pt idx="638">
                  <c:v>0.36480000000000001</c:v>
                </c:pt>
                <c:pt idx="639">
                  <c:v>0.42859999999999998</c:v>
                </c:pt>
                <c:pt idx="640">
                  <c:v>0.43730000000000002</c:v>
                </c:pt>
                <c:pt idx="641">
                  <c:v>0.44650000000000001</c:v>
                </c:pt>
                <c:pt idx="642">
                  <c:v>0.50590000000000002</c:v>
                </c:pt>
                <c:pt idx="643">
                  <c:v>0.55349999999999999</c:v>
                </c:pt>
                <c:pt idx="644">
                  <c:v>0.55189999999999995</c:v>
                </c:pt>
                <c:pt idx="645">
                  <c:v>0.61409999999999998</c:v>
                </c:pt>
                <c:pt idx="646">
                  <c:v>0.70099999999999996</c:v>
                </c:pt>
                <c:pt idx="647">
                  <c:v>0.75160000000000005</c:v>
                </c:pt>
                <c:pt idx="648">
                  <c:v>0.82169999999999999</c:v>
                </c:pt>
                <c:pt idx="649">
                  <c:v>0.79600000000000004</c:v>
                </c:pt>
                <c:pt idx="650">
                  <c:v>0.88949999999999996</c:v>
                </c:pt>
                <c:pt idx="651">
                  <c:v>1.0133000000000001</c:v>
                </c:pt>
                <c:pt idx="652">
                  <c:v>1.1176999999999999</c:v>
                </c:pt>
                <c:pt idx="653">
                  <c:v>1.2465999999999999</c:v>
                </c:pt>
                <c:pt idx="654">
                  <c:v>1.2341</c:v>
                </c:pt>
                <c:pt idx="655">
                  <c:v>1.2361</c:v>
                </c:pt>
                <c:pt idx="656">
                  <c:v>1.1120000000000001</c:v>
                </c:pt>
                <c:pt idx="657">
                  <c:v>0.93020000000000003</c:v>
                </c:pt>
                <c:pt idx="658">
                  <c:v>0.81140000000000001</c:v>
                </c:pt>
                <c:pt idx="659">
                  <c:v>0.7117</c:v>
                </c:pt>
                <c:pt idx="660">
                  <c:v>0.66849999999999998</c:v>
                </c:pt>
                <c:pt idx="661">
                  <c:v>0.69979999999999998</c:v>
                </c:pt>
                <c:pt idx="662">
                  <c:v>0.65620000000000001</c:v>
                </c:pt>
                <c:pt idx="663">
                  <c:v>0.62429999999999997</c:v>
                </c:pt>
                <c:pt idx="664">
                  <c:v>0.65080000000000005</c:v>
                </c:pt>
                <c:pt idx="665">
                  <c:v>0.67810000000000004</c:v>
                </c:pt>
                <c:pt idx="666">
                  <c:v>0.70320000000000005</c:v>
                </c:pt>
                <c:pt idx="667">
                  <c:v>0.67500000000000004</c:v>
                </c:pt>
                <c:pt idx="668">
                  <c:v>0.78180000000000005</c:v>
                </c:pt>
                <c:pt idx="669">
                  <c:v>0.74339999999999995</c:v>
                </c:pt>
                <c:pt idx="670">
                  <c:v>0.75529999999999997</c:v>
                </c:pt>
                <c:pt idx="671">
                  <c:v>0.76729999999999998</c:v>
                </c:pt>
                <c:pt idx="672">
                  <c:v>0.75549999999999995</c:v>
                </c:pt>
                <c:pt idx="673">
                  <c:v>0.86780000000000002</c:v>
                </c:pt>
                <c:pt idx="674">
                  <c:v>0.91320000000000001</c:v>
                </c:pt>
                <c:pt idx="675">
                  <c:v>0.88480000000000003</c:v>
                </c:pt>
                <c:pt idx="676">
                  <c:v>0.89480000000000004</c:v>
                </c:pt>
                <c:pt idx="677">
                  <c:v>0.87429999999999997</c:v>
                </c:pt>
                <c:pt idx="678">
                  <c:v>0.92010000000000003</c:v>
                </c:pt>
                <c:pt idx="679">
                  <c:v>0.91100000000000003</c:v>
                </c:pt>
                <c:pt idx="680">
                  <c:v>0.83630000000000004</c:v>
                </c:pt>
                <c:pt idx="681">
                  <c:v>0.83079999999999998</c:v>
                </c:pt>
                <c:pt idx="682">
                  <c:v>0.74450000000000005</c:v>
                </c:pt>
                <c:pt idx="683">
                  <c:v>0.67249999999999999</c:v>
                </c:pt>
                <c:pt idx="684">
                  <c:v>0.55300000000000005</c:v>
                </c:pt>
                <c:pt idx="685">
                  <c:v>0.54339999999999999</c:v>
                </c:pt>
                <c:pt idx="686">
                  <c:v>0.52910000000000001</c:v>
                </c:pt>
                <c:pt idx="687">
                  <c:v>0.54979999999999996</c:v>
                </c:pt>
                <c:pt idx="688">
                  <c:v>0.49730000000000002</c:v>
                </c:pt>
                <c:pt idx="689">
                  <c:v>0.42959999999999998</c:v>
                </c:pt>
                <c:pt idx="690">
                  <c:v>0.46879999999999999</c:v>
                </c:pt>
                <c:pt idx="691">
                  <c:v>0.49349999999999999</c:v>
                </c:pt>
                <c:pt idx="692">
                  <c:v>0.45050000000000001</c:v>
                </c:pt>
                <c:pt idx="693">
                  <c:v>0.44590000000000002</c:v>
                </c:pt>
                <c:pt idx="694">
                  <c:v>0.5171</c:v>
                </c:pt>
                <c:pt idx="695">
                  <c:v>0.51919999999999999</c:v>
                </c:pt>
                <c:pt idx="696">
                  <c:v>0.47320000000000001</c:v>
                </c:pt>
                <c:pt idx="697">
                  <c:v>0.42370000000000002</c:v>
                </c:pt>
                <c:pt idx="698">
                  <c:v>0.38019999999999998</c:v>
                </c:pt>
                <c:pt idx="699">
                  <c:v>0.35720000000000002</c:v>
                </c:pt>
                <c:pt idx="700">
                  <c:v>0.32869999999999999</c:v>
                </c:pt>
                <c:pt idx="701">
                  <c:v>0.29649999999999999</c:v>
                </c:pt>
                <c:pt idx="702">
                  <c:v>0.2712</c:v>
                </c:pt>
                <c:pt idx="703">
                  <c:v>0.22450000000000001</c:v>
                </c:pt>
                <c:pt idx="704">
                  <c:v>0.20949999999999999</c:v>
                </c:pt>
                <c:pt idx="705">
                  <c:v>0.20219999999999999</c:v>
                </c:pt>
                <c:pt idx="706">
                  <c:v>0.19120000000000001</c:v>
                </c:pt>
                <c:pt idx="707">
                  <c:v>0.1719</c:v>
                </c:pt>
                <c:pt idx="708">
                  <c:v>0.16919999999999999</c:v>
                </c:pt>
                <c:pt idx="709">
                  <c:v>0.17299999999999999</c:v>
                </c:pt>
                <c:pt idx="710">
                  <c:v>0.1948</c:v>
                </c:pt>
                <c:pt idx="711">
                  <c:v>0.2142</c:v>
                </c:pt>
                <c:pt idx="712">
                  <c:v>0.20069999999999999</c:v>
                </c:pt>
                <c:pt idx="713">
                  <c:v>0.19969999999999999</c:v>
                </c:pt>
                <c:pt idx="714">
                  <c:v>0.21820000000000001</c:v>
                </c:pt>
                <c:pt idx="715">
                  <c:v>0.221</c:v>
                </c:pt>
                <c:pt idx="716">
                  <c:v>0.23749999999999999</c:v>
                </c:pt>
                <c:pt idx="717">
                  <c:v>0.30180000000000001</c:v>
                </c:pt>
                <c:pt idx="718">
                  <c:v>0.37590000000000001</c:v>
                </c:pt>
                <c:pt idx="719">
                  <c:v>0.43569999999999998</c:v>
                </c:pt>
                <c:pt idx="720">
                  <c:v>0.36809999999999998</c:v>
                </c:pt>
                <c:pt idx="721">
                  <c:v>0.30449999999999999</c:v>
                </c:pt>
                <c:pt idx="722">
                  <c:v>0.25030000000000002</c:v>
                </c:pt>
                <c:pt idx="723">
                  <c:v>0.2114</c:v>
                </c:pt>
                <c:pt idx="724">
                  <c:v>0.20680000000000001</c:v>
                </c:pt>
                <c:pt idx="725">
                  <c:v>0.18809999999999999</c:v>
                </c:pt>
                <c:pt idx="726">
                  <c:v>0.2079</c:v>
                </c:pt>
                <c:pt idx="727">
                  <c:v>0.22389999999999999</c:v>
                </c:pt>
                <c:pt idx="728">
                  <c:v>0.2019</c:v>
                </c:pt>
                <c:pt idx="729">
                  <c:v>0.2006</c:v>
                </c:pt>
                <c:pt idx="730">
                  <c:v>0.2276</c:v>
                </c:pt>
                <c:pt idx="731">
                  <c:v>0.2203</c:v>
                </c:pt>
                <c:pt idx="732">
                  <c:v>0.19819999999999999</c:v>
                </c:pt>
                <c:pt idx="733">
                  <c:v>0.2175</c:v>
                </c:pt>
                <c:pt idx="734">
                  <c:v>0.23860000000000001</c:v>
                </c:pt>
                <c:pt idx="735">
                  <c:v>0.2177</c:v>
                </c:pt>
                <c:pt idx="736">
                  <c:v>0.21049999999999999</c:v>
                </c:pt>
                <c:pt idx="737">
                  <c:v>0.24310000000000001</c:v>
                </c:pt>
                <c:pt idx="738">
                  <c:v>0.2455</c:v>
                </c:pt>
                <c:pt idx="739">
                  <c:v>0.22170000000000001</c:v>
                </c:pt>
                <c:pt idx="740">
                  <c:v>0.23269999999999999</c:v>
                </c:pt>
                <c:pt idx="741">
                  <c:v>0.25969999999999999</c:v>
                </c:pt>
                <c:pt idx="742">
                  <c:v>0.2596</c:v>
                </c:pt>
                <c:pt idx="743">
                  <c:v>0.2472</c:v>
                </c:pt>
                <c:pt idx="744">
                  <c:v>0.26390000000000002</c:v>
                </c:pt>
                <c:pt idx="745">
                  <c:v>0.28599999999999998</c:v>
                </c:pt>
                <c:pt idx="746">
                  <c:v>0.2792</c:v>
                </c:pt>
                <c:pt idx="747">
                  <c:v>0.2767</c:v>
                </c:pt>
                <c:pt idx="748">
                  <c:v>0.2979</c:v>
                </c:pt>
                <c:pt idx="749">
                  <c:v>0.31190000000000001</c:v>
                </c:pt>
                <c:pt idx="750">
                  <c:v>0.30149999999999999</c:v>
                </c:pt>
                <c:pt idx="751">
                  <c:v>0.31209999999999999</c:v>
                </c:pt>
                <c:pt idx="752">
                  <c:v>0.33839999999999998</c:v>
                </c:pt>
                <c:pt idx="753">
                  <c:v>0.3362</c:v>
                </c:pt>
                <c:pt idx="754">
                  <c:v>0.36</c:v>
                </c:pt>
                <c:pt idx="755">
                  <c:v>0.35470000000000002</c:v>
                </c:pt>
                <c:pt idx="756">
                  <c:v>0.36359999999999998</c:v>
                </c:pt>
                <c:pt idx="757">
                  <c:v>0.3377</c:v>
                </c:pt>
                <c:pt idx="758">
                  <c:v>0.3206</c:v>
                </c:pt>
                <c:pt idx="759">
                  <c:v>0.30930000000000002</c:v>
                </c:pt>
                <c:pt idx="760">
                  <c:v>0.29920000000000002</c:v>
                </c:pt>
                <c:pt idx="761">
                  <c:v>0.27800000000000002</c:v>
                </c:pt>
                <c:pt idx="762">
                  <c:v>0.26829999999999998</c:v>
                </c:pt>
                <c:pt idx="763">
                  <c:v>0.26989999999999997</c:v>
                </c:pt>
                <c:pt idx="764">
                  <c:v>0.25990000000000002</c:v>
                </c:pt>
                <c:pt idx="765">
                  <c:v>0.24099999999999999</c:v>
                </c:pt>
                <c:pt idx="766">
                  <c:v>0.24010000000000001</c:v>
                </c:pt>
                <c:pt idx="767">
                  <c:v>0.2407</c:v>
                </c:pt>
                <c:pt idx="768">
                  <c:v>0.22570000000000001</c:v>
                </c:pt>
                <c:pt idx="769">
                  <c:v>0.2132</c:v>
                </c:pt>
                <c:pt idx="770">
                  <c:v>0.2205</c:v>
                </c:pt>
                <c:pt idx="771">
                  <c:v>0.22320000000000001</c:v>
                </c:pt>
                <c:pt idx="772">
                  <c:v>0.2102</c:v>
                </c:pt>
                <c:pt idx="773">
                  <c:v>0.19439999999999999</c:v>
                </c:pt>
                <c:pt idx="774">
                  <c:v>0.18909999999999999</c:v>
                </c:pt>
                <c:pt idx="775">
                  <c:v>0.19700000000000001</c:v>
                </c:pt>
                <c:pt idx="776">
                  <c:v>0.18310000000000001</c:v>
                </c:pt>
                <c:pt idx="777">
                  <c:v>0.16919999999999999</c:v>
                </c:pt>
                <c:pt idx="778">
                  <c:v>0.15939999999999999</c:v>
                </c:pt>
                <c:pt idx="779">
                  <c:v>0.17030000000000001</c:v>
                </c:pt>
                <c:pt idx="780">
                  <c:v>0.1774</c:v>
                </c:pt>
                <c:pt idx="781">
                  <c:v>0.19400000000000001</c:v>
                </c:pt>
                <c:pt idx="782">
                  <c:v>0.20569999999999999</c:v>
                </c:pt>
                <c:pt idx="783">
                  <c:v>0.20680000000000001</c:v>
                </c:pt>
                <c:pt idx="784">
                  <c:v>0.2157</c:v>
                </c:pt>
                <c:pt idx="785">
                  <c:v>0.23280000000000001</c:v>
                </c:pt>
                <c:pt idx="786">
                  <c:v>0.2452</c:v>
                </c:pt>
                <c:pt idx="787">
                  <c:v>0.24640000000000001</c:v>
                </c:pt>
                <c:pt idx="788">
                  <c:v>0.25580000000000003</c:v>
                </c:pt>
                <c:pt idx="789">
                  <c:v>0.27750000000000002</c:v>
                </c:pt>
                <c:pt idx="790">
                  <c:v>0.28420000000000001</c:v>
                </c:pt>
                <c:pt idx="791">
                  <c:v>0.28560000000000002</c:v>
                </c:pt>
                <c:pt idx="792">
                  <c:v>0.30209999999999998</c:v>
                </c:pt>
                <c:pt idx="793">
                  <c:v>0.31830000000000003</c:v>
                </c:pt>
                <c:pt idx="794">
                  <c:v>0.3221</c:v>
                </c:pt>
                <c:pt idx="795">
                  <c:v>0.33</c:v>
                </c:pt>
                <c:pt idx="796">
                  <c:v>0.3458</c:v>
                </c:pt>
                <c:pt idx="797">
                  <c:v>0.35649999999999998</c:v>
                </c:pt>
                <c:pt idx="798">
                  <c:v>0.34420000000000001</c:v>
                </c:pt>
                <c:pt idx="799">
                  <c:v>0.3453</c:v>
                </c:pt>
                <c:pt idx="800">
                  <c:v>0.317</c:v>
                </c:pt>
                <c:pt idx="801">
                  <c:v>0.30320000000000003</c:v>
                </c:pt>
                <c:pt idx="802">
                  <c:v>0.28170000000000001</c:v>
                </c:pt>
                <c:pt idx="803">
                  <c:v>0.28179999999999999</c:v>
                </c:pt>
                <c:pt idx="804">
                  <c:v>0.28770000000000001</c:v>
                </c:pt>
                <c:pt idx="805">
                  <c:v>0.27139999999999997</c:v>
                </c:pt>
                <c:pt idx="806">
                  <c:v>0.25729999999999997</c:v>
                </c:pt>
                <c:pt idx="807">
                  <c:v>0.26840000000000003</c:v>
                </c:pt>
                <c:pt idx="808">
                  <c:v>0.27129999999999999</c:v>
                </c:pt>
                <c:pt idx="809">
                  <c:v>0.2492</c:v>
                </c:pt>
                <c:pt idx="810">
                  <c:v>0.24629999999999999</c:v>
                </c:pt>
                <c:pt idx="811">
                  <c:v>0.26140000000000002</c:v>
                </c:pt>
                <c:pt idx="812">
                  <c:v>0.253</c:v>
                </c:pt>
                <c:pt idx="813">
                  <c:v>0.25740000000000002</c:v>
                </c:pt>
                <c:pt idx="814">
                  <c:v>0.25219999999999998</c:v>
                </c:pt>
                <c:pt idx="815">
                  <c:v>0.2341</c:v>
                </c:pt>
                <c:pt idx="816">
                  <c:v>0.22289999999999999</c:v>
                </c:pt>
                <c:pt idx="817">
                  <c:v>0.22989999999999999</c:v>
                </c:pt>
                <c:pt idx="818">
                  <c:v>0.2142</c:v>
                </c:pt>
                <c:pt idx="819">
                  <c:v>0.21079999999999999</c:v>
                </c:pt>
                <c:pt idx="820">
                  <c:v>0.21809999999999999</c:v>
                </c:pt>
                <c:pt idx="821">
                  <c:v>0.21959999999999999</c:v>
                </c:pt>
                <c:pt idx="822">
                  <c:v>0.21690000000000001</c:v>
                </c:pt>
                <c:pt idx="823">
                  <c:v>0.19739999999999999</c:v>
                </c:pt>
                <c:pt idx="824">
                  <c:v>0.19020000000000001</c:v>
                </c:pt>
                <c:pt idx="825">
                  <c:v>0.2082</c:v>
                </c:pt>
                <c:pt idx="826">
                  <c:v>0.24909999999999999</c:v>
                </c:pt>
                <c:pt idx="827">
                  <c:v>0.3075</c:v>
                </c:pt>
                <c:pt idx="828">
                  <c:v>0.37690000000000001</c:v>
                </c:pt>
                <c:pt idx="829">
                  <c:v>0.33329999999999999</c:v>
                </c:pt>
                <c:pt idx="830">
                  <c:v>0.30959999999999999</c:v>
                </c:pt>
                <c:pt idx="831">
                  <c:v>0.3896</c:v>
                </c:pt>
                <c:pt idx="832">
                  <c:v>0.43809999999999999</c:v>
                </c:pt>
                <c:pt idx="833">
                  <c:v>0.41710000000000003</c:v>
                </c:pt>
                <c:pt idx="834">
                  <c:v>0.42949999999999999</c:v>
                </c:pt>
                <c:pt idx="835">
                  <c:v>0.377</c:v>
                </c:pt>
                <c:pt idx="836">
                  <c:v>0.4249</c:v>
                </c:pt>
                <c:pt idx="837">
                  <c:v>0.3891</c:v>
                </c:pt>
                <c:pt idx="838">
                  <c:v>0.31309999999999999</c:v>
                </c:pt>
                <c:pt idx="839">
                  <c:v>0.25919999999999999</c:v>
                </c:pt>
                <c:pt idx="840">
                  <c:v>0.2195</c:v>
                </c:pt>
                <c:pt idx="841">
                  <c:v>0.22919999999999999</c:v>
                </c:pt>
                <c:pt idx="842">
                  <c:v>0.23830000000000001</c:v>
                </c:pt>
                <c:pt idx="843">
                  <c:v>0.2336</c:v>
                </c:pt>
                <c:pt idx="844">
                  <c:v>0.26090000000000002</c:v>
                </c:pt>
                <c:pt idx="845">
                  <c:v>0.25629999999999997</c:v>
                </c:pt>
                <c:pt idx="846">
                  <c:v>0.23050000000000001</c:v>
                </c:pt>
                <c:pt idx="847">
                  <c:v>0.24690000000000001</c:v>
                </c:pt>
                <c:pt idx="848">
                  <c:v>0.26800000000000002</c:v>
                </c:pt>
                <c:pt idx="849">
                  <c:v>0.25879999999999997</c:v>
                </c:pt>
                <c:pt idx="850">
                  <c:v>0.23430000000000001</c:v>
                </c:pt>
                <c:pt idx="851">
                  <c:v>0.2339</c:v>
                </c:pt>
                <c:pt idx="852">
                  <c:v>0.25990000000000002</c:v>
                </c:pt>
                <c:pt idx="853">
                  <c:v>0.26240000000000002</c:v>
                </c:pt>
                <c:pt idx="854">
                  <c:v>0.2427</c:v>
                </c:pt>
                <c:pt idx="855">
                  <c:v>0.25140000000000001</c:v>
                </c:pt>
                <c:pt idx="856">
                  <c:v>0.28010000000000002</c:v>
                </c:pt>
                <c:pt idx="857">
                  <c:v>0.28589999999999999</c:v>
                </c:pt>
                <c:pt idx="858">
                  <c:v>0.27189999999999998</c:v>
                </c:pt>
                <c:pt idx="859">
                  <c:v>0.28660000000000002</c:v>
                </c:pt>
                <c:pt idx="860">
                  <c:v>0.31130000000000002</c:v>
                </c:pt>
                <c:pt idx="861">
                  <c:v>0.30830000000000002</c:v>
                </c:pt>
                <c:pt idx="862">
                  <c:v>0.308</c:v>
                </c:pt>
                <c:pt idx="863">
                  <c:v>0.33</c:v>
                </c:pt>
                <c:pt idx="864">
                  <c:v>0.34939999999999999</c:v>
                </c:pt>
                <c:pt idx="865">
                  <c:v>0.35410000000000003</c:v>
                </c:pt>
                <c:pt idx="866">
                  <c:v>0.40629999999999999</c:v>
                </c:pt>
                <c:pt idx="867">
                  <c:v>0.45319999999999999</c:v>
                </c:pt>
                <c:pt idx="868">
                  <c:v>0.50980000000000003</c:v>
                </c:pt>
                <c:pt idx="869">
                  <c:v>0.52580000000000005</c:v>
                </c:pt>
                <c:pt idx="870">
                  <c:v>0.51090000000000002</c:v>
                </c:pt>
                <c:pt idx="871">
                  <c:v>0.5292</c:v>
                </c:pt>
                <c:pt idx="872">
                  <c:v>0.56979999999999997</c:v>
                </c:pt>
                <c:pt idx="873">
                  <c:v>0.66300000000000003</c:v>
                </c:pt>
                <c:pt idx="874">
                  <c:v>0.72940000000000005</c:v>
                </c:pt>
                <c:pt idx="875">
                  <c:v>0.83609999999999995</c:v>
                </c:pt>
                <c:pt idx="876">
                  <c:v>0.95960000000000001</c:v>
                </c:pt>
                <c:pt idx="877">
                  <c:v>1.0373000000000001</c:v>
                </c:pt>
                <c:pt idx="878">
                  <c:v>1.0511999999999999</c:v>
                </c:pt>
                <c:pt idx="879">
                  <c:v>1.0859000000000001</c:v>
                </c:pt>
                <c:pt idx="880">
                  <c:v>1.0327999999999999</c:v>
                </c:pt>
                <c:pt idx="881">
                  <c:v>0.92130000000000001</c:v>
                </c:pt>
                <c:pt idx="882">
                  <c:v>1.0066999999999999</c:v>
                </c:pt>
                <c:pt idx="883">
                  <c:v>0.95879999999999999</c:v>
                </c:pt>
                <c:pt idx="884">
                  <c:v>0.76480000000000004</c:v>
                </c:pt>
                <c:pt idx="885">
                  <c:v>0.62290000000000001</c:v>
                </c:pt>
                <c:pt idx="886">
                  <c:v>0.54969999999999997</c:v>
                </c:pt>
                <c:pt idx="887">
                  <c:v>0.435</c:v>
                </c:pt>
                <c:pt idx="888">
                  <c:v>0.37519999999999998</c:v>
                </c:pt>
                <c:pt idx="889">
                  <c:v>0.40849999999999997</c:v>
                </c:pt>
                <c:pt idx="890">
                  <c:v>0.34720000000000001</c:v>
                </c:pt>
                <c:pt idx="891">
                  <c:v>0.31659999999999999</c:v>
                </c:pt>
                <c:pt idx="892">
                  <c:v>0.35699999999999998</c:v>
                </c:pt>
                <c:pt idx="893">
                  <c:v>0.308</c:v>
                </c:pt>
                <c:pt idx="894">
                  <c:v>0.2969</c:v>
                </c:pt>
                <c:pt idx="895">
                  <c:v>0.3458</c:v>
                </c:pt>
                <c:pt idx="896">
                  <c:v>0.37040000000000001</c:v>
                </c:pt>
                <c:pt idx="897">
                  <c:v>0.47510000000000002</c:v>
                </c:pt>
                <c:pt idx="898">
                  <c:v>0.54430000000000001</c:v>
                </c:pt>
                <c:pt idx="899">
                  <c:v>0.45810000000000001</c:v>
                </c:pt>
                <c:pt idx="900">
                  <c:v>0.4229</c:v>
                </c:pt>
                <c:pt idx="901">
                  <c:v>0.54020000000000001</c:v>
                </c:pt>
                <c:pt idx="902">
                  <c:v>0.53190000000000004</c:v>
                </c:pt>
                <c:pt idx="903">
                  <c:v>0.52900000000000003</c:v>
                </c:pt>
                <c:pt idx="904">
                  <c:v>0.62439999999999996</c:v>
                </c:pt>
                <c:pt idx="905">
                  <c:v>0.5504</c:v>
                </c:pt>
                <c:pt idx="906">
                  <c:v>0.49580000000000002</c:v>
                </c:pt>
                <c:pt idx="907">
                  <c:v>0.51639999999999997</c:v>
                </c:pt>
                <c:pt idx="908">
                  <c:v>0.53639999999999999</c:v>
                </c:pt>
                <c:pt idx="909">
                  <c:v>0.66479999999999995</c:v>
                </c:pt>
                <c:pt idx="910">
                  <c:v>0.87029999999999996</c:v>
                </c:pt>
                <c:pt idx="911">
                  <c:v>1.0519000000000001</c:v>
                </c:pt>
                <c:pt idx="912">
                  <c:v>1.1991000000000001</c:v>
                </c:pt>
                <c:pt idx="913">
                  <c:v>1.2423999999999999</c:v>
                </c:pt>
                <c:pt idx="914">
                  <c:v>1.4087000000000001</c:v>
                </c:pt>
                <c:pt idx="915">
                  <c:v>1.6223000000000001</c:v>
                </c:pt>
                <c:pt idx="916">
                  <c:v>1.5555000000000001</c:v>
                </c:pt>
                <c:pt idx="917">
                  <c:v>1.3793</c:v>
                </c:pt>
                <c:pt idx="918">
                  <c:v>1.5537000000000001</c:v>
                </c:pt>
                <c:pt idx="919">
                  <c:v>1.6858</c:v>
                </c:pt>
                <c:pt idx="920">
                  <c:v>1.5107999999999999</c:v>
                </c:pt>
                <c:pt idx="921">
                  <c:v>1.4813000000000001</c:v>
                </c:pt>
                <c:pt idx="922">
                  <c:v>1.6698</c:v>
                </c:pt>
                <c:pt idx="923">
                  <c:v>1.6978</c:v>
                </c:pt>
                <c:pt idx="924">
                  <c:v>1.84</c:v>
                </c:pt>
                <c:pt idx="925">
                  <c:v>1.7319</c:v>
                </c:pt>
                <c:pt idx="926">
                  <c:v>1.6347</c:v>
                </c:pt>
                <c:pt idx="927">
                  <c:v>1.4498</c:v>
                </c:pt>
                <c:pt idx="928">
                  <c:v>1.4051</c:v>
                </c:pt>
                <c:pt idx="929">
                  <c:v>1.2487999999999999</c:v>
                </c:pt>
                <c:pt idx="930">
                  <c:v>1.2250000000000001</c:v>
                </c:pt>
                <c:pt idx="931">
                  <c:v>1.2663</c:v>
                </c:pt>
                <c:pt idx="932">
                  <c:v>1.1859999999999999</c:v>
                </c:pt>
                <c:pt idx="933">
                  <c:v>1.3263</c:v>
                </c:pt>
                <c:pt idx="934">
                  <c:v>1.5021</c:v>
                </c:pt>
                <c:pt idx="935">
                  <c:v>1.5987</c:v>
                </c:pt>
                <c:pt idx="936">
                  <c:v>1.6746000000000001</c:v>
                </c:pt>
                <c:pt idx="937">
                  <c:v>1.8599000000000001</c:v>
                </c:pt>
                <c:pt idx="938">
                  <c:v>1.9559</c:v>
                </c:pt>
                <c:pt idx="939">
                  <c:v>2.0996999999999999</c:v>
                </c:pt>
                <c:pt idx="940">
                  <c:v>1.9637</c:v>
                </c:pt>
                <c:pt idx="941">
                  <c:v>1.7643</c:v>
                </c:pt>
                <c:pt idx="942">
                  <c:v>1.5729</c:v>
                </c:pt>
                <c:pt idx="943">
                  <c:v>1.4308000000000001</c:v>
                </c:pt>
                <c:pt idx="944">
                  <c:v>1.4420999999999999</c:v>
                </c:pt>
                <c:pt idx="945">
                  <c:v>1.3875</c:v>
                </c:pt>
                <c:pt idx="946">
                  <c:v>1.2202</c:v>
                </c:pt>
                <c:pt idx="947">
                  <c:v>1.1386000000000001</c:v>
                </c:pt>
                <c:pt idx="948">
                  <c:v>1.1534</c:v>
                </c:pt>
                <c:pt idx="949">
                  <c:v>1.0510999999999999</c:v>
                </c:pt>
                <c:pt idx="950">
                  <c:v>0.88580000000000003</c:v>
                </c:pt>
                <c:pt idx="951">
                  <c:v>0.9052</c:v>
                </c:pt>
                <c:pt idx="952">
                  <c:v>0.90180000000000005</c:v>
                </c:pt>
                <c:pt idx="953">
                  <c:v>0.76500000000000001</c:v>
                </c:pt>
                <c:pt idx="954">
                  <c:v>0.69159999999999999</c:v>
                </c:pt>
                <c:pt idx="955">
                  <c:v>0.77229999999999999</c:v>
                </c:pt>
                <c:pt idx="956">
                  <c:v>0.74039999999999995</c:v>
                </c:pt>
                <c:pt idx="957">
                  <c:v>0.64359999999999995</c:v>
                </c:pt>
                <c:pt idx="958">
                  <c:v>0.69620000000000004</c:v>
                </c:pt>
                <c:pt idx="959">
                  <c:v>0.76949999999999996</c:v>
                </c:pt>
                <c:pt idx="960">
                  <c:v>0.79149999999999998</c:v>
                </c:pt>
                <c:pt idx="961">
                  <c:v>0.76959999999999995</c:v>
                </c:pt>
                <c:pt idx="962">
                  <c:v>0.84709999999999996</c:v>
                </c:pt>
                <c:pt idx="963">
                  <c:v>0.91769999999999996</c:v>
                </c:pt>
                <c:pt idx="964">
                  <c:v>1.0097</c:v>
                </c:pt>
                <c:pt idx="965">
                  <c:v>1.1637999999999999</c:v>
                </c:pt>
                <c:pt idx="966">
                  <c:v>1.3016000000000001</c:v>
                </c:pt>
                <c:pt idx="967">
                  <c:v>1.4258999999999999</c:v>
                </c:pt>
                <c:pt idx="968">
                  <c:v>1.6140000000000001</c:v>
                </c:pt>
                <c:pt idx="969">
                  <c:v>1.7342</c:v>
                </c:pt>
                <c:pt idx="970">
                  <c:v>1.8149</c:v>
                </c:pt>
                <c:pt idx="971">
                  <c:v>1.9387000000000001</c:v>
                </c:pt>
                <c:pt idx="972">
                  <c:v>2.0181</c:v>
                </c:pt>
                <c:pt idx="973">
                  <c:v>1.9625999999999999</c:v>
                </c:pt>
                <c:pt idx="974">
                  <c:v>2.0764999999999998</c:v>
                </c:pt>
                <c:pt idx="975">
                  <c:v>1.9928999999999999</c:v>
                </c:pt>
                <c:pt idx="976">
                  <c:v>1.9947999999999999</c:v>
                </c:pt>
                <c:pt idx="977">
                  <c:v>1.8731</c:v>
                </c:pt>
                <c:pt idx="978">
                  <c:v>1.8185</c:v>
                </c:pt>
                <c:pt idx="979">
                  <c:v>1.7809999999999999</c:v>
                </c:pt>
                <c:pt idx="980">
                  <c:v>1.6969000000000001</c:v>
                </c:pt>
                <c:pt idx="981">
                  <c:v>1.5803</c:v>
                </c:pt>
                <c:pt idx="982">
                  <c:v>1.5474000000000001</c:v>
                </c:pt>
                <c:pt idx="983">
                  <c:v>1.5415000000000001</c:v>
                </c:pt>
                <c:pt idx="984">
                  <c:v>1.4420999999999999</c:v>
                </c:pt>
                <c:pt idx="985">
                  <c:v>1.3516999999999999</c:v>
                </c:pt>
                <c:pt idx="986">
                  <c:v>1.3571</c:v>
                </c:pt>
                <c:pt idx="987">
                  <c:v>1.3326</c:v>
                </c:pt>
                <c:pt idx="988">
                  <c:v>1.2254</c:v>
                </c:pt>
                <c:pt idx="989">
                  <c:v>1.1656</c:v>
                </c:pt>
                <c:pt idx="990">
                  <c:v>1.0813999999999999</c:v>
                </c:pt>
                <c:pt idx="991">
                  <c:v>1.0911999999999999</c:v>
                </c:pt>
                <c:pt idx="992">
                  <c:v>1.0178</c:v>
                </c:pt>
                <c:pt idx="993">
                  <c:v>1.028</c:v>
                </c:pt>
                <c:pt idx="994">
                  <c:v>1.0894999999999999</c:v>
                </c:pt>
                <c:pt idx="995">
                  <c:v>1.1242000000000001</c:v>
                </c:pt>
                <c:pt idx="996">
                  <c:v>1.2423999999999999</c:v>
                </c:pt>
                <c:pt idx="997">
                  <c:v>1.3875999999999999</c:v>
                </c:pt>
                <c:pt idx="998">
                  <c:v>1.4733000000000001</c:v>
                </c:pt>
                <c:pt idx="999">
                  <c:v>1.3747</c:v>
                </c:pt>
                <c:pt idx="1000">
                  <c:v>1.3242</c:v>
                </c:pt>
                <c:pt idx="1001">
                  <c:v>1.2504</c:v>
                </c:pt>
                <c:pt idx="1002">
                  <c:v>1.2749999999999999</c:v>
                </c:pt>
                <c:pt idx="1003">
                  <c:v>1.3666</c:v>
                </c:pt>
                <c:pt idx="1004">
                  <c:v>1.4469000000000001</c:v>
                </c:pt>
                <c:pt idx="1005">
                  <c:v>1.4463999999999999</c:v>
                </c:pt>
                <c:pt idx="1006">
                  <c:v>1.5390999999999999</c:v>
                </c:pt>
                <c:pt idx="1007">
                  <c:v>1.6604000000000001</c:v>
                </c:pt>
                <c:pt idx="1008">
                  <c:v>1.6635</c:v>
                </c:pt>
                <c:pt idx="1009">
                  <c:v>1.7563</c:v>
                </c:pt>
                <c:pt idx="1010">
                  <c:v>1.8283</c:v>
                </c:pt>
                <c:pt idx="1011">
                  <c:v>1.9195</c:v>
                </c:pt>
                <c:pt idx="1012">
                  <c:v>2.061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CB0A-42E6-B07E-7FDA21594A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8885664"/>
        <c:axId val="-8884576"/>
      </c:lineChart>
      <c:catAx>
        <c:axId val="-888566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84576"/>
        <c:crosses val="autoZero"/>
        <c:auto val="1"/>
        <c:lblAlgn val="ctr"/>
        <c:lblOffset val="100"/>
        <c:tickLblSkip val="50"/>
        <c:noMultiLvlLbl val="0"/>
      </c:catAx>
      <c:valAx>
        <c:axId val="-8884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856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ayout>
        <c:manualLayout>
          <c:xMode val="edge"/>
          <c:yMode val="edge"/>
          <c:x val="5.4812500000000007E-2"/>
          <c:y val="0.18998067949839603"/>
          <c:w val="0.61460455135791425"/>
          <c:h val="7.853783902012248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u-HU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1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cat>
            <c:numRef>
              <c:f>Sheet1!$A$2:$A$51</c:f>
              <c:numCache>
                <c:formatCode>General</c:formatCode>
                <c:ptCount val="50"/>
                <c:pt idx="0">
                  <c:v>361</c:v>
                </c:pt>
                <c:pt idx="1">
                  <c:v>362</c:v>
                </c:pt>
                <c:pt idx="2">
                  <c:v>363</c:v>
                </c:pt>
                <c:pt idx="3">
                  <c:v>364</c:v>
                </c:pt>
                <c:pt idx="4">
                  <c:v>365</c:v>
                </c:pt>
                <c:pt idx="5">
                  <c:v>366</c:v>
                </c:pt>
                <c:pt idx="6">
                  <c:v>367</c:v>
                </c:pt>
                <c:pt idx="7">
                  <c:v>368</c:v>
                </c:pt>
                <c:pt idx="8">
                  <c:v>369</c:v>
                </c:pt>
                <c:pt idx="9">
                  <c:v>370</c:v>
                </c:pt>
                <c:pt idx="10">
                  <c:v>371</c:v>
                </c:pt>
                <c:pt idx="11">
                  <c:v>372</c:v>
                </c:pt>
                <c:pt idx="12">
                  <c:v>373</c:v>
                </c:pt>
                <c:pt idx="13">
                  <c:v>374</c:v>
                </c:pt>
                <c:pt idx="14">
                  <c:v>375</c:v>
                </c:pt>
                <c:pt idx="15">
                  <c:v>376</c:v>
                </c:pt>
                <c:pt idx="16">
                  <c:v>377</c:v>
                </c:pt>
                <c:pt idx="17">
                  <c:v>378</c:v>
                </c:pt>
                <c:pt idx="18">
                  <c:v>379</c:v>
                </c:pt>
                <c:pt idx="19">
                  <c:v>380</c:v>
                </c:pt>
                <c:pt idx="20">
                  <c:v>381</c:v>
                </c:pt>
                <c:pt idx="21">
                  <c:v>382</c:v>
                </c:pt>
                <c:pt idx="22">
                  <c:v>383</c:v>
                </c:pt>
                <c:pt idx="23">
                  <c:v>384</c:v>
                </c:pt>
                <c:pt idx="24">
                  <c:v>385</c:v>
                </c:pt>
                <c:pt idx="25">
                  <c:v>386</c:v>
                </c:pt>
                <c:pt idx="26">
                  <c:v>387</c:v>
                </c:pt>
                <c:pt idx="27">
                  <c:v>388</c:v>
                </c:pt>
                <c:pt idx="28">
                  <c:v>389</c:v>
                </c:pt>
                <c:pt idx="29">
                  <c:v>390</c:v>
                </c:pt>
                <c:pt idx="30">
                  <c:v>391</c:v>
                </c:pt>
                <c:pt idx="31">
                  <c:v>392</c:v>
                </c:pt>
                <c:pt idx="32">
                  <c:v>393</c:v>
                </c:pt>
                <c:pt idx="33">
                  <c:v>394</c:v>
                </c:pt>
                <c:pt idx="34">
                  <c:v>395</c:v>
                </c:pt>
                <c:pt idx="35">
                  <c:v>396</c:v>
                </c:pt>
                <c:pt idx="36">
                  <c:v>397</c:v>
                </c:pt>
                <c:pt idx="37">
                  <c:v>398</c:v>
                </c:pt>
                <c:pt idx="38">
                  <c:v>399</c:v>
                </c:pt>
                <c:pt idx="39">
                  <c:v>400</c:v>
                </c:pt>
                <c:pt idx="40">
                  <c:v>401</c:v>
                </c:pt>
                <c:pt idx="41">
                  <c:v>402</c:v>
                </c:pt>
                <c:pt idx="42">
                  <c:v>403</c:v>
                </c:pt>
                <c:pt idx="43">
                  <c:v>404</c:v>
                </c:pt>
                <c:pt idx="44">
                  <c:v>405</c:v>
                </c:pt>
                <c:pt idx="45">
                  <c:v>406</c:v>
                </c:pt>
                <c:pt idx="46">
                  <c:v>407</c:v>
                </c:pt>
                <c:pt idx="47">
                  <c:v>408</c:v>
                </c:pt>
                <c:pt idx="48">
                  <c:v>409</c:v>
                </c:pt>
                <c:pt idx="49">
                  <c:v>410</c:v>
                </c:pt>
              </c:numCache>
            </c:numRef>
          </c:cat>
          <c:val>
            <c:numRef>
              <c:f>Sheet1!$B$2:$B$51</c:f>
              <c:numCache>
                <c:formatCode>General</c:formatCode>
                <c:ptCount val="50"/>
                <c:pt idx="0">
                  <c:v>0.18</c:v>
                </c:pt>
                <c:pt idx="1">
                  <c:v>0.17299999999999999</c:v>
                </c:pt>
                <c:pt idx="2">
                  <c:v>0.19570000000000001</c:v>
                </c:pt>
                <c:pt idx="3">
                  <c:v>0.23269999999999999</c:v>
                </c:pt>
                <c:pt idx="4">
                  <c:v>0.21079999999999999</c:v>
                </c:pt>
                <c:pt idx="5">
                  <c:v>0.2319</c:v>
                </c:pt>
                <c:pt idx="6">
                  <c:v>0.25259999999999999</c:v>
                </c:pt>
                <c:pt idx="7">
                  <c:v>0.26269999999999999</c:v>
                </c:pt>
                <c:pt idx="8">
                  <c:v>0.39069999999999999</c:v>
                </c:pt>
                <c:pt idx="9">
                  <c:v>0.44</c:v>
                </c:pt>
                <c:pt idx="10">
                  <c:v>0.44330000000000003</c:v>
                </c:pt>
                <c:pt idx="11">
                  <c:v>0.4229</c:v>
                </c:pt>
                <c:pt idx="12">
                  <c:v>0.40189999999999998</c:v>
                </c:pt>
                <c:pt idx="13">
                  <c:v>0.37590000000000001</c:v>
                </c:pt>
                <c:pt idx="14">
                  <c:v>0.3846</c:v>
                </c:pt>
                <c:pt idx="15">
                  <c:v>0.35599999999999998</c:v>
                </c:pt>
                <c:pt idx="16">
                  <c:v>0.3352</c:v>
                </c:pt>
                <c:pt idx="17">
                  <c:v>0.3362</c:v>
                </c:pt>
                <c:pt idx="18">
                  <c:v>0.4501</c:v>
                </c:pt>
                <c:pt idx="19">
                  <c:v>0.36870000000000003</c:v>
                </c:pt>
                <c:pt idx="20">
                  <c:v>0.35149999999999998</c:v>
                </c:pt>
                <c:pt idx="21">
                  <c:v>0.33860000000000001</c:v>
                </c:pt>
                <c:pt idx="22">
                  <c:v>0.34210000000000002</c:v>
                </c:pt>
                <c:pt idx="23">
                  <c:v>0.34470000000000001</c:v>
                </c:pt>
                <c:pt idx="24">
                  <c:v>0.33750000000000002</c:v>
                </c:pt>
                <c:pt idx="25">
                  <c:v>0.35010000000000002</c:v>
                </c:pt>
                <c:pt idx="26">
                  <c:v>0.39140000000000003</c:v>
                </c:pt>
                <c:pt idx="27">
                  <c:v>0.44879999999999998</c:v>
                </c:pt>
                <c:pt idx="28">
                  <c:v>0.53759999999999997</c:v>
                </c:pt>
                <c:pt idx="29">
                  <c:v>0.65410000000000001</c:v>
                </c:pt>
                <c:pt idx="30">
                  <c:v>0.67110000000000003</c:v>
                </c:pt>
                <c:pt idx="31">
                  <c:v>0.66659999999999997</c:v>
                </c:pt>
                <c:pt idx="32">
                  <c:v>0.70120000000000005</c:v>
                </c:pt>
                <c:pt idx="33">
                  <c:v>0.67710000000000004</c:v>
                </c:pt>
                <c:pt idx="34">
                  <c:v>0.77329999999999999</c:v>
                </c:pt>
                <c:pt idx="35">
                  <c:v>0.80279999999999996</c:v>
                </c:pt>
                <c:pt idx="36">
                  <c:v>0.76160000000000005</c:v>
                </c:pt>
                <c:pt idx="37">
                  <c:v>0.7923</c:v>
                </c:pt>
                <c:pt idx="38">
                  <c:v>0.77100000000000002</c:v>
                </c:pt>
                <c:pt idx="39">
                  <c:v>0.67410000000000003</c:v>
                </c:pt>
                <c:pt idx="40">
                  <c:v>0.45779999999999998</c:v>
                </c:pt>
                <c:pt idx="41">
                  <c:v>0.34150000000000003</c:v>
                </c:pt>
                <c:pt idx="42">
                  <c:v>0.29709999999999998</c:v>
                </c:pt>
                <c:pt idx="43">
                  <c:v>0.29120000000000001</c:v>
                </c:pt>
                <c:pt idx="44">
                  <c:v>0.23630000000000001</c:v>
                </c:pt>
                <c:pt idx="45">
                  <c:v>0.20399999999999999</c:v>
                </c:pt>
                <c:pt idx="46">
                  <c:v>0.17949999999999999</c:v>
                </c:pt>
                <c:pt idx="47">
                  <c:v>0.1774</c:v>
                </c:pt>
                <c:pt idx="48">
                  <c:v>0.18340000000000001</c:v>
                </c:pt>
                <c:pt idx="49">
                  <c:v>0.1811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4CD-4DBD-8DE3-DCCF9C33712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eries2</c:v>
                </c:pt>
              </c:strCache>
            </c:strRef>
          </c:tx>
          <c:spPr>
            <a:ln w="19050" cap="rnd">
              <a:solidFill>
                <a:srgbClr val="0099FF"/>
              </a:solidFill>
              <a:round/>
            </a:ln>
            <a:effectLst/>
          </c:spPr>
          <c:marker>
            <c:symbol val="none"/>
          </c:marker>
          <c:cat>
            <c:numRef>
              <c:f>Sheet1!$A$2:$A$51</c:f>
              <c:numCache>
                <c:formatCode>General</c:formatCode>
                <c:ptCount val="50"/>
                <c:pt idx="0">
                  <c:v>361</c:v>
                </c:pt>
                <c:pt idx="1">
                  <c:v>362</c:v>
                </c:pt>
                <c:pt idx="2">
                  <c:v>363</c:v>
                </c:pt>
                <c:pt idx="3">
                  <c:v>364</c:v>
                </c:pt>
                <c:pt idx="4">
                  <c:v>365</c:v>
                </c:pt>
                <c:pt idx="5">
                  <c:v>366</c:v>
                </c:pt>
                <c:pt idx="6">
                  <c:v>367</c:v>
                </c:pt>
                <c:pt idx="7">
                  <c:v>368</c:v>
                </c:pt>
                <c:pt idx="8">
                  <c:v>369</c:v>
                </c:pt>
                <c:pt idx="9">
                  <c:v>370</c:v>
                </c:pt>
                <c:pt idx="10">
                  <c:v>371</c:v>
                </c:pt>
                <c:pt idx="11">
                  <c:v>372</c:v>
                </c:pt>
                <c:pt idx="12">
                  <c:v>373</c:v>
                </c:pt>
                <c:pt idx="13">
                  <c:v>374</c:v>
                </c:pt>
                <c:pt idx="14">
                  <c:v>375</c:v>
                </c:pt>
                <c:pt idx="15">
                  <c:v>376</c:v>
                </c:pt>
                <c:pt idx="16">
                  <c:v>377</c:v>
                </c:pt>
                <c:pt idx="17">
                  <c:v>378</c:v>
                </c:pt>
                <c:pt idx="18">
                  <c:v>379</c:v>
                </c:pt>
                <c:pt idx="19">
                  <c:v>380</c:v>
                </c:pt>
                <c:pt idx="20">
                  <c:v>381</c:v>
                </c:pt>
                <c:pt idx="21">
                  <c:v>382</c:v>
                </c:pt>
                <c:pt idx="22">
                  <c:v>383</c:v>
                </c:pt>
                <c:pt idx="23">
                  <c:v>384</c:v>
                </c:pt>
                <c:pt idx="24">
                  <c:v>385</c:v>
                </c:pt>
                <c:pt idx="25">
                  <c:v>386</c:v>
                </c:pt>
                <c:pt idx="26">
                  <c:v>387</c:v>
                </c:pt>
                <c:pt idx="27">
                  <c:v>388</c:v>
                </c:pt>
                <c:pt idx="28">
                  <c:v>389</c:v>
                </c:pt>
                <c:pt idx="29">
                  <c:v>390</c:v>
                </c:pt>
                <c:pt idx="30">
                  <c:v>391</c:v>
                </c:pt>
                <c:pt idx="31">
                  <c:v>392</c:v>
                </c:pt>
                <c:pt idx="32">
                  <c:v>393</c:v>
                </c:pt>
                <c:pt idx="33">
                  <c:v>394</c:v>
                </c:pt>
                <c:pt idx="34">
                  <c:v>395</c:v>
                </c:pt>
                <c:pt idx="35">
                  <c:v>396</c:v>
                </c:pt>
                <c:pt idx="36">
                  <c:v>397</c:v>
                </c:pt>
                <c:pt idx="37">
                  <c:v>398</c:v>
                </c:pt>
                <c:pt idx="38">
                  <c:v>399</c:v>
                </c:pt>
                <c:pt idx="39">
                  <c:v>400</c:v>
                </c:pt>
                <c:pt idx="40">
                  <c:v>401</c:v>
                </c:pt>
                <c:pt idx="41">
                  <c:v>402</c:v>
                </c:pt>
                <c:pt idx="42">
                  <c:v>403</c:v>
                </c:pt>
                <c:pt idx="43">
                  <c:v>404</c:v>
                </c:pt>
                <c:pt idx="44">
                  <c:v>405</c:v>
                </c:pt>
                <c:pt idx="45">
                  <c:v>406</c:v>
                </c:pt>
                <c:pt idx="46">
                  <c:v>407</c:v>
                </c:pt>
                <c:pt idx="47">
                  <c:v>408</c:v>
                </c:pt>
                <c:pt idx="48">
                  <c:v>409</c:v>
                </c:pt>
                <c:pt idx="49">
                  <c:v>410</c:v>
                </c:pt>
              </c:numCache>
            </c:numRef>
          </c:cat>
          <c:val>
            <c:numRef>
              <c:f>Sheet1!$C$2:$C$51</c:f>
              <c:numCache>
                <c:formatCode>General</c:formatCode>
                <c:ptCount val="50"/>
                <c:pt idx="0">
                  <c:v>0.2467</c:v>
                </c:pt>
                <c:pt idx="1">
                  <c:v>0.24640000000000001</c:v>
                </c:pt>
                <c:pt idx="2">
                  <c:v>0.24979999999999999</c:v>
                </c:pt>
                <c:pt idx="3">
                  <c:v>0.25140000000000001</c:v>
                </c:pt>
                <c:pt idx="4">
                  <c:v>0.2646</c:v>
                </c:pt>
                <c:pt idx="5">
                  <c:v>0.26329999999999998</c:v>
                </c:pt>
                <c:pt idx="6">
                  <c:v>0.2802</c:v>
                </c:pt>
                <c:pt idx="7">
                  <c:v>0.29210000000000003</c:v>
                </c:pt>
                <c:pt idx="8">
                  <c:v>0.30940000000000001</c:v>
                </c:pt>
                <c:pt idx="9">
                  <c:v>0.3014</c:v>
                </c:pt>
                <c:pt idx="10">
                  <c:v>0.27929999999999999</c:v>
                </c:pt>
                <c:pt idx="11">
                  <c:v>0.26190000000000002</c:v>
                </c:pt>
                <c:pt idx="12">
                  <c:v>0.26319999999999999</c:v>
                </c:pt>
                <c:pt idx="13">
                  <c:v>0.26329999999999998</c:v>
                </c:pt>
                <c:pt idx="14">
                  <c:v>0.26250000000000001</c:v>
                </c:pt>
                <c:pt idx="15">
                  <c:v>0.28170000000000001</c:v>
                </c:pt>
                <c:pt idx="16">
                  <c:v>0.27189999999999998</c:v>
                </c:pt>
                <c:pt idx="17">
                  <c:v>0.23100000000000001</c:v>
                </c:pt>
                <c:pt idx="18">
                  <c:v>0.2571</c:v>
                </c:pt>
                <c:pt idx="19">
                  <c:v>0.25019999999999998</c:v>
                </c:pt>
                <c:pt idx="20">
                  <c:v>0.26540000000000002</c:v>
                </c:pt>
                <c:pt idx="21">
                  <c:v>0.2873</c:v>
                </c:pt>
                <c:pt idx="22">
                  <c:v>0.31180000000000002</c:v>
                </c:pt>
                <c:pt idx="23">
                  <c:v>0.32029999999999997</c:v>
                </c:pt>
                <c:pt idx="24">
                  <c:v>0.33040000000000003</c:v>
                </c:pt>
                <c:pt idx="25">
                  <c:v>0.30669999999999997</c:v>
                </c:pt>
                <c:pt idx="26">
                  <c:v>0.27439999999999998</c:v>
                </c:pt>
                <c:pt idx="27">
                  <c:v>0.26179999999999998</c:v>
                </c:pt>
                <c:pt idx="28">
                  <c:v>0.30149999999999999</c:v>
                </c:pt>
                <c:pt idx="29">
                  <c:v>0.37469999999999998</c:v>
                </c:pt>
                <c:pt idx="30">
                  <c:v>0.3458</c:v>
                </c:pt>
                <c:pt idx="31">
                  <c:v>0.45590000000000003</c:v>
                </c:pt>
                <c:pt idx="32">
                  <c:v>0.45529999999999998</c:v>
                </c:pt>
                <c:pt idx="33">
                  <c:v>0.43340000000000001</c:v>
                </c:pt>
                <c:pt idx="34">
                  <c:v>0.51559999999999995</c:v>
                </c:pt>
                <c:pt idx="35">
                  <c:v>0.42130000000000001</c:v>
                </c:pt>
                <c:pt idx="36">
                  <c:v>0.39150000000000001</c:v>
                </c:pt>
                <c:pt idx="37">
                  <c:v>0.40100000000000002</c:v>
                </c:pt>
                <c:pt idx="38">
                  <c:v>0.44280000000000003</c:v>
                </c:pt>
                <c:pt idx="39">
                  <c:v>0.497</c:v>
                </c:pt>
                <c:pt idx="40">
                  <c:v>0.47610000000000002</c:v>
                </c:pt>
                <c:pt idx="41">
                  <c:v>0.37959999999999999</c:v>
                </c:pt>
                <c:pt idx="42">
                  <c:v>0.40670000000000001</c:v>
                </c:pt>
                <c:pt idx="43">
                  <c:v>0.2326</c:v>
                </c:pt>
                <c:pt idx="44">
                  <c:v>0.19620000000000001</c:v>
                </c:pt>
                <c:pt idx="45">
                  <c:v>0.20030000000000001</c:v>
                </c:pt>
                <c:pt idx="46">
                  <c:v>0.2429</c:v>
                </c:pt>
                <c:pt idx="47">
                  <c:v>0.2135</c:v>
                </c:pt>
                <c:pt idx="48">
                  <c:v>0.2109</c:v>
                </c:pt>
                <c:pt idx="49">
                  <c:v>0.2044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4CD-4DBD-8DE3-DCCF9C337125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Series3</c:v>
                </c:pt>
              </c:strCache>
            </c:strRef>
          </c:tx>
          <c:spPr>
            <a:ln w="19050" cap="rnd">
              <a:solidFill>
                <a:srgbClr val="33CCCC"/>
              </a:solidFill>
              <a:round/>
            </a:ln>
            <a:effectLst/>
          </c:spPr>
          <c:marker>
            <c:symbol val="none"/>
          </c:marker>
          <c:cat>
            <c:numRef>
              <c:f>Sheet1!$A$2:$A$51</c:f>
              <c:numCache>
                <c:formatCode>General</c:formatCode>
                <c:ptCount val="50"/>
                <c:pt idx="0">
                  <c:v>361</c:v>
                </c:pt>
                <c:pt idx="1">
                  <c:v>362</c:v>
                </c:pt>
                <c:pt idx="2">
                  <c:v>363</c:v>
                </c:pt>
                <c:pt idx="3">
                  <c:v>364</c:v>
                </c:pt>
                <c:pt idx="4">
                  <c:v>365</c:v>
                </c:pt>
                <c:pt idx="5">
                  <c:v>366</c:v>
                </c:pt>
                <c:pt idx="6">
                  <c:v>367</c:v>
                </c:pt>
                <c:pt idx="7">
                  <c:v>368</c:v>
                </c:pt>
                <c:pt idx="8">
                  <c:v>369</c:v>
                </c:pt>
                <c:pt idx="9">
                  <c:v>370</c:v>
                </c:pt>
                <c:pt idx="10">
                  <c:v>371</c:v>
                </c:pt>
                <c:pt idx="11">
                  <c:v>372</c:v>
                </c:pt>
                <c:pt idx="12">
                  <c:v>373</c:v>
                </c:pt>
                <c:pt idx="13">
                  <c:v>374</c:v>
                </c:pt>
                <c:pt idx="14">
                  <c:v>375</c:v>
                </c:pt>
                <c:pt idx="15">
                  <c:v>376</c:v>
                </c:pt>
                <c:pt idx="16">
                  <c:v>377</c:v>
                </c:pt>
                <c:pt idx="17">
                  <c:v>378</c:v>
                </c:pt>
                <c:pt idx="18">
                  <c:v>379</c:v>
                </c:pt>
                <c:pt idx="19">
                  <c:v>380</c:v>
                </c:pt>
                <c:pt idx="20">
                  <c:v>381</c:v>
                </c:pt>
                <c:pt idx="21">
                  <c:v>382</c:v>
                </c:pt>
                <c:pt idx="22">
                  <c:v>383</c:v>
                </c:pt>
                <c:pt idx="23">
                  <c:v>384</c:v>
                </c:pt>
                <c:pt idx="24">
                  <c:v>385</c:v>
                </c:pt>
                <c:pt idx="25">
                  <c:v>386</c:v>
                </c:pt>
                <c:pt idx="26">
                  <c:v>387</c:v>
                </c:pt>
                <c:pt idx="27">
                  <c:v>388</c:v>
                </c:pt>
                <c:pt idx="28">
                  <c:v>389</c:v>
                </c:pt>
                <c:pt idx="29">
                  <c:v>390</c:v>
                </c:pt>
                <c:pt idx="30">
                  <c:v>391</c:v>
                </c:pt>
                <c:pt idx="31">
                  <c:v>392</c:v>
                </c:pt>
                <c:pt idx="32">
                  <c:v>393</c:v>
                </c:pt>
                <c:pt idx="33">
                  <c:v>394</c:v>
                </c:pt>
                <c:pt idx="34">
                  <c:v>395</c:v>
                </c:pt>
                <c:pt idx="35">
                  <c:v>396</c:v>
                </c:pt>
                <c:pt idx="36">
                  <c:v>397</c:v>
                </c:pt>
                <c:pt idx="37">
                  <c:v>398</c:v>
                </c:pt>
                <c:pt idx="38">
                  <c:v>399</c:v>
                </c:pt>
                <c:pt idx="39">
                  <c:v>400</c:v>
                </c:pt>
                <c:pt idx="40">
                  <c:v>401</c:v>
                </c:pt>
                <c:pt idx="41">
                  <c:v>402</c:v>
                </c:pt>
                <c:pt idx="42">
                  <c:v>403</c:v>
                </c:pt>
                <c:pt idx="43">
                  <c:v>404</c:v>
                </c:pt>
                <c:pt idx="44">
                  <c:v>405</c:v>
                </c:pt>
                <c:pt idx="45">
                  <c:v>406</c:v>
                </c:pt>
                <c:pt idx="46">
                  <c:v>407</c:v>
                </c:pt>
                <c:pt idx="47">
                  <c:v>408</c:v>
                </c:pt>
                <c:pt idx="48">
                  <c:v>409</c:v>
                </c:pt>
                <c:pt idx="49">
                  <c:v>410</c:v>
                </c:pt>
              </c:numCache>
            </c:numRef>
          </c:cat>
          <c:val>
            <c:numRef>
              <c:f>Sheet1!$D$2:$D$51</c:f>
              <c:numCache>
                <c:formatCode>General</c:formatCode>
                <c:ptCount val="50"/>
                <c:pt idx="0">
                  <c:v>0.21440000000000001</c:v>
                </c:pt>
                <c:pt idx="1">
                  <c:v>0.22070000000000001</c:v>
                </c:pt>
                <c:pt idx="2">
                  <c:v>0.18840000000000001</c:v>
                </c:pt>
                <c:pt idx="3">
                  <c:v>0.18740000000000001</c:v>
                </c:pt>
                <c:pt idx="4">
                  <c:v>0.1925</c:v>
                </c:pt>
                <c:pt idx="5">
                  <c:v>0.20419999999999999</c:v>
                </c:pt>
                <c:pt idx="6">
                  <c:v>0.21160000000000001</c:v>
                </c:pt>
                <c:pt idx="7">
                  <c:v>0.21970000000000001</c:v>
                </c:pt>
                <c:pt idx="8">
                  <c:v>0.24030000000000001</c:v>
                </c:pt>
                <c:pt idx="9">
                  <c:v>0.25729999999999997</c:v>
                </c:pt>
                <c:pt idx="10">
                  <c:v>0.27979999999999999</c:v>
                </c:pt>
                <c:pt idx="11">
                  <c:v>0.24929999999999999</c:v>
                </c:pt>
                <c:pt idx="12">
                  <c:v>0.20710000000000001</c:v>
                </c:pt>
                <c:pt idx="13">
                  <c:v>0.1862</c:v>
                </c:pt>
                <c:pt idx="14">
                  <c:v>0.1971</c:v>
                </c:pt>
                <c:pt idx="15">
                  <c:v>0.18459999999999999</c:v>
                </c:pt>
                <c:pt idx="16">
                  <c:v>0.22170000000000001</c:v>
                </c:pt>
                <c:pt idx="17">
                  <c:v>0.2417</c:v>
                </c:pt>
                <c:pt idx="18">
                  <c:v>0.2747</c:v>
                </c:pt>
                <c:pt idx="19">
                  <c:v>0.34160000000000001</c:v>
                </c:pt>
                <c:pt idx="20">
                  <c:v>0.27729999999999999</c:v>
                </c:pt>
                <c:pt idx="21">
                  <c:v>0.2974</c:v>
                </c:pt>
                <c:pt idx="22">
                  <c:v>0.3286</c:v>
                </c:pt>
                <c:pt idx="23">
                  <c:v>0.47210000000000002</c:v>
                </c:pt>
                <c:pt idx="24">
                  <c:v>0.53029999999999999</c:v>
                </c:pt>
                <c:pt idx="25">
                  <c:v>0.47910000000000003</c:v>
                </c:pt>
                <c:pt idx="26">
                  <c:v>0.3483</c:v>
                </c:pt>
                <c:pt idx="27">
                  <c:v>0.3155</c:v>
                </c:pt>
                <c:pt idx="28">
                  <c:v>0.36709999999999998</c:v>
                </c:pt>
                <c:pt idx="29">
                  <c:v>0.44390000000000002</c:v>
                </c:pt>
                <c:pt idx="30">
                  <c:v>0.48699999999999999</c:v>
                </c:pt>
                <c:pt idx="31">
                  <c:v>0.57779999999999998</c:v>
                </c:pt>
                <c:pt idx="32">
                  <c:v>0.54600000000000004</c:v>
                </c:pt>
                <c:pt idx="33">
                  <c:v>0.5575</c:v>
                </c:pt>
                <c:pt idx="34">
                  <c:v>0.65239999999999998</c:v>
                </c:pt>
                <c:pt idx="35">
                  <c:v>0.75139999999999996</c:v>
                </c:pt>
                <c:pt idx="36">
                  <c:v>0.85660000000000003</c:v>
                </c:pt>
                <c:pt idx="37">
                  <c:v>0.79920000000000002</c:v>
                </c:pt>
                <c:pt idx="38">
                  <c:v>0.65790000000000004</c:v>
                </c:pt>
                <c:pt idx="39">
                  <c:v>0.47499999999999998</c:v>
                </c:pt>
                <c:pt idx="40">
                  <c:v>0.33939999999999998</c:v>
                </c:pt>
                <c:pt idx="41">
                  <c:v>0.26190000000000002</c:v>
                </c:pt>
                <c:pt idx="42">
                  <c:v>0.23830000000000001</c:v>
                </c:pt>
                <c:pt idx="43">
                  <c:v>0.24679999999999999</c:v>
                </c:pt>
                <c:pt idx="44">
                  <c:v>0.2455</c:v>
                </c:pt>
                <c:pt idx="45">
                  <c:v>0.1958</c:v>
                </c:pt>
                <c:pt idx="46">
                  <c:v>0.16669999999999999</c:v>
                </c:pt>
                <c:pt idx="47">
                  <c:v>0.16159999999999999</c:v>
                </c:pt>
                <c:pt idx="48">
                  <c:v>0.1588</c:v>
                </c:pt>
                <c:pt idx="49">
                  <c:v>0.1477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4CD-4DBD-8DE3-DCCF9C337125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Sheet1!$A$2:$A$51</c:f>
              <c:numCache>
                <c:formatCode>General</c:formatCode>
                <c:ptCount val="50"/>
                <c:pt idx="0">
                  <c:v>361</c:v>
                </c:pt>
                <c:pt idx="1">
                  <c:v>362</c:v>
                </c:pt>
                <c:pt idx="2">
                  <c:v>363</c:v>
                </c:pt>
                <c:pt idx="3">
                  <c:v>364</c:v>
                </c:pt>
                <c:pt idx="4">
                  <c:v>365</c:v>
                </c:pt>
                <c:pt idx="5">
                  <c:v>366</c:v>
                </c:pt>
                <c:pt idx="6">
                  <c:v>367</c:v>
                </c:pt>
                <c:pt idx="7">
                  <c:v>368</c:v>
                </c:pt>
                <c:pt idx="8">
                  <c:v>369</c:v>
                </c:pt>
                <c:pt idx="9">
                  <c:v>370</c:v>
                </c:pt>
                <c:pt idx="10">
                  <c:v>371</c:v>
                </c:pt>
                <c:pt idx="11">
                  <c:v>372</c:v>
                </c:pt>
                <c:pt idx="12">
                  <c:v>373</c:v>
                </c:pt>
                <c:pt idx="13">
                  <c:v>374</c:v>
                </c:pt>
                <c:pt idx="14">
                  <c:v>375</c:v>
                </c:pt>
                <c:pt idx="15">
                  <c:v>376</c:v>
                </c:pt>
                <c:pt idx="16">
                  <c:v>377</c:v>
                </c:pt>
                <c:pt idx="17">
                  <c:v>378</c:v>
                </c:pt>
                <c:pt idx="18">
                  <c:v>379</c:v>
                </c:pt>
                <c:pt idx="19">
                  <c:v>380</c:v>
                </c:pt>
                <c:pt idx="20">
                  <c:v>381</c:v>
                </c:pt>
                <c:pt idx="21">
                  <c:v>382</c:v>
                </c:pt>
                <c:pt idx="22">
                  <c:v>383</c:v>
                </c:pt>
                <c:pt idx="23">
                  <c:v>384</c:v>
                </c:pt>
                <c:pt idx="24">
                  <c:v>385</c:v>
                </c:pt>
                <c:pt idx="25">
                  <c:v>386</c:v>
                </c:pt>
                <c:pt idx="26">
                  <c:v>387</c:v>
                </c:pt>
                <c:pt idx="27">
                  <c:v>388</c:v>
                </c:pt>
                <c:pt idx="28">
                  <c:v>389</c:v>
                </c:pt>
                <c:pt idx="29">
                  <c:v>390</c:v>
                </c:pt>
                <c:pt idx="30">
                  <c:v>391</c:v>
                </c:pt>
                <c:pt idx="31">
                  <c:v>392</c:v>
                </c:pt>
                <c:pt idx="32">
                  <c:v>393</c:v>
                </c:pt>
                <c:pt idx="33">
                  <c:v>394</c:v>
                </c:pt>
                <c:pt idx="34">
                  <c:v>395</c:v>
                </c:pt>
                <c:pt idx="35">
                  <c:v>396</c:v>
                </c:pt>
                <c:pt idx="36">
                  <c:v>397</c:v>
                </c:pt>
                <c:pt idx="37">
                  <c:v>398</c:v>
                </c:pt>
                <c:pt idx="38">
                  <c:v>399</c:v>
                </c:pt>
                <c:pt idx="39">
                  <c:v>400</c:v>
                </c:pt>
                <c:pt idx="40">
                  <c:v>401</c:v>
                </c:pt>
                <c:pt idx="41">
                  <c:v>402</c:v>
                </c:pt>
                <c:pt idx="42">
                  <c:v>403</c:v>
                </c:pt>
                <c:pt idx="43">
                  <c:v>404</c:v>
                </c:pt>
                <c:pt idx="44">
                  <c:v>405</c:v>
                </c:pt>
                <c:pt idx="45">
                  <c:v>406</c:v>
                </c:pt>
                <c:pt idx="46">
                  <c:v>407</c:v>
                </c:pt>
                <c:pt idx="47">
                  <c:v>408</c:v>
                </c:pt>
                <c:pt idx="48">
                  <c:v>409</c:v>
                </c:pt>
                <c:pt idx="49">
                  <c:v>410</c:v>
                </c:pt>
              </c:numCache>
            </c:numRef>
          </c:cat>
          <c:val>
            <c:numRef>
              <c:f>Sheet1!$E$2:$E$51</c:f>
              <c:numCache>
                <c:formatCode>General</c:formatCode>
                <c:ptCount val="50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4CD-4DBD-8DE3-DCCF9C337125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Series4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Sheet1!$A$2:$A$51</c:f>
              <c:numCache>
                <c:formatCode>General</c:formatCode>
                <c:ptCount val="50"/>
                <c:pt idx="0">
                  <c:v>361</c:v>
                </c:pt>
                <c:pt idx="1">
                  <c:v>362</c:v>
                </c:pt>
                <c:pt idx="2">
                  <c:v>363</c:v>
                </c:pt>
                <c:pt idx="3">
                  <c:v>364</c:v>
                </c:pt>
                <c:pt idx="4">
                  <c:v>365</c:v>
                </c:pt>
                <c:pt idx="5">
                  <c:v>366</c:v>
                </c:pt>
                <c:pt idx="6">
                  <c:v>367</c:v>
                </c:pt>
                <c:pt idx="7">
                  <c:v>368</c:v>
                </c:pt>
                <c:pt idx="8">
                  <c:v>369</c:v>
                </c:pt>
                <c:pt idx="9">
                  <c:v>370</c:v>
                </c:pt>
                <c:pt idx="10">
                  <c:v>371</c:v>
                </c:pt>
                <c:pt idx="11">
                  <c:v>372</c:v>
                </c:pt>
                <c:pt idx="12">
                  <c:v>373</c:v>
                </c:pt>
                <c:pt idx="13">
                  <c:v>374</c:v>
                </c:pt>
                <c:pt idx="14">
                  <c:v>375</c:v>
                </c:pt>
                <c:pt idx="15">
                  <c:v>376</c:v>
                </c:pt>
                <c:pt idx="16">
                  <c:v>377</c:v>
                </c:pt>
                <c:pt idx="17">
                  <c:v>378</c:v>
                </c:pt>
                <c:pt idx="18">
                  <c:v>379</c:v>
                </c:pt>
                <c:pt idx="19">
                  <c:v>380</c:v>
                </c:pt>
                <c:pt idx="20">
                  <c:v>381</c:v>
                </c:pt>
                <c:pt idx="21">
                  <c:v>382</c:v>
                </c:pt>
                <c:pt idx="22">
                  <c:v>383</c:v>
                </c:pt>
                <c:pt idx="23">
                  <c:v>384</c:v>
                </c:pt>
                <c:pt idx="24">
                  <c:v>385</c:v>
                </c:pt>
                <c:pt idx="25">
                  <c:v>386</c:v>
                </c:pt>
                <c:pt idx="26">
                  <c:v>387</c:v>
                </c:pt>
                <c:pt idx="27">
                  <c:v>388</c:v>
                </c:pt>
                <c:pt idx="28">
                  <c:v>389</c:v>
                </c:pt>
                <c:pt idx="29">
                  <c:v>390</c:v>
                </c:pt>
                <c:pt idx="30">
                  <c:v>391</c:v>
                </c:pt>
                <c:pt idx="31">
                  <c:v>392</c:v>
                </c:pt>
                <c:pt idx="32">
                  <c:v>393</c:v>
                </c:pt>
                <c:pt idx="33">
                  <c:v>394</c:v>
                </c:pt>
                <c:pt idx="34">
                  <c:v>395</c:v>
                </c:pt>
                <c:pt idx="35">
                  <c:v>396</c:v>
                </c:pt>
                <c:pt idx="36">
                  <c:v>397</c:v>
                </c:pt>
                <c:pt idx="37">
                  <c:v>398</c:v>
                </c:pt>
                <c:pt idx="38">
                  <c:v>399</c:v>
                </c:pt>
                <c:pt idx="39">
                  <c:v>400</c:v>
                </c:pt>
                <c:pt idx="40">
                  <c:v>401</c:v>
                </c:pt>
                <c:pt idx="41">
                  <c:v>402</c:v>
                </c:pt>
                <c:pt idx="42">
                  <c:v>403</c:v>
                </c:pt>
                <c:pt idx="43">
                  <c:v>404</c:v>
                </c:pt>
                <c:pt idx="44">
                  <c:v>405</c:v>
                </c:pt>
                <c:pt idx="45">
                  <c:v>406</c:v>
                </c:pt>
                <c:pt idx="46">
                  <c:v>407</c:v>
                </c:pt>
                <c:pt idx="47">
                  <c:v>408</c:v>
                </c:pt>
                <c:pt idx="48">
                  <c:v>409</c:v>
                </c:pt>
                <c:pt idx="49">
                  <c:v>410</c:v>
                </c:pt>
              </c:numCache>
            </c:numRef>
          </c:cat>
          <c:val>
            <c:numRef>
              <c:f>Sheet1!$F$2:$F$51</c:f>
              <c:numCache>
                <c:formatCode>General</c:formatCode>
                <c:ptCount val="50"/>
                <c:pt idx="0">
                  <c:v>0.16109999999999999</c:v>
                </c:pt>
                <c:pt idx="1">
                  <c:v>0.1666</c:v>
                </c:pt>
                <c:pt idx="2">
                  <c:v>0.16159999999999999</c:v>
                </c:pt>
                <c:pt idx="3">
                  <c:v>0.17799999999999999</c:v>
                </c:pt>
                <c:pt idx="4">
                  <c:v>0.18049999999999999</c:v>
                </c:pt>
                <c:pt idx="5">
                  <c:v>0.19270000000000001</c:v>
                </c:pt>
                <c:pt idx="6">
                  <c:v>0.22359999999999999</c:v>
                </c:pt>
                <c:pt idx="7">
                  <c:v>0.27789999999999998</c:v>
                </c:pt>
                <c:pt idx="8">
                  <c:v>0.34</c:v>
                </c:pt>
                <c:pt idx="9">
                  <c:v>0.42320000000000002</c:v>
                </c:pt>
                <c:pt idx="10">
                  <c:v>0.55769999999999997</c:v>
                </c:pt>
                <c:pt idx="11">
                  <c:v>0.65180000000000005</c:v>
                </c:pt>
                <c:pt idx="12">
                  <c:v>0.8044</c:v>
                </c:pt>
                <c:pt idx="13">
                  <c:v>0.85580000000000001</c:v>
                </c:pt>
                <c:pt idx="14">
                  <c:v>0.7177</c:v>
                </c:pt>
                <c:pt idx="15">
                  <c:v>0.66790000000000005</c:v>
                </c:pt>
                <c:pt idx="16">
                  <c:v>0.5544</c:v>
                </c:pt>
                <c:pt idx="17">
                  <c:v>0.4768</c:v>
                </c:pt>
                <c:pt idx="18">
                  <c:v>0.4133</c:v>
                </c:pt>
                <c:pt idx="19">
                  <c:v>0.37830000000000003</c:v>
                </c:pt>
                <c:pt idx="20">
                  <c:v>0.28129999999999999</c:v>
                </c:pt>
                <c:pt idx="21">
                  <c:v>0.19370000000000001</c:v>
                </c:pt>
                <c:pt idx="22">
                  <c:v>0.1862</c:v>
                </c:pt>
                <c:pt idx="23">
                  <c:v>0.17230000000000001</c:v>
                </c:pt>
                <c:pt idx="24">
                  <c:v>0.1996</c:v>
                </c:pt>
                <c:pt idx="25">
                  <c:v>0.25</c:v>
                </c:pt>
                <c:pt idx="26">
                  <c:v>0.26989999999999997</c:v>
                </c:pt>
                <c:pt idx="27">
                  <c:v>0.31069999999999998</c:v>
                </c:pt>
                <c:pt idx="28">
                  <c:v>0.36399999999999999</c:v>
                </c:pt>
                <c:pt idx="29">
                  <c:v>0.4239</c:v>
                </c:pt>
                <c:pt idx="30">
                  <c:v>0.4572</c:v>
                </c:pt>
                <c:pt idx="31">
                  <c:v>0.45679999999999998</c:v>
                </c:pt>
                <c:pt idx="32">
                  <c:v>0.4788</c:v>
                </c:pt>
                <c:pt idx="33">
                  <c:v>0.52649999999999997</c:v>
                </c:pt>
                <c:pt idx="34">
                  <c:v>0.48699999999999999</c:v>
                </c:pt>
                <c:pt idx="35">
                  <c:v>0.4657</c:v>
                </c:pt>
                <c:pt idx="36">
                  <c:v>0.45579999999999998</c:v>
                </c:pt>
                <c:pt idx="37">
                  <c:v>0.41070000000000001</c:v>
                </c:pt>
                <c:pt idx="38">
                  <c:v>0.42499999999999999</c:v>
                </c:pt>
                <c:pt idx="39">
                  <c:v>0.35510000000000003</c:v>
                </c:pt>
                <c:pt idx="40">
                  <c:v>0.32900000000000001</c:v>
                </c:pt>
                <c:pt idx="41">
                  <c:v>0.24970000000000001</c:v>
                </c:pt>
                <c:pt idx="42">
                  <c:v>0.29709999999999998</c:v>
                </c:pt>
                <c:pt idx="43">
                  <c:v>0.34599999999999997</c:v>
                </c:pt>
                <c:pt idx="44">
                  <c:v>0.29020000000000001</c:v>
                </c:pt>
                <c:pt idx="45">
                  <c:v>0.20039999999999999</c:v>
                </c:pt>
                <c:pt idx="46">
                  <c:v>0.13569999999999999</c:v>
                </c:pt>
                <c:pt idx="47">
                  <c:v>0.12559999999999999</c:v>
                </c:pt>
                <c:pt idx="48">
                  <c:v>0.14000000000000001</c:v>
                </c:pt>
                <c:pt idx="49">
                  <c:v>0.13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4CD-4DBD-8DE3-DCCF9C337125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Series5</c:v>
                </c:pt>
              </c:strCache>
            </c:strRef>
          </c:tx>
          <c:spPr>
            <a:ln w="19050" cap="rnd">
              <a:solidFill>
                <a:srgbClr val="FF9933"/>
              </a:solidFill>
              <a:round/>
            </a:ln>
            <a:effectLst/>
          </c:spPr>
          <c:marker>
            <c:symbol val="none"/>
          </c:marker>
          <c:cat>
            <c:numRef>
              <c:f>Sheet1!$A$2:$A$51</c:f>
              <c:numCache>
                <c:formatCode>General</c:formatCode>
                <c:ptCount val="50"/>
                <c:pt idx="0">
                  <c:v>361</c:v>
                </c:pt>
                <c:pt idx="1">
                  <c:v>362</c:v>
                </c:pt>
                <c:pt idx="2">
                  <c:v>363</c:v>
                </c:pt>
                <c:pt idx="3">
                  <c:v>364</c:v>
                </c:pt>
                <c:pt idx="4">
                  <c:v>365</c:v>
                </c:pt>
                <c:pt idx="5">
                  <c:v>366</c:v>
                </c:pt>
                <c:pt idx="6">
                  <c:v>367</c:v>
                </c:pt>
                <c:pt idx="7">
                  <c:v>368</c:v>
                </c:pt>
                <c:pt idx="8">
                  <c:v>369</c:v>
                </c:pt>
                <c:pt idx="9">
                  <c:v>370</c:v>
                </c:pt>
                <c:pt idx="10">
                  <c:v>371</c:v>
                </c:pt>
                <c:pt idx="11">
                  <c:v>372</c:v>
                </c:pt>
                <c:pt idx="12">
                  <c:v>373</c:v>
                </c:pt>
                <c:pt idx="13">
                  <c:v>374</c:v>
                </c:pt>
                <c:pt idx="14">
                  <c:v>375</c:v>
                </c:pt>
                <c:pt idx="15">
                  <c:v>376</c:v>
                </c:pt>
                <c:pt idx="16">
                  <c:v>377</c:v>
                </c:pt>
                <c:pt idx="17">
                  <c:v>378</c:v>
                </c:pt>
                <c:pt idx="18">
                  <c:v>379</c:v>
                </c:pt>
                <c:pt idx="19">
                  <c:v>380</c:v>
                </c:pt>
                <c:pt idx="20">
                  <c:v>381</c:v>
                </c:pt>
                <c:pt idx="21">
                  <c:v>382</c:v>
                </c:pt>
                <c:pt idx="22">
                  <c:v>383</c:v>
                </c:pt>
                <c:pt idx="23">
                  <c:v>384</c:v>
                </c:pt>
                <c:pt idx="24">
                  <c:v>385</c:v>
                </c:pt>
                <c:pt idx="25">
                  <c:v>386</c:v>
                </c:pt>
                <c:pt idx="26">
                  <c:v>387</c:v>
                </c:pt>
                <c:pt idx="27">
                  <c:v>388</c:v>
                </c:pt>
                <c:pt idx="28">
                  <c:v>389</c:v>
                </c:pt>
                <c:pt idx="29">
                  <c:v>390</c:v>
                </c:pt>
                <c:pt idx="30">
                  <c:v>391</c:v>
                </c:pt>
                <c:pt idx="31">
                  <c:v>392</c:v>
                </c:pt>
                <c:pt idx="32">
                  <c:v>393</c:v>
                </c:pt>
                <c:pt idx="33">
                  <c:v>394</c:v>
                </c:pt>
                <c:pt idx="34">
                  <c:v>395</c:v>
                </c:pt>
                <c:pt idx="35">
                  <c:v>396</c:v>
                </c:pt>
                <c:pt idx="36">
                  <c:v>397</c:v>
                </c:pt>
                <c:pt idx="37">
                  <c:v>398</c:v>
                </c:pt>
                <c:pt idx="38">
                  <c:v>399</c:v>
                </c:pt>
                <c:pt idx="39">
                  <c:v>400</c:v>
                </c:pt>
                <c:pt idx="40">
                  <c:v>401</c:v>
                </c:pt>
                <c:pt idx="41">
                  <c:v>402</c:v>
                </c:pt>
                <c:pt idx="42">
                  <c:v>403</c:v>
                </c:pt>
                <c:pt idx="43">
                  <c:v>404</c:v>
                </c:pt>
                <c:pt idx="44">
                  <c:v>405</c:v>
                </c:pt>
                <c:pt idx="45">
                  <c:v>406</c:v>
                </c:pt>
                <c:pt idx="46">
                  <c:v>407</c:v>
                </c:pt>
                <c:pt idx="47">
                  <c:v>408</c:v>
                </c:pt>
                <c:pt idx="48">
                  <c:v>409</c:v>
                </c:pt>
                <c:pt idx="49">
                  <c:v>410</c:v>
                </c:pt>
              </c:numCache>
            </c:numRef>
          </c:cat>
          <c:val>
            <c:numRef>
              <c:f>Sheet1!$G$2:$G$51</c:f>
              <c:numCache>
                <c:formatCode>General</c:formatCode>
                <c:ptCount val="50"/>
                <c:pt idx="0">
                  <c:v>0.23960000000000001</c:v>
                </c:pt>
                <c:pt idx="1">
                  <c:v>0.30559999999999998</c:v>
                </c:pt>
                <c:pt idx="2">
                  <c:v>0.29459999999999997</c:v>
                </c:pt>
                <c:pt idx="3">
                  <c:v>0.26329999999999998</c:v>
                </c:pt>
                <c:pt idx="4">
                  <c:v>0.27700000000000002</c:v>
                </c:pt>
                <c:pt idx="5">
                  <c:v>0.28029999999999999</c:v>
                </c:pt>
                <c:pt idx="6">
                  <c:v>0.34739999999999999</c:v>
                </c:pt>
                <c:pt idx="7">
                  <c:v>0.39500000000000002</c:v>
                </c:pt>
                <c:pt idx="8">
                  <c:v>0.4723</c:v>
                </c:pt>
                <c:pt idx="9">
                  <c:v>0.52429999999999999</c:v>
                </c:pt>
                <c:pt idx="10">
                  <c:v>0.60529999999999995</c:v>
                </c:pt>
                <c:pt idx="11">
                  <c:v>0.69</c:v>
                </c:pt>
                <c:pt idx="12">
                  <c:v>0.71989999999999998</c:v>
                </c:pt>
                <c:pt idx="13">
                  <c:v>0.62480000000000002</c:v>
                </c:pt>
                <c:pt idx="14">
                  <c:v>0.58050000000000002</c:v>
                </c:pt>
                <c:pt idx="15">
                  <c:v>0.50790000000000002</c:v>
                </c:pt>
                <c:pt idx="16">
                  <c:v>0.42159999999999997</c:v>
                </c:pt>
                <c:pt idx="17">
                  <c:v>0.40770000000000001</c:v>
                </c:pt>
                <c:pt idx="18">
                  <c:v>0.38450000000000001</c:v>
                </c:pt>
                <c:pt idx="19">
                  <c:v>0.35449999999999998</c:v>
                </c:pt>
                <c:pt idx="20">
                  <c:v>0.31409999999999999</c:v>
                </c:pt>
                <c:pt idx="21">
                  <c:v>0.29220000000000002</c:v>
                </c:pt>
                <c:pt idx="22">
                  <c:v>0.32929999999999998</c:v>
                </c:pt>
                <c:pt idx="23">
                  <c:v>0.30509999999999998</c:v>
                </c:pt>
                <c:pt idx="24">
                  <c:v>0.30809999999999998</c:v>
                </c:pt>
                <c:pt idx="25">
                  <c:v>0.32740000000000002</c:v>
                </c:pt>
                <c:pt idx="26">
                  <c:v>0.36749999999999999</c:v>
                </c:pt>
                <c:pt idx="27">
                  <c:v>0.40660000000000002</c:v>
                </c:pt>
                <c:pt idx="28">
                  <c:v>0.44640000000000002</c:v>
                </c:pt>
                <c:pt idx="29">
                  <c:v>0.48799999999999999</c:v>
                </c:pt>
                <c:pt idx="30">
                  <c:v>0.53549999999999998</c:v>
                </c:pt>
                <c:pt idx="31">
                  <c:v>0.62060000000000004</c:v>
                </c:pt>
                <c:pt idx="32">
                  <c:v>0.73550000000000004</c:v>
                </c:pt>
                <c:pt idx="33">
                  <c:v>0.9103</c:v>
                </c:pt>
                <c:pt idx="34">
                  <c:v>1.02</c:v>
                </c:pt>
                <c:pt idx="35">
                  <c:v>0.9466</c:v>
                </c:pt>
                <c:pt idx="36">
                  <c:v>0.83679999999999999</c:v>
                </c:pt>
                <c:pt idx="37">
                  <c:v>0.75619999999999998</c:v>
                </c:pt>
                <c:pt idx="38">
                  <c:v>0.72089999999999999</c:v>
                </c:pt>
                <c:pt idx="39">
                  <c:v>0.5423</c:v>
                </c:pt>
                <c:pt idx="40">
                  <c:v>0.45569999999999999</c:v>
                </c:pt>
                <c:pt idx="41">
                  <c:v>0.3669</c:v>
                </c:pt>
                <c:pt idx="42">
                  <c:v>0.2908</c:v>
                </c:pt>
                <c:pt idx="43">
                  <c:v>0.2802</c:v>
                </c:pt>
                <c:pt idx="44">
                  <c:v>0.23499999999999999</c:v>
                </c:pt>
                <c:pt idx="45">
                  <c:v>0.23419999999999999</c:v>
                </c:pt>
                <c:pt idx="46">
                  <c:v>0.21920000000000001</c:v>
                </c:pt>
                <c:pt idx="47">
                  <c:v>0.24340000000000001</c:v>
                </c:pt>
                <c:pt idx="48">
                  <c:v>0.27060000000000001</c:v>
                </c:pt>
                <c:pt idx="49">
                  <c:v>0.2605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4CD-4DBD-8DE3-DCCF9C337125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Series6</c:v>
                </c:pt>
              </c:strCache>
            </c:strRef>
          </c:tx>
          <c:spPr>
            <a:ln w="19050" cap="rnd">
              <a:solidFill>
                <a:srgbClr val="FFCC00"/>
              </a:solidFill>
              <a:round/>
            </a:ln>
            <a:effectLst/>
          </c:spPr>
          <c:marker>
            <c:symbol val="none"/>
          </c:marker>
          <c:cat>
            <c:numRef>
              <c:f>Sheet1!$A$2:$A$51</c:f>
              <c:numCache>
                <c:formatCode>General</c:formatCode>
                <c:ptCount val="50"/>
                <c:pt idx="0">
                  <c:v>361</c:v>
                </c:pt>
                <c:pt idx="1">
                  <c:v>362</c:v>
                </c:pt>
                <c:pt idx="2">
                  <c:v>363</c:v>
                </c:pt>
                <c:pt idx="3">
                  <c:v>364</c:v>
                </c:pt>
                <c:pt idx="4">
                  <c:v>365</c:v>
                </c:pt>
                <c:pt idx="5">
                  <c:v>366</c:v>
                </c:pt>
                <c:pt idx="6">
                  <c:v>367</c:v>
                </c:pt>
                <c:pt idx="7">
                  <c:v>368</c:v>
                </c:pt>
                <c:pt idx="8">
                  <c:v>369</c:v>
                </c:pt>
                <c:pt idx="9">
                  <c:v>370</c:v>
                </c:pt>
                <c:pt idx="10">
                  <c:v>371</c:v>
                </c:pt>
                <c:pt idx="11">
                  <c:v>372</c:v>
                </c:pt>
                <c:pt idx="12">
                  <c:v>373</c:v>
                </c:pt>
                <c:pt idx="13">
                  <c:v>374</c:v>
                </c:pt>
                <c:pt idx="14">
                  <c:v>375</c:v>
                </c:pt>
                <c:pt idx="15">
                  <c:v>376</c:v>
                </c:pt>
                <c:pt idx="16">
                  <c:v>377</c:v>
                </c:pt>
                <c:pt idx="17">
                  <c:v>378</c:v>
                </c:pt>
                <c:pt idx="18">
                  <c:v>379</c:v>
                </c:pt>
                <c:pt idx="19">
                  <c:v>380</c:v>
                </c:pt>
                <c:pt idx="20">
                  <c:v>381</c:v>
                </c:pt>
                <c:pt idx="21">
                  <c:v>382</c:v>
                </c:pt>
                <c:pt idx="22">
                  <c:v>383</c:v>
                </c:pt>
                <c:pt idx="23">
                  <c:v>384</c:v>
                </c:pt>
                <c:pt idx="24">
                  <c:v>385</c:v>
                </c:pt>
                <c:pt idx="25">
                  <c:v>386</c:v>
                </c:pt>
                <c:pt idx="26">
                  <c:v>387</c:v>
                </c:pt>
                <c:pt idx="27">
                  <c:v>388</c:v>
                </c:pt>
                <c:pt idx="28">
                  <c:v>389</c:v>
                </c:pt>
                <c:pt idx="29">
                  <c:v>390</c:v>
                </c:pt>
                <c:pt idx="30">
                  <c:v>391</c:v>
                </c:pt>
                <c:pt idx="31">
                  <c:v>392</c:v>
                </c:pt>
                <c:pt idx="32">
                  <c:v>393</c:v>
                </c:pt>
                <c:pt idx="33">
                  <c:v>394</c:v>
                </c:pt>
                <c:pt idx="34">
                  <c:v>395</c:v>
                </c:pt>
                <c:pt idx="35">
                  <c:v>396</c:v>
                </c:pt>
                <c:pt idx="36">
                  <c:v>397</c:v>
                </c:pt>
                <c:pt idx="37">
                  <c:v>398</c:v>
                </c:pt>
                <c:pt idx="38">
                  <c:v>399</c:v>
                </c:pt>
                <c:pt idx="39">
                  <c:v>400</c:v>
                </c:pt>
                <c:pt idx="40">
                  <c:v>401</c:v>
                </c:pt>
                <c:pt idx="41">
                  <c:v>402</c:v>
                </c:pt>
                <c:pt idx="42">
                  <c:v>403</c:v>
                </c:pt>
                <c:pt idx="43">
                  <c:v>404</c:v>
                </c:pt>
                <c:pt idx="44">
                  <c:v>405</c:v>
                </c:pt>
                <c:pt idx="45">
                  <c:v>406</c:v>
                </c:pt>
                <c:pt idx="46">
                  <c:v>407</c:v>
                </c:pt>
                <c:pt idx="47">
                  <c:v>408</c:v>
                </c:pt>
                <c:pt idx="48">
                  <c:v>409</c:v>
                </c:pt>
                <c:pt idx="49">
                  <c:v>410</c:v>
                </c:pt>
              </c:numCache>
            </c:numRef>
          </c:cat>
          <c:val>
            <c:numRef>
              <c:f>Sheet1!$H$2:$H$51</c:f>
              <c:numCache>
                <c:formatCode>General</c:formatCode>
                <c:ptCount val="50"/>
                <c:pt idx="0">
                  <c:v>0.21179999999999999</c:v>
                </c:pt>
                <c:pt idx="1">
                  <c:v>0.30509999999999998</c:v>
                </c:pt>
                <c:pt idx="2">
                  <c:v>0.31430000000000002</c:v>
                </c:pt>
                <c:pt idx="3">
                  <c:v>0.37669999999999998</c:v>
                </c:pt>
                <c:pt idx="4">
                  <c:v>0.4345</c:v>
                </c:pt>
                <c:pt idx="5">
                  <c:v>0.50680000000000003</c:v>
                </c:pt>
                <c:pt idx="6">
                  <c:v>0.53800000000000003</c:v>
                </c:pt>
                <c:pt idx="7">
                  <c:v>0.64749999999999996</c:v>
                </c:pt>
                <c:pt idx="8">
                  <c:v>0.71689999999999998</c:v>
                </c:pt>
                <c:pt idx="9">
                  <c:v>0.7752</c:v>
                </c:pt>
                <c:pt idx="10">
                  <c:v>0.93220000000000003</c:v>
                </c:pt>
                <c:pt idx="11">
                  <c:v>0.96289999999999998</c:v>
                </c:pt>
                <c:pt idx="12">
                  <c:v>1.0108999999999999</c:v>
                </c:pt>
                <c:pt idx="13">
                  <c:v>0.94530000000000003</c:v>
                </c:pt>
                <c:pt idx="14">
                  <c:v>0.87949999999999995</c:v>
                </c:pt>
                <c:pt idx="15">
                  <c:v>0.84099999999999997</c:v>
                </c:pt>
                <c:pt idx="16">
                  <c:v>0.90720000000000001</c:v>
                </c:pt>
                <c:pt idx="17">
                  <c:v>0.92559999999999998</c:v>
                </c:pt>
                <c:pt idx="18">
                  <c:v>1.0067999999999999</c:v>
                </c:pt>
                <c:pt idx="19">
                  <c:v>1.1462000000000001</c:v>
                </c:pt>
                <c:pt idx="20">
                  <c:v>1.252</c:v>
                </c:pt>
                <c:pt idx="21">
                  <c:v>1.4043000000000001</c:v>
                </c:pt>
                <c:pt idx="22">
                  <c:v>1.5878000000000001</c:v>
                </c:pt>
                <c:pt idx="23">
                  <c:v>1.6674</c:v>
                </c:pt>
                <c:pt idx="24">
                  <c:v>1.5865</c:v>
                </c:pt>
                <c:pt idx="25">
                  <c:v>1.6062000000000001</c:v>
                </c:pt>
                <c:pt idx="26">
                  <c:v>1.5953999999999999</c:v>
                </c:pt>
                <c:pt idx="27">
                  <c:v>1.522</c:v>
                </c:pt>
                <c:pt idx="28">
                  <c:v>1.5539000000000001</c:v>
                </c:pt>
                <c:pt idx="29">
                  <c:v>1.4675</c:v>
                </c:pt>
                <c:pt idx="30">
                  <c:v>1.4954000000000001</c:v>
                </c:pt>
                <c:pt idx="31">
                  <c:v>1.5424</c:v>
                </c:pt>
                <c:pt idx="32">
                  <c:v>1.5064</c:v>
                </c:pt>
                <c:pt idx="33">
                  <c:v>1.3453999999999999</c:v>
                </c:pt>
                <c:pt idx="34">
                  <c:v>1.3117000000000001</c:v>
                </c:pt>
                <c:pt idx="35">
                  <c:v>1.1431</c:v>
                </c:pt>
                <c:pt idx="36">
                  <c:v>0.91859999999999997</c:v>
                </c:pt>
                <c:pt idx="37">
                  <c:v>0.78080000000000005</c:v>
                </c:pt>
                <c:pt idx="38">
                  <c:v>0.68520000000000003</c:v>
                </c:pt>
                <c:pt idx="39">
                  <c:v>0.62770000000000004</c:v>
                </c:pt>
                <c:pt idx="40">
                  <c:v>0.49049999999999999</c:v>
                </c:pt>
                <c:pt idx="41">
                  <c:v>0.36659999999999998</c:v>
                </c:pt>
                <c:pt idx="42">
                  <c:v>0.31969999999999998</c:v>
                </c:pt>
                <c:pt idx="43">
                  <c:v>0.31309999999999999</c:v>
                </c:pt>
                <c:pt idx="44">
                  <c:v>0.27289999999999998</c:v>
                </c:pt>
                <c:pt idx="45">
                  <c:v>0.23269999999999999</c:v>
                </c:pt>
                <c:pt idx="46">
                  <c:v>0.21609999999999999</c:v>
                </c:pt>
                <c:pt idx="47">
                  <c:v>0.1915</c:v>
                </c:pt>
                <c:pt idx="48">
                  <c:v>0.2175</c:v>
                </c:pt>
                <c:pt idx="49">
                  <c:v>0.23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A4CD-4DBD-8DE3-DCCF9C3371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8881312"/>
        <c:axId val="-8879680"/>
      </c:lineChart>
      <c:catAx>
        <c:axId val="-8881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79680"/>
        <c:crosses val="autoZero"/>
        <c:auto val="1"/>
        <c:lblAlgn val="ctr"/>
        <c:lblOffset val="100"/>
        <c:tickLblSkip val="5"/>
        <c:noMultiLvlLbl val="0"/>
      </c:catAx>
      <c:valAx>
        <c:axId val="-8879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81312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K$1</c:f>
              <c:strCache>
                <c:ptCount val="1"/>
                <c:pt idx="0">
                  <c:v>Series1</c:v>
                </c:pt>
              </c:strCache>
            </c:strRef>
          </c:tx>
          <c:spPr>
            <a:ln w="19050" cap="rnd">
              <a:solidFill>
                <a:srgbClr val="0000FF"/>
              </a:solidFill>
              <a:round/>
            </a:ln>
            <a:effectLst/>
          </c:spPr>
          <c:marker>
            <c:symbol val="none"/>
          </c:marker>
          <c:cat>
            <c:numRef>
              <c:f>Sheet1!$J$2:$J$164</c:f>
              <c:numCache>
                <c:formatCode>General</c:formatCode>
                <c:ptCount val="163"/>
                <c:pt idx="0">
                  <c:v>851</c:v>
                </c:pt>
                <c:pt idx="1">
                  <c:v>852</c:v>
                </c:pt>
                <c:pt idx="2">
                  <c:v>853</c:v>
                </c:pt>
                <c:pt idx="3">
                  <c:v>854</c:v>
                </c:pt>
                <c:pt idx="4">
                  <c:v>855</c:v>
                </c:pt>
                <c:pt idx="5">
                  <c:v>856</c:v>
                </c:pt>
                <c:pt idx="6">
                  <c:v>857</c:v>
                </c:pt>
                <c:pt idx="7">
                  <c:v>858</c:v>
                </c:pt>
                <c:pt idx="8">
                  <c:v>859</c:v>
                </c:pt>
                <c:pt idx="9">
                  <c:v>860</c:v>
                </c:pt>
                <c:pt idx="10">
                  <c:v>861</c:v>
                </c:pt>
                <c:pt idx="11">
                  <c:v>862</c:v>
                </c:pt>
                <c:pt idx="12">
                  <c:v>863</c:v>
                </c:pt>
                <c:pt idx="13">
                  <c:v>864</c:v>
                </c:pt>
                <c:pt idx="14">
                  <c:v>865</c:v>
                </c:pt>
                <c:pt idx="15">
                  <c:v>866</c:v>
                </c:pt>
                <c:pt idx="16">
                  <c:v>867</c:v>
                </c:pt>
                <c:pt idx="17">
                  <c:v>868</c:v>
                </c:pt>
                <c:pt idx="18">
                  <c:v>869</c:v>
                </c:pt>
                <c:pt idx="19">
                  <c:v>870</c:v>
                </c:pt>
                <c:pt idx="20">
                  <c:v>871</c:v>
                </c:pt>
                <c:pt idx="21">
                  <c:v>872</c:v>
                </c:pt>
                <c:pt idx="22">
                  <c:v>873</c:v>
                </c:pt>
                <c:pt idx="23">
                  <c:v>874</c:v>
                </c:pt>
                <c:pt idx="24">
                  <c:v>875</c:v>
                </c:pt>
                <c:pt idx="25">
                  <c:v>876</c:v>
                </c:pt>
                <c:pt idx="26">
                  <c:v>877</c:v>
                </c:pt>
                <c:pt idx="27">
                  <c:v>878</c:v>
                </c:pt>
                <c:pt idx="28">
                  <c:v>879</c:v>
                </c:pt>
                <c:pt idx="29">
                  <c:v>880</c:v>
                </c:pt>
                <c:pt idx="30">
                  <c:v>881</c:v>
                </c:pt>
                <c:pt idx="31">
                  <c:v>882</c:v>
                </c:pt>
                <c:pt idx="32">
                  <c:v>883</c:v>
                </c:pt>
                <c:pt idx="33">
                  <c:v>884</c:v>
                </c:pt>
                <c:pt idx="34">
                  <c:v>885</c:v>
                </c:pt>
                <c:pt idx="35">
                  <c:v>886</c:v>
                </c:pt>
                <c:pt idx="36">
                  <c:v>887</c:v>
                </c:pt>
                <c:pt idx="37">
                  <c:v>888</c:v>
                </c:pt>
                <c:pt idx="38">
                  <c:v>889</c:v>
                </c:pt>
                <c:pt idx="39">
                  <c:v>890</c:v>
                </c:pt>
                <c:pt idx="40">
                  <c:v>891</c:v>
                </c:pt>
                <c:pt idx="41">
                  <c:v>892</c:v>
                </c:pt>
                <c:pt idx="42">
                  <c:v>893</c:v>
                </c:pt>
                <c:pt idx="43">
                  <c:v>894</c:v>
                </c:pt>
                <c:pt idx="44">
                  <c:v>895</c:v>
                </c:pt>
                <c:pt idx="45">
                  <c:v>896</c:v>
                </c:pt>
                <c:pt idx="46">
                  <c:v>897</c:v>
                </c:pt>
                <c:pt idx="47">
                  <c:v>898</c:v>
                </c:pt>
                <c:pt idx="48">
                  <c:v>899</c:v>
                </c:pt>
                <c:pt idx="49">
                  <c:v>900</c:v>
                </c:pt>
                <c:pt idx="50">
                  <c:v>901</c:v>
                </c:pt>
                <c:pt idx="51">
                  <c:v>902</c:v>
                </c:pt>
                <c:pt idx="52">
                  <c:v>903</c:v>
                </c:pt>
                <c:pt idx="53">
                  <c:v>904</c:v>
                </c:pt>
                <c:pt idx="54">
                  <c:v>905</c:v>
                </c:pt>
                <c:pt idx="55">
                  <c:v>906</c:v>
                </c:pt>
                <c:pt idx="56">
                  <c:v>907</c:v>
                </c:pt>
                <c:pt idx="57">
                  <c:v>908</c:v>
                </c:pt>
                <c:pt idx="58">
                  <c:v>909</c:v>
                </c:pt>
                <c:pt idx="59">
                  <c:v>910</c:v>
                </c:pt>
                <c:pt idx="60">
                  <c:v>911</c:v>
                </c:pt>
                <c:pt idx="61">
                  <c:v>912</c:v>
                </c:pt>
                <c:pt idx="62">
                  <c:v>913</c:v>
                </c:pt>
                <c:pt idx="63">
                  <c:v>914</c:v>
                </c:pt>
                <c:pt idx="64">
                  <c:v>915</c:v>
                </c:pt>
                <c:pt idx="65">
                  <c:v>916</c:v>
                </c:pt>
                <c:pt idx="66">
                  <c:v>917</c:v>
                </c:pt>
                <c:pt idx="67">
                  <c:v>918</c:v>
                </c:pt>
                <c:pt idx="68">
                  <c:v>919</c:v>
                </c:pt>
                <c:pt idx="69">
                  <c:v>920</c:v>
                </c:pt>
                <c:pt idx="70">
                  <c:v>921</c:v>
                </c:pt>
                <c:pt idx="71">
                  <c:v>922</c:v>
                </c:pt>
                <c:pt idx="72">
                  <c:v>923</c:v>
                </c:pt>
                <c:pt idx="73">
                  <c:v>924</c:v>
                </c:pt>
                <c:pt idx="74">
                  <c:v>925</c:v>
                </c:pt>
                <c:pt idx="75">
                  <c:v>926</c:v>
                </c:pt>
                <c:pt idx="76">
                  <c:v>927</c:v>
                </c:pt>
                <c:pt idx="77">
                  <c:v>928</c:v>
                </c:pt>
                <c:pt idx="78">
                  <c:v>929</c:v>
                </c:pt>
                <c:pt idx="79">
                  <c:v>930</c:v>
                </c:pt>
                <c:pt idx="80">
                  <c:v>931</c:v>
                </c:pt>
                <c:pt idx="81">
                  <c:v>932</c:v>
                </c:pt>
                <c:pt idx="82">
                  <c:v>933</c:v>
                </c:pt>
                <c:pt idx="83">
                  <c:v>934</c:v>
                </c:pt>
                <c:pt idx="84">
                  <c:v>935</c:v>
                </c:pt>
                <c:pt idx="85">
                  <c:v>936</c:v>
                </c:pt>
                <c:pt idx="86">
                  <c:v>937</c:v>
                </c:pt>
                <c:pt idx="87">
                  <c:v>938</c:v>
                </c:pt>
                <c:pt idx="88">
                  <c:v>939</c:v>
                </c:pt>
                <c:pt idx="89">
                  <c:v>940</c:v>
                </c:pt>
                <c:pt idx="90">
                  <c:v>941</c:v>
                </c:pt>
                <c:pt idx="91">
                  <c:v>942</c:v>
                </c:pt>
                <c:pt idx="92">
                  <c:v>943</c:v>
                </c:pt>
                <c:pt idx="93">
                  <c:v>944</c:v>
                </c:pt>
                <c:pt idx="94">
                  <c:v>945</c:v>
                </c:pt>
                <c:pt idx="95">
                  <c:v>946</c:v>
                </c:pt>
                <c:pt idx="96">
                  <c:v>947</c:v>
                </c:pt>
                <c:pt idx="97">
                  <c:v>948</c:v>
                </c:pt>
                <c:pt idx="98">
                  <c:v>949</c:v>
                </c:pt>
                <c:pt idx="99">
                  <c:v>950</c:v>
                </c:pt>
                <c:pt idx="100">
                  <c:v>951</c:v>
                </c:pt>
                <c:pt idx="101">
                  <c:v>952</c:v>
                </c:pt>
                <c:pt idx="102">
                  <c:v>953</c:v>
                </c:pt>
                <c:pt idx="103">
                  <c:v>954</c:v>
                </c:pt>
                <c:pt idx="104">
                  <c:v>955</c:v>
                </c:pt>
                <c:pt idx="105">
                  <c:v>956</c:v>
                </c:pt>
                <c:pt idx="106">
                  <c:v>957</c:v>
                </c:pt>
                <c:pt idx="107">
                  <c:v>958</c:v>
                </c:pt>
                <c:pt idx="108">
                  <c:v>959</c:v>
                </c:pt>
                <c:pt idx="109">
                  <c:v>960</c:v>
                </c:pt>
                <c:pt idx="110">
                  <c:v>961</c:v>
                </c:pt>
                <c:pt idx="111">
                  <c:v>962</c:v>
                </c:pt>
                <c:pt idx="112">
                  <c:v>963</c:v>
                </c:pt>
                <c:pt idx="113">
                  <c:v>964</c:v>
                </c:pt>
                <c:pt idx="114">
                  <c:v>965</c:v>
                </c:pt>
                <c:pt idx="115">
                  <c:v>966</c:v>
                </c:pt>
                <c:pt idx="116">
                  <c:v>967</c:v>
                </c:pt>
                <c:pt idx="117">
                  <c:v>968</c:v>
                </c:pt>
                <c:pt idx="118">
                  <c:v>969</c:v>
                </c:pt>
                <c:pt idx="119">
                  <c:v>970</c:v>
                </c:pt>
                <c:pt idx="120">
                  <c:v>971</c:v>
                </c:pt>
                <c:pt idx="121">
                  <c:v>972</c:v>
                </c:pt>
                <c:pt idx="122">
                  <c:v>973</c:v>
                </c:pt>
                <c:pt idx="123">
                  <c:v>974</c:v>
                </c:pt>
                <c:pt idx="124">
                  <c:v>975</c:v>
                </c:pt>
                <c:pt idx="125">
                  <c:v>976</c:v>
                </c:pt>
                <c:pt idx="126">
                  <c:v>977</c:v>
                </c:pt>
                <c:pt idx="127">
                  <c:v>978</c:v>
                </c:pt>
                <c:pt idx="128">
                  <c:v>979</c:v>
                </c:pt>
                <c:pt idx="129">
                  <c:v>980</c:v>
                </c:pt>
                <c:pt idx="130">
                  <c:v>981</c:v>
                </c:pt>
                <c:pt idx="131">
                  <c:v>982</c:v>
                </c:pt>
                <c:pt idx="132">
                  <c:v>983</c:v>
                </c:pt>
                <c:pt idx="133">
                  <c:v>984</c:v>
                </c:pt>
                <c:pt idx="134">
                  <c:v>985</c:v>
                </c:pt>
                <c:pt idx="135">
                  <c:v>986</c:v>
                </c:pt>
                <c:pt idx="136">
                  <c:v>987</c:v>
                </c:pt>
                <c:pt idx="137">
                  <c:v>988</c:v>
                </c:pt>
                <c:pt idx="138">
                  <c:v>989</c:v>
                </c:pt>
                <c:pt idx="139">
                  <c:v>990</c:v>
                </c:pt>
                <c:pt idx="140">
                  <c:v>991</c:v>
                </c:pt>
                <c:pt idx="141">
                  <c:v>992</c:v>
                </c:pt>
                <c:pt idx="142">
                  <c:v>993</c:v>
                </c:pt>
                <c:pt idx="143">
                  <c:v>994</c:v>
                </c:pt>
                <c:pt idx="144">
                  <c:v>995</c:v>
                </c:pt>
                <c:pt idx="145">
                  <c:v>996</c:v>
                </c:pt>
                <c:pt idx="146">
                  <c:v>997</c:v>
                </c:pt>
                <c:pt idx="147">
                  <c:v>998</c:v>
                </c:pt>
                <c:pt idx="148">
                  <c:v>999</c:v>
                </c:pt>
                <c:pt idx="149">
                  <c:v>1000</c:v>
                </c:pt>
                <c:pt idx="150">
                  <c:v>1001</c:v>
                </c:pt>
                <c:pt idx="151">
                  <c:v>1002</c:v>
                </c:pt>
                <c:pt idx="152">
                  <c:v>1003</c:v>
                </c:pt>
                <c:pt idx="153">
                  <c:v>1004</c:v>
                </c:pt>
                <c:pt idx="154">
                  <c:v>1005</c:v>
                </c:pt>
                <c:pt idx="155">
                  <c:v>1006</c:v>
                </c:pt>
                <c:pt idx="156">
                  <c:v>1007</c:v>
                </c:pt>
                <c:pt idx="157">
                  <c:v>1008</c:v>
                </c:pt>
                <c:pt idx="158">
                  <c:v>1009</c:v>
                </c:pt>
                <c:pt idx="159">
                  <c:v>1010</c:v>
                </c:pt>
                <c:pt idx="160">
                  <c:v>1011</c:v>
                </c:pt>
                <c:pt idx="161">
                  <c:v>1012</c:v>
                </c:pt>
                <c:pt idx="162">
                  <c:v>1013</c:v>
                </c:pt>
              </c:numCache>
            </c:numRef>
          </c:cat>
          <c:val>
            <c:numRef>
              <c:f>Sheet1!$K$2:$K$164</c:f>
              <c:numCache>
                <c:formatCode>General</c:formatCode>
                <c:ptCount val="163"/>
                <c:pt idx="0">
                  <c:v>0.21659999999999999</c:v>
                </c:pt>
                <c:pt idx="1">
                  <c:v>0.20569999999999999</c:v>
                </c:pt>
                <c:pt idx="2">
                  <c:v>0.21609999999999999</c:v>
                </c:pt>
                <c:pt idx="3">
                  <c:v>0.22939999999999999</c:v>
                </c:pt>
                <c:pt idx="4">
                  <c:v>0.2177</c:v>
                </c:pt>
                <c:pt idx="5">
                  <c:v>0.21129999999999999</c:v>
                </c:pt>
                <c:pt idx="6">
                  <c:v>0.23089999999999999</c:v>
                </c:pt>
                <c:pt idx="7">
                  <c:v>0.2336</c:v>
                </c:pt>
                <c:pt idx="8">
                  <c:v>0.21329999999999999</c:v>
                </c:pt>
                <c:pt idx="9">
                  <c:v>0.21010000000000001</c:v>
                </c:pt>
                <c:pt idx="10">
                  <c:v>0.2271</c:v>
                </c:pt>
                <c:pt idx="11">
                  <c:v>0.22420000000000001</c:v>
                </c:pt>
                <c:pt idx="12">
                  <c:v>0.21029999999999999</c:v>
                </c:pt>
                <c:pt idx="13">
                  <c:v>0.2205</c:v>
                </c:pt>
                <c:pt idx="14">
                  <c:v>0.2213</c:v>
                </c:pt>
                <c:pt idx="15">
                  <c:v>0.216</c:v>
                </c:pt>
                <c:pt idx="16">
                  <c:v>0.3095</c:v>
                </c:pt>
                <c:pt idx="17">
                  <c:v>0.32879999999999998</c:v>
                </c:pt>
                <c:pt idx="18">
                  <c:v>0.40260000000000001</c:v>
                </c:pt>
                <c:pt idx="19">
                  <c:v>0.52159999999999995</c:v>
                </c:pt>
                <c:pt idx="20">
                  <c:v>0.67510000000000003</c:v>
                </c:pt>
                <c:pt idx="21">
                  <c:v>0.85829999999999995</c:v>
                </c:pt>
                <c:pt idx="22">
                  <c:v>1.0116000000000001</c:v>
                </c:pt>
                <c:pt idx="23">
                  <c:v>1.1713</c:v>
                </c:pt>
                <c:pt idx="24">
                  <c:v>1.2957000000000001</c:v>
                </c:pt>
                <c:pt idx="25">
                  <c:v>1.3903000000000001</c:v>
                </c:pt>
                <c:pt idx="26">
                  <c:v>1.3682000000000001</c:v>
                </c:pt>
                <c:pt idx="27">
                  <c:v>1.4141999999999999</c:v>
                </c:pt>
                <c:pt idx="28">
                  <c:v>1.3564000000000001</c:v>
                </c:pt>
                <c:pt idx="29">
                  <c:v>1.3245</c:v>
                </c:pt>
                <c:pt idx="30">
                  <c:v>1.1666000000000001</c:v>
                </c:pt>
                <c:pt idx="31">
                  <c:v>1.0537000000000001</c:v>
                </c:pt>
                <c:pt idx="32">
                  <c:v>0.92900000000000005</c:v>
                </c:pt>
                <c:pt idx="33">
                  <c:v>0.81559999999999999</c:v>
                </c:pt>
                <c:pt idx="34">
                  <c:v>0.7399</c:v>
                </c:pt>
                <c:pt idx="35">
                  <c:v>0.60040000000000004</c:v>
                </c:pt>
                <c:pt idx="36">
                  <c:v>0.43919999999999998</c:v>
                </c:pt>
                <c:pt idx="37">
                  <c:v>0.37609999999999999</c:v>
                </c:pt>
                <c:pt idx="38">
                  <c:v>0.28849999999999998</c:v>
                </c:pt>
                <c:pt idx="39">
                  <c:v>0.2492</c:v>
                </c:pt>
                <c:pt idx="40">
                  <c:v>0.1948</c:v>
                </c:pt>
                <c:pt idx="41">
                  <c:v>0.1812</c:v>
                </c:pt>
                <c:pt idx="42">
                  <c:v>0.21840000000000001</c:v>
                </c:pt>
                <c:pt idx="43">
                  <c:v>0.17069999999999999</c:v>
                </c:pt>
                <c:pt idx="44">
                  <c:v>0.2137</c:v>
                </c:pt>
                <c:pt idx="45">
                  <c:v>0.16769999999999999</c:v>
                </c:pt>
                <c:pt idx="46">
                  <c:v>0.17319999999999999</c:v>
                </c:pt>
                <c:pt idx="47">
                  <c:v>0.1709</c:v>
                </c:pt>
                <c:pt idx="48">
                  <c:v>0.16009999999999999</c:v>
                </c:pt>
                <c:pt idx="49">
                  <c:v>0.14219999999999999</c:v>
                </c:pt>
                <c:pt idx="50">
                  <c:v>0.1636</c:v>
                </c:pt>
                <c:pt idx="51">
                  <c:v>0.17169999999999999</c:v>
                </c:pt>
                <c:pt idx="52">
                  <c:v>0.18049999999999999</c:v>
                </c:pt>
                <c:pt idx="53">
                  <c:v>0.18940000000000001</c:v>
                </c:pt>
                <c:pt idx="54">
                  <c:v>0.22520000000000001</c:v>
                </c:pt>
                <c:pt idx="55">
                  <c:v>0.19209999999999999</c:v>
                </c:pt>
                <c:pt idx="56">
                  <c:v>0.1719</c:v>
                </c:pt>
                <c:pt idx="57">
                  <c:v>0.1593</c:v>
                </c:pt>
                <c:pt idx="58">
                  <c:v>0.15049999999999999</c:v>
                </c:pt>
                <c:pt idx="59">
                  <c:v>0.14860000000000001</c:v>
                </c:pt>
                <c:pt idx="60">
                  <c:v>0.15640000000000001</c:v>
                </c:pt>
                <c:pt idx="61">
                  <c:v>0.16339999999999999</c:v>
                </c:pt>
                <c:pt idx="62">
                  <c:v>0.1739</c:v>
                </c:pt>
                <c:pt idx="63">
                  <c:v>0.2122</c:v>
                </c:pt>
                <c:pt idx="64">
                  <c:v>0.17710000000000001</c:v>
                </c:pt>
                <c:pt idx="65">
                  <c:v>0.18970000000000001</c:v>
                </c:pt>
                <c:pt idx="66">
                  <c:v>0.17899999999999999</c:v>
                </c:pt>
                <c:pt idx="67">
                  <c:v>0.17829999999999999</c:v>
                </c:pt>
                <c:pt idx="68">
                  <c:v>0.19939999999999999</c:v>
                </c:pt>
                <c:pt idx="69">
                  <c:v>0.2051</c:v>
                </c:pt>
                <c:pt idx="70">
                  <c:v>0.1956</c:v>
                </c:pt>
                <c:pt idx="71">
                  <c:v>0.20630000000000001</c:v>
                </c:pt>
                <c:pt idx="72">
                  <c:v>0.193</c:v>
                </c:pt>
                <c:pt idx="73">
                  <c:v>0.189</c:v>
                </c:pt>
                <c:pt idx="74">
                  <c:v>0.1812</c:v>
                </c:pt>
                <c:pt idx="75">
                  <c:v>0.19950000000000001</c:v>
                </c:pt>
                <c:pt idx="76">
                  <c:v>0.19059999999999999</c:v>
                </c:pt>
                <c:pt idx="77">
                  <c:v>0.15659999999999999</c:v>
                </c:pt>
                <c:pt idx="78">
                  <c:v>0.1673</c:v>
                </c:pt>
                <c:pt idx="79">
                  <c:v>0.16039999999999999</c:v>
                </c:pt>
                <c:pt idx="80">
                  <c:v>0.1719</c:v>
                </c:pt>
                <c:pt idx="81">
                  <c:v>0.1769</c:v>
                </c:pt>
                <c:pt idx="82">
                  <c:v>0.18010000000000001</c:v>
                </c:pt>
                <c:pt idx="83">
                  <c:v>0.19650000000000001</c:v>
                </c:pt>
                <c:pt idx="84">
                  <c:v>0.19470000000000001</c:v>
                </c:pt>
                <c:pt idx="85">
                  <c:v>0.20649999999999999</c:v>
                </c:pt>
                <c:pt idx="86">
                  <c:v>0.20100000000000001</c:v>
                </c:pt>
                <c:pt idx="87">
                  <c:v>0.21129999999999999</c:v>
                </c:pt>
                <c:pt idx="88">
                  <c:v>0.22359999999999999</c:v>
                </c:pt>
                <c:pt idx="89">
                  <c:v>0.21929999999999999</c:v>
                </c:pt>
                <c:pt idx="90">
                  <c:v>0.2026</c:v>
                </c:pt>
                <c:pt idx="91">
                  <c:v>0.20019999999999999</c:v>
                </c:pt>
                <c:pt idx="92">
                  <c:v>0.19020000000000001</c:v>
                </c:pt>
                <c:pt idx="93">
                  <c:v>0.18759999999999999</c:v>
                </c:pt>
                <c:pt idx="94">
                  <c:v>0.19439999999999999</c:v>
                </c:pt>
                <c:pt idx="95">
                  <c:v>0.1913</c:v>
                </c:pt>
                <c:pt idx="96">
                  <c:v>0.18770000000000001</c:v>
                </c:pt>
                <c:pt idx="97">
                  <c:v>0.1895</c:v>
                </c:pt>
                <c:pt idx="98">
                  <c:v>0.19409999999999999</c:v>
                </c:pt>
                <c:pt idx="99">
                  <c:v>0.19159999999999999</c:v>
                </c:pt>
                <c:pt idx="100">
                  <c:v>0.19139999999999999</c:v>
                </c:pt>
                <c:pt idx="101">
                  <c:v>0.2001</c:v>
                </c:pt>
                <c:pt idx="102">
                  <c:v>0.20710000000000001</c:v>
                </c:pt>
                <c:pt idx="103">
                  <c:v>0.20280000000000001</c:v>
                </c:pt>
                <c:pt idx="104">
                  <c:v>0.2215</c:v>
                </c:pt>
                <c:pt idx="105">
                  <c:v>0.24379999999999999</c:v>
                </c:pt>
                <c:pt idx="106">
                  <c:v>0.25990000000000002</c:v>
                </c:pt>
                <c:pt idx="107">
                  <c:v>0.29930000000000001</c:v>
                </c:pt>
                <c:pt idx="108">
                  <c:v>0.32129999999999997</c:v>
                </c:pt>
                <c:pt idx="109">
                  <c:v>0.3266</c:v>
                </c:pt>
                <c:pt idx="110">
                  <c:v>0.2893</c:v>
                </c:pt>
                <c:pt idx="111">
                  <c:v>0.24479999999999999</c:v>
                </c:pt>
                <c:pt idx="112">
                  <c:v>0.21609999999999999</c:v>
                </c:pt>
                <c:pt idx="113">
                  <c:v>0.25929999999999997</c:v>
                </c:pt>
                <c:pt idx="114">
                  <c:v>0.2702</c:v>
                </c:pt>
                <c:pt idx="115">
                  <c:v>0.38450000000000001</c:v>
                </c:pt>
                <c:pt idx="116">
                  <c:v>0.33460000000000001</c:v>
                </c:pt>
                <c:pt idx="117">
                  <c:v>0.37530000000000002</c:v>
                </c:pt>
                <c:pt idx="118">
                  <c:v>0.38829999999999998</c:v>
                </c:pt>
                <c:pt idx="119">
                  <c:v>0.45989999999999998</c:v>
                </c:pt>
                <c:pt idx="120">
                  <c:v>0.31719999999999998</c:v>
                </c:pt>
                <c:pt idx="121">
                  <c:v>0.28999999999999998</c:v>
                </c:pt>
                <c:pt idx="122">
                  <c:v>0.28520000000000001</c:v>
                </c:pt>
                <c:pt idx="123">
                  <c:v>0.31569999999999998</c:v>
                </c:pt>
                <c:pt idx="124">
                  <c:v>0.32579999999999998</c:v>
                </c:pt>
                <c:pt idx="125">
                  <c:v>0.34339999999999998</c:v>
                </c:pt>
                <c:pt idx="126">
                  <c:v>0.39729999999999999</c:v>
                </c:pt>
                <c:pt idx="127">
                  <c:v>0.4052</c:v>
                </c:pt>
                <c:pt idx="128">
                  <c:v>0.34449999999999997</c:v>
                </c:pt>
                <c:pt idx="129">
                  <c:v>0.32929999999999998</c:v>
                </c:pt>
                <c:pt idx="130">
                  <c:v>0.36870000000000003</c:v>
                </c:pt>
                <c:pt idx="131">
                  <c:v>0.376</c:v>
                </c:pt>
                <c:pt idx="132">
                  <c:v>0.33560000000000001</c:v>
                </c:pt>
                <c:pt idx="133">
                  <c:v>0.34300000000000003</c:v>
                </c:pt>
                <c:pt idx="134">
                  <c:v>0.38140000000000002</c:v>
                </c:pt>
                <c:pt idx="135">
                  <c:v>0.38979999999999998</c:v>
                </c:pt>
                <c:pt idx="136">
                  <c:v>0.37080000000000002</c:v>
                </c:pt>
                <c:pt idx="137">
                  <c:v>0.3901</c:v>
                </c:pt>
                <c:pt idx="138">
                  <c:v>0.43580000000000002</c:v>
                </c:pt>
                <c:pt idx="139">
                  <c:v>0.44719999999999999</c:v>
                </c:pt>
                <c:pt idx="140">
                  <c:v>0.44490000000000002</c:v>
                </c:pt>
                <c:pt idx="141">
                  <c:v>0.4778</c:v>
                </c:pt>
                <c:pt idx="142">
                  <c:v>0.53439999999999999</c:v>
                </c:pt>
                <c:pt idx="143">
                  <c:v>0.55779999999999996</c:v>
                </c:pt>
                <c:pt idx="144">
                  <c:v>0.57089999999999996</c:v>
                </c:pt>
                <c:pt idx="145">
                  <c:v>0.624</c:v>
                </c:pt>
                <c:pt idx="146">
                  <c:v>0.751</c:v>
                </c:pt>
                <c:pt idx="147">
                  <c:v>0.91100000000000003</c:v>
                </c:pt>
                <c:pt idx="148">
                  <c:v>1.1065</c:v>
                </c:pt>
                <c:pt idx="149">
                  <c:v>1.2457</c:v>
                </c:pt>
                <c:pt idx="150">
                  <c:v>1.3647</c:v>
                </c:pt>
                <c:pt idx="151">
                  <c:v>1.4545999999999999</c:v>
                </c:pt>
                <c:pt idx="152">
                  <c:v>1.522</c:v>
                </c:pt>
                <c:pt idx="153">
                  <c:v>1.6364000000000001</c:v>
                </c:pt>
                <c:pt idx="154">
                  <c:v>1.8174999999999999</c:v>
                </c:pt>
                <c:pt idx="155">
                  <c:v>1.9188000000000001</c:v>
                </c:pt>
                <c:pt idx="156">
                  <c:v>2.0727000000000002</c:v>
                </c:pt>
                <c:pt idx="157">
                  <c:v>2.1686000000000001</c:v>
                </c:pt>
                <c:pt idx="158">
                  <c:v>2.2553000000000001</c:v>
                </c:pt>
                <c:pt idx="159">
                  <c:v>2.3205</c:v>
                </c:pt>
                <c:pt idx="160">
                  <c:v>2.4443000000000001</c:v>
                </c:pt>
                <c:pt idx="161">
                  <c:v>2.4977</c:v>
                </c:pt>
                <c:pt idx="162">
                  <c:v>2.6025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45F-4DAF-9000-A4DD7D002A4E}"/>
            </c:ext>
          </c:extLst>
        </c:ser>
        <c:ser>
          <c:idx val="1"/>
          <c:order val="1"/>
          <c:tx>
            <c:strRef>
              <c:f>Sheet1!$L$1</c:f>
              <c:strCache>
                <c:ptCount val="1"/>
                <c:pt idx="0">
                  <c:v>Series2</c:v>
                </c:pt>
              </c:strCache>
            </c:strRef>
          </c:tx>
          <c:spPr>
            <a:ln w="19050" cap="rnd">
              <a:solidFill>
                <a:srgbClr val="0099CC"/>
              </a:solidFill>
              <a:round/>
            </a:ln>
            <a:effectLst/>
          </c:spPr>
          <c:marker>
            <c:symbol val="none"/>
          </c:marker>
          <c:cat>
            <c:numRef>
              <c:f>Sheet1!$J$2:$J$164</c:f>
              <c:numCache>
                <c:formatCode>General</c:formatCode>
                <c:ptCount val="163"/>
                <c:pt idx="0">
                  <c:v>851</c:v>
                </c:pt>
                <c:pt idx="1">
                  <c:v>852</c:v>
                </c:pt>
                <c:pt idx="2">
                  <c:v>853</c:v>
                </c:pt>
                <c:pt idx="3">
                  <c:v>854</c:v>
                </c:pt>
                <c:pt idx="4">
                  <c:v>855</c:v>
                </c:pt>
                <c:pt idx="5">
                  <c:v>856</c:v>
                </c:pt>
                <c:pt idx="6">
                  <c:v>857</c:v>
                </c:pt>
                <c:pt idx="7">
                  <c:v>858</c:v>
                </c:pt>
                <c:pt idx="8">
                  <c:v>859</c:v>
                </c:pt>
                <c:pt idx="9">
                  <c:v>860</c:v>
                </c:pt>
                <c:pt idx="10">
                  <c:v>861</c:v>
                </c:pt>
                <c:pt idx="11">
                  <c:v>862</c:v>
                </c:pt>
                <c:pt idx="12">
                  <c:v>863</c:v>
                </c:pt>
                <c:pt idx="13">
                  <c:v>864</c:v>
                </c:pt>
                <c:pt idx="14">
                  <c:v>865</c:v>
                </c:pt>
                <c:pt idx="15">
                  <c:v>866</c:v>
                </c:pt>
                <c:pt idx="16">
                  <c:v>867</c:v>
                </c:pt>
                <c:pt idx="17">
                  <c:v>868</c:v>
                </c:pt>
                <c:pt idx="18">
                  <c:v>869</c:v>
                </c:pt>
                <c:pt idx="19">
                  <c:v>870</c:v>
                </c:pt>
                <c:pt idx="20">
                  <c:v>871</c:v>
                </c:pt>
                <c:pt idx="21">
                  <c:v>872</c:v>
                </c:pt>
                <c:pt idx="22">
                  <c:v>873</c:v>
                </c:pt>
                <c:pt idx="23">
                  <c:v>874</c:v>
                </c:pt>
                <c:pt idx="24">
                  <c:v>875</c:v>
                </c:pt>
                <c:pt idx="25">
                  <c:v>876</c:v>
                </c:pt>
                <c:pt idx="26">
                  <c:v>877</c:v>
                </c:pt>
                <c:pt idx="27">
                  <c:v>878</c:v>
                </c:pt>
                <c:pt idx="28">
                  <c:v>879</c:v>
                </c:pt>
                <c:pt idx="29">
                  <c:v>880</c:v>
                </c:pt>
                <c:pt idx="30">
                  <c:v>881</c:v>
                </c:pt>
                <c:pt idx="31">
                  <c:v>882</c:v>
                </c:pt>
                <c:pt idx="32">
                  <c:v>883</c:v>
                </c:pt>
                <c:pt idx="33">
                  <c:v>884</c:v>
                </c:pt>
                <c:pt idx="34">
                  <c:v>885</c:v>
                </c:pt>
                <c:pt idx="35">
                  <c:v>886</c:v>
                </c:pt>
                <c:pt idx="36">
                  <c:v>887</c:v>
                </c:pt>
                <c:pt idx="37">
                  <c:v>888</c:v>
                </c:pt>
                <c:pt idx="38">
                  <c:v>889</c:v>
                </c:pt>
                <c:pt idx="39">
                  <c:v>890</c:v>
                </c:pt>
                <c:pt idx="40">
                  <c:v>891</c:v>
                </c:pt>
                <c:pt idx="41">
                  <c:v>892</c:v>
                </c:pt>
                <c:pt idx="42">
                  <c:v>893</c:v>
                </c:pt>
                <c:pt idx="43">
                  <c:v>894</c:v>
                </c:pt>
                <c:pt idx="44">
                  <c:v>895</c:v>
                </c:pt>
                <c:pt idx="45">
                  <c:v>896</c:v>
                </c:pt>
                <c:pt idx="46">
                  <c:v>897</c:v>
                </c:pt>
                <c:pt idx="47">
                  <c:v>898</c:v>
                </c:pt>
                <c:pt idx="48">
                  <c:v>899</c:v>
                </c:pt>
                <c:pt idx="49">
                  <c:v>900</c:v>
                </c:pt>
                <c:pt idx="50">
                  <c:v>901</c:v>
                </c:pt>
                <c:pt idx="51">
                  <c:v>902</c:v>
                </c:pt>
                <c:pt idx="52">
                  <c:v>903</c:v>
                </c:pt>
                <c:pt idx="53">
                  <c:v>904</c:v>
                </c:pt>
                <c:pt idx="54">
                  <c:v>905</c:v>
                </c:pt>
                <c:pt idx="55">
                  <c:v>906</c:v>
                </c:pt>
                <c:pt idx="56">
                  <c:v>907</c:v>
                </c:pt>
                <c:pt idx="57">
                  <c:v>908</c:v>
                </c:pt>
                <c:pt idx="58">
                  <c:v>909</c:v>
                </c:pt>
                <c:pt idx="59">
                  <c:v>910</c:v>
                </c:pt>
                <c:pt idx="60">
                  <c:v>911</c:v>
                </c:pt>
                <c:pt idx="61">
                  <c:v>912</c:v>
                </c:pt>
                <c:pt idx="62">
                  <c:v>913</c:v>
                </c:pt>
                <c:pt idx="63">
                  <c:v>914</c:v>
                </c:pt>
                <c:pt idx="64">
                  <c:v>915</c:v>
                </c:pt>
                <c:pt idx="65">
                  <c:v>916</c:v>
                </c:pt>
                <c:pt idx="66">
                  <c:v>917</c:v>
                </c:pt>
                <c:pt idx="67">
                  <c:v>918</c:v>
                </c:pt>
                <c:pt idx="68">
                  <c:v>919</c:v>
                </c:pt>
                <c:pt idx="69">
                  <c:v>920</c:v>
                </c:pt>
                <c:pt idx="70">
                  <c:v>921</c:v>
                </c:pt>
                <c:pt idx="71">
                  <c:v>922</c:v>
                </c:pt>
                <c:pt idx="72">
                  <c:v>923</c:v>
                </c:pt>
                <c:pt idx="73">
                  <c:v>924</c:v>
                </c:pt>
                <c:pt idx="74">
                  <c:v>925</c:v>
                </c:pt>
                <c:pt idx="75">
                  <c:v>926</c:v>
                </c:pt>
                <c:pt idx="76">
                  <c:v>927</c:v>
                </c:pt>
                <c:pt idx="77">
                  <c:v>928</c:v>
                </c:pt>
                <c:pt idx="78">
                  <c:v>929</c:v>
                </c:pt>
                <c:pt idx="79">
                  <c:v>930</c:v>
                </c:pt>
                <c:pt idx="80">
                  <c:v>931</c:v>
                </c:pt>
                <c:pt idx="81">
                  <c:v>932</c:v>
                </c:pt>
                <c:pt idx="82">
                  <c:v>933</c:v>
                </c:pt>
                <c:pt idx="83">
                  <c:v>934</c:v>
                </c:pt>
                <c:pt idx="84">
                  <c:v>935</c:v>
                </c:pt>
                <c:pt idx="85">
                  <c:v>936</c:v>
                </c:pt>
                <c:pt idx="86">
                  <c:v>937</c:v>
                </c:pt>
                <c:pt idx="87">
                  <c:v>938</c:v>
                </c:pt>
                <c:pt idx="88">
                  <c:v>939</c:v>
                </c:pt>
                <c:pt idx="89">
                  <c:v>940</c:v>
                </c:pt>
                <c:pt idx="90">
                  <c:v>941</c:v>
                </c:pt>
                <c:pt idx="91">
                  <c:v>942</c:v>
                </c:pt>
                <c:pt idx="92">
                  <c:v>943</c:v>
                </c:pt>
                <c:pt idx="93">
                  <c:v>944</c:v>
                </c:pt>
                <c:pt idx="94">
                  <c:v>945</c:v>
                </c:pt>
                <c:pt idx="95">
                  <c:v>946</c:v>
                </c:pt>
                <c:pt idx="96">
                  <c:v>947</c:v>
                </c:pt>
                <c:pt idx="97">
                  <c:v>948</c:v>
                </c:pt>
                <c:pt idx="98">
                  <c:v>949</c:v>
                </c:pt>
                <c:pt idx="99">
                  <c:v>950</c:v>
                </c:pt>
                <c:pt idx="100">
                  <c:v>951</c:v>
                </c:pt>
                <c:pt idx="101">
                  <c:v>952</c:v>
                </c:pt>
                <c:pt idx="102">
                  <c:v>953</c:v>
                </c:pt>
                <c:pt idx="103">
                  <c:v>954</c:v>
                </c:pt>
                <c:pt idx="104">
                  <c:v>955</c:v>
                </c:pt>
                <c:pt idx="105">
                  <c:v>956</c:v>
                </c:pt>
                <c:pt idx="106">
                  <c:v>957</c:v>
                </c:pt>
                <c:pt idx="107">
                  <c:v>958</c:v>
                </c:pt>
                <c:pt idx="108">
                  <c:v>959</c:v>
                </c:pt>
                <c:pt idx="109">
                  <c:v>960</c:v>
                </c:pt>
                <c:pt idx="110">
                  <c:v>961</c:v>
                </c:pt>
                <c:pt idx="111">
                  <c:v>962</c:v>
                </c:pt>
                <c:pt idx="112">
                  <c:v>963</c:v>
                </c:pt>
                <c:pt idx="113">
                  <c:v>964</c:v>
                </c:pt>
                <c:pt idx="114">
                  <c:v>965</c:v>
                </c:pt>
                <c:pt idx="115">
                  <c:v>966</c:v>
                </c:pt>
                <c:pt idx="116">
                  <c:v>967</c:v>
                </c:pt>
                <c:pt idx="117">
                  <c:v>968</c:v>
                </c:pt>
                <c:pt idx="118">
                  <c:v>969</c:v>
                </c:pt>
                <c:pt idx="119">
                  <c:v>970</c:v>
                </c:pt>
                <c:pt idx="120">
                  <c:v>971</c:v>
                </c:pt>
                <c:pt idx="121">
                  <c:v>972</c:v>
                </c:pt>
                <c:pt idx="122">
                  <c:v>973</c:v>
                </c:pt>
                <c:pt idx="123">
                  <c:v>974</c:v>
                </c:pt>
                <c:pt idx="124">
                  <c:v>975</c:v>
                </c:pt>
                <c:pt idx="125">
                  <c:v>976</c:v>
                </c:pt>
                <c:pt idx="126">
                  <c:v>977</c:v>
                </c:pt>
                <c:pt idx="127">
                  <c:v>978</c:v>
                </c:pt>
                <c:pt idx="128">
                  <c:v>979</c:v>
                </c:pt>
                <c:pt idx="129">
                  <c:v>980</c:v>
                </c:pt>
                <c:pt idx="130">
                  <c:v>981</c:v>
                </c:pt>
                <c:pt idx="131">
                  <c:v>982</c:v>
                </c:pt>
                <c:pt idx="132">
                  <c:v>983</c:v>
                </c:pt>
                <c:pt idx="133">
                  <c:v>984</c:v>
                </c:pt>
                <c:pt idx="134">
                  <c:v>985</c:v>
                </c:pt>
                <c:pt idx="135">
                  <c:v>986</c:v>
                </c:pt>
                <c:pt idx="136">
                  <c:v>987</c:v>
                </c:pt>
                <c:pt idx="137">
                  <c:v>988</c:v>
                </c:pt>
                <c:pt idx="138">
                  <c:v>989</c:v>
                </c:pt>
                <c:pt idx="139">
                  <c:v>990</c:v>
                </c:pt>
                <c:pt idx="140">
                  <c:v>991</c:v>
                </c:pt>
                <c:pt idx="141">
                  <c:v>992</c:v>
                </c:pt>
                <c:pt idx="142">
                  <c:v>993</c:v>
                </c:pt>
                <c:pt idx="143">
                  <c:v>994</c:v>
                </c:pt>
                <c:pt idx="144">
                  <c:v>995</c:v>
                </c:pt>
                <c:pt idx="145">
                  <c:v>996</c:v>
                </c:pt>
                <c:pt idx="146">
                  <c:v>997</c:v>
                </c:pt>
                <c:pt idx="147">
                  <c:v>998</c:v>
                </c:pt>
                <c:pt idx="148">
                  <c:v>999</c:v>
                </c:pt>
                <c:pt idx="149">
                  <c:v>1000</c:v>
                </c:pt>
                <c:pt idx="150">
                  <c:v>1001</c:v>
                </c:pt>
                <c:pt idx="151">
                  <c:v>1002</c:v>
                </c:pt>
                <c:pt idx="152">
                  <c:v>1003</c:v>
                </c:pt>
                <c:pt idx="153">
                  <c:v>1004</c:v>
                </c:pt>
                <c:pt idx="154">
                  <c:v>1005</c:v>
                </c:pt>
                <c:pt idx="155">
                  <c:v>1006</c:v>
                </c:pt>
                <c:pt idx="156">
                  <c:v>1007</c:v>
                </c:pt>
                <c:pt idx="157">
                  <c:v>1008</c:v>
                </c:pt>
                <c:pt idx="158">
                  <c:v>1009</c:v>
                </c:pt>
                <c:pt idx="159">
                  <c:v>1010</c:v>
                </c:pt>
                <c:pt idx="160">
                  <c:v>1011</c:v>
                </c:pt>
                <c:pt idx="161">
                  <c:v>1012</c:v>
                </c:pt>
                <c:pt idx="162">
                  <c:v>1013</c:v>
                </c:pt>
              </c:numCache>
            </c:numRef>
          </c:cat>
          <c:val>
            <c:numRef>
              <c:f>Sheet1!$L$2:$L$164</c:f>
              <c:numCache>
                <c:formatCode>General</c:formatCode>
                <c:ptCount val="163"/>
                <c:pt idx="0">
                  <c:v>0.21909999999999999</c:v>
                </c:pt>
                <c:pt idx="1">
                  <c:v>0.2059</c:v>
                </c:pt>
                <c:pt idx="2">
                  <c:v>0.219</c:v>
                </c:pt>
                <c:pt idx="3">
                  <c:v>0.23200000000000001</c:v>
                </c:pt>
                <c:pt idx="4">
                  <c:v>0.2195</c:v>
                </c:pt>
                <c:pt idx="5">
                  <c:v>0.21129999999999999</c:v>
                </c:pt>
                <c:pt idx="6">
                  <c:v>0.23400000000000001</c:v>
                </c:pt>
                <c:pt idx="7">
                  <c:v>0.22869999999999999</c:v>
                </c:pt>
                <c:pt idx="8">
                  <c:v>0.2069</c:v>
                </c:pt>
                <c:pt idx="9">
                  <c:v>0.219</c:v>
                </c:pt>
                <c:pt idx="10">
                  <c:v>0.2392</c:v>
                </c:pt>
                <c:pt idx="11">
                  <c:v>0.22209999999999999</c:v>
                </c:pt>
                <c:pt idx="12">
                  <c:v>0.21110000000000001</c:v>
                </c:pt>
                <c:pt idx="13">
                  <c:v>0.23400000000000001</c:v>
                </c:pt>
                <c:pt idx="14">
                  <c:v>0.2392</c:v>
                </c:pt>
                <c:pt idx="15">
                  <c:v>0.21809999999999999</c:v>
                </c:pt>
                <c:pt idx="16">
                  <c:v>0.2656</c:v>
                </c:pt>
                <c:pt idx="17">
                  <c:v>0.29570000000000002</c:v>
                </c:pt>
                <c:pt idx="18">
                  <c:v>0.29210000000000003</c:v>
                </c:pt>
                <c:pt idx="19">
                  <c:v>0.36049999999999999</c:v>
                </c:pt>
                <c:pt idx="20">
                  <c:v>0.44869999999999999</c:v>
                </c:pt>
                <c:pt idx="21">
                  <c:v>0.53259999999999996</c:v>
                </c:pt>
                <c:pt idx="22">
                  <c:v>0.63980000000000004</c:v>
                </c:pt>
                <c:pt idx="23">
                  <c:v>0.74050000000000005</c:v>
                </c:pt>
                <c:pt idx="24">
                  <c:v>0.90739999999999998</c:v>
                </c:pt>
                <c:pt idx="25">
                  <c:v>0.97719999999999996</c:v>
                </c:pt>
                <c:pt idx="26">
                  <c:v>1.1688000000000001</c:v>
                </c:pt>
                <c:pt idx="27">
                  <c:v>1.3925000000000001</c:v>
                </c:pt>
                <c:pt idx="28">
                  <c:v>1.4731000000000001</c:v>
                </c:pt>
                <c:pt idx="29">
                  <c:v>1.3467</c:v>
                </c:pt>
                <c:pt idx="30">
                  <c:v>1.1788000000000001</c:v>
                </c:pt>
                <c:pt idx="31">
                  <c:v>1.1061000000000001</c:v>
                </c:pt>
                <c:pt idx="32">
                  <c:v>1.081</c:v>
                </c:pt>
                <c:pt idx="33">
                  <c:v>0.9</c:v>
                </c:pt>
                <c:pt idx="34">
                  <c:v>0.67910000000000004</c:v>
                </c:pt>
                <c:pt idx="35">
                  <c:v>0.61209999999999998</c:v>
                </c:pt>
                <c:pt idx="36">
                  <c:v>0.43559999999999999</c:v>
                </c:pt>
                <c:pt idx="37">
                  <c:v>0.29720000000000002</c:v>
                </c:pt>
                <c:pt idx="38">
                  <c:v>0.2218</c:v>
                </c:pt>
                <c:pt idx="39">
                  <c:v>0.19750000000000001</c:v>
                </c:pt>
                <c:pt idx="40">
                  <c:v>0.17380000000000001</c:v>
                </c:pt>
                <c:pt idx="41">
                  <c:v>0.17399999999999999</c:v>
                </c:pt>
                <c:pt idx="42">
                  <c:v>0.19400000000000001</c:v>
                </c:pt>
                <c:pt idx="43">
                  <c:v>0.18920000000000001</c:v>
                </c:pt>
                <c:pt idx="44">
                  <c:v>0.19320000000000001</c:v>
                </c:pt>
                <c:pt idx="45">
                  <c:v>0.247</c:v>
                </c:pt>
                <c:pt idx="46">
                  <c:v>0.2611</c:v>
                </c:pt>
                <c:pt idx="47">
                  <c:v>0.22320000000000001</c:v>
                </c:pt>
                <c:pt idx="48">
                  <c:v>0.17910000000000001</c:v>
                </c:pt>
                <c:pt idx="49">
                  <c:v>0.185</c:v>
                </c:pt>
                <c:pt idx="50">
                  <c:v>0.16880000000000001</c:v>
                </c:pt>
                <c:pt idx="51">
                  <c:v>0.1643</c:v>
                </c:pt>
                <c:pt idx="52">
                  <c:v>0.21079999999999999</c:v>
                </c:pt>
                <c:pt idx="53">
                  <c:v>0.23580000000000001</c:v>
                </c:pt>
                <c:pt idx="54">
                  <c:v>0.22620000000000001</c:v>
                </c:pt>
                <c:pt idx="55">
                  <c:v>0.20960000000000001</c:v>
                </c:pt>
                <c:pt idx="56">
                  <c:v>0.1661</c:v>
                </c:pt>
                <c:pt idx="57">
                  <c:v>0.15989999999999999</c:v>
                </c:pt>
                <c:pt idx="58">
                  <c:v>0.1651</c:v>
                </c:pt>
                <c:pt idx="59">
                  <c:v>0.16950000000000001</c:v>
                </c:pt>
                <c:pt idx="60">
                  <c:v>0.17910000000000001</c:v>
                </c:pt>
                <c:pt idx="61">
                  <c:v>0.18759999999999999</c:v>
                </c:pt>
                <c:pt idx="62">
                  <c:v>0.1888</c:v>
                </c:pt>
                <c:pt idx="63">
                  <c:v>0.2011</c:v>
                </c:pt>
                <c:pt idx="64">
                  <c:v>0.20649999999999999</c:v>
                </c:pt>
                <c:pt idx="65">
                  <c:v>0.1963</c:v>
                </c:pt>
                <c:pt idx="66">
                  <c:v>0.1764</c:v>
                </c:pt>
                <c:pt idx="67">
                  <c:v>0.20119999999999999</c:v>
                </c:pt>
                <c:pt idx="68">
                  <c:v>0.22309999999999999</c:v>
                </c:pt>
                <c:pt idx="69">
                  <c:v>0.21110000000000001</c:v>
                </c:pt>
                <c:pt idx="70">
                  <c:v>0.21010000000000001</c:v>
                </c:pt>
                <c:pt idx="71">
                  <c:v>0.2263</c:v>
                </c:pt>
                <c:pt idx="72">
                  <c:v>0.23369999999999999</c:v>
                </c:pt>
                <c:pt idx="73">
                  <c:v>0.23860000000000001</c:v>
                </c:pt>
                <c:pt idx="74">
                  <c:v>0.24110000000000001</c:v>
                </c:pt>
                <c:pt idx="75">
                  <c:v>0.25829999999999997</c:v>
                </c:pt>
                <c:pt idx="76">
                  <c:v>0.2571</c:v>
                </c:pt>
                <c:pt idx="77">
                  <c:v>0.2419</c:v>
                </c:pt>
                <c:pt idx="78">
                  <c:v>0.24410000000000001</c:v>
                </c:pt>
                <c:pt idx="79">
                  <c:v>0.2447</c:v>
                </c:pt>
                <c:pt idx="80">
                  <c:v>0.23630000000000001</c:v>
                </c:pt>
                <c:pt idx="81">
                  <c:v>0.2321</c:v>
                </c:pt>
                <c:pt idx="82">
                  <c:v>0.22040000000000001</c:v>
                </c:pt>
                <c:pt idx="83">
                  <c:v>0.23250000000000001</c:v>
                </c:pt>
                <c:pt idx="84">
                  <c:v>0.2281</c:v>
                </c:pt>
                <c:pt idx="85">
                  <c:v>0.23599999999999999</c:v>
                </c:pt>
                <c:pt idx="86">
                  <c:v>0.23960000000000001</c:v>
                </c:pt>
                <c:pt idx="87">
                  <c:v>0.2616</c:v>
                </c:pt>
                <c:pt idx="88">
                  <c:v>0.27439999999999998</c:v>
                </c:pt>
                <c:pt idx="89">
                  <c:v>0.25290000000000001</c:v>
                </c:pt>
                <c:pt idx="90">
                  <c:v>0.2457</c:v>
                </c:pt>
                <c:pt idx="91">
                  <c:v>0.23400000000000001</c:v>
                </c:pt>
                <c:pt idx="92">
                  <c:v>0.22589999999999999</c:v>
                </c:pt>
                <c:pt idx="93">
                  <c:v>0.2286</c:v>
                </c:pt>
                <c:pt idx="94">
                  <c:v>0.246</c:v>
                </c:pt>
                <c:pt idx="95">
                  <c:v>0.23860000000000001</c:v>
                </c:pt>
                <c:pt idx="96">
                  <c:v>0.22470000000000001</c:v>
                </c:pt>
                <c:pt idx="97">
                  <c:v>0.23580000000000001</c:v>
                </c:pt>
                <c:pt idx="98">
                  <c:v>0.24779999999999999</c:v>
                </c:pt>
                <c:pt idx="99">
                  <c:v>0.2316</c:v>
                </c:pt>
                <c:pt idx="100">
                  <c:v>0.2218</c:v>
                </c:pt>
                <c:pt idx="101">
                  <c:v>0.24160000000000001</c:v>
                </c:pt>
                <c:pt idx="102">
                  <c:v>0.2477</c:v>
                </c:pt>
                <c:pt idx="103">
                  <c:v>0.22900000000000001</c:v>
                </c:pt>
                <c:pt idx="104">
                  <c:v>0.2414</c:v>
                </c:pt>
                <c:pt idx="105">
                  <c:v>0.30159999999999998</c:v>
                </c:pt>
                <c:pt idx="106">
                  <c:v>0.32219999999999999</c:v>
                </c:pt>
                <c:pt idx="107">
                  <c:v>0.3931</c:v>
                </c:pt>
                <c:pt idx="108">
                  <c:v>0.4496</c:v>
                </c:pt>
                <c:pt idx="109">
                  <c:v>0.4592</c:v>
                </c:pt>
                <c:pt idx="110">
                  <c:v>0.46410000000000001</c:v>
                </c:pt>
                <c:pt idx="111">
                  <c:v>0.39729999999999999</c:v>
                </c:pt>
                <c:pt idx="112">
                  <c:v>0.41149999999999998</c:v>
                </c:pt>
                <c:pt idx="113">
                  <c:v>0.44030000000000002</c:v>
                </c:pt>
                <c:pt idx="114">
                  <c:v>0.47170000000000001</c:v>
                </c:pt>
                <c:pt idx="115">
                  <c:v>0.47710000000000002</c:v>
                </c:pt>
                <c:pt idx="116">
                  <c:v>0.52139999999999997</c:v>
                </c:pt>
                <c:pt idx="117">
                  <c:v>0.54490000000000005</c:v>
                </c:pt>
                <c:pt idx="118">
                  <c:v>0.50309999999999999</c:v>
                </c:pt>
                <c:pt idx="119">
                  <c:v>0.49869999999999998</c:v>
                </c:pt>
                <c:pt idx="120">
                  <c:v>0.50470000000000004</c:v>
                </c:pt>
                <c:pt idx="121">
                  <c:v>0.41660000000000003</c:v>
                </c:pt>
                <c:pt idx="122">
                  <c:v>0.36580000000000001</c:v>
                </c:pt>
                <c:pt idx="123">
                  <c:v>0.26240000000000002</c:v>
                </c:pt>
                <c:pt idx="124">
                  <c:v>0.27210000000000001</c:v>
                </c:pt>
                <c:pt idx="125">
                  <c:v>0.26600000000000001</c:v>
                </c:pt>
                <c:pt idx="126">
                  <c:v>0.29970000000000002</c:v>
                </c:pt>
                <c:pt idx="127">
                  <c:v>0.2903</c:v>
                </c:pt>
                <c:pt idx="128">
                  <c:v>0.25380000000000003</c:v>
                </c:pt>
                <c:pt idx="129">
                  <c:v>0.26919999999999999</c:v>
                </c:pt>
                <c:pt idx="130">
                  <c:v>0.29520000000000002</c:v>
                </c:pt>
                <c:pt idx="131">
                  <c:v>0.2737</c:v>
                </c:pt>
                <c:pt idx="132">
                  <c:v>0.27289999999999998</c:v>
                </c:pt>
                <c:pt idx="133">
                  <c:v>0.34939999999999999</c:v>
                </c:pt>
                <c:pt idx="134">
                  <c:v>0.37740000000000001</c:v>
                </c:pt>
                <c:pt idx="135">
                  <c:v>0.441</c:v>
                </c:pt>
                <c:pt idx="136">
                  <c:v>0.47399999999999998</c:v>
                </c:pt>
                <c:pt idx="137">
                  <c:v>0.61009999999999998</c:v>
                </c:pt>
                <c:pt idx="138">
                  <c:v>0.69440000000000002</c:v>
                </c:pt>
                <c:pt idx="139">
                  <c:v>0.76859999999999995</c:v>
                </c:pt>
                <c:pt idx="140">
                  <c:v>0.9415</c:v>
                </c:pt>
                <c:pt idx="141">
                  <c:v>1.0657000000000001</c:v>
                </c:pt>
                <c:pt idx="142">
                  <c:v>1.2465999999999999</c:v>
                </c:pt>
                <c:pt idx="143">
                  <c:v>1.3912</c:v>
                </c:pt>
                <c:pt idx="144">
                  <c:v>1.5321</c:v>
                </c:pt>
                <c:pt idx="145">
                  <c:v>1.6805000000000001</c:v>
                </c:pt>
                <c:pt idx="146">
                  <c:v>1.8643000000000001</c:v>
                </c:pt>
                <c:pt idx="147">
                  <c:v>2.0238</c:v>
                </c:pt>
                <c:pt idx="148">
                  <c:v>2.1871</c:v>
                </c:pt>
                <c:pt idx="149">
                  <c:v>2.2865000000000002</c:v>
                </c:pt>
                <c:pt idx="150">
                  <c:v>2.3525</c:v>
                </c:pt>
                <c:pt idx="151">
                  <c:v>2.3813</c:v>
                </c:pt>
                <c:pt idx="152">
                  <c:v>2.3954</c:v>
                </c:pt>
                <c:pt idx="153">
                  <c:v>2.4207999999999998</c:v>
                </c:pt>
                <c:pt idx="154">
                  <c:v>2.4558</c:v>
                </c:pt>
                <c:pt idx="155">
                  <c:v>2.5571999999999999</c:v>
                </c:pt>
                <c:pt idx="156">
                  <c:v>2.6671999999999998</c:v>
                </c:pt>
                <c:pt idx="157">
                  <c:v>2.7804000000000002</c:v>
                </c:pt>
                <c:pt idx="158">
                  <c:v>2.9493</c:v>
                </c:pt>
                <c:pt idx="159">
                  <c:v>3.085</c:v>
                </c:pt>
                <c:pt idx="160">
                  <c:v>3.2158000000000002</c:v>
                </c:pt>
                <c:pt idx="161">
                  <c:v>3.4116</c:v>
                </c:pt>
                <c:pt idx="162">
                  <c:v>3.5537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45F-4DAF-9000-A4DD7D002A4E}"/>
            </c:ext>
          </c:extLst>
        </c:ser>
        <c:ser>
          <c:idx val="2"/>
          <c:order val="2"/>
          <c:tx>
            <c:strRef>
              <c:f>Sheet1!$M$1</c:f>
              <c:strCache>
                <c:ptCount val="1"/>
                <c:pt idx="0">
                  <c:v>Series3</c:v>
                </c:pt>
              </c:strCache>
            </c:strRef>
          </c:tx>
          <c:spPr>
            <a:ln w="19050" cap="rnd">
              <a:solidFill>
                <a:srgbClr val="33CCCC"/>
              </a:solidFill>
              <a:round/>
            </a:ln>
            <a:effectLst/>
          </c:spPr>
          <c:marker>
            <c:symbol val="none"/>
          </c:marker>
          <c:cat>
            <c:numRef>
              <c:f>Sheet1!$J$2:$J$164</c:f>
              <c:numCache>
                <c:formatCode>General</c:formatCode>
                <c:ptCount val="163"/>
                <c:pt idx="0">
                  <c:v>851</c:v>
                </c:pt>
                <c:pt idx="1">
                  <c:v>852</c:v>
                </c:pt>
                <c:pt idx="2">
                  <c:v>853</c:v>
                </c:pt>
                <c:pt idx="3">
                  <c:v>854</c:v>
                </c:pt>
                <c:pt idx="4">
                  <c:v>855</c:v>
                </c:pt>
                <c:pt idx="5">
                  <c:v>856</c:v>
                </c:pt>
                <c:pt idx="6">
                  <c:v>857</c:v>
                </c:pt>
                <c:pt idx="7">
                  <c:v>858</c:v>
                </c:pt>
                <c:pt idx="8">
                  <c:v>859</c:v>
                </c:pt>
                <c:pt idx="9">
                  <c:v>860</c:v>
                </c:pt>
                <c:pt idx="10">
                  <c:v>861</c:v>
                </c:pt>
                <c:pt idx="11">
                  <c:v>862</c:v>
                </c:pt>
                <c:pt idx="12">
                  <c:v>863</c:v>
                </c:pt>
                <c:pt idx="13">
                  <c:v>864</c:v>
                </c:pt>
                <c:pt idx="14">
                  <c:v>865</c:v>
                </c:pt>
                <c:pt idx="15">
                  <c:v>866</c:v>
                </c:pt>
                <c:pt idx="16">
                  <c:v>867</c:v>
                </c:pt>
                <c:pt idx="17">
                  <c:v>868</c:v>
                </c:pt>
                <c:pt idx="18">
                  <c:v>869</c:v>
                </c:pt>
                <c:pt idx="19">
                  <c:v>870</c:v>
                </c:pt>
                <c:pt idx="20">
                  <c:v>871</c:v>
                </c:pt>
                <c:pt idx="21">
                  <c:v>872</c:v>
                </c:pt>
                <c:pt idx="22">
                  <c:v>873</c:v>
                </c:pt>
                <c:pt idx="23">
                  <c:v>874</c:v>
                </c:pt>
                <c:pt idx="24">
                  <c:v>875</c:v>
                </c:pt>
                <c:pt idx="25">
                  <c:v>876</c:v>
                </c:pt>
                <c:pt idx="26">
                  <c:v>877</c:v>
                </c:pt>
                <c:pt idx="27">
                  <c:v>878</c:v>
                </c:pt>
                <c:pt idx="28">
                  <c:v>879</c:v>
                </c:pt>
                <c:pt idx="29">
                  <c:v>880</c:v>
                </c:pt>
                <c:pt idx="30">
                  <c:v>881</c:v>
                </c:pt>
                <c:pt idx="31">
                  <c:v>882</c:v>
                </c:pt>
                <c:pt idx="32">
                  <c:v>883</c:v>
                </c:pt>
                <c:pt idx="33">
                  <c:v>884</c:v>
                </c:pt>
                <c:pt idx="34">
                  <c:v>885</c:v>
                </c:pt>
                <c:pt idx="35">
                  <c:v>886</c:v>
                </c:pt>
                <c:pt idx="36">
                  <c:v>887</c:v>
                </c:pt>
                <c:pt idx="37">
                  <c:v>888</c:v>
                </c:pt>
                <c:pt idx="38">
                  <c:v>889</c:v>
                </c:pt>
                <c:pt idx="39">
                  <c:v>890</c:v>
                </c:pt>
                <c:pt idx="40">
                  <c:v>891</c:v>
                </c:pt>
                <c:pt idx="41">
                  <c:v>892</c:v>
                </c:pt>
                <c:pt idx="42">
                  <c:v>893</c:v>
                </c:pt>
                <c:pt idx="43">
                  <c:v>894</c:v>
                </c:pt>
                <c:pt idx="44">
                  <c:v>895</c:v>
                </c:pt>
                <c:pt idx="45">
                  <c:v>896</c:v>
                </c:pt>
                <c:pt idx="46">
                  <c:v>897</c:v>
                </c:pt>
                <c:pt idx="47">
                  <c:v>898</c:v>
                </c:pt>
                <c:pt idx="48">
                  <c:v>899</c:v>
                </c:pt>
                <c:pt idx="49">
                  <c:v>900</c:v>
                </c:pt>
                <c:pt idx="50">
                  <c:v>901</c:v>
                </c:pt>
                <c:pt idx="51">
                  <c:v>902</c:v>
                </c:pt>
                <c:pt idx="52">
                  <c:v>903</c:v>
                </c:pt>
                <c:pt idx="53">
                  <c:v>904</c:v>
                </c:pt>
                <c:pt idx="54">
                  <c:v>905</c:v>
                </c:pt>
                <c:pt idx="55">
                  <c:v>906</c:v>
                </c:pt>
                <c:pt idx="56">
                  <c:v>907</c:v>
                </c:pt>
                <c:pt idx="57">
                  <c:v>908</c:v>
                </c:pt>
                <c:pt idx="58">
                  <c:v>909</c:v>
                </c:pt>
                <c:pt idx="59">
                  <c:v>910</c:v>
                </c:pt>
                <c:pt idx="60">
                  <c:v>911</c:v>
                </c:pt>
                <c:pt idx="61">
                  <c:v>912</c:v>
                </c:pt>
                <c:pt idx="62">
                  <c:v>913</c:v>
                </c:pt>
                <c:pt idx="63">
                  <c:v>914</c:v>
                </c:pt>
                <c:pt idx="64">
                  <c:v>915</c:v>
                </c:pt>
                <c:pt idx="65">
                  <c:v>916</c:v>
                </c:pt>
                <c:pt idx="66">
                  <c:v>917</c:v>
                </c:pt>
                <c:pt idx="67">
                  <c:v>918</c:v>
                </c:pt>
                <c:pt idx="68">
                  <c:v>919</c:v>
                </c:pt>
                <c:pt idx="69">
                  <c:v>920</c:v>
                </c:pt>
                <c:pt idx="70">
                  <c:v>921</c:v>
                </c:pt>
                <c:pt idx="71">
                  <c:v>922</c:v>
                </c:pt>
                <c:pt idx="72">
                  <c:v>923</c:v>
                </c:pt>
                <c:pt idx="73">
                  <c:v>924</c:v>
                </c:pt>
                <c:pt idx="74">
                  <c:v>925</c:v>
                </c:pt>
                <c:pt idx="75">
                  <c:v>926</c:v>
                </c:pt>
                <c:pt idx="76">
                  <c:v>927</c:v>
                </c:pt>
                <c:pt idx="77">
                  <c:v>928</c:v>
                </c:pt>
                <c:pt idx="78">
                  <c:v>929</c:v>
                </c:pt>
                <c:pt idx="79">
                  <c:v>930</c:v>
                </c:pt>
                <c:pt idx="80">
                  <c:v>931</c:v>
                </c:pt>
                <c:pt idx="81">
                  <c:v>932</c:v>
                </c:pt>
                <c:pt idx="82">
                  <c:v>933</c:v>
                </c:pt>
                <c:pt idx="83">
                  <c:v>934</c:v>
                </c:pt>
                <c:pt idx="84">
                  <c:v>935</c:v>
                </c:pt>
                <c:pt idx="85">
                  <c:v>936</c:v>
                </c:pt>
                <c:pt idx="86">
                  <c:v>937</c:v>
                </c:pt>
                <c:pt idx="87">
                  <c:v>938</c:v>
                </c:pt>
                <c:pt idx="88">
                  <c:v>939</c:v>
                </c:pt>
                <c:pt idx="89">
                  <c:v>940</c:v>
                </c:pt>
                <c:pt idx="90">
                  <c:v>941</c:v>
                </c:pt>
                <c:pt idx="91">
                  <c:v>942</c:v>
                </c:pt>
                <c:pt idx="92">
                  <c:v>943</c:v>
                </c:pt>
                <c:pt idx="93">
                  <c:v>944</c:v>
                </c:pt>
                <c:pt idx="94">
                  <c:v>945</c:v>
                </c:pt>
                <c:pt idx="95">
                  <c:v>946</c:v>
                </c:pt>
                <c:pt idx="96">
                  <c:v>947</c:v>
                </c:pt>
                <c:pt idx="97">
                  <c:v>948</c:v>
                </c:pt>
                <c:pt idx="98">
                  <c:v>949</c:v>
                </c:pt>
                <c:pt idx="99">
                  <c:v>950</c:v>
                </c:pt>
                <c:pt idx="100">
                  <c:v>951</c:v>
                </c:pt>
                <c:pt idx="101">
                  <c:v>952</c:v>
                </c:pt>
                <c:pt idx="102">
                  <c:v>953</c:v>
                </c:pt>
                <c:pt idx="103">
                  <c:v>954</c:v>
                </c:pt>
                <c:pt idx="104">
                  <c:v>955</c:v>
                </c:pt>
                <c:pt idx="105">
                  <c:v>956</c:v>
                </c:pt>
                <c:pt idx="106">
                  <c:v>957</c:v>
                </c:pt>
                <c:pt idx="107">
                  <c:v>958</c:v>
                </c:pt>
                <c:pt idx="108">
                  <c:v>959</c:v>
                </c:pt>
                <c:pt idx="109">
                  <c:v>960</c:v>
                </c:pt>
                <c:pt idx="110">
                  <c:v>961</c:v>
                </c:pt>
                <c:pt idx="111">
                  <c:v>962</c:v>
                </c:pt>
                <c:pt idx="112">
                  <c:v>963</c:v>
                </c:pt>
                <c:pt idx="113">
                  <c:v>964</c:v>
                </c:pt>
                <c:pt idx="114">
                  <c:v>965</c:v>
                </c:pt>
                <c:pt idx="115">
                  <c:v>966</c:v>
                </c:pt>
                <c:pt idx="116">
                  <c:v>967</c:v>
                </c:pt>
                <c:pt idx="117">
                  <c:v>968</c:v>
                </c:pt>
                <c:pt idx="118">
                  <c:v>969</c:v>
                </c:pt>
                <c:pt idx="119">
                  <c:v>970</c:v>
                </c:pt>
                <c:pt idx="120">
                  <c:v>971</c:v>
                </c:pt>
                <c:pt idx="121">
                  <c:v>972</c:v>
                </c:pt>
                <c:pt idx="122">
                  <c:v>973</c:v>
                </c:pt>
                <c:pt idx="123">
                  <c:v>974</c:v>
                </c:pt>
                <c:pt idx="124">
                  <c:v>975</c:v>
                </c:pt>
                <c:pt idx="125">
                  <c:v>976</c:v>
                </c:pt>
                <c:pt idx="126">
                  <c:v>977</c:v>
                </c:pt>
                <c:pt idx="127">
                  <c:v>978</c:v>
                </c:pt>
                <c:pt idx="128">
                  <c:v>979</c:v>
                </c:pt>
                <c:pt idx="129">
                  <c:v>980</c:v>
                </c:pt>
                <c:pt idx="130">
                  <c:v>981</c:v>
                </c:pt>
                <c:pt idx="131">
                  <c:v>982</c:v>
                </c:pt>
                <c:pt idx="132">
                  <c:v>983</c:v>
                </c:pt>
                <c:pt idx="133">
                  <c:v>984</c:v>
                </c:pt>
                <c:pt idx="134">
                  <c:v>985</c:v>
                </c:pt>
                <c:pt idx="135">
                  <c:v>986</c:v>
                </c:pt>
                <c:pt idx="136">
                  <c:v>987</c:v>
                </c:pt>
                <c:pt idx="137">
                  <c:v>988</c:v>
                </c:pt>
                <c:pt idx="138">
                  <c:v>989</c:v>
                </c:pt>
                <c:pt idx="139">
                  <c:v>990</c:v>
                </c:pt>
                <c:pt idx="140">
                  <c:v>991</c:v>
                </c:pt>
                <c:pt idx="141">
                  <c:v>992</c:v>
                </c:pt>
                <c:pt idx="142">
                  <c:v>993</c:v>
                </c:pt>
                <c:pt idx="143">
                  <c:v>994</c:v>
                </c:pt>
                <c:pt idx="144">
                  <c:v>995</c:v>
                </c:pt>
                <c:pt idx="145">
                  <c:v>996</c:v>
                </c:pt>
                <c:pt idx="146">
                  <c:v>997</c:v>
                </c:pt>
                <c:pt idx="147">
                  <c:v>998</c:v>
                </c:pt>
                <c:pt idx="148">
                  <c:v>999</c:v>
                </c:pt>
                <c:pt idx="149">
                  <c:v>1000</c:v>
                </c:pt>
                <c:pt idx="150">
                  <c:v>1001</c:v>
                </c:pt>
                <c:pt idx="151">
                  <c:v>1002</c:v>
                </c:pt>
                <c:pt idx="152">
                  <c:v>1003</c:v>
                </c:pt>
                <c:pt idx="153">
                  <c:v>1004</c:v>
                </c:pt>
                <c:pt idx="154">
                  <c:v>1005</c:v>
                </c:pt>
                <c:pt idx="155">
                  <c:v>1006</c:v>
                </c:pt>
                <c:pt idx="156">
                  <c:v>1007</c:v>
                </c:pt>
                <c:pt idx="157">
                  <c:v>1008</c:v>
                </c:pt>
                <c:pt idx="158">
                  <c:v>1009</c:v>
                </c:pt>
                <c:pt idx="159">
                  <c:v>1010</c:v>
                </c:pt>
                <c:pt idx="160">
                  <c:v>1011</c:v>
                </c:pt>
                <c:pt idx="161">
                  <c:v>1012</c:v>
                </c:pt>
                <c:pt idx="162">
                  <c:v>1013</c:v>
                </c:pt>
              </c:numCache>
            </c:numRef>
          </c:cat>
          <c:val>
            <c:numRef>
              <c:f>Sheet1!$M$2:$M$164</c:f>
              <c:numCache>
                <c:formatCode>General</c:formatCode>
                <c:ptCount val="163"/>
                <c:pt idx="0">
                  <c:v>0.2697</c:v>
                </c:pt>
                <c:pt idx="1">
                  <c:v>0.25850000000000001</c:v>
                </c:pt>
                <c:pt idx="2">
                  <c:v>0.27150000000000002</c:v>
                </c:pt>
                <c:pt idx="3">
                  <c:v>0.2913</c:v>
                </c:pt>
                <c:pt idx="4">
                  <c:v>0.28079999999999999</c:v>
                </c:pt>
                <c:pt idx="5">
                  <c:v>0.27679999999999999</c:v>
                </c:pt>
                <c:pt idx="6">
                  <c:v>0.2959</c:v>
                </c:pt>
                <c:pt idx="7">
                  <c:v>0.31219999999999998</c:v>
                </c:pt>
                <c:pt idx="8">
                  <c:v>0.29349999999999998</c:v>
                </c:pt>
                <c:pt idx="9">
                  <c:v>0.28370000000000001</c:v>
                </c:pt>
                <c:pt idx="10">
                  <c:v>0.30270000000000002</c:v>
                </c:pt>
                <c:pt idx="11">
                  <c:v>0.31080000000000002</c:v>
                </c:pt>
                <c:pt idx="12">
                  <c:v>0.2949</c:v>
                </c:pt>
                <c:pt idx="13">
                  <c:v>0.29980000000000001</c:v>
                </c:pt>
                <c:pt idx="14">
                  <c:v>0.28960000000000002</c:v>
                </c:pt>
                <c:pt idx="15">
                  <c:v>0.27950000000000003</c:v>
                </c:pt>
                <c:pt idx="16">
                  <c:v>0.31569999999999998</c:v>
                </c:pt>
                <c:pt idx="17">
                  <c:v>0.3841</c:v>
                </c:pt>
                <c:pt idx="18">
                  <c:v>0.56879999999999997</c:v>
                </c:pt>
                <c:pt idx="19">
                  <c:v>0.71960000000000002</c:v>
                </c:pt>
                <c:pt idx="20">
                  <c:v>0.83420000000000005</c:v>
                </c:pt>
                <c:pt idx="21">
                  <c:v>1.0044999999999999</c:v>
                </c:pt>
                <c:pt idx="22">
                  <c:v>1.1208</c:v>
                </c:pt>
                <c:pt idx="23">
                  <c:v>1.274</c:v>
                </c:pt>
                <c:pt idx="24">
                  <c:v>1.3264</c:v>
                </c:pt>
                <c:pt idx="25">
                  <c:v>1.34</c:v>
                </c:pt>
                <c:pt idx="26">
                  <c:v>1.1520999999999999</c:v>
                </c:pt>
                <c:pt idx="27">
                  <c:v>1.1413</c:v>
                </c:pt>
                <c:pt idx="28">
                  <c:v>1.2450000000000001</c:v>
                </c:pt>
                <c:pt idx="29">
                  <c:v>1.1884999999999999</c:v>
                </c:pt>
                <c:pt idx="30">
                  <c:v>0.99109999999999998</c:v>
                </c:pt>
                <c:pt idx="31">
                  <c:v>0.7419</c:v>
                </c:pt>
                <c:pt idx="32">
                  <c:v>0.62309999999999999</c:v>
                </c:pt>
                <c:pt idx="33">
                  <c:v>0.52359999999999995</c:v>
                </c:pt>
                <c:pt idx="34">
                  <c:v>0.43790000000000001</c:v>
                </c:pt>
                <c:pt idx="35">
                  <c:v>0.41839999999999999</c:v>
                </c:pt>
                <c:pt idx="36">
                  <c:v>0.38290000000000002</c:v>
                </c:pt>
                <c:pt idx="37">
                  <c:v>0.33579999999999999</c:v>
                </c:pt>
                <c:pt idx="38">
                  <c:v>0.30630000000000002</c:v>
                </c:pt>
                <c:pt idx="39">
                  <c:v>0.28660000000000002</c:v>
                </c:pt>
                <c:pt idx="40">
                  <c:v>0.26690000000000003</c:v>
                </c:pt>
                <c:pt idx="41">
                  <c:v>0.25509999999999999</c:v>
                </c:pt>
                <c:pt idx="42">
                  <c:v>0.26179999999999998</c:v>
                </c:pt>
                <c:pt idx="43">
                  <c:v>0.26179999999999998</c:v>
                </c:pt>
                <c:pt idx="44">
                  <c:v>0.24399999999999999</c:v>
                </c:pt>
                <c:pt idx="45">
                  <c:v>0.23039999999999999</c:v>
                </c:pt>
                <c:pt idx="46">
                  <c:v>0.23019999999999999</c:v>
                </c:pt>
                <c:pt idx="47">
                  <c:v>0.19500000000000001</c:v>
                </c:pt>
                <c:pt idx="48">
                  <c:v>0.1832</c:v>
                </c:pt>
                <c:pt idx="49">
                  <c:v>0.1772</c:v>
                </c:pt>
                <c:pt idx="50">
                  <c:v>0.17349999999999999</c:v>
                </c:pt>
                <c:pt idx="51">
                  <c:v>0.17929999999999999</c:v>
                </c:pt>
                <c:pt idx="52">
                  <c:v>0.1968</c:v>
                </c:pt>
                <c:pt idx="53">
                  <c:v>0.2203</c:v>
                </c:pt>
                <c:pt idx="54">
                  <c:v>0.2233</c:v>
                </c:pt>
                <c:pt idx="55">
                  <c:v>0.20180000000000001</c:v>
                </c:pt>
                <c:pt idx="56">
                  <c:v>0.1772</c:v>
                </c:pt>
                <c:pt idx="57">
                  <c:v>0.16070000000000001</c:v>
                </c:pt>
                <c:pt idx="58">
                  <c:v>0.16170000000000001</c:v>
                </c:pt>
                <c:pt idx="59">
                  <c:v>0.15540000000000001</c:v>
                </c:pt>
                <c:pt idx="60">
                  <c:v>0.16139999999999999</c:v>
                </c:pt>
                <c:pt idx="61">
                  <c:v>0.16370000000000001</c:v>
                </c:pt>
                <c:pt idx="62">
                  <c:v>0.1618</c:v>
                </c:pt>
                <c:pt idx="63">
                  <c:v>0.1714</c:v>
                </c:pt>
                <c:pt idx="64">
                  <c:v>0.22439999999999999</c:v>
                </c:pt>
                <c:pt idx="65">
                  <c:v>0.22259999999999999</c:v>
                </c:pt>
                <c:pt idx="66">
                  <c:v>0.19900000000000001</c:v>
                </c:pt>
                <c:pt idx="67">
                  <c:v>0.18720000000000001</c:v>
                </c:pt>
                <c:pt idx="68">
                  <c:v>0.2031</c:v>
                </c:pt>
                <c:pt idx="69">
                  <c:v>0.2019</c:v>
                </c:pt>
                <c:pt idx="70">
                  <c:v>0.18340000000000001</c:v>
                </c:pt>
                <c:pt idx="71">
                  <c:v>0.1933</c:v>
                </c:pt>
                <c:pt idx="72">
                  <c:v>0.1915</c:v>
                </c:pt>
                <c:pt idx="73">
                  <c:v>0.17299999999999999</c:v>
                </c:pt>
                <c:pt idx="74">
                  <c:v>0.1583</c:v>
                </c:pt>
                <c:pt idx="75">
                  <c:v>0.16839999999999999</c:v>
                </c:pt>
                <c:pt idx="76">
                  <c:v>0.16869999999999999</c:v>
                </c:pt>
                <c:pt idx="77">
                  <c:v>0.15820000000000001</c:v>
                </c:pt>
                <c:pt idx="78">
                  <c:v>0.157</c:v>
                </c:pt>
                <c:pt idx="79">
                  <c:v>0.1595</c:v>
                </c:pt>
                <c:pt idx="80">
                  <c:v>0.1598</c:v>
                </c:pt>
                <c:pt idx="81">
                  <c:v>0.16589999999999999</c:v>
                </c:pt>
                <c:pt idx="82">
                  <c:v>0.16320000000000001</c:v>
                </c:pt>
                <c:pt idx="83">
                  <c:v>0.16700000000000001</c:v>
                </c:pt>
                <c:pt idx="84">
                  <c:v>0.1739</c:v>
                </c:pt>
                <c:pt idx="85">
                  <c:v>0.1862</c:v>
                </c:pt>
                <c:pt idx="86">
                  <c:v>0.17560000000000001</c:v>
                </c:pt>
                <c:pt idx="87">
                  <c:v>0.19969999999999999</c:v>
                </c:pt>
                <c:pt idx="88">
                  <c:v>0.20710000000000001</c:v>
                </c:pt>
                <c:pt idx="89">
                  <c:v>0.20649999999999999</c:v>
                </c:pt>
                <c:pt idx="90">
                  <c:v>0.2014</c:v>
                </c:pt>
                <c:pt idx="91">
                  <c:v>0.18429999999999999</c:v>
                </c:pt>
                <c:pt idx="92">
                  <c:v>0.17169999999999999</c:v>
                </c:pt>
                <c:pt idx="93">
                  <c:v>0.16569999999999999</c:v>
                </c:pt>
                <c:pt idx="94">
                  <c:v>0.16800000000000001</c:v>
                </c:pt>
                <c:pt idx="95">
                  <c:v>0.1623</c:v>
                </c:pt>
                <c:pt idx="96">
                  <c:v>0.15490000000000001</c:v>
                </c:pt>
                <c:pt idx="97">
                  <c:v>0.1646</c:v>
                </c:pt>
                <c:pt idx="98">
                  <c:v>0.1704</c:v>
                </c:pt>
                <c:pt idx="99">
                  <c:v>0.15920000000000001</c:v>
                </c:pt>
                <c:pt idx="100">
                  <c:v>0.1583</c:v>
                </c:pt>
                <c:pt idx="101">
                  <c:v>0.1739</c:v>
                </c:pt>
                <c:pt idx="102">
                  <c:v>0.16880000000000001</c:v>
                </c:pt>
                <c:pt idx="103">
                  <c:v>0.15920000000000001</c:v>
                </c:pt>
                <c:pt idx="104">
                  <c:v>0.19020000000000001</c:v>
                </c:pt>
                <c:pt idx="105">
                  <c:v>0.21210000000000001</c:v>
                </c:pt>
                <c:pt idx="106">
                  <c:v>0.2571</c:v>
                </c:pt>
                <c:pt idx="107">
                  <c:v>0.2833</c:v>
                </c:pt>
                <c:pt idx="108">
                  <c:v>0.29759999999999998</c:v>
                </c:pt>
                <c:pt idx="109">
                  <c:v>0.50839999999999996</c:v>
                </c:pt>
                <c:pt idx="110">
                  <c:v>0.52759999999999996</c:v>
                </c:pt>
                <c:pt idx="111">
                  <c:v>0.50160000000000005</c:v>
                </c:pt>
                <c:pt idx="112">
                  <c:v>0.37240000000000001</c:v>
                </c:pt>
                <c:pt idx="113">
                  <c:v>0.40889999999999999</c:v>
                </c:pt>
                <c:pt idx="114">
                  <c:v>0.50719999999999998</c:v>
                </c:pt>
                <c:pt idx="115">
                  <c:v>0.49519999999999997</c:v>
                </c:pt>
                <c:pt idx="116">
                  <c:v>0.46329999999999999</c:v>
                </c:pt>
                <c:pt idx="117">
                  <c:v>0.39610000000000001</c:v>
                </c:pt>
                <c:pt idx="118">
                  <c:v>0.41139999999999999</c:v>
                </c:pt>
                <c:pt idx="119">
                  <c:v>0.35410000000000003</c:v>
                </c:pt>
                <c:pt idx="120">
                  <c:v>0.28289999999999998</c:v>
                </c:pt>
                <c:pt idx="121">
                  <c:v>0.27010000000000001</c:v>
                </c:pt>
                <c:pt idx="122">
                  <c:v>0.28399999999999997</c:v>
                </c:pt>
                <c:pt idx="123">
                  <c:v>0.28039999999999998</c:v>
                </c:pt>
                <c:pt idx="124">
                  <c:v>0.34949999999999998</c:v>
                </c:pt>
                <c:pt idx="125">
                  <c:v>0.41199999999999998</c:v>
                </c:pt>
                <c:pt idx="126">
                  <c:v>0.36470000000000002</c:v>
                </c:pt>
                <c:pt idx="127">
                  <c:v>0.42099999999999999</c:v>
                </c:pt>
                <c:pt idx="128">
                  <c:v>0.33289999999999997</c:v>
                </c:pt>
                <c:pt idx="129">
                  <c:v>0.36859999999999998</c:v>
                </c:pt>
                <c:pt idx="130">
                  <c:v>0.51970000000000005</c:v>
                </c:pt>
                <c:pt idx="131">
                  <c:v>0.50460000000000005</c:v>
                </c:pt>
                <c:pt idx="132">
                  <c:v>0.434</c:v>
                </c:pt>
                <c:pt idx="133">
                  <c:v>0.6159</c:v>
                </c:pt>
                <c:pt idx="134">
                  <c:v>0.71640000000000004</c:v>
                </c:pt>
                <c:pt idx="135">
                  <c:v>0.64500000000000002</c:v>
                </c:pt>
                <c:pt idx="136">
                  <c:v>0.72119999999999995</c:v>
                </c:pt>
                <c:pt idx="137">
                  <c:v>0.88029999999999997</c:v>
                </c:pt>
                <c:pt idx="138">
                  <c:v>0.89580000000000004</c:v>
                </c:pt>
                <c:pt idx="139">
                  <c:v>0.88529999999999998</c:v>
                </c:pt>
                <c:pt idx="140">
                  <c:v>1.0685</c:v>
                </c:pt>
                <c:pt idx="141">
                  <c:v>1.1977</c:v>
                </c:pt>
                <c:pt idx="142">
                  <c:v>1.2579</c:v>
                </c:pt>
                <c:pt idx="143">
                  <c:v>1.3399000000000001</c:v>
                </c:pt>
                <c:pt idx="144">
                  <c:v>1.4301999999999999</c:v>
                </c:pt>
                <c:pt idx="145">
                  <c:v>1.5169999999999999</c:v>
                </c:pt>
                <c:pt idx="146">
                  <c:v>1.5653999999999999</c:v>
                </c:pt>
                <c:pt idx="147">
                  <c:v>1.72</c:v>
                </c:pt>
                <c:pt idx="148">
                  <c:v>1.7864</c:v>
                </c:pt>
                <c:pt idx="149">
                  <c:v>1.8769</c:v>
                </c:pt>
                <c:pt idx="150">
                  <c:v>1.9910000000000001</c:v>
                </c:pt>
                <c:pt idx="151">
                  <c:v>2.0859000000000001</c:v>
                </c:pt>
                <c:pt idx="152">
                  <c:v>2.1959</c:v>
                </c:pt>
                <c:pt idx="153">
                  <c:v>2.2288000000000001</c:v>
                </c:pt>
                <c:pt idx="154">
                  <c:v>2.3445</c:v>
                </c:pt>
                <c:pt idx="155">
                  <c:v>2.3934000000000002</c:v>
                </c:pt>
                <c:pt idx="156">
                  <c:v>2.4948999999999999</c:v>
                </c:pt>
                <c:pt idx="157">
                  <c:v>2.6457999999999999</c:v>
                </c:pt>
                <c:pt idx="158">
                  <c:v>2.7570999999999999</c:v>
                </c:pt>
                <c:pt idx="159">
                  <c:v>2.8281999999999998</c:v>
                </c:pt>
                <c:pt idx="160">
                  <c:v>2.8885999999999998</c:v>
                </c:pt>
                <c:pt idx="161">
                  <c:v>3.0177999999999998</c:v>
                </c:pt>
                <c:pt idx="162">
                  <c:v>3.08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45F-4DAF-9000-A4DD7D002A4E}"/>
            </c:ext>
          </c:extLst>
        </c:ser>
        <c:ser>
          <c:idx val="3"/>
          <c:order val="3"/>
          <c:tx>
            <c:strRef>
              <c:f>Sheet1!$N$1</c:f>
              <c:strCache>
                <c:ptCount val="1"/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Sheet1!$J$2:$J$164</c:f>
              <c:numCache>
                <c:formatCode>General</c:formatCode>
                <c:ptCount val="163"/>
                <c:pt idx="0">
                  <c:v>851</c:v>
                </c:pt>
                <c:pt idx="1">
                  <c:v>852</c:v>
                </c:pt>
                <c:pt idx="2">
                  <c:v>853</c:v>
                </c:pt>
                <c:pt idx="3">
                  <c:v>854</c:v>
                </c:pt>
                <c:pt idx="4">
                  <c:v>855</c:v>
                </c:pt>
                <c:pt idx="5">
                  <c:v>856</c:v>
                </c:pt>
                <c:pt idx="6">
                  <c:v>857</c:v>
                </c:pt>
                <c:pt idx="7">
                  <c:v>858</c:v>
                </c:pt>
                <c:pt idx="8">
                  <c:v>859</c:v>
                </c:pt>
                <c:pt idx="9">
                  <c:v>860</c:v>
                </c:pt>
                <c:pt idx="10">
                  <c:v>861</c:v>
                </c:pt>
                <c:pt idx="11">
                  <c:v>862</c:v>
                </c:pt>
                <c:pt idx="12">
                  <c:v>863</c:v>
                </c:pt>
                <c:pt idx="13">
                  <c:v>864</c:v>
                </c:pt>
                <c:pt idx="14">
                  <c:v>865</c:v>
                </c:pt>
                <c:pt idx="15">
                  <c:v>866</c:v>
                </c:pt>
                <c:pt idx="16">
                  <c:v>867</c:v>
                </c:pt>
                <c:pt idx="17">
                  <c:v>868</c:v>
                </c:pt>
                <c:pt idx="18">
                  <c:v>869</c:v>
                </c:pt>
                <c:pt idx="19">
                  <c:v>870</c:v>
                </c:pt>
                <c:pt idx="20">
                  <c:v>871</c:v>
                </c:pt>
                <c:pt idx="21">
                  <c:v>872</c:v>
                </c:pt>
                <c:pt idx="22">
                  <c:v>873</c:v>
                </c:pt>
                <c:pt idx="23">
                  <c:v>874</c:v>
                </c:pt>
                <c:pt idx="24">
                  <c:v>875</c:v>
                </c:pt>
                <c:pt idx="25">
                  <c:v>876</c:v>
                </c:pt>
                <c:pt idx="26">
                  <c:v>877</c:v>
                </c:pt>
                <c:pt idx="27">
                  <c:v>878</c:v>
                </c:pt>
                <c:pt idx="28">
                  <c:v>879</c:v>
                </c:pt>
                <c:pt idx="29">
                  <c:v>880</c:v>
                </c:pt>
                <c:pt idx="30">
                  <c:v>881</c:v>
                </c:pt>
                <c:pt idx="31">
                  <c:v>882</c:v>
                </c:pt>
                <c:pt idx="32">
                  <c:v>883</c:v>
                </c:pt>
                <c:pt idx="33">
                  <c:v>884</c:v>
                </c:pt>
                <c:pt idx="34">
                  <c:v>885</c:v>
                </c:pt>
                <c:pt idx="35">
                  <c:v>886</c:v>
                </c:pt>
                <c:pt idx="36">
                  <c:v>887</c:v>
                </c:pt>
                <c:pt idx="37">
                  <c:v>888</c:v>
                </c:pt>
                <c:pt idx="38">
                  <c:v>889</c:v>
                </c:pt>
                <c:pt idx="39">
                  <c:v>890</c:v>
                </c:pt>
                <c:pt idx="40">
                  <c:v>891</c:v>
                </c:pt>
                <c:pt idx="41">
                  <c:v>892</c:v>
                </c:pt>
                <c:pt idx="42">
                  <c:v>893</c:v>
                </c:pt>
                <c:pt idx="43">
                  <c:v>894</c:v>
                </c:pt>
                <c:pt idx="44">
                  <c:v>895</c:v>
                </c:pt>
                <c:pt idx="45">
                  <c:v>896</c:v>
                </c:pt>
                <c:pt idx="46">
                  <c:v>897</c:v>
                </c:pt>
                <c:pt idx="47">
                  <c:v>898</c:v>
                </c:pt>
                <c:pt idx="48">
                  <c:v>899</c:v>
                </c:pt>
                <c:pt idx="49">
                  <c:v>900</c:v>
                </c:pt>
                <c:pt idx="50">
                  <c:v>901</c:v>
                </c:pt>
                <c:pt idx="51">
                  <c:v>902</c:v>
                </c:pt>
                <c:pt idx="52">
                  <c:v>903</c:v>
                </c:pt>
                <c:pt idx="53">
                  <c:v>904</c:v>
                </c:pt>
                <c:pt idx="54">
                  <c:v>905</c:v>
                </c:pt>
                <c:pt idx="55">
                  <c:v>906</c:v>
                </c:pt>
                <c:pt idx="56">
                  <c:v>907</c:v>
                </c:pt>
                <c:pt idx="57">
                  <c:v>908</c:v>
                </c:pt>
                <c:pt idx="58">
                  <c:v>909</c:v>
                </c:pt>
                <c:pt idx="59">
                  <c:v>910</c:v>
                </c:pt>
                <c:pt idx="60">
                  <c:v>911</c:v>
                </c:pt>
                <c:pt idx="61">
                  <c:v>912</c:v>
                </c:pt>
                <c:pt idx="62">
                  <c:v>913</c:v>
                </c:pt>
                <c:pt idx="63">
                  <c:v>914</c:v>
                </c:pt>
                <c:pt idx="64">
                  <c:v>915</c:v>
                </c:pt>
                <c:pt idx="65">
                  <c:v>916</c:v>
                </c:pt>
                <c:pt idx="66">
                  <c:v>917</c:v>
                </c:pt>
                <c:pt idx="67">
                  <c:v>918</c:v>
                </c:pt>
                <c:pt idx="68">
                  <c:v>919</c:v>
                </c:pt>
                <c:pt idx="69">
                  <c:v>920</c:v>
                </c:pt>
                <c:pt idx="70">
                  <c:v>921</c:v>
                </c:pt>
                <c:pt idx="71">
                  <c:v>922</c:v>
                </c:pt>
                <c:pt idx="72">
                  <c:v>923</c:v>
                </c:pt>
                <c:pt idx="73">
                  <c:v>924</c:v>
                </c:pt>
                <c:pt idx="74">
                  <c:v>925</c:v>
                </c:pt>
                <c:pt idx="75">
                  <c:v>926</c:v>
                </c:pt>
                <c:pt idx="76">
                  <c:v>927</c:v>
                </c:pt>
                <c:pt idx="77">
                  <c:v>928</c:v>
                </c:pt>
                <c:pt idx="78">
                  <c:v>929</c:v>
                </c:pt>
                <c:pt idx="79">
                  <c:v>930</c:v>
                </c:pt>
                <c:pt idx="80">
                  <c:v>931</c:v>
                </c:pt>
                <c:pt idx="81">
                  <c:v>932</c:v>
                </c:pt>
                <c:pt idx="82">
                  <c:v>933</c:v>
                </c:pt>
                <c:pt idx="83">
                  <c:v>934</c:v>
                </c:pt>
                <c:pt idx="84">
                  <c:v>935</c:v>
                </c:pt>
                <c:pt idx="85">
                  <c:v>936</c:v>
                </c:pt>
                <c:pt idx="86">
                  <c:v>937</c:v>
                </c:pt>
                <c:pt idx="87">
                  <c:v>938</c:v>
                </c:pt>
                <c:pt idx="88">
                  <c:v>939</c:v>
                </c:pt>
                <c:pt idx="89">
                  <c:v>940</c:v>
                </c:pt>
                <c:pt idx="90">
                  <c:v>941</c:v>
                </c:pt>
                <c:pt idx="91">
                  <c:v>942</c:v>
                </c:pt>
                <c:pt idx="92">
                  <c:v>943</c:v>
                </c:pt>
                <c:pt idx="93">
                  <c:v>944</c:v>
                </c:pt>
                <c:pt idx="94">
                  <c:v>945</c:v>
                </c:pt>
                <c:pt idx="95">
                  <c:v>946</c:v>
                </c:pt>
                <c:pt idx="96">
                  <c:v>947</c:v>
                </c:pt>
                <c:pt idx="97">
                  <c:v>948</c:v>
                </c:pt>
                <c:pt idx="98">
                  <c:v>949</c:v>
                </c:pt>
                <c:pt idx="99">
                  <c:v>950</c:v>
                </c:pt>
                <c:pt idx="100">
                  <c:v>951</c:v>
                </c:pt>
                <c:pt idx="101">
                  <c:v>952</c:v>
                </c:pt>
                <c:pt idx="102">
                  <c:v>953</c:v>
                </c:pt>
                <c:pt idx="103">
                  <c:v>954</c:v>
                </c:pt>
                <c:pt idx="104">
                  <c:v>955</c:v>
                </c:pt>
                <c:pt idx="105">
                  <c:v>956</c:v>
                </c:pt>
                <c:pt idx="106">
                  <c:v>957</c:v>
                </c:pt>
                <c:pt idx="107">
                  <c:v>958</c:v>
                </c:pt>
                <c:pt idx="108">
                  <c:v>959</c:v>
                </c:pt>
                <c:pt idx="109">
                  <c:v>960</c:v>
                </c:pt>
                <c:pt idx="110">
                  <c:v>961</c:v>
                </c:pt>
                <c:pt idx="111">
                  <c:v>962</c:v>
                </c:pt>
                <c:pt idx="112">
                  <c:v>963</c:v>
                </c:pt>
                <c:pt idx="113">
                  <c:v>964</c:v>
                </c:pt>
                <c:pt idx="114">
                  <c:v>965</c:v>
                </c:pt>
                <c:pt idx="115">
                  <c:v>966</c:v>
                </c:pt>
                <c:pt idx="116">
                  <c:v>967</c:v>
                </c:pt>
                <c:pt idx="117">
                  <c:v>968</c:v>
                </c:pt>
                <c:pt idx="118">
                  <c:v>969</c:v>
                </c:pt>
                <c:pt idx="119">
                  <c:v>970</c:v>
                </c:pt>
                <c:pt idx="120">
                  <c:v>971</c:v>
                </c:pt>
                <c:pt idx="121">
                  <c:v>972</c:v>
                </c:pt>
                <c:pt idx="122">
                  <c:v>973</c:v>
                </c:pt>
                <c:pt idx="123">
                  <c:v>974</c:v>
                </c:pt>
                <c:pt idx="124">
                  <c:v>975</c:v>
                </c:pt>
                <c:pt idx="125">
                  <c:v>976</c:v>
                </c:pt>
                <c:pt idx="126">
                  <c:v>977</c:v>
                </c:pt>
                <c:pt idx="127">
                  <c:v>978</c:v>
                </c:pt>
                <c:pt idx="128">
                  <c:v>979</c:v>
                </c:pt>
                <c:pt idx="129">
                  <c:v>980</c:v>
                </c:pt>
                <c:pt idx="130">
                  <c:v>981</c:v>
                </c:pt>
                <c:pt idx="131">
                  <c:v>982</c:v>
                </c:pt>
                <c:pt idx="132">
                  <c:v>983</c:v>
                </c:pt>
                <c:pt idx="133">
                  <c:v>984</c:v>
                </c:pt>
                <c:pt idx="134">
                  <c:v>985</c:v>
                </c:pt>
                <c:pt idx="135">
                  <c:v>986</c:v>
                </c:pt>
                <c:pt idx="136">
                  <c:v>987</c:v>
                </c:pt>
                <c:pt idx="137">
                  <c:v>988</c:v>
                </c:pt>
                <c:pt idx="138">
                  <c:v>989</c:v>
                </c:pt>
                <c:pt idx="139">
                  <c:v>990</c:v>
                </c:pt>
                <c:pt idx="140">
                  <c:v>991</c:v>
                </c:pt>
                <c:pt idx="141">
                  <c:v>992</c:v>
                </c:pt>
                <c:pt idx="142">
                  <c:v>993</c:v>
                </c:pt>
                <c:pt idx="143">
                  <c:v>994</c:v>
                </c:pt>
                <c:pt idx="144">
                  <c:v>995</c:v>
                </c:pt>
                <c:pt idx="145">
                  <c:v>996</c:v>
                </c:pt>
                <c:pt idx="146">
                  <c:v>997</c:v>
                </c:pt>
                <c:pt idx="147">
                  <c:v>998</c:v>
                </c:pt>
                <c:pt idx="148">
                  <c:v>999</c:v>
                </c:pt>
                <c:pt idx="149">
                  <c:v>1000</c:v>
                </c:pt>
                <c:pt idx="150">
                  <c:v>1001</c:v>
                </c:pt>
                <c:pt idx="151">
                  <c:v>1002</c:v>
                </c:pt>
                <c:pt idx="152">
                  <c:v>1003</c:v>
                </c:pt>
                <c:pt idx="153">
                  <c:v>1004</c:v>
                </c:pt>
                <c:pt idx="154">
                  <c:v>1005</c:v>
                </c:pt>
                <c:pt idx="155">
                  <c:v>1006</c:v>
                </c:pt>
                <c:pt idx="156">
                  <c:v>1007</c:v>
                </c:pt>
                <c:pt idx="157">
                  <c:v>1008</c:v>
                </c:pt>
                <c:pt idx="158">
                  <c:v>1009</c:v>
                </c:pt>
                <c:pt idx="159">
                  <c:v>1010</c:v>
                </c:pt>
                <c:pt idx="160">
                  <c:v>1011</c:v>
                </c:pt>
                <c:pt idx="161">
                  <c:v>1012</c:v>
                </c:pt>
                <c:pt idx="162">
                  <c:v>1013</c:v>
                </c:pt>
              </c:numCache>
            </c:numRef>
          </c:cat>
          <c:val>
            <c:numRef>
              <c:f>Sheet1!$N$2:$N$164</c:f>
              <c:numCache>
                <c:formatCode>General</c:formatCode>
                <c:ptCount val="16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45F-4DAF-9000-A4DD7D002A4E}"/>
            </c:ext>
          </c:extLst>
        </c:ser>
        <c:ser>
          <c:idx val="4"/>
          <c:order val="4"/>
          <c:tx>
            <c:strRef>
              <c:f>Sheet1!$O$1</c:f>
              <c:strCache>
                <c:ptCount val="1"/>
                <c:pt idx="0">
                  <c:v>Series4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Sheet1!$J$2:$J$164</c:f>
              <c:numCache>
                <c:formatCode>General</c:formatCode>
                <c:ptCount val="163"/>
                <c:pt idx="0">
                  <c:v>851</c:v>
                </c:pt>
                <c:pt idx="1">
                  <c:v>852</c:v>
                </c:pt>
                <c:pt idx="2">
                  <c:v>853</c:v>
                </c:pt>
                <c:pt idx="3">
                  <c:v>854</c:v>
                </c:pt>
                <c:pt idx="4">
                  <c:v>855</c:v>
                </c:pt>
                <c:pt idx="5">
                  <c:v>856</c:v>
                </c:pt>
                <c:pt idx="6">
                  <c:v>857</c:v>
                </c:pt>
                <c:pt idx="7">
                  <c:v>858</c:v>
                </c:pt>
                <c:pt idx="8">
                  <c:v>859</c:v>
                </c:pt>
                <c:pt idx="9">
                  <c:v>860</c:v>
                </c:pt>
                <c:pt idx="10">
                  <c:v>861</c:v>
                </c:pt>
                <c:pt idx="11">
                  <c:v>862</c:v>
                </c:pt>
                <c:pt idx="12">
                  <c:v>863</c:v>
                </c:pt>
                <c:pt idx="13">
                  <c:v>864</c:v>
                </c:pt>
                <c:pt idx="14">
                  <c:v>865</c:v>
                </c:pt>
                <c:pt idx="15">
                  <c:v>866</c:v>
                </c:pt>
                <c:pt idx="16">
                  <c:v>867</c:v>
                </c:pt>
                <c:pt idx="17">
                  <c:v>868</c:v>
                </c:pt>
                <c:pt idx="18">
                  <c:v>869</c:v>
                </c:pt>
                <c:pt idx="19">
                  <c:v>870</c:v>
                </c:pt>
                <c:pt idx="20">
                  <c:v>871</c:v>
                </c:pt>
                <c:pt idx="21">
                  <c:v>872</c:v>
                </c:pt>
                <c:pt idx="22">
                  <c:v>873</c:v>
                </c:pt>
                <c:pt idx="23">
                  <c:v>874</c:v>
                </c:pt>
                <c:pt idx="24">
                  <c:v>875</c:v>
                </c:pt>
                <c:pt idx="25">
                  <c:v>876</c:v>
                </c:pt>
                <c:pt idx="26">
                  <c:v>877</c:v>
                </c:pt>
                <c:pt idx="27">
                  <c:v>878</c:v>
                </c:pt>
                <c:pt idx="28">
                  <c:v>879</c:v>
                </c:pt>
                <c:pt idx="29">
                  <c:v>880</c:v>
                </c:pt>
                <c:pt idx="30">
                  <c:v>881</c:v>
                </c:pt>
                <c:pt idx="31">
                  <c:v>882</c:v>
                </c:pt>
                <c:pt idx="32">
                  <c:v>883</c:v>
                </c:pt>
                <c:pt idx="33">
                  <c:v>884</c:v>
                </c:pt>
                <c:pt idx="34">
                  <c:v>885</c:v>
                </c:pt>
                <c:pt idx="35">
                  <c:v>886</c:v>
                </c:pt>
                <c:pt idx="36">
                  <c:v>887</c:v>
                </c:pt>
                <c:pt idx="37">
                  <c:v>888</c:v>
                </c:pt>
                <c:pt idx="38">
                  <c:v>889</c:v>
                </c:pt>
                <c:pt idx="39">
                  <c:v>890</c:v>
                </c:pt>
                <c:pt idx="40">
                  <c:v>891</c:v>
                </c:pt>
                <c:pt idx="41">
                  <c:v>892</c:v>
                </c:pt>
                <c:pt idx="42">
                  <c:v>893</c:v>
                </c:pt>
                <c:pt idx="43">
                  <c:v>894</c:v>
                </c:pt>
                <c:pt idx="44">
                  <c:v>895</c:v>
                </c:pt>
                <c:pt idx="45">
                  <c:v>896</c:v>
                </c:pt>
                <c:pt idx="46">
                  <c:v>897</c:v>
                </c:pt>
                <c:pt idx="47">
                  <c:v>898</c:v>
                </c:pt>
                <c:pt idx="48">
                  <c:v>899</c:v>
                </c:pt>
                <c:pt idx="49">
                  <c:v>900</c:v>
                </c:pt>
                <c:pt idx="50">
                  <c:v>901</c:v>
                </c:pt>
                <c:pt idx="51">
                  <c:v>902</c:v>
                </c:pt>
                <c:pt idx="52">
                  <c:v>903</c:v>
                </c:pt>
                <c:pt idx="53">
                  <c:v>904</c:v>
                </c:pt>
                <c:pt idx="54">
                  <c:v>905</c:v>
                </c:pt>
                <c:pt idx="55">
                  <c:v>906</c:v>
                </c:pt>
                <c:pt idx="56">
                  <c:v>907</c:v>
                </c:pt>
                <c:pt idx="57">
                  <c:v>908</c:v>
                </c:pt>
                <c:pt idx="58">
                  <c:v>909</c:v>
                </c:pt>
                <c:pt idx="59">
                  <c:v>910</c:v>
                </c:pt>
                <c:pt idx="60">
                  <c:v>911</c:v>
                </c:pt>
                <c:pt idx="61">
                  <c:v>912</c:v>
                </c:pt>
                <c:pt idx="62">
                  <c:v>913</c:v>
                </c:pt>
                <c:pt idx="63">
                  <c:v>914</c:v>
                </c:pt>
                <c:pt idx="64">
                  <c:v>915</c:v>
                </c:pt>
                <c:pt idx="65">
                  <c:v>916</c:v>
                </c:pt>
                <c:pt idx="66">
                  <c:v>917</c:v>
                </c:pt>
                <c:pt idx="67">
                  <c:v>918</c:v>
                </c:pt>
                <c:pt idx="68">
                  <c:v>919</c:v>
                </c:pt>
                <c:pt idx="69">
                  <c:v>920</c:v>
                </c:pt>
                <c:pt idx="70">
                  <c:v>921</c:v>
                </c:pt>
                <c:pt idx="71">
                  <c:v>922</c:v>
                </c:pt>
                <c:pt idx="72">
                  <c:v>923</c:v>
                </c:pt>
                <c:pt idx="73">
                  <c:v>924</c:v>
                </c:pt>
                <c:pt idx="74">
                  <c:v>925</c:v>
                </c:pt>
                <c:pt idx="75">
                  <c:v>926</c:v>
                </c:pt>
                <c:pt idx="76">
                  <c:v>927</c:v>
                </c:pt>
                <c:pt idx="77">
                  <c:v>928</c:v>
                </c:pt>
                <c:pt idx="78">
                  <c:v>929</c:v>
                </c:pt>
                <c:pt idx="79">
                  <c:v>930</c:v>
                </c:pt>
                <c:pt idx="80">
                  <c:v>931</c:v>
                </c:pt>
                <c:pt idx="81">
                  <c:v>932</c:v>
                </c:pt>
                <c:pt idx="82">
                  <c:v>933</c:v>
                </c:pt>
                <c:pt idx="83">
                  <c:v>934</c:v>
                </c:pt>
                <c:pt idx="84">
                  <c:v>935</c:v>
                </c:pt>
                <c:pt idx="85">
                  <c:v>936</c:v>
                </c:pt>
                <c:pt idx="86">
                  <c:v>937</c:v>
                </c:pt>
                <c:pt idx="87">
                  <c:v>938</c:v>
                </c:pt>
                <c:pt idx="88">
                  <c:v>939</c:v>
                </c:pt>
                <c:pt idx="89">
                  <c:v>940</c:v>
                </c:pt>
                <c:pt idx="90">
                  <c:v>941</c:v>
                </c:pt>
                <c:pt idx="91">
                  <c:v>942</c:v>
                </c:pt>
                <c:pt idx="92">
                  <c:v>943</c:v>
                </c:pt>
                <c:pt idx="93">
                  <c:v>944</c:v>
                </c:pt>
                <c:pt idx="94">
                  <c:v>945</c:v>
                </c:pt>
                <c:pt idx="95">
                  <c:v>946</c:v>
                </c:pt>
                <c:pt idx="96">
                  <c:v>947</c:v>
                </c:pt>
                <c:pt idx="97">
                  <c:v>948</c:v>
                </c:pt>
                <c:pt idx="98">
                  <c:v>949</c:v>
                </c:pt>
                <c:pt idx="99">
                  <c:v>950</c:v>
                </c:pt>
                <c:pt idx="100">
                  <c:v>951</c:v>
                </c:pt>
                <c:pt idx="101">
                  <c:v>952</c:v>
                </c:pt>
                <c:pt idx="102">
                  <c:v>953</c:v>
                </c:pt>
                <c:pt idx="103">
                  <c:v>954</c:v>
                </c:pt>
                <c:pt idx="104">
                  <c:v>955</c:v>
                </c:pt>
                <c:pt idx="105">
                  <c:v>956</c:v>
                </c:pt>
                <c:pt idx="106">
                  <c:v>957</c:v>
                </c:pt>
                <c:pt idx="107">
                  <c:v>958</c:v>
                </c:pt>
                <c:pt idx="108">
                  <c:v>959</c:v>
                </c:pt>
                <c:pt idx="109">
                  <c:v>960</c:v>
                </c:pt>
                <c:pt idx="110">
                  <c:v>961</c:v>
                </c:pt>
                <c:pt idx="111">
                  <c:v>962</c:v>
                </c:pt>
                <c:pt idx="112">
                  <c:v>963</c:v>
                </c:pt>
                <c:pt idx="113">
                  <c:v>964</c:v>
                </c:pt>
                <c:pt idx="114">
                  <c:v>965</c:v>
                </c:pt>
                <c:pt idx="115">
                  <c:v>966</c:v>
                </c:pt>
                <c:pt idx="116">
                  <c:v>967</c:v>
                </c:pt>
                <c:pt idx="117">
                  <c:v>968</c:v>
                </c:pt>
                <c:pt idx="118">
                  <c:v>969</c:v>
                </c:pt>
                <c:pt idx="119">
                  <c:v>970</c:v>
                </c:pt>
                <c:pt idx="120">
                  <c:v>971</c:v>
                </c:pt>
                <c:pt idx="121">
                  <c:v>972</c:v>
                </c:pt>
                <c:pt idx="122">
                  <c:v>973</c:v>
                </c:pt>
                <c:pt idx="123">
                  <c:v>974</c:v>
                </c:pt>
                <c:pt idx="124">
                  <c:v>975</c:v>
                </c:pt>
                <c:pt idx="125">
                  <c:v>976</c:v>
                </c:pt>
                <c:pt idx="126">
                  <c:v>977</c:v>
                </c:pt>
                <c:pt idx="127">
                  <c:v>978</c:v>
                </c:pt>
                <c:pt idx="128">
                  <c:v>979</c:v>
                </c:pt>
                <c:pt idx="129">
                  <c:v>980</c:v>
                </c:pt>
                <c:pt idx="130">
                  <c:v>981</c:v>
                </c:pt>
                <c:pt idx="131">
                  <c:v>982</c:v>
                </c:pt>
                <c:pt idx="132">
                  <c:v>983</c:v>
                </c:pt>
                <c:pt idx="133">
                  <c:v>984</c:v>
                </c:pt>
                <c:pt idx="134">
                  <c:v>985</c:v>
                </c:pt>
                <c:pt idx="135">
                  <c:v>986</c:v>
                </c:pt>
                <c:pt idx="136">
                  <c:v>987</c:v>
                </c:pt>
                <c:pt idx="137">
                  <c:v>988</c:v>
                </c:pt>
                <c:pt idx="138">
                  <c:v>989</c:v>
                </c:pt>
                <c:pt idx="139">
                  <c:v>990</c:v>
                </c:pt>
                <c:pt idx="140">
                  <c:v>991</c:v>
                </c:pt>
                <c:pt idx="141">
                  <c:v>992</c:v>
                </c:pt>
                <c:pt idx="142">
                  <c:v>993</c:v>
                </c:pt>
                <c:pt idx="143">
                  <c:v>994</c:v>
                </c:pt>
                <c:pt idx="144">
                  <c:v>995</c:v>
                </c:pt>
                <c:pt idx="145">
                  <c:v>996</c:v>
                </c:pt>
                <c:pt idx="146">
                  <c:v>997</c:v>
                </c:pt>
                <c:pt idx="147">
                  <c:v>998</c:v>
                </c:pt>
                <c:pt idx="148">
                  <c:v>999</c:v>
                </c:pt>
                <c:pt idx="149">
                  <c:v>1000</c:v>
                </c:pt>
                <c:pt idx="150">
                  <c:v>1001</c:v>
                </c:pt>
                <c:pt idx="151">
                  <c:v>1002</c:v>
                </c:pt>
                <c:pt idx="152">
                  <c:v>1003</c:v>
                </c:pt>
                <c:pt idx="153">
                  <c:v>1004</c:v>
                </c:pt>
                <c:pt idx="154">
                  <c:v>1005</c:v>
                </c:pt>
                <c:pt idx="155">
                  <c:v>1006</c:v>
                </c:pt>
                <c:pt idx="156">
                  <c:v>1007</c:v>
                </c:pt>
                <c:pt idx="157">
                  <c:v>1008</c:v>
                </c:pt>
                <c:pt idx="158">
                  <c:v>1009</c:v>
                </c:pt>
                <c:pt idx="159">
                  <c:v>1010</c:v>
                </c:pt>
                <c:pt idx="160">
                  <c:v>1011</c:v>
                </c:pt>
                <c:pt idx="161">
                  <c:v>1012</c:v>
                </c:pt>
                <c:pt idx="162">
                  <c:v>1013</c:v>
                </c:pt>
              </c:numCache>
            </c:numRef>
          </c:cat>
          <c:val>
            <c:numRef>
              <c:f>Sheet1!$O$2:$O$164</c:f>
              <c:numCache>
                <c:formatCode>General</c:formatCode>
                <c:ptCount val="163"/>
                <c:pt idx="0">
                  <c:v>0.15279999999999999</c:v>
                </c:pt>
                <c:pt idx="1">
                  <c:v>0.13780000000000001</c:v>
                </c:pt>
                <c:pt idx="2">
                  <c:v>0.15570000000000001</c:v>
                </c:pt>
                <c:pt idx="3">
                  <c:v>0.1729</c:v>
                </c:pt>
                <c:pt idx="4">
                  <c:v>0.15840000000000001</c:v>
                </c:pt>
                <c:pt idx="5">
                  <c:v>0.151</c:v>
                </c:pt>
                <c:pt idx="6">
                  <c:v>0.1807</c:v>
                </c:pt>
                <c:pt idx="7">
                  <c:v>0.188</c:v>
                </c:pt>
                <c:pt idx="8">
                  <c:v>0.16450000000000001</c:v>
                </c:pt>
                <c:pt idx="9">
                  <c:v>0.16539999999999999</c:v>
                </c:pt>
                <c:pt idx="10">
                  <c:v>0.1958</c:v>
                </c:pt>
                <c:pt idx="11">
                  <c:v>0.19259999999999999</c:v>
                </c:pt>
                <c:pt idx="12">
                  <c:v>0.1739</c:v>
                </c:pt>
                <c:pt idx="13">
                  <c:v>0.188</c:v>
                </c:pt>
                <c:pt idx="14">
                  <c:v>0.18990000000000001</c:v>
                </c:pt>
                <c:pt idx="15">
                  <c:v>0.18740000000000001</c:v>
                </c:pt>
                <c:pt idx="16">
                  <c:v>0.2452</c:v>
                </c:pt>
                <c:pt idx="17">
                  <c:v>0.28889999999999999</c:v>
                </c:pt>
                <c:pt idx="18">
                  <c:v>0.33929999999999999</c:v>
                </c:pt>
                <c:pt idx="19">
                  <c:v>0.4279</c:v>
                </c:pt>
                <c:pt idx="20">
                  <c:v>0.44280000000000003</c:v>
                </c:pt>
                <c:pt idx="21">
                  <c:v>0.4819</c:v>
                </c:pt>
                <c:pt idx="22">
                  <c:v>0.54869999999999997</c:v>
                </c:pt>
                <c:pt idx="23">
                  <c:v>0.66520000000000001</c:v>
                </c:pt>
                <c:pt idx="24">
                  <c:v>0.74739999999999995</c:v>
                </c:pt>
                <c:pt idx="25">
                  <c:v>0.79349999999999998</c:v>
                </c:pt>
                <c:pt idx="26">
                  <c:v>0.8851</c:v>
                </c:pt>
                <c:pt idx="27">
                  <c:v>0.85029999999999994</c:v>
                </c:pt>
                <c:pt idx="28">
                  <c:v>0.98470000000000002</c:v>
                </c:pt>
                <c:pt idx="29">
                  <c:v>1.0325</c:v>
                </c:pt>
                <c:pt idx="30">
                  <c:v>0.93959999999999999</c:v>
                </c:pt>
                <c:pt idx="31">
                  <c:v>0.98960000000000004</c:v>
                </c:pt>
                <c:pt idx="32">
                  <c:v>0.91020000000000001</c:v>
                </c:pt>
                <c:pt idx="33">
                  <c:v>0.82150000000000001</c:v>
                </c:pt>
                <c:pt idx="34">
                  <c:v>0.70220000000000005</c:v>
                </c:pt>
                <c:pt idx="35">
                  <c:v>0.53400000000000003</c:v>
                </c:pt>
                <c:pt idx="36">
                  <c:v>0.38419999999999999</c:v>
                </c:pt>
                <c:pt idx="37">
                  <c:v>0.28120000000000001</c:v>
                </c:pt>
                <c:pt idx="38">
                  <c:v>0.21410000000000001</c:v>
                </c:pt>
                <c:pt idx="39">
                  <c:v>0.21190000000000001</c:v>
                </c:pt>
                <c:pt idx="40">
                  <c:v>0.16930000000000001</c:v>
                </c:pt>
                <c:pt idx="41">
                  <c:v>0.1701</c:v>
                </c:pt>
                <c:pt idx="42">
                  <c:v>0.1963</c:v>
                </c:pt>
                <c:pt idx="43">
                  <c:v>0.16850000000000001</c:v>
                </c:pt>
                <c:pt idx="44">
                  <c:v>0.19359999999999999</c:v>
                </c:pt>
                <c:pt idx="45">
                  <c:v>0.1804</c:v>
                </c:pt>
                <c:pt idx="46">
                  <c:v>0.20949999999999999</c:v>
                </c:pt>
                <c:pt idx="47">
                  <c:v>0.2155</c:v>
                </c:pt>
                <c:pt idx="48">
                  <c:v>0.2661</c:v>
                </c:pt>
                <c:pt idx="49">
                  <c:v>0.31530000000000002</c:v>
                </c:pt>
                <c:pt idx="50">
                  <c:v>0.41539999999999999</c:v>
                </c:pt>
                <c:pt idx="51">
                  <c:v>0.44019999999999998</c:v>
                </c:pt>
                <c:pt idx="52">
                  <c:v>0.56859999999999999</c:v>
                </c:pt>
                <c:pt idx="53">
                  <c:v>0.69699999999999995</c:v>
                </c:pt>
                <c:pt idx="54">
                  <c:v>0.76</c:v>
                </c:pt>
                <c:pt idx="55">
                  <c:v>0.63780000000000003</c:v>
                </c:pt>
                <c:pt idx="56">
                  <c:v>0.60309999999999997</c:v>
                </c:pt>
                <c:pt idx="57">
                  <c:v>0.48349999999999999</c:v>
                </c:pt>
                <c:pt idx="58">
                  <c:v>0.37869999999999998</c:v>
                </c:pt>
                <c:pt idx="59">
                  <c:v>0.28420000000000001</c:v>
                </c:pt>
                <c:pt idx="60">
                  <c:v>0.27150000000000002</c:v>
                </c:pt>
                <c:pt idx="61">
                  <c:v>0.3352</c:v>
                </c:pt>
                <c:pt idx="62">
                  <c:v>0.44319999999999998</c:v>
                </c:pt>
                <c:pt idx="63">
                  <c:v>0.5181</c:v>
                </c:pt>
                <c:pt idx="64">
                  <c:v>0.70020000000000004</c:v>
                </c:pt>
                <c:pt idx="65">
                  <c:v>0.80549999999999999</c:v>
                </c:pt>
                <c:pt idx="66">
                  <c:v>0.73619999999999997</c:v>
                </c:pt>
                <c:pt idx="67">
                  <c:v>0.73129999999999995</c:v>
                </c:pt>
                <c:pt idx="68">
                  <c:v>0.85140000000000005</c:v>
                </c:pt>
                <c:pt idx="69">
                  <c:v>1.0033000000000001</c:v>
                </c:pt>
                <c:pt idx="70">
                  <c:v>1.0164</c:v>
                </c:pt>
                <c:pt idx="71">
                  <c:v>1.0693999999999999</c:v>
                </c:pt>
                <c:pt idx="72">
                  <c:v>1.1778</c:v>
                </c:pt>
                <c:pt idx="73">
                  <c:v>1.2334000000000001</c:v>
                </c:pt>
                <c:pt idx="74">
                  <c:v>1.2716000000000001</c:v>
                </c:pt>
                <c:pt idx="75">
                  <c:v>1.2857000000000001</c:v>
                </c:pt>
                <c:pt idx="76">
                  <c:v>1.1508</c:v>
                </c:pt>
                <c:pt idx="77">
                  <c:v>0.99550000000000005</c:v>
                </c:pt>
                <c:pt idx="78">
                  <c:v>0.91539999999999999</c:v>
                </c:pt>
                <c:pt idx="79">
                  <c:v>0.76629999999999998</c:v>
                </c:pt>
                <c:pt idx="80">
                  <c:v>0.72260000000000002</c:v>
                </c:pt>
                <c:pt idx="81">
                  <c:v>0.63539999999999996</c:v>
                </c:pt>
                <c:pt idx="82">
                  <c:v>0.61829999999999996</c:v>
                </c:pt>
                <c:pt idx="83">
                  <c:v>0.63770000000000004</c:v>
                </c:pt>
                <c:pt idx="84">
                  <c:v>0.59489999999999998</c:v>
                </c:pt>
                <c:pt idx="85">
                  <c:v>0.58460000000000001</c:v>
                </c:pt>
                <c:pt idx="86">
                  <c:v>0.60119999999999996</c:v>
                </c:pt>
                <c:pt idx="87">
                  <c:v>0.71140000000000003</c:v>
                </c:pt>
                <c:pt idx="88">
                  <c:v>0.79239999999999999</c:v>
                </c:pt>
                <c:pt idx="89">
                  <c:v>0.85089999999999999</c:v>
                </c:pt>
                <c:pt idx="90">
                  <c:v>0.80620000000000003</c:v>
                </c:pt>
                <c:pt idx="91">
                  <c:v>0.80720000000000003</c:v>
                </c:pt>
                <c:pt idx="92">
                  <c:v>0.72560000000000002</c:v>
                </c:pt>
                <c:pt idx="93">
                  <c:v>0.75939999999999996</c:v>
                </c:pt>
                <c:pt idx="94">
                  <c:v>0.74429999999999996</c:v>
                </c:pt>
                <c:pt idx="95">
                  <c:v>0.62590000000000001</c:v>
                </c:pt>
                <c:pt idx="96">
                  <c:v>0.59330000000000005</c:v>
                </c:pt>
                <c:pt idx="97">
                  <c:v>0.65500000000000003</c:v>
                </c:pt>
                <c:pt idx="98">
                  <c:v>0.5837</c:v>
                </c:pt>
                <c:pt idx="99">
                  <c:v>0.4884</c:v>
                </c:pt>
                <c:pt idx="100">
                  <c:v>0.55569999999999997</c:v>
                </c:pt>
                <c:pt idx="101">
                  <c:v>0.59199999999999997</c:v>
                </c:pt>
                <c:pt idx="102">
                  <c:v>0.49680000000000002</c:v>
                </c:pt>
                <c:pt idx="103">
                  <c:v>0.50329999999999997</c:v>
                </c:pt>
                <c:pt idx="104">
                  <c:v>0.60470000000000002</c:v>
                </c:pt>
                <c:pt idx="105">
                  <c:v>0.58109999999999995</c:v>
                </c:pt>
                <c:pt idx="106">
                  <c:v>0.55059999999999998</c:v>
                </c:pt>
                <c:pt idx="107">
                  <c:v>0.66169999999999995</c:v>
                </c:pt>
                <c:pt idx="108">
                  <c:v>0.74260000000000004</c:v>
                </c:pt>
                <c:pt idx="109">
                  <c:v>0.83840000000000003</c:v>
                </c:pt>
                <c:pt idx="110">
                  <c:v>0.80569999999999997</c:v>
                </c:pt>
                <c:pt idx="111">
                  <c:v>0.89700000000000002</c:v>
                </c:pt>
                <c:pt idx="112">
                  <c:v>0.88600000000000001</c:v>
                </c:pt>
                <c:pt idx="113">
                  <c:v>0.78520000000000001</c:v>
                </c:pt>
                <c:pt idx="114">
                  <c:v>0.61309999999999998</c:v>
                </c:pt>
                <c:pt idx="115">
                  <c:v>0.63480000000000003</c:v>
                </c:pt>
                <c:pt idx="116">
                  <c:v>0.5776</c:v>
                </c:pt>
                <c:pt idx="117">
                  <c:v>0.67359999999999998</c:v>
                </c:pt>
                <c:pt idx="118">
                  <c:v>0.63419999999999999</c:v>
                </c:pt>
                <c:pt idx="119">
                  <c:v>0.62080000000000002</c:v>
                </c:pt>
                <c:pt idx="120">
                  <c:v>0.7177</c:v>
                </c:pt>
                <c:pt idx="121">
                  <c:v>0.70020000000000004</c:v>
                </c:pt>
                <c:pt idx="122">
                  <c:v>0.62980000000000003</c:v>
                </c:pt>
                <c:pt idx="123">
                  <c:v>0.52259999999999995</c:v>
                </c:pt>
                <c:pt idx="124">
                  <c:v>0.49440000000000001</c:v>
                </c:pt>
                <c:pt idx="125">
                  <c:v>0.50329999999999997</c:v>
                </c:pt>
                <c:pt idx="126">
                  <c:v>0.50090000000000001</c:v>
                </c:pt>
                <c:pt idx="127">
                  <c:v>0.46929999999999999</c:v>
                </c:pt>
                <c:pt idx="128">
                  <c:v>0.48559999999999998</c:v>
                </c:pt>
                <c:pt idx="129">
                  <c:v>0.55400000000000005</c:v>
                </c:pt>
                <c:pt idx="130">
                  <c:v>0.56200000000000006</c:v>
                </c:pt>
                <c:pt idx="131">
                  <c:v>0.58140000000000003</c:v>
                </c:pt>
                <c:pt idx="132">
                  <c:v>0.65790000000000004</c:v>
                </c:pt>
                <c:pt idx="133">
                  <c:v>0.7288</c:v>
                </c:pt>
                <c:pt idx="134">
                  <c:v>0.75870000000000004</c:v>
                </c:pt>
                <c:pt idx="135">
                  <c:v>0.82850000000000001</c:v>
                </c:pt>
                <c:pt idx="136">
                  <c:v>0.91869999999999996</c:v>
                </c:pt>
                <c:pt idx="137">
                  <c:v>0.97819999999999996</c:v>
                </c:pt>
                <c:pt idx="138">
                  <c:v>1.0406</c:v>
                </c:pt>
                <c:pt idx="139">
                  <c:v>1.0813999999999999</c:v>
                </c:pt>
                <c:pt idx="140">
                  <c:v>1.2145999999999999</c:v>
                </c:pt>
                <c:pt idx="141">
                  <c:v>1.3031999999999999</c:v>
                </c:pt>
                <c:pt idx="142">
                  <c:v>1.4158999999999999</c:v>
                </c:pt>
                <c:pt idx="143">
                  <c:v>1.5299</c:v>
                </c:pt>
                <c:pt idx="144">
                  <c:v>1.6238999999999999</c:v>
                </c:pt>
                <c:pt idx="145">
                  <c:v>1.732</c:v>
                </c:pt>
                <c:pt idx="146">
                  <c:v>1.8116000000000001</c:v>
                </c:pt>
                <c:pt idx="147">
                  <c:v>1.9970000000000001</c:v>
                </c:pt>
                <c:pt idx="148">
                  <c:v>2.0954999999999999</c:v>
                </c:pt>
                <c:pt idx="149">
                  <c:v>1.9975000000000001</c:v>
                </c:pt>
                <c:pt idx="150">
                  <c:v>1.9891000000000001</c:v>
                </c:pt>
                <c:pt idx="151">
                  <c:v>2.0512000000000001</c:v>
                </c:pt>
                <c:pt idx="152">
                  <c:v>2.1215000000000002</c:v>
                </c:pt>
                <c:pt idx="153">
                  <c:v>2.1897000000000002</c:v>
                </c:pt>
                <c:pt idx="154">
                  <c:v>2.2951000000000001</c:v>
                </c:pt>
                <c:pt idx="155">
                  <c:v>2.2572999999999999</c:v>
                </c:pt>
                <c:pt idx="156">
                  <c:v>2.4058999999999999</c:v>
                </c:pt>
                <c:pt idx="157">
                  <c:v>2.5261999999999998</c:v>
                </c:pt>
                <c:pt idx="158">
                  <c:v>2.4805000000000001</c:v>
                </c:pt>
                <c:pt idx="159">
                  <c:v>2.5985</c:v>
                </c:pt>
                <c:pt idx="160">
                  <c:v>2.7696999999999998</c:v>
                </c:pt>
                <c:pt idx="161">
                  <c:v>2.9186999999999999</c:v>
                </c:pt>
                <c:pt idx="162">
                  <c:v>3.0514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F45F-4DAF-9000-A4DD7D002A4E}"/>
            </c:ext>
          </c:extLst>
        </c:ser>
        <c:ser>
          <c:idx val="5"/>
          <c:order val="5"/>
          <c:tx>
            <c:strRef>
              <c:f>Sheet1!$P$1</c:f>
              <c:strCache>
                <c:ptCount val="1"/>
                <c:pt idx="0">
                  <c:v>Series5</c:v>
                </c:pt>
              </c:strCache>
            </c:strRef>
          </c:tx>
          <c:spPr>
            <a:ln w="19050" cap="rnd">
              <a:solidFill>
                <a:srgbClr val="FF9933"/>
              </a:solidFill>
              <a:round/>
            </a:ln>
            <a:effectLst/>
          </c:spPr>
          <c:marker>
            <c:symbol val="none"/>
          </c:marker>
          <c:cat>
            <c:numRef>
              <c:f>Sheet1!$J$2:$J$164</c:f>
              <c:numCache>
                <c:formatCode>General</c:formatCode>
                <c:ptCount val="163"/>
                <c:pt idx="0">
                  <c:v>851</c:v>
                </c:pt>
                <c:pt idx="1">
                  <c:v>852</c:v>
                </c:pt>
                <c:pt idx="2">
                  <c:v>853</c:v>
                </c:pt>
                <c:pt idx="3">
                  <c:v>854</c:v>
                </c:pt>
                <c:pt idx="4">
                  <c:v>855</c:v>
                </c:pt>
                <c:pt idx="5">
                  <c:v>856</c:v>
                </c:pt>
                <c:pt idx="6">
                  <c:v>857</c:v>
                </c:pt>
                <c:pt idx="7">
                  <c:v>858</c:v>
                </c:pt>
                <c:pt idx="8">
                  <c:v>859</c:v>
                </c:pt>
                <c:pt idx="9">
                  <c:v>860</c:v>
                </c:pt>
                <c:pt idx="10">
                  <c:v>861</c:v>
                </c:pt>
                <c:pt idx="11">
                  <c:v>862</c:v>
                </c:pt>
                <c:pt idx="12">
                  <c:v>863</c:v>
                </c:pt>
                <c:pt idx="13">
                  <c:v>864</c:v>
                </c:pt>
                <c:pt idx="14">
                  <c:v>865</c:v>
                </c:pt>
                <c:pt idx="15">
                  <c:v>866</c:v>
                </c:pt>
                <c:pt idx="16">
                  <c:v>867</c:v>
                </c:pt>
                <c:pt idx="17">
                  <c:v>868</c:v>
                </c:pt>
                <c:pt idx="18">
                  <c:v>869</c:v>
                </c:pt>
                <c:pt idx="19">
                  <c:v>870</c:v>
                </c:pt>
                <c:pt idx="20">
                  <c:v>871</c:v>
                </c:pt>
                <c:pt idx="21">
                  <c:v>872</c:v>
                </c:pt>
                <c:pt idx="22">
                  <c:v>873</c:v>
                </c:pt>
                <c:pt idx="23">
                  <c:v>874</c:v>
                </c:pt>
                <c:pt idx="24">
                  <c:v>875</c:v>
                </c:pt>
                <c:pt idx="25">
                  <c:v>876</c:v>
                </c:pt>
                <c:pt idx="26">
                  <c:v>877</c:v>
                </c:pt>
                <c:pt idx="27">
                  <c:v>878</c:v>
                </c:pt>
                <c:pt idx="28">
                  <c:v>879</c:v>
                </c:pt>
                <c:pt idx="29">
                  <c:v>880</c:v>
                </c:pt>
                <c:pt idx="30">
                  <c:v>881</c:v>
                </c:pt>
                <c:pt idx="31">
                  <c:v>882</c:v>
                </c:pt>
                <c:pt idx="32">
                  <c:v>883</c:v>
                </c:pt>
                <c:pt idx="33">
                  <c:v>884</c:v>
                </c:pt>
                <c:pt idx="34">
                  <c:v>885</c:v>
                </c:pt>
                <c:pt idx="35">
                  <c:v>886</c:v>
                </c:pt>
                <c:pt idx="36">
                  <c:v>887</c:v>
                </c:pt>
                <c:pt idx="37">
                  <c:v>888</c:v>
                </c:pt>
                <c:pt idx="38">
                  <c:v>889</c:v>
                </c:pt>
                <c:pt idx="39">
                  <c:v>890</c:v>
                </c:pt>
                <c:pt idx="40">
                  <c:v>891</c:v>
                </c:pt>
                <c:pt idx="41">
                  <c:v>892</c:v>
                </c:pt>
                <c:pt idx="42">
                  <c:v>893</c:v>
                </c:pt>
                <c:pt idx="43">
                  <c:v>894</c:v>
                </c:pt>
                <c:pt idx="44">
                  <c:v>895</c:v>
                </c:pt>
                <c:pt idx="45">
                  <c:v>896</c:v>
                </c:pt>
                <c:pt idx="46">
                  <c:v>897</c:v>
                </c:pt>
                <c:pt idx="47">
                  <c:v>898</c:v>
                </c:pt>
                <c:pt idx="48">
                  <c:v>899</c:v>
                </c:pt>
                <c:pt idx="49">
                  <c:v>900</c:v>
                </c:pt>
                <c:pt idx="50">
                  <c:v>901</c:v>
                </c:pt>
                <c:pt idx="51">
                  <c:v>902</c:v>
                </c:pt>
                <c:pt idx="52">
                  <c:v>903</c:v>
                </c:pt>
                <c:pt idx="53">
                  <c:v>904</c:v>
                </c:pt>
                <c:pt idx="54">
                  <c:v>905</c:v>
                </c:pt>
                <c:pt idx="55">
                  <c:v>906</c:v>
                </c:pt>
                <c:pt idx="56">
                  <c:v>907</c:v>
                </c:pt>
                <c:pt idx="57">
                  <c:v>908</c:v>
                </c:pt>
                <c:pt idx="58">
                  <c:v>909</c:v>
                </c:pt>
                <c:pt idx="59">
                  <c:v>910</c:v>
                </c:pt>
                <c:pt idx="60">
                  <c:v>911</c:v>
                </c:pt>
                <c:pt idx="61">
                  <c:v>912</c:v>
                </c:pt>
                <c:pt idx="62">
                  <c:v>913</c:v>
                </c:pt>
                <c:pt idx="63">
                  <c:v>914</c:v>
                </c:pt>
                <c:pt idx="64">
                  <c:v>915</c:v>
                </c:pt>
                <c:pt idx="65">
                  <c:v>916</c:v>
                </c:pt>
                <c:pt idx="66">
                  <c:v>917</c:v>
                </c:pt>
                <c:pt idx="67">
                  <c:v>918</c:v>
                </c:pt>
                <c:pt idx="68">
                  <c:v>919</c:v>
                </c:pt>
                <c:pt idx="69">
                  <c:v>920</c:v>
                </c:pt>
                <c:pt idx="70">
                  <c:v>921</c:v>
                </c:pt>
                <c:pt idx="71">
                  <c:v>922</c:v>
                </c:pt>
                <c:pt idx="72">
                  <c:v>923</c:v>
                </c:pt>
                <c:pt idx="73">
                  <c:v>924</c:v>
                </c:pt>
                <c:pt idx="74">
                  <c:v>925</c:v>
                </c:pt>
                <c:pt idx="75">
                  <c:v>926</c:v>
                </c:pt>
                <c:pt idx="76">
                  <c:v>927</c:v>
                </c:pt>
                <c:pt idx="77">
                  <c:v>928</c:v>
                </c:pt>
                <c:pt idx="78">
                  <c:v>929</c:v>
                </c:pt>
                <c:pt idx="79">
                  <c:v>930</c:v>
                </c:pt>
                <c:pt idx="80">
                  <c:v>931</c:v>
                </c:pt>
                <c:pt idx="81">
                  <c:v>932</c:v>
                </c:pt>
                <c:pt idx="82">
                  <c:v>933</c:v>
                </c:pt>
                <c:pt idx="83">
                  <c:v>934</c:v>
                </c:pt>
                <c:pt idx="84">
                  <c:v>935</c:v>
                </c:pt>
                <c:pt idx="85">
                  <c:v>936</c:v>
                </c:pt>
                <c:pt idx="86">
                  <c:v>937</c:v>
                </c:pt>
                <c:pt idx="87">
                  <c:v>938</c:v>
                </c:pt>
                <c:pt idx="88">
                  <c:v>939</c:v>
                </c:pt>
                <c:pt idx="89">
                  <c:v>940</c:v>
                </c:pt>
                <c:pt idx="90">
                  <c:v>941</c:v>
                </c:pt>
                <c:pt idx="91">
                  <c:v>942</c:v>
                </c:pt>
                <c:pt idx="92">
                  <c:v>943</c:v>
                </c:pt>
                <c:pt idx="93">
                  <c:v>944</c:v>
                </c:pt>
                <c:pt idx="94">
                  <c:v>945</c:v>
                </c:pt>
                <c:pt idx="95">
                  <c:v>946</c:v>
                </c:pt>
                <c:pt idx="96">
                  <c:v>947</c:v>
                </c:pt>
                <c:pt idx="97">
                  <c:v>948</c:v>
                </c:pt>
                <c:pt idx="98">
                  <c:v>949</c:v>
                </c:pt>
                <c:pt idx="99">
                  <c:v>950</c:v>
                </c:pt>
                <c:pt idx="100">
                  <c:v>951</c:v>
                </c:pt>
                <c:pt idx="101">
                  <c:v>952</c:v>
                </c:pt>
                <c:pt idx="102">
                  <c:v>953</c:v>
                </c:pt>
                <c:pt idx="103">
                  <c:v>954</c:v>
                </c:pt>
                <c:pt idx="104">
                  <c:v>955</c:v>
                </c:pt>
                <c:pt idx="105">
                  <c:v>956</c:v>
                </c:pt>
                <c:pt idx="106">
                  <c:v>957</c:v>
                </c:pt>
                <c:pt idx="107">
                  <c:v>958</c:v>
                </c:pt>
                <c:pt idx="108">
                  <c:v>959</c:v>
                </c:pt>
                <c:pt idx="109">
                  <c:v>960</c:v>
                </c:pt>
                <c:pt idx="110">
                  <c:v>961</c:v>
                </c:pt>
                <c:pt idx="111">
                  <c:v>962</c:v>
                </c:pt>
                <c:pt idx="112">
                  <c:v>963</c:v>
                </c:pt>
                <c:pt idx="113">
                  <c:v>964</c:v>
                </c:pt>
                <c:pt idx="114">
                  <c:v>965</c:v>
                </c:pt>
                <c:pt idx="115">
                  <c:v>966</c:v>
                </c:pt>
                <c:pt idx="116">
                  <c:v>967</c:v>
                </c:pt>
                <c:pt idx="117">
                  <c:v>968</c:v>
                </c:pt>
                <c:pt idx="118">
                  <c:v>969</c:v>
                </c:pt>
                <c:pt idx="119">
                  <c:v>970</c:v>
                </c:pt>
                <c:pt idx="120">
                  <c:v>971</c:v>
                </c:pt>
                <c:pt idx="121">
                  <c:v>972</c:v>
                </c:pt>
                <c:pt idx="122">
                  <c:v>973</c:v>
                </c:pt>
                <c:pt idx="123">
                  <c:v>974</c:v>
                </c:pt>
                <c:pt idx="124">
                  <c:v>975</c:v>
                </c:pt>
                <c:pt idx="125">
                  <c:v>976</c:v>
                </c:pt>
                <c:pt idx="126">
                  <c:v>977</c:v>
                </c:pt>
                <c:pt idx="127">
                  <c:v>978</c:v>
                </c:pt>
                <c:pt idx="128">
                  <c:v>979</c:v>
                </c:pt>
                <c:pt idx="129">
                  <c:v>980</c:v>
                </c:pt>
                <c:pt idx="130">
                  <c:v>981</c:v>
                </c:pt>
                <c:pt idx="131">
                  <c:v>982</c:v>
                </c:pt>
                <c:pt idx="132">
                  <c:v>983</c:v>
                </c:pt>
                <c:pt idx="133">
                  <c:v>984</c:v>
                </c:pt>
                <c:pt idx="134">
                  <c:v>985</c:v>
                </c:pt>
                <c:pt idx="135">
                  <c:v>986</c:v>
                </c:pt>
                <c:pt idx="136">
                  <c:v>987</c:v>
                </c:pt>
                <c:pt idx="137">
                  <c:v>988</c:v>
                </c:pt>
                <c:pt idx="138">
                  <c:v>989</c:v>
                </c:pt>
                <c:pt idx="139">
                  <c:v>990</c:v>
                </c:pt>
                <c:pt idx="140">
                  <c:v>991</c:v>
                </c:pt>
                <c:pt idx="141">
                  <c:v>992</c:v>
                </c:pt>
                <c:pt idx="142">
                  <c:v>993</c:v>
                </c:pt>
                <c:pt idx="143">
                  <c:v>994</c:v>
                </c:pt>
                <c:pt idx="144">
                  <c:v>995</c:v>
                </c:pt>
                <c:pt idx="145">
                  <c:v>996</c:v>
                </c:pt>
                <c:pt idx="146">
                  <c:v>997</c:v>
                </c:pt>
                <c:pt idx="147">
                  <c:v>998</c:v>
                </c:pt>
                <c:pt idx="148">
                  <c:v>999</c:v>
                </c:pt>
                <c:pt idx="149">
                  <c:v>1000</c:v>
                </c:pt>
                <c:pt idx="150">
                  <c:v>1001</c:v>
                </c:pt>
                <c:pt idx="151">
                  <c:v>1002</c:v>
                </c:pt>
                <c:pt idx="152">
                  <c:v>1003</c:v>
                </c:pt>
                <c:pt idx="153">
                  <c:v>1004</c:v>
                </c:pt>
                <c:pt idx="154">
                  <c:v>1005</c:v>
                </c:pt>
                <c:pt idx="155">
                  <c:v>1006</c:v>
                </c:pt>
                <c:pt idx="156">
                  <c:v>1007</c:v>
                </c:pt>
                <c:pt idx="157">
                  <c:v>1008</c:v>
                </c:pt>
                <c:pt idx="158">
                  <c:v>1009</c:v>
                </c:pt>
                <c:pt idx="159">
                  <c:v>1010</c:v>
                </c:pt>
                <c:pt idx="160">
                  <c:v>1011</c:v>
                </c:pt>
                <c:pt idx="161">
                  <c:v>1012</c:v>
                </c:pt>
                <c:pt idx="162">
                  <c:v>1013</c:v>
                </c:pt>
              </c:numCache>
            </c:numRef>
          </c:cat>
          <c:val>
            <c:numRef>
              <c:f>Sheet1!$P$2:$P$164</c:f>
              <c:numCache>
                <c:formatCode>General</c:formatCode>
                <c:ptCount val="163"/>
                <c:pt idx="0">
                  <c:v>0.2293</c:v>
                </c:pt>
                <c:pt idx="1">
                  <c:v>0.22140000000000001</c:v>
                </c:pt>
                <c:pt idx="2">
                  <c:v>0.24310000000000001</c:v>
                </c:pt>
                <c:pt idx="3">
                  <c:v>0.26679999999999998</c:v>
                </c:pt>
                <c:pt idx="4">
                  <c:v>0.26939999999999997</c:v>
                </c:pt>
                <c:pt idx="5">
                  <c:v>0.27229999999999999</c:v>
                </c:pt>
                <c:pt idx="6">
                  <c:v>0.29349999999999998</c:v>
                </c:pt>
                <c:pt idx="7">
                  <c:v>0.32740000000000002</c:v>
                </c:pt>
                <c:pt idx="8">
                  <c:v>0.32240000000000002</c:v>
                </c:pt>
                <c:pt idx="9">
                  <c:v>0.31209999999999999</c:v>
                </c:pt>
                <c:pt idx="10">
                  <c:v>0.34970000000000001</c:v>
                </c:pt>
                <c:pt idx="11">
                  <c:v>0.37340000000000001</c:v>
                </c:pt>
                <c:pt idx="12">
                  <c:v>0.3624</c:v>
                </c:pt>
                <c:pt idx="13">
                  <c:v>0.37440000000000001</c:v>
                </c:pt>
                <c:pt idx="14">
                  <c:v>0.38579999999999998</c:v>
                </c:pt>
                <c:pt idx="15">
                  <c:v>0.39410000000000001</c:v>
                </c:pt>
                <c:pt idx="16">
                  <c:v>0.43909999999999999</c:v>
                </c:pt>
                <c:pt idx="17">
                  <c:v>0.47860000000000003</c:v>
                </c:pt>
                <c:pt idx="18">
                  <c:v>0.51219999999999999</c:v>
                </c:pt>
                <c:pt idx="19">
                  <c:v>0.57930000000000004</c:v>
                </c:pt>
                <c:pt idx="20">
                  <c:v>0.56210000000000004</c:v>
                </c:pt>
                <c:pt idx="21">
                  <c:v>0.54039999999999999</c:v>
                </c:pt>
                <c:pt idx="22">
                  <c:v>0.61019999999999996</c:v>
                </c:pt>
                <c:pt idx="23">
                  <c:v>0.67400000000000004</c:v>
                </c:pt>
                <c:pt idx="24">
                  <c:v>0.6744</c:v>
                </c:pt>
                <c:pt idx="25">
                  <c:v>0.69110000000000005</c:v>
                </c:pt>
                <c:pt idx="26">
                  <c:v>0.78839999999999999</c:v>
                </c:pt>
                <c:pt idx="27">
                  <c:v>0.82679999999999998</c:v>
                </c:pt>
                <c:pt idx="28">
                  <c:v>0.86639999999999995</c:v>
                </c:pt>
                <c:pt idx="29">
                  <c:v>0.95499999999999996</c:v>
                </c:pt>
                <c:pt idx="30">
                  <c:v>0.94269999999999998</c:v>
                </c:pt>
                <c:pt idx="31">
                  <c:v>0.89059999999999995</c:v>
                </c:pt>
                <c:pt idx="32">
                  <c:v>0.87709999999999999</c:v>
                </c:pt>
                <c:pt idx="33">
                  <c:v>0.85609999999999997</c:v>
                </c:pt>
                <c:pt idx="34">
                  <c:v>0.8286</c:v>
                </c:pt>
                <c:pt idx="35">
                  <c:v>0.79430000000000001</c:v>
                </c:pt>
                <c:pt idx="36">
                  <c:v>0.76529999999999998</c:v>
                </c:pt>
                <c:pt idx="37">
                  <c:v>0.66859999999999997</c:v>
                </c:pt>
                <c:pt idx="38">
                  <c:v>0.53420000000000001</c:v>
                </c:pt>
                <c:pt idx="39">
                  <c:v>0.48249999999999998</c:v>
                </c:pt>
                <c:pt idx="40">
                  <c:v>0.39989999999999998</c:v>
                </c:pt>
                <c:pt idx="41">
                  <c:v>0.37980000000000003</c:v>
                </c:pt>
                <c:pt idx="42">
                  <c:v>0.41170000000000001</c:v>
                </c:pt>
                <c:pt idx="43">
                  <c:v>0.36199999999999999</c:v>
                </c:pt>
                <c:pt idx="44">
                  <c:v>0.36940000000000001</c:v>
                </c:pt>
                <c:pt idx="45">
                  <c:v>0.377</c:v>
                </c:pt>
                <c:pt idx="46">
                  <c:v>0.35599999999999998</c:v>
                </c:pt>
                <c:pt idx="47">
                  <c:v>0.39179999999999998</c:v>
                </c:pt>
                <c:pt idx="48">
                  <c:v>0.48</c:v>
                </c:pt>
                <c:pt idx="49">
                  <c:v>0.52800000000000002</c:v>
                </c:pt>
                <c:pt idx="50">
                  <c:v>0.56440000000000001</c:v>
                </c:pt>
                <c:pt idx="51">
                  <c:v>0.57720000000000005</c:v>
                </c:pt>
                <c:pt idx="52">
                  <c:v>0.59509999999999996</c:v>
                </c:pt>
                <c:pt idx="53">
                  <c:v>0.60829999999999995</c:v>
                </c:pt>
                <c:pt idx="54">
                  <c:v>0.64939999999999998</c:v>
                </c:pt>
                <c:pt idx="55">
                  <c:v>0.63439999999999996</c:v>
                </c:pt>
                <c:pt idx="56">
                  <c:v>0.58909999999999996</c:v>
                </c:pt>
                <c:pt idx="57">
                  <c:v>0.5847</c:v>
                </c:pt>
                <c:pt idx="58">
                  <c:v>0.56359999999999999</c:v>
                </c:pt>
                <c:pt idx="59">
                  <c:v>0.56579999999999997</c:v>
                </c:pt>
                <c:pt idx="60">
                  <c:v>0.56740000000000002</c:v>
                </c:pt>
                <c:pt idx="61">
                  <c:v>0.57969999999999999</c:v>
                </c:pt>
                <c:pt idx="62">
                  <c:v>0.55179999999999996</c:v>
                </c:pt>
                <c:pt idx="63">
                  <c:v>0.71750000000000003</c:v>
                </c:pt>
                <c:pt idx="64">
                  <c:v>0.81820000000000004</c:v>
                </c:pt>
                <c:pt idx="65">
                  <c:v>0.77480000000000004</c:v>
                </c:pt>
                <c:pt idx="66">
                  <c:v>0.61160000000000003</c:v>
                </c:pt>
                <c:pt idx="67">
                  <c:v>0.60429999999999995</c:v>
                </c:pt>
                <c:pt idx="68">
                  <c:v>0.7036</c:v>
                </c:pt>
                <c:pt idx="69">
                  <c:v>0.63539999999999996</c:v>
                </c:pt>
                <c:pt idx="70">
                  <c:v>0.59799999999999998</c:v>
                </c:pt>
                <c:pt idx="71">
                  <c:v>0.72399999999999998</c:v>
                </c:pt>
                <c:pt idx="72">
                  <c:v>0.79430000000000001</c:v>
                </c:pt>
                <c:pt idx="73">
                  <c:v>0.85209999999999997</c:v>
                </c:pt>
                <c:pt idx="74">
                  <c:v>0.94479999999999997</c:v>
                </c:pt>
                <c:pt idx="75">
                  <c:v>0.92459999999999998</c:v>
                </c:pt>
                <c:pt idx="76">
                  <c:v>0.95479999999999998</c:v>
                </c:pt>
                <c:pt idx="77">
                  <c:v>0.89770000000000005</c:v>
                </c:pt>
                <c:pt idx="78">
                  <c:v>0.99329999999999996</c:v>
                </c:pt>
                <c:pt idx="79">
                  <c:v>0.94599999999999995</c:v>
                </c:pt>
                <c:pt idx="80">
                  <c:v>1.0255000000000001</c:v>
                </c:pt>
                <c:pt idx="81">
                  <c:v>1.0398000000000001</c:v>
                </c:pt>
                <c:pt idx="82">
                  <c:v>1.1631</c:v>
                </c:pt>
                <c:pt idx="83">
                  <c:v>1.2432000000000001</c:v>
                </c:pt>
                <c:pt idx="84">
                  <c:v>1.2683</c:v>
                </c:pt>
                <c:pt idx="85">
                  <c:v>1.2538</c:v>
                </c:pt>
                <c:pt idx="86">
                  <c:v>1.3069</c:v>
                </c:pt>
                <c:pt idx="87">
                  <c:v>1.4171</c:v>
                </c:pt>
                <c:pt idx="88">
                  <c:v>1.4463999999999999</c:v>
                </c:pt>
                <c:pt idx="89">
                  <c:v>1.5339</c:v>
                </c:pt>
                <c:pt idx="90">
                  <c:v>1.5959000000000001</c:v>
                </c:pt>
                <c:pt idx="91">
                  <c:v>1.6587000000000001</c:v>
                </c:pt>
                <c:pt idx="92">
                  <c:v>1.8425</c:v>
                </c:pt>
                <c:pt idx="93">
                  <c:v>1.8594999999999999</c:v>
                </c:pt>
                <c:pt idx="94">
                  <c:v>1.9717</c:v>
                </c:pt>
                <c:pt idx="95">
                  <c:v>1.9301999999999999</c:v>
                </c:pt>
                <c:pt idx="96">
                  <c:v>1.8206</c:v>
                </c:pt>
                <c:pt idx="97">
                  <c:v>1.8880999999999999</c:v>
                </c:pt>
                <c:pt idx="98">
                  <c:v>1.9641</c:v>
                </c:pt>
                <c:pt idx="99">
                  <c:v>1.8721000000000001</c:v>
                </c:pt>
                <c:pt idx="100">
                  <c:v>1.8183</c:v>
                </c:pt>
                <c:pt idx="101">
                  <c:v>1.9359</c:v>
                </c:pt>
                <c:pt idx="102">
                  <c:v>1.9577</c:v>
                </c:pt>
                <c:pt idx="103">
                  <c:v>1.8459000000000001</c:v>
                </c:pt>
                <c:pt idx="104">
                  <c:v>1.8693</c:v>
                </c:pt>
                <c:pt idx="105">
                  <c:v>1.9944</c:v>
                </c:pt>
                <c:pt idx="106">
                  <c:v>1.9674</c:v>
                </c:pt>
                <c:pt idx="107">
                  <c:v>1.8847</c:v>
                </c:pt>
                <c:pt idx="108">
                  <c:v>1.9713000000000001</c:v>
                </c:pt>
                <c:pt idx="109">
                  <c:v>2.0537000000000001</c:v>
                </c:pt>
                <c:pt idx="110">
                  <c:v>2.0087999999999999</c:v>
                </c:pt>
                <c:pt idx="111">
                  <c:v>2.0074999999999998</c:v>
                </c:pt>
                <c:pt idx="112">
                  <c:v>1.9917</c:v>
                </c:pt>
                <c:pt idx="113">
                  <c:v>1.9376</c:v>
                </c:pt>
                <c:pt idx="114">
                  <c:v>1.9386000000000001</c:v>
                </c:pt>
                <c:pt idx="115">
                  <c:v>1.9365000000000001</c:v>
                </c:pt>
                <c:pt idx="116">
                  <c:v>1.9342999999999999</c:v>
                </c:pt>
                <c:pt idx="117">
                  <c:v>1.9556</c:v>
                </c:pt>
                <c:pt idx="118">
                  <c:v>1.9694</c:v>
                </c:pt>
                <c:pt idx="119">
                  <c:v>1.9703999999999999</c:v>
                </c:pt>
                <c:pt idx="120">
                  <c:v>1.9888999999999999</c:v>
                </c:pt>
                <c:pt idx="121">
                  <c:v>2.0377999999999998</c:v>
                </c:pt>
                <c:pt idx="122">
                  <c:v>2.0106000000000002</c:v>
                </c:pt>
                <c:pt idx="123">
                  <c:v>1.9593</c:v>
                </c:pt>
                <c:pt idx="124">
                  <c:v>2.0350000000000001</c:v>
                </c:pt>
                <c:pt idx="125">
                  <c:v>2.0305</c:v>
                </c:pt>
                <c:pt idx="126">
                  <c:v>2.1297000000000001</c:v>
                </c:pt>
                <c:pt idx="127">
                  <c:v>2.0569000000000002</c:v>
                </c:pt>
                <c:pt idx="128">
                  <c:v>1.9551000000000001</c:v>
                </c:pt>
                <c:pt idx="129">
                  <c:v>2.0436000000000001</c:v>
                </c:pt>
                <c:pt idx="130">
                  <c:v>2.1349</c:v>
                </c:pt>
                <c:pt idx="131">
                  <c:v>2.0577999999999999</c:v>
                </c:pt>
                <c:pt idx="132">
                  <c:v>2.0428999999999999</c:v>
                </c:pt>
                <c:pt idx="133">
                  <c:v>2.1825000000000001</c:v>
                </c:pt>
                <c:pt idx="134">
                  <c:v>2.2465000000000002</c:v>
                </c:pt>
                <c:pt idx="135">
                  <c:v>2.1991999999999998</c:v>
                </c:pt>
                <c:pt idx="136">
                  <c:v>2.2679</c:v>
                </c:pt>
                <c:pt idx="137">
                  <c:v>2.4302999999999999</c:v>
                </c:pt>
                <c:pt idx="138">
                  <c:v>2.4664000000000001</c:v>
                </c:pt>
                <c:pt idx="139">
                  <c:v>2.4735</c:v>
                </c:pt>
                <c:pt idx="140">
                  <c:v>2.5996000000000001</c:v>
                </c:pt>
                <c:pt idx="141">
                  <c:v>2.512</c:v>
                </c:pt>
                <c:pt idx="142">
                  <c:v>2.5415000000000001</c:v>
                </c:pt>
                <c:pt idx="143">
                  <c:v>2.5745</c:v>
                </c:pt>
                <c:pt idx="144">
                  <c:v>2.6185</c:v>
                </c:pt>
                <c:pt idx="145">
                  <c:v>2.6823000000000001</c:v>
                </c:pt>
                <c:pt idx="146">
                  <c:v>2.7288999999999999</c:v>
                </c:pt>
                <c:pt idx="147">
                  <c:v>2.8329</c:v>
                </c:pt>
                <c:pt idx="148">
                  <c:v>2.9237000000000002</c:v>
                </c:pt>
                <c:pt idx="149">
                  <c:v>2.9184999999999999</c:v>
                </c:pt>
                <c:pt idx="150">
                  <c:v>2.9647999999999999</c:v>
                </c:pt>
                <c:pt idx="151">
                  <c:v>3.0188999999999999</c:v>
                </c:pt>
                <c:pt idx="152">
                  <c:v>3.1166999999999998</c:v>
                </c:pt>
                <c:pt idx="153">
                  <c:v>3.2193000000000001</c:v>
                </c:pt>
                <c:pt idx="154">
                  <c:v>3.2988</c:v>
                </c:pt>
                <c:pt idx="155">
                  <c:v>3.2629000000000001</c:v>
                </c:pt>
                <c:pt idx="156">
                  <c:v>3.2621000000000002</c:v>
                </c:pt>
                <c:pt idx="157">
                  <c:v>3.3433999999999999</c:v>
                </c:pt>
                <c:pt idx="158">
                  <c:v>3.3803999999999998</c:v>
                </c:pt>
                <c:pt idx="159">
                  <c:v>3.5063</c:v>
                </c:pt>
                <c:pt idx="160">
                  <c:v>3.5674000000000001</c:v>
                </c:pt>
                <c:pt idx="161">
                  <c:v>3.6135000000000002</c:v>
                </c:pt>
                <c:pt idx="162">
                  <c:v>3.7065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45F-4DAF-9000-A4DD7D002A4E}"/>
            </c:ext>
          </c:extLst>
        </c:ser>
        <c:ser>
          <c:idx val="6"/>
          <c:order val="6"/>
          <c:tx>
            <c:strRef>
              <c:f>Sheet1!$Q$1</c:f>
              <c:strCache>
                <c:ptCount val="1"/>
                <c:pt idx="0">
                  <c:v>Series6</c:v>
                </c:pt>
              </c:strCache>
            </c:strRef>
          </c:tx>
          <c:spPr>
            <a:ln w="19050" cap="rnd">
              <a:solidFill>
                <a:srgbClr val="FFCC00"/>
              </a:solidFill>
              <a:round/>
            </a:ln>
            <a:effectLst/>
          </c:spPr>
          <c:marker>
            <c:symbol val="none"/>
          </c:marker>
          <c:cat>
            <c:numRef>
              <c:f>Sheet1!$J$2:$J$164</c:f>
              <c:numCache>
                <c:formatCode>General</c:formatCode>
                <c:ptCount val="163"/>
                <c:pt idx="0">
                  <c:v>851</c:v>
                </c:pt>
                <c:pt idx="1">
                  <c:v>852</c:v>
                </c:pt>
                <c:pt idx="2">
                  <c:v>853</c:v>
                </c:pt>
                <c:pt idx="3">
                  <c:v>854</c:v>
                </c:pt>
                <c:pt idx="4">
                  <c:v>855</c:v>
                </c:pt>
                <c:pt idx="5">
                  <c:v>856</c:v>
                </c:pt>
                <c:pt idx="6">
                  <c:v>857</c:v>
                </c:pt>
                <c:pt idx="7">
                  <c:v>858</c:v>
                </c:pt>
                <c:pt idx="8">
                  <c:v>859</c:v>
                </c:pt>
                <c:pt idx="9">
                  <c:v>860</c:v>
                </c:pt>
                <c:pt idx="10">
                  <c:v>861</c:v>
                </c:pt>
                <c:pt idx="11">
                  <c:v>862</c:v>
                </c:pt>
                <c:pt idx="12">
                  <c:v>863</c:v>
                </c:pt>
                <c:pt idx="13">
                  <c:v>864</c:v>
                </c:pt>
                <c:pt idx="14">
                  <c:v>865</c:v>
                </c:pt>
                <c:pt idx="15">
                  <c:v>866</c:v>
                </c:pt>
                <c:pt idx="16">
                  <c:v>867</c:v>
                </c:pt>
                <c:pt idx="17">
                  <c:v>868</c:v>
                </c:pt>
                <c:pt idx="18">
                  <c:v>869</c:v>
                </c:pt>
                <c:pt idx="19">
                  <c:v>870</c:v>
                </c:pt>
                <c:pt idx="20">
                  <c:v>871</c:v>
                </c:pt>
                <c:pt idx="21">
                  <c:v>872</c:v>
                </c:pt>
                <c:pt idx="22">
                  <c:v>873</c:v>
                </c:pt>
                <c:pt idx="23">
                  <c:v>874</c:v>
                </c:pt>
                <c:pt idx="24">
                  <c:v>875</c:v>
                </c:pt>
                <c:pt idx="25">
                  <c:v>876</c:v>
                </c:pt>
                <c:pt idx="26">
                  <c:v>877</c:v>
                </c:pt>
                <c:pt idx="27">
                  <c:v>878</c:v>
                </c:pt>
                <c:pt idx="28">
                  <c:v>879</c:v>
                </c:pt>
                <c:pt idx="29">
                  <c:v>880</c:v>
                </c:pt>
                <c:pt idx="30">
                  <c:v>881</c:v>
                </c:pt>
                <c:pt idx="31">
                  <c:v>882</c:v>
                </c:pt>
                <c:pt idx="32">
                  <c:v>883</c:v>
                </c:pt>
                <c:pt idx="33">
                  <c:v>884</c:v>
                </c:pt>
                <c:pt idx="34">
                  <c:v>885</c:v>
                </c:pt>
                <c:pt idx="35">
                  <c:v>886</c:v>
                </c:pt>
                <c:pt idx="36">
                  <c:v>887</c:v>
                </c:pt>
                <c:pt idx="37">
                  <c:v>888</c:v>
                </c:pt>
                <c:pt idx="38">
                  <c:v>889</c:v>
                </c:pt>
                <c:pt idx="39">
                  <c:v>890</c:v>
                </c:pt>
                <c:pt idx="40">
                  <c:v>891</c:v>
                </c:pt>
                <c:pt idx="41">
                  <c:v>892</c:v>
                </c:pt>
                <c:pt idx="42">
                  <c:v>893</c:v>
                </c:pt>
                <c:pt idx="43">
                  <c:v>894</c:v>
                </c:pt>
                <c:pt idx="44">
                  <c:v>895</c:v>
                </c:pt>
                <c:pt idx="45">
                  <c:v>896</c:v>
                </c:pt>
                <c:pt idx="46">
                  <c:v>897</c:v>
                </c:pt>
                <c:pt idx="47">
                  <c:v>898</c:v>
                </c:pt>
                <c:pt idx="48">
                  <c:v>899</c:v>
                </c:pt>
                <c:pt idx="49">
                  <c:v>900</c:v>
                </c:pt>
                <c:pt idx="50">
                  <c:v>901</c:v>
                </c:pt>
                <c:pt idx="51">
                  <c:v>902</c:v>
                </c:pt>
                <c:pt idx="52">
                  <c:v>903</c:v>
                </c:pt>
                <c:pt idx="53">
                  <c:v>904</c:v>
                </c:pt>
                <c:pt idx="54">
                  <c:v>905</c:v>
                </c:pt>
                <c:pt idx="55">
                  <c:v>906</c:v>
                </c:pt>
                <c:pt idx="56">
                  <c:v>907</c:v>
                </c:pt>
                <c:pt idx="57">
                  <c:v>908</c:v>
                </c:pt>
                <c:pt idx="58">
                  <c:v>909</c:v>
                </c:pt>
                <c:pt idx="59">
                  <c:v>910</c:v>
                </c:pt>
                <c:pt idx="60">
                  <c:v>911</c:v>
                </c:pt>
                <c:pt idx="61">
                  <c:v>912</c:v>
                </c:pt>
                <c:pt idx="62">
                  <c:v>913</c:v>
                </c:pt>
                <c:pt idx="63">
                  <c:v>914</c:v>
                </c:pt>
                <c:pt idx="64">
                  <c:v>915</c:v>
                </c:pt>
                <c:pt idx="65">
                  <c:v>916</c:v>
                </c:pt>
                <c:pt idx="66">
                  <c:v>917</c:v>
                </c:pt>
                <c:pt idx="67">
                  <c:v>918</c:v>
                </c:pt>
                <c:pt idx="68">
                  <c:v>919</c:v>
                </c:pt>
                <c:pt idx="69">
                  <c:v>920</c:v>
                </c:pt>
                <c:pt idx="70">
                  <c:v>921</c:v>
                </c:pt>
                <c:pt idx="71">
                  <c:v>922</c:v>
                </c:pt>
                <c:pt idx="72">
                  <c:v>923</c:v>
                </c:pt>
                <c:pt idx="73">
                  <c:v>924</c:v>
                </c:pt>
                <c:pt idx="74">
                  <c:v>925</c:v>
                </c:pt>
                <c:pt idx="75">
                  <c:v>926</c:v>
                </c:pt>
                <c:pt idx="76">
                  <c:v>927</c:v>
                </c:pt>
                <c:pt idx="77">
                  <c:v>928</c:v>
                </c:pt>
                <c:pt idx="78">
                  <c:v>929</c:v>
                </c:pt>
                <c:pt idx="79">
                  <c:v>930</c:v>
                </c:pt>
                <c:pt idx="80">
                  <c:v>931</c:v>
                </c:pt>
                <c:pt idx="81">
                  <c:v>932</c:v>
                </c:pt>
                <c:pt idx="82">
                  <c:v>933</c:v>
                </c:pt>
                <c:pt idx="83">
                  <c:v>934</c:v>
                </c:pt>
                <c:pt idx="84">
                  <c:v>935</c:v>
                </c:pt>
                <c:pt idx="85">
                  <c:v>936</c:v>
                </c:pt>
                <c:pt idx="86">
                  <c:v>937</c:v>
                </c:pt>
                <c:pt idx="87">
                  <c:v>938</c:v>
                </c:pt>
                <c:pt idx="88">
                  <c:v>939</c:v>
                </c:pt>
                <c:pt idx="89">
                  <c:v>940</c:v>
                </c:pt>
                <c:pt idx="90">
                  <c:v>941</c:v>
                </c:pt>
                <c:pt idx="91">
                  <c:v>942</c:v>
                </c:pt>
                <c:pt idx="92">
                  <c:v>943</c:v>
                </c:pt>
                <c:pt idx="93">
                  <c:v>944</c:v>
                </c:pt>
                <c:pt idx="94">
                  <c:v>945</c:v>
                </c:pt>
                <c:pt idx="95">
                  <c:v>946</c:v>
                </c:pt>
                <c:pt idx="96">
                  <c:v>947</c:v>
                </c:pt>
                <c:pt idx="97">
                  <c:v>948</c:v>
                </c:pt>
                <c:pt idx="98">
                  <c:v>949</c:v>
                </c:pt>
                <c:pt idx="99">
                  <c:v>950</c:v>
                </c:pt>
                <c:pt idx="100">
                  <c:v>951</c:v>
                </c:pt>
                <c:pt idx="101">
                  <c:v>952</c:v>
                </c:pt>
                <c:pt idx="102">
                  <c:v>953</c:v>
                </c:pt>
                <c:pt idx="103">
                  <c:v>954</c:v>
                </c:pt>
                <c:pt idx="104">
                  <c:v>955</c:v>
                </c:pt>
                <c:pt idx="105">
                  <c:v>956</c:v>
                </c:pt>
                <c:pt idx="106">
                  <c:v>957</c:v>
                </c:pt>
                <c:pt idx="107">
                  <c:v>958</c:v>
                </c:pt>
                <c:pt idx="108">
                  <c:v>959</c:v>
                </c:pt>
                <c:pt idx="109">
                  <c:v>960</c:v>
                </c:pt>
                <c:pt idx="110">
                  <c:v>961</c:v>
                </c:pt>
                <c:pt idx="111">
                  <c:v>962</c:v>
                </c:pt>
                <c:pt idx="112">
                  <c:v>963</c:v>
                </c:pt>
                <c:pt idx="113">
                  <c:v>964</c:v>
                </c:pt>
                <c:pt idx="114">
                  <c:v>965</c:v>
                </c:pt>
                <c:pt idx="115">
                  <c:v>966</c:v>
                </c:pt>
                <c:pt idx="116">
                  <c:v>967</c:v>
                </c:pt>
                <c:pt idx="117">
                  <c:v>968</c:v>
                </c:pt>
                <c:pt idx="118">
                  <c:v>969</c:v>
                </c:pt>
                <c:pt idx="119">
                  <c:v>970</c:v>
                </c:pt>
                <c:pt idx="120">
                  <c:v>971</c:v>
                </c:pt>
                <c:pt idx="121">
                  <c:v>972</c:v>
                </c:pt>
                <c:pt idx="122">
                  <c:v>973</c:v>
                </c:pt>
                <c:pt idx="123">
                  <c:v>974</c:v>
                </c:pt>
                <c:pt idx="124">
                  <c:v>975</c:v>
                </c:pt>
                <c:pt idx="125">
                  <c:v>976</c:v>
                </c:pt>
                <c:pt idx="126">
                  <c:v>977</c:v>
                </c:pt>
                <c:pt idx="127">
                  <c:v>978</c:v>
                </c:pt>
                <c:pt idx="128">
                  <c:v>979</c:v>
                </c:pt>
                <c:pt idx="129">
                  <c:v>980</c:v>
                </c:pt>
                <c:pt idx="130">
                  <c:v>981</c:v>
                </c:pt>
                <c:pt idx="131">
                  <c:v>982</c:v>
                </c:pt>
                <c:pt idx="132">
                  <c:v>983</c:v>
                </c:pt>
                <c:pt idx="133">
                  <c:v>984</c:v>
                </c:pt>
                <c:pt idx="134">
                  <c:v>985</c:v>
                </c:pt>
                <c:pt idx="135">
                  <c:v>986</c:v>
                </c:pt>
                <c:pt idx="136">
                  <c:v>987</c:v>
                </c:pt>
                <c:pt idx="137">
                  <c:v>988</c:v>
                </c:pt>
                <c:pt idx="138">
                  <c:v>989</c:v>
                </c:pt>
                <c:pt idx="139">
                  <c:v>990</c:v>
                </c:pt>
                <c:pt idx="140">
                  <c:v>991</c:v>
                </c:pt>
                <c:pt idx="141">
                  <c:v>992</c:v>
                </c:pt>
                <c:pt idx="142">
                  <c:v>993</c:v>
                </c:pt>
                <c:pt idx="143">
                  <c:v>994</c:v>
                </c:pt>
                <c:pt idx="144">
                  <c:v>995</c:v>
                </c:pt>
                <c:pt idx="145">
                  <c:v>996</c:v>
                </c:pt>
                <c:pt idx="146">
                  <c:v>997</c:v>
                </c:pt>
                <c:pt idx="147">
                  <c:v>998</c:v>
                </c:pt>
                <c:pt idx="148">
                  <c:v>999</c:v>
                </c:pt>
                <c:pt idx="149">
                  <c:v>1000</c:v>
                </c:pt>
                <c:pt idx="150">
                  <c:v>1001</c:v>
                </c:pt>
                <c:pt idx="151">
                  <c:v>1002</c:v>
                </c:pt>
                <c:pt idx="152">
                  <c:v>1003</c:v>
                </c:pt>
                <c:pt idx="153">
                  <c:v>1004</c:v>
                </c:pt>
                <c:pt idx="154">
                  <c:v>1005</c:v>
                </c:pt>
                <c:pt idx="155">
                  <c:v>1006</c:v>
                </c:pt>
                <c:pt idx="156">
                  <c:v>1007</c:v>
                </c:pt>
                <c:pt idx="157">
                  <c:v>1008</c:v>
                </c:pt>
                <c:pt idx="158">
                  <c:v>1009</c:v>
                </c:pt>
                <c:pt idx="159">
                  <c:v>1010</c:v>
                </c:pt>
                <c:pt idx="160">
                  <c:v>1011</c:v>
                </c:pt>
                <c:pt idx="161">
                  <c:v>1012</c:v>
                </c:pt>
                <c:pt idx="162">
                  <c:v>1013</c:v>
                </c:pt>
              </c:numCache>
            </c:numRef>
          </c:cat>
          <c:val>
            <c:numRef>
              <c:f>Sheet1!$Q$2:$Q$164</c:f>
              <c:numCache>
                <c:formatCode>General</c:formatCode>
                <c:ptCount val="163"/>
                <c:pt idx="0">
                  <c:v>0.23430000000000001</c:v>
                </c:pt>
                <c:pt idx="1">
                  <c:v>0.2339</c:v>
                </c:pt>
                <c:pt idx="2">
                  <c:v>0.25990000000000002</c:v>
                </c:pt>
                <c:pt idx="3">
                  <c:v>0.26240000000000002</c:v>
                </c:pt>
                <c:pt idx="4">
                  <c:v>0.2427</c:v>
                </c:pt>
                <c:pt idx="5">
                  <c:v>0.25140000000000001</c:v>
                </c:pt>
                <c:pt idx="6">
                  <c:v>0.28010000000000002</c:v>
                </c:pt>
                <c:pt idx="7">
                  <c:v>0.28589999999999999</c:v>
                </c:pt>
                <c:pt idx="8">
                  <c:v>0.27189999999999998</c:v>
                </c:pt>
                <c:pt idx="9">
                  <c:v>0.28660000000000002</c:v>
                </c:pt>
                <c:pt idx="10">
                  <c:v>0.31130000000000002</c:v>
                </c:pt>
                <c:pt idx="11">
                  <c:v>0.30830000000000002</c:v>
                </c:pt>
                <c:pt idx="12">
                  <c:v>0.308</c:v>
                </c:pt>
                <c:pt idx="13">
                  <c:v>0.33</c:v>
                </c:pt>
                <c:pt idx="14">
                  <c:v>0.34939999999999999</c:v>
                </c:pt>
                <c:pt idx="15">
                  <c:v>0.35410000000000003</c:v>
                </c:pt>
                <c:pt idx="16">
                  <c:v>0.40629999999999999</c:v>
                </c:pt>
                <c:pt idx="17">
                  <c:v>0.45319999999999999</c:v>
                </c:pt>
                <c:pt idx="18">
                  <c:v>0.50980000000000003</c:v>
                </c:pt>
                <c:pt idx="19">
                  <c:v>0.52580000000000005</c:v>
                </c:pt>
                <c:pt idx="20">
                  <c:v>0.51090000000000002</c:v>
                </c:pt>
                <c:pt idx="21">
                  <c:v>0.5292</c:v>
                </c:pt>
                <c:pt idx="22">
                  <c:v>0.56979999999999997</c:v>
                </c:pt>
                <c:pt idx="23">
                  <c:v>0.66300000000000003</c:v>
                </c:pt>
                <c:pt idx="24">
                  <c:v>0.72940000000000005</c:v>
                </c:pt>
                <c:pt idx="25">
                  <c:v>0.83609999999999995</c:v>
                </c:pt>
                <c:pt idx="26">
                  <c:v>0.95960000000000001</c:v>
                </c:pt>
                <c:pt idx="27">
                  <c:v>1.0373000000000001</c:v>
                </c:pt>
                <c:pt idx="28">
                  <c:v>1.0511999999999999</c:v>
                </c:pt>
                <c:pt idx="29">
                  <c:v>1.0859000000000001</c:v>
                </c:pt>
                <c:pt idx="30">
                  <c:v>1.0327999999999999</c:v>
                </c:pt>
                <c:pt idx="31">
                  <c:v>0.92130000000000001</c:v>
                </c:pt>
                <c:pt idx="32">
                  <c:v>1.0066999999999999</c:v>
                </c:pt>
                <c:pt idx="33">
                  <c:v>0.95879999999999999</c:v>
                </c:pt>
                <c:pt idx="34">
                  <c:v>0.76480000000000004</c:v>
                </c:pt>
                <c:pt idx="35">
                  <c:v>0.62290000000000001</c:v>
                </c:pt>
                <c:pt idx="36">
                  <c:v>0.54969999999999997</c:v>
                </c:pt>
                <c:pt idx="37">
                  <c:v>0.435</c:v>
                </c:pt>
                <c:pt idx="38">
                  <c:v>0.37519999999999998</c:v>
                </c:pt>
                <c:pt idx="39">
                  <c:v>0.40849999999999997</c:v>
                </c:pt>
                <c:pt idx="40">
                  <c:v>0.34720000000000001</c:v>
                </c:pt>
                <c:pt idx="41">
                  <c:v>0.31659999999999999</c:v>
                </c:pt>
                <c:pt idx="42">
                  <c:v>0.35699999999999998</c:v>
                </c:pt>
                <c:pt idx="43">
                  <c:v>0.308</c:v>
                </c:pt>
                <c:pt idx="44">
                  <c:v>0.2969</c:v>
                </c:pt>
                <c:pt idx="45">
                  <c:v>0.3458</c:v>
                </c:pt>
                <c:pt idx="46">
                  <c:v>0.37040000000000001</c:v>
                </c:pt>
                <c:pt idx="47">
                  <c:v>0.47510000000000002</c:v>
                </c:pt>
                <c:pt idx="48">
                  <c:v>0.54430000000000001</c:v>
                </c:pt>
                <c:pt idx="49">
                  <c:v>0.45810000000000001</c:v>
                </c:pt>
                <c:pt idx="50">
                  <c:v>0.4229</c:v>
                </c:pt>
                <c:pt idx="51">
                  <c:v>0.54020000000000001</c:v>
                </c:pt>
                <c:pt idx="52">
                  <c:v>0.53190000000000004</c:v>
                </c:pt>
                <c:pt idx="53">
                  <c:v>0.52900000000000003</c:v>
                </c:pt>
                <c:pt idx="54">
                  <c:v>0.62439999999999996</c:v>
                </c:pt>
                <c:pt idx="55">
                  <c:v>0.5504</c:v>
                </c:pt>
                <c:pt idx="56">
                  <c:v>0.49580000000000002</c:v>
                </c:pt>
                <c:pt idx="57">
                  <c:v>0.51639999999999997</c:v>
                </c:pt>
                <c:pt idx="58">
                  <c:v>0.53639999999999999</c:v>
                </c:pt>
                <c:pt idx="59">
                  <c:v>0.66479999999999995</c:v>
                </c:pt>
                <c:pt idx="60">
                  <c:v>0.87029999999999996</c:v>
                </c:pt>
                <c:pt idx="61">
                  <c:v>1.0519000000000001</c:v>
                </c:pt>
                <c:pt idx="62">
                  <c:v>1.1991000000000001</c:v>
                </c:pt>
                <c:pt idx="63">
                  <c:v>1.2423999999999999</c:v>
                </c:pt>
                <c:pt idx="64">
                  <c:v>1.4087000000000001</c:v>
                </c:pt>
                <c:pt idx="65">
                  <c:v>1.6223000000000001</c:v>
                </c:pt>
                <c:pt idx="66">
                  <c:v>1.5555000000000001</c:v>
                </c:pt>
                <c:pt idx="67">
                  <c:v>1.3793</c:v>
                </c:pt>
                <c:pt idx="68">
                  <c:v>1.5537000000000001</c:v>
                </c:pt>
                <c:pt idx="69">
                  <c:v>1.6858</c:v>
                </c:pt>
                <c:pt idx="70">
                  <c:v>1.5107999999999999</c:v>
                </c:pt>
                <c:pt idx="71">
                  <c:v>1.4813000000000001</c:v>
                </c:pt>
                <c:pt idx="72">
                  <c:v>1.6698</c:v>
                </c:pt>
                <c:pt idx="73">
                  <c:v>1.6978</c:v>
                </c:pt>
                <c:pt idx="74">
                  <c:v>1.84</c:v>
                </c:pt>
                <c:pt idx="75">
                  <c:v>1.7319</c:v>
                </c:pt>
                <c:pt idx="76">
                  <c:v>1.6347</c:v>
                </c:pt>
                <c:pt idx="77">
                  <c:v>1.4498</c:v>
                </c:pt>
                <c:pt idx="78">
                  <c:v>1.4051</c:v>
                </c:pt>
                <c:pt idx="79">
                  <c:v>1.2487999999999999</c:v>
                </c:pt>
                <c:pt idx="80">
                  <c:v>1.2250000000000001</c:v>
                </c:pt>
                <c:pt idx="81">
                  <c:v>1.2663</c:v>
                </c:pt>
                <c:pt idx="82">
                  <c:v>1.1859999999999999</c:v>
                </c:pt>
                <c:pt idx="83">
                  <c:v>1.3263</c:v>
                </c:pt>
                <c:pt idx="84">
                  <c:v>1.5021</c:v>
                </c:pt>
                <c:pt idx="85">
                  <c:v>1.5987</c:v>
                </c:pt>
                <c:pt idx="86">
                  <c:v>1.6746000000000001</c:v>
                </c:pt>
                <c:pt idx="87">
                  <c:v>1.8599000000000001</c:v>
                </c:pt>
                <c:pt idx="88">
                  <c:v>1.9559</c:v>
                </c:pt>
                <c:pt idx="89">
                  <c:v>2.0996999999999999</c:v>
                </c:pt>
                <c:pt idx="90">
                  <c:v>1.9637</c:v>
                </c:pt>
                <c:pt idx="91">
                  <c:v>1.7643</c:v>
                </c:pt>
                <c:pt idx="92">
                  <c:v>1.5729</c:v>
                </c:pt>
                <c:pt idx="93">
                  <c:v>1.4308000000000001</c:v>
                </c:pt>
                <c:pt idx="94">
                  <c:v>1.4420999999999999</c:v>
                </c:pt>
                <c:pt idx="95">
                  <c:v>1.3875</c:v>
                </c:pt>
                <c:pt idx="96">
                  <c:v>1.2202</c:v>
                </c:pt>
                <c:pt idx="97">
                  <c:v>1.1386000000000001</c:v>
                </c:pt>
                <c:pt idx="98">
                  <c:v>1.1534</c:v>
                </c:pt>
                <c:pt idx="99">
                  <c:v>1.0510999999999999</c:v>
                </c:pt>
                <c:pt idx="100">
                  <c:v>0.88580000000000003</c:v>
                </c:pt>
                <c:pt idx="101">
                  <c:v>0.9052</c:v>
                </c:pt>
                <c:pt idx="102">
                  <c:v>0.90180000000000005</c:v>
                </c:pt>
                <c:pt idx="103">
                  <c:v>0.76500000000000001</c:v>
                </c:pt>
                <c:pt idx="104">
                  <c:v>0.69159999999999999</c:v>
                </c:pt>
                <c:pt idx="105">
                  <c:v>0.77229999999999999</c:v>
                </c:pt>
                <c:pt idx="106">
                  <c:v>0.74039999999999995</c:v>
                </c:pt>
                <c:pt idx="107">
                  <c:v>0.64359999999999995</c:v>
                </c:pt>
                <c:pt idx="108">
                  <c:v>0.69620000000000004</c:v>
                </c:pt>
                <c:pt idx="109">
                  <c:v>0.76949999999999996</c:v>
                </c:pt>
                <c:pt idx="110">
                  <c:v>0.79149999999999998</c:v>
                </c:pt>
                <c:pt idx="111">
                  <c:v>0.76959999999999995</c:v>
                </c:pt>
                <c:pt idx="112">
                  <c:v>0.84709999999999996</c:v>
                </c:pt>
                <c:pt idx="113">
                  <c:v>0.91769999999999996</c:v>
                </c:pt>
                <c:pt idx="114">
                  <c:v>1.0097</c:v>
                </c:pt>
                <c:pt idx="115">
                  <c:v>1.1637999999999999</c:v>
                </c:pt>
                <c:pt idx="116">
                  <c:v>1.3016000000000001</c:v>
                </c:pt>
                <c:pt idx="117">
                  <c:v>1.4258999999999999</c:v>
                </c:pt>
                <c:pt idx="118">
                  <c:v>1.6140000000000001</c:v>
                </c:pt>
                <c:pt idx="119">
                  <c:v>1.7342</c:v>
                </c:pt>
                <c:pt idx="120">
                  <c:v>1.8149</c:v>
                </c:pt>
                <c:pt idx="121">
                  <c:v>1.9387000000000001</c:v>
                </c:pt>
                <c:pt idx="122">
                  <c:v>2.0181</c:v>
                </c:pt>
                <c:pt idx="123">
                  <c:v>1.9625999999999999</c:v>
                </c:pt>
                <c:pt idx="124">
                  <c:v>2.0764999999999998</c:v>
                </c:pt>
                <c:pt idx="125">
                  <c:v>1.9928999999999999</c:v>
                </c:pt>
                <c:pt idx="126">
                  <c:v>1.9947999999999999</c:v>
                </c:pt>
                <c:pt idx="127">
                  <c:v>1.8731</c:v>
                </c:pt>
                <c:pt idx="128">
                  <c:v>1.8185</c:v>
                </c:pt>
                <c:pt idx="129">
                  <c:v>1.7809999999999999</c:v>
                </c:pt>
                <c:pt idx="130">
                  <c:v>1.6969000000000001</c:v>
                </c:pt>
                <c:pt idx="131">
                  <c:v>1.5803</c:v>
                </c:pt>
                <c:pt idx="132">
                  <c:v>1.5474000000000001</c:v>
                </c:pt>
                <c:pt idx="133">
                  <c:v>1.5415000000000001</c:v>
                </c:pt>
                <c:pt idx="134">
                  <c:v>1.4420999999999999</c:v>
                </c:pt>
                <c:pt idx="135">
                  <c:v>1.3516999999999999</c:v>
                </c:pt>
                <c:pt idx="136">
                  <c:v>1.3571</c:v>
                </c:pt>
                <c:pt idx="137">
                  <c:v>1.3326</c:v>
                </c:pt>
                <c:pt idx="138">
                  <c:v>1.2254</c:v>
                </c:pt>
                <c:pt idx="139">
                  <c:v>1.1656</c:v>
                </c:pt>
                <c:pt idx="140">
                  <c:v>1.0813999999999999</c:v>
                </c:pt>
                <c:pt idx="141">
                  <c:v>1.0911999999999999</c:v>
                </c:pt>
                <c:pt idx="142">
                  <c:v>1.0178</c:v>
                </c:pt>
                <c:pt idx="143">
                  <c:v>1.028</c:v>
                </c:pt>
                <c:pt idx="144">
                  <c:v>1.0894999999999999</c:v>
                </c:pt>
                <c:pt idx="145">
                  <c:v>1.1242000000000001</c:v>
                </c:pt>
                <c:pt idx="146">
                  <c:v>1.2423999999999999</c:v>
                </c:pt>
                <c:pt idx="147">
                  <c:v>1.3875999999999999</c:v>
                </c:pt>
                <c:pt idx="148">
                  <c:v>1.4733000000000001</c:v>
                </c:pt>
                <c:pt idx="149">
                  <c:v>1.3747</c:v>
                </c:pt>
                <c:pt idx="150">
                  <c:v>1.3242</c:v>
                </c:pt>
                <c:pt idx="151">
                  <c:v>1.2504</c:v>
                </c:pt>
                <c:pt idx="152">
                  <c:v>1.2749999999999999</c:v>
                </c:pt>
                <c:pt idx="153">
                  <c:v>1.3666</c:v>
                </c:pt>
                <c:pt idx="154">
                  <c:v>1.4469000000000001</c:v>
                </c:pt>
                <c:pt idx="155">
                  <c:v>1.4463999999999999</c:v>
                </c:pt>
                <c:pt idx="156">
                  <c:v>1.5390999999999999</c:v>
                </c:pt>
                <c:pt idx="157">
                  <c:v>1.6604000000000001</c:v>
                </c:pt>
                <c:pt idx="158">
                  <c:v>1.6635</c:v>
                </c:pt>
                <c:pt idx="159">
                  <c:v>1.7563</c:v>
                </c:pt>
                <c:pt idx="160">
                  <c:v>1.8283</c:v>
                </c:pt>
                <c:pt idx="161">
                  <c:v>1.9195</c:v>
                </c:pt>
                <c:pt idx="162">
                  <c:v>2.061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F45F-4DAF-9000-A4DD7D002A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-8879136"/>
        <c:axId val="-8878592"/>
      </c:lineChart>
      <c:catAx>
        <c:axId val="-887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78592"/>
        <c:crosses val="autoZero"/>
        <c:auto val="1"/>
        <c:lblAlgn val="ctr"/>
        <c:lblOffset val="100"/>
        <c:tickLblSkip val="10"/>
        <c:noMultiLvlLbl val="0"/>
      </c:catAx>
      <c:valAx>
        <c:axId val="-8878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8879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u-HU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omments/modernComment_112_23FE84C7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48F0F498-612C-4B2E-A7DA-B9E208C41C81}" authorId="{EB075D77-3FE3-4F41-957C-8D5BC994C8E2}" created="2025-07-17T08:22:11.617">
    <pc:sldMkLst xmlns:pc="http://schemas.microsoft.com/office/powerpoint/2013/main/command">
      <pc:docMk/>
      <pc:sldMk cId="603882695" sldId="274"/>
    </pc:sldMkLst>
    <p188:txBody>
      <a:bodyPr/>
      <a:lstStyle/>
      <a:p>
        <a:r>
          <a:rPr lang="hu-HU"/>
          <a:t>A bal oldali input lane-ben adni kellene magyarázatot az erős band-re.</a:t>
        </a:r>
      </a:p>
    </p188:txBody>
  </p188:cm>
</p188:cmLst>
</file>

<file path=ppt/comments/modernComment_117_500BA9A6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326DA52B-4D9B-4930-9B48-D72E43638DE0}" authorId="{EB075D77-3FE3-4F41-957C-8D5BC994C8E2}" created="2025-11-21T09:33:41.553">
    <pc:sldMkLst xmlns:pc="http://schemas.microsoft.com/office/powerpoint/2013/main/command">
      <pc:docMk/>
      <pc:sldMk cId="1342941606" sldId="279"/>
    </pc:sldMkLst>
    <p188:txBody>
      <a:bodyPr/>
      <a:lstStyle/>
      <a:p>
        <a:r>
          <a:rPr lang="hu-HU"/>
          <a:t>Én úgy látom, hogy a 406T esetében az RMSF értékek alacsonyak mindkét esetben, azaz, épp hogy nem flexibilis régióban van mindkét esetben. Vagy az ábra aláírás hibás.</a:t>
        </a:r>
      </a:p>
    </p188:txBody>
  </p188:cm>
</p188:cmLst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3464</cdr:x>
      <cdr:y>0.4955</cdr:y>
    </cdr:from>
    <cdr:to>
      <cdr:x>0.46828</cdr:x>
      <cdr:y>0.58166</cdr:y>
    </cdr:to>
    <cdr:sp macro="" textlink="">
      <cdr:nvSpPr>
        <cdr:cNvPr id="3" name="Szövegdoboz 5"/>
        <cdr:cNvSpPr txBox="1"/>
      </cdr:nvSpPr>
      <cdr:spPr>
        <a:xfrm xmlns:a="http://schemas.openxmlformats.org/drawingml/2006/main">
          <a:off x="919777" y="965924"/>
          <a:ext cx="367327" cy="16795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</a:p>
      </cdr:txBody>
    </cdr:sp>
  </cdr:relSizeAnchor>
  <cdr:relSizeAnchor xmlns:cdr="http://schemas.openxmlformats.org/drawingml/2006/chartDrawing">
    <cdr:from>
      <cdr:x>0.5103</cdr:x>
      <cdr:y>0.70166</cdr:y>
    </cdr:from>
    <cdr:to>
      <cdr:x>0.63122</cdr:x>
      <cdr:y>0.78155</cdr:y>
    </cdr:to>
    <cdr:sp macro="" textlink="">
      <cdr:nvSpPr>
        <cdr:cNvPr id="4" name="Szövegdoboz 5"/>
        <cdr:cNvSpPr txBox="1"/>
      </cdr:nvSpPr>
      <cdr:spPr>
        <a:xfrm xmlns:a="http://schemas.openxmlformats.org/drawingml/2006/main">
          <a:off x="1402611" y="1367802"/>
          <a:ext cx="332357" cy="15573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</a:p>
      </cdr:txBody>
    </cdr:sp>
  </cdr:relSizeAnchor>
  <cdr:relSizeAnchor xmlns:cdr="http://schemas.openxmlformats.org/drawingml/2006/chartDrawing">
    <cdr:from>
      <cdr:x>0.67826</cdr:x>
      <cdr:y>0.69156</cdr:y>
    </cdr:from>
    <cdr:to>
      <cdr:x>0.79917</cdr:x>
      <cdr:y>0.77145</cdr:y>
    </cdr:to>
    <cdr:sp macro="" textlink="">
      <cdr:nvSpPr>
        <cdr:cNvPr id="5" name="Szövegdoboz 5"/>
        <cdr:cNvSpPr txBox="1"/>
      </cdr:nvSpPr>
      <cdr:spPr>
        <a:xfrm xmlns:a="http://schemas.openxmlformats.org/drawingml/2006/main">
          <a:off x="1864246" y="1348114"/>
          <a:ext cx="332330" cy="15573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B0E386-A76B-4ADB-8645-9DD8B10AB9AB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3F96DC-FE33-4E24-88B7-7DBCDB608B0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199009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hu-HU" b="1" dirty="0" err="1"/>
              <a:t>Supplementary</a:t>
            </a:r>
            <a:r>
              <a:rPr lang="hu-HU" b="1" dirty="0"/>
              <a:t> </a:t>
            </a:r>
            <a:r>
              <a:rPr lang="hu-HU" b="1" dirty="0" err="1"/>
              <a:t>Figure</a:t>
            </a:r>
            <a:r>
              <a:rPr lang="hu-HU" b="1" dirty="0"/>
              <a:t> 1.</a:t>
            </a:r>
            <a:r>
              <a:rPr lang="hu-HU" dirty="0"/>
              <a:t> </a:t>
            </a:r>
            <a:r>
              <a:rPr lang="hu-HU" dirty="0" err="1"/>
              <a:t>Proliferation</a:t>
            </a:r>
            <a:r>
              <a:rPr lang="hu-HU" baseline="0" dirty="0"/>
              <a:t> is </a:t>
            </a:r>
            <a:r>
              <a:rPr lang="hu-HU" baseline="0" dirty="0" err="1"/>
              <a:t>enriched</a:t>
            </a:r>
            <a:r>
              <a:rPr lang="hu-HU" baseline="0" dirty="0"/>
              <a:t> in </a:t>
            </a:r>
            <a:r>
              <a:rPr lang="hu-HU" i="1" baseline="0" dirty="0" err="1"/>
              <a:t>Medicago</a:t>
            </a:r>
            <a:r>
              <a:rPr lang="hu-HU" baseline="0" dirty="0"/>
              <a:t> </a:t>
            </a:r>
            <a:r>
              <a:rPr lang="hu-HU" baseline="0" dirty="0" err="1"/>
              <a:t>root</a:t>
            </a:r>
            <a:r>
              <a:rPr lang="hu-HU" baseline="0" dirty="0"/>
              <a:t> </a:t>
            </a:r>
            <a:r>
              <a:rPr lang="hu-HU" baseline="0" dirty="0" err="1"/>
              <a:t>tip</a:t>
            </a:r>
            <a:r>
              <a:rPr lang="hu-HU" baseline="0" dirty="0"/>
              <a:t>, and </a:t>
            </a:r>
            <a:r>
              <a:rPr lang="hu-HU" baseline="0" dirty="0" err="1"/>
              <a:t>young</a:t>
            </a:r>
            <a:r>
              <a:rPr lang="hu-HU" baseline="0" dirty="0"/>
              <a:t> </a:t>
            </a:r>
            <a:r>
              <a:rPr lang="hu-HU" i="1" baseline="0" dirty="0" err="1"/>
              <a:t>Brassica</a:t>
            </a:r>
            <a:r>
              <a:rPr lang="hu-HU" baseline="0" dirty="0"/>
              <a:t> </a:t>
            </a:r>
            <a:r>
              <a:rPr lang="hu-HU" baseline="0" dirty="0" err="1"/>
              <a:t>leaf</a:t>
            </a:r>
            <a:r>
              <a:rPr lang="hu-HU" baseline="0" dirty="0"/>
              <a:t>. (</a:t>
            </a:r>
            <a:r>
              <a:rPr lang="hu-HU" b="1" baseline="0" dirty="0"/>
              <a:t>A</a:t>
            </a:r>
            <a:r>
              <a:rPr lang="hu-HU" baseline="0" dirty="0"/>
              <a:t>) </a:t>
            </a:r>
            <a:r>
              <a:rPr lang="hu-HU" baseline="0" dirty="0" err="1"/>
              <a:t>EdU</a:t>
            </a:r>
            <a:r>
              <a:rPr lang="hu-HU" baseline="0" dirty="0"/>
              <a:t> </a:t>
            </a:r>
            <a:r>
              <a:rPr lang="hu-HU" baseline="0" dirty="0" err="1"/>
              <a:t>signal</a:t>
            </a:r>
            <a:r>
              <a:rPr lang="hu-HU" baseline="0" dirty="0"/>
              <a:t> is </a:t>
            </a:r>
            <a:r>
              <a:rPr lang="hu-HU" baseline="0" dirty="0" err="1"/>
              <a:t>concentrated</a:t>
            </a:r>
            <a:r>
              <a:rPr lang="hu-HU" baseline="0" dirty="0"/>
              <a:t> </a:t>
            </a:r>
            <a:r>
              <a:rPr lang="hu-HU" baseline="0" dirty="0" err="1"/>
              <a:t>to</a:t>
            </a:r>
            <a:r>
              <a:rPr lang="hu-HU" baseline="0" dirty="0"/>
              <a:t> </a:t>
            </a:r>
            <a:r>
              <a:rPr lang="hu-HU" baseline="0" dirty="0" err="1"/>
              <a:t>the</a:t>
            </a:r>
            <a:r>
              <a:rPr lang="hu-HU" baseline="0" dirty="0"/>
              <a:t> </a:t>
            </a:r>
            <a:r>
              <a:rPr lang="hu-HU" baseline="0" dirty="0" err="1"/>
              <a:t>tip</a:t>
            </a:r>
            <a:r>
              <a:rPr lang="hu-HU" baseline="0" dirty="0"/>
              <a:t> </a:t>
            </a:r>
            <a:r>
              <a:rPr lang="hu-HU" baseline="0" dirty="0" err="1"/>
              <a:t>region</a:t>
            </a:r>
            <a:r>
              <a:rPr lang="hu-HU" baseline="0" dirty="0"/>
              <a:t> of </a:t>
            </a:r>
            <a:r>
              <a:rPr lang="hu-HU" i="1" baseline="0" dirty="0" err="1"/>
              <a:t>Medicago</a:t>
            </a:r>
            <a:r>
              <a:rPr lang="hu-HU" baseline="0" dirty="0"/>
              <a:t> </a:t>
            </a:r>
            <a:r>
              <a:rPr lang="hu-HU" baseline="0" dirty="0" err="1"/>
              <a:t>root</a:t>
            </a:r>
            <a:r>
              <a:rPr lang="hu-HU" baseline="0" dirty="0"/>
              <a:t> </a:t>
            </a:r>
            <a:r>
              <a:rPr lang="hu-HU" baseline="0" dirty="0" err="1"/>
              <a:t>consisting</a:t>
            </a:r>
            <a:r>
              <a:rPr lang="hu-HU" baseline="0" dirty="0"/>
              <a:t> of </a:t>
            </a:r>
            <a:r>
              <a:rPr lang="hu-HU" baseline="0" dirty="0" err="1"/>
              <a:t>the</a:t>
            </a:r>
            <a:r>
              <a:rPr lang="hu-HU" baseline="0" dirty="0"/>
              <a:t> </a:t>
            </a:r>
            <a:r>
              <a:rPr lang="hu-HU" baseline="0" dirty="0" err="1"/>
              <a:t>dividing</a:t>
            </a:r>
            <a:r>
              <a:rPr lang="hu-HU" baseline="0" dirty="0"/>
              <a:t> </a:t>
            </a:r>
            <a:r>
              <a:rPr lang="hu-HU" baseline="0" dirty="0" err="1"/>
              <a:t>meristematic</a:t>
            </a:r>
            <a:r>
              <a:rPr lang="hu-HU" baseline="0" dirty="0"/>
              <a:t> </a:t>
            </a:r>
            <a:r>
              <a:rPr lang="hu-HU" baseline="0" dirty="0" err="1"/>
              <a:t>root</a:t>
            </a:r>
            <a:r>
              <a:rPr lang="hu-HU" baseline="0" dirty="0"/>
              <a:t> </a:t>
            </a:r>
            <a:r>
              <a:rPr lang="hu-HU" baseline="0" dirty="0" err="1"/>
              <a:t>region</a:t>
            </a:r>
            <a:r>
              <a:rPr lang="hu-HU" baseline="0" dirty="0"/>
              <a:t>. (</a:t>
            </a:r>
            <a:r>
              <a:rPr lang="hu-HU" b="1" baseline="0" dirty="0"/>
              <a:t>B</a:t>
            </a:r>
            <a:r>
              <a:rPr lang="hu-HU" baseline="0" dirty="0"/>
              <a:t>) </a:t>
            </a:r>
            <a:r>
              <a:rPr lang="hu-HU" baseline="0" dirty="0" smtClean="0"/>
              <a:t>The </a:t>
            </a:r>
            <a:r>
              <a:rPr lang="hu-HU" i="1" baseline="0" dirty="0" err="1" smtClean="0"/>
              <a:t>Medicago</a:t>
            </a:r>
            <a:r>
              <a:rPr lang="hu-HU" baseline="0" dirty="0" smtClean="0"/>
              <a:t> </a:t>
            </a:r>
            <a:r>
              <a:rPr lang="hu-HU" baseline="0" dirty="0"/>
              <a:t>RBR </a:t>
            </a:r>
            <a:r>
              <a:rPr lang="hu-HU" baseline="0" dirty="0" err="1"/>
              <a:t>was</a:t>
            </a:r>
            <a:r>
              <a:rPr lang="hu-HU" baseline="0" dirty="0"/>
              <a:t> </a:t>
            </a:r>
            <a:r>
              <a:rPr lang="hu-HU" baseline="0" dirty="0" err="1"/>
              <a:t>precipitated</a:t>
            </a:r>
            <a:r>
              <a:rPr lang="hu-HU" baseline="0" dirty="0"/>
              <a:t> </a:t>
            </a:r>
            <a:r>
              <a:rPr lang="hu-HU" baseline="0" dirty="0" err="1"/>
              <a:t>from</a:t>
            </a:r>
            <a:r>
              <a:rPr lang="hu-HU" baseline="0" dirty="0"/>
              <a:t> </a:t>
            </a:r>
            <a:r>
              <a:rPr lang="hu-HU" baseline="0" dirty="0" err="1"/>
              <a:t>the</a:t>
            </a:r>
            <a:r>
              <a:rPr lang="hu-HU" baseline="0" dirty="0"/>
              <a:t> </a:t>
            </a:r>
            <a:r>
              <a:rPr lang="hu-HU" baseline="0" dirty="0" err="1"/>
              <a:t>root</a:t>
            </a:r>
            <a:r>
              <a:rPr lang="hu-HU" baseline="0" dirty="0"/>
              <a:t> </a:t>
            </a:r>
            <a:r>
              <a:rPr lang="hu-HU" baseline="0" dirty="0" err="1"/>
              <a:t>tip</a:t>
            </a:r>
            <a:r>
              <a:rPr lang="hu-HU" baseline="0" dirty="0"/>
              <a:t> </a:t>
            </a:r>
            <a:r>
              <a:rPr lang="hu-HU" baseline="0" dirty="0" err="1" smtClean="0"/>
              <a:t>region</a:t>
            </a:r>
            <a:r>
              <a:rPr lang="hu-HU" baseline="0" dirty="0" smtClean="0"/>
              <a:t> </a:t>
            </a:r>
            <a:r>
              <a:rPr lang="hu-HU" baseline="0" dirty="0" err="1" smtClean="0"/>
              <a:t>using</a:t>
            </a:r>
            <a:r>
              <a:rPr lang="hu-HU" baseline="0" dirty="0" smtClean="0"/>
              <a:t> a </a:t>
            </a:r>
            <a:r>
              <a:rPr lang="hu-HU" baseline="0" dirty="0" err="1"/>
              <a:t>phospho-specific</a:t>
            </a:r>
            <a:r>
              <a:rPr lang="hu-HU" baseline="0" dirty="0"/>
              <a:t> RBR </a:t>
            </a:r>
            <a:r>
              <a:rPr lang="hu-HU" baseline="0" dirty="0" err="1"/>
              <a:t>antibody</a:t>
            </a:r>
            <a:r>
              <a:rPr lang="hu-HU" baseline="0" dirty="0"/>
              <a:t>. </a:t>
            </a:r>
            <a:r>
              <a:rPr lang="hu-HU" baseline="0" dirty="0" smtClean="0"/>
              <a:t>The </a:t>
            </a:r>
            <a:r>
              <a:rPr lang="hu-HU" baseline="0" dirty="0" err="1" smtClean="0"/>
              <a:t>arrowhead</a:t>
            </a:r>
            <a:r>
              <a:rPr lang="hu-HU" baseline="0" dirty="0" smtClean="0"/>
              <a:t> </a:t>
            </a:r>
            <a:r>
              <a:rPr lang="hu-HU" baseline="0" dirty="0" err="1" smtClean="0"/>
              <a:t>denotes</a:t>
            </a:r>
            <a:r>
              <a:rPr lang="hu-HU" baseline="0" dirty="0" smtClean="0"/>
              <a:t> </a:t>
            </a:r>
            <a:r>
              <a:rPr lang="hu-HU" baseline="0" dirty="0" err="1" smtClean="0"/>
              <a:t>the</a:t>
            </a:r>
            <a:r>
              <a:rPr lang="hu-HU" baseline="0" dirty="0" smtClean="0"/>
              <a:t> </a:t>
            </a:r>
            <a:r>
              <a:rPr lang="hu-HU" baseline="0" dirty="0" err="1" smtClean="0"/>
              <a:t>accumulation</a:t>
            </a:r>
            <a:r>
              <a:rPr lang="hu-HU" baseline="0" dirty="0" smtClean="0"/>
              <a:t> of </a:t>
            </a:r>
            <a:r>
              <a:rPr lang="hu-HU" baseline="0" dirty="0" err="1" smtClean="0"/>
              <a:t>the</a:t>
            </a:r>
            <a:r>
              <a:rPr lang="hu-HU" baseline="0" dirty="0" smtClean="0"/>
              <a:t> </a:t>
            </a:r>
            <a:r>
              <a:rPr lang="hu-HU" baseline="0" dirty="0"/>
              <a:t>RBR protein </a:t>
            </a:r>
            <a:r>
              <a:rPr lang="hu-HU" baseline="0" dirty="0" smtClean="0"/>
              <a:t>in </a:t>
            </a:r>
            <a:r>
              <a:rPr lang="hu-HU" baseline="0" dirty="0" err="1" smtClean="0"/>
              <a:t>the</a:t>
            </a:r>
            <a:r>
              <a:rPr lang="hu-HU" baseline="0" dirty="0" smtClean="0"/>
              <a:t> IP </a:t>
            </a:r>
            <a:r>
              <a:rPr lang="hu-HU" baseline="0" dirty="0" err="1" smtClean="0"/>
              <a:t>at</a:t>
            </a:r>
            <a:r>
              <a:rPr lang="hu-HU" baseline="0" dirty="0" smtClean="0"/>
              <a:t> </a:t>
            </a:r>
            <a:r>
              <a:rPr lang="hu-HU" baseline="0" dirty="0" err="1"/>
              <a:t>the</a:t>
            </a:r>
            <a:r>
              <a:rPr lang="hu-HU" baseline="0" dirty="0"/>
              <a:t> </a:t>
            </a:r>
            <a:r>
              <a:rPr lang="hu-HU" baseline="0" dirty="0" err="1" smtClean="0"/>
              <a:t>expected</a:t>
            </a:r>
            <a:r>
              <a:rPr lang="hu-HU" baseline="0" dirty="0" smtClean="0"/>
              <a:t> </a:t>
            </a:r>
            <a:r>
              <a:rPr lang="hu-HU" baseline="0" dirty="0" err="1"/>
              <a:t>position</a:t>
            </a:r>
            <a:r>
              <a:rPr lang="hu-HU" baseline="0" dirty="0"/>
              <a:t>. </a:t>
            </a:r>
            <a:r>
              <a:rPr lang="hu-HU" baseline="0" dirty="0" err="1"/>
              <a:t>Molecular</a:t>
            </a:r>
            <a:r>
              <a:rPr lang="hu-HU" baseline="0" dirty="0"/>
              <a:t> </a:t>
            </a:r>
            <a:r>
              <a:rPr lang="hu-HU" baseline="0" dirty="0" err="1"/>
              <a:t>weight</a:t>
            </a:r>
            <a:r>
              <a:rPr lang="hu-HU" baseline="0" dirty="0"/>
              <a:t> is </a:t>
            </a:r>
            <a:r>
              <a:rPr lang="hu-HU" baseline="0" dirty="0" err="1"/>
              <a:t>marked</a:t>
            </a:r>
            <a:r>
              <a:rPr lang="hu-HU" baseline="0" dirty="0"/>
              <a:t> </a:t>
            </a:r>
            <a:r>
              <a:rPr lang="hu-HU" baseline="0" dirty="0" err="1"/>
              <a:t>at</a:t>
            </a:r>
            <a:r>
              <a:rPr lang="hu-HU" baseline="0" dirty="0"/>
              <a:t> </a:t>
            </a:r>
            <a:r>
              <a:rPr lang="hu-HU" baseline="0" dirty="0" err="1"/>
              <a:t>the</a:t>
            </a:r>
            <a:r>
              <a:rPr lang="hu-HU" baseline="0" dirty="0"/>
              <a:t> </a:t>
            </a:r>
            <a:r>
              <a:rPr lang="hu-HU" baseline="0" dirty="0" err="1"/>
              <a:t>left</a:t>
            </a:r>
            <a:r>
              <a:rPr lang="hu-HU" baseline="0" dirty="0"/>
              <a:t> </a:t>
            </a:r>
            <a:r>
              <a:rPr lang="hu-HU" baseline="0" dirty="0" err="1"/>
              <a:t>side</a:t>
            </a:r>
            <a:r>
              <a:rPr lang="hu-HU" baseline="0" dirty="0"/>
              <a:t>. (</a:t>
            </a:r>
            <a:r>
              <a:rPr lang="hu-HU" b="1" baseline="0" dirty="0"/>
              <a:t>C</a:t>
            </a:r>
            <a:r>
              <a:rPr lang="hu-HU" baseline="0" dirty="0"/>
              <a:t>)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palisade tissue of both proliferating and elongating Brassica leaves was examined using a differential interference contrast (DIC) microscope. Arrowheads denote the presence of condensed chromosomes, which are indicative of mitotic cells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8EA43A-EBA8-462F-85C5-0596433BDCA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7637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hu-HU" b="1" dirty="0" err="1"/>
              <a:t>Supplementary</a:t>
            </a:r>
            <a:r>
              <a:rPr lang="hu-HU" b="1" dirty="0"/>
              <a:t> </a:t>
            </a:r>
            <a:r>
              <a:rPr lang="hu-HU" b="1" dirty="0" err="1"/>
              <a:t>Figure</a:t>
            </a:r>
            <a:r>
              <a:rPr lang="hu-HU" b="1" dirty="0"/>
              <a:t> 2.</a:t>
            </a:r>
            <a:r>
              <a:rPr lang="hu-HU" b="1" baseline="0" dirty="0"/>
              <a:t> </a:t>
            </a:r>
            <a:r>
              <a:rPr lang="en-US" b="1" baseline="0" dirty="0"/>
              <a:t>The mutation of both E2FA and E2FB in the </a:t>
            </a:r>
            <a:r>
              <a:rPr lang="en-US" b="1" i="1" baseline="0" dirty="0"/>
              <a:t>e2fab </a:t>
            </a:r>
            <a:r>
              <a:rPr lang="en-US" b="1" baseline="0" dirty="0"/>
              <a:t>double mutant root meristem exhibits S-phase activity comparable to that of the corresponding wild type (WT).</a:t>
            </a:r>
            <a:r>
              <a:rPr lang="hu-HU" b="1" baseline="0" dirty="0"/>
              <a:t> </a:t>
            </a:r>
            <a:r>
              <a:rPr lang="hu-HU" b="1" baseline="0" dirty="0" smtClean="0"/>
              <a:t>A, </a:t>
            </a:r>
            <a:r>
              <a:rPr lang="en-US" dirty="0" smtClean="0"/>
              <a:t>Expression of</a:t>
            </a:r>
            <a:r>
              <a:rPr lang="hu-HU" dirty="0" smtClean="0"/>
              <a:t> </a:t>
            </a:r>
            <a:r>
              <a:rPr lang="hu-HU" i="1" dirty="0" smtClean="0"/>
              <a:t>PCNA1</a:t>
            </a:r>
            <a:r>
              <a:rPr lang="hu-HU" dirty="0" smtClean="0"/>
              <a:t> </a:t>
            </a:r>
            <a:r>
              <a:rPr lang="en-US" dirty="0" smtClean="0"/>
              <a:t>gene was monitored during leaf development of WT, </a:t>
            </a:r>
            <a:r>
              <a:rPr lang="en-US" i="1" dirty="0" smtClean="0"/>
              <a:t>e2fab</a:t>
            </a:r>
            <a:r>
              <a:rPr lang="en-US" dirty="0" smtClean="0"/>
              <a:t> and </a:t>
            </a:r>
            <a:r>
              <a:rPr lang="en-US" i="1" dirty="0" smtClean="0"/>
              <a:t>e2fabc</a:t>
            </a:r>
            <a:r>
              <a:rPr lang="en-US" dirty="0" smtClean="0"/>
              <a:t> lines at the indicated days after germination (DAG) utilizing </a:t>
            </a:r>
            <a:r>
              <a:rPr lang="en-US" dirty="0" err="1" smtClean="0"/>
              <a:t>qRT</a:t>
            </a:r>
            <a:r>
              <a:rPr lang="en-US" dirty="0" smtClean="0"/>
              <a:t>-PCR. Values represent fold changes normalized to the value of the relevant transcript of the wild type at 9DAG, which was set arbitrarily at 1. Data are means +/- sd., n=3 biological repeats. ***</a:t>
            </a:r>
            <a:r>
              <a:rPr lang="en-US" i="1" dirty="0" smtClean="0"/>
              <a:t>P</a:t>
            </a:r>
            <a:r>
              <a:rPr lang="en-US" dirty="0" smtClean="0"/>
              <a:t>&lt;0.001</a:t>
            </a:r>
            <a:r>
              <a:rPr lang="hu-HU" dirty="0" smtClean="0"/>
              <a:t>; *</a:t>
            </a:r>
            <a:r>
              <a:rPr lang="hu-HU" i="1" dirty="0" smtClean="0"/>
              <a:t>P</a:t>
            </a:r>
            <a:r>
              <a:rPr lang="hu-HU" dirty="0" smtClean="0"/>
              <a:t>&lt;0.05</a:t>
            </a:r>
            <a:r>
              <a:rPr lang="en-US" dirty="0" smtClean="0"/>
              <a:t> (two-tailed, paired </a:t>
            </a:r>
            <a:r>
              <a:rPr lang="en-US" i="1" dirty="0" smtClean="0"/>
              <a:t>t</a:t>
            </a:r>
            <a:r>
              <a:rPr lang="en-US" dirty="0" smtClean="0"/>
              <a:t> test between the WT and the mutant lines at a given time point). </a:t>
            </a:r>
            <a:r>
              <a:rPr lang="hu-HU" baseline="0" dirty="0" smtClean="0"/>
              <a:t>(</a:t>
            </a:r>
            <a:r>
              <a:rPr lang="hu-HU" b="1" baseline="0" dirty="0" smtClean="0"/>
              <a:t>B-C</a:t>
            </a:r>
            <a:r>
              <a:rPr lang="hu-HU" baseline="0" dirty="0" smtClean="0"/>
              <a:t>) </a:t>
            </a:r>
            <a:r>
              <a:rPr lang="hu-HU" baseline="0" dirty="0" err="1"/>
              <a:t>EdU</a:t>
            </a:r>
            <a:r>
              <a:rPr lang="hu-HU" baseline="0" dirty="0"/>
              <a:t> </a:t>
            </a:r>
            <a:r>
              <a:rPr lang="hu-HU" baseline="0" dirty="0" err="1"/>
              <a:t>staining</a:t>
            </a:r>
            <a:r>
              <a:rPr lang="hu-HU" baseline="0" dirty="0"/>
              <a:t> of </a:t>
            </a:r>
            <a:r>
              <a:rPr lang="hu-HU" baseline="0" dirty="0" err="1"/>
              <a:t>the</a:t>
            </a:r>
            <a:r>
              <a:rPr lang="hu-HU" baseline="0" dirty="0"/>
              <a:t> </a:t>
            </a:r>
            <a:r>
              <a:rPr lang="hu-HU" baseline="0" dirty="0" err="1"/>
              <a:t>root</a:t>
            </a:r>
            <a:r>
              <a:rPr lang="hu-HU" baseline="0" dirty="0"/>
              <a:t> </a:t>
            </a:r>
            <a:r>
              <a:rPr lang="hu-HU" baseline="0" dirty="0" err="1"/>
              <a:t>tip</a:t>
            </a:r>
            <a:r>
              <a:rPr lang="hu-HU" baseline="0" dirty="0"/>
              <a:t> of WT and </a:t>
            </a:r>
            <a:r>
              <a:rPr lang="hu-HU" i="1" baseline="0" dirty="0"/>
              <a:t>e2fab</a:t>
            </a:r>
            <a:r>
              <a:rPr lang="hu-HU" baseline="0" dirty="0"/>
              <a:t> </a:t>
            </a:r>
            <a:r>
              <a:rPr lang="hu-HU" baseline="0" dirty="0" err="1" smtClean="0"/>
              <a:t>lines</a:t>
            </a:r>
            <a:r>
              <a:rPr lang="hu-HU" baseline="0" dirty="0" smtClean="0"/>
              <a:t> </a:t>
            </a:r>
            <a:r>
              <a:rPr lang="hu-HU" baseline="0" dirty="0" err="1" smtClean="0"/>
              <a:t>five</a:t>
            </a:r>
            <a:r>
              <a:rPr lang="hu-HU" baseline="0" dirty="0" smtClean="0"/>
              <a:t> </a:t>
            </a:r>
            <a:r>
              <a:rPr lang="hu-HU" baseline="0" dirty="0" err="1" smtClean="0"/>
              <a:t>days</a:t>
            </a:r>
            <a:r>
              <a:rPr lang="hu-HU" baseline="0" dirty="0" smtClean="0"/>
              <a:t> </a:t>
            </a:r>
            <a:r>
              <a:rPr lang="hu-HU" baseline="0" dirty="0" err="1" smtClean="0"/>
              <a:t>after</a:t>
            </a:r>
            <a:r>
              <a:rPr lang="hu-HU" baseline="0" dirty="0" smtClean="0"/>
              <a:t> </a:t>
            </a:r>
            <a:r>
              <a:rPr lang="hu-HU" baseline="0" dirty="0" err="1" smtClean="0"/>
              <a:t>germination</a:t>
            </a:r>
            <a:r>
              <a:rPr lang="hu-HU" baseline="0" dirty="0" smtClean="0"/>
              <a:t>. </a:t>
            </a:r>
            <a:r>
              <a:rPr lang="hu-HU" baseline="0" dirty="0" err="1"/>
              <a:t>Merged</a:t>
            </a:r>
            <a:r>
              <a:rPr lang="hu-HU" baseline="0" dirty="0"/>
              <a:t> </a:t>
            </a:r>
            <a:r>
              <a:rPr lang="hu-HU" baseline="0" dirty="0" err="1"/>
              <a:t>images</a:t>
            </a:r>
            <a:r>
              <a:rPr lang="hu-HU" baseline="0" dirty="0"/>
              <a:t> of </a:t>
            </a:r>
            <a:r>
              <a:rPr lang="hu-HU" baseline="0" dirty="0" err="1"/>
              <a:t>EdU</a:t>
            </a:r>
            <a:r>
              <a:rPr lang="hu-HU" baseline="0" dirty="0"/>
              <a:t> and </a:t>
            </a:r>
            <a:r>
              <a:rPr lang="hu-HU" baseline="0" dirty="0" err="1"/>
              <a:t>Hoechst</a:t>
            </a:r>
            <a:r>
              <a:rPr lang="hu-HU" baseline="0" dirty="0"/>
              <a:t> </a:t>
            </a:r>
            <a:r>
              <a:rPr lang="hu-HU" baseline="0" dirty="0" err="1"/>
              <a:t>staining</a:t>
            </a:r>
            <a:r>
              <a:rPr lang="hu-HU" baseline="0" dirty="0"/>
              <a:t> of </a:t>
            </a:r>
            <a:r>
              <a:rPr lang="hu-HU" baseline="0" dirty="0" err="1"/>
              <a:t>root</a:t>
            </a:r>
            <a:r>
              <a:rPr lang="hu-HU" baseline="0" dirty="0"/>
              <a:t> </a:t>
            </a:r>
            <a:r>
              <a:rPr lang="hu-HU" baseline="0" dirty="0" err="1"/>
              <a:t>tips</a:t>
            </a:r>
            <a:r>
              <a:rPr lang="hu-HU" baseline="0" dirty="0"/>
              <a:t> </a:t>
            </a:r>
            <a:r>
              <a:rPr lang="hu-HU" baseline="0" dirty="0" err="1"/>
              <a:t>shown</a:t>
            </a:r>
            <a:r>
              <a:rPr lang="hu-HU" baseline="0" dirty="0"/>
              <a:t> in </a:t>
            </a:r>
            <a:r>
              <a:rPr lang="hu-HU" b="1" baseline="0" dirty="0"/>
              <a:t>C</a:t>
            </a:r>
            <a:r>
              <a:rPr lang="hu-HU" baseline="0" dirty="0" smtClean="0"/>
              <a:t>. </a:t>
            </a:r>
            <a:r>
              <a:rPr lang="hu-HU" baseline="0" dirty="0" err="1"/>
              <a:t>Scale</a:t>
            </a:r>
            <a:r>
              <a:rPr lang="hu-HU" baseline="0" dirty="0"/>
              <a:t> bar is 100 µm in </a:t>
            </a:r>
            <a:r>
              <a:rPr lang="hu-HU" b="1" baseline="0" dirty="0"/>
              <a:t>B</a:t>
            </a:r>
            <a:r>
              <a:rPr lang="hu-HU" baseline="0" dirty="0" smtClean="0"/>
              <a:t> </a:t>
            </a:r>
            <a:r>
              <a:rPr lang="hu-HU" baseline="0" dirty="0"/>
              <a:t>and 25 µm in </a:t>
            </a:r>
            <a:r>
              <a:rPr lang="hu-HU" b="1" baseline="0" dirty="0"/>
              <a:t>C</a:t>
            </a:r>
            <a:r>
              <a:rPr lang="hu-HU" baseline="0" dirty="0" smtClean="0"/>
              <a:t>. (</a:t>
            </a:r>
            <a:r>
              <a:rPr lang="hu-HU" b="1" baseline="0" dirty="0"/>
              <a:t>D</a:t>
            </a:r>
            <a:r>
              <a:rPr lang="hu-HU" baseline="0" dirty="0" smtClean="0"/>
              <a:t>) </a:t>
            </a:r>
            <a:r>
              <a:rPr lang="hu-HU" baseline="0" dirty="0" err="1"/>
              <a:t>Number</a:t>
            </a:r>
            <a:r>
              <a:rPr lang="hu-HU" baseline="0" dirty="0"/>
              <a:t> of </a:t>
            </a:r>
            <a:r>
              <a:rPr lang="hu-HU" baseline="0" dirty="0" err="1"/>
              <a:t>EdU</a:t>
            </a:r>
            <a:r>
              <a:rPr lang="hu-HU" baseline="0" dirty="0"/>
              <a:t> </a:t>
            </a:r>
            <a:r>
              <a:rPr lang="hu-HU" baseline="0" dirty="0" err="1"/>
              <a:t>positive</a:t>
            </a:r>
            <a:r>
              <a:rPr lang="hu-HU" baseline="0" dirty="0"/>
              <a:t> </a:t>
            </a:r>
            <a:r>
              <a:rPr lang="hu-HU" baseline="0" dirty="0" err="1"/>
              <a:t>cells</a:t>
            </a:r>
            <a:r>
              <a:rPr lang="hu-HU" baseline="0" dirty="0"/>
              <a:t> in </a:t>
            </a:r>
            <a:r>
              <a:rPr lang="hu-HU" baseline="0" dirty="0" err="1"/>
              <a:t>the</a:t>
            </a:r>
            <a:r>
              <a:rPr lang="hu-HU" baseline="0" dirty="0"/>
              <a:t> </a:t>
            </a:r>
            <a:r>
              <a:rPr lang="hu-HU" baseline="0" dirty="0" err="1"/>
              <a:t>root</a:t>
            </a:r>
            <a:r>
              <a:rPr lang="hu-HU" baseline="0" dirty="0"/>
              <a:t> </a:t>
            </a:r>
            <a:r>
              <a:rPr lang="hu-HU" baseline="0" dirty="0" err="1"/>
              <a:t>meristems</a:t>
            </a:r>
            <a:r>
              <a:rPr lang="hu-HU" baseline="0" dirty="0"/>
              <a:t> of WT and </a:t>
            </a:r>
            <a:r>
              <a:rPr lang="hu-HU" i="1" baseline="0" dirty="0"/>
              <a:t>e2fab</a:t>
            </a:r>
            <a:r>
              <a:rPr lang="hu-HU" baseline="0" dirty="0"/>
              <a:t> lines. </a:t>
            </a:r>
            <a:r>
              <a:rPr lang="hu-HU" baseline="0" dirty="0" err="1"/>
              <a:t>Average</a:t>
            </a:r>
            <a:r>
              <a:rPr lang="hu-HU" baseline="0" dirty="0"/>
              <a:t> of 10 </a:t>
            </a:r>
            <a:r>
              <a:rPr lang="hu-HU" baseline="0" dirty="0" err="1"/>
              <a:t>roots</a:t>
            </a:r>
            <a:r>
              <a:rPr lang="hu-HU" baseline="0" dirty="0"/>
              <a:t> </a:t>
            </a:r>
            <a:r>
              <a:rPr lang="hu-HU" baseline="0" dirty="0" err="1"/>
              <a:t>were</a:t>
            </a:r>
            <a:r>
              <a:rPr lang="hu-HU" baseline="0" dirty="0"/>
              <a:t> </a:t>
            </a:r>
            <a:r>
              <a:rPr lang="hu-HU" baseline="0" dirty="0" err="1"/>
              <a:t>imaged</a:t>
            </a:r>
            <a:r>
              <a:rPr lang="hu-HU" baseline="0" dirty="0"/>
              <a:t> </a:t>
            </a:r>
            <a:r>
              <a:rPr lang="hu-HU" baseline="0" dirty="0" err="1"/>
              <a:t>for</a:t>
            </a:r>
            <a:r>
              <a:rPr lang="hu-HU" baseline="0" dirty="0"/>
              <a:t> </a:t>
            </a:r>
            <a:r>
              <a:rPr lang="hu-HU" baseline="0" dirty="0" err="1"/>
              <a:t>each</a:t>
            </a:r>
            <a:r>
              <a:rPr lang="hu-HU" baseline="0" dirty="0"/>
              <a:t> </a:t>
            </a:r>
            <a:r>
              <a:rPr lang="hu-HU" baseline="0" dirty="0" err="1"/>
              <a:t>genotype</a:t>
            </a:r>
            <a:r>
              <a:rPr lang="hu-HU" baseline="0" dirty="0"/>
              <a:t>. Data </a:t>
            </a:r>
            <a:r>
              <a:rPr lang="hu-HU" baseline="0" dirty="0" err="1"/>
              <a:t>are</a:t>
            </a:r>
            <a:r>
              <a:rPr lang="hu-HU" baseline="0" dirty="0"/>
              <a:t> </a:t>
            </a:r>
            <a:r>
              <a:rPr lang="hu-HU" baseline="0" dirty="0" err="1"/>
              <a:t>average</a:t>
            </a:r>
            <a:r>
              <a:rPr lang="hu-HU" baseline="0" dirty="0"/>
              <a:t> +/- standard </a:t>
            </a:r>
            <a:r>
              <a:rPr lang="hu-HU" baseline="0" dirty="0" err="1"/>
              <a:t>deviation</a:t>
            </a:r>
            <a:r>
              <a:rPr lang="hu-HU" baseline="0" dirty="0"/>
              <a:t> (n= 3 </a:t>
            </a:r>
            <a:r>
              <a:rPr lang="hu-HU" baseline="0" dirty="0" err="1"/>
              <a:t>biological</a:t>
            </a:r>
            <a:r>
              <a:rPr lang="hu-HU" baseline="0" dirty="0"/>
              <a:t> </a:t>
            </a:r>
            <a:r>
              <a:rPr lang="hu-HU" baseline="0" dirty="0" err="1"/>
              <a:t>replicates</a:t>
            </a:r>
            <a:r>
              <a:rPr lang="hu-HU" baseline="0" dirty="0"/>
              <a:t>, N= 10 </a:t>
            </a:r>
            <a:r>
              <a:rPr lang="hu-HU" baseline="0" dirty="0" err="1"/>
              <a:t>samples</a:t>
            </a:r>
            <a:r>
              <a:rPr lang="hu-HU" baseline="0" dirty="0"/>
              <a:t> in </a:t>
            </a:r>
            <a:r>
              <a:rPr lang="hu-HU" baseline="0" dirty="0" err="1"/>
              <a:t>each</a:t>
            </a:r>
            <a:r>
              <a:rPr lang="hu-HU" baseline="0" dirty="0"/>
              <a:t>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8EA43A-EBA8-462F-85C5-0596433BDCAF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96815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u-HU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</a:t>
            </a:r>
            <a:r>
              <a:rPr lang="hu-HU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hu-HU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3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RBR protein exhibits stability at the 911S CDK site when in complex with E2F-DP, whereas it demonstrates increased mobility in its monomeric form. </a:t>
            </a:r>
            <a:r>
              <a:rPr lang="hu-HU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,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exibility of both the monomeric and E2F-DP complex forms of RBR was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aluated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sing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lecular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ynamics (MD) simulations. A higher root-mean-square-fluctuation (RMSF) value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gnifies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creased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sitional flexibility. Three MD simulations were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formed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 RBR in complex with E2FB and DPB (series 1 to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ed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rk-light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lue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nes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for monomeric RBR (series 4 to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noted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y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-yellow</a:t>
            </a:r>
            <a:r>
              <a:rPr lang="hu-HU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nes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flexibility of the regions spanning amino acid residues 361 to 420 and 851 to 1011 is highlighted in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respectively.</a:t>
            </a:r>
            <a:r>
              <a:rPr lang="hu-HU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contrast to 911S, 406T is situated in a flexible region in both its complex with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2F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DP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its monomeric form, rendering it presumably more accessible to CDK enzymes.</a:t>
            </a:r>
            <a:endParaRPr lang="en-US" dirty="0"/>
          </a:p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8EA43A-EBA8-462F-85C5-0596433BDCAF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81603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u-HU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</a:t>
            </a:r>
            <a:r>
              <a:rPr lang="hu-HU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hu-HU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. The P-RBR </a:t>
            </a:r>
            <a:r>
              <a:rPr lang="hu-HU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sociated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s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e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plicated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protein </a:t>
            </a:r>
            <a:r>
              <a:rPr lang="hu-HU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lation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in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i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cago</a:t>
            </a:r>
            <a:r>
              <a:rPr lang="hu-HU" sz="1200" b="1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i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uncatula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hu-HU" sz="1200" b="1" i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assica</a:t>
            </a:r>
            <a:r>
              <a:rPr lang="hu-HU" sz="1200" b="1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b="1" i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apus</a:t>
            </a:r>
            <a:r>
              <a:rPr lang="hu-H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tology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GO)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richment analysis of interactors of P-RBR</a:t>
            </a:r>
            <a:r>
              <a:rPr lang="hu-HU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911S</a:t>
            </a:r>
            <a:r>
              <a:rPr lang="hu-HU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related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rms was conducted in the root tip of </a:t>
            </a:r>
            <a:r>
              <a:rPr lang="en-GB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cago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uncatula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hu-HU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 first leaf of </a:t>
            </a:r>
            <a:r>
              <a:rPr lang="en-GB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assica </a:t>
            </a:r>
            <a:r>
              <a:rPr lang="en-GB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apus</a:t>
            </a:r>
            <a:r>
              <a:rPr lang="hu-HU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</a:t>
            </a:r>
            <a:r>
              <a:rPr lang="hu-HU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is analysis identified the top twenty enriched Biological Processes, as determined using the Shiny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O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eb tool, with a false discovery rate (FDR) of less than 0.05.</a:t>
            </a:r>
            <a:endParaRPr lang="hu-HU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E3B93-34C2-466C-A56D-F6ABA8A949B8}" type="slidenum">
              <a:rPr lang="hu-HU" smtClean="0"/>
              <a:t>4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0722263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hu-HU" b="1" dirty="0" err="1" smtClean="0"/>
              <a:t>Supplementary</a:t>
            </a:r>
            <a:r>
              <a:rPr lang="hu-HU" b="1" dirty="0" smtClean="0"/>
              <a:t> </a:t>
            </a:r>
            <a:r>
              <a:rPr lang="hu-HU" b="1" dirty="0" err="1" smtClean="0"/>
              <a:t>Table</a:t>
            </a:r>
            <a:r>
              <a:rPr lang="hu-HU" b="1" dirty="0" smtClean="0"/>
              <a:t> 1</a:t>
            </a:r>
            <a:r>
              <a:rPr lang="hu-HU" dirty="0" smtClean="0"/>
              <a:t>.</a:t>
            </a:r>
            <a:r>
              <a:rPr lang="hu-HU" baseline="0" dirty="0" smtClean="0"/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osphorylat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K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te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av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en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entifi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lant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BR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ecifically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abidopsi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aliana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_RBR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assica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apu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n_RBR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cago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uncatula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tr_RBR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s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r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munoprecipitat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sing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ospho-specific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human RbS807/811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body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llow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y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s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ectrometry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osphorylat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reonin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rin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K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te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dicat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sition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DK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tes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_RBR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n_RBR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tr_RBR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lighted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yellow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een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urple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hu-H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pectively</a:t>
            </a:r>
            <a:r>
              <a:rPr lang="hu-H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hu-H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3F96DC-FE33-4E24-88B7-7DBCDB608B04}" type="slidenum">
              <a:rPr lang="hu-HU" smtClean="0"/>
              <a:t>5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519487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000" b="1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Table </a:t>
            </a:r>
            <a:r>
              <a:rPr lang="hu-HU" sz="1000" b="1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.</a:t>
            </a:r>
            <a:r>
              <a:rPr lang="en-US" sz="1000" b="1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List of primers and their sequences used for </a:t>
            </a:r>
            <a:r>
              <a:rPr lang="en-US" sz="1000" b="1" i="0" u="none" strike="noStrike" kern="1200" baseline="0" dirty="0" err="1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qRT</a:t>
            </a:r>
            <a:r>
              <a:rPr lang="en-US" sz="1000" b="1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-PCR analysis.</a:t>
            </a:r>
            <a:r>
              <a:rPr lang="hu-HU" sz="1000" b="0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sz="1000" b="0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the first row from left to right, gene identification (GI), gene’s name, forward (FWD) and reverse (REV)</a:t>
            </a:r>
            <a:r>
              <a:rPr lang="hu-HU" sz="1000" b="0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sz="1000" b="0" i="0" u="none" strike="noStrike" kern="1200" baseline="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equences, and the product size of the PCRs in base pair (PROD. SIZE).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3F96DC-FE33-4E24-88B7-7DBCDB608B04}" type="slidenum">
              <a:rPr lang="hu-HU" smtClean="0"/>
              <a:t>6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54386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CD98C13-16C6-0E12-4B6A-1E8DA28FAD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5B419264-B8D4-B5D3-35AE-CE248CEA86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4A5C3A2-7D3E-AD80-B1FD-A91EEE266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75D97202-7638-08F2-EF80-D525122F5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8DA5D5DE-418B-22E1-0D82-8DAAC5C48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92897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242266A-8433-8B9E-68AB-220E638E4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3DE3A389-4B0E-4B97-326A-C5BCCB6B46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1C95169-053C-B374-0309-FEE065D512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4D038CE-47C3-A2FC-A140-751AE36D7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1AA836AB-1125-5E53-EDB0-AFD91B530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99396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30AEBD61-B8BD-BB6E-2C4B-F8DDC99F82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F8DD01DD-9F75-62DB-691D-36912E25BE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BD7C4589-1DC6-7C31-447B-7D38692F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56D312B-5137-C095-6C2C-DCA2237AE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37D781D-175B-DF6E-5DB2-74ED1BBF6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14716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41A9DC8-38EB-0922-F348-9D45DCB99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3B492D2-4A54-393E-0427-F24EA9CD08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94C5B32-1160-D47E-77BF-8F23C9201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874DBCF7-CF7C-0D84-2646-B4FC264A9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C7DE5E4B-0924-95A3-2D93-E854BB3FA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89138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56CD9FC-1E6C-EC7E-44C0-64269FA15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9FC45ADD-C9A6-D593-1C2C-AD220A51BF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C08854A0-8D88-E70C-EF55-8B76459B0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B32F5A8-585E-0306-A350-BC4D80A86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924AA82-5193-B192-565D-4AE20A4E1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81216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3664EE6-BB16-E12E-467E-AA39B056E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63E53064-E466-65B8-3A23-35AE44FEB7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B5E30F36-E0AE-C5F2-04B9-3F9559FDED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ABAAA944-F9C8-7DE7-297D-43F289F81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BD7C6486-B374-A62E-BE92-D95C4155C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026D4428-B213-6B49-1AA3-2F9185860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1505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85AE604-3D68-8F30-EE69-958714B12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9560748B-5671-2608-4DA1-4A9283A6B9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5D7AA1AE-B8F0-929A-B728-3F0E339BF0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CBD4BB67-BCFC-F7B8-4B6F-CCEE01624B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A27A4AC7-EC53-0069-D0C8-88BF383682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925A2C45-23C0-A939-0FBA-2A09A35C4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2E914A66-18CC-781A-8F57-4EE12F940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3EC089FB-2F20-1EB3-FD06-A044AE111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32356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DCD24DA-7B56-70EA-D745-6432603E15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ED7C078F-D83B-0844-7C33-0618F467B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1EF1B4AF-3C5E-7BED-FDE9-E563F424E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6B88D70E-D9CB-2063-D64A-A5DDA2ABE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65307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24FC1495-3F98-4EC5-B8B4-7520DAD35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5C9F86BF-2570-8EA2-037D-6CCD37662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8981D97A-BF3B-C6AA-74F3-C5BA17C5F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04818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5C7FDF6-3337-78AD-9819-7D45674801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A60EAD49-EF56-4A42-5248-987070ACB1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50E0132-DA74-96C2-5216-BB225F6CE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53FB9EF7-D360-E511-CC94-26C61121A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A99179E4-C8E1-0B6B-D2A0-5F4290E45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3DA67368-1809-156F-C99C-D51508016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87809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C5F60F0-DF2A-A0C8-59CC-A5D6A0CA74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60F73358-7062-E548-3108-335E9C16F8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612B11B8-7406-01EF-DDB4-531584773D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8756F056-47F4-2B51-EF10-C713033CF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A456BC5E-6E04-C876-23ED-13ACDA7BF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AE27007-A490-7C86-11C2-40AE8EF6A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0439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C48A5BDE-AD68-F26E-A781-2422A7D3AC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D57ED098-F180-658C-7518-5CDE947914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91C23D8-4135-983E-7933-B2BEAE2EC5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0A861D-B76D-48C0-AF30-2A7FF1ED8BDD}" type="datetimeFigureOut">
              <a:rPr lang="hu-HU" smtClean="0"/>
              <a:t>2026. 01. 0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1B0851E-0A5C-D8C3-0881-5919457AEF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74A8C63-EEE5-D8AC-ACD9-4CB32A9720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9CFD4F-0D50-41EF-B1D0-0E18F49996E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96711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png"/><Relationship Id="rId18" Type="http://schemas.microsoft.com/office/2018/10/relationships/comments" Target="../comments/modernComment_112_23FE84C7.xml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3.jpeg"/><Relationship Id="rId2" Type="http://schemas.openxmlformats.org/officeDocument/2006/relationships/notesSlide" Target="../notesSlides/notesSlide1.xml"/><Relationship Id="rId16" Type="http://schemas.microsoft.com/office/2007/relationships/hdphoto" Target="../media/hdphoto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2.pn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jpeg"/><Relationship Id="rId7" Type="http://schemas.openxmlformats.org/officeDocument/2006/relationships/image" Target="../media/image17.jpeg"/><Relationship Id="rId12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eg"/><Relationship Id="rId11" Type="http://schemas.microsoft.com/office/2007/relationships/hdphoto" Target="../media/hdphoto4.wdp"/><Relationship Id="rId5" Type="http://schemas.openxmlformats.org/officeDocument/2006/relationships/chart" Target="../charts/chart1.xml"/><Relationship Id="rId10" Type="http://schemas.openxmlformats.org/officeDocument/2006/relationships/image" Target="../media/image19.png"/><Relationship Id="rId4" Type="http://schemas.openxmlformats.org/officeDocument/2006/relationships/image" Target="../media/image15.png"/><Relationship Id="rId9" Type="http://schemas.microsoft.com/office/2007/relationships/hdphoto" Target="../media/hdphoto3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microsoft.com/office/2018/10/relationships/comments" Target="../comments/modernComment_117_500BA9A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2431757" y="785895"/>
            <a:ext cx="2346305" cy="4314718"/>
            <a:chOff x="3341190" y="-95710"/>
            <a:chExt cx="3668220" cy="6745501"/>
          </a:xfrm>
        </p:grpSpPr>
        <p:grpSp>
          <p:nvGrpSpPr>
            <p:cNvPr id="3" name="Group 2"/>
            <p:cNvGrpSpPr/>
            <p:nvPr/>
          </p:nvGrpSpPr>
          <p:grpSpPr>
            <a:xfrm>
              <a:off x="3408286" y="423517"/>
              <a:ext cx="3601124" cy="6226274"/>
              <a:chOff x="3387810" y="2441978"/>
              <a:chExt cx="3601124" cy="6226274"/>
            </a:xfrm>
          </p:grpSpPr>
          <p:grpSp>
            <p:nvGrpSpPr>
              <p:cNvPr id="5" name="Group 4"/>
              <p:cNvGrpSpPr>
                <a:grpSpLocks noChangeAspect="1"/>
              </p:cNvGrpSpPr>
              <p:nvPr/>
            </p:nvGrpSpPr>
            <p:grpSpPr>
              <a:xfrm>
                <a:off x="4614122" y="2496051"/>
                <a:ext cx="2374812" cy="6172200"/>
                <a:chOff x="5614900" y="1152160"/>
                <a:chExt cx="3282129" cy="8530335"/>
              </a:xfrm>
            </p:grpSpPr>
            <p:pic>
              <p:nvPicPr>
                <p:cNvPr id="12" name="Picture 11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5614900" y="1152160"/>
                  <a:ext cx="2438401" cy="2438400"/>
                </a:xfrm>
                <a:prstGeom prst="rect">
                  <a:avLst/>
                </a:prstGeom>
              </p:spPr>
            </p:pic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6075807" y="2951280"/>
                  <a:ext cx="2438400" cy="2438400"/>
                </a:xfrm>
                <a:prstGeom prst="rect">
                  <a:avLst/>
                </a:prstGeom>
              </p:spPr>
            </p:pic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6233066" y="4382218"/>
                  <a:ext cx="2438400" cy="2438400"/>
                </a:xfrm>
                <a:prstGeom prst="rect">
                  <a:avLst/>
                </a:prstGeom>
              </p:spPr>
            </p:pic>
            <p:pic>
              <p:nvPicPr>
                <p:cNvPr id="15" name="Picture 14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6054984" y="5761472"/>
                  <a:ext cx="2438400" cy="2438400"/>
                </a:xfrm>
                <a:prstGeom prst="rect">
                  <a:avLst/>
                </a:prstGeom>
              </p:spPr>
            </p:pic>
            <p:pic>
              <p:nvPicPr>
                <p:cNvPr id="16" name="Picture 15"/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6458629" y="7244095"/>
                  <a:ext cx="2438400" cy="2438400"/>
                </a:xfrm>
                <a:prstGeom prst="rect">
                  <a:avLst/>
                </a:prstGeom>
              </p:spPr>
            </p:pic>
          </p:grpSp>
          <p:grpSp>
            <p:nvGrpSpPr>
              <p:cNvPr id="6" name="Group 5"/>
              <p:cNvGrpSpPr>
                <a:grpSpLocks noChangeAspect="1"/>
              </p:cNvGrpSpPr>
              <p:nvPr/>
            </p:nvGrpSpPr>
            <p:grpSpPr>
              <a:xfrm>
                <a:off x="3387810" y="2441978"/>
                <a:ext cx="2333125" cy="6226274"/>
                <a:chOff x="3101013" y="1153353"/>
                <a:chExt cx="3196068" cy="8529142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3101013" y="1153353"/>
                  <a:ext cx="2438400" cy="2438400"/>
                </a:xfrm>
                <a:prstGeom prst="rect">
                  <a:avLst/>
                </a:prstGeom>
              </p:spPr>
            </p:pic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3525600" y="2955623"/>
                  <a:ext cx="2438400" cy="2438400"/>
                </a:xfrm>
                <a:prstGeom prst="rect">
                  <a:avLst/>
                </a:prstGeom>
              </p:spPr>
            </p:pic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3641865" y="4382217"/>
                  <a:ext cx="2438400" cy="2438400"/>
                </a:xfrm>
                <a:prstGeom prst="rect">
                  <a:avLst/>
                </a:prstGeom>
              </p:spPr>
            </p:pic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3476535" y="5751314"/>
                  <a:ext cx="2438400" cy="2438400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0800000">
                  <a:off x="3858681" y="7244095"/>
                  <a:ext cx="2438400" cy="2438400"/>
                </a:xfrm>
                <a:prstGeom prst="rect">
                  <a:avLst/>
                </a:prstGeom>
              </p:spPr>
            </p:pic>
          </p:grpSp>
        </p:grpSp>
        <p:sp>
          <p:nvSpPr>
            <p:cNvPr id="4" name="TextBox 3"/>
            <p:cNvSpPr txBox="1"/>
            <p:nvPr/>
          </p:nvSpPr>
          <p:spPr>
            <a:xfrm>
              <a:off x="3341190" y="-95710"/>
              <a:ext cx="2709638" cy="625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0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dicago</a:t>
              </a:r>
              <a:r>
                <a:rPr lang="hu-HU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10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uncatula</a:t>
              </a:r>
              <a:r>
                <a:rPr lang="hu-HU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</a:t>
              </a:r>
              <a:r>
                <a:rPr lang="hu-HU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ip</a:t>
              </a:r>
              <a:endPara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dU</a:t>
              </a:r>
              <a:r>
                <a:rPr lang="hu-HU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belling</a:t>
              </a:r>
              <a:r>
                <a:rPr lang="hu-HU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or</a:t>
              </a:r>
              <a:r>
                <a:rPr lang="hu-HU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5359685" y="3113814"/>
            <a:ext cx="3893936" cy="2112949"/>
            <a:chOff x="3517363" y="1289133"/>
            <a:chExt cx="4792536" cy="2600553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24838" y="1504625"/>
              <a:ext cx="2385061" cy="2385061"/>
            </a:xfrm>
            <a:prstGeom prst="rect">
              <a:avLst/>
            </a:prstGeom>
          </p:spPr>
        </p:pic>
        <p:grpSp>
          <p:nvGrpSpPr>
            <p:cNvPr id="34" name="Group 33"/>
            <p:cNvGrpSpPr/>
            <p:nvPr/>
          </p:nvGrpSpPr>
          <p:grpSpPr>
            <a:xfrm>
              <a:off x="3517363" y="1293515"/>
              <a:ext cx="2385061" cy="2596171"/>
              <a:chOff x="1026945" y="1272219"/>
              <a:chExt cx="2385061" cy="2596171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026945" y="1483329"/>
                <a:ext cx="2385061" cy="2385061"/>
              </a:xfrm>
              <a:prstGeom prst="rect">
                <a:avLst/>
              </a:prstGeom>
            </p:spPr>
          </p:pic>
          <p:cxnSp>
            <p:nvCxnSpPr>
              <p:cNvPr id="37" name="Straight Arrow Connector 36"/>
              <p:cNvCxnSpPr/>
              <p:nvPr/>
            </p:nvCxnSpPr>
            <p:spPr>
              <a:xfrm flipH="1">
                <a:off x="2600127" y="1809856"/>
                <a:ext cx="14197" cy="170362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/>
              <p:cNvCxnSpPr/>
              <p:nvPr/>
            </p:nvCxnSpPr>
            <p:spPr>
              <a:xfrm>
                <a:off x="2176391" y="2172037"/>
                <a:ext cx="59449" cy="120673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Arrow Connector 38"/>
              <p:cNvCxnSpPr/>
              <p:nvPr/>
            </p:nvCxnSpPr>
            <p:spPr>
              <a:xfrm flipH="1">
                <a:off x="2570625" y="2615524"/>
                <a:ext cx="143077" cy="60336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1807100" y="1272219"/>
                <a:ext cx="1138773" cy="303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oung </a:t>
                </a:r>
                <a:r>
                  <a:rPr lang="hu-HU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f</a:t>
                </a:r>
                <a:r>
                  <a:rPr lang="hu-HU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6641123" y="1289133"/>
              <a:ext cx="1426821" cy="3030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longating</a:t>
              </a:r>
              <a:r>
                <a:rPr lang="hu-HU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af</a:t>
              </a:r>
              <a:r>
                <a:rPr lang="hu-HU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6082926" y="782199"/>
            <a:ext cx="2174680" cy="2294748"/>
            <a:chOff x="8295037" y="117145"/>
            <a:chExt cx="2676529" cy="2824305"/>
          </a:xfrm>
        </p:grpSpPr>
        <p:sp>
          <p:nvSpPr>
            <p:cNvPr id="42" name="TextBox 41"/>
            <p:cNvSpPr txBox="1"/>
            <p:nvPr/>
          </p:nvSpPr>
          <p:spPr>
            <a:xfrm>
              <a:off x="8295037" y="117145"/>
              <a:ext cx="438385" cy="3907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6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,</a:t>
              </a:r>
              <a:endParaRPr lang="en-GB" sz="146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3" name="Group 42"/>
            <p:cNvGrpSpPr/>
            <p:nvPr/>
          </p:nvGrpSpPr>
          <p:grpSpPr>
            <a:xfrm>
              <a:off x="8630870" y="246166"/>
              <a:ext cx="2340696" cy="2695284"/>
              <a:chOff x="8094605" y="1699902"/>
              <a:chExt cx="2340696" cy="2695284"/>
            </a:xfrm>
          </p:grpSpPr>
          <p:grpSp>
            <p:nvGrpSpPr>
              <p:cNvPr id="45" name="Group 44"/>
              <p:cNvGrpSpPr/>
              <p:nvPr/>
            </p:nvGrpSpPr>
            <p:grpSpPr>
              <a:xfrm>
                <a:off x="8094605" y="2149577"/>
                <a:ext cx="2340696" cy="2245609"/>
                <a:chOff x="6945215" y="4469973"/>
                <a:chExt cx="2340696" cy="2245609"/>
              </a:xfrm>
            </p:grpSpPr>
            <p:grpSp>
              <p:nvGrpSpPr>
                <p:cNvPr id="49" name="Group 48"/>
                <p:cNvGrpSpPr/>
                <p:nvPr/>
              </p:nvGrpSpPr>
              <p:grpSpPr>
                <a:xfrm>
                  <a:off x="7267892" y="4469973"/>
                  <a:ext cx="1275176" cy="1948624"/>
                  <a:chOff x="4830432" y="4310947"/>
                  <a:chExt cx="1275176" cy="1948624"/>
                </a:xfrm>
              </p:grpSpPr>
              <p:pic>
                <p:nvPicPr>
                  <p:cNvPr id="55" name="Picture 54"/>
                  <p:cNvPicPr>
                    <a:picLocks noChangeAspect="1"/>
                  </p:cNvPicPr>
                  <p:nvPr/>
                </p:nvPicPr>
                <p:blipFill rotWithShape="1">
                  <a:blip r:embed="rId1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2737" r="73273"/>
                  <a:stretch/>
                </p:blipFill>
                <p:spPr>
                  <a:xfrm>
                    <a:off x="5001370" y="4730031"/>
                    <a:ext cx="341907" cy="1529540"/>
                  </a:xfrm>
                  <a:prstGeom prst="rect">
                    <a:avLst/>
                  </a:prstGeom>
                </p:spPr>
              </p:pic>
              <p:pic>
                <p:nvPicPr>
                  <p:cNvPr id="56" name="Picture 55"/>
                  <p:cNvPicPr>
                    <a:picLocks noChangeAspect="1"/>
                  </p:cNvPicPr>
                  <p:nvPr/>
                </p:nvPicPr>
                <p:blipFill rotWithShape="1">
                  <a:blip r:embed="rId1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9405" r="27256"/>
                  <a:stretch/>
                </p:blipFill>
                <p:spPr>
                  <a:xfrm>
                    <a:off x="5319424" y="4730031"/>
                    <a:ext cx="326004" cy="1529540"/>
                  </a:xfrm>
                  <a:prstGeom prst="rect">
                    <a:avLst/>
                  </a:prstGeom>
                </p:spPr>
              </p:pic>
              <p:sp>
                <p:nvSpPr>
                  <p:cNvPr id="57" name="TextBox 56"/>
                  <p:cNvSpPr txBox="1"/>
                  <p:nvPr/>
                </p:nvSpPr>
                <p:spPr>
                  <a:xfrm rot="18934719">
                    <a:off x="4830432" y="4310947"/>
                    <a:ext cx="986859" cy="30304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nput</a:t>
                    </a:r>
                    <a:r>
                      <a:rPr lang="hu-HU" sz="813" b="1" dirty="0"/>
                      <a:t> 1/40</a:t>
                    </a:r>
                    <a:endParaRPr lang="en-GB" sz="813" b="1" dirty="0"/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 rot="19178968">
                    <a:off x="5183857" y="4329650"/>
                    <a:ext cx="921751" cy="30304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hu-HU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-RBR-IP</a:t>
                    </a:r>
                    <a:endParaRPr lang="en-GB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50" name="Straight Connector 49"/>
                <p:cNvCxnSpPr/>
                <p:nvPr/>
              </p:nvCxnSpPr>
              <p:spPr>
                <a:xfrm>
                  <a:off x="7272329" y="5402460"/>
                  <a:ext cx="15571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TextBox 50"/>
                <p:cNvSpPr txBox="1"/>
                <p:nvPr/>
              </p:nvSpPr>
              <p:spPr>
                <a:xfrm>
                  <a:off x="6945215" y="5274209"/>
                  <a:ext cx="422602" cy="267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13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en-GB" sz="813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7312470" y="6412541"/>
                  <a:ext cx="876374" cy="3030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BR-WB</a:t>
                  </a:r>
                  <a:endPara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8206326" y="5515708"/>
                  <a:ext cx="1079585" cy="3030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ti-</a:t>
                  </a:r>
                  <a:r>
                    <a:rPr lang="hu-HU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tRBR</a:t>
                  </a:r>
                  <a:endPara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4" name="Straight Arrow Connector 53"/>
                <p:cNvCxnSpPr/>
                <p:nvPr/>
              </p:nvCxnSpPr>
              <p:spPr>
                <a:xfrm flipH="1">
                  <a:off x="8164490" y="5416822"/>
                  <a:ext cx="91189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6" name="Straight Connector 45"/>
              <p:cNvCxnSpPr/>
              <p:nvPr/>
            </p:nvCxnSpPr>
            <p:spPr>
              <a:xfrm>
                <a:off x="8588220" y="1911085"/>
                <a:ext cx="50801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/>
              <p:cNvSpPr txBox="1"/>
              <p:nvPr/>
            </p:nvSpPr>
            <p:spPr>
              <a:xfrm>
                <a:off x="8472526" y="1699902"/>
                <a:ext cx="936232" cy="3030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t</a:t>
                </a:r>
                <a:r>
                  <a:rPr lang="hu-HU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ot</a:t>
                </a:r>
                <a:r>
                  <a:rPr lang="hu-HU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hu-HU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p</a:t>
                </a:r>
                <a:endParaRPr lang="hu-HU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8125572" y="2318623"/>
                <a:ext cx="442331" cy="2676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13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GB" sz="81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4" name="TextBox 43"/>
            <p:cNvSpPr txBox="1"/>
            <p:nvPr/>
          </p:nvSpPr>
          <p:spPr>
            <a:xfrm>
              <a:off x="9905147" y="1512945"/>
              <a:ext cx="560706" cy="3030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BR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2067982" y="370916"/>
            <a:ext cx="367408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</a:t>
            </a:r>
            <a:endParaRPr lang="en-GB" sz="14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039130" y="2992207"/>
            <a:ext cx="367408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</a:t>
            </a:r>
            <a:endParaRPr lang="en-GB" sz="14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3882695"/>
      </p:ext>
    </p:extLst>
  </p:cSld>
  <p:clrMapOvr>
    <a:masterClrMapping/>
  </p:clrMapOvr>
  <p:timing>
    <p:tnLst>
      <p:par>
        <p:cTn id="1" dur="indefinite" restart="never" nodeType="tmRoot"/>
      </p:par>
    </p:tnLst>
  </p:timing>
  <p:extLst mod="1">
    <p:ext uri="{6950BFC3-D8DA-4A85-94F7-54DA5524770B}">
      <p188:commentRel xmlns:p188="http://schemas.microsoft.com/office/powerpoint/2018/8/main" xmlns="" r:id="rId18"/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94334" y="334711"/>
            <a:ext cx="9000831" cy="545356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63" dirty="0"/>
          </a:p>
        </p:txBody>
      </p:sp>
      <p:grpSp>
        <p:nvGrpSpPr>
          <p:cNvPr id="14" name="Group 13"/>
          <p:cNvGrpSpPr/>
          <p:nvPr/>
        </p:nvGrpSpPr>
        <p:grpSpPr>
          <a:xfrm>
            <a:off x="4892665" y="379309"/>
            <a:ext cx="2497924" cy="2658890"/>
            <a:chOff x="3563620" y="1426492"/>
            <a:chExt cx="3074368" cy="327248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46"/>
            <a:stretch/>
          </p:blipFill>
          <p:spPr>
            <a:xfrm>
              <a:off x="4550108" y="1772892"/>
              <a:ext cx="2087880" cy="292608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795544" y="1480635"/>
              <a:ext cx="426548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GB" sz="813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66345" y="1426492"/>
              <a:ext cx="947401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i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2fa-2/e2fb-1</a:t>
              </a:r>
              <a:endParaRPr lang="en-GB" sz="813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4"/>
            <a:srcRect l="32005" r="36745"/>
            <a:stretch/>
          </p:blipFill>
          <p:spPr>
            <a:xfrm>
              <a:off x="3563620" y="1772892"/>
              <a:ext cx="914400" cy="2926080"/>
            </a:xfrm>
            <a:prstGeom prst="rect">
              <a:avLst/>
            </a:prstGeom>
          </p:spPr>
        </p:pic>
      </p:grpSp>
      <p:grpSp>
        <p:nvGrpSpPr>
          <p:cNvPr id="28" name="Group 27"/>
          <p:cNvGrpSpPr/>
          <p:nvPr/>
        </p:nvGrpSpPr>
        <p:grpSpPr>
          <a:xfrm>
            <a:off x="7931140" y="634287"/>
            <a:ext cx="2233637" cy="1947669"/>
            <a:chOff x="6214977" y="368709"/>
            <a:chExt cx="2749092" cy="2397131"/>
          </a:xfrm>
        </p:grpSpPr>
        <p:grpSp>
          <p:nvGrpSpPr>
            <p:cNvPr id="15" name="Group 14"/>
            <p:cNvGrpSpPr/>
            <p:nvPr/>
          </p:nvGrpSpPr>
          <p:grpSpPr>
            <a:xfrm>
              <a:off x="6220869" y="368709"/>
              <a:ext cx="2743200" cy="2397131"/>
              <a:chOff x="3342290" y="2186152"/>
              <a:chExt cx="3216165" cy="2596055"/>
            </a:xfrm>
          </p:grpSpPr>
          <p:sp>
            <p:nvSpPr>
              <p:cNvPr id="16" name="Rectangle 15"/>
              <p:cNvSpPr/>
              <p:nvPr/>
            </p:nvSpPr>
            <p:spPr>
              <a:xfrm>
                <a:off x="3342290" y="2186152"/>
                <a:ext cx="3216165" cy="25960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463"/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3615558" y="2448910"/>
                <a:ext cx="2743201" cy="2031125"/>
                <a:chOff x="3615558" y="1736835"/>
                <a:chExt cx="4572000" cy="2743200"/>
              </a:xfrm>
            </p:grpSpPr>
            <p:graphicFrame>
              <p:nvGraphicFramePr>
                <p:cNvPr id="18" name="Chart 17"/>
                <p:cNvGraphicFramePr>
                  <a:graphicFrameLocks/>
                </p:cNvGraphicFramePr>
                <p:nvPr/>
              </p:nvGraphicFramePr>
              <p:xfrm>
                <a:off x="3615558" y="1736835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19" name="Rectangle 18"/>
                <p:cNvSpPr/>
                <p:nvPr/>
              </p:nvSpPr>
              <p:spPr>
                <a:xfrm>
                  <a:off x="7136524" y="4046483"/>
                  <a:ext cx="945931" cy="262758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463"/>
                </a:p>
              </p:txBody>
            </p:sp>
          </p:grpSp>
        </p:grpSp>
        <p:sp>
          <p:nvSpPr>
            <p:cNvPr id="20" name="TextBox 19"/>
            <p:cNvSpPr txBox="1"/>
            <p:nvPr/>
          </p:nvSpPr>
          <p:spPr>
            <a:xfrm rot="16200000">
              <a:off x="5574211" y="1265764"/>
              <a:ext cx="1549142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lang="hu-HU" sz="8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S-</a:t>
              </a:r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ase</a:t>
              </a:r>
              <a:r>
                <a:rPr lang="hu-HU" sz="8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4507899" y="3306482"/>
            <a:ext cx="2882690" cy="2413080"/>
            <a:chOff x="7954246" y="2501430"/>
            <a:chExt cx="3547926" cy="2969944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44384" y="2501430"/>
              <a:ext cx="1463040" cy="1463040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39132" y="2517635"/>
              <a:ext cx="1463040" cy="1463040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44384" y="4008334"/>
              <a:ext cx="1463040" cy="146304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39132" y="4008334"/>
              <a:ext cx="1463040" cy="1463040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7954246" y="2509528"/>
              <a:ext cx="947401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i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2fa-2/e2fb-1</a:t>
              </a:r>
              <a:endParaRPr lang="en-GB" sz="813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186008" y="3964470"/>
              <a:ext cx="426548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GB" sz="813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279666" y="312177"/>
            <a:ext cx="30649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975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,</a:t>
            </a:r>
            <a:endParaRPr lang="en-GB" sz="975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463888" y="379309"/>
            <a:ext cx="30649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975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hu-HU" sz="975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endParaRPr lang="en-GB" sz="975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447263" y="314684"/>
            <a:ext cx="300082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975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,</a:t>
            </a:r>
            <a:endParaRPr lang="en-GB" sz="975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Group 32"/>
          <p:cNvGrpSpPr/>
          <p:nvPr/>
        </p:nvGrpSpPr>
        <p:grpSpPr>
          <a:xfrm>
            <a:off x="1572300" y="534464"/>
            <a:ext cx="2921665" cy="1949380"/>
            <a:chOff x="3057104" y="1939332"/>
            <a:chExt cx="2921665" cy="1949380"/>
          </a:xfrm>
        </p:grpSpPr>
        <p:sp>
          <p:nvSpPr>
            <p:cNvPr id="34" name="Rectangle 33"/>
            <p:cNvSpPr/>
            <p:nvPr/>
          </p:nvSpPr>
          <p:spPr>
            <a:xfrm>
              <a:off x="3057105" y="2034802"/>
              <a:ext cx="2546534" cy="18539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3057104" y="1939332"/>
              <a:ext cx="2921665" cy="1949380"/>
              <a:chOff x="2854583" y="1652587"/>
              <a:chExt cx="4229505" cy="2849075"/>
            </a:xfrm>
          </p:grpSpPr>
          <p:graphicFrame>
            <p:nvGraphicFramePr>
              <p:cNvPr id="36" name="Diagram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71560273"/>
                  </p:ext>
                </p:extLst>
              </p:nvPr>
            </p:nvGraphicFramePr>
            <p:xfrm>
              <a:off x="3105150" y="1652587"/>
              <a:ext cx="3978938" cy="28490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37" name="Szövegdoboz 5"/>
              <p:cNvSpPr txBox="1"/>
              <p:nvPr/>
            </p:nvSpPr>
            <p:spPr>
              <a:xfrm>
                <a:off x="3673330" y="2088716"/>
                <a:ext cx="763322" cy="254306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hu-HU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  <a:endParaRPr lang="hu-HU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>
                <a:off x="2282755" y="2898905"/>
                <a:ext cx="1500094" cy="3564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d </a:t>
                </a:r>
                <a:r>
                  <a:rPr lang="hu-HU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ange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5863564" y="4110745"/>
                <a:ext cx="4699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G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40" name="TextBox 39"/>
          <p:cNvSpPr txBox="1"/>
          <p:nvPr/>
        </p:nvSpPr>
        <p:spPr>
          <a:xfrm>
            <a:off x="4409791" y="2937010"/>
            <a:ext cx="30649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975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hu-HU" sz="975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endParaRPr lang="en-GB" sz="975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9885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>
            <a:grpSpLocks noChangeAspect="1"/>
          </p:cNvGrpSpPr>
          <p:nvPr/>
        </p:nvGrpSpPr>
        <p:grpSpPr>
          <a:xfrm>
            <a:off x="1519361" y="726358"/>
            <a:ext cx="7267073" cy="1696995"/>
            <a:chOff x="-60181" y="66674"/>
            <a:chExt cx="12252182" cy="2861109"/>
          </a:xfrm>
        </p:grpSpPr>
        <p:graphicFrame>
          <p:nvGraphicFramePr>
            <p:cNvPr id="11" name="Chart 10"/>
            <p:cNvGraphicFramePr>
              <a:graphicFrameLocks/>
            </p:cNvGraphicFramePr>
            <p:nvPr/>
          </p:nvGraphicFramePr>
          <p:xfrm>
            <a:off x="1" y="66674"/>
            <a:ext cx="1219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Rectangle 6"/>
            <p:cNvSpPr/>
            <p:nvPr/>
          </p:nvSpPr>
          <p:spPr>
            <a:xfrm>
              <a:off x="4616451" y="1460500"/>
              <a:ext cx="625415" cy="1111249"/>
            </a:xfrm>
            <a:prstGeom prst="rect">
              <a:avLst/>
            </a:prstGeom>
            <a:noFill/>
            <a:ln w="28575">
              <a:solidFill>
                <a:srgbClr val="FFC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63"/>
            </a:p>
          </p:txBody>
        </p:sp>
        <p:sp>
          <p:nvSpPr>
            <p:cNvPr id="8" name="Rectangle 7"/>
            <p:cNvSpPr/>
            <p:nvPr/>
          </p:nvSpPr>
          <p:spPr>
            <a:xfrm>
              <a:off x="10166350" y="584200"/>
              <a:ext cx="1924050" cy="1987550"/>
            </a:xfrm>
            <a:prstGeom prst="rect">
              <a:avLst/>
            </a:prstGeom>
            <a:noFill/>
            <a:ln w="28575">
              <a:solidFill>
                <a:schemeClr val="accent2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63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5733901" y="2561196"/>
              <a:ext cx="1573478" cy="3665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e</a:t>
              </a:r>
              <a:r>
                <a:rPr lang="hu-HU" sz="8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endPara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-281202" y="1254980"/>
              <a:ext cx="808629" cy="3665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MSF</a:t>
              </a:r>
              <a:endPara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1507630" y="2946364"/>
            <a:ext cx="4619827" cy="1679630"/>
            <a:chOff x="289925" y="2291480"/>
            <a:chExt cx="5685941" cy="2067236"/>
          </a:xfrm>
        </p:grpSpPr>
        <p:grpSp>
          <p:nvGrpSpPr>
            <p:cNvPr id="4" name="Group 3"/>
            <p:cNvGrpSpPr>
              <a:grpSpLocks noChangeAspect="1"/>
            </p:cNvGrpSpPr>
            <p:nvPr/>
          </p:nvGrpSpPr>
          <p:grpSpPr>
            <a:xfrm>
              <a:off x="289925" y="2291480"/>
              <a:ext cx="5685941" cy="1972797"/>
              <a:chOff x="20328" y="3839536"/>
              <a:chExt cx="6774182" cy="2350365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/>
            </p:nvGraphicFramePr>
            <p:xfrm>
              <a:off x="266801" y="3916601"/>
              <a:ext cx="6527709" cy="22733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0" name="Rectangle 9"/>
              <p:cNvSpPr/>
              <p:nvPr/>
            </p:nvSpPr>
            <p:spPr>
              <a:xfrm>
                <a:off x="644353" y="3839536"/>
                <a:ext cx="5995396" cy="1695975"/>
              </a:xfrm>
              <a:prstGeom prst="rect">
                <a:avLst/>
              </a:prstGeom>
              <a:noFill/>
              <a:ln w="28575">
                <a:solidFill>
                  <a:srgbClr val="FFC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463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-171896" y="4844387"/>
                <a:ext cx="703275" cy="318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13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MSF</a:t>
                </a:r>
                <a:endParaRPr lang="en-GB" sz="81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" name="TextBox 18"/>
            <p:cNvSpPr txBox="1"/>
            <p:nvPr/>
          </p:nvSpPr>
          <p:spPr>
            <a:xfrm>
              <a:off x="2797940" y="4091107"/>
              <a:ext cx="1148639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e</a:t>
              </a:r>
              <a:r>
                <a:rPr lang="hu-HU" sz="8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endPara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6158487" y="2761722"/>
            <a:ext cx="4160726" cy="2561114"/>
            <a:chOff x="6304873" y="2476473"/>
            <a:chExt cx="5120893" cy="3152140"/>
          </a:xfrm>
        </p:grpSpPr>
        <p:grpSp>
          <p:nvGrpSpPr>
            <p:cNvPr id="18" name="Group 17"/>
            <p:cNvGrpSpPr>
              <a:grpSpLocks noChangeAspect="1"/>
            </p:cNvGrpSpPr>
            <p:nvPr/>
          </p:nvGrpSpPr>
          <p:grpSpPr>
            <a:xfrm>
              <a:off x="6304873" y="2476473"/>
              <a:ext cx="5120893" cy="3152140"/>
              <a:chOff x="6238298" y="3149600"/>
              <a:chExt cx="6024580" cy="3708400"/>
            </a:xfrm>
          </p:grpSpPr>
          <p:graphicFrame>
            <p:nvGraphicFramePr>
              <p:cNvPr id="6" name="Chart 5"/>
              <p:cNvGraphicFramePr>
                <a:graphicFrameLocks/>
              </p:cNvGraphicFramePr>
              <p:nvPr/>
            </p:nvGraphicFramePr>
            <p:xfrm>
              <a:off x="6527709" y="3149600"/>
              <a:ext cx="5735169" cy="3708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9" name="Rectangle 8"/>
              <p:cNvSpPr/>
              <p:nvPr/>
            </p:nvSpPr>
            <p:spPr>
              <a:xfrm>
                <a:off x="7040295" y="3416955"/>
                <a:ext cx="5192642" cy="2874340"/>
              </a:xfrm>
              <a:prstGeom prst="rect">
                <a:avLst/>
              </a:prstGeom>
              <a:noFill/>
              <a:ln w="28575">
                <a:solidFill>
                  <a:schemeClr val="accent2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1463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6200000">
                <a:off x="6048480" y="4696946"/>
                <a:ext cx="694469" cy="3148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13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MSF</a:t>
                </a:r>
                <a:endParaRPr lang="en-GB" sz="81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>
              <a:off x="8762822" y="5361004"/>
              <a:ext cx="1148639" cy="267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e</a:t>
              </a:r>
              <a:r>
                <a:rPr lang="hu-HU" sz="81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hu-HU" sz="81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endParaRPr lang="en-GB" sz="81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461521" y="542900"/>
            <a:ext cx="30649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</a:t>
            </a:r>
            <a:endParaRPr lang="en-GB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461521" y="2679329"/>
            <a:ext cx="300082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</a:t>
            </a:r>
            <a:endParaRPr lang="en-GB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186969" y="2675469"/>
            <a:ext cx="306494" cy="2423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</a:t>
            </a:r>
            <a:endParaRPr lang="en-GB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2941606"/>
      </p:ext>
    </p:extLst>
  </p:cSld>
  <p:clrMapOvr>
    <a:masterClrMapping/>
  </p:clrMapOvr>
  <p:timing>
    <p:tnLst>
      <p:par>
        <p:cTn id="1" dur="indefinite" restart="never" nodeType="tmRoot"/>
      </p:par>
    </p:tnLst>
  </p:timing>
  <p:extLst mod="1">
    <p:ext uri="{6950BFC3-D8DA-4A85-94F7-54DA5524770B}">
      <p188:commentRel xmlns:p188="http://schemas.microsoft.com/office/powerpoint/2018/8/main" xmlns="" r:id="rId6"/>
    </p:ext>
  </p:extLs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190">
            <a:extLst>
              <a:ext uri="{FF2B5EF4-FFF2-40B4-BE49-F238E27FC236}">
                <a16:creationId xmlns:a16="http://schemas.microsoft.com/office/drawing/2014/main" id="{93B26362-0375-780E-31D8-CF4A282CBC8E}"/>
              </a:ext>
            </a:extLst>
          </p:cNvPr>
          <p:cNvSpPr txBox="1"/>
          <p:nvPr/>
        </p:nvSpPr>
        <p:spPr>
          <a:xfrm>
            <a:off x="597928" y="100996"/>
            <a:ext cx="47596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iched GO terms </a:t>
            </a:r>
            <a:r>
              <a:rPr lang="en-GB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cago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uncatula</a:t>
            </a:r>
            <a:r>
              <a:rPr lang="en-GB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RBR interacting proteins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p</a:t>
            </a:r>
            <a:r>
              <a:rPr lang="hu-HU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hu-HU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cess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216">
            <a:extLst>
              <a:ext uri="{FF2B5EF4-FFF2-40B4-BE49-F238E27FC236}">
                <a16:creationId xmlns:a16="http://schemas.microsoft.com/office/drawing/2014/main" id="{C00C1969-81A7-D4EA-3827-A5055BA73559}"/>
              </a:ext>
            </a:extLst>
          </p:cNvPr>
          <p:cNvSpPr txBox="1"/>
          <p:nvPr/>
        </p:nvSpPr>
        <p:spPr>
          <a:xfrm>
            <a:off x="241740" y="29743"/>
            <a:ext cx="614294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</a:t>
            </a:r>
            <a:endParaRPr lang="en-GB" sz="14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217">
            <a:extLst>
              <a:ext uri="{FF2B5EF4-FFF2-40B4-BE49-F238E27FC236}">
                <a16:creationId xmlns:a16="http://schemas.microsoft.com/office/drawing/2014/main" id="{8C1396D6-B3D4-44FB-435F-5EAED36F4ED5}"/>
              </a:ext>
            </a:extLst>
          </p:cNvPr>
          <p:cNvSpPr txBox="1"/>
          <p:nvPr/>
        </p:nvSpPr>
        <p:spPr>
          <a:xfrm>
            <a:off x="241740" y="3028768"/>
            <a:ext cx="356188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</a:t>
            </a:r>
            <a:endParaRPr lang="en-GB" sz="146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Picture 6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9493" y="354645"/>
            <a:ext cx="7801921" cy="3007905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0896" y="3362550"/>
            <a:ext cx="7883191" cy="3031065"/>
          </a:xfrm>
          <a:prstGeom prst="rect">
            <a:avLst/>
          </a:prstGeom>
        </p:spPr>
      </p:pic>
      <p:sp>
        <p:nvSpPr>
          <p:cNvPr id="6" name="TextBox 163">
            <a:extLst>
              <a:ext uri="{FF2B5EF4-FFF2-40B4-BE49-F238E27FC236}">
                <a16:creationId xmlns:a16="http://schemas.microsoft.com/office/drawing/2014/main" id="{6B146ABB-6FD8-9E9B-0137-07370F252CEC}"/>
              </a:ext>
            </a:extLst>
          </p:cNvPr>
          <p:cNvSpPr txBox="1"/>
          <p:nvPr/>
        </p:nvSpPr>
        <p:spPr>
          <a:xfrm>
            <a:off x="597928" y="3174962"/>
            <a:ext cx="50978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riched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O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ms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ssica</a:t>
            </a:r>
            <a:r>
              <a:rPr lang="hu-HU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hu-HU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RBR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acting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eloping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oung</a:t>
            </a:r>
            <a:r>
              <a:rPr lang="hu-HU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ves</a:t>
            </a:r>
            <a:endParaRPr lang="hu-HU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cess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954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1187535"/>
              </p:ext>
            </p:extLst>
          </p:nvPr>
        </p:nvGraphicFramePr>
        <p:xfrm>
          <a:off x="84082" y="639676"/>
          <a:ext cx="12107918" cy="4387472"/>
        </p:xfrm>
        <a:graphic>
          <a:graphicData uri="http://schemas.openxmlformats.org/drawingml/2006/table">
            <a:tbl>
              <a:tblPr/>
              <a:tblGrid>
                <a:gridCol w="3322208">
                  <a:extLst>
                    <a:ext uri="{9D8B030D-6E8A-4147-A177-3AD203B41FA5}">
                      <a16:colId xmlns:a16="http://schemas.microsoft.com/office/drawing/2014/main" val="917890046"/>
                    </a:ext>
                  </a:extLst>
                </a:gridCol>
                <a:gridCol w="1209370">
                  <a:extLst>
                    <a:ext uri="{9D8B030D-6E8A-4147-A177-3AD203B41FA5}">
                      <a16:colId xmlns:a16="http://schemas.microsoft.com/office/drawing/2014/main" val="3130205415"/>
                    </a:ext>
                  </a:extLst>
                </a:gridCol>
                <a:gridCol w="2504105">
                  <a:extLst>
                    <a:ext uri="{9D8B030D-6E8A-4147-A177-3AD203B41FA5}">
                      <a16:colId xmlns:a16="http://schemas.microsoft.com/office/drawing/2014/main" val="977985351"/>
                    </a:ext>
                  </a:extLst>
                </a:gridCol>
                <a:gridCol w="796761">
                  <a:extLst>
                    <a:ext uri="{9D8B030D-6E8A-4147-A177-3AD203B41FA5}">
                      <a16:colId xmlns:a16="http://schemas.microsoft.com/office/drawing/2014/main" val="3852860470"/>
                    </a:ext>
                  </a:extLst>
                </a:gridCol>
                <a:gridCol w="2895371">
                  <a:extLst>
                    <a:ext uri="{9D8B030D-6E8A-4147-A177-3AD203B41FA5}">
                      <a16:colId xmlns:a16="http://schemas.microsoft.com/office/drawing/2014/main" val="502857455"/>
                    </a:ext>
                  </a:extLst>
                </a:gridCol>
                <a:gridCol w="1380103">
                  <a:extLst>
                    <a:ext uri="{9D8B030D-6E8A-4147-A177-3AD203B41FA5}">
                      <a16:colId xmlns:a16="http://schemas.microsoft.com/office/drawing/2014/main" val="3209463729"/>
                    </a:ext>
                  </a:extLst>
                </a:gridCol>
              </a:tblGrid>
              <a:tr h="172995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dirty="0" err="1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Phosphopeptides</a:t>
                      </a:r>
                      <a:r>
                        <a:rPr lang="hu-HU" sz="1100" b="0" dirty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 </a:t>
                      </a:r>
                      <a:r>
                        <a:rPr lang="hu-HU" sz="1100" b="0" dirty="0" err="1" smtClean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At_RBR</a:t>
                      </a:r>
                      <a:endParaRPr lang="hu-HU" sz="1100" b="0" dirty="0">
                        <a:solidFill>
                          <a:srgbClr val="FFFFFF"/>
                        </a:solidFill>
                        <a:effectLst/>
                        <a:latin typeface="Ubuntu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56854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dirty="0" err="1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Position</a:t>
                      </a:r>
                      <a:endParaRPr lang="hu-HU" sz="1100" b="0" dirty="0">
                        <a:solidFill>
                          <a:srgbClr val="FFFFFF"/>
                        </a:solidFill>
                        <a:effectLst/>
                        <a:latin typeface="Ubuntu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56854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dirty="0" err="1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Phosphopeptides</a:t>
                      </a:r>
                      <a:r>
                        <a:rPr lang="hu-HU" sz="1100" b="0" dirty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 </a:t>
                      </a:r>
                      <a:r>
                        <a:rPr lang="hu-HU" sz="1100" b="0" dirty="0" err="1" smtClean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Bn_RBR</a:t>
                      </a:r>
                      <a:endParaRPr lang="hu-HU" sz="1100" b="0" dirty="0">
                        <a:solidFill>
                          <a:srgbClr val="FFFFFF"/>
                        </a:solidFill>
                        <a:effectLst/>
                        <a:latin typeface="Ubuntu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56854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Position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56854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dirty="0" err="1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Phosphopeptides</a:t>
                      </a:r>
                      <a:r>
                        <a:rPr lang="hu-HU" sz="1100" b="0" dirty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 </a:t>
                      </a:r>
                      <a:r>
                        <a:rPr lang="hu-HU" sz="1100" b="0" dirty="0" err="1" smtClean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Medtr_RBR</a:t>
                      </a:r>
                      <a:endParaRPr lang="hu-HU" sz="1100" b="0" dirty="0">
                        <a:solidFill>
                          <a:srgbClr val="FFFFFF"/>
                        </a:solidFill>
                        <a:effectLst/>
                        <a:latin typeface="Ubuntu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56854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>
                          <a:solidFill>
                            <a:srgbClr val="FFFFFF"/>
                          </a:solidFill>
                          <a:effectLst/>
                          <a:latin typeface="Ubuntu"/>
                        </a:rPr>
                        <a:t>Position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4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5685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4004839"/>
                  </a:ext>
                </a:extLst>
              </a:tr>
              <a:tr h="395416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EVQPPV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IEPNG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9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EVQPPV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IDPNGK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9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AETEMEDTKLSVVENGDQAVS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0154678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ALS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7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KIDSLS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78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3566558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FI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SPH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8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DLMM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8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3579240"/>
                  </a:ext>
                </a:extLst>
              </a:tr>
              <a:tr h="345989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FISPL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8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FISPL</a:t>
                      </a:r>
                      <a:r>
                        <a:rPr lang="hu-HU" sz="1500" b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K</a:t>
                      </a:r>
                      <a:r>
                        <a:rPr lang="hu-HU" sz="1500" b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AK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88/S39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T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Q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89 S39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716252"/>
                  </a:ext>
                </a:extLst>
              </a:tr>
              <a:tr h="395416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FISPL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K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A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89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TSPL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QR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SHANGIPGSANS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92 S396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5971057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A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STAMTTA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406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AA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STAMTTA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41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4475121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CPGQNGGIR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66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7970800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FT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KD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68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FA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KE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68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8216371"/>
                  </a:ext>
                </a:extLst>
              </a:tr>
              <a:tr h="395416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PPPLQSAFA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RPNPGGGGETCAETGINIFFT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71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FT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KD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694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9501658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ANNKPEGQCPG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88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203968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VFP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DMSP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893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QAVEANNNPEGHCPG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88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2266130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VFPSVPDM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898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VFPSVPDM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89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GHLVQNPG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05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1173413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V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HNVYVSPLRGS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03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hu-HU" sz="15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PFPSLPDM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K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18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2099977"/>
                  </a:ext>
                </a:extLst>
              </a:tr>
              <a:tr h="222422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AVHNVYV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11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AVHNVYV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08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VSAAHNVYV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9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31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4910912"/>
                  </a:ext>
                </a:extLst>
              </a:tr>
              <a:tr h="395416"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YACVGESTHAYQ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KDLSAINN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4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YACVGESTHAYQ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KDLSAINN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39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YACVGESTHAYQ</a:t>
                      </a:r>
                      <a:r>
                        <a:rPr lang="hu-HU" sz="1500" b="0" i="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hu-HU" sz="1100" b="0" i="0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KDLTAINNR</a:t>
                      </a:r>
                      <a:endParaRPr lang="hu-HU" sz="1100" b="0" dirty="0">
                        <a:solidFill>
                          <a:srgbClr val="434343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hu-HU" sz="1100" b="1" dirty="0">
                          <a:solidFill>
                            <a:srgbClr val="434343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962</a:t>
                      </a:r>
                    </a:p>
                  </a:txBody>
                  <a:tcPr marL="49427" marR="4942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524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3537481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0" y="5162120"/>
            <a:ext cx="12192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hosphorylated CDK sites have been identified in plant RBR proteins, specifically Arabidopsis thaliana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_RBR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Brassica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n_RBR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cago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uncatula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tr_RBR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se proteins were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precipitated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ing the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specific human Rb</a:t>
            </a:r>
            <a:r>
              <a:rPr lang="en-GB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7/811</a:t>
            </a:r>
            <a:r>
              <a:rPr lang="hu-HU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tibody, followed by mass spectrometry analysis. Phosphorylated threonine</a:t>
            </a:r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T)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serine</a:t>
            </a:r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)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K sites are indicated in red. The positions of the CDK sites in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_RBR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n_RBR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GB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tr_RBR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highlighted in yellow, green, and purple, respectively.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9946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6203927"/>
              </p:ext>
            </p:extLst>
          </p:nvPr>
        </p:nvGraphicFramePr>
        <p:xfrm>
          <a:off x="1832723" y="1119333"/>
          <a:ext cx="8128000" cy="2748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25600">
                  <a:extLst>
                    <a:ext uri="{9D8B030D-6E8A-4147-A177-3AD203B41FA5}">
                      <a16:colId xmlns:a16="http://schemas.microsoft.com/office/drawing/2014/main" val="14885769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362117992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2247925698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151419135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403506752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n-GB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D. SIZ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1954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1G07370.1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NA1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ATGAATCTCGGCAACA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GGGGCTCTCAAACATGA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86069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hu-HU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3G12280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R-3’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ATGGTGGAAAGACTACAACT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AGTCAGGCTCATTTGGGA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1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03729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hu-HU" sz="10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4G34160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D3;1-3’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AAGAAACCCAAGTCCCT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CAGAGAGGAGGAGACGGT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3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584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3G54650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BL17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TCCCAACATTACATCAAGTG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AGAGACAGTCATGCCACA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53927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5G42990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C18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GCAATGGACATATTTGTTTAGA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TGCAGACTGAACTCACTGTC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26369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3G18780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en-GB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CTTTAACTCTCCCGCTATG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AATCCAGCACAATACCG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0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</a:t>
                      </a:r>
                      <a:endParaRPr lang="en-GB" sz="10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1350320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832723" y="4013528"/>
            <a:ext cx="8128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hu-HU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st of primers and their sequences used for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.</a:t>
            </a:r>
            <a:r>
              <a:rPr lang="hu-H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first row from left to right, gene identification (GI), gene’s name, forward (FWD) and reverse (REV)</a:t>
            </a:r>
            <a:r>
              <a:rPr lang="hu-H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, and the product size of the PCRs in base pair (PROD. SIZE).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7345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64</TotalTime>
  <Words>1110</Words>
  <Application>Microsoft Office PowerPoint</Application>
  <PresentationFormat>Widescreen</PresentationFormat>
  <Paragraphs>167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Times New Roman</vt:lpstr>
      <vt:lpstr>Ubuntu</vt:lpstr>
      <vt:lpstr>Office-té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hér Attila Dr.</dc:creator>
  <cp:lastModifiedBy>Windows-felhasználó</cp:lastModifiedBy>
  <cp:revision>34</cp:revision>
  <dcterms:created xsi:type="dcterms:W3CDTF">2025-11-21T12:26:40Z</dcterms:created>
  <dcterms:modified xsi:type="dcterms:W3CDTF">2026-01-10T12:34:48Z</dcterms:modified>
</cp:coreProperties>
</file>